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E6C0B-5CF1-4AA3-8488-77E2857C60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10109D-5E50-435B-B384-7E64BF6CF4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1E98A2-E6E4-4D10-A537-7B6EC885B12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D956F-87CE-41A1-A078-0798A70911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CF413-DBCC-4F9E-B5DE-260FD12DBF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E6221-B083-4448-9208-F14F4EB9E4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4C492-33DC-49BB-B37B-6B8A038019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2E6DF-1A44-4F67-A1DB-6B16E07917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9FCA3-007A-4C42-9E63-6CC482E3F7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5B933-F907-4A1C-97EE-3E8BBCC41A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D886F-0AC0-4540-8B37-8AEC458BB6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BD011-4154-4117-ADDD-487D889D43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2E2B67-CFC8-490F-A130-BBCA5BF9C542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4"/>
          <p:cNvSpPr/>
          <p:nvPr/>
        </p:nvSpPr>
        <p:spPr>
          <a:xfrm>
            <a:off x="1539720" y="7551720"/>
            <a:ext cx="382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a-ES" sz="1200" spc="-1" strike="noStrike">
                <a:solidFill>
                  <a:srgbClr val="000000"/>
                </a:solidFill>
                <a:latin typeface="Arial"/>
              </a:rPr>
              <a:t>Navarro-Martin et al. Supplementary Figure 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Group 155"/>
          <p:cNvGrpSpPr/>
          <p:nvPr/>
        </p:nvGrpSpPr>
        <p:grpSpPr>
          <a:xfrm>
            <a:off x="1636560" y="2598840"/>
            <a:ext cx="4189680" cy="3577320"/>
            <a:chOff x="1636560" y="2598840"/>
            <a:chExt cx="4189680" cy="3577320"/>
          </a:xfrm>
        </p:grpSpPr>
        <p:sp>
          <p:nvSpPr>
            <p:cNvPr id="43" name="Rectangle 76"/>
            <p:cNvSpPr/>
            <p:nvPr/>
          </p:nvSpPr>
          <p:spPr>
            <a:xfrm>
              <a:off x="3033000" y="4338720"/>
              <a:ext cx="1315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ays post fertilization (dpf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Line 77"/>
            <p:cNvSpPr/>
            <p:nvPr/>
          </p:nvSpPr>
          <p:spPr>
            <a:xfrm>
              <a:off x="2043000" y="4098960"/>
              <a:ext cx="32403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78"/>
            <p:cNvSpPr/>
            <p:nvPr/>
          </p:nvSpPr>
          <p:spPr>
            <a:xfrm flipV="1">
              <a:off x="2043000" y="4098600"/>
              <a:ext cx="180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79"/>
            <p:cNvSpPr/>
            <p:nvPr/>
          </p:nvSpPr>
          <p:spPr>
            <a:xfrm flipV="1">
              <a:off x="236700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80"/>
            <p:cNvSpPr/>
            <p:nvPr/>
          </p:nvSpPr>
          <p:spPr>
            <a:xfrm flipV="1">
              <a:off x="2690640" y="4098600"/>
              <a:ext cx="180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Line 81"/>
            <p:cNvSpPr/>
            <p:nvPr/>
          </p:nvSpPr>
          <p:spPr>
            <a:xfrm flipV="1">
              <a:off x="301464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Line 82"/>
            <p:cNvSpPr/>
            <p:nvPr/>
          </p:nvSpPr>
          <p:spPr>
            <a:xfrm flipV="1">
              <a:off x="334008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Line 83"/>
            <p:cNvSpPr/>
            <p:nvPr/>
          </p:nvSpPr>
          <p:spPr>
            <a:xfrm flipV="1">
              <a:off x="366408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84"/>
            <p:cNvSpPr/>
            <p:nvPr/>
          </p:nvSpPr>
          <p:spPr>
            <a:xfrm flipV="1">
              <a:off x="3987720" y="4098600"/>
              <a:ext cx="180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85"/>
            <p:cNvSpPr/>
            <p:nvPr/>
          </p:nvSpPr>
          <p:spPr>
            <a:xfrm flipV="1">
              <a:off x="431172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86"/>
            <p:cNvSpPr/>
            <p:nvPr/>
          </p:nvSpPr>
          <p:spPr>
            <a:xfrm flipV="1">
              <a:off x="4635360" y="4098600"/>
              <a:ext cx="180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Line 87"/>
            <p:cNvSpPr/>
            <p:nvPr/>
          </p:nvSpPr>
          <p:spPr>
            <a:xfrm flipV="1">
              <a:off x="495936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88"/>
            <p:cNvSpPr/>
            <p:nvPr/>
          </p:nvSpPr>
          <p:spPr>
            <a:xfrm flipV="1">
              <a:off x="5283360" y="4098600"/>
              <a:ext cx="144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Rectangle 89"/>
            <p:cNvSpPr/>
            <p:nvPr/>
          </p:nvSpPr>
          <p:spPr>
            <a:xfrm>
              <a:off x="2012400" y="41814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Rectangle 90"/>
            <p:cNvSpPr/>
            <p:nvPr/>
          </p:nvSpPr>
          <p:spPr>
            <a:xfrm>
              <a:off x="2305800" y="41814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Rectangle 91"/>
            <p:cNvSpPr/>
            <p:nvPr/>
          </p:nvSpPr>
          <p:spPr>
            <a:xfrm>
              <a:off x="2629800" y="41814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Rectangle 92"/>
            <p:cNvSpPr/>
            <p:nvPr/>
          </p:nvSpPr>
          <p:spPr>
            <a:xfrm>
              <a:off x="2953440" y="41814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Rectangle 93"/>
            <p:cNvSpPr/>
            <p:nvPr/>
          </p:nvSpPr>
          <p:spPr>
            <a:xfrm>
              <a:off x="324864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Rectangle 94"/>
            <p:cNvSpPr/>
            <p:nvPr/>
          </p:nvSpPr>
          <p:spPr>
            <a:xfrm>
              <a:off x="357228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Rectangle 95"/>
            <p:cNvSpPr/>
            <p:nvPr/>
          </p:nvSpPr>
          <p:spPr>
            <a:xfrm>
              <a:off x="389628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96"/>
            <p:cNvSpPr/>
            <p:nvPr/>
          </p:nvSpPr>
          <p:spPr>
            <a:xfrm>
              <a:off x="422028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1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Rectangle 97"/>
            <p:cNvSpPr/>
            <p:nvPr/>
          </p:nvSpPr>
          <p:spPr>
            <a:xfrm>
              <a:off x="454392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4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Rectangle 98"/>
            <p:cNvSpPr/>
            <p:nvPr/>
          </p:nvSpPr>
          <p:spPr>
            <a:xfrm>
              <a:off x="486792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7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Rectangle 99"/>
            <p:cNvSpPr/>
            <p:nvPr/>
          </p:nvSpPr>
          <p:spPr>
            <a:xfrm>
              <a:off x="5191560" y="4181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Rectangle 100"/>
            <p:cNvSpPr/>
            <p:nvPr/>
          </p:nvSpPr>
          <p:spPr>
            <a:xfrm rot="16200000">
              <a:off x="1285560" y="3317040"/>
              <a:ext cx="823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emperature (ºC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101"/>
            <p:cNvSpPr/>
            <p:nvPr/>
          </p:nvSpPr>
          <p:spPr>
            <a:xfrm flipV="1">
              <a:off x="2043000" y="2658960"/>
              <a:ext cx="1800" cy="1440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Line 102"/>
            <p:cNvSpPr/>
            <p:nvPr/>
          </p:nvSpPr>
          <p:spPr>
            <a:xfrm>
              <a:off x="2011320" y="3987720"/>
              <a:ext cx="3168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Line 103"/>
            <p:cNvSpPr/>
            <p:nvPr/>
          </p:nvSpPr>
          <p:spPr>
            <a:xfrm>
              <a:off x="2011320" y="3765600"/>
              <a:ext cx="316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Line 104"/>
            <p:cNvSpPr/>
            <p:nvPr/>
          </p:nvSpPr>
          <p:spPr>
            <a:xfrm>
              <a:off x="2011320" y="3544920"/>
              <a:ext cx="316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Line 105"/>
            <p:cNvSpPr/>
            <p:nvPr/>
          </p:nvSpPr>
          <p:spPr>
            <a:xfrm>
              <a:off x="2011320" y="3322800"/>
              <a:ext cx="316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Line 106"/>
            <p:cNvSpPr/>
            <p:nvPr/>
          </p:nvSpPr>
          <p:spPr>
            <a:xfrm>
              <a:off x="2011320" y="3100320"/>
              <a:ext cx="3168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107"/>
            <p:cNvSpPr/>
            <p:nvPr/>
          </p:nvSpPr>
          <p:spPr>
            <a:xfrm>
              <a:off x="2011320" y="2879640"/>
              <a:ext cx="3168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Line 108"/>
            <p:cNvSpPr/>
            <p:nvPr/>
          </p:nvSpPr>
          <p:spPr>
            <a:xfrm>
              <a:off x="2011320" y="2658960"/>
              <a:ext cx="3168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Rectangle 109"/>
            <p:cNvSpPr/>
            <p:nvPr/>
          </p:nvSpPr>
          <p:spPr>
            <a:xfrm>
              <a:off x="1834200" y="39276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110"/>
            <p:cNvSpPr/>
            <p:nvPr/>
          </p:nvSpPr>
          <p:spPr>
            <a:xfrm>
              <a:off x="1834200" y="37051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111"/>
            <p:cNvSpPr/>
            <p:nvPr/>
          </p:nvSpPr>
          <p:spPr>
            <a:xfrm>
              <a:off x="1834200" y="348444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Rectangle 112"/>
            <p:cNvSpPr/>
            <p:nvPr/>
          </p:nvSpPr>
          <p:spPr>
            <a:xfrm>
              <a:off x="1834200" y="32623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Rectangle 113"/>
            <p:cNvSpPr/>
            <p:nvPr/>
          </p:nvSpPr>
          <p:spPr>
            <a:xfrm>
              <a:off x="1834200" y="30402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Rectangle 114"/>
            <p:cNvSpPr/>
            <p:nvPr/>
          </p:nvSpPr>
          <p:spPr>
            <a:xfrm>
              <a:off x="1834200" y="28195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Rectangle 115"/>
            <p:cNvSpPr/>
            <p:nvPr/>
          </p:nvSpPr>
          <p:spPr>
            <a:xfrm>
              <a:off x="1834200" y="259884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6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Freeform 116"/>
            <p:cNvSpPr/>
            <p:nvPr/>
          </p:nvSpPr>
          <p:spPr>
            <a:xfrm flipV="1">
              <a:off x="2065320" y="2837520"/>
              <a:ext cx="3218040" cy="1120680"/>
            </a:xfrm>
            <a:custGeom>
              <a:avLst/>
              <a:gdLst>
                <a:gd name="textAreaLeft" fmla="*/ 0 w 3218040"/>
                <a:gd name="textAreaRight" fmla="*/ 3218400 w 3218040"/>
                <a:gd name="textAreaTop" fmla="*/ -360 h 1120680"/>
                <a:gd name="textAreaBottom" fmla="*/ 1120680 h 1120680"/>
              </a:gdLst>
              <a:ahLst/>
              <a:rect l="textAreaLeft" t="textAreaTop" r="textAreaRight" b="textAreaBottom"/>
              <a:pathLst>
                <a:path w="3520" h="1275">
                  <a:moveTo>
                    <a:pt x="0" y="6"/>
                  </a:moveTo>
                  <a:lnTo>
                    <a:pt x="1" y="6"/>
                  </a:lnTo>
                  <a:lnTo>
                    <a:pt x="2" y="6"/>
                  </a:lnTo>
                  <a:lnTo>
                    <a:pt x="3" y="7"/>
                  </a:lnTo>
                  <a:lnTo>
                    <a:pt x="4" y="7"/>
                  </a:lnTo>
                  <a:lnTo>
                    <a:pt x="5" y="7"/>
                  </a:lnTo>
                  <a:lnTo>
                    <a:pt x="6" y="7"/>
                  </a:lnTo>
                  <a:lnTo>
                    <a:pt x="7" y="7"/>
                  </a:lnTo>
                  <a:lnTo>
                    <a:pt x="8" y="7"/>
                  </a:lnTo>
                  <a:lnTo>
                    <a:pt x="9" y="7"/>
                  </a:lnTo>
                  <a:lnTo>
                    <a:pt x="10" y="7"/>
                  </a:lnTo>
                  <a:lnTo>
                    <a:pt x="11" y="6"/>
                  </a:lnTo>
                  <a:lnTo>
                    <a:pt x="12" y="6"/>
                  </a:lnTo>
                  <a:lnTo>
                    <a:pt x="13" y="6"/>
                  </a:lnTo>
                  <a:lnTo>
                    <a:pt x="13" y="5"/>
                  </a:lnTo>
                  <a:lnTo>
                    <a:pt x="14" y="5"/>
                  </a:lnTo>
                  <a:lnTo>
                    <a:pt x="15" y="5"/>
                  </a:lnTo>
                  <a:lnTo>
                    <a:pt x="15" y="4"/>
                  </a:lnTo>
                  <a:lnTo>
                    <a:pt x="16" y="4"/>
                  </a:lnTo>
                  <a:lnTo>
                    <a:pt x="17" y="3"/>
                  </a:lnTo>
                  <a:lnTo>
                    <a:pt x="18" y="3"/>
                  </a:lnTo>
                  <a:lnTo>
                    <a:pt x="18" y="2"/>
                  </a:lnTo>
                  <a:lnTo>
                    <a:pt x="19" y="2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2" y="0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8" y="2"/>
                  </a:lnTo>
                  <a:lnTo>
                    <a:pt x="29" y="2"/>
                  </a:lnTo>
                  <a:lnTo>
                    <a:pt x="30" y="3"/>
                  </a:lnTo>
                  <a:lnTo>
                    <a:pt x="31" y="3"/>
                  </a:lnTo>
                  <a:lnTo>
                    <a:pt x="31" y="4"/>
                  </a:lnTo>
                  <a:lnTo>
                    <a:pt x="32" y="4"/>
                  </a:lnTo>
                  <a:lnTo>
                    <a:pt x="32" y="5"/>
                  </a:lnTo>
                  <a:lnTo>
                    <a:pt x="33" y="5"/>
                  </a:lnTo>
                  <a:lnTo>
                    <a:pt x="33" y="6"/>
                  </a:lnTo>
                  <a:lnTo>
                    <a:pt x="34" y="6"/>
                  </a:lnTo>
                  <a:lnTo>
                    <a:pt x="34" y="7"/>
                  </a:lnTo>
                  <a:lnTo>
                    <a:pt x="35" y="8"/>
                  </a:lnTo>
                  <a:lnTo>
                    <a:pt x="36" y="9"/>
                  </a:lnTo>
                  <a:lnTo>
                    <a:pt x="36" y="10"/>
                  </a:lnTo>
                  <a:lnTo>
                    <a:pt x="37" y="11"/>
                  </a:lnTo>
                  <a:lnTo>
                    <a:pt x="37" y="12"/>
                  </a:lnTo>
                  <a:lnTo>
                    <a:pt x="38" y="13"/>
                  </a:lnTo>
                  <a:lnTo>
                    <a:pt x="38" y="14"/>
                  </a:lnTo>
                  <a:lnTo>
                    <a:pt x="39" y="14"/>
                  </a:lnTo>
                  <a:lnTo>
                    <a:pt x="39" y="15"/>
                  </a:lnTo>
                  <a:lnTo>
                    <a:pt x="40" y="16"/>
                  </a:lnTo>
                  <a:lnTo>
                    <a:pt x="40" y="17"/>
                  </a:lnTo>
                  <a:lnTo>
                    <a:pt x="41" y="18"/>
                  </a:lnTo>
                  <a:lnTo>
                    <a:pt x="41" y="19"/>
                  </a:lnTo>
                  <a:lnTo>
                    <a:pt x="42" y="19"/>
                  </a:lnTo>
                  <a:lnTo>
                    <a:pt x="42" y="20"/>
                  </a:lnTo>
                  <a:lnTo>
                    <a:pt x="43" y="21"/>
                  </a:lnTo>
                  <a:lnTo>
                    <a:pt x="43" y="22"/>
                  </a:lnTo>
                  <a:lnTo>
                    <a:pt x="44" y="23"/>
                  </a:lnTo>
                  <a:lnTo>
                    <a:pt x="44" y="24"/>
                  </a:lnTo>
                  <a:lnTo>
                    <a:pt x="45" y="24"/>
                  </a:lnTo>
                  <a:lnTo>
                    <a:pt x="45" y="25"/>
                  </a:lnTo>
                  <a:lnTo>
                    <a:pt x="45" y="26"/>
                  </a:lnTo>
                  <a:lnTo>
                    <a:pt x="46" y="27"/>
                  </a:lnTo>
                  <a:lnTo>
                    <a:pt x="47" y="28"/>
                  </a:lnTo>
                  <a:lnTo>
                    <a:pt x="47" y="29"/>
                  </a:lnTo>
                  <a:lnTo>
                    <a:pt x="48" y="30"/>
                  </a:lnTo>
                  <a:lnTo>
                    <a:pt x="49" y="31"/>
                  </a:lnTo>
                  <a:lnTo>
                    <a:pt x="49" y="32"/>
                  </a:lnTo>
                  <a:lnTo>
                    <a:pt x="50" y="33"/>
                  </a:lnTo>
                  <a:lnTo>
                    <a:pt x="51" y="34"/>
                  </a:lnTo>
                  <a:lnTo>
                    <a:pt x="51" y="35"/>
                  </a:lnTo>
                  <a:lnTo>
                    <a:pt x="52" y="35"/>
                  </a:lnTo>
                  <a:lnTo>
                    <a:pt x="52" y="36"/>
                  </a:lnTo>
                  <a:lnTo>
                    <a:pt x="53" y="37"/>
                  </a:lnTo>
                  <a:lnTo>
                    <a:pt x="54" y="38"/>
                  </a:lnTo>
                  <a:lnTo>
                    <a:pt x="54" y="39"/>
                  </a:lnTo>
                  <a:lnTo>
                    <a:pt x="55" y="39"/>
                  </a:lnTo>
                  <a:lnTo>
                    <a:pt x="56" y="40"/>
                  </a:lnTo>
                  <a:lnTo>
                    <a:pt x="57" y="40"/>
                  </a:lnTo>
                  <a:lnTo>
                    <a:pt x="58" y="41"/>
                  </a:lnTo>
                  <a:lnTo>
                    <a:pt x="59" y="41"/>
                  </a:lnTo>
                  <a:lnTo>
                    <a:pt x="60" y="41"/>
                  </a:lnTo>
                  <a:lnTo>
                    <a:pt x="61" y="41"/>
                  </a:lnTo>
                  <a:lnTo>
                    <a:pt x="62" y="41"/>
                  </a:lnTo>
                  <a:lnTo>
                    <a:pt x="63" y="40"/>
                  </a:lnTo>
                  <a:lnTo>
                    <a:pt x="63" y="41"/>
                  </a:lnTo>
                  <a:lnTo>
                    <a:pt x="64" y="41"/>
                  </a:lnTo>
                  <a:lnTo>
                    <a:pt x="65" y="41"/>
                  </a:lnTo>
                  <a:lnTo>
                    <a:pt x="66" y="41"/>
                  </a:lnTo>
                  <a:lnTo>
                    <a:pt x="66" y="42"/>
                  </a:lnTo>
                  <a:lnTo>
                    <a:pt x="67" y="42"/>
                  </a:lnTo>
                  <a:lnTo>
                    <a:pt x="67" y="43"/>
                  </a:lnTo>
                  <a:lnTo>
                    <a:pt x="68" y="44"/>
                  </a:lnTo>
                  <a:lnTo>
                    <a:pt x="68" y="45"/>
                  </a:lnTo>
                  <a:lnTo>
                    <a:pt x="69" y="46"/>
                  </a:lnTo>
                  <a:lnTo>
                    <a:pt x="69" y="47"/>
                  </a:lnTo>
                  <a:lnTo>
                    <a:pt x="70" y="48"/>
                  </a:lnTo>
                  <a:lnTo>
                    <a:pt x="70" y="49"/>
                  </a:lnTo>
                  <a:lnTo>
                    <a:pt x="71" y="51"/>
                  </a:lnTo>
                  <a:lnTo>
                    <a:pt x="71" y="53"/>
                  </a:lnTo>
                  <a:lnTo>
                    <a:pt x="71" y="55"/>
                  </a:lnTo>
                  <a:lnTo>
                    <a:pt x="72" y="57"/>
                  </a:lnTo>
                  <a:lnTo>
                    <a:pt x="72" y="60"/>
                  </a:lnTo>
                  <a:lnTo>
                    <a:pt x="73" y="63"/>
                  </a:lnTo>
                  <a:lnTo>
                    <a:pt x="73" y="66"/>
                  </a:lnTo>
                  <a:lnTo>
                    <a:pt x="74" y="69"/>
                  </a:lnTo>
                  <a:lnTo>
                    <a:pt x="74" y="72"/>
                  </a:lnTo>
                  <a:lnTo>
                    <a:pt x="75" y="75"/>
                  </a:lnTo>
                  <a:lnTo>
                    <a:pt x="75" y="79"/>
                  </a:lnTo>
                  <a:lnTo>
                    <a:pt x="76" y="82"/>
                  </a:lnTo>
                  <a:lnTo>
                    <a:pt x="76" y="86"/>
                  </a:lnTo>
                  <a:lnTo>
                    <a:pt x="77" y="90"/>
                  </a:lnTo>
                  <a:lnTo>
                    <a:pt x="77" y="94"/>
                  </a:lnTo>
                  <a:lnTo>
                    <a:pt x="78" y="98"/>
                  </a:lnTo>
                  <a:lnTo>
                    <a:pt x="78" y="102"/>
                  </a:lnTo>
                  <a:lnTo>
                    <a:pt x="79" y="106"/>
                  </a:lnTo>
                  <a:lnTo>
                    <a:pt x="79" y="110"/>
                  </a:lnTo>
                  <a:lnTo>
                    <a:pt x="79" y="114"/>
                  </a:lnTo>
                  <a:lnTo>
                    <a:pt x="80" y="119"/>
                  </a:lnTo>
                  <a:lnTo>
                    <a:pt x="80" y="123"/>
                  </a:lnTo>
                  <a:lnTo>
                    <a:pt x="81" y="127"/>
                  </a:lnTo>
                  <a:lnTo>
                    <a:pt x="81" y="132"/>
                  </a:lnTo>
                  <a:lnTo>
                    <a:pt x="82" y="136"/>
                  </a:lnTo>
                  <a:lnTo>
                    <a:pt x="82" y="141"/>
                  </a:lnTo>
                  <a:lnTo>
                    <a:pt x="83" y="145"/>
                  </a:lnTo>
                  <a:lnTo>
                    <a:pt x="83" y="150"/>
                  </a:lnTo>
                  <a:lnTo>
                    <a:pt x="84" y="154"/>
                  </a:lnTo>
                  <a:lnTo>
                    <a:pt x="84" y="159"/>
                  </a:lnTo>
                  <a:lnTo>
                    <a:pt x="85" y="163"/>
                  </a:lnTo>
                  <a:lnTo>
                    <a:pt x="85" y="168"/>
                  </a:lnTo>
                  <a:lnTo>
                    <a:pt x="86" y="172"/>
                  </a:lnTo>
                  <a:lnTo>
                    <a:pt x="86" y="176"/>
                  </a:lnTo>
                  <a:lnTo>
                    <a:pt x="87" y="181"/>
                  </a:lnTo>
                  <a:lnTo>
                    <a:pt x="87" y="185"/>
                  </a:lnTo>
                  <a:lnTo>
                    <a:pt x="88" y="189"/>
                  </a:lnTo>
                  <a:lnTo>
                    <a:pt x="88" y="193"/>
                  </a:lnTo>
                  <a:lnTo>
                    <a:pt x="88" y="197"/>
                  </a:lnTo>
                  <a:lnTo>
                    <a:pt x="89" y="200"/>
                  </a:lnTo>
                  <a:lnTo>
                    <a:pt x="89" y="204"/>
                  </a:lnTo>
                  <a:lnTo>
                    <a:pt x="90" y="207"/>
                  </a:lnTo>
                  <a:lnTo>
                    <a:pt x="90" y="211"/>
                  </a:lnTo>
                  <a:lnTo>
                    <a:pt x="91" y="214"/>
                  </a:lnTo>
                  <a:lnTo>
                    <a:pt x="91" y="217"/>
                  </a:lnTo>
                  <a:lnTo>
                    <a:pt x="92" y="220"/>
                  </a:lnTo>
                  <a:lnTo>
                    <a:pt x="92" y="222"/>
                  </a:lnTo>
                  <a:lnTo>
                    <a:pt x="93" y="224"/>
                  </a:lnTo>
                  <a:lnTo>
                    <a:pt x="93" y="227"/>
                  </a:lnTo>
                  <a:lnTo>
                    <a:pt x="94" y="229"/>
                  </a:lnTo>
                  <a:lnTo>
                    <a:pt x="94" y="230"/>
                  </a:lnTo>
                  <a:lnTo>
                    <a:pt x="95" y="232"/>
                  </a:lnTo>
                  <a:lnTo>
                    <a:pt x="95" y="233"/>
                  </a:lnTo>
                  <a:lnTo>
                    <a:pt x="96" y="234"/>
                  </a:lnTo>
                  <a:lnTo>
                    <a:pt x="96" y="235"/>
                  </a:lnTo>
                  <a:lnTo>
                    <a:pt x="97" y="235"/>
                  </a:lnTo>
                  <a:lnTo>
                    <a:pt x="98" y="235"/>
                  </a:lnTo>
                  <a:lnTo>
                    <a:pt x="99" y="235"/>
                  </a:lnTo>
                  <a:lnTo>
                    <a:pt x="99" y="234"/>
                  </a:lnTo>
                  <a:lnTo>
                    <a:pt x="100" y="233"/>
                  </a:lnTo>
                  <a:lnTo>
                    <a:pt x="101" y="232"/>
                  </a:lnTo>
                  <a:lnTo>
                    <a:pt x="101" y="231"/>
                  </a:lnTo>
                  <a:lnTo>
                    <a:pt x="102" y="230"/>
                  </a:lnTo>
                  <a:lnTo>
                    <a:pt x="103" y="229"/>
                  </a:lnTo>
                  <a:lnTo>
                    <a:pt x="103" y="228"/>
                  </a:lnTo>
                  <a:lnTo>
                    <a:pt x="104" y="227"/>
                  </a:lnTo>
                  <a:lnTo>
                    <a:pt x="104" y="226"/>
                  </a:lnTo>
                  <a:lnTo>
                    <a:pt x="105" y="225"/>
                  </a:lnTo>
                  <a:lnTo>
                    <a:pt x="105" y="224"/>
                  </a:lnTo>
                  <a:lnTo>
                    <a:pt x="106" y="223"/>
                  </a:lnTo>
                  <a:lnTo>
                    <a:pt x="107" y="222"/>
                  </a:lnTo>
                  <a:lnTo>
                    <a:pt x="108" y="222"/>
                  </a:lnTo>
                  <a:lnTo>
                    <a:pt x="109" y="222"/>
                  </a:lnTo>
                  <a:lnTo>
                    <a:pt x="110" y="222"/>
                  </a:lnTo>
                  <a:lnTo>
                    <a:pt x="110" y="223"/>
                  </a:lnTo>
                  <a:lnTo>
                    <a:pt x="111" y="224"/>
                  </a:lnTo>
                  <a:lnTo>
                    <a:pt x="111" y="225"/>
                  </a:lnTo>
                  <a:lnTo>
                    <a:pt x="112" y="226"/>
                  </a:lnTo>
                  <a:lnTo>
                    <a:pt x="112" y="227"/>
                  </a:lnTo>
                  <a:lnTo>
                    <a:pt x="113" y="228"/>
                  </a:lnTo>
                  <a:lnTo>
                    <a:pt x="113" y="230"/>
                  </a:lnTo>
                  <a:lnTo>
                    <a:pt x="113" y="231"/>
                  </a:lnTo>
                  <a:lnTo>
                    <a:pt x="114" y="233"/>
                  </a:lnTo>
                  <a:lnTo>
                    <a:pt x="114" y="235"/>
                  </a:lnTo>
                  <a:lnTo>
                    <a:pt x="115" y="237"/>
                  </a:lnTo>
                  <a:lnTo>
                    <a:pt x="115" y="240"/>
                  </a:lnTo>
                  <a:lnTo>
                    <a:pt x="116" y="243"/>
                  </a:lnTo>
                  <a:lnTo>
                    <a:pt x="116" y="245"/>
                  </a:lnTo>
                  <a:lnTo>
                    <a:pt x="117" y="248"/>
                  </a:lnTo>
                  <a:lnTo>
                    <a:pt x="117" y="252"/>
                  </a:lnTo>
                  <a:lnTo>
                    <a:pt x="118" y="255"/>
                  </a:lnTo>
                  <a:lnTo>
                    <a:pt x="118" y="259"/>
                  </a:lnTo>
                  <a:lnTo>
                    <a:pt x="119" y="263"/>
                  </a:lnTo>
                  <a:lnTo>
                    <a:pt x="119" y="268"/>
                  </a:lnTo>
                  <a:lnTo>
                    <a:pt x="120" y="272"/>
                  </a:lnTo>
                  <a:lnTo>
                    <a:pt x="120" y="277"/>
                  </a:lnTo>
                  <a:lnTo>
                    <a:pt x="121" y="282"/>
                  </a:lnTo>
                  <a:lnTo>
                    <a:pt x="121" y="287"/>
                  </a:lnTo>
                  <a:lnTo>
                    <a:pt x="122" y="293"/>
                  </a:lnTo>
                  <a:lnTo>
                    <a:pt x="122" y="298"/>
                  </a:lnTo>
                  <a:lnTo>
                    <a:pt x="122" y="303"/>
                  </a:lnTo>
                  <a:lnTo>
                    <a:pt x="123" y="309"/>
                  </a:lnTo>
                  <a:lnTo>
                    <a:pt x="123" y="314"/>
                  </a:lnTo>
                  <a:lnTo>
                    <a:pt x="124" y="319"/>
                  </a:lnTo>
                  <a:lnTo>
                    <a:pt x="124" y="325"/>
                  </a:lnTo>
                  <a:lnTo>
                    <a:pt x="125" y="330"/>
                  </a:lnTo>
                  <a:lnTo>
                    <a:pt x="125" y="335"/>
                  </a:lnTo>
                  <a:lnTo>
                    <a:pt x="126" y="340"/>
                  </a:lnTo>
                  <a:lnTo>
                    <a:pt x="126" y="345"/>
                  </a:lnTo>
                  <a:lnTo>
                    <a:pt x="127" y="350"/>
                  </a:lnTo>
                  <a:lnTo>
                    <a:pt x="127" y="355"/>
                  </a:lnTo>
                  <a:lnTo>
                    <a:pt x="128" y="359"/>
                  </a:lnTo>
                  <a:lnTo>
                    <a:pt x="128" y="364"/>
                  </a:lnTo>
                  <a:lnTo>
                    <a:pt x="129" y="368"/>
                  </a:lnTo>
                  <a:lnTo>
                    <a:pt x="129" y="372"/>
                  </a:lnTo>
                  <a:lnTo>
                    <a:pt x="130" y="375"/>
                  </a:lnTo>
                  <a:lnTo>
                    <a:pt x="130" y="379"/>
                  </a:lnTo>
                  <a:lnTo>
                    <a:pt x="131" y="381"/>
                  </a:lnTo>
                  <a:lnTo>
                    <a:pt x="131" y="383"/>
                  </a:lnTo>
                  <a:lnTo>
                    <a:pt x="131" y="385"/>
                  </a:lnTo>
                  <a:lnTo>
                    <a:pt x="132" y="387"/>
                  </a:lnTo>
                  <a:lnTo>
                    <a:pt x="132" y="388"/>
                  </a:lnTo>
                  <a:lnTo>
                    <a:pt x="133" y="389"/>
                  </a:lnTo>
                  <a:lnTo>
                    <a:pt x="133" y="390"/>
                  </a:lnTo>
                  <a:lnTo>
                    <a:pt x="134" y="391"/>
                  </a:lnTo>
                  <a:lnTo>
                    <a:pt x="134" y="392"/>
                  </a:lnTo>
                  <a:lnTo>
                    <a:pt x="135" y="393"/>
                  </a:lnTo>
                  <a:lnTo>
                    <a:pt x="136" y="394"/>
                  </a:lnTo>
                  <a:lnTo>
                    <a:pt x="136" y="395"/>
                  </a:lnTo>
                  <a:lnTo>
                    <a:pt x="137" y="395"/>
                  </a:lnTo>
                  <a:lnTo>
                    <a:pt x="137" y="396"/>
                  </a:lnTo>
                  <a:lnTo>
                    <a:pt x="138" y="396"/>
                  </a:lnTo>
                  <a:lnTo>
                    <a:pt x="138" y="397"/>
                  </a:lnTo>
                  <a:lnTo>
                    <a:pt x="139" y="398"/>
                  </a:lnTo>
                  <a:lnTo>
                    <a:pt x="139" y="399"/>
                  </a:lnTo>
                  <a:lnTo>
                    <a:pt x="139" y="400"/>
                  </a:lnTo>
                  <a:lnTo>
                    <a:pt x="140" y="401"/>
                  </a:lnTo>
                  <a:lnTo>
                    <a:pt x="140" y="403"/>
                  </a:lnTo>
                  <a:lnTo>
                    <a:pt x="141" y="405"/>
                  </a:lnTo>
                  <a:lnTo>
                    <a:pt x="141" y="407"/>
                  </a:lnTo>
                  <a:lnTo>
                    <a:pt x="142" y="409"/>
                  </a:lnTo>
                  <a:lnTo>
                    <a:pt x="142" y="412"/>
                  </a:lnTo>
                  <a:lnTo>
                    <a:pt x="143" y="415"/>
                  </a:lnTo>
                  <a:lnTo>
                    <a:pt x="143" y="419"/>
                  </a:lnTo>
                  <a:lnTo>
                    <a:pt x="144" y="423"/>
                  </a:lnTo>
                  <a:lnTo>
                    <a:pt x="144" y="427"/>
                  </a:lnTo>
                  <a:lnTo>
                    <a:pt x="145" y="431"/>
                  </a:lnTo>
                  <a:lnTo>
                    <a:pt x="145" y="436"/>
                  </a:lnTo>
                  <a:lnTo>
                    <a:pt x="146" y="441"/>
                  </a:lnTo>
                  <a:lnTo>
                    <a:pt x="146" y="445"/>
                  </a:lnTo>
                  <a:lnTo>
                    <a:pt x="147" y="450"/>
                  </a:lnTo>
                  <a:lnTo>
                    <a:pt x="147" y="455"/>
                  </a:lnTo>
                  <a:lnTo>
                    <a:pt x="148" y="460"/>
                  </a:lnTo>
                  <a:lnTo>
                    <a:pt x="148" y="465"/>
                  </a:lnTo>
                  <a:lnTo>
                    <a:pt x="148" y="470"/>
                  </a:lnTo>
                  <a:lnTo>
                    <a:pt x="149" y="475"/>
                  </a:lnTo>
                  <a:lnTo>
                    <a:pt x="149" y="480"/>
                  </a:lnTo>
                  <a:lnTo>
                    <a:pt x="150" y="485"/>
                  </a:lnTo>
                  <a:lnTo>
                    <a:pt x="150" y="490"/>
                  </a:lnTo>
                  <a:lnTo>
                    <a:pt x="151" y="494"/>
                  </a:lnTo>
                  <a:lnTo>
                    <a:pt x="151" y="499"/>
                  </a:lnTo>
                  <a:lnTo>
                    <a:pt x="152" y="503"/>
                  </a:lnTo>
                  <a:lnTo>
                    <a:pt x="152" y="508"/>
                  </a:lnTo>
                  <a:lnTo>
                    <a:pt x="153" y="512"/>
                  </a:lnTo>
                  <a:lnTo>
                    <a:pt x="153" y="516"/>
                  </a:lnTo>
                  <a:lnTo>
                    <a:pt x="154" y="519"/>
                  </a:lnTo>
                  <a:lnTo>
                    <a:pt x="154" y="522"/>
                  </a:lnTo>
                  <a:lnTo>
                    <a:pt x="155" y="525"/>
                  </a:lnTo>
                  <a:lnTo>
                    <a:pt x="155" y="528"/>
                  </a:lnTo>
                  <a:lnTo>
                    <a:pt x="156" y="530"/>
                  </a:lnTo>
                  <a:lnTo>
                    <a:pt x="156" y="532"/>
                  </a:lnTo>
                  <a:lnTo>
                    <a:pt x="156" y="534"/>
                  </a:lnTo>
                  <a:lnTo>
                    <a:pt x="157" y="536"/>
                  </a:lnTo>
                  <a:lnTo>
                    <a:pt x="157" y="537"/>
                  </a:lnTo>
                  <a:lnTo>
                    <a:pt x="158" y="539"/>
                  </a:lnTo>
                  <a:lnTo>
                    <a:pt x="158" y="540"/>
                  </a:lnTo>
                  <a:lnTo>
                    <a:pt x="159" y="541"/>
                  </a:lnTo>
                  <a:lnTo>
                    <a:pt x="159" y="542"/>
                  </a:lnTo>
                  <a:lnTo>
                    <a:pt x="160" y="542"/>
                  </a:lnTo>
                  <a:lnTo>
                    <a:pt x="160" y="543"/>
                  </a:lnTo>
                  <a:lnTo>
                    <a:pt x="161" y="544"/>
                  </a:lnTo>
                  <a:lnTo>
                    <a:pt x="162" y="544"/>
                  </a:lnTo>
                  <a:lnTo>
                    <a:pt x="163" y="544"/>
                  </a:lnTo>
                  <a:lnTo>
                    <a:pt x="164" y="544"/>
                  </a:lnTo>
                  <a:lnTo>
                    <a:pt x="165" y="544"/>
                  </a:lnTo>
                  <a:lnTo>
                    <a:pt x="166" y="543"/>
                  </a:lnTo>
                  <a:lnTo>
                    <a:pt x="167" y="543"/>
                  </a:lnTo>
                  <a:lnTo>
                    <a:pt x="168" y="542"/>
                  </a:lnTo>
                  <a:lnTo>
                    <a:pt x="169" y="542"/>
                  </a:lnTo>
                  <a:lnTo>
                    <a:pt x="170" y="542"/>
                  </a:lnTo>
                  <a:lnTo>
                    <a:pt x="170" y="543"/>
                  </a:lnTo>
                  <a:lnTo>
                    <a:pt x="171" y="543"/>
                  </a:lnTo>
                  <a:lnTo>
                    <a:pt x="171" y="544"/>
                  </a:lnTo>
                  <a:lnTo>
                    <a:pt x="172" y="544"/>
                  </a:lnTo>
                  <a:lnTo>
                    <a:pt x="172" y="545"/>
                  </a:lnTo>
                  <a:lnTo>
                    <a:pt x="173" y="546"/>
                  </a:lnTo>
                  <a:lnTo>
                    <a:pt x="173" y="548"/>
                  </a:lnTo>
                  <a:lnTo>
                    <a:pt x="173" y="549"/>
                  </a:lnTo>
                  <a:lnTo>
                    <a:pt x="174" y="551"/>
                  </a:lnTo>
                  <a:lnTo>
                    <a:pt x="174" y="553"/>
                  </a:lnTo>
                  <a:lnTo>
                    <a:pt x="175" y="555"/>
                  </a:lnTo>
                  <a:lnTo>
                    <a:pt x="175" y="558"/>
                  </a:lnTo>
                  <a:lnTo>
                    <a:pt x="176" y="560"/>
                  </a:lnTo>
                  <a:lnTo>
                    <a:pt x="176" y="564"/>
                  </a:lnTo>
                  <a:lnTo>
                    <a:pt x="177" y="567"/>
                  </a:lnTo>
                  <a:lnTo>
                    <a:pt x="177" y="571"/>
                  </a:lnTo>
                  <a:lnTo>
                    <a:pt x="178" y="576"/>
                  </a:lnTo>
                  <a:lnTo>
                    <a:pt x="178" y="580"/>
                  </a:lnTo>
                  <a:lnTo>
                    <a:pt x="179" y="586"/>
                  </a:lnTo>
                  <a:lnTo>
                    <a:pt x="179" y="591"/>
                  </a:lnTo>
                  <a:lnTo>
                    <a:pt x="180" y="597"/>
                  </a:lnTo>
                  <a:lnTo>
                    <a:pt x="180" y="603"/>
                  </a:lnTo>
                  <a:lnTo>
                    <a:pt x="181" y="609"/>
                  </a:lnTo>
                  <a:lnTo>
                    <a:pt x="181" y="616"/>
                  </a:lnTo>
                  <a:lnTo>
                    <a:pt x="182" y="622"/>
                  </a:lnTo>
                  <a:lnTo>
                    <a:pt x="182" y="629"/>
                  </a:lnTo>
                  <a:lnTo>
                    <a:pt x="182" y="635"/>
                  </a:lnTo>
                  <a:lnTo>
                    <a:pt x="183" y="642"/>
                  </a:lnTo>
                  <a:lnTo>
                    <a:pt x="183" y="649"/>
                  </a:lnTo>
                  <a:lnTo>
                    <a:pt x="184" y="656"/>
                  </a:lnTo>
                  <a:lnTo>
                    <a:pt x="184" y="663"/>
                  </a:lnTo>
                  <a:lnTo>
                    <a:pt x="185" y="669"/>
                  </a:lnTo>
                  <a:lnTo>
                    <a:pt x="185" y="676"/>
                  </a:lnTo>
                  <a:lnTo>
                    <a:pt x="186" y="682"/>
                  </a:lnTo>
                  <a:lnTo>
                    <a:pt x="186" y="689"/>
                  </a:lnTo>
                  <a:lnTo>
                    <a:pt x="187" y="695"/>
                  </a:lnTo>
                  <a:lnTo>
                    <a:pt x="187" y="701"/>
                  </a:lnTo>
                  <a:lnTo>
                    <a:pt x="188" y="707"/>
                  </a:lnTo>
                  <a:lnTo>
                    <a:pt x="188" y="712"/>
                  </a:lnTo>
                  <a:lnTo>
                    <a:pt x="189" y="717"/>
                  </a:lnTo>
                  <a:lnTo>
                    <a:pt x="189" y="722"/>
                  </a:lnTo>
                  <a:lnTo>
                    <a:pt x="190" y="726"/>
                  </a:lnTo>
                  <a:lnTo>
                    <a:pt x="190" y="730"/>
                  </a:lnTo>
                  <a:lnTo>
                    <a:pt x="190" y="733"/>
                  </a:lnTo>
                  <a:lnTo>
                    <a:pt x="191" y="736"/>
                  </a:lnTo>
                  <a:lnTo>
                    <a:pt x="191" y="739"/>
                  </a:lnTo>
                  <a:lnTo>
                    <a:pt x="192" y="742"/>
                  </a:lnTo>
                  <a:lnTo>
                    <a:pt x="192" y="744"/>
                  </a:lnTo>
                  <a:lnTo>
                    <a:pt x="193" y="746"/>
                  </a:lnTo>
                  <a:lnTo>
                    <a:pt x="193" y="748"/>
                  </a:lnTo>
                  <a:lnTo>
                    <a:pt x="194" y="750"/>
                  </a:lnTo>
                  <a:lnTo>
                    <a:pt x="194" y="752"/>
                  </a:lnTo>
                  <a:lnTo>
                    <a:pt x="195" y="754"/>
                  </a:lnTo>
                  <a:lnTo>
                    <a:pt x="195" y="755"/>
                  </a:lnTo>
                  <a:lnTo>
                    <a:pt x="196" y="757"/>
                  </a:lnTo>
                  <a:lnTo>
                    <a:pt x="196" y="758"/>
                  </a:lnTo>
                  <a:lnTo>
                    <a:pt x="197" y="760"/>
                  </a:lnTo>
                  <a:lnTo>
                    <a:pt x="197" y="761"/>
                  </a:lnTo>
                  <a:lnTo>
                    <a:pt x="198" y="763"/>
                  </a:lnTo>
                  <a:lnTo>
                    <a:pt x="198" y="764"/>
                  </a:lnTo>
                  <a:lnTo>
                    <a:pt x="199" y="766"/>
                  </a:lnTo>
                  <a:lnTo>
                    <a:pt x="199" y="767"/>
                  </a:lnTo>
                  <a:lnTo>
                    <a:pt x="199" y="769"/>
                  </a:lnTo>
                  <a:lnTo>
                    <a:pt x="200" y="771"/>
                  </a:lnTo>
                  <a:lnTo>
                    <a:pt x="200" y="773"/>
                  </a:lnTo>
                  <a:lnTo>
                    <a:pt x="201" y="775"/>
                  </a:lnTo>
                  <a:lnTo>
                    <a:pt x="201" y="778"/>
                  </a:lnTo>
                  <a:lnTo>
                    <a:pt x="202" y="781"/>
                  </a:lnTo>
                  <a:lnTo>
                    <a:pt x="202" y="784"/>
                  </a:lnTo>
                  <a:lnTo>
                    <a:pt x="203" y="787"/>
                  </a:lnTo>
                  <a:lnTo>
                    <a:pt x="203" y="791"/>
                  </a:lnTo>
                  <a:lnTo>
                    <a:pt x="204" y="794"/>
                  </a:lnTo>
                  <a:lnTo>
                    <a:pt x="204" y="798"/>
                  </a:lnTo>
                  <a:lnTo>
                    <a:pt x="205" y="802"/>
                  </a:lnTo>
                  <a:lnTo>
                    <a:pt x="205" y="805"/>
                  </a:lnTo>
                  <a:lnTo>
                    <a:pt x="206" y="809"/>
                  </a:lnTo>
                  <a:lnTo>
                    <a:pt x="206" y="813"/>
                  </a:lnTo>
                  <a:lnTo>
                    <a:pt x="207" y="817"/>
                  </a:lnTo>
                  <a:lnTo>
                    <a:pt x="207" y="820"/>
                  </a:lnTo>
                  <a:lnTo>
                    <a:pt x="208" y="824"/>
                  </a:lnTo>
                  <a:lnTo>
                    <a:pt x="208" y="828"/>
                  </a:lnTo>
                  <a:lnTo>
                    <a:pt x="208" y="832"/>
                  </a:lnTo>
                  <a:lnTo>
                    <a:pt x="209" y="835"/>
                  </a:lnTo>
                  <a:lnTo>
                    <a:pt x="209" y="839"/>
                  </a:lnTo>
                  <a:lnTo>
                    <a:pt x="210" y="842"/>
                  </a:lnTo>
                  <a:lnTo>
                    <a:pt x="210" y="846"/>
                  </a:lnTo>
                  <a:lnTo>
                    <a:pt x="211" y="849"/>
                  </a:lnTo>
                  <a:lnTo>
                    <a:pt x="211" y="852"/>
                  </a:lnTo>
                  <a:lnTo>
                    <a:pt x="212" y="855"/>
                  </a:lnTo>
                  <a:lnTo>
                    <a:pt x="212" y="858"/>
                  </a:lnTo>
                  <a:lnTo>
                    <a:pt x="213" y="860"/>
                  </a:lnTo>
                  <a:lnTo>
                    <a:pt x="213" y="862"/>
                  </a:lnTo>
                  <a:lnTo>
                    <a:pt x="214" y="863"/>
                  </a:lnTo>
                  <a:lnTo>
                    <a:pt x="214" y="865"/>
                  </a:lnTo>
                  <a:lnTo>
                    <a:pt x="215" y="866"/>
                  </a:lnTo>
                  <a:lnTo>
                    <a:pt x="215" y="867"/>
                  </a:lnTo>
                  <a:lnTo>
                    <a:pt x="216" y="868"/>
                  </a:lnTo>
                  <a:lnTo>
                    <a:pt x="216" y="869"/>
                  </a:lnTo>
                  <a:lnTo>
                    <a:pt x="217" y="870"/>
                  </a:lnTo>
                  <a:lnTo>
                    <a:pt x="218" y="870"/>
                  </a:lnTo>
                  <a:lnTo>
                    <a:pt x="219" y="871"/>
                  </a:lnTo>
                  <a:lnTo>
                    <a:pt x="219" y="870"/>
                  </a:lnTo>
                  <a:lnTo>
                    <a:pt x="220" y="870"/>
                  </a:lnTo>
                  <a:lnTo>
                    <a:pt x="221" y="870"/>
                  </a:lnTo>
                  <a:lnTo>
                    <a:pt x="221" y="869"/>
                  </a:lnTo>
                  <a:lnTo>
                    <a:pt x="222" y="869"/>
                  </a:lnTo>
                  <a:lnTo>
                    <a:pt x="223" y="868"/>
                  </a:lnTo>
                  <a:lnTo>
                    <a:pt x="224" y="867"/>
                  </a:lnTo>
                  <a:lnTo>
                    <a:pt x="225" y="866"/>
                  </a:lnTo>
                  <a:lnTo>
                    <a:pt x="225" y="865"/>
                  </a:lnTo>
                  <a:lnTo>
                    <a:pt x="226" y="865"/>
                  </a:lnTo>
                  <a:lnTo>
                    <a:pt x="226" y="864"/>
                  </a:lnTo>
                  <a:lnTo>
                    <a:pt x="227" y="864"/>
                  </a:lnTo>
                  <a:lnTo>
                    <a:pt x="227" y="863"/>
                  </a:lnTo>
                  <a:lnTo>
                    <a:pt x="228" y="863"/>
                  </a:lnTo>
                  <a:lnTo>
                    <a:pt x="229" y="862"/>
                  </a:lnTo>
                  <a:lnTo>
                    <a:pt x="230" y="862"/>
                  </a:lnTo>
                  <a:lnTo>
                    <a:pt x="230" y="861"/>
                  </a:lnTo>
                  <a:lnTo>
                    <a:pt x="231" y="861"/>
                  </a:lnTo>
                  <a:lnTo>
                    <a:pt x="232" y="861"/>
                  </a:lnTo>
                  <a:lnTo>
                    <a:pt x="233" y="861"/>
                  </a:lnTo>
                  <a:lnTo>
                    <a:pt x="234" y="861"/>
                  </a:lnTo>
                  <a:lnTo>
                    <a:pt x="235" y="861"/>
                  </a:lnTo>
                  <a:lnTo>
                    <a:pt x="236" y="861"/>
                  </a:lnTo>
                  <a:lnTo>
                    <a:pt x="236" y="862"/>
                  </a:lnTo>
                  <a:lnTo>
                    <a:pt x="237" y="862"/>
                  </a:lnTo>
                  <a:lnTo>
                    <a:pt x="238" y="863"/>
                  </a:lnTo>
                  <a:lnTo>
                    <a:pt x="239" y="863"/>
                  </a:lnTo>
                  <a:lnTo>
                    <a:pt x="239" y="864"/>
                  </a:lnTo>
                  <a:lnTo>
                    <a:pt x="240" y="864"/>
                  </a:lnTo>
                  <a:lnTo>
                    <a:pt x="240" y="865"/>
                  </a:lnTo>
                  <a:lnTo>
                    <a:pt x="241" y="865"/>
                  </a:lnTo>
                  <a:lnTo>
                    <a:pt x="241" y="866"/>
                  </a:lnTo>
                  <a:lnTo>
                    <a:pt x="242" y="866"/>
                  </a:lnTo>
                  <a:lnTo>
                    <a:pt x="242" y="867"/>
                  </a:lnTo>
                  <a:lnTo>
                    <a:pt x="243" y="868"/>
                  </a:lnTo>
                  <a:lnTo>
                    <a:pt x="244" y="869"/>
                  </a:lnTo>
                  <a:lnTo>
                    <a:pt x="245" y="869"/>
                  </a:lnTo>
                  <a:lnTo>
                    <a:pt x="245" y="870"/>
                  </a:lnTo>
                  <a:lnTo>
                    <a:pt x="246" y="870"/>
                  </a:lnTo>
                  <a:lnTo>
                    <a:pt x="247" y="871"/>
                  </a:lnTo>
                  <a:lnTo>
                    <a:pt x="248" y="871"/>
                  </a:lnTo>
                  <a:lnTo>
                    <a:pt x="249" y="871"/>
                  </a:lnTo>
                  <a:lnTo>
                    <a:pt x="249" y="870"/>
                  </a:lnTo>
                  <a:lnTo>
                    <a:pt x="250" y="870"/>
                  </a:lnTo>
                  <a:lnTo>
                    <a:pt x="250" y="869"/>
                  </a:lnTo>
                  <a:lnTo>
                    <a:pt x="251" y="869"/>
                  </a:lnTo>
                  <a:lnTo>
                    <a:pt x="251" y="868"/>
                  </a:lnTo>
                  <a:lnTo>
                    <a:pt x="252" y="867"/>
                  </a:lnTo>
                  <a:lnTo>
                    <a:pt x="253" y="866"/>
                  </a:lnTo>
                  <a:lnTo>
                    <a:pt x="253" y="865"/>
                  </a:lnTo>
                  <a:lnTo>
                    <a:pt x="254" y="865"/>
                  </a:lnTo>
                  <a:lnTo>
                    <a:pt x="254" y="864"/>
                  </a:lnTo>
                  <a:lnTo>
                    <a:pt x="255" y="863"/>
                  </a:lnTo>
                  <a:lnTo>
                    <a:pt x="255" y="862"/>
                  </a:lnTo>
                  <a:lnTo>
                    <a:pt x="256" y="862"/>
                  </a:lnTo>
                  <a:lnTo>
                    <a:pt x="256" y="861"/>
                  </a:lnTo>
                  <a:lnTo>
                    <a:pt x="257" y="860"/>
                  </a:lnTo>
                  <a:lnTo>
                    <a:pt x="257" y="859"/>
                  </a:lnTo>
                  <a:lnTo>
                    <a:pt x="258" y="859"/>
                  </a:lnTo>
                  <a:lnTo>
                    <a:pt x="258" y="858"/>
                  </a:lnTo>
                  <a:lnTo>
                    <a:pt x="259" y="857"/>
                  </a:lnTo>
                  <a:lnTo>
                    <a:pt x="259" y="856"/>
                  </a:lnTo>
                  <a:lnTo>
                    <a:pt x="260" y="856"/>
                  </a:lnTo>
                  <a:lnTo>
                    <a:pt x="260" y="855"/>
                  </a:lnTo>
                  <a:lnTo>
                    <a:pt x="261" y="855"/>
                  </a:lnTo>
                  <a:lnTo>
                    <a:pt x="261" y="854"/>
                  </a:lnTo>
                  <a:lnTo>
                    <a:pt x="262" y="854"/>
                  </a:lnTo>
                  <a:lnTo>
                    <a:pt x="263" y="854"/>
                  </a:lnTo>
                  <a:lnTo>
                    <a:pt x="263" y="853"/>
                  </a:lnTo>
                  <a:lnTo>
                    <a:pt x="264" y="853"/>
                  </a:lnTo>
                  <a:lnTo>
                    <a:pt x="265" y="853"/>
                  </a:lnTo>
                  <a:lnTo>
                    <a:pt x="266" y="853"/>
                  </a:lnTo>
                  <a:lnTo>
                    <a:pt x="267" y="853"/>
                  </a:lnTo>
                  <a:lnTo>
                    <a:pt x="268" y="853"/>
                  </a:lnTo>
                  <a:lnTo>
                    <a:pt x="269" y="853"/>
                  </a:lnTo>
                  <a:lnTo>
                    <a:pt x="270" y="854"/>
                  </a:lnTo>
                  <a:lnTo>
                    <a:pt x="271" y="854"/>
                  </a:lnTo>
                  <a:lnTo>
                    <a:pt x="272" y="854"/>
                  </a:lnTo>
                  <a:lnTo>
                    <a:pt x="273" y="854"/>
                  </a:lnTo>
                  <a:lnTo>
                    <a:pt x="274" y="855"/>
                  </a:lnTo>
                  <a:lnTo>
                    <a:pt x="275" y="855"/>
                  </a:lnTo>
                  <a:lnTo>
                    <a:pt x="276" y="855"/>
                  </a:lnTo>
                  <a:lnTo>
                    <a:pt x="277" y="856"/>
                  </a:lnTo>
                  <a:lnTo>
                    <a:pt x="278" y="856"/>
                  </a:lnTo>
                  <a:lnTo>
                    <a:pt x="279" y="856"/>
                  </a:lnTo>
                  <a:lnTo>
                    <a:pt x="280" y="856"/>
                  </a:lnTo>
                  <a:lnTo>
                    <a:pt x="280" y="857"/>
                  </a:lnTo>
                  <a:lnTo>
                    <a:pt x="281" y="857"/>
                  </a:lnTo>
                  <a:lnTo>
                    <a:pt x="282" y="857"/>
                  </a:lnTo>
                  <a:lnTo>
                    <a:pt x="283" y="857"/>
                  </a:lnTo>
                  <a:lnTo>
                    <a:pt x="284" y="857"/>
                  </a:lnTo>
                  <a:lnTo>
                    <a:pt x="285" y="857"/>
                  </a:lnTo>
                  <a:lnTo>
                    <a:pt x="286" y="857"/>
                  </a:lnTo>
                  <a:lnTo>
                    <a:pt x="287" y="857"/>
                  </a:lnTo>
                  <a:lnTo>
                    <a:pt x="288" y="857"/>
                  </a:lnTo>
                  <a:lnTo>
                    <a:pt x="289" y="857"/>
                  </a:lnTo>
                  <a:lnTo>
                    <a:pt x="290" y="857"/>
                  </a:lnTo>
                  <a:lnTo>
                    <a:pt x="290" y="858"/>
                  </a:lnTo>
                  <a:lnTo>
                    <a:pt x="291" y="858"/>
                  </a:lnTo>
                  <a:lnTo>
                    <a:pt x="292" y="858"/>
                  </a:lnTo>
                  <a:lnTo>
                    <a:pt x="293" y="858"/>
                  </a:lnTo>
                  <a:lnTo>
                    <a:pt x="293" y="859"/>
                  </a:lnTo>
                  <a:lnTo>
                    <a:pt x="294" y="859"/>
                  </a:lnTo>
                  <a:lnTo>
                    <a:pt x="295" y="860"/>
                  </a:lnTo>
                  <a:lnTo>
                    <a:pt x="296" y="861"/>
                  </a:lnTo>
                  <a:lnTo>
                    <a:pt x="297" y="862"/>
                  </a:lnTo>
                  <a:lnTo>
                    <a:pt x="298" y="863"/>
                  </a:lnTo>
                  <a:lnTo>
                    <a:pt x="298" y="864"/>
                  </a:lnTo>
                  <a:lnTo>
                    <a:pt x="299" y="864"/>
                  </a:lnTo>
                  <a:lnTo>
                    <a:pt x="299" y="865"/>
                  </a:lnTo>
                  <a:lnTo>
                    <a:pt x="300" y="866"/>
                  </a:lnTo>
                  <a:lnTo>
                    <a:pt x="301" y="867"/>
                  </a:lnTo>
                  <a:lnTo>
                    <a:pt x="301" y="868"/>
                  </a:lnTo>
                  <a:lnTo>
                    <a:pt x="302" y="868"/>
                  </a:lnTo>
                  <a:lnTo>
                    <a:pt x="302" y="869"/>
                  </a:lnTo>
                  <a:lnTo>
                    <a:pt x="303" y="870"/>
                  </a:lnTo>
                  <a:lnTo>
                    <a:pt x="303" y="871"/>
                  </a:lnTo>
                  <a:lnTo>
                    <a:pt x="304" y="871"/>
                  </a:lnTo>
                  <a:lnTo>
                    <a:pt x="304" y="872"/>
                  </a:lnTo>
                  <a:lnTo>
                    <a:pt x="305" y="872"/>
                  </a:lnTo>
                  <a:lnTo>
                    <a:pt x="305" y="873"/>
                  </a:lnTo>
                  <a:lnTo>
                    <a:pt x="306" y="873"/>
                  </a:lnTo>
                  <a:lnTo>
                    <a:pt x="307" y="874"/>
                  </a:lnTo>
                  <a:lnTo>
                    <a:pt x="308" y="874"/>
                  </a:lnTo>
                  <a:lnTo>
                    <a:pt x="309" y="874"/>
                  </a:lnTo>
                  <a:lnTo>
                    <a:pt x="310" y="874"/>
                  </a:lnTo>
                  <a:lnTo>
                    <a:pt x="311" y="873"/>
                  </a:lnTo>
                  <a:lnTo>
                    <a:pt x="312" y="873"/>
                  </a:lnTo>
                  <a:lnTo>
                    <a:pt x="312" y="872"/>
                  </a:lnTo>
                  <a:lnTo>
                    <a:pt x="313" y="872"/>
                  </a:lnTo>
                  <a:lnTo>
                    <a:pt x="313" y="871"/>
                  </a:lnTo>
                  <a:lnTo>
                    <a:pt x="314" y="871"/>
                  </a:lnTo>
                  <a:lnTo>
                    <a:pt x="314" y="870"/>
                  </a:lnTo>
                  <a:lnTo>
                    <a:pt x="315" y="870"/>
                  </a:lnTo>
                  <a:lnTo>
                    <a:pt x="315" y="869"/>
                  </a:lnTo>
                  <a:lnTo>
                    <a:pt x="316" y="868"/>
                  </a:lnTo>
                  <a:lnTo>
                    <a:pt x="317" y="867"/>
                  </a:lnTo>
                  <a:lnTo>
                    <a:pt x="317" y="866"/>
                  </a:lnTo>
                  <a:lnTo>
                    <a:pt x="318" y="866"/>
                  </a:lnTo>
                  <a:lnTo>
                    <a:pt x="318" y="865"/>
                  </a:lnTo>
                  <a:lnTo>
                    <a:pt x="319" y="864"/>
                  </a:lnTo>
                  <a:lnTo>
                    <a:pt x="319" y="863"/>
                  </a:lnTo>
                  <a:lnTo>
                    <a:pt x="319" y="862"/>
                  </a:lnTo>
                  <a:lnTo>
                    <a:pt x="320" y="861"/>
                  </a:lnTo>
                  <a:lnTo>
                    <a:pt x="320" y="860"/>
                  </a:lnTo>
                  <a:lnTo>
                    <a:pt x="321" y="859"/>
                  </a:lnTo>
                  <a:lnTo>
                    <a:pt x="321" y="858"/>
                  </a:lnTo>
                  <a:lnTo>
                    <a:pt x="322" y="858"/>
                  </a:lnTo>
                  <a:lnTo>
                    <a:pt x="322" y="857"/>
                  </a:lnTo>
                  <a:lnTo>
                    <a:pt x="323" y="856"/>
                  </a:lnTo>
                  <a:lnTo>
                    <a:pt x="323" y="855"/>
                  </a:lnTo>
                  <a:lnTo>
                    <a:pt x="324" y="854"/>
                  </a:lnTo>
                  <a:lnTo>
                    <a:pt x="324" y="853"/>
                  </a:lnTo>
                  <a:lnTo>
                    <a:pt x="325" y="852"/>
                  </a:lnTo>
                  <a:lnTo>
                    <a:pt x="326" y="851"/>
                  </a:lnTo>
                  <a:lnTo>
                    <a:pt x="327" y="850"/>
                  </a:lnTo>
                  <a:lnTo>
                    <a:pt x="327" y="849"/>
                  </a:lnTo>
                  <a:lnTo>
                    <a:pt x="328" y="849"/>
                  </a:lnTo>
                  <a:lnTo>
                    <a:pt x="329" y="849"/>
                  </a:lnTo>
                  <a:lnTo>
                    <a:pt x="330" y="849"/>
                  </a:lnTo>
                  <a:lnTo>
                    <a:pt x="331" y="850"/>
                  </a:lnTo>
                  <a:lnTo>
                    <a:pt x="332" y="851"/>
                  </a:lnTo>
                  <a:lnTo>
                    <a:pt x="332" y="852"/>
                  </a:lnTo>
                  <a:lnTo>
                    <a:pt x="333" y="853"/>
                  </a:lnTo>
                  <a:lnTo>
                    <a:pt x="333" y="854"/>
                  </a:lnTo>
                  <a:lnTo>
                    <a:pt x="334" y="855"/>
                  </a:lnTo>
                  <a:lnTo>
                    <a:pt x="334" y="856"/>
                  </a:lnTo>
                  <a:lnTo>
                    <a:pt x="335" y="858"/>
                  </a:lnTo>
                  <a:lnTo>
                    <a:pt x="335" y="859"/>
                  </a:lnTo>
                  <a:lnTo>
                    <a:pt x="336" y="860"/>
                  </a:lnTo>
                  <a:lnTo>
                    <a:pt x="336" y="862"/>
                  </a:lnTo>
                  <a:lnTo>
                    <a:pt x="336" y="863"/>
                  </a:lnTo>
                  <a:lnTo>
                    <a:pt x="337" y="865"/>
                  </a:lnTo>
                  <a:lnTo>
                    <a:pt x="337" y="866"/>
                  </a:lnTo>
                  <a:lnTo>
                    <a:pt x="338" y="867"/>
                  </a:lnTo>
                  <a:lnTo>
                    <a:pt x="338" y="869"/>
                  </a:lnTo>
                  <a:lnTo>
                    <a:pt x="339" y="870"/>
                  </a:lnTo>
                  <a:lnTo>
                    <a:pt x="339" y="871"/>
                  </a:lnTo>
                  <a:lnTo>
                    <a:pt x="340" y="873"/>
                  </a:lnTo>
                  <a:lnTo>
                    <a:pt x="340" y="874"/>
                  </a:lnTo>
                  <a:lnTo>
                    <a:pt x="341" y="875"/>
                  </a:lnTo>
                  <a:lnTo>
                    <a:pt x="341" y="876"/>
                  </a:lnTo>
                  <a:lnTo>
                    <a:pt x="342" y="877"/>
                  </a:lnTo>
                  <a:lnTo>
                    <a:pt x="342" y="878"/>
                  </a:lnTo>
                  <a:lnTo>
                    <a:pt x="343" y="878"/>
                  </a:lnTo>
                  <a:lnTo>
                    <a:pt x="343" y="879"/>
                  </a:lnTo>
                  <a:lnTo>
                    <a:pt x="344" y="879"/>
                  </a:lnTo>
                  <a:lnTo>
                    <a:pt x="345" y="879"/>
                  </a:lnTo>
                  <a:lnTo>
                    <a:pt x="346" y="879"/>
                  </a:lnTo>
                  <a:lnTo>
                    <a:pt x="346" y="878"/>
                  </a:lnTo>
                  <a:lnTo>
                    <a:pt x="347" y="878"/>
                  </a:lnTo>
                  <a:lnTo>
                    <a:pt x="348" y="877"/>
                  </a:lnTo>
                  <a:lnTo>
                    <a:pt x="349" y="876"/>
                  </a:lnTo>
                  <a:lnTo>
                    <a:pt x="349" y="875"/>
                  </a:lnTo>
                  <a:lnTo>
                    <a:pt x="350" y="875"/>
                  </a:lnTo>
                  <a:lnTo>
                    <a:pt x="350" y="874"/>
                  </a:lnTo>
                  <a:lnTo>
                    <a:pt x="351" y="873"/>
                  </a:lnTo>
                  <a:lnTo>
                    <a:pt x="352" y="872"/>
                  </a:lnTo>
                  <a:lnTo>
                    <a:pt x="352" y="871"/>
                  </a:lnTo>
                  <a:lnTo>
                    <a:pt x="353" y="870"/>
                  </a:lnTo>
                  <a:lnTo>
                    <a:pt x="353" y="869"/>
                  </a:lnTo>
                  <a:lnTo>
                    <a:pt x="354" y="868"/>
                  </a:lnTo>
                  <a:lnTo>
                    <a:pt x="355" y="867"/>
                  </a:lnTo>
                  <a:lnTo>
                    <a:pt x="356" y="866"/>
                  </a:lnTo>
                  <a:lnTo>
                    <a:pt x="357" y="866"/>
                  </a:lnTo>
                  <a:lnTo>
                    <a:pt x="357" y="865"/>
                  </a:lnTo>
                  <a:lnTo>
                    <a:pt x="358" y="865"/>
                  </a:lnTo>
                  <a:lnTo>
                    <a:pt x="359" y="865"/>
                  </a:lnTo>
                  <a:lnTo>
                    <a:pt x="360" y="865"/>
                  </a:lnTo>
                  <a:lnTo>
                    <a:pt x="360" y="864"/>
                  </a:lnTo>
                  <a:lnTo>
                    <a:pt x="361" y="864"/>
                  </a:lnTo>
                  <a:lnTo>
                    <a:pt x="362" y="864"/>
                  </a:lnTo>
                  <a:lnTo>
                    <a:pt x="362" y="865"/>
                  </a:lnTo>
                  <a:lnTo>
                    <a:pt x="363" y="865"/>
                  </a:lnTo>
                  <a:lnTo>
                    <a:pt x="364" y="865"/>
                  </a:lnTo>
                  <a:lnTo>
                    <a:pt x="365" y="865"/>
                  </a:lnTo>
                  <a:lnTo>
                    <a:pt x="365" y="866"/>
                  </a:lnTo>
                  <a:lnTo>
                    <a:pt x="366" y="866"/>
                  </a:lnTo>
                  <a:lnTo>
                    <a:pt x="367" y="867"/>
                  </a:lnTo>
                  <a:lnTo>
                    <a:pt x="368" y="867"/>
                  </a:lnTo>
                  <a:lnTo>
                    <a:pt x="368" y="868"/>
                  </a:lnTo>
                  <a:lnTo>
                    <a:pt x="369" y="868"/>
                  </a:lnTo>
                  <a:lnTo>
                    <a:pt x="370" y="869"/>
                  </a:lnTo>
                  <a:lnTo>
                    <a:pt x="371" y="870"/>
                  </a:lnTo>
                  <a:lnTo>
                    <a:pt x="372" y="870"/>
                  </a:lnTo>
                  <a:lnTo>
                    <a:pt x="372" y="871"/>
                  </a:lnTo>
                  <a:lnTo>
                    <a:pt x="373" y="871"/>
                  </a:lnTo>
                  <a:lnTo>
                    <a:pt x="374" y="871"/>
                  </a:lnTo>
                  <a:lnTo>
                    <a:pt x="375" y="872"/>
                  </a:lnTo>
                  <a:lnTo>
                    <a:pt x="376" y="872"/>
                  </a:lnTo>
                  <a:lnTo>
                    <a:pt x="377" y="871"/>
                  </a:lnTo>
                  <a:lnTo>
                    <a:pt x="378" y="871"/>
                  </a:lnTo>
                  <a:lnTo>
                    <a:pt x="379" y="870"/>
                  </a:lnTo>
                  <a:lnTo>
                    <a:pt x="379" y="869"/>
                  </a:lnTo>
                  <a:lnTo>
                    <a:pt x="380" y="868"/>
                  </a:lnTo>
                  <a:lnTo>
                    <a:pt x="380" y="867"/>
                  </a:lnTo>
                  <a:lnTo>
                    <a:pt x="381" y="867"/>
                  </a:lnTo>
                  <a:lnTo>
                    <a:pt x="381" y="866"/>
                  </a:lnTo>
                  <a:lnTo>
                    <a:pt x="382" y="865"/>
                  </a:lnTo>
                  <a:lnTo>
                    <a:pt x="382" y="864"/>
                  </a:lnTo>
                  <a:lnTo>
                    <a:pt x="383" y="863"/>
                  </a:lnTo>
                  <a:lnTo>
                    <a:pt x="383" y="862"/>
                  </a:lnTo>
                  <a:lnTo>
                    <a:pt x="384" y="861"/>
                  </a:lnTo>
                  <a:lnTo>
                    <a:pt x="385" y="860"/>
                  </a:lnTo>
                  <a:lnTo>
                    <a:pt x="385" y="859"/>
                  </a:lnTo>
                  <a:lnTo>
                    <a:pt x="386" y="858"/>
                  </a:lnTo>
                  <a:lnTo>
                    <a:pt x="386" y="857"/>
                  </a:lnTo>
                  <a:lnTo>
                    <a:pt x="387" y="857"/>
                  </a:lnTo>
                  <a:lnTo>
                    <a:pt x="387" y="856"/>
                  </a:lnTo>
                  <a:lnTo>
                    <a:pt x="388" y="855"/>
                  </a:lnTo>
                  <a:lnTo>
                    <a:pt x="389" y="854"/>
                  </a:lnTo>
                  <a:lnTo>
                    <a:pt x="390" y="854"/>
                  </a:lnTo>
                  <a:lnTo>
                    <a:pt x="391" y="855"/>
                  </a:lnTo>
                  <a:lnTo>
                    <a:pt x="392" y="855"/>
                  </a:lnTo>
                  <a:lnTo>
                    <a:pt x="392" y="856"/>
                  </a:lnTo>
                  <a:lnTo>
                    <a:pt x="393" y="857"/>
                  </a:lnTo>
                  <a:lnTo>
                    <a:pt x="394" y="858"/>
                  </a:lnTo>
                  <a:lnTo>
                    <a:pt x="394" y="859"/>
                  </a:lnTo>
                  <a:lnTo>
                    <a:pt x="395" y="860"/>
                  </a:lnTo>
                  <a:lnTo>
                    <a:pt x="396" y="861"/>
                  </a:lnTo>
                  <a:lnTo>
                    <a:pt x="396" y="862"/>
                  </a:lnTo>
                  <a:lnTo>
                    <a:pt x="396" y="863"/>
                  </a:lnTo>
                  <a:lnTo>
                    <a:pt x="397" y="863"/>
                  </a:lnTo>
                  <a:lnTo>
                    <a:pt x="397" y="864"/>
                  </a:lnTo>
                  <a:lnTo>
                    <a:pt x="398" y="865"/>
                  </a:lnTo>
                  <a:lnTo>
                    <a:pt x="399" y="866"/>
                  </a:lnTo>
                  <a:lnTo>
                    <a:pt x="399" y="867"/>
                  </a:lnTo>
                  <a:lnTo>
                    <a:pt x="400" y="867"/>
                  </a:lnTo>
                  <a:lnTo>
                    <a:pt x="401" y="868"/>
                  </a:lnTo>
                  <a:lnTo>
                    <a:pt x="402" y="868"/>
                  </a:lnTo>
                  <a:lnTo>
                    <a:pt x="402" y="867"/>
                  </a:lnTo>
                  <a:lnTo>
                    <a:pt x="403" y="867"/>
                  </a:lnTo>
                  <a:lnTo>
                    <a:pt x="403" y="866"/>
                  </a:lnTo>
                  <a:lnTo>
                    <a:pt x="404" y="866"/>
                  </a:lnTo>
                  <a:lnTo>
                    <a:pt x="404" y="865"/>
                  </a:lnTo>
                  <a:lnTo>
                    <a:pt x="404" y="864"/>
                  </a:lnTo>
                  <a:lnTo>
                    <a:pt x="405" y="863"/>
                  </a:lnTo>
                  <a:lnTo>
                    <a:pt x="405" y="862"/>
                  </a:lnTo>
                  <a:lnTo>
                    <a:pt x="406" y="861"/>
                  </a:lnTo>
                  <a:lnTo>
                    <a:pt x="406" y="860"/>
                  </a:lnTo>
                  <a:lnTo>
                    <a:pt x="407" y="859"/>
                  </a:lnTo>
                  <a:lnTo>
                    <a:pt x="407" y="858"/>
                  </a:lnTo>
                  <a:lnTo>
                    <a:pt x="408" y="857"/>
                  </a:lnTo>
                  <a:lnTo>
                    <a:pt x="408" y="855"/>
                  </a:lnTo>
                  <a:lnTo>
                    <a:pt x="409" y="854"/>
                  </a:lnTo>
                  <a:lnTo>
                    <a:pt x="409" y="853"/>
                  </a:lnTo>
                  <a:lnTo>
                    <a:pt x="410" y="852"/>
                  </a:lnTo>
                  <a:lnTo>
                    <a:pt x="410" y="851"/>
                  </a:lnTo>
                  <a:lnTo>
                    <a:pt x="411" y="849"/>
                  </a:lnTo>
                  <a:lnTo>
                    <a:pt x="411" y="848"/>
                  </a:lnTo>
                  <a:lnTo>
                    <a:pt x="412" y="847"/>
                  </a:lnTo>
                  <a:lnTo>
                    <a:pt x="412" y="846"/>
                  </a:lnTo>
                  <a:lnTo>
                    <a:pt x="413" y="845"/>
                  </a:lnTo>
                  <a:lnTo>
                    <a:pt x="413" y="844"/>
                  </a:lnTo>
                  <a:lnTo>
                    <a:pt x="413" y="843"/>
                  </a:lnTo>
                  <a:lnTo>
                    <a:pt x="414" y="843"/>
                  </a:lnTo>
                  <a:lnTo>
                    <a:pt x="415" y="842"/>
                  </a:lnTo>
                  <a:lnTo>
                    <a:pt x="416" y="842"/>
                  </a:lnTo>
                  <a:lnTo>
                    <a:pt x="417" y="842"/>
                  </a:lnTo>
                  <a:lnTo>
                    <a:pt x="418" y="842"/>
                  </a:lnTo>
                  <a:lnTo>
                    <a:pt x="419" y="842"/>
                  </a:lnTo>
                  <a:lnTo>
                    <a:pt x="420" y="842"/>
                  </a:lnTo>
                  <a:lnTo>
                    <a:pt x="421" y="843"/>
                  </a:lnTo>
                  <a:lnTo>
                    <a:pt x="422" y="843"/>
                  </a:lnTo>
                  <a:lnTo>
                    <a:pt x="422" y="844"/>
                  </a:lnTo>
                  <a:lnTo>
                    <a:pt x="423" y="844"/>
                  </a:lnTo>
                  <a:lnTo>
                    <a:pt x="424" y="844"/>
                  </a:lnTo>
                  <a:lnTo>
                    <a:pt x="424" y="845"/>
                  </a:lnTo>
                  <a:lnTo>
                    <a:pt x="425" y="845"/>
                  </a:lnTo>
                  <a:lnTo>
                    <a:pt x="426" y="845"/>
                  </a:lnTo>
                  <a:lnTo>
                    <a:pt x="427" y="845"/>
                  </a:lnTo>
                  <a:lnTo>
                    <a:pt x="428" y="845"/>
                  </a:lnTo>
                  <a:lnTo>
                    <a:pt x="428" y="844"/>
                  </a:lnTo>
                  <a:lnTo>
                    <a:pt x="429" y="844"/>
                  </a:lnTo>
                  <a:lnTo>
                    <a:pt x="430" y="844"/>
                  </a:lnTo>
                  <a:lnTo>
                    <a:pt x="431" y="844"/>
                  </a:lnTo>
                  <a:lnTo>
                    <a:pt x="432" y="844"/>
                  </a:lnTo>
                  <a:lnTo>
                    <a:pt x="433" y="844"/>
                  </a:lnTo>
                  <a:lnTo>
                    <a:pt x="434" y="844"/>
                  </a:lnTo>
                  <a:lnTo>
                    <a:pt x="435" y="844"/>
                  </a:lnTo>
                  <a:lnTo>
                    <a:pt x="435" y="845"/>
                  </a:lnTo>
                  <a:lnTo>
                    <a:pt x="436" y="845"/>
                  </a:lnTo>
                  <a:lnTo>
                    <a:pt x="437" y="846"/>
                  </a:lnTo>
                  <a:lnTo>
                    <a:pt x="437" y="847"/>
                  </a:lnTo>
                  <a:lnTo>
                    <a:pt x="438" y="847"/>
                  </a:lnTo>
                  <a:lnTo>
                    <a:pt x="438" y="848"/>
                  </a:lnTo>
                  <a:lnTo>
                    <a:pt x="439" y="850"/>
                  </a:lnTo>
                  <a:lnTo>
                    <a:pt x="439" y="851"/>
                  </a:lnTo>
                  <a:lnTo>
                    <a:pt x="439" y="852"/>
                  </a:lnTo>
                  <a:lnTo>
                    <a:pt x="440" y="853"/>
                  </a:lnTo>
                  <a:lnTo>
                    <a:pt x="440" y="854"/>
                  </a:lnTo>
                  <a:lnTo>
                    <a:pt x="441" y="856"/>
                  </a:lnTo>
                  <a:lnTo>
                    <a:pt x="441" y="857"/>
                  </a:lnTo>
                  <a:lnTo>
                    <a:pt x="442" y="858"/>
                  </a:lnTo>
                  <a:lnTo>
                    <a:pt x="442" y="860"/>
                  </a:lnTo>
                  <a:lnTo>
                    <a:pt x="443" y="861"/>
                  </a:lnTo>
                  <a:lnTo>
                    <a:pt x="443" y="862"/>
                  </a:lnTo>
                  <a:lnTo>
                    <a:pt x="444" y="864"/>
                  </a:lnTo>
                  <a:lnTo>
                    <a:pt x="444" y="865"/>
                  </a:lnTo>
                  <a:lnTo>
                    <a:pt x="445" y="866"/>
                  </a:lnTo>
                  <a:lnTo>
                    <a:pt x="445" y="867"/>
                  </a:lnTo>
                  <a:lnTo>
                    <a:pt x="446" y="868"/>
                  </a:lnTo>
                  <a:lnTo>
                    <a:pt x="446" y="869"/>
                  </a:lnTo>
                  <a:lnTo>
                    <a:pt x="447" y="870"/>
                  </a:lnTo>
                  <a:lnTo>
                    <a:pt x="447" y="871"/>
                  </a:lnTo>
                  <a:lnTo>
                    <a:pt x="447" y="872"/>
                  </a:lnTo>
                  <a:lnTo>
                    <a:pt x="448" y="873"/>
                  </a:lnTo>
                  <a:lnTo>
                    <a:pt x="449" y="874"/>
                  </a:lnTo>
                  <a:lnTo>
                    <a:pt x="450" y="874"/>
                  </a:lnTo>
                  <a:lnTo>
                    <a:pt x="451" y="874"/>
                  </a:lnTo>
                  <a:lnTo>
                    <a:pt x="451" y="873"/>
                  </a:lnTo>
                  <a:lnTo>
                    <a:pt x="452" y="873"/>
                  </a:lnTo>
                  <a:lnTo>
                    <a:pt x="453" y="872"/>
                  </a:lnTo>
                  <a:lnTo>
                    <a:pt x="454" y="871"/>
                  </a:lnTo>
                  <a:lnTo>
                    <a:pt x="454" y="870"/>
                  </a:lnTo>
                  <a:lnTo>
                    <a:pt x="455" y="870"/>
                  </a:lnTo>
                  <a:lnTo>
                    <a:pt x="455" y="869"/>
                  </a:lnTo>
                  <a:lnTo>
                    <a:pt x="456" y="868"/>
                  </a:lnTo>
                  <a:lnTo>
                    <a:pt x="456" y="867"/>
                  </a:lnTo>
                  <a:lnTo>
                    <a:pt x="457" y="866"/>
                  </a:lnTo>
                  <a:lnTo>
                    <a:pt x="457" y="865"/>
                  </a:lnTo>
                  <a:lnTo>
                    <a:pt x="458" y="865"/>
                  </a:lnTo>
                  <a:lnTo>
                    <a:pt x="458" y="864"/>
                  </a:lnTo>
                  <a:lnTo>
                    <a:pt x="459" y="863"/>
                  </a:lnTo>
                  <a:lnTo>
                    <a:pt x="460" y="862"/>
                  </a:lnTo>
                  <a:lnTo>
                    <a:pt x="461" y="862"/>
                  </a:lnTo>
                  <a:lnTo>
                    <a:pt x="462" y="861"/>
                  </a:lnTo>
                  <a:lnTo>
                    <a:pt x="463" y="862"/>
                  </a:lnTo>
                  <a:lnTo>
                    <a:pt x="464" y="862"/>
                  </a:lnTo>
                  <a:lnTo>
                    <a:pt x="464" y="863"/>
                  </a:lnTo>
                  <a:lnTo>
                    <a:pt x="465" y="863"/>
                  </a:lnTo>
                  <a:lnTo>
                    <a:pt x="465" y="864"/>
                  </a:lnTo>
                  <a:lnTo>
                    <a:pt x="466" y="864"/>
                  </a:lnTo>
                  <a:lnTo>
                    <a:pt x="466" y="865"/>
                  </a:lnTo>
                  <a:lnTo>
                    <a:pt x="467" y="865"/>
                  </a:lnTo>
                  <a:lnTo>
                    <a:pt x="467" y="866"/>
                  </a:lnTo>
                  <a:lnTo>
                    <a:pt x="468" y="867"/>
                  </a:lnTo>
                  <a:lnTo>
                    <a:pt x="469" y="868"/>
                  </a:lnTo>
                  <a:lnTo>
                    <a:pt x="469" y="869"/>
                  </a:lnTo>
                  <a:lnTo>
                    <a:pt x="470" y="870"/>
                  </a:lnTo>
                  <a:lnTo>
                    <a:pt x="470" y="871"/>
                  </a:lnTo>
                  <a:lnTo>
                    <a:pt x="471" y="872"/>
                  </a:lnTo>
                  <a:lnTo>
                    <a:pt x="471" y="873"/>
                  </a:lnTo>
                  <a:lnTo>
                    <a:pt x="472" y="873"/>
                  </a:lnTo>
                  <a:lnTo>
                    <a:pt x="472" y="874"/>
                  </a:lnTo>
                  <a:lnTo>
                    <a:pt x="473" y="875"/>
                  </a:lnTo>
                  <a:lnTo>
                    <a:pt x="473" y="876"/>
                  </a:lnTo>
                  <a:lnTo>
                    <a:pt x="473" y="877"/>
                  </a:lnTo>
                  <a:lnTo>
                    <a:pt x="474" y="878"/>
                  </a:lnTo>
                  <a:lnTo>
                    <a:pt x="474" y="879"/>
                  </a:lnTo>
                  <a:lnTo>
                    <a:pt x="475" y="880"/>
                  </a:lnTo>
                  <a:lnTo>
                    <a:pt x="475" y="881"/>
                  </a:lnTo>
                  <a:lnTo>
                    <a:pt x="476" y="881"/>
                  </a:lnTo>
                  <a:lnTo>
                    <a:pt x="476" y="882"/>
                  </a:lnTo>
                  <a:lnTo>
                    <a:pt x="477" y="883"/>
                  </a:lnTo>
                  <a:lnTo>
                    <a:pt x="477" y="884"/>
                  </a:lnTo>
                  <a:lnTo>
                    <a:pt x="478" y="885"/>
                  </a:lnTo>
                  <a:lnTo>
                    <a:pt x="479" y="886"/>
                  </a:lnTo>
                  <a:lnTo>
                    <a:pt x="479" y="887"/>
                  </a:lnTo>
                  <a:lnTo>
                    <a:pt x="480" y="888"/>
                  </a:lnTo>
                  <a:lnTo>
                    <a:pt x="481" y="889"/>
                  </a:lnTo>
                  <a:lnTo>
                    <a:pt x="481" y="890"/>
                  </a:lnTo>
                  <a:lnTo>
                    <a:pt x="482" y="890"/>
                  </a:lnTo>
                  <a:lnTo>
                    <a:pt x="482" y="891"/>
                  </a:lnTo>
                  <a:lnTo>
                    <a:pt x="483" y="891"/>
                  </a:lnTo>
                  <a:lnTo>
                    <a:pt x="484" y="892"/>
                  </a:lnTo>
                  <a:lnTo>
                    <a:pt x="485" y="892"/>
                  </a:lnTo>
                  <a:lnTo>
                    <a:pt x="486" y="892"/>
                  </a:lnTo>
                  <a:lnTo>
                    <a:pt x="487" y="892"/>
                  </a:lnTo>
                  <a:lnTo>
                    <a:pt x="488" y="891"/>
                  </a:lnTo>
                  <a:lnTo>
                    <a:pt x="489" y="891"/>
                  </a:lnTo>
                  <a:lnTo>
                    <a:pt x="490" y="890"/>
                  </a:lnTo>
                  <a:lnTo>
                    <a:pt x="491" y="889"/>
                  </a:lnTo>
                  <a:lnTo>
                    <a:pt x="492" y="888"/>
                  </a:lnTo>
                  <a:lnTo>
                    <a:pt x="493" y="888"/>
                  </a:lnTo>
                  <a:lnTo>
                    <a:pt x="493" y="887"/>
                  </a:lnTo>
                  <a:lnTo>
                    <a:pt x="494" y="887"/>
                  </a:lnTo>
                  <a:lnTo>
                    <a:pt x="495" y="887"/>
                  </a:lnTo>
                  <a:lnTo>
                    <a:pt x="495" y="886"/>
                  </a:lnTo>
                  <a:lnTo>
                    <a:pt x="496" y="886"/>
                  </a:lnTo>
                  <a:lnTo>
                    <a:pt x="497" y="886"/>
                  </a:lnTo>
                  <a:lnTo>
                    <a:pt x="498" y="886"/>
                  </a:lnTo>
                  <a:lnTo>
                    <a:pt x="499" y="886"/>
                  </a:lnTo>
                  <a:lnTo>
                    <a:pt x="500" y="886"/>
                  </a:lnTo>
                  <a:lnTo>
                    <a:pt x="501" y="887"/>
                  </a:lnTo>
                  <a:lnTo>
                    <a:pt x="502" y="887"/>
                  </a:lnTo>
                  <a:lnTo>
                    <a:pt x="503" y="887"/>
                  </a:lnTo>
                  <a:lnTo>
                    <a:pt x="503" y="888"/>
                  </a:lnTo>
                  <a:lnTo>
                    <a:pt x="504" y="888"/>
                  </a:lnTo>
                  <a:lnTo>
                    <a:pt x="505" y="888"/>
                  </a:lnTo>
                  <a:lnTo>
                    <a:pt x="506" y="889"/>
                  </a:lnTo>
                  <a:lnTo>
                    <a:pt x="507" y="889"/>
                  </a:lnTo>
                  <a:lnTo>
                    <a:pt x="508" y="889"/>
                  </a:lnTo>
                  <a:lnTo>
                    <a:pt x="509" y="889"/>
                  </a:lnTo>
                  <a:lnTo>
                    <a:pt x="509" y="888"/>
                  </a:lnTo>
                  <a:lnTo>
                    <a:pt x="510" y="888"/>
                  </a:lnTo>
                  <a:lnTo>
                    <a:pt x="511" y="888"/>
                  </a:lnTo>
                  <a:lnTo>
                    <a:pt x="511" y="887"/>
                  </a:lnTo>
                  <a:lnTo>
                    <a:pt x="512" y="887"/>
                  </a:lnTo>
                  <a:lnTo>
                    <a:pt x="513" y="886"/>
                  </a:lnTo>
                  <a:lnTo>
                    <a:pt x="514" y="886"/>
                  </a:lnTo>
                  <a:lnTo>
                    <a:pt x="514" y="885"/>
                  </a:lnTo>
                  <a:lnTo>
                    <a:pt x="515" y="885"/>
                  </a:lnTo>
                  <a:lnTo>
                    <a:pt x="515" y="884"/>
                  </a:lnTo>
                  <a:lnTo>
                    <a:pt x="516" y="884"/>
                  </a:lnTo>
                  <a:lnTo>
                    <a:pt x="516" y="883"/>
                  </a:lnTo>
                  <a:lnTo>
                    <a:pt x="517" y="883"/>
                  </a:lnTo>
                  <a:lnTo>
                    <a:pt x="518" y="882"/>
                  </a:lnTo>
                  <a:lnTo>
                    <a:pt x="519" y="882"/>
                  </a:lnTo>
                  <a:lnTo>
                    <a:pt x="520" y="881"/>
                  </a:lnTo>
                  <a:lnTo>
                    <a:pt x="521" y="881"/>
                  </a:lnTo>
                  <a:lnTo>
                    <a:pt x="522" y="881"/>
                  </a:lnTo>
                  <a:lnTo>
                    <a:pt x="523" y="881"/>
                  </a:lnTo>
                  <a:lnTo>
                    <a:pt x="524" y="881"/>
                  </a:lnTo>
                  <a:lnTo>
                    <a:pt x="525" y="881"/>
                  </a:lnTo>
                  <a:lnTo>
                    <a:pt x="526" y="881"/>
                  </a:lnTo>
                  <a:lnTo>
                    <a:pt x="527" y="881"/>
                  </a:lnTo>
                  <a:lnTo>
                    <a:pt x="528" y="881"/>
                  </a:lnTo>
                  <a:lnTo>
                    <a:pt x="529" y="881"/>
                  </a:lnTo>
                  <a:lnTo>
                    <a:pt x="530" y="881"/>
                  </a:lnTo>
                  <a:lnTo>
                    <a:pt x="531" y="881"/>
                  </a:lnTo>
                  <a:lnTo>
                    <a:pt x="532" y="881"/>
                  </a:lnTo>
                  <a:lnTo>
                    <a:pt x="533" y="881"/>
                  </a:lnTo>
                  <a:lnTo>
                    <a:pt x="534" y="880"/>
                  </a:lnTo>
                  <a:lnTo>
                    <a:pt x="535" y="880"/>
                  </a:lnTo>
                  <a:lnTo>
                    <a:pt x="536" y="879"/>
                  </a:lnTo>
                  <a:lnTo>
                    <a:pt x="537" y="879"/>
                  </a:lnTo>
                  <a:lnTo>
                    <a:pt x="538" y="878"/>
                  </a:lnTo>
                  <a:lnTo>
                    <a:pt x="539" y="878"/>
                  </a:lnTo>
                  <a:lnTo>
                    <a:pt x="539" y="877"/>
                  </a:lnTo>
                  <a:lnTo>
                    <a:pt x="540" y="877"/>
                  </a:lnTo>
                  <a:lnTo>
                    <a:pt x="540" y="876"/>
                  </a:lnTo>
                  <a:lnTo>
                    <a:pt x="541" y="876"/>
                  </a:lnTo>
                  <a:lnTo>
                    <a:pt x="541" y="875"/>
                  </a:lnTo>
                  <a:lnTo>
                    <a:pt x="542" y="875"/>
                  </a:lnTo>
                  <a:lnTo>
                    <a:pt x="543" y="874"/>
                  </a:lnTo>
                  <a:lnTo>
                    <a:pt x="544" y="873"/>
                  </a:lnTo>
                  <a:lnTo>
                    <a:pt x="545" y="873"/>
                  </a:lnTo>
                  <a:lnTo>
                    <a:pt x="545" y="872"/>
                  </a:lnTo>
                  <a:lnTo>
                    <a:pt x="546" y="872"/>
                  </a:lnTo>
                  <a:lnTo>
                    <a:pt x="547" y="871"/>
                  </a:lnTo>
                  <a:lnTo>
                    <a:pt x="548" y="871"/>
                  </a:lnTo>
                  <a:lnTo>
                    <a:pt x="548" y="870"/>
                  </a:lnTo>
                  <a:lnTo>
                    <a:pt x="549" y="870"/>
                  </a:lnTo>
                  <a:lnTo>
                    <a:pt x="550" y="870"/>
                  </a:lnTo>
                  <a:lnTo>
                    <a:pt x="550" y="869"/>
                  </a:lnTo>
                  <a:lnTo>
                    <a:pt x="551" y="869"/>
                  </a:lnTo>
                  <a:lnTo>
                    <a:pt x="552" y="868"/>
                  </a:lnTo>
                  <a:lnTo>
                    <a:pt x="553" y="868"/>
                  </a:lnTo>
                  <a:lnTo>
                    <a:pt x="554" y="868"/>
                  </a:lnTo>
                  <a:lnTo>
                    <a:pt x="555" y="868"/>
                  </a:lnTo>
                  <a:lnTo>
                    <a:pt x="556" y="868"/>
                  </a:lnTo>
                  <a:lnTo>
                    <a:pt x="557" y="868"/>
                  </a:lnTo>
                  <a:lnTo>
                    <a:pt x="558" y="868"/>
                  </a:lnTo>
                  <a:lnTo>
                    <a:pt x="559" y="868"/>
                  </a:lnTo>
                  <a:lnTo>
                    <a:pt x="560" y="868"/>
                  </a:lnTo>
                  <a:lnTo>
                    <a:pt x="560" y="869"/>
                  </a:lnTo>
                  <a:lnTo>
                    <a:pt x="561" y="869"/>
                  </a:lnTo>
                  <a:lnTo>
                    <a:pt x="562" y="869"/>
                  </a:lnTo>
                  <a:lnTo>
                    <a:pt x="563" y="869"/>
                  </a:lnTo>
                  <a:lnTo>
                    <a:pt x="563" y="870"/>
                  </a:lnTo>
                  <a:lnTo>
                    <a:pt x="564" y="870"/>
                  </a:lnTo>
                  <a:lnTo>
                    <a:pt x="565" y="870"/>
                  </a:lnTo>
                  <a:lnTo>
                    <a:pt x="566" y="870"/>
                  </a:lnTo>
                  <a:lnTo>
                    <a:pt x="567" y="871"/>
                  </a:lnTo>
                  <a:lnTo>
                    <a:pt x="568" y="871"/>
                  </a:lnTo>
                  <a:lnTo>
                    <a:pt x="569" y="871"/>
                  </a:lnTo>
                  <a:lnTo>
                    <a:pt x="570" y="871"/>
                  </a:lnTo>
                  <a:lnTo>
                    <a:pt x="571" y="871"/>
                  </a:lnTo>
                  <a:lnTo>
                    <a:pt x="572" y="871"/>
                  </a:lnTo>
                  <a:lnTo>
                    <a:pt x="573" y="871"/>
                  </a:lnTo>
                  <a:lnTo>
                    <a:pt x="574" y="871"/>
                  </a:lnTo>
                  <a:lnTo>
                    <a:pt x="575" y="871"/>
                  </a:lnTo>
                  <a:lnTo>
                    <a:pt x="576" y="871"/>
                  </a:lnTo>
                  <a:lnTo>
                    <a:pt x="577" y="870"/>
                  </a:lnTo>
                  <a:lnTo>
                    <a:pt x="578" y="870"/>
                  </a:lnTo>
                  <a:lnTo>
                    <a:pt x="579" y="869"/>
                  </a:lnTo>
                  <a:lnTo>
                    <a:pt x="580" y="869"/>
                  </a:lnTo>
                  <a:lnTo>
                    <a:pt x="580" y="868"/>
                  </a:lnTo>
                  <a:lnTo>
                    <a:pt x="581" y="868"/>
                  </a:lnTo>
                  <a:lnTo>
                    <a:pt x="581" y="867"/>
                  </a:lnTo>
                  <a:lnTo>
                    <a:pt x="582" y="867"/>
                  </a:lnTo>
                  <a:lnTo>
                    <a:pt x="582" y="866"/>
                  </a:lnTo>
                  <a:lnTo>
                    <a:pt x="583" y="866"/>
                  </a:lnTo>
                  <a:lnTo>
                    <a:pt x="584" y="865"/>
                  </a:lnTo>
                  <a:lnTo>
                    <a:pt x="584" y="864"/>
                  </a:lnTo>
                  <a:lnTo>
                    <a:pt x="585" y="864"/>
                  </a:lnTo>
                  <a:lnTo>
                    <a:pt x="585" y="863"/>
                  </a:lnTo>
                  <a:lnTo>
                    <a:pt x="586" y="863"/>
                  </a:lnTo>
                  <a:lnTo>
                    <a:pt x="587" y="862"/>
                  </a:lnTo>
                  <a:lnTo>
                    <a:pt x="588" y="861"/>
                  </a:lnTo>
                  <a:lnTo>
                    <a:pt x="589" y="861"/>
                  </a:lnTo>
                  <a:lnTo>
                    <a:pt x="590" y="860"/>
                  </a:lnTo>
                  <a:lnTo>
                    <a:pt x="591" y="860"/>
                  </a:lnTo>
                  <a:lnTo>
                    <a:pt x="592" y="860"/>
                  </a:lnTo>
                  <a:lnTo>
                    <a:pt x="593" y="860"/>
                  </a:lnTo>
                  <a:lnTo>
                    <a:pt x="593" y="861"/>
                  </a:lnTo>
                  <a:lnTo>
                    <a:pt x="594" y="861"/>
                  </a:lnTo>
                  <a:lnTo>
                    <a:pt x="595" y="861"/>
                  </a:lnTo>
                  <a:lnTo>
                    <a:pt x="595" y="862"/>
                  </a:lnTo>
                  <a:lnTo>
                    <a:pt x="596" y="862"/>
                  </a:lnTo>
                  <a:lnTo>
                    <a:pt x="597" y="863"/>
                  </a:lnTo>
                  <a:lnTo>
                    <a:pt x="598" y="863"/>
                  </a:lnTo>
                  <a:lnTo>
                    <a:pt x="598" y="864"/>
                  </a:lnTo>
                  <a:lnTo>
                    <a:pt x="599" y="864"/>
                  </a:lnTo>
                  <a:lnTo>
                    <a:pt x="599" y="865"/>
                  </a:lnTo>
                  <a:lnTo>
                    <a:pt x="600" y="865"/>
                  </a:lnTo>
                  <a:lnTo>
                    <a:pt x="600" y="866"/>
                  </a:lnTo>
                  <a:lnTo>
                    <a:pt x="601" y="866"/>
                  </a:lnTo>
                  <a:lnTo>
                    <a:pt x="601" y="867"/>
                  </a:lnTo>
                  <a:lnTo>
                    <a:pt x="602" y="867"/>
                  </a:lnTo>
                  <a:lnTo>
                    <a:pt x="602" y="868"/>
                  </a:lnTo>
                  <a:lnTo>
                    <a:pt x="603" y="868"/>
                  </a:lnTo>
                  <a:lnTo>
                    <a:pt x="604" y="869"/>
                  </a:lnTo>
                  <a:lnTo>
                    <a:pt x="605" y="869"/>
                  </a:lnTo>
                  <a:lnTo>
                    <a:pt x="605" y="870"/>
                  </a:lnTo>
                  <a:lnTo>
                    <a:pt x="606" y="870"/>
                  </a:lnTo>
                  <a:lnTo>
                    <a:pt x="607" y="871"/>
                  </a:lnTo>
                  <a:lnTo>
                    <a:pt x="608" y="871"/>
                  </a:lnTo>
                  <a:lnTo>
                    <a:pt x="609" y="872"/>
                  </a:lnTo>
                  <a:lnTo>
                    <a:pt x="610" y="872"/>
                  </a:lnTo>
                  <a:lnTo>
                    <a:pt x="610" y="873"/>
                  </a:lnTo>
                  <a:lnTo>
                    <a:pt x="611" y="874"/>
                  </a:lnTo>
                  <a:lnTo>
                    <a:pt x="612" y="874"/>
                  </a:lnTo>
                  <a:lnTo>
                    <a:pt x="612" y="875"/>
                  </a:lnTo>
                  <a:lnTo>
                    <a:pt x="613" y="875"/>
                  </a:lnTo>
                  <a:lnTo>
                    <a:pt x="613" y="876"/>
                  </a:lnTo>
                  <a:lnTo>
                    <a:pt x="614" y="876"/>
                  </a:lnTo>
                  <a:lnTo>
                    <a:pt x="614" y="877"/>
                  </a:lnTo>
                  <a:lnTo>
                    <a:pt x="615" y="877"/>
                  </a:lnTo>
                  <a:lnTo>
                    <a:pt x="615" y="878"/>
                  </a:lnTo>
                  <a:lnTo>
                    <a:pt x="616" y="879"/>
                  </a:lnTo>
                  <a:lnTo>
                    <a:pt x="617" y="880"/>
                  </a:lnTo>
                  <a:lnTo>
                    <a:pt x="617" y="881"/>
                  </a:lnTo>
                  <a:lnTo>
                    <a:pt x="618" y="882"/>
                  </a:lnTo>
                  <a:lnTo>
                    <a:pt x="618" y="883"/>
                  </a:lnTo>
                  <a:lnTo>
                    <a:pt x="619" y="884"/>
                  </a:lnTo>
                  <a:lnTo>
                    <a:pt x="620" y="885"/>
                  </a:lnTo>
                  <a:lnTo>
                    <a:pt x="621" y="886"/>
                  </a:lnTo>
                  <a:lnTo>
                    <a:pt x="621" y="887"/>
                  </a:lnTo>
                  <a:lnTo>
                    <a:pt x="622" y="887"/>
                  </a:lnTo>
                  <a:lnTo>
                    <a:pt x="623" y="888"/>
                  </a:lnTo>
                  <a:lnTo>
                    <a:pt x="624" y="888"/>
                  </a:lnTo>
                  <a:lnTo>
                    <a:pt x="624" y="889"/>
                  </a:lnTo>
                  <a:lnTo>
                    <a:pt x="625" y="889"/>
                  </a:lnTo>
                  <a:lnTo>
                    <a:pt x="626" y="889"/>
                  </a:lnTo>
                  <a:lnTo>
                    <a:pt x="627" y="889"/>
                  </a:lnTo>
                  <a:lnTo>
                    <a:pt x="627" y="888"/>
                  </a:lnTo>
                  <a:lnTo>
                    <a:pt x="628" y="887"/>
                  </a:lnTo>
                  <a:lnTo>
                    <a:pt x="629" y="886"/>
                  </a:lnTo>
                  <a:lnTo>
                    <a:pt x="630" y="885"/>
                  </a:lnTo>
                  <a:lnTo>
                    <a:pt x="630" y="884"/>
                  </a:lnTo>
                  <a:lnTo>
                    <a:pt x="631" y="883"/>
                  </a:lnTo>
                  <a:lnTo>
                    <a:pt x="632" y="882"/>
                  </a:lnTo>
                  <a:lnTo>
                    <a:pt x="632" y="881"/>
                  </a:lnTo>
                  <a:lnTo>
                    <a:pt x="633" y="880"/>
                  </a:lnTo>
                  <a:lnTo>
                    <a:pt x="633" y="879"/>
                  </a:lnTo>
                  <a:lnTo>
                    <a:pt x="634" y="879"/>
                  </a:lnTo>
                  <a:lnTo>
                    <a:pt x="634" y="878"/>
                  </a:lnTo>
                  <a:lnTo>
                    <a:pt x="635" y="877"/>
                  </a:lnTo>
                  <a:lnTo>
                    <a:pt x="635" y="876"/>
                  </a:lnTo>
                  <a:lnTo>
                    <a:pt x="635" y="875"/>
                  </a:lnTo>
                  <a:lnTo>
                    <a:pt x="636" y="875"/>
                  </a:lnTo>
                  <a:lnTo>
                    <a:pt x="636" y="874"/>
                  </a:lnTo>
                  <a:lnTo>
                    <a:pt x="637" y="873"/>
                  </a:lnTo>
                  <a:lnTo>
                    <a:pt x="638" y="872"/>
                  </a:lnTo>
                  <a:lnTo>
                    <a:pt x="639" y="871"/>
                  </a:lnTo>
                  <a:lnTo>
                    <a:pt x="640" y="871"/>
                  </a:lnTo>
                  <a:lnTo>
                    <a:pt x="641" y="870"/>
                  </a:lnTo>
                  <a:lnTo>
                    <a:pt x="642" y="870"/>
                  </a:lnTo>
                  <a:lnTo>
                    <a:pt x="643" y="870"/>
                  </a:lnTo>
                  <a:lnTo>
                    <a:pt x="644" y="870"/>
                  </a:lnTo>
                  <a:lnTo>
                    <a:pt x="644" y="871"/>
                  </a:lnTo>
                  <a:lnTo>
                    <a:pt x="645" y="871"/>
                  </a:lnTo>
                  <a:lnTo>
                    <a:pt x="646" y="872"/>
                  </a:lnTo>
                  <a:lnTo>
                    <a:pt x="647" y="872"/>
                  </a:lnTo>
                  <a:lnTo>
                    <a:pt x="647" y="873"/>
                  </a:lnTo>
                  <a:lnTo>
                    <a:pt x="648" y="873"/>
                  </a:lnTo>
                  <a:lnTo>
                    <a:pt x="648" y="874"/>
                  </a:lnTo>
                  <a:lnTo>
                    <a:pt x="649" y="874"/>
                  </a:lnTo>
                  <a:lnTo>
                    <a:pt x="649" y="875"/>
                  </a:lnTo>
                  <a:lnTo>
                    <a:pt x="650" y="875"/>
                  </a:lnTo>
                  <a:lnTo>
                    <a:pt x="650" y="876"/>
                  </a:lnTo>
                  <a:lnTo>
                    <a:pt x="651" y="877"/>
                  </a:lnTo>
                  <a:lnTo>
                    <a:pt x="652" y="878"/>
                  </a:lnTo>
                  <a:lnTo>
                    <a:pt x="653" y="879"/>
                  </a:lnTo>
                  <a:lnTo>
                    <a:pt x="653" y="880"/>
                  </a:lnTo>
                  <a:lnTo>
                    <a:pt x="654" y="881"/>
                  </a:lnTo>
                  <a:lnTo>
                    <a:pt x="654" y="882"/>
                  </a:lnTo>
                  <a:lnTo>
                    <a:pt x="655" y="882"/>
                  </a:lnTo>
                  <a:lnTo>
                    <a:pt x="655" y="883"/>
                  </a:lnTo>
                  <a:lnTo>
                    <a:pt x="656" y="883"/>
                  </a:lnTo>
                  <a:lnTo>
                    <a:pt x="656" y="884"/>
                  </a:lnTo>
                  <a:lnTo>
                    <a:pt x="657" y="884"/>
                  </a:lnTo>
                  <a:lnTo>
                    <a:pt x="657" y="885"/>
                  </a:lnTo>
                  <a:lnTo>
                    <a:pt x="658" y="885"/>
                  </a:lnTo>
                  <a:lnTo>
                    <a:pt x="658" y="886"/>
                  </a:lnTo>
                  <a:lnTo>
                    <a:pt x="659" y="886"/>
                  </a:lnTo>
                  <a:lnTo>
                    <a:pt x="660" y="886"/>
                  </a:lnTo>
                  <a:lnTo>
                    <a:pt x="661" y="886"/>
                  </a:lnTo>
                  <a:lnTo>
                    <a:pt x="662" y="885"/>
                  </a:lnTo>
                  <a:lnTo>
                    <a:pt x="663" y="884"/>
                  </a:lnTo>
                  <a:lnTo>
                    <a:pt x="664" y="883"/>
                  </a:lnTo>
                  <a:lnTo>
                    <a:pt x="664" y="882"/>
                  </a:lnTo>
                  <a:lnTo>
                    <a:pt x="665" y="882"/>
                  </a:lnTo>
                  <a:lnTo>
                    <a:pt x="665" y="881"/>
                  </a:lnTo>
                  <a:lnTo>
                    <a:pt x="666" y="880"/>
                  </a:lnTo>
                  <a:lnTo>
                    <a:pt x="666" y="879"/>
                  </a:lnTo>
                  <a:lnTo>
                    <a:pt x="667" y="878"/>
                  </a:lnTo>
                  <a:lnTo>
                    <a:pt x="667" y="877"/>
                  </a:lnTo>
                  <a:lnTo>
                    <a:pt x="668" y="876"/>
                  </a:lnTo>
                  <a:lnTo>
                    <a:pt x="668" y="875"/>
                  </a:lnTo>
                  <a:lnTo>
                    <a:pt x="669" y="875"/>
                  </a:lnTo>
                  <a:lnTo>
                    <a:pt x="669" y="874"/>
                  </a:lnTo>
                  <a:lnTo>
                    <a:pt x="670" y="873"/>
                  </a:lnTo>
                  <a:lnTo>
                    <a:pt x="670" y="872"/>
                  </a:lnTo>
                  <a:lnTo>
                    <a:pt x="671" y="871"/>
                  </a:lnTo>
                  <a:lnTo>
                    <a:pt x="672" y="870"/>
                  </a:lnTo>
                  <a:lnTo>
                    <a:pt x="673" y="869"/>
                  </a:lnTo>
                  <a:lnTo>
                    <a:pt x="674" y="869"/>
                  </a:lnTo>
                  <a:lnTo>
                    <a:pt x="674" y="870"/>
                  </a:lnTo>
                  <a:lnTo>
                    <a:pt x="675" y="870"/>
                  </a:lnTo>
                  <a:lnTo>
                    <a:pt x="675" y="871"/>
                  </a:lnTo>
                  <a:lnTo>
                    <a:pt x="676" y="871"/>
                  </a:lnTo>
                  <a:lnTo>
                    <a:pt x="676" y="872"/>
                  </a:lnTo>
                  <a:lnTo>
                    <a:pt x="677" y="872"/>
                  </a:lnTo>
                  <a:lnTo>
                    <a:pt x="677" y="873"/>
                  </a:lnTo>
                  <a:lnTo>
                    <a:pt x="678" y="874"/>
                  </a:lnTo>
                  <a:lnTo>
                    <a:pt x="678" y="875"/>
                  </a:lnTo>
                  <a:lnTo>
                    <a:pt x="679" y="876"/>
                  </a:lnTo>
                  <a:lnTo>
                    <a:pt x="679" y="877"/>
                  </a:lnTo>
                  <a:lnTo>
                    <a:pt x="680" y="878"/>
                  </a:lnTo>
                  <a:lnTo>
                    <a:pt x="680" y="879"/>
                  </a:lnTo>
                  <a:lnTo>
                    <a:pt x="681" y="880"/>
                  </a:lnTo>
                  <a:lnTo>
                    <a:pt x="682" y="881"/>
                  </a:lnTo>
                  <a:lnTo>
                    <a:pt x="682" y="882"/>
                  </a:lnTo>
                  <a:lnTo>
                    <a:pt x="683" y="882"/>
                  </a:lnTo>
                  <a:lnTo>
                    <a:pt x="683" y="883"/>
                  </a:lnTo>
                  <a:lnTo>
                    <a:pt x="684" y="883"/>
                  </a:lnTo>
                  <a:lnTo>
                    <a:pt x="684" y="884"/>
                  </a:lnTo>
                  <a:lnTo>
                    <a:pt x="685" y="884"/>
                  </a:lnTo>
                  <a:lnTo>
                    <a:pt x="686" y="884"/>
                  </a:lnTo>
                  <a:lnTo>
                    <a:pt x="687" y="884"/>
                  </a:lnTo>
                  <a:lnTo>
                    <a:pt x="687" y="883"/>
                  </a:lnTo>
                  <a:lnTo>
                    <a:pt x="688" y="882"/>
                  </a:lnTo>
                  <a:lnTo>
                    <a:pt x="689" y="881"/>
                  </a:lnTo>
                  <a:lnTo>
                    <a:pt x="689" y="880"/>
                  </a:lnTo>
                  <a:lnTo>
                    <a:pt x="690" y="880"/>
                  </a:lnTo>
                  <a:lnTo>
                    <a:pt x="690" y="879"/>
                  </a:lnTo>
                  <a:lnTo>
                    <a:pt x="691" y="878"/>
                  </a:lnTo>
                  <a:lnTo>
                    <a:pt x="692" y="877"/>
                  </a:lnTo>
                  <a:lnTo>
                    <a:pt x="692" y="876"/>
                  </a:lnTo>
                  <a:lnTo>
                    <a:pt x="693" y="876"/>
                  </a:lnTo>
                  <a:lnTo>
                    <a:pt x="693" y="875"/>
                  </a:lnTo>
                  <a:lnTo>
                    <a:pt x="694" y="874"/>
                  </a:lnTo>
                  <a:lnTo>
                    <a:pt x="695" y="873"/>
                  </a:lnTo>
                  <a:lnTo>
                    <a:pt x="696" y="872"/>
                  </a:lnTo>
                  <a:lnTo>
                    <a:pt x="697" y="872"/>
                  </a:lnTo>
                  <a:lnTo>
                    <a:pt x="697" y="873"/>
                  </a:lnTo>
                  <a:lnTo>
                    <a:pt x="698" y="873"/>
                  </a:lnTo>
                  <a:lnTo>
                    <a:pt x="698" y="874"/>
                  </a:lnTo>
                  <a:lnTo>
                    <a:pt x="699" y="875"/>
                  </a:lnTo>
                  <a:lnTo>
                    <a:pt x="700" y="876"/>
                  </a:lnTo>
                  <a:lnTo>
                    <a:pt x="700" y="877"/>
                  </a:lnTo>
                  <a:lnTo>
                    <a:pt x="701" y="878"/>
                  </a:lnTo>
                  <a:lnTo>
                    <a:pt x="701" y="879"/>
                  </a:lnTo>
                  <a:lnTo>
                    <a:pt x="702" y="880"/>
                  </a:lnTo>
                  <a:lnTo>
                    <a:pt x="702" y="881"/>
                  </a:lnTo>
                  <a:lnTo>
                    <a:pt x="703" y="882"/>
                  </a:lnTo>
                  <a:lnTo>
                    <a:pt x="703" y="884"/>
                  </a:lnTo>
                  <a:lnTo>
                    <a:pt x="704" y="885"/>
                  </a:lnTo>
                  <a:lnTo>
                    <a:pt x="704" y="886"/>
                  </a:lnTo>
                  <a:lnTo>
                    <a:pt x="704" y="887"/>
                  </a:lnTo>
                  <a:lnTo>
                    <a:pt x="705" y="888"/>
                  </a:lnTo>
                  <a:lnTo>
                    <a:pt x="705" y="889"/>
                  </a:lnTo>
                  <a:lnTo>
                    <a:pt x="706" y="890"/>
                  </a:lnTo>
                  <a:lnTo>
                    <a:pt x="706" y="891"/>
                  </a:lnTo>
                  <a:lnTo>
                    <a:pt x="707" y="892"/>
                  </a:lnTo>
                  <a:lnTo>
                    <a:pt x="707" y="893"/>
                  </a:lnTo>
                  <a:lnTo>
                    <a:pt x="708" y="894"/>
                  </a:lnTo>
                  <a:lnTo>
                    <a:pt x="709" y="895"/>
                  </a:lnTo>
                  <a:lnTo>
                    <a:pt x="710" y="895"/>
                  </a:lnTo>
                  <a:lnTo>
                    <a:pt x="710" y="896"/>
                  </a:lnTo>
                  <a:lnTo>
                    <a:pt x="711" y="896"/>
                  </a:lnTo>
                  <a:lnTo>
                    <a:pt x="712" y="895"/>
                  </a:lnTo>
                  <a:lnTo>
                    <a:pt x="713" y="895"/>
                  </a:lnTo>
                  <a:lnTo>
                    <a:pt x="714" y="894"/>
                  </a:lnTo>
                  <a:lnTo>
                    <a:pt x="715" y="894"/>
                  </a:lnTo>
                  <a:lnTo>
                    <a:pt x="715" y="893"/>
                  </a:lnTo>
                  <a:lnTo>
                    <a:pt x="716" y="893"/>
                  </a:lnTo>
                  <a:lnTo>
                    <a:pt x="717" y="892"/>
                  </a:lnTo>
                  <a:lnTo>
                    <a:pt x="718" y="892"/>
                  </a:lnTo>
                  <a:lnTo>
                    <a:pt x="719" y="892"/>
                  </a:lnTo>
                  <a:lnTo>
                    <a:pt x="720" y="892"/>
                  </a:lnTo>
                  <a:lnTo>
                    <a:pt x="721" y="892"/>
                  </a:lnTo>
                  <a:lnTo>
                    <a:pt x="721" y="893"/>
                  </a:lnTo>
                  <a:lnTo>
                    <a:pt x="722" y="893"/>
                  </a:lnTo>
                  <a:lnTo>
                    <a:pt x="722" y="894"/>
                  </a:lnTo>
                  <a:lnTo>
                    <a:pt x="723" y="895"/>
                  </a:lnTo>
                  <a:lnTo>
                    <a:pt x="723" y="896"/>
                  </a:lnTo>
                  <a:lnTo>
                    <a:pt x="724" y="897"/>
                  </a:lnTo>
                  <a:lnTo>
                    <a:pt x="725" y="898"/>
                  </a:lnTo>
                  <a:lnTo>
                    <a:pt x="725" y="899"/>
                  </a:lnTo>
                  <a:lnTo>
                    <a:pt x="726" y="900"/>
                  </a:lnTo>
                  <a:lnTo>
                    <a:pt x="726" y="901"/>
                  </a:lnTo>
                  <a:lnTo>
                    <a:pt x="727" y="902"/>
                  </a:lnTo>
                  <a:lnTo>
                    <a:pt x="727" y="904"/>
                  </a:lnTo>
                  <a:lnTo>
                    <a:pt x="728" y="905"/>
                  </a:lnTo>
                  <a:lnTo>
                    <a:pt x="728" y="906"/>
                  </a:lnTo>
                  <a:lnTo>
                    <a:pt x="729" y="907"/>
                  </a:lnTo>
                  <a:lnTo>
                    <a:pt x="729" y="908"/>
                  </a:lnTo>
                  <a:lnTo>
                    <a:pt x="730" y="909"/>
                  </a:lnTo>
                  <a:lnTo>
                    <a:pt x="730" y="910"/>
                  </a:lnTo>
                  <a:lnTo>
                    <a:pt x="730" y="911"/>
                  </a:lnTo>
                  <a:lnTo>
                    <a:pt x="731" y="912"/>
                  </a:lnTo>
                  <a:lnTo>
                    <a:pt x="731" y="913"/>
                  </a:lnTo>
                  <a:lnTo>
                    <a:pt x="732" y="914"/>
                  </a:lnTo>
                  <a:lnTo>
                    <a:pt x="732" y="915"/>
                  </a:lnTo>
                  <a:lnTo>
                    <a:pt x="733" y="915"/>
                  </a:lnTo>
                  <a:lnTo>
                    <a:pt x="733" y="916"/>
                  </a:lnTo>
                  <a:lnTo>
                    <a:pt x="734" y="917"/>
                  </a:lnTo>
                  <a:lnTo>
                    <a:pt x="735" y="918"/>
                  </a:lnTo>
                  <a:lnTo>
                    <a:pt x="736" y="918"/>
                  </a:lnTo>
                  <a:lnTo>
                    <a:pt x="736" y="919"/>
                  </a:lnTo>
                  <a:lnTo>
                    <a:pt x="737" y="919"/>
                  </a:lnTo>
                  <a:lnTo>
                    <a:pt x="738" y="919"/>
                  </a:lnTo>
                  <a:lnTo>
                    <a:pt x="738" y="920"/>
                  </a:lnTo>
                  <a:lnTo>
                    <a:pt x="739" y="920"/>
                  </a:lnTo>
                  <a:lnTo>
                    <a:pt x="740" y="920"/>
                  </a:lnTo>
                  <a:lnTo>
                    <a:pt x="741" y="920"/>
                  </a:lnTo>
                  <a:lnTo>
                    <a:pt x="741" y="919"/>
                  </a:lnTo>
                  <a:lnTo>
                    <a:pt x="742" y="919"/>
                  </a:lnTo>
                  <a:lnTo>
                    <a:pt x="743" y="919"/>
                  </a:lnTo>
                  <a:lnTo>
                    <a:pt x="743" y="918"/>
                  </a:lnTo>
                  <a:lnTo>
                    <a:pt x="744" y="918"/>
                  </a:lnTo>
                  <a:lnTo>
                    <a:pt x="745" y="917"/>
                  </a:lnTo>
                  <a:lnTo>
                    <a:pt x="746" y="916"/>
                  </a:lnTo>
                  <a:lnTo>
                    <a:pt x="747" y="915"/>
                  </a:lnTo>
                  <a:lnTo>
                    <a:pt x="747" y="914"/>
                  </a:lnTo>
                  <a:lnTo>
                    <a:pt x="748" y="914"/>
                  </a:lnTo>
                  <a:lnTo>
                    <a:pt x="748" y="913"/>
                  </a:lnTo>
                  <a:lnTo>
                    <a:pt x="749" y="912"/>
                  </a:lnTo>
                  <a:lnTo>
                    <a:pt x="750" y="911"/>
                  </a:lnTo>
                  <a:lnTo>
                    <a:pt x="751" y="910"/>
                  </a:lnTo>
                  <a:lnTo>
                    <a:pt x="752" y="909"/>
                  </a:lnTo>
                  <a:lnTo>
                    <a:pt x="753" y="909"/>
                  </a:lnTo>
                  <a:lnTo>
                    <a:pt x="753" y="908"/>
                  </a:lnTo>
                  <a:lnTo>
                    <a:pt x="754" y="908"/>
                  </a:lnTo>
                  <a:lnTo>
                    <a:pt x="755" y="907"/>
                  </a:lnTo>
                  <a:lnTo>
                    <a:pt x="756" y="907"/>
                  </a:lnTo>
                  <a:lnTo>
                    <a:pt x="757" y="907"/>
                  </a:lnTo>
                  <a:lnTo>
                    <a:pt x="758" y="908"/>
                  </a:lnTo>
                  <a:lnTo>
                    <a:pt x="759" y="908"/>
                  </a:lnTo>
                  <a:lnTo>
                    <a:pt x="759" y="909"/>
                  </a:lnTo>
                  <a:lnTo>
                    <a:pt x="760" y="909"/>
                  </a:lnTo>
                  <a:lnTo>
                    <a:pt x="760" y="910"/>
                  </a:lnTo>
                  <a:lnTo>
                    <a:pt x="761" y="910"/>
                  </a:lnTo>
                  <a:lnTo>
                    <a:pt x="761" y="911"/>
                  </a:lnTo>
                  <a:lnTo>
                    <a:pt x="762" y="911"/>
                  </a:lnTo>
                  <a:lnTo>
                    <a:pt x="762" y="912"/>
                  </a:lnTo>
                  <a:lnTo>
                    <a:pt x="763" y="913"/>
                  </a:lnTo>
                  <a:lnTo>
                    <a:pt x="764" y="914"/>
                  </a:lnTo>
                  <a:lnTo>
                    <a:pt x="764" y="915"/>
                  </a:lnTo>
                  <a:lnTo>
                    <a:pt x="765" y="916"/>
                  </a:lnTo>
                  <a:lnTo>
                    <a:pt x="766" y="917"/>
                  </a:lnTo>
                  <a:lnTo>
                    <a:pt x="767" y="918"/>
                  </a:lnTo>
                  <a:lnTo>
                    <a:pt x="767" y="919"/>
                  </a:lnTo>
                  <a:lnTo>
                    <a:pt x="768" y="919"/>
                  </a:lnTo>
                  <a:lnTo>
                    <a:pt x="768" y="920"/>
                  </a:lnTo>
                  <a:lnTo>
                    <a:pt x="769" y="920"/>
                  </a:lnTo>
                  <a:lnTo>
                    <a:pt x="769" y="921"/>
                  </a:lnTo>
                  <a:lnTo>
                    <a:pt x="770" y="921"/>
                  </a:lnTo>
                  <a:lnTo>
                    <a:pt x="771" y="922"/>
                  </a:lnTo>
                  <a:lnTo>
                    <a:pt x="772" y="922"/>
                  </a:lnTo>
                  <a:lnTo>
                    <a:pt x="772" y="923"/>
                  </a:lnTo>
                  <a:lnTo>
                    <a:pt x="773" y="923"/>
                  </a:lnTo>
                  <a:lnTo>
                    <a:pt x="774" y="923"/>
                  </a:lnTo>
                  <a:lnTo>
                    <a:pt x="774" y="924"/>
                  </a:lnTo>
                  <a:lnTo>
                    <a:pt x="775" y="924"/>
                  </a:lnTo>
                  <a:lnTo>
                    <a:pt x="776" y="924"/>
                  </a:lnTo>
                  <a:lnTo>
                    <a:pt x="777" y="924"/>
                  </a:lnTo>
                  <a:lnTo>
                    <a:pt x="778" y="924"/>
                  </a:lnTo>
                  <a:lnTo>
                    <a:pt x="779" y="924"/>
                  </a:lnTo>
                  <a:lnTo>
                    <a:pt x="780" y="924"/>
                  </a:lnTo>
                  <a:lnTo>
                    <a:pt x="781" y="923"/>
                  </a:lnTo>
                  <a:lnTo>
                    <a:pt x="782" y="923"/>
                  </a:lnTo>
                  <a:lnTo>
                    <a:pt x="783" y="922"/>
                  </a:lnTo>
                  <a:lnTo>
                    <a:pt x="784" y="922"/>
                  </a:lnTo>
                  <a:lnTo>
                    <a:pt x="785" y="922"/>
                  </a:lnTo>
                  <a:lnTo>
                    <a:pt x="785" y="921"/>
                  </a:lnTo>
                  <a:lnTo>
                    <a:pt x="786" y="921"/>
                  </a:lnTo>
                  <a:lnTo>
                    <a:pt x="787" y="921"/>
                  </a:lnTo>
                  <a:lnTo>
                    <a:pt x="788" y="921"/>
                  </a:lnTo>
                  <a:lnTo>
                    <a:pt x="789" y="921"/>
                  </a:lnTo>
                  <a:lnTo>
                    <a:pt x="790" y="921"/>
                  </a:lnTo>
                  <a:lnTo>
                    <a:pt x="790" y="922"/>
                  </a:lnTo>
                  <a:lnTo>
                    <a:pt x="791" y="922"/>
                  </a:lnTo>
                  <a:lnTo>
                    <a:pt x="792" y="923"/>
                  </a:lnTo>
                  <a:lnTo>
                    <a:pt x="793" y="924"/>
                  </a:lnTo>
                  <a:lnTo>
                    <a:pt x="793" y="925"/>
                  </a:lnTo>
                  <a:lnTo>
                    <a:pt x="794" y="925"/>
                  </a:lnTo>
                  <a:lnTo>
                    <a:pt x="794" y="926"/>
                  </a:lnTo>
                  <a:lnTo>
                    <a:pt x="795" y="927"/>
                  </a:lnTo>
                  <a:lnTo>
                    <a:pt x="795" y="928"/>
                  </a:lnTo>
                  <a:lnTo>
                    <a:pt x="796" y="928"/>
                  </a:lnTo>
                  <a:lnTo>
                    <a:pt x="796" y="929"/>
                  </a:lnTo>
                  <a:lnTo>
                    <a:pt x="797" y="930"/>
                  </a:lnTo>
                  <a:lnTo>
                    <a:pt x="797" y="931"/>
                  </a:lnTo>
                  <a:lnTo>
                    <a:pt x="798" y="932"/>
                  </a:lnTo>
                  <a:lnTo>
                    <a:pt x="798" y="933"/>
                  </a:lnTo>
                  <a:lnTo>
                    <a:pt x="799" y="934"/>
                  </a:lnTo>
                  <a:lnTo>
                    <a:pt x="799" y="935"/>
                  </a:lnTo>
                  <a:lnTo>
                    <a:pt x="800" y="935"/>
                  </a:lnTo>
                  <a:lnTo>
                    <a:pt x="800" y="936"/>
                  </a:lnTo>
                  <a:lnTo>
                    <a:pt x="801" y="937"/>
                  </a:lnTo>
                  <a:lnTo>
                    <a:pt x="802" y="938"/>
                  </a:lnTo>
                  <a:lnTo>
                    <a:pt x="803" y="939"/>
                  </a:lnTo>
                  <a:lnTo>
                    <a:pt x="804" y="939"/>
                  </a:lnTo>
                  <a:lnTo>
                    <a:pt x="805" y="939"/>
                  </a:lnTo>
                  <a:lnTo>
                    <a:pt x="806" y="939"/>
                  </a:lnTo>
                  <a:lnTo>
                    <a:pt x="806" y="938"/>
                  </a:lnTo>
                  <a:lnTo>
                    <a:pt x="807" y="938"/>
                  </a:lnTo>
                  <a:lnTo>
                    <a:pt x="807" y="937"/>
                  </a:lnTo>
                  <a:lnTo>
                    <a:pt x="808" y="937"/>
                  </a:lnTo>
                  <a:lnTo>
                    <a:pt x="808" y="936"/>
                  </a:lnTo>
                  <a:lnTo>
                    <a:pt x="809" y="936"/>
                  </a:lnTo>
                  <a:lnTo>
                    <a:pt x="809" y="935"/>
                  </a:lnTo>
                  <a:lnTo>
                    <a:pt x="810" y="935"/>
                  </a:lnTo>
                  <a:lnTo>
                    <a:pt x="810" y="934"/>
                  </a:lnTo>
                  <a:lnTo>
                    <a:pt x="811" y="934"/>
                  </a:lnTo>
                  <a:lnTo>
                    <a:pt x="811" y="933"/>
                  </a:lnTo>
                  <a:lnTo>
                    <a:pt x="812" y="932"/>
                  </a:lnTo>
                  <a:lnTo>
                    <a:pt x="813" y="931"/>
                  </a:lnTo>
                  <a:lnTo>
                    <a:pt x="814" y="930"/>
                  </a:lnTo>
                  <a:lnTo>
                    <a:pt x="814" y="929"/>
                  </a:lnTo>
                  <a:lnTo>
                    <a:pt x="815" y="929"/>
                  </a:lnTo>
                  <a:lnTo>
                    <a:pt x="815" y="928"/>
                  </a:lnTo>
                  <a:lnTo>
                    <a:pt x="816" y="927"/>
                  </a:lnTo>
                  <a:lnTo>
                    <a:pt x="817" y="927"/>
                  </a:lnTo>
                  <a:lnTo>
                    <a:pt x="817" y="926"/>
                  </a:lnTo>
                  <a:lnTo>
                    <a:pt x="818" y="926"/>
                  </a:lnTo>
                  <a:lnTo>
                    <a:pt x="819" y="925"/>
                  </a:lnTo>
                  <a:lnTo>
                    <a:pt x="820" y="925"/>
                  </a:lnTo>
                  <a:lnTo>
                    <a:pt x="821" y="925"/>
                  </a:lnTo>
                  <a:lnTo>
                    <a:pt x="821" y="924"/>
                  </a:lnTo>
                  <a:lnTo>
                    <a:pt x="822" y="924"/>
                  </a:lnTo>
                  <a:lnTo>
                    <a:pt x="823" y="924"/>
                  </a:lnTo>
                  <a:lnTo>
                    <a:pt x="824" y="924"/>
                  </a:lnTo>
                  <a:lnTo>
                    <a:pt x="825" y="924"/>
                  </a:lnTo>
                  <a:lnTo>
                    <a:pt x="826" y="924"/>
                  </a:lnTo>
                  <a:lnTo>
                    <a:pt x="827" y="924"/>
                  </a:lnTo>
                  <a:lnTo>
                    <a:pt x="828" y="924"/>
                  </a:lnTo>
                  <a:lnTo>
                    <a:pt x="829" y="924"/>
                  </a:lnTo>
                  <a:lnTo>
                    <a:pt x="830" y="924"/>
                  </a:lnTo>
                  <a:lnTo>
                    <a:pt x="831" y="924"/>
                  </a:lnTo>
                  <a:lnTo>
                    <a:pt x="832" y="924"/>
                  </a:lnTo>
                  <a:lnTo>
                    <a:pt x="832" y="925"/>
                  </a:lnTo>
                  <a:lnTo>
                    <a:pt x="833" y="925"/>
                  </a:lnTo>
                  <a:lnTo>
                    <a:pt x="834" y="925"/>
                  </a:lnTo>
                  <a:lnTo>
                    <a:pt x="835" y="926"/>
                  </a:lnTo>
                  <a:lnTo>
                    <a:pt x="836" y="926"/>
                  </a:lnTo>
                  <a:lnTo>
                    <a:pt x="836" y="927"/>
                  </a:lnTo>
                  <a:lnTo>
                    <a:pt x="837" y="927"/>
                  </a:lnTo>
                  <a:lnTo>
                    <a:pt x="838" y="928"/>
                  </a:lnTo>
                  <a:lnTo>
                    <a:pt x="839" y="928"/>
                  </a:lnTo>
                  <a:lnTo>
                    <a:pt x="839" y="929"/>
                  </a:lnTo>
                  <a:lnTo>
                    <a:pt x="840" y="929"/>
                  </a:lnTo>
                  <a:lnTo>
                    <a:pt x="840" y="930"/>
                  </a:lnTo>
                  <a:lnTo>
                    <a:pt x="841" y="930"/>
                  </a:lnTo>
                  <a:lnTo>
                    <a:pt x="841" y="931"/>
                  </a:lnTo>
                  <a:lnTo>
                    <a:pt x="842" y="932"/>
                  </a:lnTo>
                  <a:lnTo>
                    <a:pt x="843" y="933"/>
                  </a:lnTo>
                  <a:lnTo>
                    <a:pt x="844" y="934"/>
                  </a:lnTo>
                  <a:lnTo>
                    <a:pt x="845" y="935"/>
                  </a:lnTo>
                  <a:lnTo>
                    <a:pt x="846" y="936"/>
                  </a:lnTo>
                  <a:lnTo>
                    <a:pt x="846" y="937"/>
                  </a:lnTo>
                  <a:lnTo>
                    <a:pt x="847" y="937"/>
                  </a:lnTo>
                  <a:lnTo>
                    <a:pt x="847" y="938"/>
                  </a:lnTo>
                  <a:lnTo>
                    <a:pt x="848" y="938"/>
                  </a:lnTo>
                  <a:lnTo>
                    <a:pt x="848" y="939"/>
                  </a:lnTo>
                  <a:lnTo>
                    <a:pt x="849" y="940"/>
                  </a:lnTo>
                  <a:lnTo>
                    <a:pt x="849" y="941"/>
                  </a:lnTo>
                  <a:lnTo>
                    <a:pt x="850" y="941"/>
                  </a:lnTo>
                  <a:lnTo>
                    <a:pt x="850" y="942"/>
                  </a:lnTo>
                  <a:lnTo>
                    <a:pt x="851" y="943"/>
                  </a:lnTo>
                  <a:lnTo>
                    <a:pt x="852" y="944"/>
                  </a:lnTo>
                  <a:lnTo>
                    <a:pt x="852" y="945"/>
                  </a:lnTo>
                  <a:lnTo>
                    <a:pt x="853" y="945"/>
                  </a:lnTo>
                  <a:lnTo>
                    <a:pt x="853" y="946"/>
                  </a:lnTo>
                  <a:lnTo>
                    <a:pt x="854" y="947"/>
                  </a:lnTo>
                  <a:lnTo>
                    <a:pt x="855" y="948"/>
                  </a:lnTo>
                  <a:lnTo>
                    <a:pt x="856" y="949"/>
                  </a:lnTo>
                  <a:lnTo>
                    <a:pt x="857" y="950"/>
                  </a:lnTo>
                  <a:lnTo>
                    <a:pt x="858" y="951"/>
                  </a:lnTo>
                  <a:lnTo>
                    <a:pt x="859" y="951"/>
                  </a:lnTo>
                  <a:lnTo>
                    <a:pt x="859" y="952"/>
                  </a:lnTo>
                  <a:lnTo>
                    <a:pt x="860" y="952"/>
                  </a:lnTo>
                  <a:lnTo>
                    <a:pt x="861" y="952"/>
                  </a:lnTo>
                  <a:lnTo>
                    <a:pt x="861" y="951"/>
                  </a:lnTo>
                  <a:lnTo>
                    <a:pt x="862" y="951"/>
                  </a:lnTo>
                  <a:lnTo>
                    <a:pt x="863" y="951"/>
                  </a:lnTo>
                  <a:lnTo>
                    <a:pt x="863" y="950"/>
                  </a:lnTo>
                  <a:lnTo>
                    <a:pt x="864" y="949"/>
                  </a:lnTo>
                  <a:lnTo>
                    <a:pt x="865" y="948"/>
                  </a:lnTo>
                  <a:lnTo>
                    <a:pt x="865" y="947"/>
                  </a:lnTo>
                  <a:lnTo>
                    <a:pt x="866" y="946"/>
                  </a:lnTo>
                  <a:lnTo>
                    <a:pt x="867" y="945"/>
                  </a:lnTo>
                  <a:lnTo>
                    <a:pt x="867" y="944"/>
                  </a:lnTo>
                  <a:lnTo>
                    <a:pt x="867" y="943"/>
                  </a:lnTo>
                  <a:lnTo>
                    <a:pt x="868" y="943"/>
                  </a:lnTo>
                  <a:lnTo>
                    <a:pt x="868" y="942"/>
                  </a:lnTo>
                  <a:lnTo>
                    <a:pt x="869" y="941"/>
                  </a:lnTo>
                  <a:lnTo>
                    <a:pt x="870" y="940"/>
                  </a:lnTo>
                  <a:lnTo>
                    <a:pt x="870" y="939"/>
                  </a:lnTo>
                  <a:lnTo>
                    <a:pt x="871" y="939"/>
                  </a:lnTo>
                  <a:lnTo>
                    <a:pt x="872" y="938"/>
                  </a:lnTo>
                  <a:lnTo>
                    <a:pt x="873" y="938"/>
                  </a:lnTo>
                  <a:lnTo>
                    <a:pt x="874" y="939"/>
                  </a:lnTo>
                  <a:lnTo>
                    <a:pt x="875" y="940"/>
                  </a:lnTo>
                  <a:lnTo>
                    <a:pt x="875" y="941"/>
                  </a:lnTo>
                  <a:lnTo>
                    <a:pt x="875" y="942"/>
                  </a:lnTo>
                  <a:lnTo>
                    <a:pt x="876" y="943"/>
                  </a:lnTo>
                  <a:lnTo>
                    <a:pt x="876" y="944"/>
                  </a:lnTo>
                  <a:lnTo>
                    <a:pt x="877" y="945"/>
                  </a:lnTo>
                  <a:lnTo>
                    <a:pt x="877" y="947"/>
                  </a:lnTo>
                  <a:lnTo>
                    <a:pt x="878" y="948"/>
                  </a:lnTo>
                  <a:lnTo>
                    <a:pt x="878" y="950"/>
                  </a:lnTo>
                  <a:lnTo>
                    <a:pt x="879" y="951"/>
                  </a:lnTo>
                  <a:lnTo>
                    <a:pt x="879" y="953"/>
                  </a:lnTo>
                  <a:lnTo>
                    <a:pt x="880" y="955"/>
                  </a:lnTo>
                  <a:lnTo>
                    <a:pt x="880" y="957"/>
                  </a:lnTo>
                  <a:lnTo>
                    <a:pt x="881" y="958"/>
                  </a:lnTo>
                  <a:lnTo>
                    <a:pt x="881" y="960"/>
                  </a:lnTo>
                  <a:lnTo>
                    <a:pt x="882" y="962"/>
                  </a:lnTo>
                  <a:lnTo>
                    <a:pt x="882" y="964"/>
                  </a:lnTo>
                  <a:lnTo>
                    <a:pt x="883" y="966"/>
                  </a:lnTo>
                  <a:lnTo>
                    <a:pt x="883" y="967"/>
                  </a:lnTo>
                  <a:lnTo>
                    <a:pt x="884" y="969"/>
                  </a:lnTo>
                  <a:lnTo>
                    <a:pt x="884" y="971"/>
                  </a:lnTo>
                  <a:lnTo>
                    <a:pt x="884" y="972"/>
                  </a:lnTo>
                  <a:lnTo>
                    <a:pt x="885" y="974"/>
                  </a:lnTo>
                  <a:lnTo>
                    <a:pt x="885" y="975"/>
                  </a:lnTo>
                  <a:lnTo>
                    <a:pt x="886" y="977"/>
                  </a:lnTo>
                  <a:lnTo>
                    <a:pt x="886" y="978"/>
                  </a:lnTo>
                  <a:lnTo>
                    <a:pt x="887" y="979"/>
                  </a:lnTo>
                  <a:lnTo>
                    <a:pt x="887" y="980"/>
                  </a:lnTo>
                  <a:lnTo>
                    <a:pt x="888" y="981"/>
                  </a:lnTo>
                  <a:lnTo>
                    <a:pt x="889" y="982"/>
                  </a:lnTo>
                  <a:lnTo>
                    <a:pt x="889" y="983"/>
                  </a:lnTo>
                  <a:lnTo>
                    <a:pt x="890" y="983"/>
                  </a:lnTo>
                  <a:lnTo>
                    <a:pt x="890" y="984"/>
                  </a:lnTo>
                  <a:lnTo>
                    <a:pt x="891" y="984"/>
                  </a:lnTo>
                  <a:lnTo>
                    <a:pt x="892" y="985"/>
                  </a:lnTo>
                  <a:lnTo>
                    <a:pt x="893" y="986"/>
                  </a:lnTo>
                  <a:lnTo>
                    <a:pt x="894" y="986"/>
                  </a:lnTo>
                  <a:lnTo>
                    <a:pt x="895" y="986"/>
                  </a:lnTo>
                  <a:lnTo>
                    <a:pt x="896" y="987"/>
                  </a:lnTo>
                  <a:lnTo>
                    <a:pt x="897" y="987"/>
                  </a:lnTo>
                  <a:lnTo>
                    <a:pt x="898" y="987"/>
                  </a:lnTo>
                  <a:lnTo>
                    <a:pt x="898" y="988"/>
                  </a:lnTo>
                  <a:lnTo>
                    <a:pt x="899" y="988"/>
                  </a:lnTo>
                  <a:lnTo>
                    <a:pt x="900" y="989"/>
                  </a:lnTo>
                  <a:lnTo>
                    <a:pt x="901" y="990"/>
                  </a:lnTo>
                  <a:lnTo>
                    <a:pt x="901" y="991"/>
                  </a:lnTo>
                  <a:lnTo>
                    <a:pt x="902" y="991"/>
                  </a:lnTo>
                  <a:lnTo>
                    <a:pt x="902" y="992"/>
                  </a:lnTo>
                  <a:lnTo>
                    <a:pt x="903" y="992"/>
                  </a:lnTo>
                  <a:lnTo>
                    <a:pt x="903" y="993"/>
                  </a:lnTo>
                  <a:lnTo>
                    <a:pt x="904" y="993"/>
                  </a:lnTo>
                  <a:lnTo>
                    <a:pt x="904" y="994"/>
                  </a:lnTo>
                  <a:lnTo>
                    <a:pt x="905" y="994"/>
                  </a:lnTo>
                  <a:lnTo>
                    <a:pt x="906" y="995"/>
                  </a:lnTo>
                  <a:lnTo>
                    <a:pt x="907" y="996"/>
                  </a:lnTo>
                  <a:lnTo>
                    <a:pt x="908" y="997"/>
                  </a:lnTo>
                  <a:lnTo>
                    <a:pt x="909" y="997"/>
                  </a:lnTo>
                  <a:lnTo>
                    <a:pt x="909" y="998"/>
                  </a:lnTo>
                  <a:lnTo>
                    <a:pt x="910" y="998"/>
                  </a:lnTo>
                  <a:lnTo>
                    <a:pt x="911" y="998"/>
                  </a:lnTo>
                  <a:lnTo>
                    <a:pt x="912" y="998"/>
                  </a:lnTo>
                  <a:lnTo>
                    <a:pt x="913" y="998"/>
                  </a:lnTo>
                  <a:lnTo>
                    <a:pt x="914" y="998"/>
                  </a:lnTo>
                  <a:lnTo>
                    <a:pt x="915" y="998"/>
                  </a:lnTo>
                  <a:lnTo>
                    <a:pt x="916" y="998"/>
                  </a:lnTo>
                  <a:lnTo>
                    <a:pt x="917" y="998"/>
                  </a:lnTo>
                  <a:lnTo>
                    <a:pt x="918" y="998"/>
                  </a:lnTo>
                  <a:lnTo>
                    <a:pt x="919" y="998"/>
                  </a:lnTo>
                  <a:lnTo>
                    <a:pt x="920" y="998"/>
                  </a:lnTo>
                  <a:lnTo>
                    <a:pt x="921" y="998"/>
                  </a:lnTo>
                  <a:lnTo>
                    <a:pt x="922" y="998"/>
                  </a:lnTo>
                  <a:lnTo>
                    <a:pt x="923" y="998"/>
                  </a:lnTo>
                  <a:lnTo>
                    <a:pt x="924" y="998"/>
                  </a:lnTo>
                  <a:lnTo>
                    <a:pt x="925" y="999"/>
                  </a:lnTo>
                  <a:lnTo>
                    <a:pt x="926" y="999"/>
                  </a:lnTo>
                  <a:lnTo>
                    <a:pt x="927" y="999"/>
                  </a:lnTo>
                  <a:lnTo>
                    <a:pt x="928" y="1000"/>
                  </a:lnTo>
                  <a:lnTo>
                    <a:pt x="929" y="1000"/>
                  </a:lnTo>
                  <a:lnTo>
                    <a:pt x="930" y="1000"/>
                  </a:lnTo>
                  <a:lnTo>
                    <a:pt x="931" y="1000"/>
                  </a:lnTo>
                  <a:lnTo>
                    <a:pt x="931" y="1001"/>
                  </a:lnTo>
                  <a:lnTo>
                    <a:pt x="932" y="1001"/>
                  </a:lnTo>
                  <a:lnTo>
                    <a:pt x="933" y="1001"/>
                  </a:lnTo>
                  <a:lnTo>
                    <a:pt x="934" y="1001"/>
                  </a:lnTo>
                  <a:lnTo>
                    <a:pt x="935" y="1001"/>
                  </a:lnTo>
                  <a:lnTo>
                    <a:pt x="936" y="1000"/>
                  </a:lnTo>
                  <a:lnTo>
                    <a:pt x="937" y="1000"/>
                  </a:lnTo>
                  <a:lnTo>
                    <a:pt x="938" y="1000"/>
                  </a:lnTo>
                  <a:lnTo>
                    <a:pt x="939" y="999"/>
                  </a:lnTo>
                  <a:lnTo>
                    <a:pt x="940" y="999"/>
                  </a:lnTo>
                  <a:lnTo>
                    <a:pt x="941" y="998"/>
                  </a:lnTo>
                  <a:lnTo>
                    <a:pt x="942" y="998"/>
                  </a:lnTo>
                  <a:lnTo>
                    <a:pt x="942" y="997"/>
                  </a:lnTo>
                  <a:lnTo>
                    <a:pt x="943" y="997"/>
                  </a:lnTo>
                  <a:lnTo>
                    <a:pt x="944" y="996"/>
                  </a:lnTo>
                  <a:lnTo>
                    <a:pt x="944" y="995"/>
                  </a:lnTo>
                  <a:lnTo>
                    <a:pt x="945" y="995"/>
                  </a:lnTo>
                  <a:lnTo>
                    <a:pt x="945" y="994"/>
                  </a:lnTo>
                  <a:lnTo>
                    <a:pt x="946" y="994"/>
                  </a:lnTo>
                  <a:lnTo>
                    <a:pt x="946" y="993"/>
                  </a:lnTo>
                  <a:lnTo>
                    <a:pt x="947" y="993"/>
                  </a:lnTo>
                  <a:lnTo>
                    <a:pt x="947" y="992"/>
                  </a:lnTo>
                  <a:lnTo>
                    <a:pt x="948" y="992"/>
                  </a:lnTo>
                  <a:lnTo>
                    <a:pt x="948" y="991"/>
                  </a:lnTo>
                  <a:lnTo>
                    <a:pt x="949" y="990"/>
                  </a:lnTo>
                  <a:lnTo>
                    <a:pt x="950" y="989"/>
                  </a:lnTo>
                  <a:lnTo>
                    <a:pt x="950" y="988"/>
                  </a:lnTo>
                  <a:lnTo>
                    <a:pt x="951" y="988"/>
                  </a:lnTo>
                  <a:lnTo>
                    <a:pt x="951" y="987"/>
                  </a:lnTo>
                  <a:lnTo>
                    <a:pt x="952" y="986"/>
                  </a:lnTo>
                  <a:lnTo>
                    <a:pt x="952" y="985"/>
                  </a:lnTo>
                  <a:lnTo>
                    <a:pt x="953" y="984"/>
                  </a:lnTo>
                  <a:lnTo>
                    <a:pt x="953" y="983"/>
                  </a:lnTo>
                  <a:lnTo>
                    <a:pt x="954" y="982"/>
                  </a:lnTo>
                  <a:lnTo>
                    <a:pt x="954" y="981"/>
                  </a:lnTo>
                  <a:lnTo>
                    <a:pt x="955" y="981"/>
                  </a:lnTo>
                  <a:lnTo>
                    <a:pt x="955" y="980"/>
                  </a:lnTo>
                  <a:lnTo>
                    <a:pt x="956" y="979"/>
                  </a:lnTo>
                  <a:lnTo>
                    <a:pt x="956" y="978"/>
                  </a:lnTo>
                  <a:lnTo>
                    <a:pt x="957" y="977"/>
                  </a:lnTo>
                  <a:lnTo>
                    <a:pt x="957" y="976"/>
                  </a:lnTo>
                  <a:lnTo>
                    <a:pt x="958" y="975"/>
                  </a:lnTo>
                  <a:lnTo>
                    <a:pt x="958" y="974"/>
                  </a:lnTo>
                  <a:lnTo>
                    <a:pt x="959" y="973"/>
                  </a:lnTo>
                  <a:lnTo>
                    <a:pt x="959" y="972"/>
                  </a:lnTo>
                  <a:lnTo>
                    <a:pt x="960" y="971"/>
                  </a:lnTo>
                  <a:lnTo>
                    <a:pt x="960" y="970"/>
                  </a:lnTo>
                  <a:lnTo>
                    <a:pt x="961" y="969"/>
                  </a:lnTo>
                  <a:lnTo>
                    <a:pt x="961" y="968"/>
                  </a:lnTo>
                  <a:lnTo>
                    <a:pt x="961" y="967"/>
                  </a:lnTo>
                  <a:lnTo>
                    <a:pt x="962" y="965"/>
                  </a:lnTo>
                  <a:lnTo>
                    <a:pt x="962" y="964"/>
                  </a:lnTo>
                  <a:lnTo>
                    <a:pt x="963" y="963"/>
                  </a:lnTo>
                  <a:lnTo>
                    <a:pt x="963" y="962"/>
                  </a:lnTo>
                  <a:lnTo>
                    <a:pt x="964" y="960"/>
                  </a:lnTo>
                  <a:lnTo>
                    <a:pt x="964" y="959"/>
                  </a:lnTo>
                  <a:lnTo>
                    <a:pt x="965" y="958"/>
                  </a:lnTo>
                  <a:lnTo>
                    <a:pt x="965" y="956"/>
                  </a:lnTo>
                  <a:lnTo>
                    <a:pt x="966" y="955"/>
                  </a:lnTo>
                  <a:lnTo>
                    <a:pt x="966" y="953"/>
                  </a:lnTo>
                  <a:lnTo>
                    <a:pt x="967" y="952"/>
                  </a:lnTo>
                  <a:lnTo>
                    <a:pt x="967" y="950"/>
                  </a:lnTo>
                  <a:lnTo>
                    <a:pt x="968" y="948"/>
                  </a:lnTo>
                  <a:lnTo>
                    <a:pt x="968" y="947"/>
                  </a:lnTo>
                  <a:lnTo>
                    <a:pt x="969" y="945"/>
                  </a:lnTo>
                  <a:lnTo>
                    <a:pt x="969" y="943"/>
                  </a:lnTo>
                  <a:lnTo>
                    <a:pt x="969" y="941"/>
                  </a:lnTo>
                  <a:lnTo>
                    <a:pt x="970" y="939"/>
                  </a:lnTo>
                  <a:lnTo>
                    <a:pt x="970" y="937"/>
                  </a:lnTo>
                  <a:lnTo>
                    <a:pt x="971" y="935"/>
                  </a:lnTo>
                  <a:lnTo>
                    <a:pt x="971" y="933"/>
                  </a:lnTo>
                  <a:lnTo>
                    <a:pt x="972" y="931"/>
                  </a:lnTo>
                  <a:lnTo>
                    <a:pt x="972" y="929"/>
                  </a:lnTo>
                  <a:lnTo>
                    <a:pt x="973" y="927"/>
                  </a:lnTo>
                  <a:lnTo>
                    <a:pt x="973" y="925"/>
                  </a:lnTo>
                  <a:lnTo>
                    <a:pt x="974" y="923"/>
                  </a:lnTo>
                  <a:lnTo>
                    <a:pt x="974" y="922"/>
                  </a:lnTo>
                  <a:lnTo>
                    <a:pt x="975" y="920"/>
                  </a:lnTo>
                  <a:lnTo>
                    <a:pt x="975" y="918"/>
                  </a:lnTo>
                  <a:lnTo>
                    <a:pt x="976" y="917"/>
                  </a:lnTo>
                  <a:lnTo>
                    <a:pt x="976" y="916"/>
                  </a:lnTo>
                  <a:lnTo>
                    <a:pt x="977" y="914"/>
                  </a:lnTo>
                  <a:lnTo>
                    <a:pt x="977" y="913"/>
                  </a:lnTo>
                  <a:lnTo>
                    <a:pt x="978" y="912"/>
                  </a:lnTo>
                  <a:lnTo>
                    <a:pt x="978" y="911"/>
                  </a:lnTo>
                  <a:lnTo>
                    <a:pt x="979" y="910"/>
                  </a:lnTo>
                  <a:lnTo>
                    <a:pt x="980" y="910"/>
                  </a:lnTo>
                  <a:lnTo>
                    <a:pt x="981" y="911"/>
                  </a:lnTo>
                  <a:lnTo>
                    <a:pt x="981" y="912"/>
                  </a:lnTo>
                  <a:lnTo>
                    <a:pt x="982" y="913"/>
                  </a:lnTo>
                  <a:lnTo>
                    <a:pt x="982" y="914"/>
                  </a:lnTo>
                  <a:lnTo>
                    <a:pt x="983" y="916"/>
                  </a:lnTo>
                  <a:lnTo>
                    <a:pt x="983" y="917"/>
                  </a:lnTo>
                  <a:lnTo>
                    <a:pt x="984" y="919"/>
                  </a:lnTo>
                  <a:lnTo>
                    <a:pt x="984" y="921"/>
                  </a:lnTo>
                  <a:lnTo>
                    <a:pt x="985" y="923"/>
                  </a:lnTo>
                  <a:lnTo>
                    <a:pt x="985" y="925"/>
                  </a:lnTo>
                  <a:lnTo>
                    <a:pt x="986" y="927"/>
                  </a:lnTo>
                  <a:lnTo>
                    <a:pt x="986" y="929"/>
                  </a:lnTo>
                  <a:lnTo>
                    <a:pt x="986" y="931"/>
                  </a:lnTo>
                  <a:lnTo>
                    <a:pt x="987" y="934"/>
                  </a:lnTo>
                  <a:lnTo>
                    <a:pt x="987" y="936"/>
                  </a:lnTo>
                  <a:lnTo>
                    <a:pt x="988" y="938"/>
                  </a:lnTo>
                  <a:lnTo>
                    <a:pt x="988" y="941"/>
                  </a:lnTo>
                  <a:lnTo>
                    <a:pt x="989" y="943"/>
                  </a:lnTo>
                  <a:lnTo>
                    <a:pt x="989" y="945"/>
                  </a:lnTo>
                  <a:lnTo>
                    <a:pt x="990" y="947"/>
                  </a:lnTo>
                  <a:lnTo>
                    <a:pt x="990" y="949"/>
                  </a:lnTo>
                  <a:lnTo>
                    <a:pt x="991" y="951"/>
                  </a:lnTo>
                  <a:lnTo>
                    <a:pt x="991" y="953"/>
                  </a:lnTo>
                  <a:lnTo>
                    <a:pt x="992" y="955"/>
                  </a:lnTo>
                  <a:lnTo>
                    <a:pt x="992" y="957"/>
                  </a:lnTo>
                  <a:lnTo>
                    <a:pt x="993" y="958"/>
                  </a:lnTo>
                  <a:lnTo>
                    <a:pt x="993" y="960"/>
                  </a:lnTo>
                  <a:lnTo>
                    <a:pt x="994" y="961"/>
                  </a:lnTo>
                  <a:lnTo>
                    <a:pt x="994" y="962"/>
                  </a:lnTo>
                  <a:lnTo>
                    <a:pt x="995" y="963"/>
                  </a:lnTo>
                  <a:lnTo>
                    <a:pt x="995" y="964"/>
                  </a:lnTo>
                  <a:lnTo>
                    <a:pt x="995" y="965"/>
                  </a:lnTo>
                  <a:lnTo>
                    <a:pt x="996" y="965"/>
                  </a:lnTo>
                  <a:lnTo>
                    <a:pt x="996" y="966"/>
                  </a:lnTo>
                  <a:lnTo>
                    <a:pt x="997" y="966"/>
                  </a:lnTo>
                  <a:lnTo>
                    <a:pt x="997" y="967"/>
                  </a:lnTo>
                  <a:lnTo>
                    <a:pt x="998" y="967"/>
                  </a:lnTo>
                  <a:lnTo>
                    <a:pt x="999" y="968"/>
                  </a:lnTo>
                  <a:lnTo>
                    <a:pt x="1000" y="968"/>
                  </a:lnTo>
                  <a:lnTo>
                    <a:pt x="1001" y="968"/>
                  </a:lnTo>
                  <a:lnTo>
                    <a:pt x="1001" y="969"/>
                  </a:lnTo>
                  <a:lnTo>
                    <a:pt x="1002" y="969"/>
                  </a:lnTo>
                  <a:lnTo>
                    <a:pt x="1003" y="969"/>
                  </a:lnTo>
                  <a:lnTo>
                    <a:pt x="1004" y="969"/>
                  </a:lnTo>
                  <a:lnTo>
                    <a:pt x="1005" y="970"/>
                  </a:lnTo>
                  <a:lnTo>
                    <a:pt x="1006" y="971"/>
                  </a:lnTo>
                  <a:lnTo>
                    <a:pt x="1007" y="971"/>
                  </a:lnTo>
                  <a:lnTo>
                    <a:pt x="1007" y="972"/>
                  </a:lnTo>
                  <a:lnTo>
                    <a:pt x="1008" y="972"/>
                  </a:lnTo>
                  <a:lnTo>
                    <a:pt x="1008" y="973"/>
                  </a:lnTo>
                  <a:lnTo>
                    <a:pt x="1009" y="973"/>
                  </a:lnTo>
                  <a:lnTo>
                    <a:pt x="1009" y="974"/>
                  </a:lnTo>
                  <a:lnTo>
                    <a:pt x="1010" y="974"/>
                  </a:lnTo>
                  <a:lnTo>
                    <a:pt x="1010" y="975"/>
                  </a:lnTo>
                  <a:lnTo>
                    <a:pt x="1011" y="975"/>
                  </a:lnTo>
                  <a:lnTo>
                    <a:pt x="1011" y="976"/>
                  </a:lnTo>
                  <a:lnTo>
                    <a:pt x="1012" y="976"/>
                  </a:lnTo>
                  <a:lnTo>
                    <a:pt x="1012" y="977"/>
                  </a:lnTo>
                  <a:lnTo>
                    <a:pt x="1013" y="978"/>
                  </a:lnTo>
                  <a:lnTo>
                    <a:pt x="1014" y="979"/>
                  </a:lnTo>
                  <a:lnTo>
                    <a:pt x="1014" y="980"/>
                  </a:lnTo>
                  <a:lnTo>
                    <a:pt x="1015" y="980"/>
                  </a:lnTo>
                  <a:lnTo>
                    <a:pt x="1015" y="981"/>
                  </a:lnTo>
                  <a:lnTo>
                    <a:pt x="1016" y="981"/>
                  </a:lnTo>
                  <a:lnTo>
                    <a:pt x="1016" y="982"/>
                  </a:lnTo>
                  <a:lnTo>
                    <a:pt x="1017" y="982"/>
                  </a:lnTo>
                  <a:lnTo>
                    <a:pt x="1017" y="983"/>
                  </a:lnTo>
                  <a:lnTo>
                    <a:pt x="1018" y="983"/>
                  </a:lnTo>
                  <a:lnTo>
                    <a:pt x="1018" y="984"/>
                  </a:lnTo>
                  <a:lnTo>
                    <a:pt x="1019" y="984"/>
                  </a:lnTo>
                  <a:lnTo>
                    <a:pt x="1019" y="985"/>
                  </a:lnTo>
                  <a:lnTo>
                    <a:pt x="1020" y="985"/>
                  </a:lnTo>
                  <a:lnTo>
                    <a:pt x="1021" y="986"/>
                  </a:lnTo>
                  <a:lnTo>
                    <a:pt x="1022" y="987"/>
                  </a:lnTo>
                  <a:lnTo>
                    <a:pt x="1023" y="987"/>
                  </a:lnTo>
                  <a:lnTo>
                    <a:pt x="1024" y="988"/>
                  </a:lnTo>
                  <a:lnTo>
                    <a:pt x="1025" y="988"/>
                  </a:lnTo>
                  <a:lnTo>
                    <a:pt x="1026" y="988"/>
                  </a:lnTo>
                  <a:lnTo>
                    <a:pt x="1027" y="988"/>
                  </a:lnTo>
                  <a:lnTo>
                    <a:pt x="1028" y="987"/>
                  </a:lnTo>
                  <a:lnTo>
                    <a:pt x="1029" y="987"/>
                  </a:lnTo>
                  <a:lnTo>
                    <a:pt x="1029" y="986"/>
                  </a:lnTo>
                  <a:lnTo>
                    <a:pt x="1030" y="985"/>
                  </a:lnTo>
                  <a:lnTo>
                    <a:pt x="1031" y="984"/>
                  </a:lnTo>
                  <a:lnTo>
                    <a:pt x="1031" y="983"/>
                  </a:lnTo>
                  <a:lnTo>
                    <a:pt x="1032" y="983"/>
                  </a:lnTo>
                  <a:lnTo>
                    <a:pt x="1032" y="982"/>
                  </a:lnTo>
                  <a:lnTo>
                    <a:pt x="1033" y="982"/>
                  </a:lnTo>
                  <a:lnTo>
                    <a:pt x="1033" y="981"/>
                  </a:lnTo>
                  <a:lnTo>
                    <a:pt x="1034" y="980"/>
                  </a:lnTo>
                  <a:lnTo>
                    <a:pt x="1035" y="979"/>
                  </a:lnTo>
                  <a:lnTo>
                    <a:pt x="1036" y="978"/>
                  </a:lnTo>
                  <a:lnTo>
                    <a:pt x="1037" y="977"/>
                  </a:lnTo>
                  <a:lnTo>
                    <a:pt x="1038" y="976"/>
                  </a:lnTo>
                  <a:lnTo>
                    <a:pt x="1039" y="975"/>
                  </a:lnTo>
                  <a:lnTo>
                    <a:pt x="1040" y="975"/>
                  </a:lnTo>
                  <a:lnTo>
                    <a:pt x="1040" y="976"/>
                  </a:lnTo>
                  <a:lnTo>
                    <a:pt x="1041" y="976"/>
                  </a:lnTo>
                  <a:lnTo>
                    <a:pt x="1042" y="976"/>
                  </a:lnTo>
                  <a:lnTo>
                    <a:pt x="1042" y="977"/>
                  </a:lnTo>
                  <a:lnTo>
                    <a:pt x="1043" y="977"/>
                  </a:lnTo>
                  <a:lnTo>
                    <a:pt x="1043" y="978"/>
                  </a:lnTo>
                  <a:lnTo>
                    <a:pt x="1044" y="978"/>
                  </a:lnTo>
                  <a:lnTo>
                    <a:pt x="1044" y="979"/>
                  </a:lnTo>
                  <a:lnTo>
                    <a:pt x="1045" y="979"/>
                  </a:lnTo>
                  <a:lnTo>
                    <a:pt x="1045" y="980"/>
                  </a:lnTo>
                  <a:lnTo>
                    <a:pt x="1046" y="981"/>
                  </a:lnTo>
                  <a:lnTo>
                    <a:pt x="1046" y="982"/>
                  </a:lnTo>
                  <a:lnTo>
                    <a:pt x="1047" y="982"/>
                  </a:lnTo>
                  <a:lnTo>
                    <a:pt x="1047" y="983"/>
                  </a:lnTo>
                  <a:lnTo>
                    <a:pt x="1048" y="984"/>
                  </a:lnTo>
                  <a:lnTo>
                    <a:pt x="1049" y="985"/>
                  </a:lnTo>
                  <a:lnTo>
                    <a:pt x="1050" y="986"/>
                  </a:lnTo>
                  <a:lnTo>
                    <a:pt x="1051" y="987"/>
                  </a:lnTo>
                  <a:lnTo>
                    <a:pt x="1052" y="988"/>
                  </a:lnTo>
                  <a:lnTo>
                    <a:pt x="1053" y="988"/>
                  </a:lnTo>
                  <a:lnTo>
                    <a:pt x="1054" y="988"/>
                  </a:lnTo>
                  <a:lnTo>
                    <a:pt x="1055" y="988"/>
                  </a:lnTo>
                  <a:lnTo>
                    <a:pt x="1056" y="988"/>
                  </a:lnTo>
                  <a:lnTo>
                    <a:pt x="1056" y="989"/>
                  </a:lnTo>
                  <a:lnTo>
                    <a:pt x="1057" y="989"/>
                  </a:lnTo>
                  <a:lnTo>
                    <a:pt x="1058" y="989"/>
                  </a:lnTo>
                  <a:lnTo>
                    <a:pt x="1059" y="990"/>
                  </a:lnTo>
                  <a:lnTo>
                    <a:pt x="1060" y="991"/>
                  </a:lnTo>
                  <a:lnTo>
                    <a:pt x="1061" y="992"/>
                  </a:lnTo>
                  <a:lnTo>
                    <a:pt x="1062" y="993"/>
                  </a:lnTo>
                  <a:lnTo>
                    <a:pt x="1062" y="994"/>
                  </a:lnTo>
                  <a:lnTo>
                    <a:pt x="1063" y="995"/>
                  </a:lnTo>
                  <a:lnTo>
                    <a:pt x="1063" y="996"/>
                  </a:lnTo>
                  <a:lnTo>
                    <a:pt x="1063" y="998"/>
                  </a:lnTo>
                  <a:lnTo>
                    <a:pt x="1064" y="1000"/>
                  </a:lnTo>
                  <a:lnTo>
                    <a:pt x="1064" y="1001"/>
                  </a:lnTo>
                  <a:lnTo>
                    <a:pt x="1065" y="1003"/>
                  </a:lnTo>
                  <a:lnTo>
                    <a:pt x="1065" y="1005"/>
                  </a:lnTo>
                  <a:lnTo>
                    <a:pt x="1066" y="1007"/>
                  </a:lnTo>
                  <a:lnTo>
                    <a:pt x="1066" y="1009"/>
                  </a:lnTo>
                  <a:lnTo>
                    <a:pt x="1067" y="1012"/>
                  </a:lnTo>
                  <a:lnTo>
                    <a:pt x="1067" y="1014"/>
                  </a:lnTo>
                  <a:lnTo>
                    <a:pt x="1068" y="1016"/>
                  </a:lnTo>
                  <a:lnTo>
                    <a:pt x="1068" y="1018"/>
                  </a:lnTo>
                  <a:lnTo>
                    <a:pt x="1069" y="1020"/>
                  </a:lnTo>
                  <a:lnTo>
                    <a:pt x="1069" y="1022"/>
                  </a:lnTo>
                  <a:lnTo>
                    <a:pt x="1070" y="1025"/>
                  </a:lnTo>
                  <a:lnTo>
                    <a:pt x="1070" y="1027"/>
                  </a:lnTo>
                  <a:lnTo>
                    <a:pt x="1071" y="1029"/>
                  </a:lnTo>
                  <a:lnTo>
                    <a:pt x="1071" y="1031"/>
                  </a:lnTo>
                  <a:lnTo>
                    <a:pt x="1072" y="1033"/>
                  </a:lnTo>
                  <a:lnTo>
                    <a:pt x="1072" y="1035"/>
                  </a:lnTo>
                  <a:lnTo>
                    <a:pt x="1072" y="1036"/>
                  </a:lnTo>
                  <a:lnTo>
                    <a:pt x="1073" y="1038"/>
                  </a:lnTo>
                  <a:lnTo>
                    <a:pt x="1073" y="1040"/>
                  </a:lnTo>
                  <a:lnTo>
                    <a:pt x="1074" y="1041"/>
                  </a:lnTo>
                  <a:lnTo>
                    <a:pt x="1074" y="1042"/>
                  </a:lnTo>
                  <a:lnTo>
                    <a:pt x="1075" y="1043"/>
                  </a:lnTo>
                  <a:lnTo>
                    <a:pt x="1075" y="1044"/>
                  </a:lnTo>
                  <a:lnTo>
                    <a:pt x="1076" y="1044"/>
                  </a:lnTo>
                  <a:lnTo>
                    <a:pt x="1076" y="1045"/>
                  </a:lnTo>
                  <a:lnTo>
                    <a:pt x="1077" y="1045"/>
                  </a:lnTo>
                  <a:lnTo>
                    <a:pt x="1078" y="1045"/>
                  </a:lnTo>
                  <a:lnTo>
                    <a:pt x="1079" y="1045"/>
                  </a:lnTo>
                  <a:lnTo>
                    <a:pt x="1079" y="1044"/>
                  </a:lnTo>
                  <a:lnTo>
                    <a:pt x="1080" y="1044"/>
                  </a:lnTo>
                  <a:lnTo>
                    <a:pt x="1080" y="1043"/>
                  </a:lnTo>
                  <a:lnTo>
                    <a:pt x="1081" y="1043"/>
                  </a:lnTo>
                  <a:lnTo>
                    <a:pt x="1081" y="1042"/>
                  </a:lnTo>
                  <a:lnTo>
                    <a:pt x="1082" y="1042"/>
                  </a:lnTo>
                  <a:lnTo>
                    <a:pt x="1082" y="1041"/>
                  </a:lnTo>
                  <a:lnTo>
                    <a:pt x="1083" y="1040"/>
                  </a:lnTo>
                  <a:lnTo>
                    <a:pt x="1084" y="1039"/>
                  </a:lnTo>
                  <a:lnTo>
                    <a:pt x="1085" y="1038"/>
                  </a:lnTo>
                  <a:lnTo>
                    <a:pt x="1086" y="1038"/>
                  </a:lnTo>
                  <a:lnTo>
                    <a:pt x="1086" y="1037"/>
                  </a:lnTo>
                  <a:lnTo>
                    <a:pt x="1087" y="1037"/>
                  </a:lnTo>
                  <a:lnTo>
                    <a:pt x="1087" y="1038"/>
                  </a:lnTo>
                  <a:lnTo>
                    <a:pt x="1088" y="1038"/>
                  </a:lnTo>
                  <a:lnTo>
                    <a:pt x="1089" y="1039"/>
                  </a:lnTo>
                  <a:lnTo>
                    <a:pt x="1089" y="1040"/>
                  </a:lnTo>
                  <a:lnTo>
                    <a:pt x="1090" y="1040"/>
                  </a:lnTo>
                  <a:lnTo>
                    <a:pt x="1090" y="1041"/>
                  </a:lnTo>
                  <a:lnTo>
                    <a:pt x="1091" y="1042"/>
                  </a:lnTo>
                  <a:lnTo>
                    <a:pt x="1092" y="1043"/>
                  </a:lnTo>
                  <a:lnTo>
                    <a:pt x="1092" y="1044"/>
                  </a:lnTo>
                  <a:lnTo>
                    <a:pt x="1093" y="1045"/>
                  </a:lnTo>
                  <a:lnTo>
                    <a:pt x="1094" y="1046"/>
                  </a:lnTo>
                  <a:lnTo>
                    <a:pt x="1094" y="1047"/>
                  </a:lnTo>
                  <a:lnTo>
                    <a:pt x="1095" y="1047"/>
                  </a:lnTo>
                  <a:lnTo>
                    <a:pt x="1095" y="1048"/>
                  </a:lnTo>
                  <a:lnTo>
                    <a:pt x="1096" y="1049"/>
                  </a:lnTo>
                  <a:lnTo>
                    <a:pt x="1097" y="1050"/>
                  </a:lnTo>
                  <a:lnTo>
                    <a:pt x="1098" y="1051"/>
                  </a:lnTo>
                  <a:lnTo>
                    <a:pt x="1099" y="1051"/>
                  </a:lnTo>
                  <a:lnTo>
                    <a:pt x="1099" y="1050"/>
                  </a:lnTo>
                  <a:lnTo>
                    <a:pt x="1100" y="1050"/>
                  </a:lnTo>
                  <a:lnTo>
                    <a:pt x="1101" y="1049"/>
                  </a:lnTo>
                  <a:lnTo>
                    <a:pt x="1101" y="1048"/>
                  </a:lnTo>
                  <a:lnTo>
                    <a:pt x="1102" y="1048"/>
                  </a:lnTo>
                  <a:lnTo>
                    <a:pt x="1102" y="1047"/>
                  </a:lnTo>
                  <a:lnTo>
                    <a:pt x="1103" y="1046"/>
                  </a:lnTo>
                  <a:lnTo>
                    <a:pt x="1104" y="1045"/>
                  </a:lnTo>
                  <a:lnTo>
                    <a:pt x="1104" y="1044"/>
                  </a:lnTo>
                  <a:lnTo>
                    <a:pt x="1105" y="1043"/>
                  </a:lnTo>
                  <a:lnTo>
                    <a:pt x="1105" y="1042"/>
                  </a:lnTo>
                  <a:lnTo>
                    <a:pt x="1106" y="1042"/>
                  </a:lnTo>
                  <a:lnTo>
                    <a:pt x="1106" y="1041"/>
                  </a:lnTo>
                  <a:lnTo>
                    <a:pt x="1106" y="1040"/>
                  </a:lnTo>
                  <a:lnTo>
                    <a:pt x="1107" y="1039"/>
                  </a:lnTo>
                  <a:lnTo>
                    <a:pt x="1108" y="1038"/>
                  </a:lnTo>
                  <a:lnTo>
                    <a:pt x="1109" y="1037"/>
                  </a:lnTo>
                  <a:lnTo>
                    <a:pt x="1110" y="1036"/>
                  </a:lnTo>
                  <a:lnTo>
                    <a:pt x="1111" y="1036"/>
                  </a:lnTo>
                  <a:lnTo>
                    <a:pt x="1112" y="1036"/>
                  </a:lnTo>
                  <a:lnTo>
                    <a:pt x="1113" y="1036"/>
                  </a:lnTo>
                  <a:lnTo>
                    <a:pt x="1113" y="1037"/>
                  </a:lnTo>
                  <a:lnTo>
                    <a:pt x="1114" y="1037"/>
                  </a:lnTo>
                  <a:lnTo>
                    <a:pt x="1115" y="1038"/>
                  </a:lnTo>
                  <a:lnTo>
                    <a:pt x="1115" y="1039"/>
                  </a:lnTo>
                  <a:lnTo>
                    <a:pt x="1116" y="1040"/>
                  </a:lnTo>
                  <a:lnTo>
                    <a:pt x="1117" y="1041"/>
                  </a:lnTo>
                  <a:lnTo>
                    <a:pt x="1117" y="1042"/>
                  </a:lnTo>
                  <a:lnTo>
                    <a:pt x="1118" y="1043"/>
                  </a:lnTo>
                  <a:lnTo>
                    <a:pt x="1119" y="1044"/>
                  </a:lnTo>
                  <a:lnTo>
                    <a:pt x="1119" y="1045"/>
                  </a:lnTo>
                  <a:lnTo>
                    <a:pt x="1120" y="1046"/>
                  </a:lnTo>
                  <a:lnTo>
                    <a:pt x="1121" y="1047"/>
                  </a:lnTo>
                  <a:lnTo>
                    <a:pt x="1121" y="1048"/>
                  </a:lnTo>
                  <a:lnTo>
                    <a:pt x="1122" y="1049"/>
                  </a:lnTo>
                  <a:lnTo>
                    <a:pt x="1123" y="1050"/>
                  </a:lnTo>
                  <a:lnTo>
                    <a:pt x="1123" y="1051"/>
                  </a:lnTo>
                  <a:lnTo>
                    <a:pt x="1124" y="1051"/>
                  </a:lnTo>
                  <a:lnTo>
                    <a:pt x="1125" y="1052"/>
                  </a:lnTo>
                  <a:lnTo>
                    <a:pt x="1126" y="1052"/>
                  </a:lnTo>
                  <a:lnTo>
                    <a:pt x="1126" y="1053"/>
                  </a:lnTo>
                  <a:lnTo>
                    <a:pt x="1127" y="1053"/>
                  </a:lnTo>
                  <a:lnTo>
                    <a:pt x="1128" y="1053"/>
                  </a:lnTo>
                  <a:lnTo>
                    <a:pt x="1128" y="1054"/>
                  </a:lnTo>
                  <a:lnTo>
                    <a:pt x="1129" y="1054"/>
                  </a:lnTo>
                  <a:lnTo>
                    <a:pt x="1130" y="1054"/>
                  </a:lnTo>
                  <a:lnTo>
                    <a:pt x="1130" y="1055"/>
                  </a:lnTo>
                  <a:lnTo>
                    <a:pt x="1131" y="1055"/>
                  </a:lnTo>
                  <a:lnTo>
                    <a:pt x="1132" y="1055"/>
                  </a:lnTo>
                  <a:lnTo>
                    <a:pt x="1132" y="1056"/>
                  </a:lnTo>
                  <a:lnTo>
                    <a:pt x="1133" y="1056"/>
                  </a:lnTo>
                  <a:lnTo>
                    <a:pt x="1133" y="1057"/>
                  </a:lnTo>
                  <a:lnTo>
                    <a:pt x="1134" y="1057"/>
                  </a:lnTo>
                  <a:lnTo>
                    <a:pt x="1134" y="1058"/>
                  </a:lnTo>
                  <a:lnTo>
                    <a:pt x="1135" y="1058"/>
                  </a:lnTo>
                  <a:lnTo>
                    <a:pt x="1135" y="1059"/>
                  </a:lnTo>
                  <a:lnTo>
                    <a:pt x="1136" y="1059"/>
                  </a:lnTo>
                  <a:lnTo>
                    <a:pt x="1136" y="1060"/>
                  </a:lnTo>
                  <a:lnTo>
                    <a:pt x="1137" y="1060"/>
                  </a:lnTo>
                  <a:lnTo>
                    <a:pt x="1137" y="1061"/>
                  </a:lnTo>
                  <a:lnTo>
                    <a:pt x="1138" y="1061"/>
                  </a:lnTo>
                  <a:lnTo>
                    <a:pt x="1139" y="1061"/>
                  </a:lnTo>
                  <a:lnTo>
                    <a:pt x="1139" y="1062"/>
                  </a:lnTo>
                  <a:lnTo>
                    <a:pt x="1140" y="1062"/>
                  </a:lnTo>
                  <a:lnTo>
                    <a:pt x="1141" y="1061"/>
                  </a:lnTo>
                  <a:lnTo>
                    <a:pt x="1142" y="1061"/>
                  </a:lnTo>
                  <a:lnTo>
                    <a:pt x="1142" y="1060"/>
                  </a:lnTo>
                  <a:lnTo>
                    <a:pt x="1143" y="1059"/>
                  </a:lnTo>
                  <a:lnTo>
                    <a:pt x="1143" y="1058"/>
                  </a:lnTo>
                  <a:lnTo>
                    <a:pt x="1144" y="1057"/>
                  </a:lnTo>
                  <a:lnTo>
                    <a:pt x="1144" y="1056"/>
                  </a:lnTo>
                  <a:lnTo>
                    <a:pt x="1145" y="1054"/>
                  </a:lnTo>
                  <a:lnTo>
                    <a:pt x="1145" y="1053"/>
                  </a:lnTo>
                  <a:lnTo>
                    <a:pt x="1146" y="1051"/>
                  </a:lnTo>
                  <a:lnTo>
                    <a:pt x="1146" y="1049"/>
                  </a:lnTo>
                  <a:lnTo>
                    <a:pt x="1147" y="1046"/>
                  </a:lnTo>
                  <a:lnTo>
                    <a:pt x="1147" y="1043"/>
                  </a:lnTo>
                  <a:lnTo>
                    <a:pt x="1148" y="1040"/>
                  </a:lnTo>
                  <a:lnTo>
                    <a:pt x="1148" y="1037"/>
                  </a:lnTo>
                  <a:lnTo>
                    <a:pt x="1149" y="1034"/>
                  </a:lnTo>
                  <a:lnTo>
                    <a:pt x="1149" y="1031"/>
                  </a:lnTo>
                  <a:lnTo>
                    <a:pt x="1149" y="1028"/>
                  </a:lnTo>
                  <a:lnTo>
                    <a:pt x="1150" y="1024"/>
                  </a:lnTo>
                  <a:lnTo>
                    <a:pt x="1150" y="1020"/>
                  </a:lnTo>
                  <a:lnTo>
                    <a:pt x="1151" y="1017"/>
                  </a:lnTo>
                  <a:lnTo>
                    <a:pt x="1151" y="1013"/>
                  </a:lnTo>
                  <a:lnTo>
                    <a:pt x="1152" y="1009"/>
                  </a:lnTo>
                  <a:lnTo>
                    <a:pt x="1152" y="1006"/>
                  </a:lnTo>
                  <a:lnTo>
                    <a:pt x="1153" y="1002"/>
                  </a:lnTo>
                  <a:lnTo>
                    <a:pt x="1153" y="998"/>
                  </a:lnTo>
                  <a:lnTo>
                    <a:pt x="1154" y="994"/>
                  </a:lnTo>
                  <a:lnTo>
                    <a:pt x="1154" y="991"/>
                  </a:lnTo>
                  <a:lnTo>
                    <a:pt x="1155" y="987"/>
                  </a:lnTo>
                  <a:lnTo>
                    <a:pt x="1155" y="984"/>
                  </a:lnTo>
                  <a:lnTo>
                    <a:pt x="1156" y="980"/>
                  </a:lnTo>
                  <a:lnTo>
                    <a:pt x="1156" y="977"/>
                  </a:lnTo>
                  <a:lnTo>
                    <a:pt x="1157" y="974"/>
                  </a:lnTo>
                  <a:lnTo>
                    <a:pt x="1157" y="971"/>
                  </a:lnTo>
                  <a:lnTo>
                    <a:pt x="1158" y="968"/>
                  </a:lnTo>
                  <a:lnTo>
                    <a:pt x="1158" y="965"/>
                  </a:lnTo>
                  <a:lnTo>
                    <a:pt x="1158" y="963"/>
                  </a:lnTo>
                  <a:lnTo>
                    <a:pt x="1159" y="961"/>
                  </a:lnTo>
                  <a:lnTo>
                    <a:pt x="1159" y="959"/>
                  </a:lnTo>
                  <a:lnTo>
                    <a:pt x="1160" y="957"/>
                  </a:lnTo>
                  <a:lnTo>
                    <a:pt x="1160" y="955"/>
                  </a:lnTo>
                  <a:lnTo>
                    <a:pt x="1161" y="954"/>
                  </a:lnTo>
                  <a:lnTo>
                    <a:pt x="1161" y="953"/>
                  </a:lnTo>
                  <a:lnTo>
                    <a:pt x="1162" y="951"/>
                  </a:lnTo>
                  <a:lnTo>
                    <a:pt x="1162" y="950"/>
                  </a:lnTo>
                  <a:lnTo>
                    <a:pt x="1163" y="949"/>
                  </a:lnTo>
                  <a:lnTo>
                    <a:pt x="1164" y="948"/>
                  </a:lnTo>
                  <a:lnTo>
                    <a:pt x="1164" y="947"/>
                  </a:lnTo>
                  <a:lnTo>
                    <a:pt x="1165" y="947"/>
                  </a:lnTo>
                  <a:lnTo>
                    <a:pt x="1166" y="947"/>
                  </a:lnTo>
                  <a:lnTo>
                    <a:pt x="1167" y="947"/>
                  </a:lnTo>
                  <a:lnTo>
                    <a:pt x="1168" y="948"/>
                  </a:lnTo>
                  <a:lnTo>
                    <a:pt x="1169" y="949"/>
                  </a:lnTo>
                  <a:lnTo>
                    <a:pt x="1170" y="950"/>
                  </a:lnTo>
                  <a:lnTo>
                    <a:pt x="1170" y="951"/>
                  </a:lnTo>
                  <a:lnTo>
                    <a:pt x="1171" y="952"/>
                  </a:lnTo>
                  <a:lnTo>
                    <a:pt x="1171" y="954"/>
                  </a:lnTo>
                  <a:lnTo>
                    <a:pt x="1172" y="955"/>
                  </a:lnTo>
                  <a:lnTo>
                    <a:pt x="1172" y="956"/>
                  </a:lnTo>
                  <a:lnTo>
                    <a:pt x="1173" y="958"/>
                  </a:lnTo>
                  <a:lnTo>
                    <a:pt x="1173" y="959"/>
                  </a:lnTo>
                  <a:lnTo>
                    <a:pt x="1174" y="960"/>
                  </a:lnTo>
                  <a:lnTo>
                    <a:pt x="1174" y="962"/>
                  </a:lnTo>
                  <a:lnTo>
                    <a:pt x="1175" y="964"/>
                  </a:lnTo>
                  <a:lnTo>
                    <a:pt x="1175" y="965"/>
                  </a:lnTo>
                  <a:lnTo>
                    <a:pt x="1175" y="967"/>
                  </a:lnTo>
                  <a:lnTo>
                    <a:pt x="1176" y="969"/>
                  </a:lnTo>
                  <a:lnTo>
                    <a:pt x="1176" y="971"/>
                  </a:lnTo>
                  <a:lnTo>
                    <a:pt x="1177" y="973"/>
                  </a:lnTo>
                  <a:lnTo>
                    <a:pt x="1177" y="975"/>
                  </a:lnTo>
                  <a:lnTo>
                    <a:pt x="1178" y="976"/>
                  </a:lnTo>
                  <a:lnTo>
                    <a:pt x="1178" y="978"/>
                  </a:lnTo>
                  <a:lnTo>
                    <a:pt x="1179" y="980"/>
                  </a:lnTo>
                  <a:lnTo>
                    <a:pt x="1179" y="982"/>
                  </a:lnTo>
                  <a:lnTo>
                    <a:pt x="1180" y="984"/>
                  </a:lnTo>
                  <a:lnTo>
                    <a:pt x="1180" y="986"/>
                  </a:lnTo>
                  <a:lnTo>
                    <a:pt x="1181" y="988"/>
                  </a:lnTo>
                  <a:lnTo>
                    <a:pt x="1181" y="990"/>
                  </a:lnTo>
                  <a:lnTo>
                    <a:pt x="1182" y="993"/>
                  </a:lnTo>
                  <a:lnTo>
                    <a:pt x="1182" y="995"/>
                  </a:lnTo>
                  <a:lnTo>
                    <a:pt x="1183" y="997"/>
                  </a:lnTo>
                  <a:lnTo>
                    <a:pt x="1183" y="999"/>
                  </a:lnTo>
                  <a:lnTo>
                    <a:pt x="1183" y="1001"/>
                  </a:lnTo>
                  <a:lnTo>
                    <a:pt x="1184" y="1003"/>
                  </a:lnTo>
                  <a:lnTo>
                    <a:pt x="1184" y="1005"/>
                  </a:lnTo>
                  <a:lnTo>
                    <a:pt x="1185" y="1007"/>
                  </a:lnTo>
                  <a:lnTo>
                    <a:pt x="1185" y="1009"/>
                  </a:lnTo>
                  <a:lnTo>
                    <a:pt x="1186" y="1011"/>
                  </a:lnTo>
                  <a:lnTo>
                    <a:pt x="1186" y="1013"/>
                  </a:lnTo>
                  <a:lnTo>
                    <a:pt x="1187" y="1015"/>
                  </a:lnTo>
                  <a:lnTo>
                    <a:pt x="1187" y="1017"/>
                  </a:lnTo>
                  <a:lnTo>
                    <a:pt x="1188" y="1019"/>
                  </a:lnTo>
                  <a:lnTo>
                    <a:pt x="1188" y="1021"/>
                  </a:lnTo>
                  <a:lnTo>
                    <a:pt x="1189" y="1023"/>
                  </a:lnTo>
                  <a:lnTo>
                    <a:pt x="1189" y="1025"/>
                  </a:lnTo>
                  <a:lnTo>
                    <a:pt x="1190" y="1027"/>
                  </a:lnTo>
                  <a:lnTo>
                    <a:pt x="1190" y="1029"/>
                  </a:lnTo>
                  <a:lnTo>
                    <a:pt x="1191" y="1030"/>
                  </a:lnTo>
                  <a:lnTo>
                    <a:pt x="1191" y="1032"/>
                  </a:lnTo>
                  <a:lnTo>
                    <a:pt x="1192" y="1034"/>
                  </a:lnTo>
                  <a:lnTo>
                    <a:pt x="1192" y="1036"/>
                  </a:lnTo>
                  <a:lnTo>
                    <a:pt x="1192" y="1037"/>
                  </a:lnTo>
                  <a:lnTo>
                    <a:pt x="1193" y="1039"/>
                  </a:lnTo>
                  <a:lnTo>
                    <a:pt x="1193" y="1040"/>
                  </a:lnTo>
                  <a:lnTo>
                    <a:pt x="1194" y="1042"/>
                  </a:lnTo>
                  <a:lnTo>
                    <a:pt x="1194" y="1043"/>
                  </a:lnTo>
                  <a:lnTo>
                    <a:pt x="1195" y="1045"/>
                  </a:lnTo>
                  <a:lnTo>
                    <a:pt x="1195" y="1046"/>
                  </a:lnTo>
                  <a:lnTo>
                    <a:pt x="1196" y="1048"/>
                  </a:lnTo>
                  <a:lnTo>
                    <a:pt x="1196" y="1049"/>
                  </a:lnTo>
                  <a:lnTo>
                    <a:pt x="1197" y="1050"/>
                  </a:lnTo>
                  <a:lnTo>
                    <a:pt x="1197" y="1052"/>
                  </a:lnTo>
                  <a:lnTo>
                    <a:pt x="1198" y="1053"/>
                  </a:lnTo>
                  <a:lnTo>
                    <a:pt x="1198" y="1054"/>
                  </a:lnTo>
                  <a:lnTo>
                    <a:pt x="1199" y="1055"/>
                  </a:lnTo>
                  <a:lnTo>
                    <a:pt x="1199" y="1056"/>
                  </a:lnTo>
                  <a:lnTo>
                    <a:pt x="1200" y="1057"/>
                  </a:lnTo>
                  <a:lnTo>
                    <a:pt x="1200" y="1058"/>
                  </a:lnTo>
                  <a:lnTo>
                    <a:pt x="1200" y="1059"/>
                  </a:lnTo>
                  <a:lnTo>
                    <a:pt x="1201" y="1060"/>
                  </a:lnTo>
                  <a:lnTo>
                    <a:pt x="1201" y="1061"/>
                  </a:lnTo>
                  <a:lnTo>
                    <a:pt x="1202" y="1062"/>
                  </a:lnTo>
                  <a:lnTo>
                    <a:pt x="1202" y="1063"/>
                  </a:lnTo>
                  <a:lnTo>
                    <a:pt x="1203" y="1063"/>
                  </a:lnTo>
                  <a:lnTo>
                    <a:pt x="1203" y="1064"/>
                  </a:lnTo>
                  <a:lnTo>
                    <a:pt x="1204" y="1065"/>
                  </a:lnTo>
                  <a:lnTo>
                    <a:pt x="1205" y="1066"/>
                  </a:lnTo>
                  <a:lnTo>
                    <a:pt x="1205" y="1067"/>
                  </a:lnTo>
                  <a:lnTo>
                    <a:pt x="1206" y="1067"/>
                  </a:lnTo>
                  <a:lnTo>
                    <a:pt x="1206" y="1068"/>
                  </a:lnTo>
                  <a:lnTo>
                    <a:pt x="1207" y="1068"/>
                  </a:lnTo>
                  <a:lnTo>
                    <a:pt x="1208" y="1069"/>
                  </a:lnTo>
                  <a:lnTo>
                    <a:pt x="1209" y="1069"/>
                  </a:lnTo>
                  <a:lnTo>
                    <a:pt x="1209" y="1070"/>
                  </a:lnTo>
                  <a:lnTo>
                    <a:pt x="1210" y="1070"/>
                  </a:lnTo>
                  <a:lnTo>
                    <a:pt x="1211" y="1071"/>
                  </a:lnTo>
                  <a:lnTo>
                    <a:pt x="1212" y="1071"/>
                  </a:lnTo>
                  <a:lnTo>
                    <a:pt x="1213" y="1071"/>
                  </a:lnTo>
                  <a:lnTo>
                    <a:pt x="1214" y="1071"/>
                  </a:lnTo>
                  <a:lnTo>
                    <a:pt x="1215" y="1071"/>
                  </a:lnTo>
                  <a:lnTo>
                    <a:pt x="1216" y="1071"/>
                  </a:lnTo>
                  <a:lnTo>
                    <a:pt x="1217" y="1071"/>
                  </a:lnTo>
                  <a:lnTo>
                    <a:pt x="1217" y="1070"/>
                  </a:lnTo>
                  <a:lnTo>
                    <a:pt x="1218" y="1070"/>
                  </a:lnTo>
                  <a:lnTo>
                    <a:pt x="1218" y="1069"/>
                  </a:lnTo>
                  <a:lnTo>
                    <a:pt x="1219" y="1069"/>
                  </a:lnTo>
                  <a:lnTo>
                    <a:pt x="1220" y="1068"/>
                  </a:lnTo>
                  <a:lnTo>
                    <a:pt x="1221" y="1068"/>
                  </a:lnTo>
                  <a:lnTo>
                    <a:pt x="1222" y="1067"/>
                  </a:lnTo>
                  <a:lnTo>
                    <a:pt x="1223" y="1067"/>
                  </a:lnTo>
                  <a:lnTo>
                    <a:pt x="1224" y="1067"/>
                  </a:lnTo>
                  <a:lnTo>
                    <a:pt x="1225" y="1067"/>
                  </a:lnTo>
                  <a:lnTo>
                    <a:pt x="1226" y="1067"/>
                  </a:lnTo>
                  <a:lnTo>
                    <a:pt x="1227" y="1068"/>
                  </a:lnTo>
                  <a:lnTo>
                    <a:pt x="1228" y="1069"/>
                  </a:lnTo>
                  <a:lnTo>
                    <a:pt x="1229" y="1070"/>
                  </a:lnTo>
                  <a:lnTo>
                    <a:pt x="1230" y="1071"/>
                  </a:lnTo>
                  <a:lnTo>
                    <a:pt x="1230" y="1072"/>
                  </a:lnTo>
                  <a:lnTo>
                    <a:pt x="1231" y="1073"/>
                  </a:lnTo>
                  <a:lnTo>
                    <a:pt x="1231" y="1074"/>
                  </a:lnTo>
                  <a:lnTo>
                    <a:pt x="1232" y="1075"/>
                  </a:lnTo>
                  <a:lnTo>
                    <a:pt x="1232" y="1076"/>
                  </a:lnTo>
                  <a:lnTo>
                    <a:pt x="1233" y="1077"/>
                  </a:lnTo>
                  <a:lnTo>
                    <a:pt x="1233" y="1078"/>
                  </a:lnTo>
                  <a:lnTo>
                    <a:pt x="1234" y="1079"/>
                  </a:lnTo>
                  <a:lnTo>
                    <a:pt x="1234" y="1080"/>
                  </a:lnTo>
                  <a:lnTo>
                    <a:pt x="1235" y="1082"/>
                  </a:lnTo>
                  <a:lnTo>
                    <a:pt x="1235" y="1083"/>
                  </a:lnTo>
                  <a:lnTo>
                    <a:pt x="1235" y="1084"/>
                  </a:lnTo>
                  <a:lnTo>
                    <a:pt x="1236" y="1085"/>
                  </a:lnTo>
                  <a:lnTo>
                    <a:pt x="1236" y="1086"/>
                  </a:lnTo>
                  <a:lnTo>
                    <a:pt x="1237" y="1087"/>
                  </a:lnTo>
                  <a:lnTo>
                    <a:pt x="1237" y="1088"/>
                  </a:lnTo>
                  <a:lnTo>
                    <a:pt x="1238" y="1089"/>
                  </a:lnTo>
                  <a:lnTo>
                    <a:pt x="1238" y="1090"/>
                  </a:lnTo>
                  <a:lnTo>
                    <a:pt x="1239" y="1091"/>
                  </a:lnTo>
                  <a:lnTo>
                    <a:pt x="1239" y="1092"/>
                  </a:lnTo>
                  <a:lnTo>
                    <a:pt x="1240" y="1093"/>
                  </a:lnTo>
                  <a:lnTo>
                    <a:pt x="1241" y="1094"/>
                  </a:lnTo>
                  <a:lnTo>
                    <a:pt x="1242" y="1095"/>
                  </a:lnTo>
                  <a:lnTo>
                    <a:pt x="1243" y="1095"/>
                  </a:lnTo>
                  <a:lnTo>
                    <a:pt x="1244" y="1095"/>
                  </a:lnTo>
                  <a:lnTo>
                    <a:pt x="1245" y="1095"/>
                  </a:lnTo>
                  <a:lnTo>
                    <a:pt x="1245" y="1094"/>
                  </a:lnTo>
                  <a:lnTo>
                    <a:pt x="1246" y="1094"/>
                  </a:lnTo>
                  <a:lnTo>
                    <a:pt x="1247" y="1093"/>
                  </a:lnTo>
                  <a:lnTo>
                    <a:pt x="1247" y="1092"/>
                  </a:lnTo>
                  <a:lnTo>
                    <a:pt x="1248" y="1092"/>
                  </a:lnTo>
                  <a:lnTo>
                    <a:pt x="1248" y="1091"/>
                  </a:lnTo>
                  <a:lnTo>
                    <a:pt x="1249" y="1090"/>
                  </a:lnTo>
                  <a:lnTo>
                    <a:pt x="1249" y="1089"/>
                  </a:lnTo>
                  <a:lnTo>
                    <a:pt x="1250" y="1088"/>
                  </a:lnTo>
                  <a:lnTo>
                    <a:pt x="1250" y="1087"/>
                  </a:lnTo>
                  <a:lnTo>
                    <a:pt x="1251" y="1085"/>
                  </a:lnTo>
                  <a:lnTo>
                    <a:pt x="1251" y="1084"/>
                  </a:lnTo>
                  <a:lnTo>
                    <a:pt x="1252" y="1083"/>
                  </a:lnTo>
                  <a:lnTo>
                    <a:pt x="1252" y="1081"/>
                  </a:lnTo>
                  <a:lnTo>
                    <a:pt x="1252" y="1080"/>
                  </a:lnTo>
                  <a:lnTo>
                    <a:pt x="1253" y="1078"/>
                  </a:lnTo>
                  <a:lnTo>
                    <a:pt x="1253" y="1076"/>
                  </a:lnTo>
                  <a:lnTo>
                    <a:pt x="1254" y="1074"/>
                  </a:lnTo>
                  <a:lnTo>
                    <a:pt x="1254" y="1073"/>
                  </a:lnTo>
                  <a:lnTo>
                    <a:pt x="1255" y="1071"/>
                  </a:lnTo>
                  <a:lnTo>
                    <a:pt x="1255" y="1069"/>
                  </a:lnTo>
                  <a:lnTo>
                    <a:pt x="1256" y="1067"/>
                  </a:lnTo>
                  <a:lnTo>
                    <a:pt x="1256" y="1064"/>
                  </a:lnTo>
                  <a:lnTo>
                    <a:pt x="1257" y="1062"/>
                  </a:lnTo>
                  <a:lnTo>
                    <a:pt x="1257" y="1060"/>
                  </a:lnTo>
                  <a:lnTo>
                    <a:pt x="1258" y="1058"/>
                  </a:lnTo>
                  <a:lnTo>
                    <a:pt x="1258" y="1056"/>
                  </a:lnTo>
                  <a:lnTo>
                    <a:pt x="1259" y="1054"/>
                  </a:lnTo>
                  <a:lnTo>
                    <a:pt x="1259" y="1052"/>
                  </a:lnTo>
                  <a:lnTo>
                    <a:pt x="1260" y="1049"/>
                  </a:lnTo>
                  <a:lnTo>
                    <a:pt x="1260" y="1047"/>
                  </a:lnTo>
                  <a:lnTo>
                    <a:pt x="1260" y="1045"/>
                  </a:lnTo>
                  <a:lnTo>
                    <a:pt x="1261" y="1043"/>
                  </a:lnTo>
                  <a:lnTo>
                    <a:pt x="1261" y="1041"/>
                  </a:lnTo>
                  <a:lnTo>
                    <a:pt x="1262" y="1039"/>
                  </a:lnTo>
                  <a:lnTo>
                    <a:pt x="1262" y="1037"/>
                  </a:lnTo>
                  <a:lnTo>
                    <a:pt x="1263" y="1035"/>
                  </a:lnTo>
                  <a:lnTo>
                    <a:pt x="1263" y="1033"/>
                  </a:lnTo>
                  <a:lnTo>
                    <a:pt x="1264" y="1031"/>
                  </a:lnTo>
                  <a:lnTo>
                    <a:pt x="1264" y="1030"/>
                  </a:lnTo>
                  <a:lnTo>
                    <a:pt x="1265" y="1028"/>
                  </a:lnTo>
                  <a:lnTo>
                    <a:pt x="1265" y="1026"/>
                  </a:lnTo>
                  <a:lnTo>
                    <a:pt x="1266" y="1025"/>
                  </a:lnTo>
                  <a:lnTo>
                    <a:pt x="1266" y="1023"/>
                  </a:lnTo>
                  <a:lnTo>
                    <a:pt x="1267" y="1022"/>
                  </a:lnTo>
                  <a:lnTo>
                    <a:pt x="1267" y="1021"/>
                  </a:lnTo>
                  <a:lnTo>
                    <a:pt x="1268" y="1019"/>
                  </a:lnTo>
                  <a:lnTo>
                    <a:pt x="1268" y="1018"/>
                  </a:lnTo>
                  <a:lnTo>
                    <a:pt x="1269" y="1017"/>
                  </a:lnTo>
                  <a:lnTo>
                    <a:pt x="1269" y="1016"/>
                  </a:lnTo>
                  <a:lnTo>
                    <a:pt x="1269" y="1015"/>
                  </a:lnTo>
                  <a:lnTo>
                    <a:pt x="1270" y="1014"/>
                  </a:lnTo>
                  <a:lnTo>
                    <a:pt x="1271" y="1013"/>
                  </a:lnTo>
                  <a:lnTo>
                    <a:pt x="1271" y="1012"/>
                  </a:lnTo>
                  <a:lnTo>
                    <a:pt x="1272" y="1012"/>
                  </a:lnTo>
                  <a:lnTo>
                    <a:pt x="1273" y="1011"/>
                  </a:lnTo>
                  <a:lnTo>
                    <a:pt x="1274" y="1011"/>
                  </a:lnTo>
                  <a:lnTo>
                    <a:pt x="1275" y="1011"/>
                  </a:lnTo>
                  <a:lnTo>
                    <a:pt x="1276" y="1012"/>
                  </a:lnTo>
                  <a:lnTo>
                    <a:pt x="1277" y="1013"/>
                  </a:lnTo>
                  <a:lnTo>
                    <a:pt x="1277" y="1014"/>
                  </a:lnTo>
                  <a:lnTo>
                    <a:pt x="1278" y="1015"/>
                  </a:lnTo>
                  <a:lnTo>
                    <a:pt x="1278" y="1016"/>
                  </a:lnTo>
                  <a:lnTo>
                    <a:pt x="1279" y="1017"/>
                  </a:lnTo>
                  <a:lnTo>
                    <a:pt x="1279" y="1018"/>
                  </a:lnTo>
                  <a:lnTo>
                    <a:pt x="1280" y="1020"/>
                  </a:lnTo>
                  <a:lnTo>
                    <a:pt x="1280" y="1021"/>
                  </a:lnTo>
                  <a:lnTo>
                    <a:pt x="1281" y="1022"/>
                  </a:lnTo>
                  <a:lnTo>
                    <a:pt x="1281" y="1023"/>
                  </a:lnTo>
                  <a:lnTo>
                    <a:pt x="1282" y="1024"/>
                  </a:lnTo>
                  <a:lnTo>
                    <a:pt x="1282" y="1026"/>
                  </a:lnTo>
                  <a:lnTo>
                    <a:pt x="1283" y="1027"/>
                  </a:lnTo>
                  <a:lnTo>
                    <a:pt x="1283" y="1028"/>
                  </a:lnTo>
                  <a:lnTo>
                    <a:pt x="1284" y="1030"/>
                  </a:lnTo>
                  <a:lnTo>
                    <a:pt x="1284" y="1031"/>
                  </a:lnTo>
                  <a:lnTo>
                    <a:pt x="1285" y="1032"/>
                  </a:lnTo>
                  <a:lnTo>
                    <a:pt x="1285" y="1033"/>
                  </a:lnTo>
                  <a:lnTo>
                    <a:pt x="1286" y="1034"/>
                  </a:lnTo>
                  <a:lnTo>
                    <a:pt x="1286" y="1036"/>
                  </a:lnTo>
                  <a:lnTo>
                    <a:pt x="1286" y="1037"/>
                  </a:lnTo>
                  <a:lnTo>
                    <a:pt x="1287" y="1038"/>
                  </a:lnTo>
                  <a:lnTo>
                    <a:pt x="1287" y="1039"/>
                  </a:lnTo>
                  <a:lnTo>
                    <a:pt x="1288" y="1040"/>
                  </a:lnTo>
                  <a:lnTo>
                    <a:pt x="1288" y="1041"/>
                  </a:lnTo>
                  <a:lnTo>
                    <a:pt x="1289" y="1041"/>
                  </a:lnTo>
                  <a:lnTo>
                    <a:pt x="1289" y="1042"/>
                  </a:lnTo>
                  <a:lnTo>
                    <a:pt x="1290" y="1043"/>
                  </a:lnTo>
                  <a:lnTo>
                    <a:pt x="1291" y="1044"/>
                  </a:lnTo>
                  <a:lnTo>
                    <a:pt x="1291" y="1045"/>
                  </a:lnTo>
                  <a:lnTo>
                    <a:pt x="1292" y="1045"/>
                  </a:lnTo>
                  <a:lnTo>
                    <a:pt x="1292" y="1046"/>
                  </a:lnTo>
                  <a:lnTo>
                    <a:pt x="1293" y="1046"/>
                  </a:lnTo>
                  <a:lnTo>
                    <a:pt x="1293" y="1047"/>
                  </a:lnTo>
                  <a:lnTo>
                    <a:pt x="1294" y="1047"/>
                  </a:lnTo>
                  <a:lnTo>
                    <a:pt x="1294" y="1048"/>
                  </a:lnTo>
                  <a:lnTo>
                    <a:pt x="1295" y="1049"/>
                  </a:lnTo>
                  <a:lnTo>
                    <a:pt x="1295" y="1050"/>
                  </a:lnTo>
                  <a:lnTo>
                    <a:pt x="1296" y="1050"/>
                  </a:lnTo>
                  <a:lnTo>
                    <a:pt x="1296" y="1051"/>
                  </a:lnTo>
                  <a:lnTo>
                    <a:pt x="1297" y="1051"/>
                  </a:lnTo>
                  <a:lnTo>
                    <a:pt x="1297" y="1052"/>
                  </a:lnTo>
                  <a:lnTo>
                    <a:pt x="1298" y="1053"/>
                  </a:lnTo>
                  <a:lnTo>
                    <a:pt x="1298" y="1054"/>
                  </a:lnTo>
                  <a:lnTo>
                    <a:pt x="1299" y="1055"/>
                  </a:lnTo>
                  <a:lnTo>
                    <a:pt x="1300" y="1057"/>
                  </a:lnTo>
                  <a:lnTo>
                    <a:pt x="1300" y="1058"/>
                  </a:lnTo>
                  <a:lnTo>
                    <a:pt x="1301" y="1059"/>
                  </a:lnTo>
                  <a:lnTo>
                    <a:pt x="1301" y="1061"/>
                  </a:lnTo>
                  <a:lnTo>
                    <a:pt x="1302" y="1062"/>
                  </a:lnTo>
                  <a:lnTo>
                    <a:pt x="1302" y="1064"/>
                  </a:lnTo>
                  <a:lnTo>
                    <a:pt x="1303" y="1065"/>
                  </a:lnTo>
                  <a:lnTo>
                    <a:pt x="1303" y="1067"/>
                  </a:lnTo>
                  <a:lnTo>
                    <a:pt x="1303" y="1068"/>
                  </a:lnTo>
                  <a:lnTo>
                    <a:pt x="1304" y="1070"/>
                  </a:lnTo>
                  <a:lnTo>
                    <a:pt x="1304" y="1071"/>
                  </a:lnTo>
                  <a:lnTo>
                    <a:pt x="1305" y="1073"/>
                  </a:lnTo>
                  <a:lnTo>
                    <a:pt x="1305" y="1074"/>
                  </a:lnTo>
                  <a:lnTo>
                    <a:pt x="1306" y="1076"/>
                  </a:lnTo>
                  <a:lnTo>
                    <a:pt x="1306" y="1077"/>
                  </a:lnTo>
                  <a:lnTo>
                    <a:pt x="1307" y="1079"/>
                  </a:lnTo>
                  <a:lnTo>
                    <a:pt x="1307" y="1080"/>
                  </a:lnTo>
                  <a:lnTo>
                    <a:pt x="1308" y="1082"/>
                  </a:lnTo>
                  <a:lnTo>
                    <a:pt x="1308" y="1083"/>
                  </a:lnTo>
                  <a:lnTo>
                    <a:pt x="1309" y="1085"/>
                  </a:lnTo>
                  <a:lnTo>
                    <a:pt x="1309" y="1086"/>
                  </a:lnTo>
                  <a:lnTo>
                    <a:pt x="1310" y="1087"/>
                  </a:lnTo>
                  <a:lnTo>
                    <a:pt x="1310" y="1088"/>
                  </a:lnTo>
                  <a:lnTo>
                    <a:pt x="1311" y="1089"/>
                  </a:lnTo>
                  <a:lnTo>
                    <a:pt x="1311" y="1090"/>
                  </a:lnTo>
                  <a:lnTo>
                    <a:pt x="1312" y="1091"/>
                  </a:lnTo>
                  <a:lnTo>
                    <a:pt x="1312" y="1092"/>
                  </a:lnTo>
                  <a:lnTo>
                    <a:pt x="1313" y="1092"/>
                  </a:lnTo>
                  <a:lnTo>
                    <a:pt x="1314" y="1093"/>
                  </a:lnTo>
                  <a:lnTo>
                    <a:pt x="1315" y="1093"/>
                  </a:lnTo>
                  <a:lnTo>
                    <a:pt x="1316" y="1093"/>
                  </a:lnTo>
                  <a:lnTo>
                    <a:pt x="1317" y="1094"/>
                  </a:lnTo>
                  <a:lnTo>
                    <a:pt x="1318" y="1094"/>
                  </a:lnTo>
                  <a:lnTo>
                    <a:pt x="1319" y="1094"/>
                  </a:lnTo>
                  <a:lnTo>
                    <a:pt x="1320" y="1095"/>
                  </a:lnTo>
                  <a:lnTo>
                    <a:pt x="1321" y="1096"/>
                  </a:lnTo>
                  <a:lnTo>
                    <a:pt x="1322" y="1097"/>
                  </a:lnTo>
                  <a:lnTo>
                    <a:pt x="1323" y="1098"/>
                  </a:lnTo>
                  <a:lnTo>
                    <a:pt x="1323" y="1099"/>
                  </a:lnTo>
                  <a:lnTo>
                    <a:pt x="1324" y="1100"/>
                  </a:lnTo>
                  <a:lnTo>
                    <a:pt x="1324" y="1101"/>
                  </a:lnTo>
                  <a:lnTo>
                    <a:pt x="1325" y="1103"/>
                  </a:lnTo>
                  <a:lnTo>
                    <a:pt x="1325" y="1104"/>
                  </a:lnTo>
                  <a:lnTo>
                    <a:pt x="1326" y="1105"/>
                  </a:lnTo>
                  <a:lnTo>
                    <a:pt x="1326" y="1107"/>
                  </a:lnTo>
                  <a:lnTo>
                    <a:pt x="1327" y="1108"/>
                  </a:lnTo>
                  <a:lnTo>
                    <a:pt x="1327" y="1110"/>
                  </a:lnTo>
                  <a:lnTo>
                    <a:pt x="1328" y="1111"/>
                  </a:lnTo>
                  <a:lnTo>
                    <a:pt x="1328" y="1112"/>
                  </a:lnTo>
                  <a:lnTo>
                    <a:pt x="1329" y="1114"/>
                  </a:lnTo>
                  <a:lnTo>
                    <a:pt x="1329" y="1115"/>
                  </a:lnTo>
                  <a:lnTo>
                    <a:pt x="1329" y="1116"/>
                  </a:lnTo>
                  <a:lnTo>
                    <a:pt x="1330" y="1117"/>
                  </a:lnTo>
                  <a:lnTo>
                    <a:pt x="1330" y="1118"/>
                  </a:lnTo>
                  <a:lnTo>
                    <a:pt x="1331" y="1119"/>
                  </a:lnTo>
                  <a:lnTo>
                    <a:pt x="1332" y="1120"/>
                  </a:lnTo>
                  <a:lnTo>
                    <a:pt x="1333" y="1120"/>
                  </a:lnTo>
                  <a:lnTo>
                    <a:pt x="1334" y="1120"/>
                  </a:lnTo>
                  <a:lnTo>
                    <a:pt x="1335" y="1119"/>
                  </a:lnTo>
                  <a:lnTo>
                    <a:pt x="1335" y="1118"/>
                  </a:lnTo>
                  <a:lnTo>
                    <a:pt x="1336" y="1116"/>
                  </a:lnTo>
                  <a:lnTo>
                    <a:pt x="1336" y="1114"/>
                  </a:lnTo>
                  <a:lnTo>
                    <a:pt x="1337" y="1112"/>
                  </a:lnTo>
                  <a:lnTo>
                    <a:pt x="1337" y="1110"/>
                  </a:lnTo>
                  <a:lnTo>
                    <a:pt x="1337" y="1108"/>
                  </a:lnTo>
                  <a:lnTo>
                    <a:pt x="1338" y="1105"/>
                  </a:lnTo>
                  <a:lnTo>
                    <a:pt x="1338" y="1103"/>
                  </a:lnTo>
                  <a:lnTo>
                    <a:pt x="1339" y="1100"/>
                  </a:lnTo>
                  <a:lnTo>
                    <a:pt x="1339" y="1097"/>
                  </a:lnTo>
                  <a:lnTo>
                    <a:pt x="1340" y="1094"/>
                  </a:lnTo>
                  <a:lnTo>
                    <a:pt x="1340" y="1091"/>
                  </a:lnTo>
                  <a:lnTo>
                    <a:pt x="1341" y="1089"/>
                  </a:lnTo>
                  <a:lnTo>
                    <a:pt x="1341" y="1086"/>
                  </a:lnTo>
                  <a:lnTo>
                    <a:pt x="1342" y="1083"/>
                  </a:lnTo>
                  <a:lnTo>
                    <a:pt x="1342" y="1080"/>
                  </a:lnTo>
                  <a:lnTo>
                    <a:pt x="1343" y="1077"/>
                  </a:lnTo>
                  <a:lnTo>
                    <a:pt x="1343" y="1075"/>
                  </a:lnTo>
                  <a:lnTo>
                    <a:pt x="1344" y="1072"/>
                  </a:lnTo>
                  <a:lnTo>
                    <a:pt x="1344" y="1070"/>
                  </a:lnTo>
                  <a:lnTo>
                    <a:pt x="1345" y="1067"/>
                  </a:lnTo>
                  <a:lnTo>
                    <a:pt x="1345" y="1065"/>
                  </a:lnTo>
                  <a:lnTo>
                    <a:pt x="1346" y="1063"/>
                  </a:lnTo>
                  <a:lnTo>
                    <a:pt x="1346" y="1062"/>
                  </a:lnTo>
                  <a:lnTo>
                    <a:pt x="1346" y="1060"/>
                  </a:lnTo>
                  <a:lnTo>
                    <a:pt x="1347" y="1059"/>
                  </a:lnTo>
                  <a:lnTo>
                    <a:pt x="1348" y="1058"/>
                  </a:lnTo>
                  <a:lnTo>
                    <a:pt x="1349" y="1058"/>
                  </a:lnTo>
                  <a:lnTo>
                    <a:pt x="1350" y="1058"/>
                  </a:lnTo>
                  <a:lnTo>
                    <a:pt x="1350" y="1059"/>
                  </a:lnTo>
                  <a:lnTo>
                    <a:pt x="1351" y="1059"/>
                  </a:lnTo>
                  <a:lnTo>
                    <a:pt x="1351" y="1060"/>
                  </a:lnTo>
                  <a:lnTo>
                    <a:pt x="1352" y="1060"/>
                  </a:lnTo>
                  <a:lnTo>
                    <a:pt x="1352" y="1061"/>
                  </a:lnTo>
                  <a:lnTo>
                    <a:pt x="1353" y="1062"/>
                  </a:lnTo>
                  <a:lnTo>
                    <a:pt x="1353" y="1063"/>
                  </a:lnTo>
                  <a:lnTo>
                    <a:pt x="1354" y="1064"/>
                  </a:lnTo>
                  <a:lnTo>
                    <a:pt x="1354" y="1065"/>
                  </a:lnTo>
                  <a:lnTo>
                    <a:pt x="1355" y="1066"/>
                  </a:lnTo>
                  <a:lnTo>
                    <a:pt x="1355" y="1067"/>
                  </a:lnTo>
                  <a:lnTo>
                    <a:pt x="1356" y="1068"/>
                  </a:lnTo>
                  <a:lnTo>
                    <a:pt x="1356" y="1069"/>
                  </a:lnTo>
                  <a:lnTo>
                    <a:pt x="1357" y="1069"/>
                  </a:lnTo>
                  <a:lnTo>
                    <a:pt x="1357" y="1070"/>
                  </a:lnTo>
                  <a:lnTo>
                    <a:pt x="1358" y="1070"/>
                  </a:lnTo>
                  <a:lnTo>
                    <a:pt x="1358" y="1071"/>
                  </a:lnTo>
                  <a:lnTo>
                    <a:pt x="1359" y="1071"/>
                  </a:lnTo>
                  <a:lnTo>
                    <a:pt x="1359" y="1070"/>
                  </a:lnTo>
                  <a:lnTo>
                    <a:pt x="1360" y="1070"/>
                  </a:lnTo>
                  <a:lnTo>
                    <a:pt x="1361" y="1069"/>
                  </a:lnTo>
                  <a:lnTo>
                    <a:pt x="1362" y="1068"/>
                  </a:lnTo>
                  <a:lnTo>
                    <a:pt x="1362" y="1067"/>
                  </a:lnTo>
                  <a:lnTo>
                    <a:pt x="1363" y="1067"/>
                  </a:lnTo>
                  <a:lnTo>
                    <a:pt x="1363" y="1066"/>
                  </a:lnTo>
                  <a:lnTo>
                    <a:pt x="1363" y="1065"/>
                  </a:lnTo>
                  <a:lnTo>
                    <a:pt x="1364" y="1064"/>
                  </a:lnTo>
                  <a:lnTo>
                    <a:pt x="1364" y="1063"/>
                  </a:lnTo>
                  <a:lnTo>
                    <a:pt x="1365" y="1062"/>
                  </a:lnTo>
                  <a:lnTo>
                    <a:pt x="1366" y="1061"/>
                  </a:lnTo>
                  <a:lnTo>
                    <a:pt x="1366" y="1060"/>
                  </a:lnTo>
                  <a:lnTo>
                    <a:pt x="1367" y="1059"/>
                  </a:lnTo>
                  <a:lnTo>
                    <a:pt x="1367" y="1058"/>
                  </a:lnTo>
                  <a:lnTo>
                    <a:pt x="1368" y="1058"/>
                  </a:lnTo>
                  <a:lnTo>
                    <a:pt x="1368" y="1057"/>
                  </a:lnTo>
                  <a:lnTo>
                    <a:pt x="1369" y="1057"/>
                  </a:lnTo>
                  <a:lnTo>
                    <a:pt x="1369" y="1056"/>
                  </a:lnTo>
                  <a:lnTo>
                    <a:pt x="1370" y="1056"/>
                  </a:lnTo>
                  <a:lnTo>
                    <a:pt x="1370" y="1055"/>
                  </a:lnTo>
                  <a:lnTo>
                    <a:pt x="1371" y="1056"/>
                  </a:lnTo>
                  <a:lnTo>
                    <a:pt x="1372" y="1057"/>
                  </a:lnTo>
                  <a:lnTo>
                    <a:pt x="1372" y="1058"/>
                  </a:lnTo>
                  <a:lnTo>
                    <a:pt x="1373" y="1058"/>
                  </a:lnTo>
                  <a:lnTo>
                    <a:pt x="1373" y="1059"/>
                  </a:lnTo>
                  <a:lnTo>
                    <a:pt x="1374" y="1060"/>
                  </a:lnTo>
                  <a:lnTo>
                    <a:pt x="1374" y="1061"/>
                  </a:lnTo>
                  <a:lnTo>
                    <a:pt x="1375" y="1062"/>
                  </a:lnTo>
                  <a:lnTo>
                    <a:pt x="1375" y="1063"/>
                  </a:lnTo>
                  <a:lnTo>
                    <a:pt x="1376" y="1064"/>
                  </a:lnTo>
                  <a:lnTo>
                    <a:pt x="1376" y="1066"/>
                  </a:lnTo>
                  <a:lnTo>
                    <a:pt x="1377" y="1067"/>
                  </a:lnTo>
                  <a:lnTo>
                    <a:pt x="1377" y="1068"/>
                  </a:lnTo>
                  <a:lnTo>
                    <a:pt x="1378" y="1070"/>
                  </a:lnTo>
                  <a:lnTo>
                    <a:pt x="1378" y="1071"/>
                  </a:lnTo>
                  <a:lnTo>
                    <a:pt x="1379" y="1073"/>
                  </a:lnTo>
                  <a:lnTo>
                    <a:pt x="1379" y="1074"/>
                  </a:lnTo>
                  <a:lnTo>
                    <a:pt x="1380" y="1076"/>
                  </a:lnTo>
                  <a:lnTo>
                    <a:pt x="1380" y="1078"/>
                  </a:lnTo>
                  <a:lnTo>
                    <a:pt x="1380" y="1079"/>
                  </a:lnTo>
                  <a:lnTo>
                    <a:pt x="1381" y="1081"/>
                  </a:lnTo>
                  <a:lnTo>
                    <a:pt x="1381" y="1083"/>
                  </a:lnTo>
                  <a:lnTo>
                    <a:pt x="1382" y="1084"/>
                  </a:lnTo>
                  <a:lnTo>
                    <a:pt x="1382" y="1086"/>
                  </a:lnTo>
                  <a:lnTo>
                    <a:pt x="1383" y="1088"/>
                  </a:lnTo>
                  <a:lnTo>
                    <a:pt x="1383" y="1089"/>
                  </a:lnTo>
                  <a:lnTo>
                    <a:pt x="1384" y="1091"/>
                  </a:lnTo>
                  <a:lnTo>
                    <a:pt x="1384" y="1093"/>
                  </a:lnTo>
                  <a:lnTo>
                    <a:pt x="1385" y="1094"/>
                  </a:lnTo>
                  <a:lnTo>
                    <a:pt x="1385" y="1096"/>
                  </a:lnTo>
                  <a:lnTo>
                    <a:pt x="1386" y="1098"/>
                  </a:lnTo>
                  <a:lnTo>
                    <a:pt x="1386" y="1099"/>
                  </a:lnTo>
                  <a:lnTo>
                    <a:pt x="1387" y="1101"/>
                  </a:lnTo>
                  <a:lnTo>
                    <a:pt x="1387" y="1103"/>
                  </a:lnTo>
                  <a:lnTo>
                    <a:pt x="1388" y="1104"/>
                  </a:lnTo>
                  <a:lnTo>
                    <a:pt x="1388" y="1106"/>
                  </a:lnTo>
                  <a:lnTo>
                    <a:pt x="1389" y="1107"/>
                  </a:lnTo>
                  <a:lnTo>
                    <a:pt x="1389" y="1109"/>
                  </a:lnTo>
                  <a:lnTo>
                    <a:pt x="1389" y="1111"/>
                  </a:lnTo>
                  <a:lnTo>
                    <a:pt x="1390" y="1112"/>
                  </a:lnTo>
                  <a:lnTo>
                    <a:pt x="1390" y="1114"/>
                  </a:lnTo>
                  <a:lnTo>
                    <a:pt x="1391" y="1115"/>
                  </a:lnTo>
                  <a:lnTo>
                    <a:pt x="1391" y="1117"/>
                  </a:lnTo>
                  <a:lnTo>
                    <a:pt x="1392" y="1118"/>
                  </a:lnTo>
                  <a:lnTo>
                    <a:pt x="1392" y="1120"/>
                  </a:lnTo>
                  <a:lnTo>
                    <a:pt x="1393" y="1121"/>
                  </a:lnTo>
                  <a:lnTo>
                    <a:pt x="1393" y="1122"/>
                  </a:lnTo>
                  <a:lnTo>
                    <a:pt x="1394" y="1124"/>
                  </a:lnTo>
                  <a:lnTo>
                    <a:pt x="1394" y="1125"/>
                  </a:lnTo>
                  <a:lnTo>
                    <a:pt x="1395" y="1126"/>
                  </a:lnTo>
                  <a:lnTo>
                    <a:pt x="1395" y="1127"/>
                  </a:lnTo>
                  <a:lnTo>
                    <a:pt x="1396" y="1128"/>
                  </a:lnTo>
                  <a:lnTo>
                    <a:pt x="1396" y="1129"/>
                  </a:lnTo>
                  <a:lnTo>
                    <a:pt x="1397" y="1131"/>
                  </a:lnTo>
                  <a:lnTo>
                    <a:pt x="1397" y="1132"/>
                  </a:lnTo>
                  <a:lnTo>
                    <a:pt x="1397" y="1133"/>
                  </a:lnTo>
                  <a:lnTo>
                    <a:pt x="1398" y="1134"/>
                  </a:lnTo>
                  <a:lnTo>
                    <a:pt x="1398" y="1135"/>
                  </a:lnTo>
                  <a:lnTo>
                    <a:pt x="1399" y="1135"/>
                  </a:lnTo>
                  <a:lnTo>
                    <a:pt x="1399" y="1136"/>
                  </a:lnTo>
                  <a:lnTo>
                    <a:pt x="1400" y="1137"/>
                  </a:lnTo>
                  <a:lnTo>
                    <a:pt x="1400" y="1138"/>
                  </a:lnTo>
                  <a:lnTo>
                    <a:pt x="1401" y="1139"/>
                  </a:lnTo>
                  <a:lnTo>
                    <a:pt x="1401" y="1140"/>
                  </a:lnTo>
                  <a:lnTo>
                    <a:pt x="1402" y="1141"/>
                  </a:lnTo>
                  <a:lnTo>
                    <a:pt x="1402" y="1142"/>
                  </a:lnTo>
                  <a:lnTo>
                    <a:pt x="1403" y="1143"/>
                  </a:lnTo>
                  <a:lnTo>
                    <a:pt x="1403" y="1144"/>
                  </a:lnTo>
                  <a:lnTo>
                    <a:pt x="1404" y="1144"/>
                  </a:lnTo>
                  <a:lnTo>
                    <a:pt x="1404" y="1145"/>
                  </a:lnTo>
                  <a:lnTo>
                    <a:pt x="1405" y="1146"/>
                  </a:lnTo>
                  <a:lnTo>
                    <a:pt x="1405" y="1147"/>
                  </a:lnTo>
                  <a:lnTo>
                    <a:pt x="1406" y="1148"/>
                  </a:lnTo>
                  <a:lnTo>
                    <a:pt x="1406" y="1149"/>
                  </a:lnTo>
                  <a:lnTo>
                    <a:pt x="1406" y="1150"/>
                  </a:lnTo>
                  <a:lnTo>
                    <a:pt x="1407" y="1150"/>
                  </a:lnTo>
                  <a:lnTo>
                    <a:pt x="1407" y="1151"/>
                  </a:lnTo>
                  <a:lnTo>
                    <a:pt x="1408" y="1152"/>
                  </a:lnTo>
                  <a:lnTo>
                    <a:pt x="1408" y="1153"/>
                  </a:lnTo>
                  <a:lnTo>
                    <a:pt x="1409" y="1154"/>
                  </a:lnTo>
                  <a:lnTo>
                    <a:pt x="1410" y="1155"/>
                  </a:lnTo>
                  <a:lnTo>
                    <a:pt x="1410" y="1156"/>
                  </a:lnTo>
                  <a:lnTo>
                    <a:pt x="1411" y="1157"/>
                  </a:lnTo>
                  <a:lnTo>
                    <a:pt x="1412" y="1158"/>
                  </a:lnTo>
                  <a:lnTo>
                    <a:pt x="1413" y="1159"/>
                  </a:lnTo>
                  <a:lnTo>
                    <a:pt x="1414" y="1160"/>
                  </a:lnTo>
                  <a:lnTo>
                    <a:pt x="1414" y="1161"/>
                  </a:lnTo>
                  <a:lnTo>
                    <a:pt x="1415" y="1161"/>
                  </a:lnTo>
                  <a:lnTo>
                    <a:pt x="1416" y="1161"/>
                  </a:lnTo>
                  <a:lnTo>
                    <a:pt x="1416" y="1162"/>
                  </a:lnTo>
                  <a:lnTo>
                    <a:pt x="1417" y="1162"/>
                  </a:lnTo>
                  <a:lnTo>
                    <a:pt x="1418" y="1161"/>
                  </a:lnTo>
                  <a:lnTo>
                    <a:pt x="1419" y="1160"/>
                  </a:lnTo>
                  <a:lnTo>
                    <a:pt x="1420" y="1159"/>
                  </a:lnTo>
                  <a:lnTo>
                    <a:pt x="1420" y="1158"/>
                  </a:lnTo>
                  <a:lnTo>
                    <a:pt x="1421" y="1158"/>
                  </a:lnTo>
                  <a:lnTo>
                    <a:pt x="1421" y="1157"/>
                  </a:lnTo>
                  <a:lnTo>
                    <a:pt x="1422" y="1156"/>
                  </a:lnTo>
                  <a:lnTo>
                    <a:pt x="1422" y="1155"/>
                  </a:lnTo>
                  <a:lnTo>
                    <a:pt x="1423" y="1154"/>
                  </a:lnTo>
                  <a:lnTo>
                    <a:pt x="1423" y="1153"/>
                  </a:lnTo>
                  <a:lnTo>
                    <a:pt x="1423" y="1152"/>
                  </a:lnTo>
                  <a:lnTo>
                    <a:pt x="1424" y="1151"/>
                  </a:lnTo>
                  <a:lnTo>
                    <a:pt x="1424" y="1150"/>
                  </a:lnTo>
                  <a:lnTo>
                    <a:pt x="1425" y="1148"/>
                  </a:lnTo>
                  <a:lnTo>
                    <a:pt x="1425" y="1147"/>
                  </a:lnTo>
                  <a:lnTo>
                    <a:pt x="1426" y="1146"/>
                  </a:lnTo>
                  <a:lnTo>
                    <a:pt x="1426" y="1145"/>
                  </a:lnTo>
                  <a:lnTo>
                    <a:pt x="1427" y="1143"/>
                  </a:lnTo>
                  <a:lnTo>
                    <a:pt x="1427" y="1142"/>
                  </a:lnTo>
                  <a:lnTo>
                    <a:pt x="1428" y="1140"/>
                  </a:lnTo>
                  <a:lnTo>
                    <a:pt x="1428" y="1139"/>
                  </a:lnTo>
                  <a:lnTo>
                    <a:pt x="1429" y="1137"/>
                  </a:lnTo>
                  <a:lnTo>
                    <a:pt x="1429" y="1136"/>
                  </a:lnTo>
                  <a:lnTo>
                    <a:pt x="1430" y="1134"/>
                  </a:lnTo>
                  <a:lnTo>
                    <a:pt x="1430" y="1132"/>
                  </a:lnTo>
                  <a:lnTo>
                    <a:pt x="1431" y="1131"/>
                  </a:lnTo>
                  <a:lnTo>
                    <a:pt x="1431" y="1129"/>
                  </a:lnTo>
                  <a:lnTo>
                    <a:pt x="1431" y="1127"/>
                  </a:lnTo>
                  <a:lnTo>
                    <a:pt x="1432" y="1126"/>
                  </a:lnTo>
                  <a:lnTo>
                    <a:pt x="1432" y="1124"/>
                  </a:lnTo>
                  <a:lnTo>
                    <a:pt x="1433" y="1122"/>
                  </a:lnTo>
                  <a:lnTo>
                    <a:pt x="1433" y="1120"/>
                  </a:lnTo>
                  <a:lnTo>
                    <a:pt x="1434" y="1119"/>
                  </a:lnTo>
                  <a:lnTo>
                    <a:pt x="1434" y="1117"/>
                  </a:lnTo>
                  <a:lnTo>
                    <a:pt x="1435" y="1115"/>
                  </a:lnTo>
                  <a:lnTo>
                    <a:pt x="1435" y="1113"/>
                  </a:lnTo>
                  <a:lnTo>
                    <a:pt x="1436" y="1112"/>
                  </a:lnTo>
                  <a:lnTo>
                    <a:pt x="1436" y="1110"/>
                  </a:lnTo>
                  <a:lnTo>
                    <a:pt x="1437" y="1108"/>
                  </a:lnTo>
                  <a:lnTo>
                    <a:pt x="1437" y="1107"/>
                  </a:lnTo>
                  <a:lnTo>
                    <a:pt x="1438" y="1105"/>
                  </a:lnTo>
                  <a:lnTo>
                    <a:pt x="1438" y="1104"/>
                  </a:lnTo>
                  <a:lnTo>
                    <a:pt x="1439" y="1102"/>
                  </a:lnTo>
                  <a:lnTo>
                    <a:pt x="1439" y="1101"/>
                  </a:lnTo>
                  <a:lnTo>
                    <a:pt x="1440" y="1099"/>
                  </a:lnTo>
                  <a:lnTo>
                    <a:pt x="1440" y="1098"/>
                  </a:lnTo>
                  <a:lnTo>
                    <a:pt x="1440" y="1096"/>
                  </a:lnTo>
                  <a:lnTo>
                    <a:pt x="1441" y="1095"/>
                  </a:lnTo>
                  <a:lnTo>
                    <a:pt x="1441" y="1094"/>
                  </a:lnTo>
                  <a:lnTo>
                    <a:pt x="1442" y="1093"/>
                  </a:lnTo>
                  <a:lnTo>
                    <a:pt x="1442" y="1092"/>
                  </a:lnTo>
                  <a:lnTo>
                    <a:pt x="1443" y="1091"/>
                  </a:lnTo>
                  <a:lnTo>
                    <a:pt x="1443" y="1090"/>
                  </a:lnTo>
                  <a:lnTo>
                    <a:pt x="1444" y="1089"/>
                  </a:lnTo>
                  <a:lnTo>
                    <a:pt x="1444" y="1088"/>
                  </a:lnTo>
                  <a:lnTo>
                    <a:pt x="1445" y="1087"/>
                  </a:lnTo>
                  <a:lnTo>
                    <a:pt x="1445" y="1086"/>
                  </a:lnTo>
                  <a:lnTo>
                    <a:pt x="1446" y="1085"/>
                  </a:lnTo>
                  <a:lnTo>
                    <a:pt x="1446" y="1084"/>
                  </a:lnTo>
                  <a:lnTo>
                    <a:pt x="1447" y="1083"/>
                  </a:lnTo>
                  <a:lnTo>
                    <a:pt x="1447" y="1082"/>
                  </a:lnTo>
                  <a:lnTo>
                    <a:pt x="1448" y="1082"/>
                  </a:lnTo>
                  <a:lnTo>
                    <a:pt x="1448" y="1081"/>
                  </a:lnTo>
                  <a:lnTo>
                    <a:pt x="1448" y="1080"/>
                  </a:lnTo>
                  <a:lnTo>
                    <a:pt x="1449" y="1079"/>
                  </a:lnTo>
                  <a:lnTo>
                    <a:pt x="1449" y="1078"/>
                  </a:lnTo>
                  <a:lnTo>
                    <a:pt x="1450" y="1077"/>
                  </a:lnTo>
                  <a:lnTo>
                    <a:pt x="1450" y="1075"/>
                  </a:lnTo>
                  <a:lnTo>
                    <a:pt x="1451" y="1074"/>
                  </a:lnTo>
                  <a:lnTo>
                    <a:pt x="1451" y="1073"/>
                  </a:lnTo>
                  <a:lnTo>
                    <a:pt x="1452" y="1072"/>
                  </a:lnTo>
                  <a:lnTo>
                    <a:pt x="1452" y="1071"/>
                  </a:lnTo>
                  <a:lnTo>
                    <a:pt x="1453" y="1069"/>
                  </a:lnTo>
                  <a:lnTo>
                    <a:pt x="1453" y="1067"/>
                  </a:lnTo>
                  <a:lnTo>
                    <a:pt x="1454" y="1066"/>
                  </a:lnTo>
                  <a:lnTo>
                    <a:pt x="1454" y="1064"/>
                  </a:lnTo>
                  <a:lnTo>
                    <a:pt x="1455" y="1062"/>
                  </a:lnTo>
                  <a:lnTo>
                    <a:pt x="1455" y="1060"/>
                  </a:lnTo>
                  <a:lnTo>
                    <a:pt x="1456" y="1059"/>
                  </a:lnTo>
                  <a:lnTo>
                    <a:pt x="1456" y="1057"/>
                  </a:lnTo>
                  <a:lnTo>
                    <a:pt x="1457" y="1055"/>
                  </a:lnTo>
                  <a:lnTo>
                    <a:pt x="1457" y="1053"/>
                  </a:lnTo>
                  <a:lnTo>
                    <a:pt x="1457" y="1051"/>
                  </a:lnTo>
                  <a:lnTo>
                    <a:pt x="1458" y="1050"/>
                  </a:lnTo>
                  <a:lnTo>
                    <a:pt x="1458" y="1048"/>
                  </a:lnTo>
                  <a:lnTo>
                    <a:pt x="1459" y="1047"/>
                  </a:lnTo>
                  <a:lnTo>
                    <a:pt x="1459" y="1045"/>
                  </a:lnTo>
                  <a:lnTo>
                    <a:pt x="1460" y="1044"/>
                  </a:lnTo>
                  <a:lnTo>
                    <a:pt x="1460" y="1043"/>
                  </a:lnTo>
                  <a:lnTo>
                    <a:pt x="1461" y="1041"/>
                  </a:lnTo>
                  <a:lnTo>
                    <a:pt x="1461" y="1040"/>
                  </a:lnTo>
                  <a:lnTo>
                    <a:pt x="1462" y="1040"/>
                  </a:lnTo>
                  <a:lnTo>
                    <a:pt x="1462" y="1039"/>
                  </a:lnTo>
                  <a:lnTo>
                    <a:pt x="1463" y="1039"/>
                  </a:lnTo>
                  <a:lnTo>
                    <a:pt x="1463" y="1038"/>
                  </a:lnTo>
                  <a:lnTo>
                    <a:pt x="1464" y="1038"/>
                  </a:lnTo>
                  <a:lnTo>
                    <a:pt x="1465" y="1039"/>
                  </a:lnTo>
                  <a:lnTo>
                    <a:pt x="1465" y="1040"/>
                  </a:lnTo>
                  <a:lnTo>
                    <a:pt x="1466" y="1041"/>
                  </a:lnTo>
                  <a:lnTo>
                    <a:pt x="1466" y="1043"/>
                  </a:lnTo>
                  <a:lnTo>
                    <a:pt x="1466" y="1044"/>
                  </a:lnTo>
                  <a:lnTo>
                    <a:pt x="1467" y="1046"/>
                  </a:lnTo>
                  <a:lnTo>
                    <a:pt x="1467" y="1048"/>
                  </a:lnTo>
                  <a:lnTo>
                    <a:pt x="1468" y="1050"/>
                  </a:lnTo>
                  <a:lnTo>
                    <a:pt x="1468" y="1053"/>
                  </a:lnTo>
                  <a:lnTo>
                    <a:pt x="1469" y="1055"/>
                  </a:lnTo>
                  <a:lnTo>
                    <a:pt x="1469" y="1058"/>
                  </a:lnTo>
                  <a:lnTo>
                    <a:pt x="1470" y="1060"/>
                  </a:lnTo>
                  <a:lnTo>
                    <a:pt x="1470" y="1063"/>
                  </a:lnTo>
                  <a:lnTo>
                    <a:pt x="1471" y="1066"/>
                  </a:lnTo>
                  <a:lnTo>
                    <a:pt x="1471" y="1068"/>
                  </a:lnTo>
                  <a:lnTo>
                    <a:pt x="1472" y="1071"/>
                  </a:lnTo>
                  <a:lnTo>
                    <a:pt x="1472" y="1074"/>
                  </a:lnTo>
                  <a:lnTo>
                    <a:pt x="1473" y="1076"/>
                  </a:lnTo>
                  <a:lnTo>
                    <a:pt x="1473" y="1079"/>
                  </a:lnTo>
                  <a:lnTo>
                    <a:pt x="1474" y="1082"/>
                  </a:lnTo>
                  <a:lnTo>
                    <a:pt x="1474" y="1084"/>
                  </a:lnTo>
                  <a:lnTo>
                    <a:pt x="1474" y="1086"/>
                  </a:lnTo>
                  <a:lnTo>
                    <a:pt x="1475" y="1089"/>
                  </a:lnTo>
                  <a:lnTo>
                    <a:pt x="1475" y="1091"/>
                  </a:lnTo>
                  <a:lnTo>
                    <a:pt x="1476" y="1093"/>
                  </a:lnTo>
                  <a:lnTo>
                    <a:pt x="1476" y="1095"/>
                  </a:lnTo>
                  <a:lnTo>
                    <a:pt x="1477" y="1096"/>
                  </a:lnTo>
                  <a:lnTo>
                    <a:pt x="1477" y="1098"/>
                  </a:lnTo>
                  <a:lnTo>
                    <a:pt x="1478" y="1099"/>
                  </a:lnTo>
                  <a:lnTo>
                    <a:pt x="1478" y="1100"/>
                  </a:lnTo>
                  <a:lnTo>
                    <a:pt x="1479" y="1101"/>
                  </a:lnTo>
                  <a:lnTo>
                    <a:pt x="1479" y="1102"/>
                  </a:lnTo>
                  <a:lnTo>
                    <a:pt x="1480" y="1102"/>
                  </a:lnTo>
                  <a:lnTo>
                    <a:pt x="1480" y="1103"/>
                  </a:lnTo>
                  <a:lnTo>
                    <a:pt x="1481" y="1103"/>
                  </a:lnTo>
                  <a:lnTo>
                    <a:pt x="1482" y="1103"/>
                  </a:lnTo>
                  <a:lnTo>
                    <a:pt x="1483" y="1103"/>
                  </a:lnTo>
                  <a:lnTo>
                    <a:pt x="1484" y="1102"/>
                  </a:lnTo>
                  <a:lnTo>
                    <a:pt x="1485" y="1101"/>
                  </a:lnTo>
                  <a:lnTo>
                    <a:pt x="1486" y="1100"/>
                  </a:lnTo>
                  <a:lnTo>
                    <a:pt x="1486" y="1099"/>
                  </a:lnTo>
                  <a:lnTo>
                    <a:pt x="1487" y="1099"/>
                  </a:lnTo>
                  <a:lnTo>
                    <a:pt x="1487" y="1098"/>
                  </a:lnTo>
                  <a:lnTo>
                    <a:pt x="1488" y="1097"/>
                  </a:lnTo>
                  <a:lnTo>
                    <a:pt x="1488" y="1096"/>
                  </a:lnTo>
                  <a:lnTo>
                    <a:pt x="1489" y="1096"/>
                  </a:lnTo>
                  <a:lnTo>
                    <a:pt x="1489" y="1095"/>
                  </a:lnTo>
                  <a:lnTo>
                    <a:pt x="1490" y="1094"/>
                  </a:lnTo>
                  <a:lnTo>
                    <a:pt x="1491" y="1093"/>
                  </a:lnTo>
                  <a:lnTo>
                    <a:pt x="1491" y="1092"/>
                  </a:lnTo>
                  <a:lnTo>
                    <a:pt x="1491" y="1091"/>
                  </a:lnTo>
                  <a:lnTo>
                    <a:pt x="1492" y="1091"/>
                  </a:lnTo>
                  <a:lnTo>
                    <a:pt x="1492" y="1090"/>
                  </a:lnTo>
                  <a:lnTo>
                    <a:pt x="1493" y="1089"/>
                  </a:lnTo>
                  <a:lnTo>
                    <a:pt x="1494" y="1088"/>
                  </a:lnTo>
                  <a:lnTo>
                    <a:pt x="1494" y="1087"/>
                  </a:lnTo>
                  <a:lnTo>
                    <a:pt x="1495" y="1087"/>
                  </a:lnTo>
                  <a:lnTo>
                    <a:pt x="1495" y="1086"/>
                  </a:lnTo>
                  <a:lnTo>
                    <a:pt x="1496" y="1086"/>
                  </a:lnTo>
                  <a:lnTo>
                    <a:pt x="1496" y="1085"/>
                  </a:lnTo>
                  <a:lnTo>
                    <a:pt x="1497" y="1085"/>
                  </a:lnTo>
                  <a:lnTo>
                    <a:pt x="1498" y="1084"/>
                  </a:lnTo>
                  <a:lnTo>
                    <a:pt x="1499" y="1084"/>
                  </a:lnTo>
                  <a:lnTo>
                    <a:pt x="1500" y="1084"/>
                  </a:lnTo>
                  <a:lnTo>
                    <a:pt x="1500" y="1085"/>
                  </a:lnTo>
                  <a:lnTo>
                    <a:pt x="1501" y="1085"/>
                  </a:lnTo>
                  <a:lnTo>
                    <a:pt x="1502" y="1086"/>
                  </a:lnTo>
                  <a:lnTo>
                    <a:pt x="1503" y="1087"/>
                  </a:lnTo>
                  <a:lnTo>
                    <a:pt x="1503" y="1088"/>
                  </a:lnTo>
                  <a:lnTo>
                    <a:pt x="1504" y="1088"/>
                  </a:lnTo>
                  <a:lnTo>
                    <a:pt x="1504" y="1089"/>
                  </a:lnTo>
                  <a:lnTo>
                    <a:pt x="1505" y="1090"/>
                  </a:lnTo>
                  <a:lnTo>
                    <a:pt x="1505" y="1091"/>
                  </a:lnTo>
                  <a:lnTo>
                    <a:pt x="1506" y="1092"/>
                  </a:lnTo>
                  <a:lnTo>
                    <a:pt x="1506" y="1093"/>
                  </a:lnTo>
                  <a:lnTo>
                    <a:pt x="1507" y="1094"/>
                  </a:lnTo>
                  <a:lnTo>
                    <a:pt x="1507" y="1095"/>
                  </a:lnTo>
                  <a:lnTo>
                    <a:pt x="1508" y="1096"/>
                  </a:lnTo>
                  <a:lnTo>
                    <a:pt x="1508" y="1097"/>
                  </a:lnTo>
                  <a:lnTo>
                    <a:pt x="1508" y="1098"/>
                  </a:lnTo>
                  <a:lnTo>
                    <a:pt x="1509" y="1099"/>
                  </a:lnTo>
                  <a:lnTo>
                    <a:pt x="1509" y="1100"/>
                  </a:lnTo>
                  <a:lnTo>
                    <a:pt x="1510" y="1101"/>
                  </a:lnTo>
                  <a:lnTo>
                    <a:pt x="1510" y="1102"/>
                  </a:lnTo>
                  <a:lnTo>
                    <a:pt x="1511" y="1103"/>
                  </a:lnTo>
                  <a:lnTo>
                    <a:pt x="1511" y="1104"/>
                  </a:lnTo>
                  <a:lnTo>
                    <a:pt x="1512" y="1105"/>
                  </a:lnTo>
                  <a:lnTo>
                    <a:pt x="1512" y="1106"/>
                  </a:lnTo>
                  <a:lnTo>
                    <a:pt x="1513" y="1107"/>
                  </a:lnTo>
                  <a:lnTo>
                    <a:pt x="1513" y="1108"/>
                  </a:lnTo>
                  <a:lnTo>
                    <a:pt x="1514" y="1109"/>
                  </a:lnTo>
                  <a:lnTo>
                    <a:pt x="1514" y="1110"/>
                  </a:lnTo>
                  <a:lnTo>
                    <a:pt x="1515" y="1111"/>
                  </a:lnTo>
                  <a:lnTo>
                    <a:pt x="1515" y="1112"/>
                  </a:lnTo>
                  <a:lnTo>
                    <a:pt x="1516" y="1113"/>
                  </a:lnTo>
                  <a:lnTo>
                    <a:pt x="1517" y="1114"/>
                  </a:lnTo>
                  <a:lnTo>
                    <a:pt x="1517" y="1115"/>
                  </a:lnTo>
                  <a:lnTo>
                    <a:pt x="1517" y="1116"/>
                  </a:lnTo>
                  <a:lnTo>
                    <a:pt x="1518" y="1117"/>
                  </a:lnTo>
                  <a:lnTo>
                    <a:pt x="1518" y="1118"/>
                  </a:lnTo>
                  <a:lnTo>
                    <a:pt x="1519" y="1118"/>
                  </a:lnTo>
                  <a:lnTo>
                    <a:pt x="1519" y="1119"/>
                  </a:lnTo>
                  <a:lnTo>
                    <a:pt x="1520" y="1120"/>
                  </a:lnTo>
                  <a:lnTo>
                    <a:pt x="1520" y="1121"/>
                  </a:lnTo>
                  <a:lnTo>
                    <a:pt x="1521" y="1122"/>
                  </a:lnTo>
                  <a:lnTo>
                    <a:pt x="1522" y="1123"/>
                  </a:lnTo>
                  <a:lnTo>
                    <a:pt x="1522" y="1124"/>
                  </a:lnTo>
                  <a:lnTo>
                    <a:pt x="1523" y="1125"/>
                  </a:lnTo>
                  <a:lnTo>
                    <a:pt x="1523" y="1126"/>
                  </a:lnTo>
                  <a:lnTo>
                    <a:pt x="1524" y="1127"/>
                  </a:lnTo>
                  <a:lnTo>
                    <a:pt x="1524" y="1128"/>
                  </a:lnTo>
                  <a:lnTo>
                    <a:pt x="1525" y="1129"/>
                  </a:lnTo>
                  <a:lnTo>
                    <a:pt x="1525" y="1130"/>
                  </a:lnTo>
                  <a:lnTo>
                    <a:pt x="1525" y="1131"/>
                  </a:lnTo>
                  <a:lnTo>
                    <a:pt x="1526" y="1132"/>
                  </a:lnTo>
                  <a:lnTo>
                    <a:pt x="1526" y="1133"/>
                  </a:lnTo>
                  <a:lnTo>
                    <a:pt x="1527" y="1134"/>
                  </a:lnTo>
                  <a:lnTo>
                    <a:pt x="1527" y="1135"/>
                  </a:lnTo>
                  <a:lnTo>
                    <a:pt x="1528" y="1137"/>
                  </a:lnTo>
                  <a:lnTo>
                    <a:pt x="1528" y="1138"/>
                  </a:lnTo>
                  <a:lnTo>
                    <a:pt x="1529" y="1139"/>
                  </a:lnTo>
                  <a:lnTo>
                    <a:pt x="1529" y="1140"/>
                  </a:lnTo>
                  <a:lnTo>
                    <a:pt x="1530" y="1141"/>
                  </a:lnTo>
                  <a:lnTo>
                    <a:pt x="1530" y="1142"/>
                  </a:lnTo>
                  <a:lnTo>
                    <a:pt x="1531" y="1143"/>
                  </a:lnTo>
                  <a:lnTo>
                    <a:pt x="1531" y="1144"/>
                  </a:lnTo>
                  <a:lnTo>
                    <a:pt x="1532" y="1145"/>
                  </a:lnTo>
                  <a:lnTo>
                    <a:pt x="1532" y="1146"/>
                  </a:lnTo>
                  <a:lnTo>
                    <a:pt x="1533" y="1147"/>
                  </a:lnTo>
                  <a:lnTo>
                    <a:pt x="1534" y="1148"/>
                  </a:lnTo>
                  <a:lnTo>
                    <a:pt x="1534" y="1149"/>
                  </a:lnTo>
                  <a:lnTo>
                    <a:pt x="1534" y="1150"/>
                  </a:lnTo>
                  <a:lnTo>
                    <a:pt x="1535" y="1150"/>
                  </a:lnTo>
                  <a:lnTo>
                    <a:pt x="1535" y="1151"/>
                  </a:lnTo>
                  <a:lnTo>
                    <a:pt x="1536" y="1151"/>
                  </a:lnTo>
                  <a:lnTo>
                    <a:pt x="1537" y="1152"/>
                  </a:lnTo>
                  <a:lnTo>
                    <a:pt x="1538" y="1152"/>
                  </a:lnTo>
                  <a:lnTo>
                    <a:pt x="1539" y="1152"/>
                  </a:lnTo>
                  <a:lnTo>
                    <a:pt x="1540" y="1153"/>
                  </a:lnTo>
                  <a:lnTo>
                    <a:pt x="1541" y="1153"/>
                  </a:lnTo>
                  <a:lnTo>
                    <a:pt x="1542" y="1153"/>
                  </a:lnTo>
                  <a:lnTo>
                    <a:pt x="1542" y="1154"/>
                  </a:lnTo>
                  <a:lnTo>
                    <a:pt x="1543" y="1154"/>
                  </a:lnTo>
                  <a:lnTo>
                    <a:pt x="1543" y="1155"/>
                  </a:lnTo>
                  <a:lnTo>
                    <a:pt x="1544" y="1155"/>
                  </a:lnTo>
                  <a:lnTo>
                    <a:pt x="1544" y="1156"/>
                  </a:lnTo>
                  <a:lnTo>
                    <a:pt x="1545" y="1157"/>
                  </a:lnTo>
                  <a:lnTo>
                    <a:pt x="1546" y="1158"/>
                  </a:lnTo>
                  <a:lnTo>
                    <a:pt x="1546" y="1159"/>
                  </a:lnTo>
                  <a:lnTo>
                    <a:pt x="1547" y="1160"/>
                  </a:lnTo>
                  <a:lnTo>
                    <a:pt x="1547" y="1162"/>
                  </a:lnTo>
                  <a:lnTo>
                    <a:pt x="1548" y="1163"/>
                  </a:lnTo>
                  <a:lnTo>
                    <a:pt x="1548" y="1165"/>
                  </a:lnTo>
                  <a:lnTo>
                    <a:pt x="1549" y="1167"/>
                  </a:lnTo>
                  <a:lnTo>
                    <a:pt x="1549" y="1169"/>
                  </a:lnTo>
                  <a:lnTo>
                    <a:pt x="1550" y="1171"/>
                  </a:lnTo>
                  <a:lnTo>
                    <a:pt x="1550" y="1173"/>
                  </a:lnTo>
                  <a:lnTo>
                    <a:pt x="1551" y="1176"/>
                  </a:lnTo>
                  <a:lnTo>
                    <a:pt x="1551" y="1178"/>
                  </a:lnTo>
                  <a:lnTo>
                    <a:pt x="1551" y="1180"/>
                  </a:lnTo>
                  <a:lnTo>
                    <a:pt x="1552" y="1182"/>
                  </a:lnTo>
                  <a:lnTo>
                    <a:pt x="1552" y="1185"/>
                  </a:lnTo>
                  <a:lnTo>
                    <a:pt x="1553" y="1187"/>
                  </a:lnTo>
                  <a:lnTo>
                    <a:pt x="1553" y="1189"/>
                  </a:lnTo>
                  <a:lnTo>
                    <a:pt x="1554" y="1191"/>
                  </a:lnTo>
                  <a:lnTo>
                    <a:pt x="1554" y="1193"/>
                  </a:lnTo>
                  <a:lnTo>
                    <a:pt x="1555" y="1195"/>
                  </a:lnTo>
                  <a:lnTo>
                    <a:pt x="1555" y="1197"/>
                  </a:lnTo>
                  <a:lnTo>
                    <a:pt x="1556" y="1199"/>
                  </a:lnTo>
                  <a:lnTo>
                    <a:pt x="1556" y="1201"/>
                  </a:lnTo>
                  <a:lnTo>
                    <a:pt x="1557" y="1202"/>
                  </a:lnTo>
                  <a:lnTo>
                    <a:pt x="1557" y="1203"/>
                  </a:lnTo>
                  <a:lnTo>
                    <a:pt x="1558" y="1205"/>
                  </a:lnTo>
                  <a:lnTo>
                    <a:pt x="1558" y="1206"/>
                  </a:lnTo>
                  <a:lnTo>
                    <a:pt x="1559" y="1206"/>
                  </a:lnTo>
                  <a:lnTo>
                    <a:pt x="1559" y="1207"/>
                  </a:lnTo>
                  <a:lnTo>
                    <a:pt x="1560" y="1207"/>
                  </a:lnTo>
                  <a:lnTo>
                    <a:pt x="1560" y="1206"/>
                  </a:lnTo>
                  <a:lnTo>
                    <a:pt x="1561" y="1205"/>
                  </a:lnTo>
                  <a:lnTo>
                    <a:pt x="1561" y="1204"/>
                  </a:lnTo>
                  <a:lnTo>
                    <a:pt x="1562" y="1203"/>
                  </a:lnTo>
                  <a:lnTo>
                    <a:pt x="1562" y="1202"/>
                  </a:lnTo>
                  <a:lnTo>
                    <a:pt x="1563" y="1201"/>
                  </a:lnTo>
                  <a:lnTo>
                    <a:pt x="1563" y="1200"/>
                  </a:lnTo>
                  <a:lnTo>
                    <a:pt x="1564" y="1198"/>
                  </a:lnTo>
                  <a:lnTo>
                    <a:pt x="1564" y="1197"/>
                  </a:lnTo>
                  <a:lnTo>
                    <a:pt x="1565" y="1196"/>
                  </a:lnTo>
                  <a:lnTo>
                    <a:pt x="1565" y="1194"/>
                  </a:lnTo>
                  <a:lnTo>
                    <a:pt x="1566" y="1193"/>
                  </a:lnTo>
                  <a:lnTo>
                    <a:pt x="1566" y="1192"/>
                  </a:lnTo>
                  <a:lnTo>
                    <a:pt x="1567" y="1191"/>
                  </a:lnTo>
                  <a:lnTo>
                    <a:pt x="1567" y="1190"/>
                  </a:lnTo>
                  <a:lnTo>
                    <a:pt x="1568" y="1189"/>
                  </a:lnTo>
                  <a:lnTo>
                    <a:pt x="1568" y="1188"/>
                  </a:lnTo>
                  <a:lnTo>
                    <a:pt x="1568" y="1187"/>
                  </a:lnTo>
                  <a:lnTo>
                    <a:pt x="1569" y="1187"/>
                  </a:lnTo>
                  <a:lnTo>
                    <a:pt x="1570" y="1187"/>
                  </a:lnTo>
                  <a:lnTo>
                    <a:pt x="1571" y="1187"/>
                  </a:lnTo>
                  <a:lnTo>
                    <a:pt x="1571" y="1188"/>
                  </a:lnTo>
                  <a:lnTo>
                    <a:pt x="1572" y="1190"/>
                  </a:lnTo>
                  <a:lnTo>
                    <a:pt x="1572" y="1191"/>
                  </a:lnTo>
                  <a:lnTo>
                    <a:pt x="1573" y="1193"/>
                  </a:lnTo>
                  <a:lnTo>
                    <a:pt x="1573" y="1195"/>
                  </a:lnTo>
                  <a:lnTo>
                    <a:pt x="1574" y="1198"/>
                  </a:lnTo>
                  <a:lnTo>
                    <a:pt x="1574" y="1200"/>
                  </a:lnTo>
                  <a:lnTo>
                    <a:pt x="1575" y="1203"/>
                  </a:lnTo>
                  <a:lnTo>
                    <a:pt x="1575" y="1206"/>
                  </a:lnTo>
                  <a:lnTo>
                    <a:pt x="1576" y="1208"/>
                  </a:lnTo>
                  <a:lnTo>
                    <a:pt x="1576" y="1211"/>
                  </a:lnTo>
                  <a:lnTo>
                    <a:pt x="1577" y="1215"/>
                  </a:lnTo>
                  <a:lnTo>
                    <a:pt x="1577" y="1218"/>
                  </a:lnTo>
                  <a:lnTo>
                    <a:pt x="1577" y="1221"/>
                  </a:lnTo>
                  <a:lnTo>
                    <a:pt x="1578" y="1224"/>
                  </a:lnTo>
                  <a:lnTo>
                    <a:pt x="1578" y="1227"/>
                  </a:lnTo>
                  <a:lnTo>
                    <a:pt x="1579" y="1231"/>
                  </a:lnTo>
                  <a:lnTo>
                    <a:pt x="1579" y="1234"/>
                  </a:lnTo>
                  <a:lnTo>
                    <a:pt x="1580" y="1237"/>
                  </a:lnTo>
                  <a:lnTo>
                    <a:pt x="1580" y="1241"/>
                  </a:lnTo>
                  <a:lnTo>
                    <a:pt x="1581" y="1244"/>
                  </a:lnTo>
                  <a:lnTo>
                    <a:pt x="1581" y="1247"/>
                  </a:lnTo>
                  <a:lnTo>
                    <a:pt x="1582" y="1250"/>
                  </a:lnTo>
                  <a:lnTo>
                    <a:pt x="1582" y="1253"/>
                  </a:lnTo>
                  <a:lnTo>
                    <a:pt x="1583" y="1255"/>
                  </a:lnTo>
                  <a:lnTo>
                    <a:pt x="1583" y="1258"/>
                  </a:lnTo>
                  <a:lnTo>
                    <a:pt x="1584" y="1260"/>
                  </a:lnTo>
                  <a:lnTo>
                    <a:pt x="1584" y="1262"/>
                  </a:lnTo>
                  <a:lnTo>
                    <a:pt x="1585" y="1263"/>
                  </a:lnTo>
                  <a:lnTo>
                    <a:pt x="1585" y="1265"/>
                  </a:lnTo>
                  <a:lnTo>
                    <a:pt x="1585" y="1267"/>
                  </a:lnTo>
                  <a:lnTo>
                    <a:pt x="1586" y="1268"/>
                  </a:lnTo>
                  <a:lnTo>
                    <a:pt x="1586" y="1269"/>
                  </a:lnTo>
                  <a:lnTo>
                    <a:pt x="1587" y="1270"/>
                  </a:lnTo>
                  <a:lnTo>
                    <a:pt x="1587" y="1271"/>
                  </a:lnTo>
                  <a:lnTo>
                    <a:pt x="1588" y="1272"/>
                  </a:lnTo>
                  <a:lnTo>
                    <a:pt x="1588" y="1273"/>
                  </a:lnTo>
                  <a:lnTo>
                    <a:pt x="1589" y="1274"/>
                  </a:lnTo>
                  <a:lnTo>
                    <a:pt x="1590" y="1274"/>
                  </a:lnTo>
                  <a:lnTo>
                    <a:pt x="1590" y="1275"/>
                  </a:lnTo>
                  <a:lnTo>
                    <a:pt x="1591" y="1275"/>
                  </a:lnTo>
                  <a:lnTo>
                    <a:pt x="1592" y="1275"/>
                  </a:lnTo>
                  <a:lnTo>
                    <a:pt x="1593" y="1274"/>
                  </a:lnTo>
                  <a:lnTo>
                    <a:pt x="1594" y="1273"/>
                  </a:lnTo>
                  <a:lnTo>
                    <a:pt x="1594" y="1272"/>
                  </a:lnTo>
                  <a:lnTo>
                    <a:pt x="1595" y="1271"/>
                  </a:lnTo>
                  <a:lnTo>
                    <a:pt x="1595" y="1270"/>
                  </a:lnTo>
                  <a:lnTo>
                    <a:pt x="1596" y="1269"/>
                  </a:lnTo>
                  <a:lnTo>
                    <a:pt x="1596" y="1267"/>
                  </a:lnTo>
                  <a:lnTo>
                    <a:pt x="1597" y="1266"/>
                  </a:lnTo>
                  <a:lnTo>
                    <a:pt x="1597" y="1265"/>
                  </a:lnTo>
                  <a:lnTo>
                    <a:pt x="1598" y="1263"/>
                  </a:lnTo>
                  <a:lnTo>
                    <a:pt x="1598" y="1262"/>
                  </a:lnTo>
                  <a:lnTo>
                    <a:pt x="1599" y="1260"/>
                  </a:lnTo>
                  <a:lnTo>
                    <a:pt x="1599" y="1259"/>
                  </a:lnTo>
                  <a:lnTo>
                    <a:pt x="1600" y="1257"/>
                  </a:lnTo>
                  <a:lnTo>
                    <a:pt x="1600" y="1256"/>
                  </a:lnTo>
                  <a:lnTo>
                    <a:pt x="1601" y="1254"/>
                  </a:lnTo>
                  <a:lnTo>
                    <a:pt x="1601" y="1253"/>
                  </a:lnTo>
                  <a:lnTo>
                    <a:pt x="1602" y="1251"/>
                  </a:lnTo>
                  <a:lnTo>
                    <a:pt x="1602" y="1250"/>
                  </a:lnTo>
                  <a:lnTo>
                    <a:pt x="1603" y="1248"/>
                  </a:lnTo>
                  <a:lnTo>
                    <a:pt x="1603" y="1247"/>
                  </a:lnTo>
                  <a:lnTo>
                    <a:pt x="1603" y="1246"/>
                  </a:lnTo>
                  <a:lnTo>
                    <a:pt x="1604" y="1245"/>
                  </a:lnTo>
                  <a:lnTo>
                    <a:pt x="1604" y="1244"/>
                  </a:lnTo>
                  <a:lnTo>
                    <a:pt x="1605" y="1243"/>
                  </a:lnTo>
                  <a:lnTo>
                    <a:pt x="1605" y="1242"/>
                  </a:lnTo>
                  <a:lnTo>
                    <a:pt x="1606" y="1241"/>
                  </a:lnTo>
                  <a:lnTo>
                    <a:pt x="1606" y="1240"/>
                  </a:lnTo>
                  <a:lnTo>
                    <a:pt x="1607" y="1240"/>
                  </a:lnTo>
                  <a:lnTo>
                    <a:pt x="1608" y="1240"/>
                  </a:lnTo>
                  <a:lnTo>
                    <a:pt x="1609" y="1240"/>
                  </a:lnTo>
                  <a:lnTo>
                    <a:pt x="1610" y="1240"/>
                  </a:lnTo>
                  <a:lnTo>
                    <a:pt x="1611" y="1240"/>
                  </a:lnTo>
                  <a:lnTo>
                    <a:pt x="1612" y="1240"/>
                  </a:lnTo>
                  <a:lnTo>
                    <a:pt x="1613" y="1240"/>
                  </a:lnTo>
                  <a:lnTo>
                    <a:pt x="1614" y="1239"/>
                  </a:lnTo>
                  <a:lnTo>
                    <a:pt x="1615" y="1238"/>
                  </a:lnTo>
                  <a:lnTo>
                    <a:pt x="1615" y="1237"/>
                  </a:lnTo>
                  <a:lnTo>
                    <a:pt x="1616" y="1236"/>
                  </a:lnTo>
                  <a:lnTo>
                    <a:pt x="1616" y="1235"/>
                  </a:lnTo>
                  <a:lnTo>
                    <a:pt x="1617" y="1233"/>
                  </a:lnTo>
                  <a:lnTo>
                    <a:pt x="1617" y="1231"/>
                  </a:lnTo>
                  <a:lnTo>
                    <a:pt x="1618" y="1229"/>
                  </a:lnTo>
                  <a:lnTo>
                    <a:pt x="1618" y="1227"/>
                  </a:lnTo>
                  <a:lnTo>
                    <a:pt x="1619" y="1223"/>
                  </a:lnTo>
                  <a:lnTo>
                    <a:pt x="1619" y="1220"/>
                  </a:lnTo>
                  <a:lnTo>
                    <a:pt x="1620" y="1216"/>
                  </a:lnTo>
                  <a:lnTo>
                    <a:pt x="1620" y="1212"/>
                  </a:lnTo>
                  <a:lnTo>
                    <a:pt x="1620" y="1208"/>
                  </a:lnTo>
                  <a:lnTo>
                    <a:pt x="1621" y="1203"/>
                  </a:lnTo>
                  <a:lnTo>
                    <a:pt x="1621" y="1199"/>
                  </a:lnTo>
                  <a:lnTo>
                    <a:pt x="1622" y="1194"/>
                  </a:lnTo>
                  <a:lnTo>
                    <a:pt x="1622" y="1189"/>
                  </a:lnTo>
                  <a:lnTo>
                    <a:pt x="1623" y="1184"/>
                  </a:lnTo>
                  <a:lnTo>
                    <a:pt x="1623" y="1179"/>
                  </a:lnTo>
                  <a:lnTo>
                    <a:pt x="1624" y="1174"/>
                  </a:lnTo>
                  <a:lnTo>
                    <a:pt x="1624" y="1169"/>
                  </a:lnTo>
                  <a:lnTo>
                    <a:pt x="1625" y="1164"/>
                  </a:lnTo>
                  <a:lnTo>
                    <a:pt x="1625" y="1159"/>
                  </a:lnTo>
                  <a:lnTo>
                    <a:pt x="1626" y="1155"/>
                  </a:lnTo>
                  <a:lnTo>
                    <a:pt x="1626" y="1150"/>
                  </a:lnTo>
                  <a:lnTo>
                    <a:pt x="1627" y="1145"/>
                  </a:lnTo>
                  <a:lnTo>
                    <a:pt x="1627" y="1141"/>
                  </a:lnTo>
                  <a:lnTo>
                    <a:pt x="1628" y="1137"/>
                  </a:lnTo>
                  <a:lnTo>
                    <a:pt x="1628" y="1133"/>
                  </a:lnTo>
                  <a:lnTo>
                    <a:pt x="1628" y="1129"/>
                  </a:lnTo>
                  <a:lnTo>
                    <a:pt x="1629" y="1125"/>
                  </a:lnTo>
                  <a:lnTo>
                    <a:pt x="1629" y="1122"/>
                  </a:lnTo>
                  <a:lnTo>
                    <a:pt x="1630" y="1119"/>
                  </a:lnTo>
                  <a:lnTo>
                    <a:pt x="1630" y="1117"/>
                  </a:lnTo>
                  <a:lnTo>
                    <a:pt x="1631" y="1115"/>
                  </a:lnTo>
                  <a:lnTo>
                    <a:pt x="1631" y="1114"/>
                  </a:lnTo>
                  <a:lnTo>
                    <a:pt x="1632" y="1113"/>
                  </a:lnTo>
                  <a:lnTo>
                    <a:pt x="1632" y="1112"/>
                  </a:lnTo>
                  <a:lnTo>
                    <a:pt x="1633" y="1111"/>
                  </a:lnTo>
                  <a:lnTo>
                    <a:pt x="1634" y="1111"/>
                  </a:lnTo>
                  <a:lnTo>
                    <a:pt x="1634" y="1110"/>
                  </a:lnTo>
                  <a:lnTo>
                    <a:pt x="1635" y="1111"/>
                  </a:lnTo>
                  <a:lnTo>
                    <a:pt x="1636" y="1111"/>
                  </a:lnTo>
                  <a:lnTo>
                    <a:pt x="1636" y="1112"/>
                  </a:lnTo>
                  <a:lnTo>
                    <a:pt x="1637" y="1113"/>
                  </a:lnTo>
                  <a:lnTo>
                    <a:pt x="1637" y="1114"/>
                  </a:lnTo>
                  <a:lnTo>
                    <a:pt x="1638" y="1115"/>
                  </a:lnTo>
                  <a:lnTo>
                    <a:pt x="1638" y="1116"/>
                  </a:lnTo>
                  <a:lnTo>
                    <a:pt x="1639" y="1117"/>
                  </a:lnTo>
                  <a:lnTo>
                    <a:pt x="1639" y="1118"/>
                  </a:lnTo>
                  <a:lnTo>
                    <a:pt x="1640" y="1119"/>
                  </a:lnTo>
                  <a:lnTo>
                    <a:pt x="1640" y="1120"/>
                  </a:lnTo>
                  <a:lnTo>
                    <a:pt x="1641" y="1121"/>
                  </a:lnTo>
                  <a:lnTo>
                    <a:pt x="1642" y="1122"/>
                  </a:lnTo>
                  <a:lnTo>
                    <a:pt x="1643" y="1123"/>
                  </a:lnTo>
                  <a:lnTo>
                    <a:pt x="1644" y="1123"/>
                  </a:lnTo>
                  <a:lnTo>
                    <a:pt x="1644" y="1122"/>
                  </a:lnTo>
                  <a:lnTo>
                    <a:pt x="1645" y="1122"/>
                  </a:lnTo>
                  <a:lnTo>
                    <a:pt x="1646" y="1121"/>
                  </a:lnTo>
                  <a:lnTo>
                    <a:pt x="1647" y="1120"/>
                  </a:lnTo>
                  <a:lnTo>
                    <a:pt x="1648" y="1119"/>
                  </a:lnTo>
                  <a:lnTo>
                    <a:pt x="1648" y="1118"/>
                  </a:lnTo>
                  <a:lnTo>
                    <a:pt x="1649" y="1118"/>
                  </a:lnTo>
                  <a:lnTo>
                    <a:pt x="1649" y="1117"/>
                  </a:lnTo>
                  <a:lnTo>
                    <a:pt x="1650" y="1116"/>
                  </a:lnTo>
                  <a:lnTo>
                    <a:pt x="1650" y="1115"/>
                  </a:lnTo>
                  <a:lnTo>
                    <a:pt x="1651" y="1114"/>
                  </a:lnTo>
                  <a:lnTo>
                    <a:pt x="1651" y="1113"/>
                  </a:lnTo>
                  <a:lnTo>
                    <a:pt x="1652" y="1112"/>
                  </a:lnTo>
                  <a:lnTo>
                    <a:pt x="1652" y="1111"/>
                  </a:lnTo>
                  <a:lnTo>
                    <a:pt x="1653" y="1110"/>
                  </a:lnTo>
                  <a:lnTo>
                    <a:pt x="1653" y="1109"/>
                  </a:lnTo>
                  <a:lnTo>
                    <a:pt x="1654" y="1108"/>
                  </a:lnTo>
                  <a:lnTo>
                    <a:pt x="1654" y="1107"/>
                  </a:lnTo>
                  <a:lnTo>
                    <a:pt x="1655" y="1107"/>
                  </a:lnTo>
                  <a:lnTo>
                    <a:pt x="1655" y="1106"/>
                  </a:lnTo>
                  <a:lnTo>
                    <a:pt x="1656" y="1105"/>
                  </a:lnTo>
                  <a:lnTo>
                    <a:pt x="1657" y="1104"/>
                  </a:lnTo>
                  <a:lnTo>
                    <a:pt x="1657" y="1103"/>
                  </a:lnTo>
                  <a:lnTo>
                    <a:pt x="1658" y="1103"/>
                  </a:lnTo>
                  <a:lnTo>
                    <a:pt x="1658" y="1102"/>
                  </a:lnTo>
                  <a:lnTo>
                    <a:pt x="1659" y="1101"/>
                  </a:lnTo>
                  <a:lnTo>
                    <a:pt x="1659" y="1100"/>
                  </a:lnTo>
                  <a:lnTo>
                    <a:pt x="1660" y="1100"/>
                  </a:lnTo>
                  <a:lnTo>
                    <a:pt x="1660" y="1099"/>
                  </a:lnTo>
                  <a:lnTo>
                    <a:pt x="1661" y="1098"/>
                  </a:lnTo>
                  <a:lnTo>
                    <a:pt x="1661" y="1097"/>
                  </a:lnTo>
                  <a:lnTo>
                    <a:pt x="1662" y="1096"/>
                  </a:lnTo>
                  <a:lnTo>
                    <a:pt x="1662" y="1095"/>
                  </a:lnTo>
                  <a:lnTo>
                    <a:pt x="1663" y="1094"/>
                  </a:lnTo>
                  <a:lnTo>
                    <a:pt x="1663" y="1093"/>
                  </a:lnTo>
                  <a:lnTo>
                    <a:pt x="1664" y="1092"/>
                  </a:lnTo>
                  <a:lnTo>
                    <a:pt x="1664" y="1091"/>
                  </a:lnTo>
                  <a:lnTo>
                    <a:pt x="1665" y="1090"/>
                  </a:lnTo>
                  <a:lnTo>
                    <a:pt x="1665" y="1089"/>
                  </a:lnTo>
                  <a:lnTo>
                    <a:pt x="1666" y="1088"/>
                  </a:lnTo>
                  <a:lnTo>
                    <a:pt x="1666" y="1086"/>
                  </a:lnTo>
                  <a:lnTo>
                    <a:pt x="1667" y="1085"/>
                  </a:lnTo>
                  <a:lnTo>
                    <a:pt x="1667" y="1084"/>
                  </a:lnTo>
                  <a:lnTo>
                    <a:pt x="1668" y="1083"/>
                  </a:lnTo>
                  <a:lnTo>
                    <a:pt x="1668" y="1081"/>
                  </a:lnTo>
                  <a:lnTo>
                    <a:pt x="1669" y="1080"/>
                  </a:lnTo>
                  <a:lnTo>
                    <a:pt x="1669" y="1079"/>
                  </a:lnTo>
                  <a:lnTo>
                    <a:pt x="1670" y="1078"/>
                  </a:lnTo>
                  <a:lnTo>
                    <a:pt x="1670" y="1076"/>
                  </a:lnTo>
                  <a:lnTo>
                    <a:pt x="1671" y="1075"/>
                  </a:lnTo>
                  <a:lnTo>
                    <a:pt x="1671" y="1074"/>
                  </a:lnTo>
                  <a:lnTo>
                    <a:pt x="1671" y="1072"/>
                  </a:lnTo>
                  <a:lnTo>
                    <a:pt x="1672" y="1071"/>
                  </a:lnTo>
                  <a:lnTo>
                    <a:pt x="1672" y="1070"/>
                  </a:lnTo>
                  <a:lnTo>
                    <a:pt x="1673" y="1069"/>
                  </a:lnTo>
                  <a:lnTo>
                    <a:pt x="1673" y="1068"/>
                  </a:lnTo>
                  <a:lnTo>
                    <a:pt x="1674" y="1067"/>
                  </a:lnTo>
                  <a:lnTo>
                    <a:pt x="1674" y="1065"/>
                  </a:lnTo>
                  <a:lnTo>
                    <a:pt x="1675" y="1064"/>
                  </a:lnTo>
                  <a:lnTo>
                    <a:pt x="1675" y="1063"/>
                  </a:lnTo>
                  <a:lnTo>
                    <a:pt x="1676" y="1062"/>
                  </a:lnTo>
                  <a:lnTo>
                    <a:pt x="1677" y="1061"/>
                  </a:lnTo>
                  <a:lnTo>
                    <a:pt x="1677" y="1060"/>
                  </a:lnTo>
                  <a:lnTo>
                    <a:pt x="1678" y="1060"/>
                  </a:lnTo>
                  <a:lnTo>
                    <a:pt x="1678" y="1059"/>
                  </a:lnTo>
                  <a:lnTo>
                    <a:pt x="1679" y="1059"/>
                  </a:lnTo>
                  <a:lnTo>
                    <a:pt x="1679" y="1058"/>
                  </a:lnTo>
                  <a:lnTo>
                    <a:pt x="1680" y="1058"/>
                  </a:lnTo>
                  <a:lnTo>
                    <a:pt x="1681" y="1057"/>
                  </a:lnTo>
                  <a:lnTo>
                    <a:pt x="1682" y="1057"/>
                  </a:lnTo>
                  <a:lnTo>
                    <a:pt x="1683" y="1057"/>
                  </a:lnTo>
                  <a:lnTo>
                    <a:pt x="1684" y="1058"/>
                  </a:lnTo>
                  <a:lnTo>
                    <a:pt x="1685" y="1058"/>
                  </a:lnTo>
                  <a:lnTo>
                    <a:pt x="1686" y="1058"/>
                  </a:lnTo>
                  <a:lnTo>
                    <a:pt x="1686" y="1059"/>
                  </a:lnTo>
                  <a:lnTo>
                    <a:pt x="1687" y="1059"/>
                  </a:lnTo>
                  <a:lnTo>
                    <a:pt x="1688" y="1059"/>
                  </a:lnTo>
                  <a:lnTo>
                    <a:pt x="1688" y="1060"/>
                  </a:lnTo>
                  <a:lnTo>
                    <a:pt x="1689" y="1060"/>
                  </a:lnTo>
                  <a:lnTo>
                    <a:pt x="1690" y="1060"/>
                  </a:lnTo>
                  <a:lnTo>
                    <a:pt x="1690" y="1061"/>
                  </a:lnTo>
                  <a:lnTo>
                    <a:pt x="1691" y="1061"/>
                  </a:lnTo>
                  <a:lnTo>
                    <a:pt x="1692" y="1061"/>
                  </a:lnTo>
                  <a:lnTo>
                    <a:pt x="1693" y="1061"/>
                  </a:lnTo>
                  <a:lnTo>
                    <a:pt x="1693" y="1062"/>
                  </a:lnTo>
                  <a:lnTo>
                    <a:pt x="1694" y="1062"/>
                  </a:lnTo>
                  <a:lnTo>
                    <a:pt x="1695" y="1062"/>
                  </a:lnTo>
                  <a:lnTo>
                    <a:pt x="1695" y="1063"/>
                  </a:lnTo>
                  <a:lnTo>
                    <a:pt x="1696" y="1063"/>
                  </a:lnTo>
                  <a:lnTo>
                    <a:pt x="1697" y="1064"/>
                  </a:lnTo>
                  <a:lnTo>
                    <a:pt x="1697" y="1065"/>
                  </a:lnTo>
                  <a:lnTo>
                    <a:pt x="1698" y="1065"/>
                  </a:lnTo>
                  <a:lnTo>
                    <a:pt x="1698" y="1066"/>
                  </a:lnTo>
                  <a:lnTo>
                    <a:pt x="1699" y="1066"/>
                  </a:lnTo>
                  <a:lnTo>
                    <a:pt x="1699" y="1067"/>
                  </a:lnTo>
                  <a:lnTo>
                    <a:pt x="1700" y="1068"/>
                  </a:lnTo>
                  <a:lnTo>
                    <a:pt x="1701" y="1069"/>
                  </a:lnTo>
                  <a:lnTo>
                    <a:pt x="1701" y="1070"/>
                  </a:lnTo>
                  <a:lnTo>
                    <a:pt x="1702" y="1072"/>
                  </a:lnTo>
                  <a:lnTo>
                    <a:pt x="1702" y="1073"/>
                  </a:lnTo>
                  <a:lnTo>
                    <a:pt x="1703" y="1074"/>
                  </a:lnTo>
                  <a:lnTo>
                    <a:pt x="1703" y="1075"/>
                  </a:lnTo>
                  <a:lnTo>
                    <a:pt x="1704" y="1077"/>
                  </a:lnTo>
                  <a:lnTo>
                    <a:pt x="1704" y="1078"/>
                  </a:lnTo>
                  <a:lnTo>
                    <a:pt x="1705" y="1079"/>
                  </a:lnTo>
                  <a:lnTo>
                    <a:pt x="1705" y="1081"/>
                  </a:lnTo>
                  <a:lnTo>
                    <a:pt x="1705" y="1082"/>
                  </a:lnTo>
                  <a:lnTo>
                    <a:pt x="1706" y="1083"/>
                  </a:lnTo>
                  <a:lnTo>
                    <a:pt x="1706" y="1084"/>
                  </a:lnTo>
                  <a:lnTo>
                    <a:pt x="1707" y="1085"/>
                  </a:lnTo>
                  <a:lnTo>
                    <a:pt x="1707" y="1086"/>
                  </a:lnTo>
                  <a:lnTo>
                    <a:pt x="1708" y="1087"/>
                  </a:lnTo>
                  <a:lnTo>
                    <a:pt x="1708" y="1088"/>
                  </a:lnTo>
                  <a:lnTo>
                    <a:pt x="1709" y="1089"/>
                  </a:lnTo>
                  <a:lnTo>
                    <a:pt x="1709" y="1090"/>
                  </a:lnTo>
                  <a:lnTo>
                    <a:pt x="1710" y="1090"/>
                  </a:lnTo>
                  <a:lnTo>
                    <a:pt x="1711" y="1091"/>
                  </a:lnTo>
                  <a:lnTo>
                    <a:pt x="1712" y="1091"/>
                  </a:lnTo>
                  <a:lnTo>
                    <a:pt x="1713" y="1090"/>
                  </a:lnTo>
                  <a:lnTo>
                    <a:pt x="1713" y="1089"/>
                  </a:lnTo>
                  <a:lnTo>
                    <a:pt x="1714" y="1088"/>
                  </a:lnTo>
                  <a:lnTo>
                    <a:pt x="1714" y="1087"/>
                  </a:lnTo>
                  <a:lnTo>
                    <a:pt x="1714" y="1085"/>
                  </a:lnTo>
                  <a:lnTo>
                    <a:pt x="1715" y="1084"/>
                  </a:lnTo>
                  <a:lnTo>
                    <a:pt x="1715" y="1082"/>
                  </a:lnTo>
                  <a:lnTo>
                    <a:pt x="1716" y="1080"/>
                  </a:lnTo>
                  <a:lnTo>
                    <a:pt x="1716" y="1079"/>
                  </a:lnTo>
                  <a:lnTo>
                    <a:pt x="1717" y="1077"/>
                  </a:lnTo>
                  <a:lnTo>
                    <a:pt x="1717" y="1075"/>
                  </a:lnTo>
                  <a:lnTo>
                    <a:pt x="1718" y="1073"/>
                  </a:lnTo>
                  <a:lnTo>
                    <a:pt x="1718" y="1072"/>
                  </a:lnTo>
                  <a:lnTo>
                    <a:pt x="1719" y="1070"/>
                  </a:lnTo>
                  <a:lnTo>
                    <a:pt x="1719" y="1068"/>
                  </a:lnTo>
                  <a:lnTo>
                    <a:pt x="1720" y="1067"/>
                  </a:lnTo>
                  <a:lnTo>
                    <a:pt x="1720" y="1065"/>
                  </a:lnTo>
                  <a:lnTo>
                    <a:pt x="1721" y="1064"/>
                  </a:lnTo>
                  <a:lnTo>
                    <a:pt x="1721" y="1063"/>
                  </a:lnTo>
                  <a:lnTo>
                    <a:pt x="1722" y="1062"/>
                  </a:lnTo>
                  <a:lnTo>
                    <a:pt x="1722" y="1061"/>
                  </a:lnTo>
                  <a:lnTo>
                    <a:pt x="1723" y="1061"/>
                  </a:lnTo>
                  <a:lnTo>
                    <a:pt x="1724" y="1061"/>
                  </a:lnTo>
                  <a:lnTo>
                    <a:pt x="1724" y="1062"/>
                  </a:lnTo>
                  <a:lnTo>
                    <a:pt x="1725" y="1063"/>
                  </a:lnTo>
                  <a:lnTo>
                    <a:pt x="1725" y="1065"/>
                  </a:lnTo>
                  <a:lnTo>
                    <a:pt x="1726" y="1067"/>
                  </a:lnTo>
                  <a:lnTo>
                    <a:pt x="1726" y="1069"/>
                  </a:lnTo>
                  <a:lnTo>
                    <a:pt x="1727" y="1071"/>
                  </a:lnTo>
                  <a:lnTo>
                    <a:pt x="1727" y="1074"/>
                  </a:lnTo>
                  <a:lnTo>
                    <a:pt x="1728" y="1077"/>
                  </a:lnTo>
                  <a:lnTo>
                    <a:pt x="1728" y="1080"/>
                  </a:lnTo>
                  <a:lnTo>
                    <a:pt x="1729" y="1083"/>
                  </a:lnTo>
                  <a:lnTo>
                    <a:pt x="1729" y="1086"/>
                  </a:lnTo>
                  <a:lnTo>
                    <a:pt x="1730" y="1089"/>
                  </a:lnTo>
                  <a:lnTo>
                    <a:pt x="1730" y="1092"/>
                  </a:lnTo>
                  <a:lnTo>
                    <a:pt x="1731" y="1095"/>
                  </a:lnTo>
                  <a:lnTo>
                    <a:pt x="1731" y="1098"/>
                  </a:lnTo>
                  <a:lnTo>
                    <a:pt x="1731" y="1102"/>
                  </a:lnTo>
                  <a:lnTo>
                    <a:pt x="1732" y="1105"/>
                  </a:lnTo>
                  <a:lnTo>
                    <a:pt x="1732" y="1108"/>
                  </a:lnTo>
                  <a:lnTo>
                    <a:pt x="1733" y="1110"/>
                  </a:lnTo>
                  <a:lnTo>
                    <a:pt x="1733" y="1113"/>
                  </a:lnTo>
                  <a:lnTo>
                    <a:pt x="1734" y="1116"/>
                  </a:lnTo>
                  <a:lnTo>
                    <a:pt x="1734" y="1118"/>
                  </a:lnTo>
                  <a:lnTo>
                    <a:pt x="1735" y="1120"/>
                  </a:lnTo>
                  <a:lnTo>
                    <a:pt x="1735" y="1122"/>
                  </a:lnTo>
                  <a:lnTo>
                    <a:pt x="1736" y="1124"/>
                  </a:lnTo>
                  <a:lnTo>
                    <a:pt x="1736" y="1125"/>
                  </a:lnTo>
                  <a:lnTo>
                    <a:pt x="1737" y="1126"/>
                  </a:lnTo>
                  <a:lnTo>
                    <a:pt x="1738" y="1126"/>
                  </a:lnTo>
                  <a:lnTo>
                    <a:pt x="1739" y="1126"/>
                  </a:lnTo>
                  <a:lnTo>
                    <a:pt x="1739" y="1125"/>
                  </a:lnTo>
                  <a:lnTo>
                    <a:pt x="1739" y="1124"/>
                  </a:lnTo>
                  <a:lnTo>
                    <a:pt x="1740" y="1123"/>
                  </a:lnTo>
                  <a:lnTo>
                    <a:pt x="1740" y="1122"/>
                  </a:lnTo>
                  <a:lnTo>
                    <a:pt x="1741" y="1120"/>
                  </a:lnTo>
                  <a:lnTo>
                    <a:pt x="1741" y="1119"/>
                  </a:lnTo>
                  <a:lnTo>
                    <a:pt x="1742" y="1117"/>
                  </a:lnTo>
                  <a:lnTo>
                    <a:pt x="1742" y="1115"/>
                  </a:lnTo>
                  <a:lnTo>
                    <a:pt x="1743" y="1113"/>
                  </a:lnTo>
                  <a:lnTo>
                    <a:pt x="1743" y="1111"/>
                  </a:lnTo>
                  <a:lnTo>
                    <a:pt x="1744" y="1108"/>
                  </a:lnTo>
                  <a:lnTo>
                    <a:pt x="1744" y="1106"/>
                  </a:lnTo>
                  <a:lnTo>
                    <a:pt x="1745" y="1103"/>
                  </a:lnTo>
                  <a:lnTo>
                    <a:pt x="1745" y="1101"/>
                  </a:lnTo>
                  <a:lnTo>
                    <a:pt x="1746" y="1098"/>
                  </a:lnTo>
                  <a:lnTo>
                    <a:pt x="1746" y="1095"/>
                  </a:lnTo>
                  <a:lnTo>
                    <a:pt x="1747" y="1092"/>
                  </a:lnTo>
                  <a:lnTo>
                    <a:pt x="1747" y="1090"/>
                  </a:lnTo>
                  <a:lnTo>
                    <a:pt x="1748" y="1087"/>
                  </a:lnTo>
                  <a:lnTo>
                    <a:pt x="1748" y="1084"/>
                  </a:lnTo>
                  <a:lnTo>
                    <a:pt x="1748" y="1082"/>
                  </a:lnTo>
                  <a:lnTo>
                    <a:pt x="1749" y="1079"/>
                  </a:lnTo>
                  <a:lnTo>
                    <a:pt x="1749" y="1077"/>
                  </a:lnTo>
                  <a:lnTo>
                    <a:pt x="1750" y="1074"/>
                  </a:lnTo>
                  <a:lnTo>
                    <a:pt x="1750" y="1072"/>
                  </a:lnTo>
                  <a:lnTo>
                    <a:pt x="1751" y="1070"/>
                  </a:lnTo>
                  <a:lnTo>
                    <a:pt x="1751" y="1067"/>
                  </a:lnTo>
                  <a:lnTo>
                    <a:pt x="1752" y="1065"/>
                  </a:lnTo>
                  <a:lnTo>
                    <a:pt x="1752" y="1064"/>
                  </a:lnTo>
                  <a:lnTo>
                    <a:pt x="1753" y="1062"/>
                  </a:lnTo>
                  <a:lnTo>
                    <a:pt x="1753" y="1061"/>
                  </a:lnTo>
                  <a:lnTo>
                    <a:pt x="1754" y="1059"/>
                  </a:lnTo>
                  <a:lnTo>
                    <a:pt x="1754" y="1058"/>
                  </a:lnTo>
                  <a:lnTo>
                    <a:pt x="1755" y="1057"/>
                  </a:lnTo>
                  <a:lnTo>
                    <a:pt x="1756" y="1056"/>
                  </a:lnTo>
                  <a:lnTo>
                    <a:pt x="1757" y="1057"/>
                  </a:lnTo>
                  <a:lnTo>
                    <a:pt x="1757" y="1058"/>
                  </a:lnTo>
                  <a:lnTo>
                    <a:pt x="1758" y="1059"/>
                  </a:lnTo>
                  <a:lnTo>
                    <a:pt x="1758" y="1061"/>
                  </a:lnTo>
                  <a:lnTo>
                    <a:pt x="1759" y="1063"/>
                  </a:lnTo>
                  <a:lnTo>
                    <a:pt x="1759" y="1065"/>
                  </a:lnTo>
                  <a:lnTo>
                    <a:pt x="1760" y="1068"/>
                  </a:lnTo>
                  <a:lnTo>
                    <a:pt x="1760" y="1071"/>
                  </a:lnTo>
                  <a:lnTo>
                    <a:pt x="1761" y="1075"/>
                  </a:lnTo>
                  <a:lnTo>
                    <a:pt x="1761" y="1079"/>
                  </a:lnTo>
                  <a:lnTo>
                    <a:pt x="1762" y="1084"/>
                  </a:lnTo>
                  <a:lnTo>
                    <a:pt x="1762" y="1089"/>
                  </a:lnTo>
                  <a:lnTo>
                    <a:pt x="1763" y="1094"/>
                  </a:lnTo>
                  <a:lnTo>
                    <a:pt x="1763" y="1099"/>
                  </a:lnTo>
                  <a:lnTo>
                    <a:pt x="1764" y="1105"/>
                  </a:lnTo>
                  <a:lnTo>
                    <a:pt x="1764" y="1111"/>
                  </a:lnTo>
                  <a:lnTo>
                    <a:pt x="1765" y="1117"/>
                  </a:lnTo>
                  <a:lnTo>
                    <a:pt x="1765" y="1122"/>
                  </a:lnTo>
                  <a:lnTo>
                    <a:pt x="1765" y="1128"/>
                  </a:lnTo>
                  <a:lnTo>
                    <a:pt x="1766" y="1135"/>
                  </a:lnTo>
                  <a:lnTo>
                    <a:pt x="1766" y="1141"/>
                  </a:lnTo>
                  <a:lnTo>
                    <a:pt x="1767" y="1147"/>
                  </a:lnTo>
                  <a:lnTo>
                    <a:pt x="1767" y="1152"/>
                  </a:lnTo>
                  <a:lnTo>
                    <a:pt x="1768" y="1158"/>
                  </a:lnTo>
                  <a:lnTo>
                    <a:pt x="1768" y="1164"/>
                  </a:lnTo>
                  <a:lnTo>
                    <a:pt x="1769" y="1170"/>
                  </a:lnTo>
                  <a:lnTo>
                    <a:pt x="1769" y="1175"/>
                  </a:lnTo>
                  <a:lnTo>
                    <a:pt x="1770" y="1180"/>
                  </a:lnTo>
                  <a:lnTo>
                    <a:pt x="1770" y="1185"/>
                  </a:lnTo>
                  <a:lnTo>
                    <a:pt x="1771" y="1190"/>
                  </a:lnTo>
                  <a:lnTo>
                    <a:pt x="1771" y="1194"/>
                  </a:lnTo>
                  <a:lnTo>
                    <a:pt x="1772" y="1198"/>
                  </a:lnTo>
                  <a:lnTo>
                    <a:pt x="1772" y="1201"/>
                  </a:lnTo>
                  <a:lnTo>
                    <a:pt x="1773" y="1204"/>
                  </a:lnTo>
                  <a:lnTo>
                    <a:pt x="1773" y="1206"/>
                  </a:lnTo>
                  <a:lnTo>
                    <a:pt x="1774" y="1208"/>
                  </a:lnTo>
                  <a:lnTo>
                    <a:pt x="1774" y="1210"/>
                  </a:lnTo>
                  <a:lnTo>
                    <a:pt x="1774" y="1211"/>
                  </a:lnTo>
                  <a:lnTo>
                    <a:pt x="1775" y="1212"/>
                  </a:lnTo>
                  <a:lnTo>
                    <a:pt x="1775" y="1213"/>
                  </a:lnTo>
                  <a:lnTo>
                    <a:pt x="1776" y="1214"/>
                  </a:lnTo>
                  <a:lnTo>
                    <a:pt x="1777" y="1215"/>
                  </a:lnTo>
                  <a:lnTo>
                    <a:pt x="1778" y="1215"/>
                  </a:lnTo>
                  <a:lnTo>
                    <a:pt x="1779" y="1215"/>
                  </a:lnTo>
                  <a:lnTo>
                    <a:pt x="1779" y="1214"/>
                  </a:lnTo>
                  <a:lnTo>
                    <a:pt x="1780" y="1214"/>
                  </a:lnTo>
                  <a:lnTo>
                    <a:pt x="1781" y="1213"/>
                  </a:lnTo>
                  <a:lnTo>
                    <a:pt x="1782" y="1213"/>
                  </a:lnTo>
                  <a:lnTo>
                    <a:pt x="1782" y="1212"/>
                  </a:lnTo>
                  <a:lnTo>
                    <a:pt x="1783" y="1212"/>
                  </a:lnTo>
                  <a:lnTo>
                    <a:pt x="1783" y="1211"/>
                  </a:lnTo>
                  <a:lnTo>
                    <a:pt x="1784" y="1212"/>
                  </a:lnTo>
                  <a:lnTo>
                    <a:pt x="1785" y="1213"/>
                  </a:lnTo>
                  <a:lnTo>
                    <a:pt x="1786" y="1214"/>
                  </a:lnTo>
                  <a:lnTo>
                    <a:pt x="1787" y="1215"/>
                  </a:lnTo>
                  <a:lnTo>
                    <a:pt x="1787" y="1216"/>
                  </a:lnTo>
                  <a:lnTo>
                    <a:pt x="1788" y="1217"/>
                  </a:lnTo>
                  <a:lnTo>
                    <a:pt x="1788" y="1218"/>
                  </a:lnTo>
                  <a:lnTo>
                    <a:pt x="1789" y="1219"/>
                  </a:lnTo>
                  <a:lnTo>
                    <a:pt x="1789" y="1220"/>
                  </a:lnTo>
                  <a:lnTo>
                    <a:pt x="1790" y="1222"/>
                  </a:lnTo>
                  <a:lnTo>
                    <a:pt x="1790" y="1223"/>
                  </a:lnTo>
                  <a:lnTo>
                    <a:pt x="1791" y="1224"/>
                  </a:lnTo>
                  <a:lnTo>
                    <a:pt x="1791" y="1226"/>
                  </a:lnTo>
                  <a:lnTo>
                    <a:pt x="1791" y="1227"/>
                  </a:lnTo>
                  <a:lnTo>
                    <a:pt x="1792" y="1228"/>
                  </a:lnTo>
                  <a:lnTo>
                    <a:pt x="1792" y="1230"/>
                  </a:lnTo>
                  <a:lnTo>
                    <a:pt x="1793" y="1231"/>
                  </a:lnTo>
                  <a:lnTo>
                    <a:pt x="1793" y="1233"/>
                  </a:lnTo>
                  <a:lnTo>
                    <a:pt x="1794" y="1234"/>
                  </a:lnTo>
                  <a:lnTo>
                    <a:pt x="1794" y="1236"/>
                  </a:lnTo>
                  <a:lnTo>
                    <a:pt x="1795" y="1237"/>
                  </a:lnTo>
                  <a:lnTo>
                    <a:pt x="1795" y="1239"/>
                  </a:lnTo>
                  <a:lnTo>
                    <a:pt x="1796" y="1240"/>
                  </a:lnTo>
                  <a:lnTo>
                    <a:pt x="1796" y="1241"/>
                  </a:lnTo>
                  <a:lnTo>
                    <a:pt x="1797" y="1242"/>
                  </a:lnTo>
                  <a:lnTo>
                    <a:pt x="1797" y="1243"/>
                  </a:lnTo>
                  <a:lnTo>
                    <a:pt x="1798" y="1244"/>
                  </a:lnTo>
                  <a:lnTo>
                    <a:pt x="1798" y="1245"/>
                  </a:lnTo>
                  <a:lnTo>
                    <a:pt x="1799" y="1246"/>
                  </a:lnTo>
                  <a:lnTo>
                    <a:pt x="1799" y="1247"/>
                  </a:lnTo>
                  <a:lnTo>
                    <a:pt x="1799" y="1248"/>
                  </a:lnTo>
                  <a:lnTo>
                    <a:pt x="1800" y="1249"/>
                  </a:lnTo>
                  <a:lnTo>
                    <a:pt x="1800" y="1250"/>
                  </a:lnTo>
                  <a:lnTo>
                    <a:pt x="1801" y="1251"/>
                  </a:lnTo>
                  <a:lnTo>
                    <a:pt x="1802" y="1252"/>
                  </a:lnTo>
                  <a:lnTo>
                    <a:pt x="1803" y="1253"/>
                  </a:lnTo>
                  <a:lnTo>
                    <a:pt x="1804" y="1254"/>
                  </a:lnTo>
                  <a:lnTo>
                    <a:pt x="1805" y="1254"/>
                  </a:lnTo>
                  <a:lnTo>
                    <a:pt x="1806" y="1254"/>
                  </a:lnTo>
                  <a:lnTo>
                    <a:pt x="1806" y="1253"/>
                  </a:lnTo>
                  <a:lnTo>
                    <a:pt x="1807" y="1253"/>
                  </a:lnTo>
                  <a:lnTo>
                    <a:pt x="1807" y="1252"/>
                  </a:lnTo>
                  <a:lnTo>
                    <a:pt x="1808" y="1251"/>
                  </a:lnTo>
                  <a:lnTo>
                    <a:pt x="1808" y="1250"/>
                  </a:lnTo>
                  <a:lnTo>
                    <a:pt x="1808" y="1249"/>
                  </a:lnTo>
                  <a:lnTo>
                    <a:pt x="1809" y="1247"/>
                  </a:lnTo>
                  <a:lnTo>
                    <a:pt x="1809" y="1246"/>
                  </a:lnTo>
                  <a:lnTo>
                    <a:pt x="1810" y="1244"/>
                  </a:lnTo>
                  <a:lnTo>
                    <a:pt x="1810" y="1243"/>
                  </a:lnTo>
                  <a:lnTo>
                    <a:pt x="1811" y="1241"/>
                  </a:lnTo>
                  <a:lnTo>
                    <a:pt x="1811" y="1239"/>
                  </a:lnTo>
                  <a:lnTo>
                    <a:pt x="1812" y="1237"/>
                  </a:lnTo>
                  <a:lnTo>
                    <a:pt x="1812" y="1235"/>
                  </a:lnTo>
                  <a:lnTo>
                    <a:pt x="1813" y="1233"/>
                  </a:lnTo>
                  <a:lnTo>
                    <a:pt x="1813" y="1231"/>
                  </a:lnTo>
                  <a:lnTo>
                    <a:pt x="1814" y="1229"/>
                  </a:lnTo>
                  <a:lnTo>
                    <a:pt x="1814" y="1227"/>
                  </a:lnTo>
                  <a:lnTo>
                    <a:pt x="1815" y="1225"/>
                  </a:lnTo>
                  <a:lnTo>
                    <a:pt x="1815" y="1223"/>
                  </a:lnTo>
                  <a:lnTo>
                    <a:pt x="1816" y="1221"/>
                  </a:lnTo>
                  <a:lnTo>
                    <a:pt x="1816" y="1219"/>
                  </a:lnTo>
                  <a:lnTo>
                    <a:pt x="1816" y="1217"/>
                  </a:lnTo>
                  <a:lnTo>
                    <a:pt x="1817" y="1215"/>
                  </a:lnTo>
                  <a:lnTo>
                    <a:pt x="1817" y="1214"/>
                  </a:lnTo>
                  <a:lnTo>
                    <a:pt x="1818" y="1212"/>
                  </a:lnTo>
                  <a:lnTo>
                    <a:pt x="1818" y="1210"/>
                  </a:lnTo>
                  <a:lnTo>
                    <a:pt x="1819" y="1208"/>
                  </a:lnTo>
                  <a:lnTo>
                    <a:pt x="1819" y="1207"/>
                  </a:lnTo>
                  <a:lnTo>
                    <a:pt x="1820" y="1207"/>
                  </a:lnTo>
                  <a:lnTo>
                    <a:pt x="1820" y="1206"/>
                  </a:lnTo>
                  <a:lnTo>
                    <a:pt x="1821" y="1205"/>
                  </a:lnTo>
                  <a:lnTo>
                    <a:pt x="1821" y="1204"/>
                  </a:lnTo>
                  <a:lnTo>
                    <a:pt x="1822" y="1203"/>
                  </a:lnTo>
                  <a:lnTo>
                    <a:pt x="1822" y="1202"/>
                  </a:lnTo>
                  <a:lnTo>
                    <a:pt x="1823" y="1202"/>
                  </a:lnTo>
                  <a:lnTo>
                    <a:pt x="1823" y="1201"/>
                  </a:lnTo>
                  <a:lnTo>
                    <a:pt x="1824" y="1200"/>
                  </a:lnTo>
                  <a:lnTo>
                    <a:pt x="1824" y="1199"/>
                  </a:lnTo>
                  <a:lnTo>
                    <a:pt x="1825" y="1198"/>
                  </a:lnTo>
                  <a:lnTo>
                    <a:pt x="1825" y="1197"/>
                  </a:lnTo>
                  <a:lnTo>
                    <a:pt x="1825" y="1195"/>
                  </a:lnTo>
                  <a:lnTo>
                    <a:pt x="1826" y="1194"/>
                  </a:lnTo>
                  <a:lnTo>
                    <a:pt x="1826" y="1192"/>
                  </a:lnTo>
                  <a:lnTo>
                    <a:pt x="1827" y="1191"/>
                  </a:lnTo>
                  <a:lnTo>
                    <a:pt x="1827" y="1189"/>
                  </a:lnTo>
                  <a:lnTo>
                    <a:pt x="1828" y="1187"/>
                  </a:lnTo>
                  <a:lnTo>
                    <a:pt x="1828" y="1184"/>
                  </a:lnTo>
                  <a:lnTo>
                    <a:pt x="1829" y="1182"/>
                  </a:lnTo>
                  <a:lnTo>
                    <a:pt x="1829" y="1179"/>
                  </a:lnTo>
                  <a:lnTo>
                    <a:pt x="1830" y="1176"/>
                  </a:lnTo>
                  <a:lnTo>
                    <a:pt x="1830" y="1173"/>
                  </a:lnTo>
                  <a:lnTo>
                    <a:pt x="1831" y="1169"/>
                  </a:lnTo>
                  <a:lnTo>
                    <a:pt x="1831" y="1164"/>
                  </a:lnTo>
                  <a:lnTo>
                    <a:pt x="1832" y="1159"/>
                  </a:lnTo>
                  <a:lnTo>
                    <a:pt x="1832" y="1153"/>
                  </a:lnTo>
                  <a:lnTo>
                    <a:pt x="1833" y="1148"/>
                  </a:lnTo>
                  <a:lnTo>
                    <a:pt x="1833" y="1142"/>
                  </a:lnTo>
                  <a:lnTo>
                    <a:pt x="1834" y="1136"/>
                  </a:lnTo>
                  <a:lnTo>
                    <a:pt x="1834" y="1130"/>
                  </a:lnTo>
                  <a:lnTo>
                    <a:pt x="1834" y="1124"/>
                  </a:lnTo>
                  <a:lnTo>
                    <a:pt x="1835" y="1118"/>
                  </a:lnTo>
                  <a:lnTo>
                    <a:pt x="1835" y="1112"/>
                  </a:lnTo>
                  <a:lnTo>
                    <a:pt x="1836" y="1107"/>
                  </a:lnTo>
                  <a:lnTo>
                    <a:pt x="1836" y="1101"/>
                  </a:lnTo>
                  <a:lnTo>
                    <a:pt x="1837" y="1096"/>
                  </a:lnTo>
                  <a:lnTo>
                    <a:pt x="1837" y="1090"/>
                  </a:lnTo>
                  <a:lnTo>
                    <a:pt x="1838" y="1086"/>
                  </a:lnTo>
                  <a:lnTo>
                    <a:pt x="1838" y="1081"/>
                  </a:lnTo>
                  <a:lnTo>
                    <a:pt x="1839" y="1077"/>
                  </a:lnTo>
                  <a:lnTo>
                    <a:pt x="1839" y="1073"/>
                  </a:lnTo>
                  <a:lnTo>
                    <a:pt x="1840" y="1069"/>
                  </a:lnTo>
                  <a:lnTo>
                    <a:pt x="1840" y="1066"/>
                  </a:lnTo>
                  <a:lnTo>
                    <a:pt x="1841" y="1064"/>
                  </a:lnTo>
                  <a:lnTo>
                    <a:pt x="1841" y="1062"/>
                  </a:lnTo>
                  <a:lnTo>
                    <a:pt x="1842" y="1061"/>
                  </a:lnTo>
                  <a:lnTo>
                    <a:pt x="1842" y="1060"/>
                  </a:lnTo>
                  <a:lnTo>
                    <a:pt x="1843" y="1062"/>
                  </a:lnTo>
                  <a:lnTo>
                    <a:pt x="1843" y="1065"/>
                  </a:lnTo>
                  <a:lnTo>
                    <a:pt x="1844" y="1068"/>
                  </a:lnTo>
                  <a:lnTo>
                    <a:pt x="1844" y="1072"/>
                  </a:lnTo>
                  <a:lnTo>
                    <a:pt x="1845" y="1076"/>
                  </a:lnTo>
                  <a:lnTo>
                    <a:pt x="1845" y="1081"/>
                  </a:lnTo>
                  <a:lnTo>
                    <a:pt x="1846" y="1086"/>
                  </a:lnTo>
                  <a:lnTo>
                    <a:pt x="1846" y="1092"/>
                  </a:lnTo>
                  <a:lnTo>
                    <a:pt x="1847" y="1098"/>
                  </a:lnTo>
                  <a:lnTo>
                    <a:pt x="1847" y="1104"/>
                  </a:lnTo>
                  <a:lnTo>
                    <a:pt x="1848" y="1110"/>
                  </a:lnTo>
                  <a:lnTo>
                    <a:pt x="1848" y="1116"/>
                  </a:lnTo>
                  <a:lnTo>
                    <a:pt x="1849" y="1122"/>
                  </a:lnTo>
                  <a:lnTo>
                    <a:pt x="1849" y="1128"/>
                  </a:lnTo>
                  <a:lnTo>
                    <a:pt x="1850" y="1134"/>
                  </a:lnTo>
                  <a:lnTo>
                    <a:pt x="1850" y="1140"/>
                  </a:lnTo>
                  <a:lnTo>
                    <a:pt x="1851" y="1146"/>
                  </a:lnTo>
                  <a:lnTo>
                    <a:pt x="1851" y="1151"/>
                  </a:lnTo>
                  <a:lnTo>
                    <a:pt x="1851" y="1156"/>
                  </a:lnTo>
                  <a:lnTo>
                    <a:pt x="1852" y="1161"/>
                  </a:lnTo>
                  <a:lnTo>
                    <a:pt x="1852" y="1165"/>
                  </a:lnTo>
                  <a:lnTo>
                    <a:pt x="1853" y="1169"/>
                  </a:lnTo>
                  <a:lnTo>
                    <a:pt x="1853" y="1172"/>
                  </a:lnTo>
                  <a:lnTo>
                    <a:pt x="1854" y="1175"/>
                  </a:lnTo>
                  <a:lnTo>
                    <a:pt x="1854" y="1177"/>
                  </a:lnTo>
                  <a:lnTo>
                    <a:pt x="1855" y="1177"/>
                  </a:lnTo>
                  <a:lnTo>
                    <a:pt x="1856" y="1175"/>
                  </a:lnTo>
                  <a:lnTo>
                    <a:pt x="1856" y="1174"/>
                  </a:lnTo>
                  <a:lnTo>
                    <a:pt x="1857" y="1171"/>
                  </a:lnTo>
                  <a:lnTo>
                    <a:pt x="1857" y="1169"/>
                  </a:lnTo>
                  <a:lnTo>
                    <a:pt x="1858" y="1165"/>
                  </a:lnTo>
                  <a:lnTo>
                    <a:pt x="1858" y="1162"/>
                  </a:lnTo>
                  <a:lnTo>
                    <a:pt x="1859" y="1157"/>
                  </a:lnTo>
                  <a:lnTo>
                    <a:pt x="1859" y="1153"/>
                  </a:lnTo>
                  <a:lnTo>
                    <a:pt x="1859" y="1148"/>
                  </a:lnTo>
                  <a:lnTo>
                    <a:pt x="1860" y="1143"/>
                  </a:lnTo>
                  <a:lnTo>
                    <a:pt x="1860" y="1137"/>
                  </a:lnTo>
                  <a:lnTo>
                    <a:pt x="1861" y="1131"/>
                  </a:lnTo>
                  <a:lnTo>
                    <a:pt x="1861" y="1126"/>
                  </a:lnTo>
                  <a:lnTo>
                    <a:pt x="1862" y="1119"/>
                  </a:lnTo>
                  <a:lnTo>
                    <a:pt x="1862" y="1113"/>
                  </a:lnTo>
                  <a:lnTo>
                    <a:pt x="1863" y="1107"/>
                  </a:lnTo>
                  <a:lnTo>
                    <a:pt x="1863" y="1101"/>
                  </a:lnTo>
                  <a:lnTo>
                    <a:pt x="1864" y="1095"/>
                  </a:lnTo>
                  <a:lnTo>
                    <a:pt x="1864" y="1088"/>
                  </a:lnTo>
                  <a:lnTo>
                    <a:pt x="1865" y="1082"/>
                  </a:lnTo>
                  <a:lnTo>
                    <a:pt x="1865" y="1076"/>
                  </a:lnTo>
                  <a:lnTo>
                    <a:pt x="1866" y="1070"/>
                  </a:lnTo>
                  <a:lnTo>
                    <a:pt x="1866" y="1065"/>
                  </a:lnTo>
                  <a:lnTo>
                    <a:pt x="1867" y="1060"/>
                  </a:lnTo>
                  <a:lnTo>
                    <a:pt x="1867" y="1055"/>
                  </a:lnTo>
                  <a:lnTo>
                    <a:pt x="1868" y="1051"/>
                  </a:lnTo>
                  <a:lnTo>
                    <a:pt x="1868" y="1047"/>
                  </a:lnTo>
                  <a:lnTo>
                    <a:pt x="1868" y="1043"/>
                  </a:lnTo>
                  <a:lnTo>
                    <a:pt x="1869" y="1040"/>
                  </a:lnTo>
                  <a:lnTo>
                    <a:pt x="1869" y="1037"/>
                  </a:lnTo>
                  <a:lnTo>
                    <a:pt x="1870" y="1034"/>
                  </a:lnTo>
                  <a:lnTo>
                    <a:pt x="1870" y="1031"/>
                  </a:lnTo>
                  <a:lnTo>
                    <a:pt x="1871" y="1029"/>
                  </a:lnTo>
                  <a:lnTo>
                    <a:pt x="1871" y="1027"/>
                  </a:lnTo>
                  <a:lnTo>
                    <a:pt x="1872" y="1025"/>
                  </a:lnTo>
                  <a:lnTo>
                    <a:pt x="1872" y="1024"/>
                  </a:lnTo>
                  <a:lnTo>
                    <a:pt x="1873" y="1023"/>
                  </a:lnTo>
                  <a:lnTo>
                    <a:pt x="1873" y="1022"/>
                  </a:lnTo>
                  <a:lnTo>
                    <a:pt x="1874" y="1022"/>
                  </a:lnTo>
                  <a:lnTo>
                    <a:pt x="1875" y="1023"/>
                  </a:lnTo>
                  <a:lnTo>
                    <a:pt x="1875" y="1024"/>
                  </a:lnTo>
                  <a:lnTo>
                    <a:pt x="1876" y="1025"/>
                  </a:lnTo>
                  <a:lnTo>
                    <a:pt x="1876" y="1027"/>
                  </a:lnTo>
                  <a:lnTo>
                    <a:pt x="1876" y="1029"/>
                  </a:lnTo>
                  <a:lnTo>
                    <a:pt x="1877" y="1031"/>
                  </a:lnTo>
                  <a:lnTo>
                    <a:pt x="1877" y="1034"/>
                  </a:lnTo>
                  <a:lnTo>
                    <a:pt x="1878" y="1037"/>
                  </a:lnTo>
                  <a:lnTo>
                    <a:pt x="1878" y="1041"/>
                  </a:lnTo>
                  <a:lnTo>
                    <a:pt x="1879" y="1046"/>
                  </a:lnTo>
                  <a:lnTo>
                    <a:pt x="1879" y="1050"/>
                  </a:lnTo>
                  <a:lnTo>
                    <a:pt x="1880" y="1055"/>
                  </a:lnTo>
                  <a:lnTo>
                    <a:pt x="1880" y="1061"/>
                  </a:lnTo>
                  <a:lnTo>
                    <a:pt x="1881" y="1066"/>
                  </a:lnTo>
                  <a:lnTo>
                    <a:pt x="1881" y="1072"/>
                  </a:lnTo>
                  <a:lnTo>
                    <a:pt x="1882" y="1078"/>
                  </a:lnTo>
                  <a:lnTo>
                    <a:pt x="1882" y="1084"/>
                  </a:lnTo>
                  <a:lnTo>
                    <a:pt x="1883" y="1091"/>
                  </a:lnTo>
                  <a:lnTo>
                    <a:pt x="1883" y="1097"/>
                  </a:lnTo>
                  <a:lnTo>
                    <a:pt x="1884" y="1104"/>
                  </a:lnTo>
                  <a:lnTo>
                    <a:pt x="1884" y="1110"/>
                  </a:lnTo>
                  <a:lnTo>
                    <a:pt x="1885" y="1117"/>
                  </a:lnTo>
                  <a:lnTo>
                    <a:pt x="1885" y="1123"/>
                  </a:lnTo>
                  <a:lnTo>
                    <a:pt x="1885" y="1130"/>
                  </a:lnTo>
                  <a:lnTo>
                    <a:pt x="1886" y="1136"/>
                  </a:lnTo>
                  <a:lnTo>
                    <a:pt x="1886" y="1142"/>
                  </a:lnTo>
                  <a:lnTo>
                    <a:pt x="1887" y="1148"/>
                  </a:lnTo>
                  <a:lnTo>
                    <a:pt x="1887" y="1154"/>
                  </a:lnTo>
                  <a:lnTo>
                    <a:pt x="1888" y="1159"/>
                  </a:lnTo>
                  <a:lnTo>
                    <a:pt x="1888" y="1164"/>
                  </a:lnTo>
                  <a:lnTo>
                    <a:pt x="1889" y="1169"/>
                  </a:lnTo>
                  <a:lnTo>
                    <a:pt x="1889" y="1174"/>
                  </a:lnTo>
                  <a:lnTo>
                    <a:pt x="1890" y="1178"/>
                  </a:lnTo>
                  <a:lnTo>
                    <a:pt x="1890" y="1182"/>
                  </a:lnTo>
                  <a:lnTo>
                    <a:pt x="1891" y="1185"/>
                  </a:lnTo>
                  <a:lnTo>
                    <a:pt x="1891" y="1187"/>
                  </a:lnTo>
                  <a:lnTo>
                    <a:pt x="1892" y="1189"/>
                  </a:lnTo>
                  <a:lnTo>
                    <a:pt x="1892" y="1191"/>
                  </a:lnTo>
                  <a:lnTo>
                    <a:pt x="1893" y="1193"/>
                  </a:lnTo>
                  <a:lnTo>
                    <a:pt x="1893" y="1194"/>
                  </a:lnTo>
                  <a:lnTo>
                    <a:pt x="1893" y="1195"/>
                  </a:lnTo>
                  <a:lnTo>
                    <a:pt x="1894" y="1196"/>
                  </a:lnTo>
                  <a:lnTo>
                    <a:pt x="1895" y="1196"/>
                  </a:lnTo>
                  <a:lnTo>
                    <a:pt x="1896" y="1196"/>
                  </a:lnTo>
                  <a:lnTo>
                    <a:pt x="1897" y="1195"/>
                  </a:lnTo>
                  <a:lnTo>
                    <a:pt x="1897" y="1194"/>
                  </a:lnTo>
                  <a:lnTo>
                    <a:pt x="1898" y="1193"/>
                  </a:lnTo>
                  <a:lnTo>
                    <a:pt x="1898" y="1192"/>
                  </a:lnTo>
                  <a:lnTo>
                    <a:pt x="1899" y="1191"/>
                  </a:lnTo>
                  <a:lnTo>
                    <a:pt x="1899" y="1190"/>
                  </a:lnTo>
                  <a:lnTo>
                    <a:pt x="1900" y="1188"/>
                  </a:lnTo>
                  <a:lnTo>
                    <a:pt x="1900" y="1187"/>
                  </a:lnTo>
                  <a:lnTo>
                    <a:pt x="1901" y="1186"/>
                  </a:lnTo>
                  <a:lnTo>
                    <a:pt x="1901" y="1184"/>
                  </a:lnTo>
                  <a:lnTo>
                    <a:pt x="1902" y="1183"/>
                  </a:lnTo>
                  <a:lnTo>
                    <a:pt x="1902" y="1182"/>
                  </a:lnTo>
                  <a:lnTo>
                    <a:pt x="1902" y="1181"/>
                  </a:lnTo>
                  <a:lnTo>
                    <a:pt x="1903" y="1180"/>
                  </a:lnTo>
                  <a:lnTo>
                    <a:pt x="1903" y="1178"/>
                  </a:lnTo>
                  <a:lnTo>
                    <a:pt x="1904" y="1177"/>
                  </a:lnTo>
                  <a:lnTo>
                    <a:pt x="1904" y="1176"/>
                  </a:lnTo>
                  <a:lnTo>
                    <a:pt x="1905" y="1175"/>
                  </a:lnTo>
                  <a:lnTo>
                    <a:pt x="1905" y="1174"/>
                  </a:lnTo>
                  <a:lnTo>
                    <a:pt x="1906" y="1173"/>
                  </a:lnTo>
                  <a:lnTo>
                    <a:pt x="1907" y="1172"/>
                  </a:lnTo>
                  <a:lnTo>
                    <a:pt x="1907" y="1171"/>
                  </a:lnTo>
                  <a:lnTo>
                    <a:pt x="1908" y="1170"/>
                  </a:lnTo>
                  <a:lnTo>
                    <a:pt x="1908" y="1169"/>
                  </a:lnTo>
                  <a:lnTo>
                    <a:pt x="1909" y="1168"/>
                  </a:lnTo>
                  <a:lnTo>
                    <a:pt x="1909" y="1167"/>
                  </a:lnTo>
                  <a:lnTo>
                    <a:pt x="1910" y="1167"/>
                  </a:lnTo>
                  <a:lnTo>
                    <a:pt x="1910" y="1166"/>
                  </a:lnTo>
                  <a:lnTo>
                    <a:pt x="1911" y="1165"/>
                  </a:lnTo>
                  <a:lnTo>
                    <a:pt x="1911" y="1164"/>
                  </a:lnTo>
                  <a:lnTo>
                    <a:pt x="1912" y="1163"/>
                  </a:lnTo>
                  <a:lnTo>
                    <a:pt x="1913" y="1162"/>
                  </a:lnTo>
                  <a:lnTo>
                    <a:pt x="1914" y="1161"/>
                  </a:lnTo>
                  <a:lnTo>
                    <a:pt x="1914" y="1160"/>
                  </a:lnTo>
                  <a:lnTo>
                    <a:pt x="1915" y="1160"/>
                  </a:lnTo>
                  <a:lnTo>
                    <a:pt x="1915" y="1159"/>
                  </a:lnTo>
                  <a:lnTo>
                    <a:pt x="1916" y="1159"/>
                  </a:lnTo>
                  <a:lnTo>
                    <a:pt x="1916" y="1158"/>
                  </a:lnTo>
                  <a:lnTo>
                    <a:pt x="1917" y="1158"/>
                  </a:lnTo>
                  <a:lnTo>
                    <a:pt x="1917" y="1157"/>
                  </a:lnTo>
                  <a:lnTo>
                    <a:pt x="1918" y="1157"/>
                  </a:lnTo>
                  <a:lnTo>
                    <a:pt x="1919" y="1157"/>
                  </a:lnTo>
                  <a:lnTo>
                    <a:pt x="1920" y="1157"/>
                  </a:lnTo>
                  <a:lnTo>
                    <a:pt x="1921" y="1157"/>
                  </a:lnTo>
                  <a:lnTo>
                    <a:pt x="1922" y="1157"/>
                  </a:lnTo>
                  <a:lnTo>
                    <a:pt x="1922" y="1158"/>
                  </a:lnTo>
                  <a:lnTo>
                    <a:pt x="1923" y="1158"/>
                  </a:lnTo>
                  <a:lnTo>
                    <a:pt x="1923" y="1159"/>
                  </a:lnTo>
                  <a:lnTo>
                    <a:pt x="1924" y="1159"/>
                  </a:lnTo>
                  <a:lnTo>
                    <a:pt x="1924" y="1160"/>
                  </a:lnTo>
                  <a:lnTo>
                    <a:pt x="1925" y="1161"/>
                  </a:lnTo>
                  <a:lnTo>
                    <a:pt x="1925" y="1162"/>
                  </a:lnTo>
                  <a:lnTo>
                    <a:pt x="1926" y="1162"/>
                  </a:lnTo>
                  <a:lnTo>
                    <a:pt x="1926" y="1163"/>
                  </a:lnTo>
                  <a:lnTo>
                    <a:pt x="1927" y="1165"/>
                  </a:lnTo>
                  <a:lnTo>
                    <a:pt x="1927" y="1166"/>
                  </a:lnTo>
                  <a:lnTo>
                    <a:pt x="1928" y="1167"/>
                  </a:lnTo>
                  <a:lnTo>
                    <a:pt x="1928" y="1168"/>
                  </a:lnTo>
                  <a:lnTo>
                    <a:pt x="1928" y="1170"/>
                  </a:lnTo>
                  <a:lnTo>
                    <a:pt x="1929" y="1171"/>
                  </a:lnTo>
                  <a:lnTo>
                    <a:pt x="1929" y="1173"/>
                  </a:lnTo>
                  <a:lnTo>
                    <a:pt x="1930" y="1174"/>
                  </a:lnTo>
                  <a:lnTo>
                    <a:pt x="1930" y="1176"/>
                  </a:lnTo>
                  <a:lnTo>
                    <a:pt x="1931" y="1177"/>
                  </a:lnTo>
                  <a:lnTo>
                    <a:pt x="1931" y="1179"/>
                  </a:lnTo>
                  <a:lnTo>
                    <a:pt x="1932" y="1181"/>
                  </a:lnTo>
                  <a:lnTo>
                    <a:pt x="1932" y="1183"/>
                  </a:lnTo>
                  <a:lnTo>
                    <a:pt x="1933" y="1185"/>
                  </a:lnTo>
                  <a:lnTo>
                    <a:pt x="1933" y="1187"/>
                  </a:lnTo>
                  <a:lnTo>
                    <a:pt x="1934" y="1189"/>
                  </a:lnTo>
                  <a:lnTo>
                    <a:pt x="1934" y="1191"/>
                  </a:lnTo>
                  <a:lnTo>
                    <a:pt x="1935" y="1193"/>
                  </a:lnTo>
                  <a:lnTo>
                    <a:pt x="1935" y="1195"/>
                  </a:lnTo>
                  <a:lnTo>
                    <a:pt x="1936" y="1197"/>
                  </a:lnTo>
                  <a:lnTo>
                    <a:pt x="1936" y="1199"/>
                  </a:lnTo>
                  <a:lnTo>
                    <a:pt x="1936" y="1202"/>
                  </a:lnTo>
                  <a:lnTo>
                    <a:pt x="1937" y="1204"/>
                  </a:lnTo>
                  <a:lnTo>
                    <a:pt x="1937" y="1206"/>
                  </a:lnTo>
                  <a:lnTo>
                    <a:pt x="1938" y="1209"/>
                  </a:lnTo>
                  <a:lnTo>
                    <a:pt x="1938" y="1211"/>
                  </a:lnTo>
                  <a:lnTo>
                    <a:pt x="1939" y="1214"/>
                  </a:lnTo>
                  <a:lnTo>
                    <a:pt x="1939" y="1216"/>
                  </a:lnTo>
                  <a:lnTo>
                    <a:pt x="1940" y="1218"/>
                  </a:lnTo>
                  <a:lnTo>
                    <a:pt x="1940" y="1221"/>
                  </a:lnTo>
                  <a:lnTo>
                    <a:pt x="1941" y="1223"/>
                  </a:lnTo>
                  <a:lnTo>
                    <a:pt x="1941" y="1226"/>
                  </a:lnTo>
                  <a:lnTo>
                    <a:pt x="1942" y="1228"/>
                  </a:lnTo>
                  <a:lnTo>
                    <a:pt x="1942" y="1230"/>
                  </a:lnTo>
                  <a:lnTo>
                    <a:pt x="1943" y="1233"/>
                  </a:lnTo>
                  <a:lnTo>
                    <a:pt x="1943" y="1235"/>
                  </a:lnTo>
                  <a:lnTo>
                    <a:pt x="1944" y="1237"/>
                  </a:lnTo>
                  <a:lnTo>
                    <a:pt x="1944" y="1239"/>
                  </a:lnTo>
                  <a:lnTo>
                    <a:pt x="1945" y="1242"/>
                  </a:lnTo>
                  <a:lnTo>
                    <a:pt x="1945" y="1244"/>
                  </a:lnTo>
                  <a:lnTo>
                    <a:pt x="1945" y="1246"/>
                  </a:lnTo>
                  <a:lnTo>
                    <a:pt x="1946" y="1247"/>
                  </a:lnTo>
                  <a:lnTo>
                    <a:pt x="1946" y="1249"/>
                  </a:lnTo>
                  <a:lnTo>
                    <a:pt x="1947" y="1251"/>
                  </a:lnTo>
                  <a:lnTo>
                    <a:pt x="1947" y="1253"/>
                  </a:lnTo>
                  <a:lnTo>
                    <a:pt x="1948" y="1254"/>
                  </a:lnTo>
                  <a:lnTo>
                    <a:pt x="1948" y="1256"/>
                  </a:lnTo>
                  <a:lnTo>
                    <a:pt x="1949" y="1257"/>
                  </a:lnTo>
                  <a:lnTo>
                    <a:pt x="1949" y="1258"/>
                  </a:lnTo>
                  <a:lnTo>
                    <a:pt x="1950" y="1259"/>
                  </a:lnTo>
                  <a:lnTo>
                    <a:pt x="1950" y="1260"/>
                  </a:lnTo>
                  <a:lnTo>
                    <a:pt x="1951" y="1260"/>
                  </a:lnTo>
                  <a:lnTo>
                    <a:pt x="1951" y="1261"/>
                  </a:lnTo>
                  <a:lnTo>
                    <a:pt x="1952" y="1261"/>
                  </a:lnTo>
                  <a:lnTo>
                    <a:pt x="1952" y="1262"/>
                  </a:lnTo>
                  <a:lnTo>
                    <a:pt x="1953" y="1262"/>
                  </a:lnTo>
                  <a:lnTo>
                    <a:pt x="1953" y="1263"/>
                  </a:lnTo>
                  <a:lnTo>
                    <a:pt x="1954" y="1263"/>
                  </a:lnTo>
                  <a:lnTo>
                    <a:pt x="1955" y="1263"/>
                  </a:lnTo>
                  <a:lnTo>
                    <a:pt x="1956" y="1263"/>
                  </a:lnTo>
                  <a:lnTo>
                    <a:pt x="1956" y="1262"/>
                  </a:lnTo>
                  <a:lnTo>
                    <a:pt x="1957" y="1262"/>
                  </a:lnTo>
                  <a:lnTo>
                    <a:pt x="1958" y="1262"/>
                  </a:lnTo>
                  <a:lnTo>
                    <a:pt x="1958" y="1261"/>
                  </a:lnTo>
                  <a:lnTo>
                    <a:pt x="1959" y="1261"/>
                  </a:lnTo>
                  <a:lnTo>
                    <a:pt x="1960" y="1261"/>
                  </a:lnTo>
                  <a:lnTo>
                    <a:pt x="1960" y="1260"/>
                  </a:lnTo>
                  <a:lnTo>
                    <a:pt x="1961" y="1260"/>
                  </a:lnTo>
                  <a:lnTo>
                    <a:pt x="1962" y="1259"/>
                  </a:lnTo>
                  <a:lnTo>
                    <a:pt x="1963" y="1259"/>
                  </a:lnTo>
                  <a:lnTo>
                    <a:pt x="1963" y="1258"/>
                  </a:lnTo>
                  <a:lnTo>
                    <a:pt x="1964" y="1258"/>
                  </a:lnTo>
                  <a:lnTo>
                    <a:pt x="1965" y="1258"/>
                  </a:lnTo>
                  <a:lnTo>
                    <a:pt x="1965" y="1257"/>
                  </a:lnTo>
                  <a:lnTo>
                    <a:pt x="1966" y="1257"/>
                  </a:lnTo>
                  <a:lnTo>
                    <a:pt x="1967" y="1256"/>
                  </a:lnTo>
                  <a:lnTo>
                    <a:pt x="1968" y="1256"/>
                  </a:lnTo>
                  <a:lnTo>
                    <a:pt x="1968" y="1255"/>
                  </a:lnTo>
                  <a:lnTo>
                    <a:pt x="1969" y="1255"/>
                  </a:lnTo>
                  <a:lnTo>
                    <a:pt x="1970" y="1254"/>
                  </a:lnTo>
                  <a:lnTo>
                    <a:pt x="1971" y="1253"/>
                  </a:lnTo>
                  <a:lnTo>
                    <a:pt x="1971" y="1252"/>
                  </a:lnTo>
                  <a:lnTo>
                    <a:pt x="1972" y="1251"/>
                  </a:lnTo>
                  <a:lnTo>
                    <a:pt x="1973" y="1250"/>
                  </a:lnTo>
                  <a:lnTo>
                    <a:pt x="1973" y="1249"/>
                  </a:lnTo>
                  <a:lnTo>
                    <a:pt x="1974" y="1248"/>
                  </a:lnTo>
                  <a:lnTo>
                    <a:pt x="1974" y="1247"/>
                  </a:lnTo>
                  <a:lnTo>
                    <a:pt x="1975" y="1246"/>
                  </a:lnTo>
                  <a:lnTo>
                    <a:pt x="1975" y="1245"/>
                  </a:lnTo>
                  <a:lnTo>
                    <a:pt x="1976" y="1244"/>
                  </a:lnTo>
                  <a:lnTo>
                    <a:pt x="1976" y="1243"/>
                  </a:lnTo>
                  <a:lnTo>
                    <a:pt x="1977" y="1242"/>
                  </a:lnTo>
                  <a:lnTo>
                    <a:pt x="1977" y="1241"/>
                  </a:lnTo>
                  <a:lnTo>
                    <a:pt x="1978" y="1240"/>
                  </a:lnTo>
                  <a:lnTo>
                    <a:pt x="1978" y="1239"/>
                  </a:lnTo>
                  <a:lnTo>
                    <a:pt x="1979" y="1239"/>
                  </a:lnTo>
                  <a:lnTo>
                    <a:pt x="1979" y="1238"/>
                  </a:lnTo>
                  <a:lnTo>
                    <a:pt x="1979" y="1237"/>
                  </a:lnTo>
                  <a:lnTo>
                    <a:pt x="1980" y="1236"/>
                  </a:lnTo>
                  <a:lnTo>
                    <a:pt x="1980" y="1235"/>
                  </a:lnTo>
                  <a:lnTo>
                    <a:pt x="1981" y="1234"/>
                  </a:lnTo>
                  <a:lnTo>
                    <a:pt x="1981" y="1233"/>
                  </a:lnTo>
                  <a:lnTo>
                    <a:pt x="1982" y="1233"/>
                  </a:lnTo>
                  <a:lnTo>
                    <a:pt x="1982" y="1232"/>
                  </a:lnTo>
                  <a:lnTo>
                    <a:pt x="1983" y="1231"/>
                  </a:lnTo>
                  <a:lnTo>
                    <a:pt x="1984" y="1230"/>
                  </a:lnTo>
                  <a:lnTo>
                    <a:pt x="1985" y="1229"/>
                  </a:lnTo>
                  <a:lnTo>
                    <a:pt x="1986" y="1229"/>
                  </a:lnTo>
                  <a:lnTo>
                    <a:pt x="1987" y="1229"/>
                  </a:lnTo>
                  <a:lnTo>
                    <a:pt x="1988" y="1229"/>
                  </a:lnTo>
                  <a:lnTo>
                    <a:pt x="1989" y="1230"/>
                  </a:lnTo>
                  <a:lnTo>
                    <a:pt x="1990" y="1230"/>
                  </a:lnTo>
                  <a:lnTo>
                    <a:pt x="1991" y="1231"/>
                  </a:lnTo>
                  <a:lnTo>
                    <a:pt x="1992" y="1231"/>
                  </a:lnTo>
                  <a:lnTo>
                    <a:pt x="1992" y="1232"/>
                  </a:lnTo>
                  <a:lnTo>
                    <a:pt x="1993" y="1232"/>
                  </a:lnTo>
                  <a:lnTo>
                    <a:pt x="1994" y="1233"/>
                  </a:lnTo>
                  <a:lnTo>
                    <a:pt x="1995" y="1233"/>
                  </a:lnTo>
                  <a:lnTo>
                    <a:pt x="1995" y="1234"/>
                  </a:lnTo>
                  <a:lnTo>
                    <a:pt x="1996" y="1234"/>
                  </a:lnTo>
                  <a:lnTo>
                    <a:pt x="1997" y="1234"/>
                  </a:lnTo>
                  <a:lnTo>
                    <a:pt x="1997" y="1235"/>
                  </a:lnTo>
                  <a:lnTo>
                    <a:pt x="1998" y="1235"/>
                  </a:lnTo>
                  <a:lnTo>
                    <a:pt x="1999" y="1235"/>
                  </a:lnTo>
                  <a:lnTo>
                    <a:pt x="2000" y="1235"/>
                  </a:lnTo>
                  <a:lnTo>
                    <a:pt x="2001" y="1235"/>
                  </a:lnTo>
                  <a:lnTo>
                    <a:pt x="2002" y="1235"/>
                  </a:lnTo>
                  <a:lnTo>
                    <a:pt x="2003" y="1236"/>
                  </a:lnTo>
                  <a:lnTo>
                    <a:pt x="2004" y="1236"/>
                  </a:lnTo>
                  <a:lnTo>
                    <a:pt x="2005" y="1236"/>
                  </a:lnTo>
                  <a:lnTo>
                    <a:pt x="2005" y="1237"/>
                  </a:lnTo>
                  <a:lnTo>
                    <a:pt x="2006" y="1237"/>
                  </a:lnTo>
                  <a:lnTo>
                    <a:pt x="2007" y="1238"/>
                  </a:lnTo>
                  <a:lnTo>
                    <a:pt x="2008" y="1239"/>
                  </a:lnTo>
                  <a:lnTo>
                    <a:pt x="2009" y="1240"/>
                  </a:lnTo>
                  <a:lnTo>
                    <a:pt x="2009" y="1241"/>
                  </a:lnTo>
                  <a:lnTo>
                    <a:pt x="2010" y="1242"/>
                  </a:lnTo>
                  <a:lnTo>
                    <a:pt x="2010" y="1243"/>
                  </a:lnTo>
                  <a:lnTo>
                    <a:pt x="2011" y="1244"/>
                  </a:lnTo>
                  <a:lnTo>
                    <a:pt x="2011" y="1245"/>
                  </a:lnTo>
                  <a:lnTo>
                    <a:pt x="2012" y="1245"/>
                  </a:lnTo>
                  <a:lnTo>
                    <a:pt x="2012" y="1246"/>
                  </a:lnTo>
                  <a:lnTo>
                    <a:pt x="2013" y="1247"/>
                  </a:lnTo>
                  <a:lnTo>
                    <a:pt x="2013" y="1248"/>
                  </a:lnTo>
                  <a:lnTo>
                    <a:pt x="2013" y="1249"/>
                  </a:lnTo>
                  <a:lnTo>
                    <a:pt x="2014" y="1250"/>
                  </a:lnTo>
                  <a:lnTo>
                    <a:pt x="2014" y="1251"/>
                  </a:lnTo>
                  <a:lnTo>
                    <a:pt x="2015" y="1252"/>
                  </a:lnTo>
                  <a:lnTo>
                    <a:pt x="2015" y="1253"/>
                  </a:lnTo>
                  <a:lnTo>
                    <a:pt x="2016" y="1254"/>
                  </a:lnTo>
                  <a:lnTo>
                    <a:pt x="2016" y="1255"/>
                  </a:lnTo>
                  <a:lnTo>
                    <a:pt x="2017" y="1256"/>
                  </a:lnTo>
                  <a:lnTo>
                    <a:pt x="2017" y="1257"/>
                  </a:lnTo>
                  <a:lnTo>
                    <a:pt x="2018" y="1257"/>
                  </a:lnTo>
                  <a:lnTo>
                    <a:pt x="2018" y="1258"/>
                  </a:lnTo>
                  <a:lnTo>
                    <a:pt x="2019" y="1259"/>
                  </a:lnTo>
                  <a:lnTo>
                    <a:pt x="2020" y="1260"/>
                  </a:lnTo>
                  <a:lnTo>
                    <a:pt x="2021" y="1261"/>
                  </a:lnTo>
                  <a:lnTo>
                    <a:pt x="2022" y="1261"/>
                  </a:lnTo>
                  <a:lnTo>
                    <a:pt x="2023" y="1262"/>
                  </a:lnTo>
                  <a:lnTo>
                    <a:pt x="2024" y="1262"/>
                  </a:lnTo>
                  <a:lnTo>
                    <a:pt x="2025" y="1261"/>
                  </a:lnTo>
                  <a:lnTo>
                    <a:pt x="2026" y="1261"/>
                  </a:lnTo>
                  <a:lnTo>
                    <a:pt x="2027" y="1261"/>
                  </a:lnTo>
                  <a:lnTo>
                    <a:pt x="2028" y="1261"/>
                  </a:lnTo>
                  <a:lnTo>
                    <a:pt x="2029" y="1261"/>
                  </a:lnTo>
                  <a:lnTo>
                    <a:pt x="2029" y="1260"/>
                  </a:lnTo>
                  <a:lnTo>
                    <a:pt x="2030" y="1260"/>
                  </a:lnTo>
                  <a:lnTo>
                    <a:pt x="2031" y="1260"/>
                  </a:lnTo>
                  <a:lnTo>
                    <a:pt x="2032" y="1260"/>
                  </a:lnTo>
                  <a:lnTo>
                    <a:pt x="2033" y="1260"/>
                  </a:lnTo>
                  <a:lnTo>
                    <a:pt x="2034" y="1260"/>
                  </a:lnTo>
                  <a:lnTo>
                    <a:pt x="2035" y="1260"/>
                  </a:lnTo>
                  <a:lnTo>
                    <a:pt x="2036" y="1260"/>
                  </a:lnTo>
                  <a:lnTo>
                    <a:pt x="2036" y="1261"/>
                  </a:lnTo>
                  <a:lnTo>
                    <a:pt x="2037" y="1261"/>
                  </a:lnTo>
                  <a:lnTo>
                    <a:pt x="2038" y="1261"/>
                  </a:lnTo>
                  <a:lnTo>
                    <a:pt x="2038" y="1262"/>
                  </a:lnTo>
                  <a:lnTo>
                    <a:pt x="2039" y="1262"/>
                  </a:lnTo>
                  <a:lnTo>
                    <a:pt x="2040" y="1263"/>
                  </a:lnTo>
                  <a:lnTo>
                    <a:pt x="2041" y="1264"/>
                  </a:lnTo>
                  <a:lnTo>
                    <a:pt x="2042" y="1265"/>
                  </a:lnTo>
                  <a:lnTo>
                    <a:pt x="2043" y="1265"/>
                  </a:lnTo>
                  <a:lnTo>
                    <a:pt x="2043" y="1266"/>
                  </a:lnTo>
                  <a:lnTo>
                    <a:pt x="2044" y="1266"/>
                  </a:lnTo>
                  <a:lnTo>
                    <a:pt x="2044" y="1267"/>
                  </a:lnTo>
                  <a:lnTo>
                    <a:pt x="2045" y="1267"/>
                  </a:lnTo>
                  <a:lnTo>
                    <a:pt x="2045" y="1268"/>
                  </a:lnTo>
                  <a:lnTo>
                    <a:pt x="2046" y="1268"/>
                  </a:lnTo>
                  <a:lnTo>
                    <a:pt x="2046" y="1269"/>
                  </a:lnTo>
                  <a:lnTo>
                    <a:pt x="2047" y="1269"/>
                  </a:lnTo>
                  <a:lnTo>
                    <a:pt x="2047" y="1270"/>
                  </a:lnTo>
                  <a:lnTo>
                    <a:pt x="2048" y="1270"/>
                  </a:lnTo>
                  <a:lnTo>
                    <a:pt x="2048" y="1271"/>
                  </a:lnTo>
                  <a:lnTo>
                    <a:pt x="2049" y="1271"/>
                  </a:lnTo>
                  <a:lnTo>
                    <a:pt x="2049" y="1272"/>
                  </a:lnTo>
                  <a:lnTo>
                    <a:pt x="2050" y="1272"/>
                  </a:lnTo>
                  <a:lnTo>
                    <a:pt x="2051" y="1272"/>
                  </a:lnTo>
                  <a:lnTo>
                    <a:pt x="2052" y="1272"/>
                  </a:lnTo>
                  <a:lnTo>
                    <a:pt x="2053" y="1272"/>
                  </a:lnTo>
                  <a:lnTo>
                    <a:pt x="2054" y="1272"/>
                  </a:lnTo>
                  <a:lnTo>
                    <a:pt x="2054" y="1271"/>
                  </a:lnTo>
                  <a:lnTo>
                    <a:pt x="2055" y="1271"/>
                  </a:lnTo>
                  <a:lnTo>
                    <a:pt x="2056" y="1270"/>
                  </a:lnTo>
                  <a:lnTo>
                    <a:pt x="2056" y="1269"/>
                  </a:lnTo>
                  <a:lnTo>
                    <a:pt x="2056" y="1268"/>
                  </a:lnTo>
                  <a:lnTo>
                    <a:pt x="2057" y="1267"/>
                  </a:lnTo>
                  <a:lnTo>
                    <a:pt x="2057" y="1266"/>
                  </a:lnTo>
                  <a:lnTo>
                    <a:pt x="2058" y="1265"/>
                  </a:lnTo>
                  <a:lnTo>
                    <a:pt x="2058" y="1263"/>
                  </a:lnTo>
                  <a:lnTo>
                    <a:pt x="2059" y="1262"/>
                  </a:lnTo>
                  <a:lnTo>
                    <a:pt x="2059" y="1260"/>
                  </a:lnTo>
                  <a:lnTo>
                    <a:pt x="2060" y="1259"/>
                  </a:lnTo>
                  <a:lnTo>
                    <a:pt x="2060" y="1257"/>
                  </a:lnTo>
                  <a:lnTo>
                    <a:pt x="2061" y="1256"/>
                  </a:lnTo>
                  <a:lnTo>
                    <a:pt x="2061" y="1254"/>
                  </a:lnTo>
                  <a:lnTo>
                    <a:pt x="2062" y="1252"/>
                  </a:lnTo>
                  <a:lnTo>
                    <a:pt x="2062" y="1251"/>
                  </a:lnTo>
                  <a:lnTo>
                    <a:pt x="2063" y="1249"/>
                  </a:lnTo>
                  <a:lnTo>
                    <a:pt x="2063" y="1247"/>
                  </a:lnTo>
                  <a:lnTo>
                    <a:pt x="2064" y="1245"/>
                  </a:lnTo>
                  <a:lnTo>
                    <a:pt x="2064" y="1243"/>
                  </a:lnTo>
                  <a:lnTo>
                    <a:pt x="2065" y="1241"/>
                  </a:lnTo>
                  <a:lnTo>
                    <a:pt x="2065" y="1239"/>
                  </a:lnTo>
                  <a:lnTo>
                    <a:pt x="2065" y="1237"/>
                  </a:lnTo>
                  <a:lnTo>
                    <a:pt x="2066" y="1235"/>
                  </a:lnTo>
                  <a:lnTo>
                    <a:pt x="2066" y="1233"/>
                  </a:lnTo>
                  <a:lnTo>
                    <a:pt x="2067" y="1231"/>
                  </a:lnTo>
                  <a:lnTo>
                    <a:pt x="2067" y="1229"/>
                  </a:lnTo>
                  <a:lnTo>
                    <a:pt x="2068" y="1227"/>
                  </a:lnTo>
                  <a:lnTo>
                    <a:pt x="2068" y="1225"/>
                  </a:lnTo>
                  <a:lnTo>
                    <a:pt x="2069" y="1223"/>
                  </a:lnTo>
                  <a:lnTo>
                    <a:pt x="2069" y="1221"/>
                  </a:lnTo>
                  <a:lnTo>
                    <a:pt x="2070" y="1219"/>
                  </a:lnTo>
                  <a:lnTo>
                    <a:pt x="2070" y="1217"/>
                  </a:lnTo>
                  <a:lnTo>
                    <a:pt x="2071" y="1215"/>
                  </a:lnTo>
                  <a:lnTo>
                    <a:pt x="2071" y="1213"/>
                  </a:lnTo>
                  <a:lnTo>
                    <a:pt x="2072" y="1211"/>
                  </a:lnTo>
                  <a:lnTo>
                    <a:pt x="2072" y="1209"/>
                  </a:lnTo>
                  <a:lnTo>
                    <a:pt x="2073" y="1207"/>
                  </a:lnTo>
                  <a:lnTo>
                    <a:pt x="2073" y="1205"/>
                  </a:lnTo>
                  <a:lnTo>
                    <a:pt x="2073" y="1203"/>
                  </a:lnTo>
                  <a:lnTo>
                    <a:pt x="2074" y="1201"/>
                  </a:lnTo>
                  <a:lnTo>
                    <a:pt x="2074" y="1200"/>
                  </a:lnTo>
                  <a:lnTo>
                    <a:pt x="2075" y="1198"/>
                  </a:lnTo>
                  <a:lnTo>
                    <a:pt x="2075" y="1196"/>
                  </a:lnTo>
                  <a:lnTo>
                    <a:pt x="2076" y="1194"/>
                  </a:lnTo>
                  <a:lnTo>
                    <a:pt x="2076" y="1192"/>
                  </a:lnTo>
                  <a:lnTo>
                    <a:pt x="2077" y="1191"/>
                  </a:lnTo>
                  <a:lnTo>
                    <a:pt x="2077" y="1189"/>
                  </a:lnTo>
                  <a:lnTo>
                    <a:pt x="2078" y="1187"/>
                  </a:lnTo>
                  <a:lnTo>
                    <a:pt x="2078" y="1186"/>
                  </a:lnTo>
                  <a:lnTo>
                    <a:pt x="2079" y="1184"/>
                  </a:lnTo>
                  <a:lnTo>
                    <a:pt x="2079" y="1183"/>
                  </a:lnTo>
                  <a:lnTo>
                    <a:pt x="2080" y="1181"/>
                  </a:lnTo>
                  <a:lnTo>
                    <a:pt x="2080" y="1180"/>
                  </a:lnTo>
                  <a:lnTo>
                    <a:pt x="2081" y="1179"/>
                  </a:lnTo>
                  <a:lnTo>
                    <a:pt x="2081" y="1177"/>
                  </a:lnTo>
                  <a:lnTo>
                    <a:pt x="2082" y="1176"/>
                  </a:lnTo>
                  <a:lnTo>
                    <a:pt x="2082" y="1175"/>
                  </a:lnTo>
                  <a:lnTo>
                    <a:pt x="2082" y="1174"/>
                  </a:lnTo>
                  <a:lnTo>
                    <a:pt x="2083" y="1172"/>
                  </a:lnTo>
                  <a:lnTo>
                    <a:pt x="2083" y="1171"/>
                  </a:lnTo>
                  <a:lnTo>
                    <a:pt x="2084" y="1170"/>
                  </a:lnTo>
                  <a:lnTo>
                    <a:pt x="2084" y="1169"/>
                  </a:lnTo>
                  <a:lnTo>
                    <a:pt x="2085" y="1168"/>
                  </a:lnTo>
                  <a:lnTo>
                    <a:pt x="2085" y="1167"/>
                  </a:lnTo>
                  <a:lnTo>
                    <a:pt x="2086" y="1166"/>
                  </a:lnTo>
                  <a:lnTo>
                    <a:pt x="2086" y="1165"/>
                  </a:lnTo>
                  <a:lnTo>
                    <a:pt x="2087" y="1164"/>
                  </a:lnTo>
                  <a:lnTo>
                    <a:pt x="2088" y="1163"/>
                  </a:lnTo>
                  <a:lnTo>
                    <a:pt x="2088" y="1162"/>
                  </a:lnTo>
                  <a:lnTo>
                    <a:pt x="2089" y="1161"/>
                  </a:lnTo>
                  <a:lnTo>
                    <a:pt x="2090" y="1160"/>
                  </a:lnTo>
                  <a:lnTo>
                    <a:pt x="2090" y="1159"/>
                  </a:lnTo>
                  <a:lnTo>
                    <a:pt x="2090" y="1158"/>
                  </a:lnTo>
                  <a:lnTo>
                    <a:pt x="2091" y="1158"/>
                  </a:lnTo>
                  <a:lnTo>
                    <a:pt x="2091" y="1157"/>
                  </a:lnTo>
                  <a:lnTo>
                    <a:pt x="2092" y="1157"/>
                  </a:lnTo>
                  <a:lnTo>
                    <a:pt x="2092" y="1156"/>
                  </a:lnTo>
                  <a:lnTo>
                    <a:pt x="2093" y="1156"/>
                  </a:lnTo>
                  <a:lnTo>
                    <a:pt x="2093" y="1155"/>
                  </a:lnTo>
                  <a:lnTo>
                    <a:pt x="2094" y="1155"/>
                  </a:lnTo>
                  <a:lnTo>
                    <a:pt x="2094" y="1154"/>
                  </a:lnTo>
                  <a:lnTo>
                    <a:pt x="2095" y="1154"/>
                  </a:lnTo>
                  <a:lnTo>
                    <a:pt x="2096" y="1153"/>
                  </a:lnTo>
                  <a:lnTo>
                    <a:pt x="2097" y="1153"/>
                  </a:lnTo>
                  <a:lnTo>
                    <a:pt x="2098" y="1153"/>
                  </a:lnTo>
                  <a:lnTo>
                    <a:pt x="2099" y="1153"/>
                  </a:lnTo>
                  <a:lnTo>
                    <a:pt x="2100" y="1153"/>
                  </a:lnTo>
                  <a:lnTo>
                    <a:pt x="2100" y="1154"/>
                  </a:lnTo>
                  <a:lnTo>
                    <a:pt x="2101" y="1154"/>
                  </a:lnTo>
                  <a:lnTo>
                    <a:pt x="2102" y="1155"/>
                  </a:lnTo>
                  <a:lnTo>
                    <a:pt x="2103" y="1156"/>
                  </a:lnTo>
                  <a:lnTo>
                    <a:pt x="2103" y="1157"/>
                  </a:lnTo>
                  <a:lnTo>
                    <a:pt x="2104" y="1158"/>
                  </a:lnTo>
                  <a:lnTo>
                    <a:pt x="2104" y="1159"/>
                  </a:lnTo>
                  <a:lnTo>
                    <a:pt x="2105" y="1160"/>
                  </a:lnTo>
                  <a:lnTo>
                    <a:pt x="2105" y="1161"/>
                  </a:lnTo>
                  <a:lnTo>
                    <a:pt x="2106" y="1163"/>
                  </a:lnTo>
                  <a:lnTo>
                    <a:pt x="2106" y="1164"/>
                  </a:lnTo>
                  <a:lnTo>
                    <a:pt x="2107" y="1165"/>
                  </a:lnTo>
                  <a:lnTo>
                    <a:pt x="2107" y="1166"/>
                  </a:lnTo>
                  <a:lnTo>
                    <a:pt x="2107" y="1167"/>
                  </a:lnTo>
                  <a:lnTo>
                    <a:pt x="2108" y="1168"/>
                  </a:lnTo>
                  <a:lnTo>
                    <a:pt x="2108" y="1170"/>
                  </a:lnTo>
                  <a:lnTo>
                    <a:pt x="2109" y="1171"/>
                  </a:lnTo>
                  <a:lnTo>
                    <a:pt x="2109" y="1172"/>
                  </a:lnTo>
                  <a:lnTo>
                    <a:pt x="2110" y="1173"/>
                  </a:lnTo>
                  <a:lnTo>
                    <a:pt x="2110" y="1174"/>
                  </a:lnTo>
                  <a:lnTo>
                    <a:pt x="2111" y="1175"/>
                  </a:lnTo>
                  <a:lnTo>
                    <a:pt x="2111" y="1176"/>
                  </a:lnTo>
                  <a:lnTo>
                    <a:pt x="2112" y="1177"/>
                  </a:lnTo>
                  <a:lnTo>
                    <a:pt x="2112" y="1178"/>
                  </a:lnTo>
                  <a:lnTo>
                    <a:pt x="2113" y="1178"/>
                  </a:lnTo>
                  <a:lnTo>
                    <a:pt x="2113" y="1179"/>
                  </a:lnTo>
                  <a:lnTo>
                    <a:pt x="2114" y="1179"/>
                  </a:lnTo>
                  <a:lnTo>
                    <a:pt x="2114" y="1180"/>
                  </a:lnTo>
                  <a:lnTo>
                    <a:pt x="2115" y="1180"/>
                  </a:lnTo>
                  <a:lnTo>
                    <a:pt x="2116" y="1180"/>
                  </a:lnTo>
                  <a:lnTo>
                    <a:pt x="2117" y="1179"/>
                  </a:lnTo>
                  <a:lnTo>
                    <a:pt x="2118" y="1178"/>
                  </a:lnTo>
                  <a:lnTo>
                    <a:pt x="2119" y="1177"/>
                  </a:lnTo>
                  <a:lnTo>
                    <a:pt x="2119" y="1176"/>
                  </a:lnTo>
                  <a:lnTo>
                    <a:pt x="2120" y="1176"/>
                  </a:lnTo>
                  <a:lnTo>
                    <a:pt x="2120" y="1175"/>
                  </a:lnTo>
                  <a:lnTo>
                    <a:pt x="2121" y="1174"/>
                  </a:lnTo>
                  <a:lnTo>
                    <a:pt x="2121" y="1173"/>
                  </a:lnTo>
                  <a:lnTo>
                    <a:pt x="2122" y="1172"/>
                  </a:lnTo>
                  <a:lnTo>
                    <a:pt x="2122" y="1171"/>
                  </a:lnTo>
                  <a:lnTo>
                    <a:pt x="2123" y="1170"/>
                  </a:lnTo>
                  <a:lnTo>
                    <a:pt x="2123" y="1169"/>
                  </a:lnTo>
                  <a:lnTo>
                    <a:pt x="2124" y="1168"/>
                  </a:lnTo>
                  <a:lnTo>
                    <a:pt x="2124" y="1166"/>
                  </a:lnTo>
                  <a:lnTo>
                    <a:pt x="2125" y="1165"/>
                  </a:lnTo>
                  <a:lnTo>
                    <a:pt x="2125" y="1164"/>
                  </a:lnTo>
                  <a:lnTo>
                    <a:pt x="2125" y="1163"/>
                  </a:lnTo>
                  <a:lnTo>
                    <a:pt x="2126" y="1162"/>
                  </a:lnTo>
                  <a:lnTo>
                    <a:pt x="2126" y="1160"/>
                  </a:lnTo>
                  <a:lnTo>
                    <a:pt x="2127" y="1159"/>
                  </a:lnTo>
                  <a:lnTo>
                    <a:pt x="2127" y="1158"/>
                  </a:lnTo>
                  <a:lnTo>
                    <a:pt x="2128" y="1157"/>
                  </a:lnTo>
                  <a:lnTo>
                    <a:pt x="2128" y="1156"/>
                  </a:lnTo>
                  <a:lnTo>
                    <a:pt x="2129" y="1154"/>
                  </a:lnTo>
                  <a:lnTo>
                    <a:pt x="2129" y="1153"/>
                  </a:lnTo>
                  <a:lnTo>
                    <a:pt x="2130" y="1152"/>
                  </a:lnTo>
                  <a:lnTo>
                    <a:pt x="2130" y="1151"/>
                  </a:lnTo>
                  <a:lnTo>
                    <a:pt x="2131" y="1150"/>
                  </a:lnTo>
                  <a:lnTo>
                    <a:pt x="2131" y="1149"/>
                  </a:lnTo>
                  <a:lnTo>
                    <a:pt x="2132" y="1148"/>
                  </a:lnTo>
                  <a:lnTo>
                    <a:pt x="2132" y="1147"/>
                  </a:lnTo>
                  <a:lnTo>
                    <a:pt x="2133" y="1146"/>
                  </a:lnTo>
                  <a:lnTo>
                    <a:pt x="2133" y="1145"/>
                  </a:lnTo>
                  <a:lnTo>
                    <a:pt x="2133" y="1144"/>
                  </a:lnTo>
                  <a:lnTo>
                    <a:pt x="2134" y="1143"/>
                  </a:lnTo>
                  <a:lnTo>
                    <a:pt x="2134" y="1142"/>
                  </a:lnTo>
                  <a:lnTo>
                    <a:pt x="2135" y="1142"/>
                  </a:lnTo>
                  <a:lnTo>
                    <a:pt x="2135" y="1141"/>
                  </a:lnTo>
                  <a:lnTo>
                    <a:pt x="2136" y="1141"/>
                  </a:lnTo>
                  <a:lnTo>
                    <a:pt x="2136" y="1140"/>
                  </a:lnTo>
                  <a:lnTo>
                    <a:pt x="2137" y="1140"/>
                  </a:lnTo>
                  <a:lnTo>
                    <a:pt x="2137" y="1139"/>
                  </a:lnTo>
                  <a:lnTo>
                    <a:pt x="2138" y="1139"/>
                  </a:lnTo>
                  <a:lnTo>
                    <a:pt x="2139" y="1138"/>
                  </a:lnTo>
                  <a:lnTo>
                    <a:pt x="2140" y="1138"/>
                  </a:lnTo>
                  <a:lnTo>
                    <a:pt x="2141" y="1138"/>
                  </a:lnTo>
                  <a:lnTo>
                    <a:pt x="2142" y="1138"/>
                  </a:lnTo>
                  <a:lnTo>
                    <a:pt x="2142" y="1139"/>
                  </a:lnTo>
                  <a:lnTo>
                    <a:pt x="2143" y="1139"/>
                  </a:lnTo>
                  <a:lnTo>
                    <a:pt x="2144" y="1140"/>
                  </a:lnTo>
                  <a:lnTo>
                    <a:pt x="2145" y="1140"/>
                  </a:lnTo>
                  <a:lnTo>
                    <a:pt x="2145" y="1141"/>
                  </a:lnTo>
                  <a:lnTo>
                    <a:pt x="2146" y="1141"/>
                  </a:lnTo>
                  <a:lnTo>
                    <a:pt x="2147" y="1142"/>
                  </a:lnTo>
                  <a:lnTo>
                    <a:pt x="2148" y="1142"/>
                  </a:lnTo>
                  <a:lnTo>
                    <a:pt x="2148" y="1143"/>
                  </a:lnTo>
                  <a:lnTo>
                    <a:pt x="2149" y="1143"/>
                  </a:lnTo>
                  <a:lnTo>
                    <a:pt x="2150" y="1143"/>
                  </a:lnTo>
                  <a:lnTo>
                    <a:pt x="2150" y="1144"/>
                  </a:lnTo>
                  <a:lnTo>
                    <a:pt x="2151" y="1144"/>
                  </a:lnTo>
                  <a:lnTo>
                    <a:pt x="2152" y="1144"/>
                  </a:lnTo>
                  <a:lnTo>
                    <a:pt x="2153" y="1143"/>
                  </a:lnTo>
                  <a:lnTo>
                    <a:pt x="2154" y="1143"/>
                  </a:lnTo>
                  <a:lnTo>
                    <a:pt x="2155" y="1143"/>
                  </a:lnTo>
                  <a:lnTo>
                    <a:pt x="2155" y="1142"/>
                  </a:lnTo>
                  <a:lnTo>
                    <a:pt x="2156" y="1142"/>
                  </a:lnTo>
                  <a:lnTo>
                    <a:pt x="2157" y="1141"/>
                  </a:lnTo>
                  <a:lnTo>
                    <a:pt x="2158" y="1141"/>
                  </a:lnTo>
                  <a:lnTo>
                    <a:pt x="2158" y="1140"/>
                  </a:lnTo>
                  <a:lnTo>
                    <a:pt x="2159" y="1140"/>
                  </a:lnTo>
                  <a:lnTo>
                    <a:pt x="2159" y="1139"/>
                  </a:lnTo>
                  <a:lnTo>
                    <a:pt x="2159" y="1138"/>
                  </a:lnTo>
                  <a:lnTo>
                    <a:pt x="2160" y="1138"/>
                  </a:lnTo>
                  <a:lnTo>
                    <a:pt x="2160" y="1137"/>
                  </a:lnTo>
                  <a:lnTo>
                    <a:pt x="2161" y="1136"/>
                  </a:lnTo>
                  <a:lnTo>
                    <a:pt x="2162" y="1135"/>
                  </a:lnTo>
                  <a:lnTo>
                    <a:pt x="2162" y="1134"/>
                  </a:lnTo>
                  <a:lnTo>
                    <a:pt x="2163" y="1133"/>
                  </a:lnTo>
                  <a:lnTo>
                    <a:pt x="2164" y="1132"/>
                  </a:lnTo>
                  <a:lnTo>
                    <a:pt x="2164" y="1131"/>
                  </a:lnTo>
                  <a:lnTo>
                    <a:pt x="2165" y="1130"/>
                  </a:lnTo>
                  <a:lnTo>
                    <a:pt x="2165" y="1129"/>
                  </a:lnTo>
                  <a:lnTo>
                    <a:pt x="2166" y="1128"/>
                  </a:lnTo>
                  <a:lnTo>
                    <a:pt x="2166" y="1127"/>
                  </a:lnTo>
                  <a:lnTo>
                    <a:pt x="2167" y="1126"/>
                  </a:lnTo>
                  <a:lnTo>
                    <a:pt x="2167" y="1125"/>
                  </a:lnTo>
                  <a:lnTo>
                    <a:pt x="2168" y="1124"/>
                  </a:lnTo>
                  <a:lnTo>
                    <a:pt x="2168" y="1123"/>
                  </a:lnTo>
                  <a:lnTo>
                    <a:pt x="2169" y="1122"/>
                  </a:lnTo>
                  <a:lnTo>
                    <a:pt x="2169" y="1121"/>
                  </a:lnTo>
                  <a:lnTo>
                    <a:pt x="2170" y="1120"/>
                  </a:lnTo>
                  <a:lnTo>
                    <a:pt x="2170" y="1119"/>
                  </a:lnTo>
                  <a:lnTo>
                    <a:pt x="2171" y="1118"/>
                  </a:lnTo>
                  <a:lnTo>
                    <a:pt x="2172" y="1117"/>
                  </a:lnTo>
                  <a:lnTo>
                    <a:pt x="2172" y="1116"/>
                  </a:lnTo>
                  <a:lnTo>
                    <a:pt x="2173" y="1115"/>
                  </a:lnTo>
                  <a:lnTo>
                    <a:pt x="2174" y="1114"/>
                  </a:lnTo>
                  <a:lnTo>
                    <a:pt x="2174" y="1113"/>
                  </a:lnTo>
                  <a:lnTo>
                    <a:pt x="2175" y="1113"/>
                  </a:lnTo>
                  <a:lnTo>
                    <a:pt x="2175" y="1112"/>
                  </a:lnTo>
                  <a:lnTo>
                    <a:pt x="2176" y="1112"/>
                  </a:lnTo>
                  <a:lnTo>
                    <a:pt x="2176" y="1111"/>
                  </a:lnTo>
                  <a:lnTo>
                    <a:pt x="2177" y="1111"/>
                  </a:lnTo>
                  <a:lnTo>
                    <a:pt x="2177" y="1110"/>
                  </a:lnTo>
                  <a:lnTo>
                    <a:pt x="2178" y="1110"/>
                  </a:lnTo>
                  <a:lnTo>
                    <a:pt x="2179" y="1109"/>
                  </a:lnTo>
                  <a:lnTo>
                    <a:pt x="2180" y="1109"/>
                  </a:lnTo>
                  <a:lnTo>
                    <a:pt x="2181" y="1108"/>
                  </a:lnTo>
                  <a:lnTo>
                    <a:pt x="2182" y="1108"/>
                  </a:lnTo>
                  <a:lnTo>
                    <a:pt x="2183" y="1108"/>
                  </a:lnTo>
                  <a:lnTo>
                    <a:pt x="2184" y="1107"/>
                  </a:lnTo>
                  <a:lnTo>
                    <a:pt x="2185" y="1107"/>
                  </a:lnTo>
                  <a:lnTo>
                    <a:pt x="2186" y="1107"/>
                  </a:lnTo>
                  <a:lnTo>
                    <a:pt x="2187" y="1107"/>
                  </a:lnTo>
                  <a:lnTo>
                    <a:pt x="2188" y="1106"/>
                  </a:lnTo>
                  <a:lnTo>
                    <a:pt x="2189" y="1106"/>
                  </a:lnTo>
                  <a:lnTo>
                    <a:pt x="2190" y="1106"/>
                  </a:lnTo>
                  <a:lnTo>
                    <a:pt x="2191" y="1106"/>
                  </a:lnTo>
                  <a:lnTo>
                    <a:pt x="2192" y="1106"/>
                  </a:lnTo>
                  <a:lnTo>
                    <a:pt x="2193" y="1106"/>
                  </a:lnTo>
                  <a:lnTo>
                    <a:pt x="2194" y="1106"/>
                  </a:lnTo>
                  <a:lnTo>
                    <a:pt x="2195" y="1107"/>
                  </a:lnTo>
                  <a:lnTo>
                    <a:pt x="2196" y="1107"/>
                  </a:lnTo>
                  <a:lnTo>
                    <a:pt x="2197" y="1107"/>
                  </a:lnTo>
                  <a:lnTo>
                    <a:pt x="2198" y="1107"/>
                  </a:lnTo>
                  <a:lnTo>
                    <a:pt x="2198" y="1108"/>
                  </a:lnTo>
                  <a:lnTo>
                    <a:pt x="2199" y="1108"/>
                  </a:lnTo>
                  <a:lnTo>
                    <a:pt x="2200" y="1109"/>
                  </a:lnTo>
                  <a:lnTo>
                    <a:pt x="2201" y="1109"/>
                  </a:lnTo>
                  <a:lnTo>
                    <a:pt x="2201" y="1110"/>
                  </a:lnTo>
                  <a:lnTo>
                    <a:pt x="2202" y="1110"/>
                  </a:lnTo>
                  <a:lnTo>
                    <a:pt x="2202" y="1111"/>
                  </a:lnTo>
                  <a:lnTo>
                    <a:pt x="2203" y="1111"/>
                  </a:lnTo>
                  <a:lnTo>
                    <a:pt x="2203" y="1112"/>
                  </a:lnTo>
                  <a:lnTo>
                    <a:pt x="2204" y="1112"/>
                  </a:lnTo>
                  <a:lnTo>
                    <a:pt x="2205" y="1113"/>
                  </a:lnTo>
                  <a:lnTo>
                    <a:pt x="2206" y="1114"/>
                  </a:lnTo>
                  <a:lnTo>
                    <a:pt x="2206" y="1115"/>
                  </a:lnTo>
                  <a:lnTo>
                    <a:pt x="2207" y="1115"/>
                  </a:lnTo>
                  <a:lnTo>
                    <a:pt x="2207" y="1116"/>
                  </a:lnTo>
                  <a:lnTo>
                    <a:pt x="2208" y="1116"/>
                  </a:lnTo>
                  <a:lnTo>
                    <a:pt x="2208" y="1117"/>
                  </a:lnTo>
                  <a:lnTo>
                    <a:pt x="2209" y="1118"/>
                  </a:lnTo>
                  <a:lnTo>
                    <a:pt x="2210" y="1119"/>
                  </a:lnTo>
                  <a:lnTo>
                    <a:pt x="2210" y="1120"/>
                  </a:lnTo>
                  <a:lnTo>
                    <a:pt x="2211" y="1121"/>
                  </a:lnTo>
                  <a:lnTo>
                    <a:pt x="2211" y="1122"/>
                  </a:lnTo>
                  <a:lnTo>
                    <a:pt x="2212" y="1122"/>
                  </a:lnTo>
                  <a:lnTo>
                    <a:pt x="2212" y="1123"/>
                  </a:lnTo>
                  <a:lnTo>
                    <a:pt x="2213" y="1124"/>
                  </a:lnTo>
                  <a:lnTo>
                    <a:pt x="2213" y="1125"/>
                  </a:lnTo>
                  <a:lnTo>
                    <a:pt x="2214" y="1125"/>
                  </a:lnTo>
                  <a:lnTo>
                    <a:pt x="2214" y="1126"/>
                  </a:lnTo>
                  <a:lnTo>
                    <a:pt x="2215" y="1127"/>
                  </a:lnTo>
                  <a:lnTo>
                    <a:pt x="2215" y="1128"/>
                  </a:lnTo>
                  <a:lnTo>
                    <a:pt x="2216" y="1128"/>
                  </a:lnTo>
                  <a:lnTo>
                    <a:pt x="2216" y="1129"/>
                  </a:lnTo>
                  <a:lnTo>
                    <a:pt x="2217" y="1130"/>
                  </a:lnTo>
                  <a:lnTo>
                    <a:pt x="2217" y="1131"/>
                  </a:lnTo>
                  <a:lnTo>
                    <a:pt x="2218" y="1131"/>
                  </a:lnTo>
                  <a:lnTo>
                    <a:pt x="2218" y="1132"/>
                  </a:lnTo>
                  <a:lnTo>
                    <a:pt x="2219" y="1133"/>
                  </a:lnTo>
                  <a:lnTo>
                    <a:pt x="2219" y="1134"/>
                  </a:lnTo>
                  <a:lnTo>
                    <a:pt x="2220" y="1135"/>
                  </a:lnTo>
                  <a:lnTo>
                    <a:pt x="2220" y="1136"/>
                  </a:lnTo>
                  <a:lnTo>
                    <a:pt x="2221" y="1136"/>
                  </a:lnTo>
                  <a:lnTo>
                    <a:pt x="2221" y="1137"/>
                  </a:lnTo>
                  <a:lnTo>
                    <a:pt x="2222" y="1138"/>
                  </a:lnTo>
                  <a:lnTo>
                    <a:pt x="2223" y="1139"/>
                  </a:lnTo>
                  <a:lnTo>
                    <a:pt x="2224" y="1140"/>
                  </a:lnTo>
                  <a:lnTo>
                    <a:pt x="2225" y="1141"/>
                  </a:lnTo>
                  <a:lnTo>
                    <a:pt x="2226" y="1141"/>
                  </a:lnTo>
                  <a:lnTo>
                    <a:pt x="2226" y="1142"/>
                  </a:lnTo>
                  <a:lnTo>
                    <a:pt x="2227" y="1142"/>
                  </a:lnTo>
                  <a:lnTo>
                    <a:pt x="2228" y="1142"/>
                  </a:lnTo>
                  <a:lnTo>
                    <a:pt x="2229" y="1142"/>
                  </a:lnTo>
                  <a:lnTo>
                    <a:pt x="2230" y="1142"/>
                  </a:lnTo>
                  <a:lnTo>
                    <a:pt x="2231" y="1142"/>
                  </a:lnTo>
                  <a:lnTo>
                    <a:pt x="2231" y="1141"/>
                  </a:lnTo>
                  <a:lnTo>
                    <a:pt x="2232" y="1141"/>
                  </a:lnTo>
                  <a:lnTo>
                    <a:pt x="2232" y="1140"/>
                  </a:lnTo>
                  <a:lnTo>
                    <a:pt x="2233" y="1140"/>
                  </a:lnTo>
                  <a:lnTo>
                    <a:pt x="2233" y="1139"/>
                  </a:lnTo>
                  <a:lnTo>
                    <a:pt x="2234" y="1138"/>
                  </a:lnTo>
                  <a:lnTo>
                    <a:pt x="2234" y="1137"/>
                  </a:lnTo>
                  <a:lnTo>
                    <a:pt x="2235" y="1136"/>
                  </a:lnTo>
                  <a:lnTo>
                    <a:pt x="2235" y="1135"/>
                  </a:lnTo>
                  <a:lnTo>
                    <a:pt x="2236" y="1133"/>
                  </a:lnTo>
                  <a:lnTo>
                    <a:pt x="2236" y="1132"/>
                  </a:lnTo>
                  <a:lnTo>
                    <a:pt x="2236" y="1131"/>
                  </a:lnTo>
                  <a:lnTo>
                    <a:pt x="2237" y="1130"/>
                  </a:lnTo>
                  <a:lnTo>
                    <a:pt x="2237" y="1128"/>
                  </a:lnTo>
                  <a:lnTo>
                    <a:pt x="2238" y="1127"/>
                  </a:lnTo>
                  <a:lnTo>
                    <a:pt x="2238" y="1125"/>
                  </a:lnTo>
                  <a:lnTo>
                    <a:pt x="2239" y="1124"/>
                  </a:lnTo>
                  <a:lnTo>
                    <a:pt x="2239" y="1122"/>
                  </a:lnTo>
                  <a:lnTo>
                    <a:pt x="2240" y="1121"/>
                  </a:lnTo>
                  <a:lnTo>
                    <a:pt x="2240" y="1119"/>
                  </a:lnTo>
                  <a:lnTo>
                    <a:pt x="2241" y="1118"/>
                  </a:lnTo>
                  <a:lnTo>
                    <a:pt x="2241" y="1116"/>
                  </a:lnTo>
                  <a:lnTo>
                    <a:pt x="2242" y="1115"/>
                  </a:lnTo>
                  <a:lnTo>
                    <a:pt x="2242" y="1113"/>
                  </a:lnTo>
                  <a:lnTo>
                    <a:pt x="2243" y="1112"/>
                  </a:lnTo>
                  <a:lnTo>
                    <a:pt x="2243" y="1110"/>
                  </a:lnTo>
                  <a:lnTo>
                    <a:pt x="2244" y="1108"/>
                  </a:lnTo>
                  <a:lnTo>
                    <a:pt x="2244" y="1107"/>
                  </a:lnTo>
                  <a:lnTo>
                    <a:pt x="2244" y="1105"/>
                  </a:lnTo>
                  <a:lnTo>
                    <a:pt x="2245" y="1104"/>
                  </a:lnTo>
                  <a:lnTo>
                    <a:pt x="2245" y="1102"/>
                  </a:lnTo>
                  <a:lnTo>
                    <a:pt x="2246" y="1101"/>
                  </a:lnTo>
                  <a:lnTo>
                    <a:pt x="2246" y="1099"/>
                  </a:lnTo>
                  <a:lnTo>
                    <a:pt x="2247" y="1097"/>
                  </a:lnTo>
                  <a:lnTo>
                    <a:pt x="2247" y="1096"/>
                  </a:lnTo>
                  <a:lnTo>
                    <a:pt x="2248" y="1094"/>
                  </a:lnTo>
                  <a:lnTo>
                    <a:pt x="2248" y="1093"/>
                  </a:lnTo>
                  <a:lnTo>
                    <a:pt x="2249" y="1091"/>
                  </a:lnTo>
                  <a:lnTo>
                    <a:pt x="2249" y="1090"/>
                  </a:lnTo>
                  <a:lnTo>
                    <a:pt x="2250" y="1088"/>
                  </a:lnTo>
                  <a:lnTo>
                    <a:pt x="2250" y="1087"/>
                  </a:lnTo>
                  <a:lnTo>
                    <a:pt x="2251" y="1086"/>
                  </a:lnTo>
                  <a:lnTo>
                    <a:pt x="2251" y="1084"/>
                  </a:lnTo>
                  <a:lnTo>
                    <a:pt x="2252" y="1083"/>
                  </a:lnTo>
                  <a:lnTo>
                    <a:pt x="2252" y="1081"/>
                  </a:lnTo>
                  <a:lnTo>
                    <a:pt x="2253" y="1080"/>
                  </a:lnTo>
                  <a:lnTo>
                    <a:pt x="2253" y="1079"/>
                  </a:lnTo>
                  <a:lnTo>
                    <a:pt x="2253" y="1077"/>
                  </a:lnTo>
                  <a:lnTo>
                    <a:pt x="2254" y="1076"/>
                  </a:lnTo>
                  <a:lnTo>
                    <a:pt x="2254" y="1075"/>
                  </a:lnTo>
                  <a:lnTo>
                    <a:pt x="2255" y="1073"/>
                  </a:lnTo>
                  <a:lnTo>
                    <a:pt x="2255" y="1072"/>
                  </a:lnTo>
                  <a:lnTo>
                    <a:pt x="2256" y="1071"/>
                  </a:lnTo>
                  <a:lnTo>
                    <a:pt x="2256" y="1069"/>
                  </a:lnTo>
                  <a:lnTo>
                    <a:pt x="2257" y="1068"/>
                  </a:lnTo>
                  <a:lnTo>
                    <a:pt x="2257" y="1067"/>
                  </a:lnTo>
                  <a:lnTo>
                    <a:pt x="2258" y="1066"/>
                  </a:lnTo>
                  <a:lnTo>
                    <a:pt x="2258" y="1064"/>
                  </a:lnTo>
                  <a:lnTo>
                    <a:pt x="2259" y="1063"/>
                  </a:lnTo>
                  <a:lnTo>
                    <a:pt x="2259" y="1062"/>
                  </a:lnTo>
                  <a:lnTo>
                    <a:pt x="2260" y="1060"/>
                  </a:lnTo>
                  <a:lnTo>
                    <a:pt x="2260" y="1059"/>
                  </a:lnTo>
                  <a:lnTo>
                    <a:pt x="2261" y="1058"/>
                  </a:lnTo>
                  <a:lnTo>
                    <a:pt x="2261" y="1056"/>
                  </a:lnTo>
                  <a:lnTo>
                    <a:pt x="2261" y="1054"/>
                  </a:lnTo>
                  <a:lnTo>
                    <a:pt x="2262" y="1053"/>
                  </a:lnTo>
                  <a:lnTo>
                    <a:pt x="2262" y="1051"/>
                  </a:lnTo>
                  <a:lnTo>
                    <a:pt x="2263" y="1049"/>
                  </a:lnTo>
                  <a:lnTo>
                    <a:pt x="2263" y="1048"/>
                  </a:lnTo>
                  <a:lnTo>
                    <a:pt x="2264" y="1046"/>
                  </a:lnTo>
                  <a:lnTo>
                    <a:pt x="2264" y="1044"/>
                  </a:lnTo>
                  <a:lnTo>
                    <a:pt x="2265" y="1042"/>
                  </a:lnTo>
                  <a:lnTo>
                    <a:pt x="2265" y="1039"/>
                  </a:lnTo>
                  <a:lnTo>
                    <a:pt x="2266" y="1037"/>
                  </a:lnTo>
                  <a:lnTo>
                    <a:pt x="2266" y="1035"/>
                  </a:lnTo>
                  <a:lnTo>
                    <a:pt x="2267" y="1032"/>
                  </a:lnTo>
                  <a:lnTo>
                    <a:pt x="2267" y="1030"/>
                  </a:lnTo>
                  <a:lnTo>
                    <a:pt x="2268" y="1027"/>
                  </a:lnTo>
                  <a:lnTo>
                    <a:pt x="2268" y="1024"/>
                  </a:lnTo>
                  <a:lnTo>
                    <a:pt x="2269" y="1020"/>
                  </a:lnTo>
                  <a:lnTo>
                    <a:pt x="2269" y="1017"/>
                  </a:lnTo>
                  <a:lnTo>
                    <a:pt x="2270" y="1014"/>
                  </a:lnTo>
                  <a:lnTo>
                    <a:pt x="2270" y="1010"/>
                  </a:lnTo>
                  <a:lnTo>
                    <a:pt x="2270" y="1007"/>
                  </a:lnTo>
                  <a:lnTo>
                    <a:pt x="2271" y="1003"/>
                  </a:lnTo>
                  <a:lnTo>
                    <a:pt x="2271" y="999"/>
                  </a:lnTo>
                  <a:lnTo>
                    <a:pt x="2272" y="996"/>
                  </a:lnTo>
                  <a:lnTo>
                    <a:pt x="2272" y="992"/>
                  </a:lnTo>
                  <a:lnTo>
                    <a:pt x="2273" y="988"/>
                  </a:lnTo>
                  <a:lnTo>
                    <a:pt x="2273" y="985"/>
                  </a:lnTo>
                  <a:lnTo>
                    <a:pt x="2274" y="981"/>
                  </a:lnTo>
                  <a:lnTo>
                    <a:pt x="2274" y="977"/>
                  </a:lnTo>
                  <a:lnTo>
                    <a:pt x="2275" y="974"/>
                  </a:lnTo>
                  <a:lnTo>
                    <a:pt x="2275" y="970"/>
                  </a:lnTo>
                  <a:lnTo>
                    <a:pt x="2276" y="967"/>
                  </a:lnTo>
                  <a:lnTo>
                    <a:pt x="2276" y="963"/>
                  </a:lnTo>
                  <a:lnTo>
                    <a:pt x="2277" y="960"/>
                  </a:lnTo>
                  <a:lnTo>
                    <a:pt x="2277" y="957"/>
                  </a:lnTo>
                  <a:lnTo>
                    <a:pt x="2278" y="954"/>
                  </a:lnTo>
                  <a:lnTo>
                    <a:pt x="2278" y="951"/>
                  </a:lnTo>
                  <a:lnTo>
                    <a:pt x="2279" y="948"/>
                  </a:lnTo>
                  <a:lnTo>
                    <a:pt x="2279" y="946"/>
                  </a:lnTo>
                  <a:lnTo>
                    <a:pt x="2279" y="943"/>
                  </a:lnTo>
                  <a:lnTo>
                    <a:pt x="2280" y="942"/>
                  </a:lnTo>
                  <a:lnTo>
                    <a:pt x="2280" y="940"/>
                  </a:lnTo>
                  <a:lnTo>
                    <a:pt x="2281" y="938"/>
                  </a:lnTo>
                  <a:lnTo>
                    <a:pt x="2281" y="937"/>
                  </a:lnTo>
                  <a:lnTo>
                    <a:pt x="2282" y="936"/>
                  </a:lnTo>
                  <a:lnTo>
                    <a:pt x="2282" y="935"/>
                  </a:lnTo>
                  <a:lnTo>
                    <a:pt x="2283" y="934"/>
                  </a:lnTo>
                  <a:lnTo>
                    <a:pt x="2283" y="933"/>
                  </a:lnTo>
                  <a:lnTo>
                    <a:pt x="2284" y="932"/>
                  </a:lnTo>
                  <a:lnTo>
                    <a:pt x="2285" y="932"/>
                  </a:lnTo>
                  <a:lnTo>
                    <a:pt x="2285" y="931"/>
                  </a:lnTo>
                  <a:lnTo>
                    <a:pt x="2286" y="931"/>
                  </a:lnTo>
                  <a:lnTo>
                    <a:pt x="2287" y="931"/>
                  </a:lnTo>
                  <a:lnTo>
                    <a:pt x="2287" y="932"/>
                  </a:lnTo>
                  <a:lnTo>
                    <a:pt x="2288" y="932"/>
                  </a:lnTo>
                  <a:lnTo>
                    <a:pt x="2289" y="933"/>
                  </a:lnTo>
                  <a:lnTo>
                    <a:pt x="2290" y="934"/>
                  </a:lnTo>
                  <a:lnTo>
                    <a:pt x="2290" y="935"/>
                  </a:lnTo>
                  <a:lnTo>
                    <a:pt x="2291" y="935"/>
                  </a:lnTo>
                  <a:lnTo>
                    <a:pt x="2291" y="936"/>
                  </a:lnTo>
                  <a:lnTo>
                    <a:pt x="2292" y="937"/>
                  </a:lnTo>
                  <a:lnTo>
                    <a:pt x="2293" y="938"/>
                  </a:lnTo>
                  <a:lnTo>
                    <a:pt x="2293" y="939"/>
                  </a:lnTo>
                  <a:lnTo>
                    <a:pt x="2294" y="939"/>
                  </a:lnTo>
                  <a:lnTo>
                    <a:pt x="2294" y="940"/>
                  </a:lnTo>
                  <a:lnTo>
                    <a:pt x="2295" y="941"/>
                  </a:lnTo>
                  <a:lnTo>
                    <a:pt x="2296" y="942"/>
                  </a:lnTo>
                  <a:lnTo>
                    <a:pt x="2296" y="943"/>
                  </a:lnTo>
                  <a:lnTo>
                    <a:pt x="2297" y="944"/>
                  </a:lnTo>
                  <a:lnTo>
                    <a:pt x="2297" y="945"/>
                  </a:lnTo>
                  <a:lnTo>
                    <a:pt x="2298" y="945"/>
                  </a:lnTo>
                  <a:lnTo>
                    <a:pt x="2298" y="946"/>
                  </a:lnTo>
                  <a:lnTo>
                    <a:pt x="2299" y="946"/>
                  </a:lnTo>
                  <a:lnTo>
                    <a:pt x="2299" y="947"/>
                  </a:lnTo>
                  <a:lnTo>
                    <a:pt x="2300" y="947"/>
                  </a:lnTo>
                  <a:lnTo>
                    <a:pt x="2301" y="948"/>
                  </a:lnTo>
                  <a:lnTo>
                    <a:pt x="2302" y="948"/>
                  </a:lnTo>
                  <a:lnTo>
                    <a:pt x="2303" y="948"/>
                  </a:lnTo>
                  <a:lnTo>
                    <a:pt x="2304" y="948"/>
                  </a:lnTo>
                  <a:lnTo>
                    <a:pt x="2305" y="947"/>
                  </a:lnTo>
                  <a:lnTo>
                    <a:pt x="2306" y="947"/>
                  </a:lnTo>
                  <a:lnTo>
                    <a:pt x="2306" y="946"/>
                  </a:lnTo>
                  <a:lnTo>
                    <a:pt x="2307" y="946"/>
                  </a:lnTo>
                  <a:lnTo>
                    <a:pt x="2307" y="945"/>
                  </a:lnTo>
                  <a:lnTo>
                    <a:pt x="2308" y="944"/>
                  </a:lnTo>
                  <a:lnTo>
                    <a:pt x="2309" y="943"/>
                  </a:lnTo>
                  <a:lnTo>
                    <a:pt x="2309" y="942"/>
                  </a:lnTo>
                  <a:lnTo>
                    <a:pt x="2310" y="941"/>
                  </a:lnTo>
                  <a:lnTo>
                    <a:pt x="2310" y="940"/>
                  </a:lnTo>
                  <a:lnTo>
                    <a:pt x="2311" y="939"/>
                  </a:lnTo>
                  <a:lnTo>
                    <a:pt x="2311" y="938"/>
                  </a:lnTo>
                  <a:lnTo>
                    <a:pt x="2312" y="937"/>
                  </a:lnTo>
                  <a:lnTo>
                    <a:pt x="2312" y="936"/>
                  </a:lnTo>
                  <a:lnTo>
                    <a:pt x="2313" y="935"/>
                  </a:lnTo>
                  <a:lnTo>
                    <a:pt x="2313" y="934"/>
                  </a:lnTo>
                  <a:lnTo>
                    <a:pt x="2313" y="933"/>
                  </a:lnTo>
                  <a:lnTo>
                    <a:pt x="2314" y="932"/>
                  </a:lnTo>
                  <a:lnTo>
                    <a:pt x="2314" y="931"/>
                  </a:lnTo>
                  <a:lnTo>
                    <a:pt x="2315" y="930"/>
                  </a:lnTo>
                  <a:lnTo>
                    <a:pt x="2315" y="929"/>
                  </a:lnTo>
                  <a:lnTo>
                    <a:pt x="2316" y="928"/>
                  </a:lnTo>
                  <a:lnTo>
                    <a:pt x="2316" y="926"/>
                  </a:lnTo>
                  <a:lnTo>
                    <a:pt x="2317" y="925"/>
                  </a:lnTo>
                  <a:lnTo>
                    <a:pt x="2317" y="924"/>
                  </a:lnTo>
                  <a:lnTo>
                    <a:pt x="2318" y="923"/>
                  </a:lnTo>
                  <a:lnTo>
                    <a:pt x="2318" y="922"/>
                  </a:lnTo>
                  <a:lnTo>
                    <a:pt x="2319" y="921"/>
                  </a:lnTo>
                  <a:lnTo>
                    <a:pt x="2319" y="920"/>
                  </a:lnTo>
                  <a:lnTo>
                    <a:pt x="2320" y="919"/>
                  </a:lnTo>
                  <a:lnTo>
                    <a:pt x="2320" y="918"/>
                  </a:lnTo>
                  <a:lnTo>
                    <a:pt x="2321" y="917"/>
                  </a:lnTo>
                  <a:lnTo>
                    <a:pt x="2321" y="916"/>
                  </a:lnTo>
                  <a:lnTo>
                    <a:pt x="2321" y="915"/>
                  </a:lnTo>
                  <a:lnTo>
                    <a:pt x="2322" y="914"/>
                  </a:lnTo>
                  <a:lnTo>
                    <a:pt x="2322" y="913"/>
                  </a:lnTo>
                  <a:lnTo>
                    <a:pt x="2323" y="912"/>
                  </a:lnTo>
                  <a:lnTo>
                    <a:pt x="2323" y="911"/>
                  </a:lnTo>
                  <a:lnTo>
                    <a:pt x="2324" y="910"/>
                  </a:lnTo>
                  <a:lnTo>
                    <a:pt x="2325" y="909"/>
                  </a:lnTo>
                  <a:lnTo>
                    <a:pt x="2325" y="908"/>
                  </a:lnTo>
                  <a:lnTo>
                    <a:pt x="2326" y="908"/>
                  </a:lnTo>
                  <a:lnTo>
                    <a:pt x="2326" y="907"/>
                  </a:lnTo>
                  <a:lnTo>
                    <a:pt x="2327" y="907"/>
                  </a:lnTo>
                  <a:lnTo>
                    <a:pt x="2328" y="907"/>
                  </a:lnTo>
                  <a:lnTo>
                    <a:pt x="2329" y="906"/>
                  </a:lnTo>
                  <a:lnTo>
                    <a:pt x="2330" y="907"/>
                  </a:lnTo>
                  <a:lnTo>
                    <a:pt x="2331" y="907"/>
                  </a:lnTo>
                  <a:lnTo>
                    <a:pt x="2332" y="907"/>
                  </a:lnTo>
                  <a:lnTo>
                    <a:pt x="2333" y="908"/>
                  </a:lnTo>
                  <a:lnTo>
                    <a:pt x="2334" y="908"/>
                  </a:lnTo>
                  <a:lnTo>
                    <a:pt x="2335" y="909"/>
                  </a:lnTo>
                  <a:lnTo>
                    <a:pt x="2336" y="909"/>
                  </a:lnTo>
                  <a:lnTo>
                    <a:pt x="2337" y="910"/>
                  </a:lnTo>
                  <a:lnTo>
                    <a:pt x="2338" y="910"/>
                  </a:lnTo>
                  <a:lnTo>
                    <a:pt x="2339" y="910"/>
                  </a:lnTo>
                  <a:lnTo>
                    <a:pt x="2340" y="910"/>
                  </a:lnTo>
                  <a:lnTo>
                    <a:pt x="2341" y="909"/>
                  </a:lnTo>
                  <a:lnTo>
                    <a:pt x="2342" y="909"/>
                  </a:lnTo>
                  <a:lnTo>
                    <a:pt x="2342" y="908"/>
                  </a:lnTo>
                  <a:lnTo>
                    <a:pt x="2343" y="908"/>
                  </a:lnTo>
                  <a:lnTo>
                    <a:pt x="2344" y="907"/>
                  </a:lnTo>
                  <a:lnTo>
                    <a:pt x="2345" y="907"/>
                  </a:lnTo>
                  <a:lnTo>
                    <a:pt x="2345" y="906"/>
                  </a:lnTo>
                  <a:lnTo>
                    <a:pt x="2346" y="906"/>
                  </a:lnTo>
                  <a:lnTo>
                    <a:pt x="2347" y="906"/>
                  </a:lnTo>
                  <a:lnTo>
                    <a:pt x="2347" y="905"/>
                  </a:lnTo>
                  <a:lnTo>
                    <a:pt x="2348" y="905"/>
                  </a:lnTo>
                  <a:lnTo>
                    <a:pt x="2349" y="904"/>
                  </a:lnTo>
                  <a:lnTo>
                    <a:pt x="2350" y="904"/>
                  </a:lnTo>
                  <a:lnTo>
                    <a:pt x="2351" y="904"/>
                  </a:lnTo>
                  <a:lnTo>
                    <a:pt x="2352" y="905"/>
                  </a:lnTo>
                  <a:lnTo>
                    <a:pt x="2353" y="905"/>
                  </a:lnTo>
                  <a:lnTo>
                    <a:pt x="2353" y="906"/>
                  </a:lnTo>
                  <a:lnTo>
                    <a:pt x="2354" y="906"/>
                  </a:lnTo>
                  <a:lnTo>
                    <a:pt x="2354" y="907"/>
                  </a:lnTo>
                  <a:lnTo>
                    <a:pt x="2355" y="907"/>
                  </a:lnTo>
                  <a:lnTo>
                    <a:pt x="2356" y="908"/>
                  </a:lnTo>
                  <a:lnTo>
                    <a:pt x="2357" y="909"/>
                  </a:lnTo>
                  <a:lnTo>
                    <a:pt x="2358" y="909"/>
                  </a:lnTo>
                  <a:lnTo>
                    <a:pt x="2358" y="910"/>
                  </a:lnTo>
                  <a:lnTo>
                    <a:pt x="2359" y="910"/>
                  </a:lnTo>
                  <a:lnTo>
                    <a:pt x="2360" y="910"/>
                  </a:lnTo>
                  <a:lnTo>
                    <a:pt x="2361" y="910"/>
                  </a:lnTo>
                  <a:lnTo>
                    <a:pt x="2362" y="910"/>
                  </a:lnTo>
                  <a:lnTo>
                    <a:pt x="2363" y="910"/>
                  </a:lnTo>
                  <a:lnTo>
                    <a:pt x="2363" y="909"/>
                  </a:lnTo>
                  <a:lnTo>
                    <a:pt x="2364" y="909"/>
                  </a:lnTo>
                  <a:lnTo>
                    <a:pt x="2364" y="908"/>
                  </a:lnTo>
                  <a:lnTo>
                    <a:pt x="2365" y="907"/>
                  </a:lnTo>
                  <a:lnTo>
                    <a:pt x="2365" y="906"/>
                  </a:lnTo>
                  <a:lnTo>
                    <a:pt x="2366" y="906"/>
                  </a:lnTo>
                  <a:lnTo>
                    <a:pt x="2366" y="905"/>
                  </a:lnTo>
                  <a:lnTo>
                    <a:pt x="2367" y="904"/>
                  </a:lnTo>
                  <a:lnTo>
                    <a:pt x="2367" y="903"/>
                  </a:lnTo>
                  <a:lnTo>
                    <a:pt x="2368" y="902"/>
                  </a:lnTo>
                  <a:lnTo>
                    <a:pt x="2369" y="901"/>
                  </a:lnTo>
                  <a:lnTo>
                    <a:pt x="2369" y="900"/>
                  </a:lnTo>
                  <a:lnTo>
                    <a:pt x="2370" y="899"/>
                  </a:lnTo>
                  <a:lnTo>
                    <a:pt x="2371" y="898"/>
                  </a:lnTo>
                  <a:lnTo>
                    <a:pt x="2371" y="897"/>
                  </a:lnTo>
                  <a:lnTo>
                    <a:pt x="2372" y="897"/>
                  </a:lnTo>
                  <a:lnTo>
                    <a:pt x="2372" y="896"/>
                  </a:lnTo>
                  <a:lnTo>
                    <a:pt x="2373" y="896"/>
                  </a:lnTo>
                  <a:lnTo>
                    <a:pt x="2373" y="895"/>
                  </a:lnTo>
                  <a:lnTo>
                    <a:pt x="2374" y="895"/>
                  </a:lnTo>
                  <a:lnTo>
                    <a:pt x="2375" y="895"/>
                  </a:lnTo>
                  <a:lnTo>
                    <a:pt x="2375" y="896"/>
                  </a:lnTo>
                  <a:lnTo>
                    <a:pt x="2376" y="896"/>
                  </a:lnTo>
                  <a:lnTo>
                    <a:pt x="2376" y="897"/>
                  </a:lnTo>
                  <a:lnTo>
                    <a:pt x="2377" y="897"/>
                  </a:lnTo>
                  <a:lnTo>
                    <a:pt x="2377" y="898"/>
                  </a:lnTo>
                  <a:lnTo>
                    <a:pt x="2378" y="899"/>
                  </a:lnTo>
                  <a:lnTo>
                    <a:pt x="2379" y="900"/>
                  </a:lnTo>
                  <a:lnTo>
                    <a:pt x="2379" y="901"/>
                  </a:lnTo>
                  <a:lnTo>
                    <a:pt x="2380" y="902"/>
                  </a:lnTo>
                  <a:lnTo>
                    <a:pt x="2381" y="903"/>
                  </a:lnTo>
                  <a:lnTo>
                    <a:pt x="2381" y="904"/>
                  </a:lnTo>
                  <a:lnTo>
                    <a:pt x="2381" y="905"/>
                  </a:lnTo>
                  <a:lnTo>
                    <a:pt x="2382" y="906"/>
                  </a:lnTo>
                  <a:lnTo>
                    <a:pt x="2382" y="907"/>
                  </a:lnTo>
                  <a:lnTo>
                    <a:pt x="2383" y="907"/>
                  </a:lnTo>
                  <a:lnTo>
                    <a:pt x="2383" y="908"/>
                  </a:lnTo>
                  <a:lnTo>
                    <a:pt x="2384" y="909"/>
                  </a:lnTo>
                  <a:lnTo>
                    <a:pt x="2384" y="910"/>
                  </a:lnTo>
                  <a:lnTo>
                    <a:pt x="2385" y="910"/>
                  </a:lnTo>
                  <a:lnTo>
                    <a:pt x="2385" y="911"/>
                  </a:lnTo>
                  <a:lnTo>
                    <a:pt x="2386" y="912"/>
                  </a:lnTo>
                  <a:lnTo>
                    <a:pt x="2387" y="912"/>
                  </a:lnTo>
                  <a:lnTo>
                    <a:pt x="2388" y="913"/>
                  </a:lnTo>
                  <a:lnTo>
                    <a:pt x="2389" y="913"/>
                  </a:lnTo>
                  <a:lnTo>
                    <a:pt x="2390" y="913"/>
                  </a:lnTo>
                  <a:lnTo>
                    <a:pt x="2390" y="914"/>
                  </a:lnTo>
                  <a:lnTo>
                    <a:pt x="2391" y="914"/>
                  </a:lnTo>
                  <a:lnTo>
                    <a:pt x="2391" y="915"/>
                  </a:lnTo>
                  <a:lnTo>
                    <a:pt x="2392" y="915"/>
                  </a:lnTo>
                  <a:lnTo>
                    <a:pt x="2392" y="916"/>
                  </a:lnTo>
                  <a:lnTo>
                    <a:pt x="2393" y="916"/>
                  </a:lnTo>
                  <a:lnTo>
                    <a:pt x="2393" y="917"/>
                  </a:lnTo>
                  <a:lnTo>
                    <a:pt x="2394" y="917"/>
                  </a:lnTo>
                  <a:lnTo>
                    <a:pt x="2394" y="918"/>
                  </a:lnTo>
                  <a:lnTo>
                    <a:pt x="2395" y="919"/>
                  </a:lnTo>
                  <a:lnTo>
                    <a:pt x="2395" y="920"/>
                  </a:lnTo>
                  <a:lnTo>
                    <a:pt x="2396" y="922"/>
                  </a:lnTo>
                  <a:lnTo>
                    <a:pt x="2396" y="923"/>
                  </a:lnTo>
                  <a:lnTo>
                    <a:pt x="2397" y="925"/>
                  </a:lnTo>
                  <a:lnTo>
                    <a:pt x="2397" y="926"/>
                  </a:lnTo>
                  <a:lnTo>
                    <a:pt x="2398" y="928"/>
                  </a:lnTo>
                  <a:lnTo>
                    <a:pt x="2398" y="931"/>
                  </a:lnTo>
                  <a:lnTo>
                    <a:pt x="2398" y="933"/>
                  </a:lnTo>
                  <a:lnTo>
                    <a:pt x="2399" y="936"/>
                  </a:lnTo>
                  <a:lnTo>
                    <a:pt x="2399" y="939"/>
                  </a:lnTo>
                  <a:lnTo>
                    <a:pt x="2400" y="942"/>
                  </a:lnTo>
                  <a:lnTo>
                    <a:pt x="2400" y="945"/>
                  </a:lnTo>
                  <a:lnTo>
                    <a:pt x="2401" y="948"/>
                  </a:lnTo>
                  <a:lnTo>
                    <a:pt x="2401" y="951"/>
                  </a:lnTo>
                  <a:lnTo>
                    <a:pt x="2402" y="954"/>
                  </a:lnTo>
                  <a:lnTo>
                    <a:pt x="2402" y="958"/>
                  </a:lnTo>
                  <a:lnTo>
                    <a:pt x="2403" y="961"/>
                  </a:lnTo>
                  <a:lnTo>
                    <a:pt x="2403" y="965"/>
                  </a:lnTo>
                  <a:lnTo>
                    <a:pt x="2404" y="968"/>
                  </a:lnTo>
                  <a:lnTo>
                    <a:pt x="2404" y="971"/>
                  </a:lnTo>
                  <a:lnTo>
                    <a:pt x="2405" y="975"/>
                  </a:lnTo>
                  <a:lnTo>
                    <a:pt x="2405" y="978"/>
                  </a:lnTo>
                  <a:lnTo>
                    <a:pt x="2406" y="982"/>
                  </a:lnTo>
                  <a:lnTo>
                    <a:pt x="2406" y="985"/>
                  </a:lnTo>
                  <a:lnTo>
                    <a:pt x="2407" y="988"/>
                  </a:lnTo>
                  <a:lnTo>
                    <a:pt x="2407" y="991"/>
                  </a:lnTo>
                  <a:lnTo>
                    <a:pt x="2407" y="995"/>
                  </a:lnTo>
                  <a:lnTo>
                    <a:pt x="2408" y="997"/>
                  </a:lnTo>
                  <a:lnTo>
                    <a:pt x="2408" y="1000"/>
                  </a:lnTo>
                  <a:lnTo>
                    <a:pt x="2409" y="1003"/>
                  </a:lnTo>
                  <a:lnTo>
                    <a:pt x="2409" y="1006"/>
                  </a:lnTo>
                  <a:lnTo>
                    <a:pt x="2410" y="1008"/>
                  </a:lnTo>
                  <a:lnTo>
                    <a:pt x="2410" y="1009"/>
                  </a:lnTo>
                  <a:lnTo>
                    <a:pt x="2411" y="1011"/>
                  </a:lnTo>
                  <a:lnTo>
                    <a:pt x="2411" y="1013"/>
                  </a:lnTo>
                  <a:lnTo>
                    <a:pt x="2412" y="1014"/>
                  </a:lnTo>
                  <a:lnTo>
                    <a:pt x="2412" y="1015"/>
                  </a:lnTo>
                  <a:lnTo>
                    <a:pt x="2413" y="1016"/>
                  </a:lnTo>
                  <a:lnTo>
                    <a:pt x="2413" y="1017"/>
                  </a:lnTo>
                  <a:lnTo>
                    <a:pt x="2414" y="1018"/>
                  </a:lnTo>
                  <a:lnTo>
                    <a:pt x="2415" y="1019"/>
                  </a:lnTo>
                  <a:lnTo>
                    <a:pt x="2416" y="1019"/>
                  </a:lnTo>
                  <a:lnTo>
                    <a:pt x="2416" y="1020"/>
                  </a:lnTo>
                  <a:lnTo>
                    <a:pt x="2417" y="1019"/>
                  </a:lnTo>
                  <a:lnTo>
                    <a:pt x="2418" y="1019"/>
                  </a:lnTo>
                  <a:lnTo>
                    <a:pt x="2418" y="1018"/>
                  </a:lnTo>
                  <a:lnTo>
                    <a:pt x="2419" y="1018"/>
                  </a:lnTo>
                  <a:lnTo>
                    <a:pt x="2419" y="1017"/>
                  </a:lnTo>
                  <a:lnTo>
                    <a:pt x="2420" y="1016"/>
                  </a:lnTo>
                  <a:lnTo>
                    <a:pt x="2420" y="1015"/>
                  </a:lnTo>
                  <a:lnTo>
                    <a:pt x="2421" y="1014"/>
                  </a:lnTo>
                  <a:lnTo>
                    <a:pt x="2421" y="1013"/>
                  </a:lnTo>
                  <a:lnTo>
                    <a:pt x="2422" y="1012"/>
                  </a:lnTo>
                  <a:lnTo>
                    <a:pt x="2422" y="1011"/>
                  </a:lnTo>
                  <a:lnTo>
                    <a:pt x="2423" y="1009"/>
                  </a:lnTo>
                  <a:lnTo>
                    <a:pt x="2423" y="1008"/>
                  </a:lnTo>
                  <a:lnTo>
                    <a:pt x="2424" y="1006"/>
                  </a:lnTo>
                  <a:lnTo>
                    <a:pt x="2424" y="1005"/>
                  </a:lnTo>
                  <a:lnTo>
                    <a:pt x="2424" y="1003"/>
                  </a:lnTo>
                  <a:lnTo>
                    <a:pt x="2425" y="1001"/>
                  </a:lnTo>
                  <a:lnTo>
                    <a:pt x="2425" y="1000"/>
                  </a:lnTo>
                  <a:lnTo>
                    <a:pt x="2426" y="998"/>
                  </a:lnTo>
                  <a:lnTo>
                    <a:pt x="2426" y="996"/>
                  </a:lnTo>
                  <a:lnTo>
                    <a:pt x="2427" y="994"/>
                  </a:lnTo>
                  <a:lnTo>
                    <a:pt x="2427" y="992"/>
                  </a:lnTo>
                  <a:lnTo>
                    <a:pt x="2428" y="990"/>
                  </a:lnTo>
                  <a:lnTo>
                    <a:pt x="2428" y="988"/>
                  </a:lnTo>
                  <a:lnTo>
                    <a:pt x="2429" y="986"/>
                  </a:lnTo>
                  <a:lnTo>
                    <a:pt x="2429" y="984"/>
                  </a:lnTo>
                  <a:lnTo>
                    <a:pt x="2430" y="982"/>
                  </a:lnTo>
                  <a:lnTo>
                    <a:pt x="2430" y="980"/>
                  </a:lnTo>
                  <a:lnTo>
                    <a:pt x="2431" y="977"/>
                  </a:lnTo>
                  <a:lnTo>
                    <a:pt x="2431" y="975"/>
                  </a:lnTo>
                  <a:lnTo>
                    <a:pt x="2432" y="973"/>
                  </a:lnTo>
                  <a:lnTo>
                    <a:pt x="2432" y="971"/>
                  </a:lnTo>
                  <a:lnTo>
                    <a:pt x="2433" y="968"/>
                  </a:lnTo>
                  <a:lnTo>
                    <a:pt x="2433" y="966"/>
                  </a:lnTo>
                  <a:lnTo>
                    <a:pt x="2433" y="964"/>
                  </a:lnTo>
                  <a:lnTo>
                    <a:pt x="2434" y="961"/>
                  </a:lnTo>
                  <a:lnTo>
                    <a:pt x="2434" y="959"/>
                  </a:lnTo>
                  <a:lnTo>
                    <a:pt x="2435" y="956"/>
                  </a:lnTo>
                  <a:lnTo>
                    <a:pt x="2435" y="954"/>
                  </a:lnTo>
                  <a:lnTo>
                    <a:pt x="2436" y="951"/>
                  </a:lnTo>
                  <a:lnTo>
                    <a:pt x="2436" y="949"/>
                  </a:lnTo>
                  <a:lnTo>
                    <a:pt x="2437" y="946"/>
                  </a:lnTo>
                  <a:lnTo>
                    <a:pt x="2437" y="944"/>
                  </a:lnTo>
                  <a:lnTo>
                    <a:pt x="2438" y="942"/>
                  </a:lnTo>
                  <a:lnTo>
                    <a:pt x="2438" y="940"/>
                  </a:lnTo>
                  <a:lnTo>
                    <a:pt x="2439" y="937"/>
                  </a:lnTo>
                  <a:lnTo>
                    <a:pt x="2439" y="935"/>
                  </a:lnTo>
                  <a:lnTo>
                    <a:pt x="2440" y="933"/>
                  </a:lnTo>
                  <a:lnTo>
                    <a:pt x="2440" y="931"/>
                  </a:lnTo>
                  <a:lnTo>
                    <a:pt x="2441" y="929"/>
                  </a:lnTo>
                  <a:lnTo>
                    <a:pt x="2441" y="927"/>
                  </a:lnTo>
                  <a:lnTo>
                    <a:pt x="2441" y="926"/>
                  </a:lnTo>
                  <a:lnTo>
                    <a:pt x="2442" y="924"/>
                  </a:lnTo>
                  <a:lnTo>
                    <a:pt x="2442" y="922"/>
                  </a:lnTo>
                  <a:lnTo>
                    <a:pt x="2443" y="921"/>
                  </a:lnTo>
                  <a:lnTo>
                    <a:pt x="2443" y="920"/>
                  </a:lnTo>
                  <a:lnTo>
                    <a:pt x="2444" y="918"/>
                  </a:lnTo>
                  <a:lnTo>
                    <a:pt x="2444" y="917"/>
                  </a:lnTo>
                  <a:lnTo>
                    <a:pt x="2445" y="916"/>
                  </a:lnTo>
                  <a:lnTo>
                    <a:pt x="2445" y="915"/>
                  </a:lnTo>
                  <a:lnTo>
                    <a:pt x="2446" y="915"/>
                  </a:lnTo>
                  <a:lnTo>
                    <a:pt x="2446" y="914"/>
                  </a:lnTo>
                  <a:lnTo>
                    <a:pt x="2447" y="914"/>
                  </a:lnTo>
                  <a:lnTo>
                    <a:pt x="2448" y="913"/>
                  </a:lnTo>
                  <a:lnTo>
                    <a:pt x="2449" y="913"/>
                  </a:lnTo>
                  <a:lnTo>
                    <a:pt x="2450" y="913"/>
                  </a:lnTo>
                  <a:lnTo>
                    <a:pt x="2451" y="913"/>
                  </a:lnTo>
                  <a:lnTo>
                    <a:pt x="2452" y="913"/>
                  </a:lnTo>
                  <a:lnTo>
                    <a:pt x="2453" y="913"/>
                  </a:lnTo>
                  <a:lnTo>
                    <a:pt x="2454" y="913"/>
                  </a:lnTo>
                  <a:lnTo>
                    <a:pt x="2455" y="913"/>
                  </a:lnTo>
                  <a:lnTo>
                    <a:pt x="2456" y="913"/>
                  </a:lnTo>
                  <a:lnTo>
                    <a:pt x="2456" y="912"/>
                  </a:lnTo>
                  <a:lnTo>
                    <a:pt x="2457" y="912"/>
                  </a:lnTo>
                  <a:lnTo>
                    <a:pt x="2457" y="911"/>
                  </a:lnTo>
                  <a:lnTo>
                    <a:pt x="2458" y="910"/>
                  </a:lnTo>
                  <a:lnTo>
                    <a:pt x="2458" y="909"/>
                  </a:lnTo>
                  <a:lnTo>
                    <a:pt x="2458" y="908"/>
                  </a:lnTo>
                  <a:lnTo>
                    <a:pt x="2459" y="907"/>
                  </a:lnTo>
                  <a:lnTo>
                    <a:pt x="2459" y="906"/>
                  </a:lnTo>
                  <a:lnTo>
                    <a:pt x="2460" y="904"/>
                  </a:lnTo>
                  <a:lnTo>
                    <a:pt x="2460" y="903"/>
                  </a:lnTo>
                  <a:lnTo>
                    <a:pt x="2461" y="902"/>
                  </a:lnTo>
                  <a:lnTo>
                    <a:pt x="2461" y="901"/>
                  </a:lnTo>
                  <a:lnTo>
                    <a:pt x="2462" y="899"/>
                  </a:lnTo>
                  <a:lnTo>
                    <a:pt x="2462" y="898"/>
                  </a:lnTo>
                  <a:lnTo>
                    <a:pt x="2463" y="896"/>
                  </a:lnTo>
                  <a:lnTo>
                    <a:pt x="2463" y="895"/>
                  </a:lnTo>
                  <a:lnTo>
                    <a:pt x="2464" y="894"/>
                  </a:lnTo>
                  <a:lnTo>
                    <a:pt x="2464" y="892"/>
                  </a:lnTo>
                  <a:lnTo>
                    <a:pt x="2465" y="891"/>
                  </a:lnTo>
                  <a:lnTo>
                    <a:pt x="2465" y="890"/>
                  </a:lnTo>
                  <a:lnTo>
                    <a:pt x="2466" y="889"/>
                  </a:lnTo>
                  <a:lnTo>
                    <a:pt x="2466" y="887"/>
                  </a:lnTo>
                  <a:lnTo>
                    <a:pt x="2467" y="886"/>
                  </a:lnTo>
                  <a:lnTo>
                    <a:pt x="2467" y="885"/>
                  </a:lnTo>
                  <a:lnTo>
                    <a:pt x="2467" y="884"/>
                  </a:lnTo>
                  <a:lnTo>
                    <a:pt x="2468" y="884"/>
                  </a:lnTo>
                  <a:lnTo>
                    <a:pt x="2468" y="883"/>
                  </a:lnTo>
                  <a:lnTo>
                    <a:pt x="2469" y="882"/>
                  </a:lnTo>
                  <a:lnTo>
                    <a:pt x="2470" y="882"/>
                  </a:lnTo>
                  <a:lnTo>
                    <a:pt x="2471" y="882"/>
                  </a:lnTo>
                  <a:lnTo>
                    <a:pt x="2472" y="882"/>
                  </a:lnTo>
                  <a:lnTo>
                    <a:pt x="2473" y="883"/>
                  </a:lnTo>
                  <a:lnTo>
                    <a:pt x="2474" y="884"/>
                  </a:lnTo>
                  <a:lnTo>
                    <a:pt x="2475" y="885"/>
                  </a:lnTo>
                  <a:lnTo>
                    <a:pt x="2475" y="886"/>
                  </a:lnTo>
                  <a:lnTo>
                    <a:pt x="2476" y="886"/>
                  </a:lnTo>
                  <a:lnTo>
                    <a:pt x="2476" y="887"/>
                  </a:lnTo>
                  <a:lnTo>
                    <a:pt x="2477" y="888"/>
                  </a:lnTo>
                  <a:lnTo>
                    <a:pt x="2478" y="889"/>
                  </a:lnTo>
                  <a:lnTo>
                    <a:pt x="2479" y="890"/>
                  </a:lnTo>
                  <a:lnTo>
                    <a:pt x="2479" y="891"/>
                  </a:lnTo>
                  <a:lnTo>
                    <a:pt x="2480" y="891"/>
                  </a:lnTo>
                  <a:lnTo>
                    <a:pt x="2480" y="892"/>
                  </a:lnTo>
                  <a:lnTo>
                    <a:pt x="2481" y="892"/>
                  </a:lnTo>
                  <a:lnTo>
                    <a:pt x="2481" y="893"/>
                  </a:lnTo>
                  <a:lnTo>
                    <a:pt x="2482" y="893"/>
                  </a:lnTo>
                  <a:lnTo>
                    <a:pt x="2482" y="894"/>
                  </a:lnTo>
                  <a:lnTo>
                    <a:pt x="2483" y="894"/>
                  </a:lnTo>
                  <a:lnTo>
                    <a:pt x="2484" y="895"/>
                  </a:lnTo>
                  <a:lnTo>
                    <a:pt x="2485" y="895"/>
                  </a:lnTo>
                  <a:lnTo>
                    <a:pt x="2486" y="895"/>
                  </a:lnTo>
                  <a:lnTo>
                    <a:pt x="2487" y="895"/>
                  </a:lnTo>
                  <a:lnTo>
                    <a:pt x="2488" y="895"/>
                  </a:lnTo>
                  <a:lnTo>
                    <a:pt x="2489" y="895"/>
                  </a:lnTo>
                  <a:lnTo>
                    <a:pt x="2489" y="894"/>
                  </a:lnTo>
                  <a:lnTo>
                    <a:pt x="2490" y="894"/>
                  </a:lnTo>
                  <a:lnTo>
                    <a:pt x="2491" y="893"/>
                  </a:lnTo>
                  <a:lnTo>
                    <a:pt x="2492" y="892"/>
                  </a:lnTo>
                  <a:lnTo>
                    <a:pt x="2493" y="891"/>
                  </a:lnTo>
                  <a:lnTo>
                    <a:pt x="2493" y="890"/>
                  </a:lnTo>
                  <a:lnTo>
                    <a:pt x="2494" y="889"/>
                  </a:lnTo>
                  <a:lnTo>
                    <a:pt x="2494" y="888"/>
                  </a:lnTo>
                  <a:lnTo>
                    <a:pt x="2495" y="887"/>
                  </a:lnTo>
                  <a:lnTo>
                    <a:pt x="2495" y="886"/>
                  </a:lnTo>
                  <a:lnTo>
                    <a:pt x="2496" y="885"/>
                  </a:lnTo>
                  <a:lnTo>
                    <a:pt x="2496" y="884"/>
                  </a:lnTo>
                  <a:lnTo>
                    <a:pt x="2497" y="884"/>
                  </a:lnTo>
                  <a:lnTo>
                    <a:pt x="2497" y="883"/>
                  </a:lnTo>
                  <a:lnTo>
                    <a:pt x="2498" y="882"/>
                  </a:lnTo>
                  <a:lnTo>
                    <a:pt x="2498" y="880"/>
                  </a:lnTo>
                  <a:lnTo>
                    <a:pt x="2499" y="879"/>
                  </a:lnTo>
                  <a:lnTo>
                    <a:pt x="2499" y="878"/>
                  </a:lnTo>
                  <a:lnTo>
                    <a:pt x="2500" y="877"/>
                  </a:lnTo>
                  <a:lnTo>
                    <a:pt x="2500" y="876"/>
                  </a:lnTo>
                  <a:lnTo>
                    <a:pt x="2501" y="875"/>
                  </a:lnTo>
                  <a:lnTo>
                    <a:pt x="2501" y="874"/>
                  </a:lnTo>
                  <a:lnTo>
                    <a:pt x="2502" y="873"/>
                  </a:lnTo>
                  <a:lnTo>
                    <a:pt x="2502" y="872"/>
                  </a:lnTo>
                  <a:lnTo>
                    <a:pt x="2503" y="871"/>
                  </a:lnTo>
                  <a:lnTo>
                    <a:pt x="2503" y="870"/>
                  </a:lnTo>
                  <a:lnTo>
                    <a:pt x="2504" y="869"/>
                  </a:lnTo>
                  <a:lnTo>
                    <a:pt x="2504" y="868"/>
                  </a:lnTo>
                  <a:lnTo>
                    <a:pt x="2505" y="868"/>
                  </a:lnTo>
                  <a:lnTo>
                    <a:pt x="2505" y="867"/>
                  </a:lnTo>
                  <a:lnTo>
                    <a:pt x="2506" y="866"/>
                  </a:lnTo>
                  <a:lnTo>
                    <a:pt x="2507" y="865"/>
                  </a:lnTo>
                  <a:lnTo>
                    <a:pt x="2508" y="864"/>
                  </a:lnTo>
                  <a:lnTo>
                    <a:pt x="2509" y="863"/>
                  </a:lnTo>
                  <a:lnTo>
                    <a:pt x="2510" y="862"/>
                  </a:lnTo>
                  <a:lnTo>
                    <a:pt x="2510" y="861"/>
                  </a:lnTo>
                  <a:lnTo>
                    <a:pt x="2511" y="861"/>
                  </a:lnTo>
                  <a:lnTo>
                    <a:pt x="2511" y="860"/>
                  </a:lnTo>
                  <a:lnTo>
                    <a:pt x="2512" y="860"/>
                  </a:lnTo>
                  <a:lnTo>
                    <a:pt x="2512" y="859"/>
                  </a:lnTo>
                  <a:lnTo>
                    <a:pt x="2513" y="859"/>
                  </a:lnTo>
                  <a:lnTo>
                    <a:pt x="2513" y="858"/>
                  </a:lnTo>
                  <a:lnTo>
                    <a:pt x="2514" y="858"/>
                  </a:lnTo>
                  <a:lnTo>
                    <a:pt x="2514" y="857"/>
                  </a:lnTo>
                  <a:lnTo>
                    <a:pt x="2515" y="857"/>
                  </a:lnTo>
                  <a:lnTo>
                    <a:pt x="2515" y="856"/>
                  </a:lnTo>
                  <a:lnTo>
                    <a:pt x="2516" y="856"/>
                  </a:lnTo>
                  <a:lnTo>
                    <a:pt x="2516" y="855"/>
                  </a:lnTo>
                  <a:lnTo>
                    <a:pt x="2517" y="854"/>
                  </a:lnTo>
                  <a:lnTo>
                    <a:pt x="2517" y="853"/>
                  </a:lnTo>
                  <a:lnTo>
                    <a:pt x="2518" y="853"/>
                  </a:lnTo>
                  <a:lnTo>
                    <a:pt x="2518" y="852"/>
                  </a:lnTo>
                  <a:lnTo>
                    <a:pt x="2518" y="851"/>
                  </a:lnTo>
                  <a:lnTo>
                    <a:pt x="2519" y="850"/>
                  </a:lnTo>
                  <a:lnTo>
                    <a:pt x="2519" y="849"/>
                  </a:lnTo>
                  <a:lnTo>
                    <a:pt x="2520" y="848"/>
                  </a:lnTo>
                  <a:lnTo>
                    <a:pt x="2520" y="847"/>
                  </a:lnTo>
                  <a:lnTo>
                    <a:pt x="2521" y="846"/>
                  </a:lnTo>
                  <a:lnTo>
                    <a:pt x="2521" y="845"/>
                  </a:lnTo>
                  <a:lnTo>
                    <a:pt x="2522" y="844"/>
                  </a:lnTo>
                  <a:lnTo>
                    <a:pt x="2522" y="843"/>
                  </a:lnTo>
                  <a:lnTo>
                    <a:pt x="2523" y="842"/>
                  </a:lnTo>
                  <a:lnTo>
                    <a:pt x="2523" y="841"/>
                  </a:lnTo>
                  <a:lnTo>
                    <a:pt x="2524" y="839"/>
                  </a:lnTo>
                  <a:lnTo>
                    <a:pt x="2524" y="838"/>
                  </a:lnTo>
                  <a:lnTo>
                    <a:pt x="2525" y="837"/>
                  </a:lnTo>
                  <a:lnTo>
                    <a:pt x="2525" y="836"/>
                  </a:lnTo>
                  <a:lnTo>
                    <a:pt x="2526" y="834"/>
                  </a:lnTo>
                  <a:lnTo>
                    <a:pt x="2526" y="833"/>
                  </a:lnTo>
                  <a:lnTo>
                    <a:pt x="2527" y="831"/>
                  </a:lnTo>
                  <a:lnTo>
                    <a:pt x="2527" y="830"/>
                  </a:lnTo>
                  <a:lnTo>
                    <a:pt x="2527" y="828"/>
                  </a:lnTo>
                  <a:lnTo>
                    <a:pt x="2528" y="827"/>
                  </a:lnTo>
                  <a:lnTo>
                    <a:pt x="2528" y="825"/>
                  </a:lnTo>
                  <a:lnTo>
                    <a:pt x="2529" y="823"/>
                  </a:lnTo>
                  <a:lnTo>
                    <a:pt x="2529" y="822"/>
                  </a:lnTo>
                  <a:lnTo>
                    <a:pt x="2530" y="820"/>
                  </a:lnTo>
                  <a:lnTo>
                    <a:pt x="2530" y="818"/>
                  </a:lnTo>
                  <a:lnTo>
                    <a:pt x="2531" y="817"/>
                  </a:lnTo>
                  <a:lnTo>
                    <a:pt x="2531" y="815"/>
                  </a:lnTo>
                  <a:lnTo>
                    <a:pt x="2532" y="813"/>
                  </a:lnTo>
                  <a:lnTo>
                    <a:pt x="2532" y="811"/>
                  </a:lnTo>
                  <a:lnTo>
                    <a:pt x="2533" y="810"/>
                  </a:lnTo>
                  <a:lnTo>
                    <a:pt x="2533" y="808"/>
                  </a:lnTo>
                  <a:lnTo>
                    <a:pt x="2534" y="806"/>
                  </a:lnTo>
                  <a:lnTo>
                    <a:pt x="2534" y="804"/>
                  </a:lnTo>
                  <a:lnTo>
                    <a:pt x="2535" y="803"/>
                  </a:lnTo>
                  <a:lnTo>
                    <a:pt x="2535" y="801"/>
                  </a:lnTo>
                  <a:lnTo>
                    <a:pt x="2535" y="799"/>
                  </a:lnTo>
                  <a:lnTo>
                    <a:pt x="2536" y="798"/>
                  </a:lnTo>
                  <a:lnTo>
                    <a:pt x="2536" y="796"/>
                  </a:lnTo>
                  <a:lnTo>
                    <a:pt x="2537" y="794"/>
                  </a:lnTo>
                  <a:lnTo>
                    <a:pt x="2537" y="793"/>
                  </a:lnTo>
                  <a:lnTo>
                    <a:pt x="2538" y="791"/>
                  </a:lnTo>
                  <a:lnTo>
                    <a:pt x="2538" y="790"/>
                  </a:lnTo>
                  <a:lnTo>
                    <a:pt x="2539" y="789"/>
                  </a:lnTo>
                  <a:lnTo>
                    <a:pt x="2539" y="787"/>
                  </a:lnTo>
                  <a:lnTo>
                    <a:pt x="2540" y="786"/>
                  </a:lnTo>
                  <a:lnTo>
                    <a:pt x="2540" y="785"/>
                  </a:lnTo>
                  <a:lnTo>
                    <a:pt x="2541" y="784"/>
                  </a:lnTo>
                  <a:lnTo>
                    <a:pt x="2541" y="783"/>
                  </a:lnTo>
                  <a:lnTo>
                    <a:pt x="2542" y="783"/>
                  </a:lnTo>
                  <a:lnTo>
                    <a:pt x="2542" y="782"/>
                  </a:lnTo>
                  <a:lnTo>
                    <a:pt x="2543" y="781"/>
                  </a:lnTo>
                  <a:lnTo>
                    <a:pt x="2543" y="780"/>
                  </a:lnTo>
                  <a:lnTo>
                    <a:pt x="2544" y="780"/>
                  </a:lnTo>
                  <a:lnTo>
                    <a:pt x="2544" y="779"/>
                  </a:lnTo>
                  <a:lnTo>
                    <a:pt x="2544" y="778"/>
                  </a:lnTo>
                  <a:lnTo>
                    <a:pt x="2545" y="778"/>
                  </a:lnTo>
                  <a:lnTo>
                    <a:pt x="2545" y="777"/>
                  </a:lnTo>
                  <a:lnTo>
                    <a:pt x="2546" y="777"/>
                  </a:lnTo>
                  <a:lnTo>
                    <a:pt x="2546" y="776"/>
                  </a:lnTo>
                  <a:lnTo>
                    <a:pt x="2547" y="776"/>
                  </a:lnTo>
                  <a:lnTo>
                    <a:pt x="2547" y="775"/>
                  </a:lnTo>
                  <a:lnTo>
                    <a:pt x="2548" y="775"/>
                  </a:lnTo>
                  <a:lnTo>
                    <a:pt x="2549" y="774"/>
                  </a:lnTo>
                  <a:lnTo>
                    <a:pt x="2550" y="773"/>
                  </a:lnTo>
                  <a:lnTo>
                    <a:pt x="2551" y="773"/>
                  </a:lnTo>
                  <a:lnTo>
                    <a:pt x="2551" y="772"/>
                  </a:lnTo>
                  <a:lnTo>
                    <a:pt x="2552" y="772"/>
                  </a:lnTo>
                  <a:lnTo>
                    <a:pt x="2552" y="771"/>
                  </a:lnTo>
                  <a:lnTo>
                    <a:pt x="2553" y="771"/>
                  </a:lnTo>
                  <a:lnTo>
                    <a:pt x="2553" y="770"/>
                  </a:lnTo>
                  <a:lnTo>
                    <a:pt x="2554" y="770"/>
                  </a:lnTo>
                  <a:lnTo>
                    <a:pt x="2554" y="769"/>
                  </a:lnTo>
                  <a:lnTo>
                    <a:pt x="2555" y="769"/>
                  </a:lnTo>
                  <a:lnTo>
                    <a:pt x="2555" y="768"/>
                  </a:lnTo>
                  <a:lnTo>
                    <a:pt x="2556" y="768"/>
                  </a:lnTo>
                  <a:lnTo>
                    <a:pt x="2557" y="767"/>
                  </a:lnTo>
                  <a:lnTo>
                    <a:pt x="2558" y="767"/>
                  </a:lnTo>
                  <a:lnTo>
                    <a:pt x="2558" y="766"/>
                  </a:lnTo>
                  <a:lnTo>
                    <a:pt x="2559" y="766"/>
                  </a:lnTo>
                  <a:lnTo>
                    <a:pt x="2560" y="765"/>
                  </a:lnTo>
                  <a:lnTo>
                    <a:pt x="2561" y="765"/>
                  </a:lnTo>
                  <a:lnTo>
                    <a:pt x="2562" y="765"/>
                  </a:lnTo>
                  <a:lnTo>
                    <a:pt x="2563" y="765"/>
                  </a:lnTo>
                  <a:lnTo>
                    <a:pt x="2564" y="766"/>
                  </a:lnTo>
                  <a:lnTo>
                    <a:pt x="2565" y="767"/>
                  </a:lnTo>
                  <a:lnTo>
                    <a:pt x="2566" y="768"/>
                  </a:lnTo>
                  <a:lnTo>
                    <a:pt x="2567" y="769"/>
                  </a:lnTo>
                  <a:lnTo>
                    <a:pt x="2567" y="770"/>
                  </a:lnTo>
                  <a:lnTo>
                    <a:pt x="2568" y="770"/>
                  </a:lnTo>
                  <a:lnTo>
                    <a:pt x="2569" y="771"/>
                  </a:lnTo>
                  <a:lnTo>
                    <a:pt x="2570" y="772"/>
                  </a:lnTo>
                  <a:lnTo>
                    <a:pt x="2571" y="772"/>
                  </a:lnTo>
                  <a:lnTo>
                    <a:pt x="2572" y="772"/>
                  </a:lnTo>
                  <a:lnTo>
                    <a:pt x="2573" y="772"/>
                  </a:lnTo>
                  <a:lnTo>
                    <a:pt x="2573" y="771"/>
                  </a:lnTo>
                  <a:lnTo>
                    <a:pt x="2574" y="771"/>
                  </a:lnTo>
                  <a:lnTo>
                    <a:pt x="2574" y="770"/>
                  </a:lnTo>
                  <a:lnTo>
                    <a:pt x="2575" y="769"/>
                  </a:lnTo>
                  <a:lnTo>
                    <a:pt x="2575" y="768"/>
                  </a:lnTo>
                  <a:lnTo>
                    <a:pt x="2576" y="767"/>
                  </a:lnTo>
                  <a:lnTo>
                    <a:pt x="2576" y="765"/>
                  </a:lnTo>
                  <a:lnTo>
                    <a:pt x="2577" y="764"/>
                  </a:lnTo>
                  <a:lnTo>
                    <a:pt x="2577" y="762"/>
                  </a:lnTo>
                  <a:lnTo>
                    <a:pt x="2578" y="760"/>
                  </a:lnTo>
                  <a:lnTo>
                    <a:pt x="2578" y="758"/>
                  </a:lnTo>
                  <a:lnTo>
                    <a:pt x="2578" y="757"/>
                  </a:lnTo>
                  <a:lnTo>
                    <a:pt x="2579" y="755"/>
                  </a:lnTo>
                  <a:lnTo>
                    <a:pt x="2579" y="753"/>
                  </a:lnTo>
                  <a:lnTo>
                    <a:pt x="2580" y="752"/>
                  </a:lnTo>
                  <a:lnTo>
                    <a:pt x="2580" y="750"/>
                  </a:lnTo>
                  <a:lnTo>
                    <a:pt x="2581" y="748"/>
                  </a:lnTo>
                  <a:lnTo>
                    <a:pt x="2581" y="747"/>
                  </a:lnTo>
                  <a:lnTo>
                    <a:pt x="2582" y="746"/>
                  </a:lnTo>
                  <a:lnTo>
                    <a:pt x="2582" y="744"/>
                  </a:lnTo>
                  <a:lnTo>
                    <a:pt x="2583" y="743"/>
                  </a:lnTo>
                  <a:lnTo>
                    <a:pt x="2584" y="742"/>
                  </a:lnTo>
                  <a:lnTo>
                    <a:pt x="2585" y="741"/>
                  </a:lnTo>
                  <a:lnTo>
                    <a:pt x="2585" y="742"/>
                  </a:lnTo>
                  <a:lnTo>
                    <a:pt x="2586" y="742"/>
                  </a:lnTo>
                  <a:lnTo>
                    <a:pt x="2586" y="743"/>
                  </a:lnTo>
                  <a:lnTo>
                    <a:pt x="2587" y="744"/>
                  </a:lnTo>
                  <a:lnTo>
                    <a:pt x="2587" y="745"/>
                  </a:lnTo>
                  <a:lnTo>
                    <a:pt x="2587" y="747"/>
                  </a:lnTo>
                  <a:lnTo>
                    <a:pt x="2588" y="750"/>
                  </a:lnTo>
                  <a:lnTo>
                    <a:pt x="2588" y="753"/>
                  </a:lnTo>
                  <a:lnTo>
                    <a:pt x="2589" y="755"/>
                  </a:lnTo>
                  <a:lnTo>
                    <a:pt x="2589" y="759"/>
                  </a:lnTo>
                  <a:lnTo>
                    <a:pt x="2590" y="762"/>
                  </a:lnTo>
                  <a:lnTo>
                    <a:pt x="2590" y="765"/>
                  </a:lnTo>
                  <a:lnTo>
                    <a:pt x="2591" y="769"/>
                  </a:lnTo>
                  <a:lnTo>
                    <a:pt x="2591" y="773"/>
                  </a:lnTo>
                  <a:lnTo>
                    <a:pt x="2592" y="777"/>
                  </a:lnTo>
                  <a:lnTo>
                    <a:pt x="2592" y="781"/>
                  </a:lnTo>
                  <a:lnTo>
                    <a:pt x="2593" y="785"/>
                  </a:lnTo>
                  <a:lnTo>
                    <a:pt x="2593" y="789"/>
                  </a:lnTo>
                  <a:lnTo>
                    <a:pt x="2594" y="793"/>
                  </a:lnTo>
                  <a:lnTo>
                    <a:pt x="2594" y="797"/>
                  </a:lnTo>
                  <a:lnTo>
                    <a:pt x="2595" y="802"/>
                  </a:lnTo>
                  <a:lnTo>
                    <a:pt x="2595" y="806"/>
                  </a:lnTo>
                  <a:lnTo>
                    <a:pt x="2595" y="810"/>
                  </a:lnTo>
                  <a:lnTo>
                    <a:pt x="2596" y="814"/>
                  </a:lnTo>
                  <a:lnTo>
                    <a:pt x="2596" y="818"/>
                  </a:lnTo>
                  <a:lnTo>
                    <a:pt x="2597" y="821"/>
                  </a:lnTo>
                  <a:lnTo>
                    <a:pt x="2597" y="825"/>
                  </a:lnTo>
                  <a:lnTo>
                    <a:pt x="2598" y="828"/>
                  </a:lnTo>
                  <a:lnTo>
                    <a:pt x="2598" y="831"/>
                  </a:lnTo>
                  <a:lnTo>
                    <a:pt x="2599" y="834"/>
                  </a:lnTo>
                  <a:lnTo>
                    <a:pt x="2599" y="836"/>
                  </a:lnTo>
                  <a:lnTo>
                    <a:pt x="2600" y="838"/>
                  </a:lnTo>
                  <a:lnTo>
                    <a:pt x="2600" y="840"/>
                  </a:lnTo>
                  <a:lnTo>
                    <a:pt x="2601" y="842"/>
                  </a:lnTo>
                  <a:lnTo>
                    <a:pt x="2601" y="844"/>
                  </a:lnTo>
                  <a:lnTo>
                    <a:pt x="2602" y="845"/>
                  </a:lnTo>
                  <a:lnTo>
                    <a:pt x="2602" y="846"/>
                  </a:lnTo>
                  <a:lnTo>
                    <a:pt x="2603" y="847"/>
                  </a:lnTo>
                  <a:lnTo>
                    <a:pt x="2603" y="848"/>
                  </a:lnTo>
                  <a:lnTo>
                    <a:pt x="2604" y="849"/>
                  </a:lnTo>
                  <a:lnTo>
                    <a:pt x="2604" y="850"/>
                  </a:lnTo>
                  <a:lnTo>
                    <a:pt x="2605" y="850"/>
                  </a:lnTo>
                  <a:lnTo>
                    <a:pt x="2606" y="850"/>
                  </a:lnTo>
                  <a:lnTo>
                    <a:pt x="2607" y="850"/>
                  </a:lnTo>
                  <a:lnTo>
                    <a:pt x="2608" y="849"/>
                  </a:lnTo>
                  <a:lnTo>
                    <a:pt x="2609" y="848"/>
                  </a:lnTo>
                  <a:lnTo>
                    <a:pt x="2610" y="847"/>
                  </a:lnTo>
                  <a:lnTo>
                    <a:pt x="2611" y="846"/>
                  </a:lnTo>
                  <a:lnTo>
                    <a:pt x="2611" y="845"/>
                  </a:lnTo>
                  <a:lnTo>
                    <a:pt x="2612" y="844"/>
                  </a:lnTo>
                  <a:lnTo>
                    <a:pt x="2612" y="843"/>
                  </a:lnTo>
                  <a:lnTo>
                    <a:pt x="2613" y="842"/>
                  </a:lnTo>
                  <a:lnTo>
                    <a:pt x="2613" y="841"/>
                  </a:lnTo>
                  <a:lnTo>
                    <a:pt x="2614" y="840"/>
                  </a:lnTo>
                  <a:lnTo>
                    <a:pt x="2614" y="839"/>
                  </a:lnTo>
                  <a:lnTo>
                    <a:pt x="2615" y="838"/>
                  </a:lnTo>
                  <a:lnTo>
                    <a:pt x="2615" y="837"/>
                  </a:lnTo>
                  <a:lnTo>
                    <a:pt x="2616" y="836"/>
                  </a:lnTo>
                  <a:lnTo>
                    <a:pt x="2616" y="835"/>
                  </a:lnTo>
                  <a:lnTo>
                    <a:pt x="2617" y="834"/>
                  </a:lnTo>
                  <a:lnTo>
                    <a:pt x="2617" y="833"/>
                  </a:lnTo>
                  <a:lnTo>
                    <a:pt x="2618" y="832"/>
                  </a:lnTo>
                  <a:lnTo>
                    <a:pt x="2618" y="831"/>
                  </a:lnTo>
                  <a:lnTo>
                    <a:pt x="2619" y="830"/>
                  </a:lnTo>
                  <a:lnTo>
                    <a:pt x="2619" y="829"/>
                  </a:lnTo>
                  <a:lnTo>
                    <a:pt x="2620" y="828"/>
                  </a:lnTo>
                  <a:lnTo>
                    <a:pt x="2620" y="827"/>
                  </a:lnTo>
                  <a:lnTo>
                    <a:pt x="2621" y="827"/>
                  </a:lnTo>
                  <a:lnTo>
                    <a:pt x="2621" y="826"/>
                  </a:lnTo>
                  <a:lnTo>
                    <a:pt x="2621" y="825"/>
                  </a:lnTo>
                  <a:lnTo>
                    <a:pt x="2622" y="824"/>
                  </a:lnTo>
                  <a:lnTo>
                    <a:pt x="2622" y="823"/>
                  </a:lnTo>
                  <a:lnTo>
                    <a:pt x="2623" y="822"/>
                  </a:lnTo>
                  <a:lnTo>
                    <a:pt x="2623" y="821"/>
                  </a:lnTo>
                  <a:lnTo>
                    <a:pt x="2624" y="820"/>
                  </a:lnTo>
                  <a:lnTo>
                    <a:pt x="2624" y="819"/>
                  </a:lnTo>
                  <a:lnTo>
                    <a:pt x="2625" y="818"/>
                  </a:lnTo>
                  <a:lnTo>
                    <a:pt x="2625" y="817"/>
                  </a:lnTo>
                  <a:lnTo>
                    <a:pt x="2626" y="816"/>
                  </a:lnTo>
                  <a:lnTo>
                    <a:pt x="2626" y="815"/>
                  </a:lnTo>
                  <a:lnTo>
                    <a:pt x="2627" y="814"/>
                  </a:lnTo>
                  <a:lnTo>
                    <a:pt x="2628" y="813"/>
                  </a:lnTo>
                  <a:lnTo>
                    <a:pt x="2628" y="812"/>
                  </a:lnTo>
                  <a:lnTo>
                    <a:pt x="2629" y="811"/>
                  </a:lnTo>
                  <a:lnTo>
                    <a:pt x="2629" y="810"/>
                  </a:lnTo>
                  <a:lnTo>
                    <a:pt x="2630" y="809"/>
                  </a:lnTo>
                  <a:lnTo>
                    <a:pt x="2630" y="808"/>
                  </a:lnTo>
                  <a:lnTo>
                    <a:pt x="2631" y="808"/>
                  </a:lnTo>
                  <a:lnTo>
                    <a:pt x="2631" y="807"/>
                  </a:lnTo>
                  <a:lnTo>
                    <a:pt x="2632" y="806"/>
                  </a:lnTo>
                  <a:lnTo>
                    <a:pt x="2633" y="805"/>
                  </a:lnTo>
                  <a:lnTo>
                    <a:pt x="2634" y="804"/>
                  </a:lnTo>
                  <a:lnTo>
                    <a:pt x="2635" y="803"/>
                  </a:lnTo>
                  <a:lnTo>
                    <a:pt x="2636" y="802"/>
                  </a:lnTo>
                  <a:lnTo>
                    <a:pt x="2637" y="801"/>
                  </a:lnTo>
                  <a:lnTo>
                    <a:pt x="2638" y="800"/>
                  </a:lnTo>
                  <a:lnTo>
                    <a:pt x="2638" y="799"/>
                  </a:lnTo>
                  <a:lnTo>
                    <a:pt x="2639" y="799"/>
                  </a:lnTo>
                  <a:lnTo>
                    <a:pt x="2639" y="798"/>
                  </a:lnTo>
                  <a:lnTo>
                    <a:pt x="2640" y="797"/>
                  </a:lnTo>
                  <a:lnTo>
                    <a:pt x="2641" y="796"/>
                  </a:lnTo>
                  <a:lnTo>
                    <a:pt x="2641" y="795"/>
                  </a:lnTo>
                  <a:lnTo>
                    <a:pt x="2642" y="795"/>
                  </a:lnTo>
                  <a:lnTo>
                    <a:pt x="2642" y="794"/>
                  </a:lnTo>
                  <a:lnTo>
                    <a:pt x="2643" y="793"/>
                  </a:lnTo>
                  <a:lnTo>
                    <a:pt x="2643" y="792"/>
                  </a:lnTo>
                  <a:lnTo>
                    <a:pt x="2644" y="791"/>
                  </a:lnTo>
                  <a:lnTo>
                    <a:pt x="2644" y="790"/>
                  </a:lnTo>
                  <a:lnTo>
                    <a:pt x="2645" y="789"/>
                  </a:lnTo>
                  <a:lnTo>
                    <a:pt x="2645" y="787"/>
                  </a:lnTo>
                  <a:lnTo>
                    <a:pt x="2646" y="786"/>
                  </a:lnTo>
                  <a:lnTo>
                    <a:pt x="2646" y="784"/>
                  </a:lnTo>
                  <a:lnTo>
                    <a:pt x="2647" y="783"/>
                  </a:lnTo>
                  <a:lnTo>
                    <a:pt x="2647" y="781"/>
                  </a:lnTo>
                  <a:lnTo>
                    <a:pt x="2647" y="779"/>
                  </a:lnTo>
                  <a:lnTo>
                    <a:pt x="2648" y="777"/>
                  </a:lnTo>
                  <a:lnTo>
                    <a:pt x="2648" y="775"/>
                  </a:lnTo>
                  <a:lnTo>
                    <a:pt x="2649" y="774"/>
                  </a:lnTo>
                  <a:lnTo>
                    <a:pt x="2649" y="772"/>
                  </a:lnTo>
                  <a:lnTo>
                    <a:pt x="2650" y="770"/>
                  </a:lnTo>
                  <a:lnTo>
                    <a:pt x="2650" y="768"/>
                  </a:lnTo>
                  <a:lnTo>
                    <a:pt x="2651" y="766"/>
                  </a:lnTo>
                  <a:lnTo>
                    <a:pt x="2651" y="765"/>
                  </a:lnTo>
                  <a:lnTo>
                    <a:pt x="2652" y="763"/>
                  </a:lnTo>
                  <a:lnTo>
                    <a:pt x="2652" y="761"/>
                  </a:lnTo>
                  <a:lnTo>
                    <a:pt x="2653" y="760"/>
                  </a:lnTo>
                  <a:lnTo>
                    <a:pt x="2653" y="759"/>
                  </a:lnTo>
                  <a:lnTo>
                    <a:pt x="2654" y="757"/>
                  </a:lnTo>
                  <a:lnTo>
                    <a:pt x="2654" y="756"/>
                  </a:lnTo>
                  <a:lnTo>
                    <a:pt x="2655" y="755"/>
                  </a:lnTo>
                  <a:lnTo>
                    <a:pt x="2655" y="754"/>
                  </a:lnTo>
                  <a:lnTo>
                    <a:pt x="2656" y="753"/>
                  </a:lnTo>
                  <a:lnTo>
                    <a:pt x="2657" y="753"/>
                  </a:lnTo>
                  <a:lnTo>
                    <a:pt x="2658" y="753"/>
                  </a:lnTo>
                  <a:lnTo>
                    <a:pt x="2658" y="754"/>
                  </a:lnTo>
                  <a:lnTo>
                    <a:pt x="2659" y="755"/>
                  </a:lnTo>
                  <a:lnTo>
                    <a:pt x="2659" y="757"/>
                  </a:lnTo>
                  <a:lnTo>
                    <a:pt x="2660" y="758"/>
                  </a:lnTo>
                  <a:lnTo>
                    <a:pt x="2660" y="760"/>
                  </a:lnTo>
                  <a:lnTo>
                    <a:pt x="2661" y="762"/>
                  </a:lnTo>
                  <a:lnTo>
                    <a:pt x="2661" y="763"/>
                  </a:lnTo>
                  <a:lnTo>
                    <a:pt x="2662" y="765"/>
                  </a:lnTo>
                  <a:lnTo>
                    <a:pt x="2662" y="767"/>
                  </a:lnTo>
                  <a:lnTo>
                    <a:pt x="2663" y="769"/>
                  </a:lnTo>
                  <a:lnTo>
                    <a:pt x="2663" y="772"/>
                  </a:lnTo>
                  <a:lnTo>
                    <a:pt x="2664" y="774"/>
                  </a:lnTo>
                  <a:lnTo>
                    <a:pt x="2664" y="776"/>
                  </a:lnTo>
                  <a:lnTo>
                    <a:pt x="2664" y="778"/>
                  </a:lnTo>
                  <a:lnTo>
                    <a:pt x="2665" y="780"/>
                  </a:lnTo>
                  <a:lnTo>
                    <a:pt x="2665" y="782"/>
                  </a:lnTo>
                  <a:lnTo>
                    <a:pt x="2666" y="784"/>
                  </a:lnTo>
                  <a:lnTo>
                    <a:pt x="2666" y="786"/>
                  </a:lnTo>
                  <a:lnTo>
                    <a:pt x="2667" y="788"/>
                  </a:lnTo>
                  <a:lnTo>
                    <a:pt x="2667" y="790"/>
                  </a:lnTo>
                  <a:lnTo>
                    <a:pt x="2668" y="791"/>
                  </a:lnTo>
                  <a:lnTo>
                    <a:pt x="2668" y="793"/>
                  </a:lnTo>
                  <a:lnTo>
                    <a:pt x="2669" y="794"/>
                  </a:lnTo>
                  <a:lnTo>
                    <a:pt x="2669" y="795"/>
                  </a:lnTo>
                  <a:lnTo>
                    <a:pt x="2670" y="796"/>
                  </a:lnTo>
                  <a:lnTo>
                    <a:pt x="2671" y="796"/>
                  </a:lnTo>
                  <a:lnTo>
                    <a:pt x="2672" y="796"/>
                  </a:lnTo>
                  <a:lnTo>
                    <a:pt x="2673" y="795"/>
                  </a:lnTo>
                  <a:lnTo>
                    <a:pt x="2674" y="794"/>
                  </a:lnTo>
                  <a:lnTo>
                    <a:pt x="2675" y="793"/>
                  </a:lnTo>
                  <a:lnTo>
                    <a:pt x="2675" y="792"/>
                  </a:lnTo>
                  <a:lnTo>
                    <a:pt x="2676" y="792"/>
                  </a:lnTo>
                  <a:lnTo>
                    <a:pt x="2676" y="791"/>
                  </a:lnTo>
                  <a:lnTo>
                    <a:pt x="2677" y="790"/>
                  </a:lnTo>
                  <a:lnTo>
                    <a:pt x="2677" y="789"/>
                  </a:lnTo>
                  <a:lnTo>
                    <a:pt x="2678" y="789"/>
                  </a:lnTo>
                  <a:lnTo>
                    <a:pt x="2678" y="788"/>
                  </a:lnTo>
                  <a:lnTo>
                    <a:pt x="2679" y="788"/>
                  </a:lnTo>
                  <a:lnTo>
                    <a:pt x="2679" y="787"/>
                  </a:lnTo>
                  <a:lnTo>
                    <a:pt x="2680" y="787"/>
                  </a:lnTo>
                  <a:lnTo>
                    <a:pt x="2680" y="786"/>
                  </a:lnTo>
                  <a:lnTo>
                    <a:pt x="2681" y="786"/>
                  </a:lnTo>
                  <a:lnTo>
                    <a:pt x="2682" y="787"/>
                  </a:lnTo>
                  <a:lnTo>
                    <a:pt x="2683" y="788"/>
                  </a:lnTo>
                  <a:lnTo>
                    <a:pt x="2683" y="789"/>
                  </a:lnTo>
                  <a:lnTo>
                    <a:pt x="2684" y="789"/>
                  </a:lnTo>
                  <a:lnTo>
                    <a:pt x="2684" y="790"/>
                  </a:lnTo>
                  <a:lnTo>
                    <a:pt x="2685" y="791"/>
                  </a:lnTo>
                  <a:lnTo>
                    <a:pt x="2685" y="792"/>
                  </a:lnTo>
                  <a:lnTo>
                    <a:pt x="2686" y="794"/>
                  </a:lnTo>
                  <a:lnTo>
                    <a:pt x="2686" y="795"/>
                  </a:lnTo>
                  <a:lnTo>
                    <a:pt x="2687" y="796"/>
                  </a:lnTo>
                  <a:lnTo>
                    <a:pt x="2687" y="797"/>
                  </a:lnTo>
                  <a:lnTo>
                    <a:pt x="2688" y="799"/>
                  </a:lnTo>
                  <a:lnTo>
                    <a:pt x="2688" y="800"/>
                  </a:lnTo>
                  <a:lnTo>
                    <a:pt x="2689" y="801"/>
                  </a:lnTo>
                  <a:lnTo>
                    <a:pt x="2689" y="803"/>
                  </a:lnTo>
                  <a:lnTo>
                    <a:pt x="2689" y="804"/>
                  </a:lnTo>
                  <a:lnTo>
                    <a:pt x="2690" y="806"/>
                  </a:lnTo>
                  <a:lnTo>
                    <a:pt x="2690" y="807"/>
                  </a:lnTo>
                  <a:lnTo>
                    <a:pt x="2691" y="808"/>
                  </a:lnTo>
                  <a:lnTo>
                    <a:pt x="2691" y="810"/>
                  </a:lnTo>
                  <a:lnTo>
                    <a:pt x="2692" y="811"/>
                  </a:lnTo>
                  <a:lnTo>
                    <a:pt x="2692" y="812"/>
                  </a:lnTo>
                  <a:lnTo>
                    <a:pt x="2693" y="813"/>
                  </a:lnTo>
                  <a:lnTo>
                    <a:pt x="2693" y="814"/>
                  </a:lnTo>
                  <a:lnTo>
                    <a:pt x="2694" y="815"/>
                  </a:lnTo>
                  <a:lnTo>
                    <a:pt x="2695" y="816"/>
                  </a:lnTo>
                  <a:lnTo>
                    <a:pt x="2695" y="817"/>
                  </a:lnTo>
                  <a:lnTo>
                    <a:pt x="2696" y="817"/>
                  </a:lnTo>
                  <a:lnTo>
                    <a:pt x="2696" y="818"/>
                  </a:lnTo>
                  <a:lnTo>
                    <a:pt x="2697" y="818"/>
                  </a:lnTo>
                  <a:lnTo>
                    <a:pt x="2698" y="819"/>
                  </a:lnTo>
                  <a:lnTo>
                    <a:pt x="2699" y="819"/>
                  </a:lnTo>
                  <a:lnTo>
                    <a:pt x="2700" y="819"/>
                  </a:lnTo>
                  <a:lnTo>
                    <a:pt x="2701" y="819"/>
                  </a:lnTo>
                  <a:lnTo>
                    <a:pt x="2701" y="818"/>
                  </a:lnTo>
                  <a:lnTo>
                    <a:pt x="2702" y="818"/>
                  </a:lnTo>
                  <a:lnTo>
                    <a:pt x="2703" y="817"/>
                  </a:lnTo>
                  <a:lnTo>
                    <a:pt x="2704" y="816"/>
                  </a:lnTo>
                  <a:lnTo>
                    <a:pt x="2704" y="815"/>
                  </a:lnTo>
                  <a:lnTo>
                    <a:pt x="2705" y="815"/>
                  </a:lnTo>
                  <a:lnTo>
                    <a:pt x="2705" y="814"/>
                  </a:lnTo>
                  <a:lnTo>
                    <a:pt x="2706" y="813"/>
                  </a:lnTo>
                  <a:lnTo>
                    <a:pt x="2706" y="812"/>
                  </a:lnTo>
                  <a:lnTo>
                    <a:pt x="2706" y="811"/>
                  </a:lnTo>
                  <a:lnTo>
                    <a:pt x="2707" y="810"/>
                  </a:lnTo>
                  <a:lnTo>
                    <a:pt x="2707" y="809"/>
                  </a:lnTo>
                  <a:lnTo>
                    <a:pt x="2708" y="808"/>
                  </a:lnTo>
                  <a:lnTo>
                    <a:pt x="2708" y="806"/>
                  </a:lnTo>
                  <a:lnTo>
                    <a:pt x="2709" y="805"/>
                  </a:lnTo>
                  <a:lnTo>
                    <a:pt x="2709" y="804"/>
                  </a:lnTo>
                  <a:lnTo>
                    <a:pt x="2710" y="802"/>
                  </a:lnTo>
                  <a:lnTo>
                    <a:pt x="2710" y="801"/>
                  </a:lnTo>
                  <a:lnTo>
                    <a:pt x="2711" y="799"/>
                  </a:lnTo>
                  <a:lnTo>
                    <a:pt x="2711" y="798"/>
                  </a:lnTo>
                  <a:lnTo>
                    <a:pt x="2712" y="796"/>
                  </a:lnTo>
                  <a:lnTo>
                    <a:pt x="2712" y="794"/>
                  </a:lnTo>
                  <a:lnTo>
                    <a:pt x="2713" y="793"/>
                  </a:lnTo>
                  <a:lnTo>
                    <a:pt x="2713" y="791"/>
                  </a:lnTo>
                  <a:lnTo>
                    <a:pt x="2714" y="789"/>
                  </a:lnTo>
                  <a:lnTo>
                    <a:pt x="2714" y="788"/>
                  </a:lnTo>
                  <a:lnTo>
                    <a:pt x="2715" y="786"/>
                  </a:lnTo>
                  <a:lnTo>
                    <a:pt x="2715" y="784"/>
                  </a:lnTo>
                  <a:lnTo>
                    <a:pt x="2715" y="782"/>
                  </a:lnTo>
                  <a:lnTo>
                    <a:pt x="2716" y="780"/>
                  </a:lnTo>
                  <a:lnTo>
                    <a:pt x="2716" y="778"/>
                  </a:lnTo>
                  <a:lnTo>
                    <a:pt x="2717" y="776"/>
                  </a:lnTo>
                  <a:lnTo>
                    <a:pt x="2717" y="774"/>
                  </a:lnTo>
                  <a:lnTo>
                    <a:pt x="2718" y="772"/>
                  </a:lnTo>
                  <a:lnTo>
                    <a:pt x="2718" y="770"/>
                  </a:lnTo>
                  <a:lnTo>
                    <a:pt x="2719" y="768"/>
                  </a:lnTo>
                  <a:lnTo>
                    <a:pt x="2719" y="766"/>
                  </a:lnTo>
                  <a:lnTo>
                    <a:pt x="2720" y="764"/>
                  </a:lnTo>
                  <a:lnTo>
                    <a:pt x="2720" y="762"/>
                  </a:lnTo>
                  <a:lnTo>
                    <a:pt x="2721" y="760"/>
                  </a:lnTo>
                  <a:lnTo>
                    <a:pt x="2721" y="758"/>
                  </a:lnTo>
                  <a:lnTo>
                    <a:pt x="2722" y="756"/>
                  </a:lnTo>
                  <a:lnTo>
                    <a:pt x="2722" y="754"/>
                  </a:lnTo>
                  <a:lnTo>
                    <a:pt x="2723" y="752"/>
                  </a:lnTo>
                  <a:lnTo>
                    <a:pt x="2723" y="750"/>
                  </a:lnTo>
                  <a:lnTo>
                    <a:pt x="2724" y="748"/>
                  </a:lnTo>
                  <a:lnTo>
                    <a:pt x="2724" y="746"/>
                  </a:lnTo>
                  <a:lnTo>
                    <a:pt x="2724" y="744"/>
                  </a:lnTo>
                  <a:lnTo>
                    <a:pt x="2725" y="742"/>
                  </a:lnTo>
                  <a:lnTo>
                    <a:pt x="2725" y="740"/>
                  </a:lnTo>
                  <a:lnTo>
                    <a:pt x="2726" y="738"/>
                  </a:lnTo>
                  <a:lnTo>
                    <a:pt x="2726" y="737"/>
                  </a:lnTo>
                  <a:lnTo>
                    <a:pt x="2727" y="735"/>
                  </a:lnTo>
                  <a:lnTo>
                    <a:pt x="2727" y="733"/>
                  </a:lnTo>
                  <a:lnTo>
                    <a:pt x="2728" y="732"/>
                  </a:lnTo>
                  <a:lnTo>
                    <a:pt x="2728" y="730"/>
                  </a:lnTo>
                  <a:lnTo>
                    <a:pt x="2729" y="728"/>
                  </a:lnTo>
                  <a:lnTo>
                    <a:pt x="2729" y="727"/>
                  </a:lnTo>
                  <a:lnTo>
                    <a:pt x="2730" y="725"/>
                  </a:lnTo>
                  <a:lnTo>
                    <a:pt x="2730" y="724"/>
                  </a:lnTo>
                  <a:lnTo>
                    <a:pt x="2731" y="723"/>
                  </a:lnTo>
                  <a:lnTo>
                    <a:pt x="2731" y="722"/>
                  </a:lnTo>
                  <a:lnTo>
                    <a:pt x="2732" y="720"/>
                  </a:lnTo>
                  <a:lnTo>
                    <a:pt x="2732" y="719"/>
                  </a:lnTo>
                  <a:lnTo>
                    <a:pt x="2732" y="718"/>
                  </a:lnTo>
                  <a:lnTo>
                    <a:pt x="2733" y="717"/>
                  </a:lnTo>
                  <a:lnTo>
                    <a:pt x="2733" y="716"/>
                  </a:lnTo>
                  <a:lnTo>
                    <a:pt x="2734" y="715"/>
                  </a:lnTo>
                  <a:lnTo>
                    <a:pt x="2734" y="714"/>
                  </a:lnTo>
                  <a:lnTo>
                    <a:pt x="2735" y="713"/>
                  </a:lnTo>
                  <a:lnTo>
                    <a:pt x="2735" y="712"/>
                  </a:lnTo>
                  <a:lnTo>
                    <a:pt x="2736" y="711"/>
                  </a:lnTo>
                  <a:lnTo>
                    <a:pt x="2737" y="710"/>
                  </a:lnTo>
                  <a:lnTo>
                    <a:pt x="2737" y="709"/>
                  </a:lnTo>
                  <a:lnTo>
                    <a:pt x="2738" y="708"/>
                  </a:lnTo>
                  <a:lnTo>
                    <a:pt x="2739" y="707"/>
                  </a:lnTo>
                  <a:lnTo>
                    <a:pt x="2740" y="706"/>
                  </a:lnTo>
                  <a:lnTo>
                    <a:pt x="2741" y="705"/>
                  </a:lnTo>
                  <a:lnTo>
                    <a:pt x="2742" y="705"/>
                  </a:lnTo>
                  <a:lnTo>
                    <a:pt x="2742" y="704"/>
                  </a:lnTo>
                  <a:lnTo>
                    <a:pt x="2743" y="704"/>
                  </a:lnTo>
                  <a:lnTo>
                    <a:pt x="2744" y="704"/>
                  </a:lnTo>
                  <a:lnTo>
                    <a:pt x="2745" y="704"/>
                  </a:lnTo>
                  <a:lnTo>
                    <a:pt x="2746" y="703"/>
                  </a:lnTo>
                  <a:lnTo>
                    <a:pt x="2747" y="703"/>
                  </a:lnTo>
                  <a:lnTo>
                    <a:pt x="2748" y="703"/>
                  </a:lnTo>
                  <a:lnTo>
                    <a:pt x="2749" y="703"/>
                  </a:lnTo>
                  <a:lnTo>
                    <a:pt x="2750" y="703"/>
                  </a:lnTo>
                  <a:lnTo>
                    <a:pt x="2751" y="703"/>
                  </a:lnTo>
                  <a:lnTo>
                    <a:pt x="2752" y="703"/>
                  </a:lnTo>
                  <a:lnTo>
                    <a:pt x="2753" y="702"/>
                  </a:lnTo>
                  <a:lnTo>
                    <a:pt x="2754" y="702"/>
                  </a:lnTo>
                  <a:lnTo>
                    <a:pt x="2755" y="702"/>
                  </a:lnTo>
                  <a:lnTo>
                    <a:pt x="2756" y="702"/>
                  </a:lnTo>
                  <a:lnTo>
                    <a:pt x="2757" y="702"/>
                  </a:lnTo>
                  <a:lnTo>
                    <a:pt x="2757" y="701"/>
                  </a:lnTo>
                  <a:lnTo>
                    <a:pt x="2758" y="701"/>
                  </a:lnTo>
                  <a:lnTo>
                    <a:pt x="2759" y="701"/>
                  </a:lnTo>
                  <a:lnTo>
                    <a:pt x="2760" y="702"/>
                  </a:lnTo>
                  <a:lnTo>
                    <a:pt x="2761" y="702"/>
                  </a:lnTo>
                  <a:lnTo>
                    <a:pt x="2762" y="702"/>
                  </a:lnTo>
                  <a:lnTo>
                    <a:pt x="2762" y="703"/>
                  </a:lnTo>
                  <a:lnTo>
                    <a:pt x="2763" y="703"/>
                  </a:lnTo>
                  <a:lnTo>
                    <a:pt x="2763" y="704"/>
                  </a:lnTo>
                  <a:lnTo>
                    <a:pt x="2764" y="704"/>
                  </a:lnTo>
                  <a:lnTo>
                    <a:pt x="2764" y="705"/>
                  </a:lnTo>
                  <a:lnTo>
                    <a:pt x="2765" y="706"/>
                  </a:lnTo>
                  <a:lnTo>
                    <a:pt x="2766" y="707"/>
                  </a:lnTo>
                  <a:lnTo>
                    <a:pt x="2766" y="708"/>
                  </a:lnTo>
                  <a:lnTo>
                    <a:pt x="2766" y="709"/>
                  </a:lnTo>
                  <a:lnTo>
                    <a:pt x="2767" y="710"/>
                  </a:lnTo>
                  <a:lnTo>
                    <a:pt x="2767" y="711"/>
                  </a:lnTo>
                  <a:lnTo>
                    <a:pt x="2768" y="712"/>
                  </a:lnTo>
                  <a:lnTo>
                    <a:pt x="2768" y="713"/>
                  </a:lnTo>
                  <a:lnTo>
                    <a:pt x="2769" y="714"/>
                  </a:lnTo>
                  <a:lnTo>
                    <a:pt x="2769" y="716"/>
                  </a:lnTo>
                  <a:lnTo>
                    <a:pt x="2770" y="717"/>
                  </a:lnTo>
                  <a:lnTo>
                    <a:pt x="2770" y="718"/>
                  </a:lnTo>
                  <a:lnTo>
                    <a:pt x="2771" y="719"/>
                  </a:lnTo>
                  <a:lnTo>
                    <a:pt x="2771" y="720"/>
                  </a:lnTo>
                  <a:lnTo>
                    <a:pt x="2772" y="721"/>
                  </a:lnTo>
                  <a:lnTo>
                    <a:pt x="2772" y="722"/>
                  </a:lnTo>
                  <a:lnTo>
                    <a:pt x="2773" y="723"/>
                  </a:lnTo>
                  <a:lnTo>
                    <a:pt x="2774" y="724"/>
                  </a:lnTo>
                  <a:lnTo>
                    <a:pt x="2774" y="725"/>
                  </a:lnTo>
                  <a:lnTo>
                    <a:pt x="2775" y="726"/>
                  </a:lnTo>
                  <a:lnTo>
                    <a:pt x="2775" y="727"/>
                  </a:lnTo>
                  <a:lnTo>
                    <a:pt x="2776" y="727"/>
                  </a:lnTo>
                  <a:lnTo>
                    <a:pt x="2777" y="728"/>
                  </a:lnTo>
                  <a:lnTo>
                    <a:pt x="2778" y="728"/>
                  </a:lnTo>
                  <a:lnTo>
                    <a:pt x="2779" y="728"/>
                  </a:lnTo>
                  <a:lnTo>
                    <a:pt x="2780" y="728"/>
                  </a:lnTo>
                  <a:lnTo>
                    <a:pt x="2780" y="727"/>
                  </a:lnTo>
                  <a:lnTo>
                    <a:pt x="2781" y="727"/>
                  </a:lnTo>
                  <a:lnTo>
                    <a:pt x="2782" y="726"/>
                  </a:lnTo>
                  <a:lnTo>
                    <a:pt x="2783" y="725"/>
                  </a:lnTo>
                  <a:lnTo>
                    <a:pt x="2784" y="724"/>
                  </a:lnTo>
                  <a:lnTo>
                    <a:pt x="2784" y="723"/>
                  </a:lnTo>
                  <a:lnTo>
                    <a:pt x="2785" y="723"/>
                  </a:lnTo>
                  <a:lnTo>
                    <a:pt x="2785" y="722"/>
                  </a:lnTo>
                  <a:lnTo>
                    <a:pt x="2786" y="721"/>
                  </a:lnTo>
                  <a:lnTo>
                    <a:pt x="2787" y="720"/>
                  </a:lnTo>
                  <a:lnTo>
                    <a:pt x="2787" y="719"/>
                  </a:lnTo>
                  <a:lnTo>
                    <a:pt x="2788" y="719"/>
                  </a:lnTo>
                  <a:lnTo>
                    <a:pt x="2788" y="718"/>
                  </a:lnTo>
                  <a:lnTo>
                    <a:pt x="2789" y="717"/>
                  </a:lnTo>
                  <a:lnTo>
                    <a:pt x="2790" y="716"/>
                  </a:lnTo>
                  <a:lnTo>
                    <a:pt x="2791" y="715"/>
                  </a:lnTo>
                  <a:lnTo>
                    <a:pt x="2791" y="714"/>
                  </a:lnTo>
                  <a:lnTo>
                    <a:pt x="2792" y="714"/>
                  </a:lnTo>
                  <a:lnTo>
                    <a:pt x="2792" y="713"/>
                  </a:lnTo>
                  <a:lnTo>
                    <a:pt x="2792" y="712"/>
                  </a:lnTo>
                  <a:lnTo>
                    <a:pt x="2793" y="712"/>
                  </a:lnTo>
                  <a:lnTo>
                    <a:pt x="2793" y="711"/>
                  </a:lnTo>
                  <a:lnTo>
                    <a:pt x="2794" y="710"/>
                  </a:lnTo>
                  <a:lnTo>
                    <a:pt x="2795" y="709"/>
                  </a:lnTo>
                  <a:lnTo>
                    <a:pt x="2796" y="708"/>
                  </a:lnTo>
                  <a:lnTo>
                    <a:pt x="2796" y="707"/>
                  </a:lnTo>
                  <a:lnTo>
                    <a:pt x="2797" y="707"/>
                  </a:lnTo>
                  <a:lnTo>
                    <a:pt x="2797" y="706"/>
                  </a:lnTo>
                  <a:lnTo>
                    <a:pt x="2798" y="706"/>
                  </a:lnTo>
                  <a:lnTo>
                    <a:pt x="2798" y="705"/>
                  </a:lnTo>
                  <a:lnTo>
                    <a:pt x="2799" y="705"/>
                  </a:lnTo>
                  <a:lnTo>
                    <a:pt x="2799" y="704"/>
                  </a:lnTo>
                  <a:lnTo>
                    <a:pt x="2800" y="703"/>
                  </a:lnTo>
                  <a:lnTo>
                    <a:pt x="2801" y="702"/>
                  </a:lnTo>
                  <a:lnTo>
                    <a:pt x="2801" y="701"/>
                  </a:lnTo>
                  <a:lnTo>
                    <a:pt x="2802" y="700"/>
                  </a:lnTo>
                  <a:lnTo>
                    <a:pt x="2802" y="699"/>
                  </a:lnTo>
                  <a:lnTo>
                    <a:pt x="2803" y="699"/>
                  </a:lnTo>
                  <a:lnTo>
                    <a:pt x="2803" y="698"/>
                  </a:lnTo>
                  <a:lnTo>
                    <a:pt x="2804" y="698"/>
                  </a:lnTo>
                  <a:lnTo>
                    <a:pt x="2804" y="697"/>
                  </a:lnTo>
                  <a:lnTo>
                    <a:pt x="2805" y="697"/>
                  </a:lnTo>
                  <a:lnTo>
                    <a:pt x="2806" y="696"/>
                  </a:lnTo>
                  <a:lnTo>
                    <a:pt x="2807" y="696"/>
                  </a:lnTo>
                  <a:lnTo>
                    <a:pt x="2808" y="696"/>
                  </a:lnTo>
                  <a:lnTo>
                    <a:pt x="2809" y="696"/>
                  </a:lnTo>
                  <a:lnTo>
                    <a:pt x="2809" y="697"/>
                  </a:lnTo>
                  <a:lnTo>
                    <a:pt x="2810" y="697"/>
                  </a:lnTo>
                  <a:lnTo>
                    <a:pt x="2810" y="698"/>
                  </a:lnTo>
                  <a:lnTo>
                    <a:pt x="2811" y="698"/>
                  </a:lnTo>
                  <a:lnTo>
                    <a:pt x="2811" y="699"/>
                  </a:lnTo>
                  <a:lnTo>
                    <a:pt x="2812" y="700"/>
                  </a:lnTo>
                  <a:lnTo>
                    <a:pt x="2812" y="701"/>
                  </a:lnTo>
                  <a:lnTo>
                    <a:pt x="2813" y="703"/>
                  </a:lnTo>
                  <a:lnTo>
                    <a:pt x="2813" y="704"/>
                  </a:lnTo>
                  <a:lnTo>
                    <a:pt x="2814" y="705"/>
                  </a:lnTo>
                  <a:lnTo>
                    <a:pt x="2814" y="706"/>
                  </a:lnTo>
                  <a:lnTo>
                    <a:pt x="2815" y="708"/>
                  </a:lnTo>
                  <a:lnTo>
                    <a:pt x="2815" y="709"/>
                  </a:lnTo>
                  <a:lnTo>
                    <a:pt x="2816" y="710"/>
                  </a:lnTo>
                  <a:lnTo>
                    <a:pt x="2816" y="711"/>
                  </a:lnTo>
                  <a:lnTo>
                    <a:pt x="2817" y="712"/>
                  </a:lnTo>
                  <a:lnTo>
                    <a:pt x="2817" y="713"/>
                  </a:lnTo>
                  <a:lnTo>
                    <a:pt x="2818" y="714"/>
                  </a:lnTo>
                  <a:lnTo>
                    <a:pt x="2818" y="715"/>
                  </a:lnTo>
                  <a:lnTo>
                    <a:pt x="2818" y="716"/>
                  </a:lnTo>
                  <a:lnTo>
                    <a:pt x="2819" y="716"/>
                  </a:lnTo>
                  <a:lnTo>
                    <a:pt x="2820" y="717"/>
                  </a:lnTo>
                  <a:lnTo>
                    <a:pt x="2821" y="716"/>
                  </a:lnTo>
                  <a:lnTo>
                    <a:pt x="2822" y="715"/>
                  </a:lnTo>
                  <a:lnTo>
                    <a:pt x="2822" y="714"/>
                  </a:lnTo>
                  <a:lnTo>
                    <a:pt x="2823" y="713"/>
                  </a:lnTo>
                  <a:lnTo>
                    <a:pt x="2823" y="711"/>
                  </a:lnTo>
                  <a:lnTo>
                    <a:pt x="2824" y="709"/>
                  </a:lnTo>
                  <a:lnTo>
                    <a:pt x="2824" y="707"/>
                  </a:lnTo>
                  <a:lnTo>
                    <a:pt x="2825" y="704"/>
                  </a:lnTo>
                  <a:lnTo>
                    <a:pt x="2825" y="702"/>
                  </a:lnTo>
                  <a:lnTo>
                    <a:pt x="2826" y="699"/>
                  </a:lnTo>
                  <a:lnTo>
                    <a:pt x="2826" y="695"/>
                  </a:lnTo>
                  <a:lnTo>
                    <a:pt x="2826" y="692"/>
                  </a:lnTo>
                  <a:lnTo>
                    <a:pt x="2827" y="689"/>
                  </a:lnTo>
                  <a:lnTo>
                    <a:pt x="2827" y="685"/>
                  </a:lnTo>
                  <a:lnTo>
                    <a:pt x="2828" y="682"/>
                  </a:lnTo>
                  <a:lnTo>
                    <a:pt x="2828" y="679"/>
                  </a:lnTo>
                  <a:lnTo>
                    <a:pt x="2829" y="675"/>
                  </a:lnTo>
                  <a:lnTo>
                    <a:pt x="2829" y="671"/>
                  </a:lnTo>
                  <a:lnTo>
                    <a:pt x="2830" y="668"/>
                  </a:lnTo>
                  <a:lnTo>
                    <a:pt x="2830" y="664"/>
                  </a:lnTo>
                  <a:lnTo>
                    <a:pt x="2831" y="661"/>
                  </a:lnTo>
                  <a:lnTo>
                    <a:pt x="2831" y="658"/>
                  </a:lnTo>
                  <a:lnTo>
                    <a:pt x="2832" y="655"/>
                  </a:lnTo>
                  <a:lnTo>
                    <a:pt x="2832" y="652"/>
                  </a:lnTo>
                  <a:lnTo>
                    <a:pt x="2833" y="649"/>
                  </a:lnTo>
                  <a:lnTo>
                    <a:pt x="2833" y="646"/>
                  </a:lnTo>
                  <a:lnTo>
                    <a:pt x="2834" y="643"/>
                  </a:lnTo>
                  <a:lnTo>
                    <a:pt x="2834" y="641"/>
                  </a:lnTo>
                  <a:lnTo>
                    <a:pt x="2835" y="639"/>
                  </a:lnTo>
                  <a:lnTo>
                    <a:pt x="2835" y="638"/>
                  </a:lnTo>
                  <a:lnTo>
                    <a:pt x="2835" y="637"/>
                  </a:lnTo>
                  <a:lnTo>
                    <a:pt x="2836" y="636"/>
                  </a:lnTo>
                  <a:lnTo>
                    <a:pt x="2836" y="635"/>
                  </a:lnTo>
                  <a:lnTo>
                    <a:pt x="2837" y="635"/>
                  </a:lnTo>
                  <a:lnTo>
                    <a:pt x="2838" y="635"/>
                  </a:lnTo>
                  <a:lnTo>
                    <a:pt x="2839" y="635"/>
                  </a:lnTo>
                  <a:lnTo>
                    <a:pt x="2839" y="636"/>
                  </a:lnTo>
                  <a:lnTo>
                    <a:pt x="2840" y="636"/>
                  </a:lnTo>
                  <a:lnTo>
                    <a:pt x="2840" y="637"/>
                  </a:lnTo>
                  <a:lnTo>
                    <a:pt x="2841" y="638"/>
                  </a:lnTo>
                  <a:lnTo>
                    <a:pt x="2841" y="639"/>
                  </a:lnTo>
                  <a:lnTo>
                    <a:pt x="2842" y="640"/>
                  </a:lnTo>
                  <a:lnTo>
                    <a:pt x="2842" y="641"/>
                  </a:lnTo>
                  <a:lnTo>
                    <a:pt x="2843" y="642"/>
                  </a:lnTo>
                  <a:lnTo>
                    <a:pt x="2843" y="643"/>
                  </a:lnTo>
                  <a:lnTo>
                    <a:pt x="2843" y="645"/>
                  </a:lnTo>
                  <a:lnTo>
                    <a:pt x="2844" y="646"/>
                  </a:lnTo>
                  <a:lnTo>
                    <a:pt x="2844" y="647"/>
                  </a:lnTo>
                  <a:lnTo>
                    <a:pt x="2845" y="649"/>
                  </a:lnTo>
                  <a:lnTo>
                    <a:pt x="2845" y="650"/>
                  </a:lnTo>
                  <a:lnTo>
                    <a:pt x="2846" y="651"/>
                  </a:lnTo>
                  <a:lnTo>
                    <a:pt x="2846" y="653"/>
                  </a:lnTo>
                  <a:lnTo>
                    <a:pt x="2847" y="654"/>
                  </a:lnTo>
                  <a:lnTo>
                    <a:pt x="2848" y="655"/>
                  </a:lnTo>
                  <a:lnTo>
                    <a:pt x="2848" y="656"/>
                  </a:lnTo>
                  <a:lnTo>
                    <a:pt x="2849" y="657"/>
                  </a:lnTo>
                  <a:lnTo>
                    <a:pt x="2849" y="658"/>
                  </a:lnTo>
                  <a:lnTo>
                    <a:pt x="2850" y="658"/>
                  </a:lnTo>
                  <a:lnTo>
                    <a:pt x="2850" y="659"/>
                  </a:lnTo>
                  <a:lnTo>
                    <a:pt x="2851" y="659"/>
                  </a:lnTo>
                  <a:lnTo>
                    <a:pt x="2851" y="660"/>
                  </a:lnTo>
                  <a:lnTo>
                    <a:pt x="2852" y="661"/>
                  </a:lnTo>
                  <a:lnTo>
                    <a:pt x="2852" y="662"/>
                  </a:lnTo>
                  <a:lnTo>
                    <a:pt x="2853" y="662"/>
                  </a:lnTo>
                  <a:lnTo>
                    <a:pt x="2853" y="663"/>
                  </a:lnTo>
                  <a:lnTo>
                    <a:pt x="2854" y="663"/>
                  </a:lnTo>
                  <a:lnTo>
                    <a:pt x="2855" y="664"/>
                  </a:lnTo>
                  <a:lnTo>
                    <a:pt x="2856" y="665"/>
                  </a:lnTo>
                  <a:lnTo>
                    <a:pt x="2857" y="665"/>
                  </a:lnTo>
                  <a:lnTo>
                    <a:pt x="2857" y="666"/>
                  </a:lnTo>
                  <a:lnTo>
                    <a:pt x="2858" y="666"/>
                  </a:lnTo>
                  <a:lnTo>
                    <a:pt x="2859" y="667"/>
                  </a:lnTo>
                  <a:lnTo>
                    <a:pt x="2860" y="668"/>
                  </a:lnTo>
                  <a:lnTo>
                    <a:pt x="2861" y="669"/>
                  </a:lnTo>
                  <a:lnTo>
                    <a:pt x="2861" y="670"/>
                  </a:lnTo>
                  <a:lnTo>
                    <a:pt x="2862" y="670"/>
                  </a:lnTo>
                  <a:lnTo>
                    <a:pt x="2862" y="671"/>
                  </a:lnTo>
                  <a:lnTo>
                    <a:pt x="2863" y="671"/>
                  </a:lnTo>
                  <a:lnTo>
                    <a:pt x="2863" y="672"/>
                  </a:lnTo>
                  <a:lnTo>
                    <a:pt x="2864" y="672"/>
                  </a:lnTo>
                  <a:lnTo>
                    <a:pt x="2865" y="673"/>
                  </a:lnTo>
                  <a:lnTo>
                    <a:pt x="2866" y="673"/>
                  </a:lnTo>
                  <a:lnTo>
                    <a:pt x="2867" y="673"/>
                  </a:lnTo>
                  <a:lnTo>
                    <a:pt x="2868" y="673"/>
                  </a:lnTo>
                  <a:lnTo>
                    <a:pt x="2869" y="673"/>
                  </a:lnTo>
                  <a:lnTo>
                    <a:pt x="2870" y="672"/>
                  </a:lnTo>
                  <a:lnTo>
                    <a:pt x="2871" y="671"/>
                  </a:lnTo>
                  <a:lnTo>
                    <a:pt x="2871" y="670"/>
                  </a:lnTo>
                  <a:lnTo>
                    <a:pt x="2872" y="670"/>
                  </a:lnTo>
                  <a:lnTo>
                    <a:pt x="2872" y="669"/>
                  </a:lnTo>
                  <a:lnTo>
                    <a:pt x="2873" y="668"/>
                  </a:lnTo>
                  <a:lnTo>
                    <a:pt x="2873" y="667"/>
                  </a:lnTo>
                  <a:lnTo>
                    <a:pt x="2874" y="666"/>
                  </a:lnTo>
                  <a:lnTo>
                    <a:pt x="2874" y="665"/>
                  </a:lnTo>
                  <a:lnTo>
                    <a:pt x="2875" y="664"/>
                  </a:lnTo>
                  <a:lnTo>
                    <a:pt x="2875" y="663"/>
                  </a:lnTo>
                  <a:lnTo>
                    <a:pt x="2876" y="662"/>
                  </a:lnTo>
                  <a:lnTo>
                    <a:pt x="2876" y="661"/>
                  </a:lnTo>
                  <a:lnTo>
                    <a:pt x="2877" y="660"/>
                  </a:lnTo>
                  <a:lnTo>
                    <a:pt x="2877" y="659"/>
                  </a:lnTo>
                  <a:lnTo>
                    <a:pt x="2878" y="658"/>
                  </a:lnTo>
                  <a:lnTo>
                    <a:pt x="2878" y="657"/>
                  </a:lnTo>
                  <a:lnTo>
                    <a:pt x="2878" y="656"/>
                  </a:lnTo>
                  <a:lnTo>
                    <a:pt x="2879" y="655"/>
                  </a:lnTo>
                  <a:lnTo>
                    <a:pt x="2879" y="654"/>
                  </a:lnTo>
                  <a:lnTo>
                    <a:pt x="2880" y="653"/>
                  </a:lnTo>
                  <a:lnTo>
                    <a:pt x="2880" y="652"/>
                  </a:lnTo>
                  <a:lnTo>
                    <a:pt x="2881" y="651"/>
                  </a:lnTo>
                  <a:lnTo>
                    <a:pt x="2881" y="650"/>
                  </a:lnTo>
                  <a:lnTo>
                    <a:pt x="2882" y="650"/>
                  </a:lnTo>
                  <a:lnTo>
                    <a:pt x="2882" y="649"/>
                  </a:lnTo>
                  <a:lnTo>
                    <a:pt x="2883" y="648"/>
                  </a:lnTo>
                  <a:lnTo>
                    <a:pt x="2884" y="647"/>
                  </a:lnTo>
                  <a:lnTo>
                    <a:pt x="2884" y="646"/>
                  </a:lnTo>
                  <a:lnTo>
                    <a:pt x="2885" y="646"/>
                  </a:lnTo>
                  <a:lnTo>
                    <a:pt x="2885" y="645"/>
                  </a:lnTo>
                  <a:lnTo>
                    <a:pt x="2886" y="645"/>
                  </a:lnTo>
                  <a:lnTo>
                    <a:pt x="2886" y="644"/>
                  </a:lnTo>
                  <a:lnTo>
                    <a:pt x="2887" y="644"/>
                  </a:lnTo>
                  <a:lnTo>
                    <a:pt x="2887" y="643"/>
                  </a:lnTo>
                  <a:lnTo>
                    <a:pt x="2888" y="643"/>
                  </a:lnTo>
                  <a:lnTo>
                    <a:pt x="2889" y="643"/>
                  </a:lnTo>
                  <a:lnTo>
                    <a:pt x="2889" y="642"/>
                  </a:lnTo>
                  <a:lnTo>
                    <a:pt x="2890" y="642"/>
                  </a:lnTo>
                  <a:lnTo>
                    <a:pt x="2891" y="642"/>
                  </a:lnTo>
                  <a:lnTo>
                    <a:pt x="2892" y="641"/>
                  </a:lnTo>
                  <a:lnTo>
                    <a:pt x="2893" y="641"/>
                  </a:lnTo>
                  <a:lnTo>
                    <a:pt x="2894" y="641"/>
                  </a:lnTo>
                  <a:lnTo>
                    <a:pt x="2894" y="640"/>
                  </a:lnTo>
                  <a:lnTo>
                    <a:pt x="2895" y="640"/>
                  </a:lnTo>
                  <a:lnTo>
                    <a:pt x="2895" y="639"/>
                  </a:lnTo>
                  <a:lnTo>
                    <a:pt x="2896" y="639"/>
                  </a:lnTo>
                  <a:lnTo>
                    <a:pt x="2897" y="639"/>
                  </a:lnTo>
                  <a:lnTo>
                    <a:pt x="2897" y="638"/>
                  </a:lnTo>
                  <a:lnTo>
                    <a:pt x="2898" y="638"/>
                  </a:lnTo>
                  <a:lnTo>
                    <a:pt x="2898" y="637"/>
                  </a:lnTo>
                  <a:lnTo>
                    <a:pt x="2899" y="637"/>
                  </a:lnTo>
                  <a:lnTo>
                    <a:pt x="2900" y="636"/>
                  </a:lnTo>
                  <a:lnTo>
                    <a:pt x="2901" y="635"/>
                  </a:lnTo>
                  <a:lnTo>
                    <a:pt x="2902" y="635"/>
                  </a:lnTo>
                  <a:lnTo>
                    <a:pt x="2902" y="634"/>
                  </a:lnTo>
                  <a:lnTo>
                    <a:pt x="2903" y="634"/>
                  </a:lnTo>
                  <a:lnTo>
                    <a:pt x="2903" y="633"/>
                  </a:lnTo>
                  <a:lnTo>
                    <a:pt x="2903" y="632"/>
                  </a:lnTo>
                  <a:lnTo>
                    <a:pt x="2904" y="632"/>
                  </a:lnTo>
                  <a:lnTo>
                    <a:pt x="2904" y="631"/>
                  </a:lnTo>
                  <a:lnTo>
                    <a:pt x="2905" y="631"/>
                  </a:lnTo>
                  <a:lnTo>
                    <a:pt x="2905" y="630"/>
                  </a:lnTo>
                  <a:lnTo>
                    <a:pt x="2906" y="629"/>
                  </a:lnTo>
                  <a:lnTo>
                    <a:pt x="2907" y="628"/>
                  </a:lnTo>
                  <a:lnTo>
                    <a:pt x="2907" y="627"/>
                  </a:lnTo>
                  <a:lnTo>
                    <a:pt x="2908" y="626"/>
                  </a:lnTo>
                  <a:lnTo>
                    <a:pt x="2909" y="625"/>
                  </a:lnTo>
                  <a:lnTo>
                    <a:pt x="2909" y="624"/>
                  </a:lnTo>
                  <a:lnTo>
                    <a:pt x="2910" y="623"/>
                  </a:lnTo>
                  <a:lnTo>
                    <a:pt x="2910" y="622"/>
                  </a:lnTo>
                  <a:lnTo>
                    <a:pt x="2911" y="621"/>
                  </a:lnTo>
                  <a:lnTo>
                    <a:pt x="2911" y="620"/>
                  </a:lnTo>
                  <a:lnTo>
                    <a:pt x="2912" y="620"/>
                  </a:lnTo>
                  <a:lnTo>
                    <a:pt x="2912" y="619"/>
                  </a:lnTo>
                  <a:lnTo>
                    <a:pt x="2912" y="618"/>
                  </a:lnTo>
                  <a:lnTo>
                    <a:pt x="2913" y="617"/>
                  </a:lnTo>
                  <a:lnTo>
                    <a:pt x="2913" y="616"/>
                  </a:lnTo>
                  <a:lnTo>
                    <a:pt x="2914" y="615"/>
                  </a:lnTo>
                  <a:lnTo>
                    <a:pt x="2914" y="614"/>
                  </a:lnTo>
                  <a:lnTo>
                    <a:pt x="2915" y="613"/>
                  </a:lnTo>
                  <a:lnTo>
                    <a:pt x="2915" y="612"/>
                  </a:lnTo>
                  <a:lnTo>
                    <a:pt x="2916" y="611"/>
                  </a:lnTo>
                  <a:lnTo>
                    <a:pt x="2917" y="610"/>
                  </a:lnTo>
                  <a:lnTo>
                    <a:pt x="2917" y="609"/>
                  </a:lnTo>
                  <a:lnTo>
                    <a:pt x="2918" y="608"/>
                  </a:lnTo>
                  <a:lnTo>
                    <a:pt x="2918" y="607"/>
                  </a:lnTo>
                  <a:lnTo>
                    <a:pt x="2919" y="606"/>
                  </a:lnTo>
                  <a:lnTo>
                    <a:pt x="2920" y="605"/>
                  </a:lnTo>
                  <a:lnTo>
                    <a:pt x="2920" y="604"/>
                  </a:lnTo>
                  <a:lnTo>
                    <a:pt x="2920" y="603"/>
                  </a:lnTo>
                  <a:lnTo>
                    <a:pt x="2921" y="602"/>
                  </a:lnTo>
                  <a:lnTo>
                    <a:pt x="2922" y="601"/>
                  </a:lnTo>
                  <a:lnTo>
                    <a:pt x="2922" y="600"/>
                  </a:lnTo>
                  <a:lnTo>
                    <a:pt x="2923" y="600"/>
                  </a:lnTo>
                  <a:lnTo>
                    <a:pt x="2923" y="599"/>
                  </a:lnTo>
                  <a:lnTo>
                    <a:pt x="2924" y="598"/>
                  </a:lnTo>
                  <a:lnTo>
                    <a:pt x="2925" y="597"/>
                  </a:lnTo>
                  <a:lnTo>
                    <a:pt x="2925" y="596"/>
                  </a:lnTo>
                  <a:lnTo>
                    <a:pt x="2926" y="596"/>
                  </a:lnTo>
                  <a:lnTo>
                    <a:pt x="2926" y="595"/>
                  </a:lnTo>
                  <a:lnTo>
                    <a:pt x="2927" y="595"/>
                  </a:lnTo>
                  <a:lnTo>
                    <a:pt x="2927" y="594"/>
                  </a:lnTo>
                  <a:lnTo>
                    <a:pt x="2928" y="594"/>
                  </a:lnTo>
                  <a:lnTo>
                    <a:pt x="2928" y="593"/>
                  </a:lnTo>
                  <a:lnTo>
                    <a:pt x="2929" y="593"/>
                  </a:lnTo>
                  <a:lnTo>
                    <a:pt x="2929" y="592"/>
                  </a:lnTo>
                  <a:lnTo>
                    <a:pt x="2930" y="591"/>
                  </a:lnTo>
                  <a:lnTo>
                    <a:pt x="2931" y="591"/>
                  </a:lnTo>
                  <a:lnTo>
                    <a:pt x="2931" y="590"/>
                  </a:lnTo>
                  <a:lnTo>
                    <a:pt x="2932" y="590"/>
                  </a:lnTo>
                  <a:lnTo>
                    <a:pt x="2933" y="589"/>
                  </a:lnTo>
                  <a:lnTo>
                    <a:pt x="2934" y="589"/>
                  </a:lnTo>
                  <a:lnTo>
                    <a:pt x="2934" y="588"/>
                  </a:lnTo>
                  <a:lnTo>
                    <a:pt x="2935" y="588"/>
                  </a:lnTo>
                  <a:lnTo>
                    <a:pt x="2936" y="588"/>
                  </a:lnTo>
                  <a:lnTo>
                    <a:pt x="2937" y="587"/>
                  </a:lnTo>
                  <a:lnTo>
                    <a:pt x="2938" y="587"/>
                  </a:lnTo>
                  <a:lnTo>
                    <a:pt x="2939" y="587"/>
                  </a:lnTo>
                  <a:lnTo>
                    <a:pt x="2939" y="586"/>
                  </a:lnTo>
                  <a:lnTo>
                    <a:pt x="2940" y="586"/>
                  </a:lnTo>
                  <a:lnTo>
                    <a:pt x="2941" y="586"/>
                  </a:lnTo>
                  <a:lnTo>
                    <a:pt x="2942" y="586"/>
                  </a:lnTo>
                  <a:lnTo>
                    <a:pt x="2943" y="586"/>
                  </a:lnTo>
                  <a:lnTo>
                    <a:pt x="2943" y="585"/>
                  </a:lnTo>
                  <a:lnTo>
                    <a:pt x="2944" y="585"/>
                  </a:lnTo>
                  <a:lnTo>
                    <a:pt x="2945" y="585"/>
                  </a:lnTo>
                  <a:lnTo>
                    <a:pt x="2946" y="585"/>
                  </a:lnTo>
                  <a:lnTo>
                    <a:pt x="2947" y="585"/>
                  </a:lnTo>
                  <a:lnTo>
                    <a:pt x="2948" y="586"/>
                  </a:lnTo>
                  <a:lnTo>
                    <a:pt x="2949" y="586"/>
                  </a:lnTo>
                  <a:lnTo>
                    <a:pt x="2950" y="587"/>
                  </a:lnTo>
                  <a:lnTo>
                    <a:pt x="2951" y="587"/>
                  </a:lnTo>
                  <a:lnTo>
                    <a:pt x="2951" y="588"/>
                  </a:lnTo>
                  <a:lnTo>
                    <a:pt x="2952" y="588"/>
                  </a:lnTo>
                  <a:lnTo>
                    <a:pt x="2952" y="589"/>
                  </a:lnTo>
                  <a:lnTo>
                    <a:pt x="2953" y="589"/>
                  </a:lnTo>
                  <a:lnTo>
                    <a:pt x="2953" y="590"/>
                  </a:lnTo>
                  <a:lnTo>
                    <a:pt x="2954" y="590"/>
                  </a:lnTo>
                  <a:lnTo>
                    <a:pt x="2954" y="591"/>
                  </a:lnTo>
                  <a:lnTo>
                    <a:pt x="2955" y="592"/>
                  </a:lnTo>
                  <a:lnTo>
                    <a:pt x="2955" y="593"/>
                  </a:lnTo>
                  <a:lnTo>
                    <a:pt x="2955" y="594"/>
                  </a:lnTo>
                  <a:lnTo>
                    <a:pt x="2956" y="594"/>
                  </a:lnTo>
                  <a:lnTo>
                    <a:pt x="2956" y="595"/>
                  </a:lnTo>
                  <a:lnTo>
                    <a:pt x="2957" y="596"/>
                  </a:lnTo>
                  <a:lnTo>
                    <a:pt x="2957" y="597"/>
                  </a:lnTo>
                  <a:lnTo>
                    <a:pt x="2958" y="598"/>
                  </a:lnTo>
                  <a:lnTo>
                    <a:pt x="2958" y="599"/>
                  </a:lnTo>
                  <a:lnTo>
                    <a:pt x="2959" y="599"/>
                  </a:lnTo>
                  <a:lnTo>
                    <a:pt x="2959" y="600"/>
                  </a:lnTo>
                  <a:lnTo>
                    <a:pt x="2960" y="601"/>
                  </a:lnTo>
                  <a:lnTo>
                    <a:pt x="2960" y="602"/>
                  </a:lnTo>
                  <a:lnTo>
                    <a:pt x="2961" y="602"/>
                  </a:lnTo>
                  <a:lnTo>
                    <a:pt x="2961" y="603"/>
                  </a:lnTo>
                  <a:lnTo>
                    <a:pt x="2962" y="604"/>
                  </a:lnTo>
                  <a:lnTo>
                    <a:pt x="2963" y="605"/>
                  </a:lnTo>
                  <a:lnTo>
                    <a:pt x="2964" y="606"/>
                  </a:lnTo>
                  <a:lnTo>
                    <a:pt x="2965" y="606"/>
                  </a:lnTo>
                  <a:lnTo>
                    <a:pt x="2966" y="605"/>
                  </a:lnTo>
                  <a:lnTo>
                    <a:pt x="2967" y="605"/>
                  </a:lnTo>
                  <a:lnTo>
                    <a:pt x="2967" y="604"/>
                  </a:lnTo>
                  <a:lnTo>
                    <a:pt x="2968" y="604"/>
                  </a:lnTo>
                  <a:lnTo>
                    <a:pt x="2968" y="603"/>
                  </a:lnTo>
                  <a:lnTo>
                    <a:pt x="2969" y="603"/>
                  </a:lnTo>
                  <a:lnTo>
                    <a:pt x="2969" y="602"/>
                  </a:lnTo>
                  <a:lnTo>
                    <a:pt x="2970" y="601"/>
                  </a:lnTo>
                  <a:lnTo>
                    <a:pt x="2971" y="600"/>
                  </a:lnTo>
                  <a:lnTo>
                    <a:pt x="2971" y="599"/>
                  </a:lnTo>
                  <a:lnTo>
                    <a:pt x="2972" y="598"/>
                  </a:lnTo>
                  <a:lnTo>
                    <a:pt x="2972" y="597"/>
                  </a:lnTo>
                  <a:lnTo>
                    <a:pt x="2972" y="596"/>
                  </a:lnTo>
                  <a:lnTo>
                    <a:pt x="2973" y="595"/>
                  </a:lnTo>
                  <a:lnTo>
                    <a:pt x="2973" y="594"/>
                  </a:lnTo>
                  <a:lnTo>
                    <a:pt x="2974" y="592"/>
                  </a:lnTo>
                  <a:lnTo>
                    <a:pt x="2974" y="591"/>
                  </a:lnTo>
                  <a:lnTo>
                    <a:pt x="2975" y="590"/>
                  </a:lnTo>
                  <a:lnTo>
                    <a:pt x="2975" y="589"/>
                  </a:lnTo>
                  <a:lnTo>
                    <a:pt x="2976" y="587"/>
                  </a:lnTo>
                  <a:lnTo>
                    <a:pt x="2976" y="586"/>
                  </a:lnTo>
                  <a:lnTo>
                    <a:pt x="2977" y="585"/>
                  </a:lnTo>
                  <a:lnTo>
                    <a:pt x="2977" y="584"/>
                  </a:lnTo>
                  <a:lnTo>
                    <a:pt x="2978" y="582"/>
                  </a:lnTo>
                  <a:lnTo>
                    <a:pt x="2978" y="581"/>
                  </a:lnTo>
                  <a:lnTo>
                    <a:pt x="2979" y="580"/>
                  </a:lnTo>
                  <a:lnTo>
                    <a:pt x="2979" y="578"/>
                  </a:lnTo>
                  <a:lnTo>
                    <a:pt x="2980" y="577"/>
                  </a:lnTo>
                  <a:lnTo>
                    <a:pt x="2980" y="576"/>
                  </a:lnTo>
                  <a:lnTo>
                    <a:pt x="2980" y="574"/>
                  </a:lnTo>
                  <a:lnTo>
                    <a:pt x="2981" y="573"/>
                  </a:lnTo>
                  <a:lnTo>
                    <a:pt x="2981" y="572"/>
                  </a:lnTo>
                  <a:lnTo>
                    <a:pt x="2982" y="570"/>
                  </a:lnTo>
                  <a:lnTo>
                    <a:pt x="2982" y="569"/>
                  </a:lnTo>
                  <a:lnTo>
                    <a:pt x="2983" y="568"/>
                  </a:lnTo>
                  <a:lnTo>
                    <a:pt x="2983" y="567"/>
                  </a:lnTo>
                  <a:lnTo>
                    <a:pt x="2984" y="565"/>
                  </a:lnTo>
                  <a:lnTo>
                    <a:pt x="2984" y="564"/>
                  </a:lnTo>
                  <a:lnTo>
                    <a:pt x="2985" y="563"/>
                  </a:lnTo>
                  <a:lnTo>
                    <a:pt x="2985" y="562"/>
                  </a:lnTo>
                  <a:lnTo>
                    <a:pt x="2986" y="561"/>
                  </a:lnTo>
                  <a:lnTo>
                    <a:pt x="2986" y="560"/>
                  </a:lnTo>
                  <a:lnTo>
                    <a:pt x="2987" y="559"/>
                  </a:lnTo>
                  <a:lnTo>
                    <a:pt x="2987" y="558"/>
                  </a:lnTo>
                  <a:lnTo>
                    <a:pt x="2988" y="557"/>
                  </a:lnTo>
                  <a:lnTo>
                    <a:pt x="2988" y="556"/>
                  </a:lnTo>
                  <a:lnTo>
                    <a:pt x="2989" y="555"/>
                  </a:lnTo>
                  <a:lnTo>
                    <a:pt x="2989" y="553"/>
                  </a:lnTo>
                  <a:lnTo>
                    <a:pt x="2989" y="552"/>
                  </a:lnTo>
                  <a:lnTo>
                    <a:pt x="2990" y="551"/>
                  </a:lnTo>
                  <a:lnTo>
                    <a:pt x="2991" y="550"/>
                  </a:lnTo>
                  <a:lnTo>
                    <a:pt x="2991" y="549"/>
                  </a:lnTo>
                  <a:lnTo>
                    <a:pt x="2992" y="548"/>
                  </a:lnTo>
                  <a:lnTo>
                    <a:pt x="2993" y="547"/>
                  </a:lnTo>
                  <a:lnTo>
                    <a:pt x="2994" y="547"/>
                  </a:lnTo>
                  <a:lnTo>
                    <a:pt x="2995" y="546"/>
                  </a:lnTo>
                  <a:lnTo>
                    <a:pt x="2995" y="547"/>
                  </a:lnTo>
                  <a:lnTo>
                    <a:pt x="2996" y="547"/>
                  </a:lnTo>
                  <a:lnTo>
                    <a:pt x="2997" y="548"/>
                  </a:lnTo>
                  <a:lnTo>
                    <a:pt x="2997" y="549"/>
                  </a:lnTo>
                  <a:lnTo>
                    <a:pt x="2998" y="550"/>
                  </a:lnTo>
                  <a:lnTo>
                    <a:pt x="2998" y="551"/>
                  </a:lnTo>
                  <a:lnTo>
                    <a:pt x="2999" y="553"/>
                  </a:lnTo>
                  <a:lnTo>
                    <a:pt x="2999" y="554"/>
                  </a:lnTo>
                  <a:lnTo>
                    <a:pt x="3000" y="556"/>
                  </a:lnTo>
                  <a:lnTo>
                    <a:pt x="3000" y="558"/>
                  </a:lnTo>
                  <a:lnTo>
                    <a:pt x="3001" y="561"/>
                  </a:lnTo>
                  <a:lnTo>
                    <a:pt x="3001" y="563"/>
                  </a:lnTo>
                  <a:lnTo>
                    <a:pt x="3002" y="566"/>
                  </a:lnTo>
                  <a:lnTo>
                    <a:pt x="3002" y="569"/>
                  </a:lnTo>
                  <a:lnTo>
                    <a:pt x="3003" y="572"/>
                  </a:lnTo>
                  <a:lnTo>
                    <a:pt x="3003" y="575"/>
                  </a:lnTo>
                  <a:lnTo>
                    <a:pt x="3004" y="578"/>
                  </a:lnTo>
                  <a:lnTo>
                    <a:pt x="3004" y="581"/>
                  </a:lnTo>
                  <a:lnTo>
                    <a:pt x="3005" y="584"/>
                  </a:lnTo>
                  <a:lnTo>
                    <a:pt x="3005" y="586"/>
                  </a:lnTo>
                  <a:lnTo>
                    <a:pt x="3006" y="589"/>
                  </a:lnTo>
                  <a:lnTo>
                    <a:pt x="3006" y="592"/>
                  </a:lnTo>
                  <a:lnTo>
                    <a:pt x="3006" y="594"/>
                  </a:lnTo>
                  <a:lnTo>
                    <a:pt x="3007" y="597"/>
                  </a:lnTo>
                  <a:lnTo>
                    <a:pt x="3007" y="599"/>
                  </a:lnTo>
                  <a:lnTo>
                    <a:pt x="3008" y="601"/>
                  </a:lnTo>
                  <a:lnTo>
                    <a:pt x="3008" y="603"/>
                  </a:lnTo>
                  <a:lnTo>
                    <a:pt x="3009" y="604"/>
                  </a:lnTo>
                  <a:lnTo>
                    <a:pt x="3009" y="606"/>
                  </a:lnTo>
                  <a:lnTo>
                    <a:pt x="3010" y="607"/>
                  </a:lnTo>
                  <a:lnTo>
                    <a:pt x="3011" y="608"/>
                  </a:lnTo>
                  <a:lnTo>
                    <a:pt x="3012" y="607"/>
                  </a:lnTo>
                  <a:lnTo>
                    <a:pt x="3012" y="606"/>
                  </a:lnTo>
                  <a:lnTo>
                    <a:pt x="3013" y="604"/>
                  </a:lnTo>
                  <a:lnTo>
                    <a:pt x="3013" y="602"/>
                  </a:lnTo>
                  <a:lnTo>
                    <a:pt x="3014" y="599"/>
                  </a:lnTo>
                  <a:lnTo>
                    <a:pt x="3014" y="596"/>
                  </a:lnTo>
                  <a:lnTo>
                    <a:pt x="3015" y="593"/>
                  </a:lnTo>
                  <a:lnTo>
                    <a:pt x="3015" y="590"/>
                  </a:lnTo>
                  <a:lnTo>
                    <a:pt x="3015" y="586"/>
                  </a:lnTo>
                  <a:lnTo>
                    <a:pt x="3016" y="582"/>
                  </a:lnTo>
                  <a:lnTo>
                    <a:pt x="3016" y="578"/>
                  </a:lnTo>
                  <a:lnTo>
                    <a:pt x="3017" y="574"/>
                  </a:lnTo>
                  <a:lnTo>
                    <a:pt x="3017" y="570"/>
                  </a:lnTo>
                  <a:lnTo>
                    <a:pt x="3018" y="566"/>
                  </a:lnTo>
                  <a:lnTo>
                    <a:pt x="3018" y="562"/>
                  </a:lnTo>
                  <a:lnTo>
                    <a:pt x="3019" y="558"/>
                  </a:lnTo>
                  <a:lnTo>
                    <a:pt x="3019" y="554"/>
                  </a:lnTo>
                  <a:lnTo>
                    <a:pt x="3020" y="550"/>
                  </a:lnTo>
                  <a:lnTo>
                    <a:pt x="3020" y="546"/>
                  </a:lnTo>
                  <a:lnTo>
                    <a:pt x="3021" y="542"/>
                  </a:lnTo>
                  <a:lnTo>
                    <a:pt x="3021" y="538"/>
                  </a:lnTo>
                  <a:lnTo>
                    <a:pt x="3022" y="535"/>
                  </a:lnTo>
                  <a:lnTo>
                    <a:pt x="3022" y="532"/>
                  </a:lnTo>
                  <a:lnTo>
                    <a:pt x="3023" y="529"/>
                  </a:lnTo>
                  <a:lnTo>
                    <a:pt x="3023" y="526"/>
                  </a:lnTo>
                  <a:lnTo>
                    <a:pt x="3023" y="524"/>
                  </a:lnTo>
                  <a:lnTo>
                    <a:pt x="3024" y="523"/>
                  </a:lnTo>
                  <a:lnTo>
                    <a:pt x="3024" y="522"/>
                  </a:lnTo>
                  <a:lnTo>
                    <a:pt x="3025" y="521"/>
                  </a:lnTo>
                  <a:lnTo>
                    <a:pt x="3026" y="521"/>
                  </a:lnTo>
                  <a:lnTo>
                    <a:pt x="3027" y="522"/>
                  </a:lnTo>
                  <a:lnTo>
                    <a:pt x="3027" y="523"/>
                  </a:lnTo>
                  <a:lnTo>
                    <a:pt x="3028" y="524"/>
                  </a:lnTo>
                  <a:lnTo>
                    <a:pt x="3028" y="525"/>
                  </a:lnTo>
                  <a:lnTo>
                    <a:pt x="3029" y="526"/>
                  </a:lnTo>
                  <a:lnTo>
                    <a:pt x="3029" y="527"/>
                  </a:lnTo>
                  <a:lnTo>
                    <a:pt x="3030" y="529"/>
                  </a:lnTo>
                  <a:lnTo>
                    <a:pt x="3030" y="530"/>
                  </a:lnTo>
                  <a:lnTo>
                    <a:pt x="3031" y="532"/>
                  </a:lnTo>
                  <a:lnTo>
                    <a:pt x="3031" y="533"/>
                  </a:lnTo>
                  <a:lnTo>
                    <a:pt x="3032" y="535"/>
                  </a:lnTo>
                  <a:lnTo>
                    <a:pt x="3032" y="537"/>
                  </a:lnTo>
                  <a:lnTo>
                    <a:pt x="3032" y="538"/>
                  </a:lnTo>
                  <a:lnTo>
                    <a:pt x="3033" y="540"/>
                  </a:lnTo>
                  <a:lnTo>
                    <a:pt x="3033" y="541"/>
                  </a:lnTo>
                  <a:lnTo>
                    <a:pt x="3034" y="543"/>
                  </a:lnTo>
                  <a:lnTo>
                    <a:pt x="3034" y="544"/>
                  </a:lnTo>
                  <a:lnTo>
                    <a:pt x="3035" y="546"/>
                  </a:lnTo>
                  <a:lnTo>
                    <a:pt x="3035" y="547"/>
                  </a:lnTo>
                  <a:lnTo>
                    <a:pt x="3036" y="547"/>
                  </a:lnTo>
                  <a:lnTo>
                    <a:pt x="3037" y="547"/>
                  </a:lnTo>
                  <a:lnTo>
                    <a:pt x="3038" y="547"/>
                  </a:lnTo>
                  <a:lnTo>
                    <a:pt x="3039" y="546"/>
                  </a:lnTo>
                  <a:lnTo>
                    <a:pt x="3040" y="546"/>
                  </a:lnTo>
                  <a:lnTo>
                    <a:pt x="3040" y="545"/>
                  </a:lnTo>
                  <a:lnTo>
                    <a:pt x="3041" y="544"/>
                  </a:lnTo>
                  <a:lnTo>
                    <a:pt x="3042" y="543"/>
                  </a:lnTo>
                  <a:lnTo>
                    <a:pt x="3043" y="543"/>
                  </a:lnTo>
                  <a:lnTo>
                    <a:pt x="3043" y="542"/>
                  </a:lnTo>
                  <a:lnTo>
                    <a:pt x="3044" y="542"/>
                  </a:lnTo>
                  <a:lnTo>
                    <a:pt x="3045" y="542"/>
                  </a:lnTo>
                  <a:lnTo>
                    <a:pt x="3045" y="543"/>
                  </a:lnTo>
                  <a:lnTo>
                    <a:pt x="3046" y="543"/>
                  </a:lnTo>
                  <a:lnTo>
                    <a:pt x="3046" y="544"/>
                  </a:lnTo>
                  <a:lnTo>
                    <a:pt x="3047" y="544"/>
                  </a:lnTo>
                  <a:lnTo>
                    <a:pt x="3047" y="545"/>
                  </a:lnTo>
                  <a:lnTo>
                    <a:pt x="3048" y="547"/>
                  </a:lnTo>
                  <a:lnTo>
                    <a:pt x="3048" y="549"/>
                  </a:lnTo>
                  <a:lnTo>
                    <a:pt x="3049" y="551"/>
                  </a:lnTo>
                  <a:lnTo>
                    <a:pt x="3049" y="553"/>
                  </a:lnTo>
                  <a:lnTo>
                    <a:pt x="3049" y="555"/>
                  </a:lnTo>
                  <a:lnTo>
                    <a:pt x="3050" y="558"/>
                  </a:lnTo>
                  <a:lnTo>
                    <a:pt x="3050" y="560"/>
                  </a:lnTo>
                  <a:lnTo>
                    <a:pt x="3051" y="563"/>
                  </a:lnTo>
                  <a:lnTo>
                    <a:pt x="3051" y="566"/>
                  </a:lnTo>
                  <a:lnTo>
                    <a:pt x="3052" y="569"/>
                  </a:lnTo>
                  <a:lnTo>
                    <a:pt x="3052" y="571"/>
                  </a:lnTo>
                  <a:lnTo>
                    <a:pt x="3053" y="574"/>
                  </a:lnTo>
                  <a:lnTo>
                    <a:pt x="3053" y="577"/>
                  </a:lnTo>
                  <a:lnTo>
                    <a:pt x="3054" y="580"/>
                  </a:lnTo>
                  <a:lnTo>
                    <a:pt x="3054" y="583"/>
                  </a:lnTo>
                  <a:lnTo>
                    <a:pt x="3055" y="585"/>
                  </a:lnTo>
                  <a:lnTo>
                    <a:pt x="3055" y="588"/>
                  </a:lnTo>
                  <a:lnTo>
                    <a:pt x="3056" y="590"/>
                  </a:lnTo>
                  <a:lnTo>
                    <a:pt x="3056" y="593"/>
                  </a:lnTo>
                  <a:lnTo>
                    <a:pt x="3057" y="595"/>
                  </a:lnTo>
                  <a:lnTo>
                    <a:pt x="3057" y="597"/>
                  </a:lnTo>
                  <a:lnTo>
                    <a:pt x="3057" y="599"/>
                  </a:lnTo>
                  <a:lnTo>
                    <a:pt x="3058" y="601"/>
                  </a:lnTo>
                  <a:lnTo>
                    <a:pt x="3058" y="603"/>
                  </a:lnTo>
                  <a:lnTo>
                    <a:pt x="3059" y="604"/>
                  </a:lnTo>
                  <a:lnTo>
                    <a:pt x="3059" y="605"/>
                  </a:lnTo>
                  <a:lnTo>
                    <a:pt x="3060" y="605"/>
                  </a:lnTo>
                  <a:lnTo>
                    <a:pt x="3060" y="606"/>
                  </a:lnTo>
                  <a:lnTo>
                    <a:pt x="3061" y="606"/>
                  </a:lnTo>
                  <a:lnTo>
                    <a:pt x="3062" y="605"/>
                  </a:lnTo>
                  <a:lnTo>
                    <a:pt x="3063" y="605"/>
                  </a:lnTo>
                  <a:lnTo>
                    <a:pt x="3063" y="604"/>
                  </a:lnTo>
                  <a:lnTo>
                    <a:pt x="3064" y="603"/>
                  </a:lnTo>
                  <a:lnTo>
                    <a:pt x="3064" y="602"/>
                  </a:lnTo>
                  <a:lnTo>
                    <a:pt x="3065" y="601"/>
                  </a:lnTo>
                  <a:lnTo>
                    <a:pt x="3065" y="600"/>
                  </a:lnTo>
                  <a:lnTo>
                    <a:pt x="3066" y="599"/>
                  </a:lnTo>
                  <a:lnTo>
                    <a:pt x="3066" y="598"/>
                  </a:lnTo>
                  <a:lnTo>
                    <a:pt x="3066" y="596"/>
                  </a:lnTo>
                  <a:lnTo>
                    <a:pt x="3067" y="595"/>
                  </a:lnTo>
                  <a:lnTo>
                    <a:pt x="3067" y="594"/>
                  </a:lnTo>
                  <a:lnTo>
                    <a:pt x="3068" y="592"/>
                  </a:lnTo>
                  <a:lnTo>
                    <a:pt x="3068" y="591"/>
                  </a:lnTo>
                  <a:lnTo>
                    <a:pt x="3069" y="590"/>
                  </a:lnTo>
                  <a:lnTo>
                    <a:pt x="3069" y="588"/>
                  </a:lnTo>
                  <a:lnTo>
                    <a:pt x="3070" y="587"/>
                  </a:lnTo>
                  <a:lnTo>
                    <a:pt x="3070" y="586"/>
                  </a:lnTo>
                  <a:lnTo>
                    <a:pt x="3071" y="585"/>
                  </a:lnTo>
                  <a:lnTo>
                    <a:pt x="3071" y="584"/>
                  </a:lnTo>
                  <a:lnTo>
                    <a:pt x="3072" y="583"/>
                  </a:lnTo>
                  <a:lnTo>
                    <a:pt x="3072" y="582"/>
                  </a:lnTo>
                  <a:lnTo>
                    <a:pt x="3073" y="581"/>
                  </a:lnTo>
                  <a:lnTo>
                    <a:pt x="3074" y="580"/>
                  </a:lnTo>
                  <a:lnTo>
                    <a:pt x="3074" y="579"/>
                  </a:lnTo>
                  <a:lnTo>
                    <a:pt x="3075" y="579"/>
                  </a:lnTo>
                  <a:lnTo>
                    <a:pt x="3075" y="578"/>
                  </a:lnTo>
                  <a:lnTo>
                    <a:pt x="3076" y="578"/>
                  </a:lnTo>
                  <a:lnTo>
                    <a:pt x="3077" y="578"/>
                  </a:lnTo>
                  <a:lnTo>
                    <a:pt x="3077" y="577"/>
                  </a:lnTo>
                  <a:lnTo>
                    <a:pt x="3078" y="577"/>
                  </a:lnTo>
                  <a:lnTo>
                    <a:pt x="3079" y="577"/>
                  </a:lnTo>
                  <a:lnTo>
                    <a:pt x="3080" y="576"/>
                  </a:lnTo>
                  <a:lnTo>
                    <a:pt x="3081" y="576"/>
                  </a:lnTo>
                  <a:lnTo>
                    <a:pt x="3082" y="576"/>
                  </a:lnTo>
                  <a:lnTo>
                    <a:pt x="3083" y="575"/>
                  </a:lnTo>
                  <a:lnTo>
                    <a:pt x="3084" y="574"/>
                  </a:lnTo>
                  <a:lnTo>
                    <a:pt x="3085" y="573"/>
                  </a:lnTo>
                  <a:lnTo>
                    <a:pt x="3086" y="573"/>
                  </a:lnTo>
                  <a:lnTo>
                    <a:pt x="3086" y="572"/>
                  </a:lnTo>
                  <a:lnTo>
                    <a:pt x="3087" y="572"/>
                  </a:lnTo>
                  <a:lnTo>
                    <a:pt x="3087" y="571"/>
                  </a:lnTo>
                  <a:lnTo>
                    <a:pt x="3088" y="571"/>
                  </a:lnTo>
                  <a:lnTo>
                    <a:pt x="3088" y="570"/>
                  </a:lnTo>
                  <a:lnTo>
                    <a:pt x="3089" y="570"/>
                  </a:lnTo>
                  <a:lnTo>
                    <a:pt x="3089" y="569"/>
                  </a:lnTo>
                  <a:lnTo>
                    <a:pt x="3090" y="569"/>
                  </a:lnTo>
                  <a:lnTo>
                    <a:pt x="3090" y="568"/>
                  </a:lnTo>
                  <a:lnTo>
                    <a:pt x="3091" y="568"/>
                  </a:lnTo>
                  <a:lnTo>
                    <a:pt x="3092" y="567"/>
                  </a:lnTo>
                  <a:lnTo>
                    <a:pt x="3092" y="566"/>
                  </a:lnTo>
                  <a:lnTo>
                    <a:pt x="3093" y="566"/>
                  </a:lnTo>
                  <a:lnTo>
                    <a:pt x="3094" y="565"/>
                  </a:lnTo>
                  <a:lnTo>
                    <a:pt x="3095" y="565"/>
                  </a:lnTo>
                  <a:lnTo>
                    <a:pt x="3095" y="564"/>
                  </a:lnTo>
                  <a:lnTo>
                    <a:pt x="3096" y="564"/>
                  </a:lnTo>
                  <a:lnTo>
                    <a:pt x="3097" y="564"/>
                  </a:lnTo>
                  <a:lnTo>
                    <a:pt x="3097" y="563"/>
                  </a:lnTo>
                  <a:lnTo>
                    <a:pt x="3098" y="563"/>
                  </a:lnTo>
                  <a:lnTo>
                    <a:pt x="3099" y="563"/>
                  </a:lnTo>
                  <a:lnTo>
                    <a:pt x="3100" y="562"/>
                  </a:lnTo>
                  <a:lnTo>
                    <a:pt x="3101" y="562"/>
                  </a:lnTo>
                  <a:lnTo>
                    <a:pt x="3102" y="562"/>
                  </a:lnTo>
                  <a:lnTo>
                    <a:pt x="3103" y="562"/>
                  </a:lnTo>
                  <a:lnTo>
                    <a:pt x="3104" y="562"/>
                  </a:lnTo>
                  <a:lnTo>
                    <a:pt x="3105" y="562"/>
                  </a:lnTo>
                  <a:lnTo>
                    <a:pt x="3106" y="562"/>
                  </a:lnTo>
                  <a:lnTo>
                    <a:pt x="3107" y="562"/>
                  </a:lnTo>
                  <a:lnTo>
                    <a:pt x="3108" y="562"/>
                  </a:lnTo>
                  <a:lnTo>
                    <a:pt x="3109" y="562"/>
                  </a:lnTo>
                  <a:lnTo>
                    <a:pt x="3110" y="562"/>
                  </a:lnTo>
                  <a:lnTo>
                    <a:pt x="3111" y="562"/>
                  </a:lnTo>
                  <a:lnTo>
                    <a:pt x="3112" y="562"/>
                  </a:lnTo>
                  <a:lnTo>
                    <a:pt x="3113" y="562"/>
                  </a:lnTo>
                  <a:lnTo>
                    <a:pt x="3114" y="562"/>
                  </a:lnTo>
                  <a:lnTo>
                    <a:pt x="3115" y="562"/>
                  </a:lnTo>
                  <a:lnTo>
                    <a:pt x="3116" y="562"/>
                  </a:lnTo>
                  <a:lnTo>
                    <a:pt x="3117" y="562"/>
                  </a:lnTo>
                  <a:lnTo>
                    <a:pt x="3118" y="562"/>
                  </a:lnTo>
                  <a:lnTo>
                    <a:pt x="3119" y="561"/>
                  </a:lnTo>
                  <a:lnTo>
                    <a:pt x="3120" y="561"/>
                  </a:lnTo>
                  <a:lnTo>
                    <a:pt x="3121" y="561"/>
                  </a:lnTo>
                  <a:lnTo>
                    <a:pt x="3121" y="560"/>
                  </a:lnTo>
                  <a:lnTo>
                    <a:pt x="3122" y="560"/>
                  </a:lnTo>
                  <a:lnTo>
                    <a:pt x="3123" y="559"/>
                  </a:lnTo>
                  <a:lnTo>
                    <a:pt x="3124" y="559"/>
                  </a:lnTo>
                  <a:lnTo>
                    <a:pt x="3124" y="558"/>
                  </a:lnTo>
                  <a:lnTo>
                    <a:pt x="3125" y="558"/>
                  </a:lnTo>
                  <a:lnTo>
                    <a:pt x="3125" y="557"/>
                  </a:lnTo>
                  <a:lnTo>
                    <a:pt x="3126" y="557"/>
                  </a:lnTo>
                  <a:lnTo>
                    <a:pt x="3126" y="556"/>
                  </a:lnTo>
                  <a:lnTo>
                    <a:pt x="3127" y="556"/>
                  </a:lnTo>
                  <a:lnTo>
                    <a:pt x="3127" y="555"/>
                  </a:lnTo>
                  <a:lnTo>
                    <a:pt x="3128" y="555"/>
                  </a:lnTo>
                  <a:lnTo>
                    <a:pt x="3128" y="554"/>
                  </a:lnTo>
                  <a:lnTo>
                    <a:pt x="3129" y="554"/>
                  </a:lnTo>
                  <a:lnTo>
                    <a:pt x="3129" y="553"/>
                  </a:lnTo>
                  <a:lnTo>
                    <a:pt x="3130" y="553"/>
                  </a:lnTo>
                  <a:lnTo>
                    <a:pt x="3130" y="552"/>
                  </a:lnTo>
                  <a:lnTo>
                    <a:pt x="3131" y="552"/>
                  </a:lnTo>
                  <a:lnTo>
                    <a:pt x="3131" y="551"/>
                  </a:lnTo>
                  <a:lnTo>
                    <a:pt x="3132" y="551"/>
                  </a:lnTo>
                  <a:lnTo>
                    <a:pt x="3132" y="550"/>
                  </a:lnTo>
                  <a:lnTo>
                    <a:pt x="3133" y="549"/>
                  </a:lnTo>
                  <a:lnTo>
                    <a:pt x="3134" y="548"/>
                  </a:lnTo>
                  <a:lnTo>
                    <a:pt x="3134" y="547"/>
                  </a:lnTo>
                  <a:lnTo>
                    <a:pt x="3135" y="547"/>
                  </a:lnTo>
                  <a:lnTo>
                    <a:pt x="3135" y="546"/>
                  </a:lnTo>
                  <a:lnTo>
                    <a:pt x="3136" y="545"/>
                  </a:lnTo>
                  <a:lnTo>
                    <a:pt x="3137" y="544"/>
                  </a:lnTo>
                  <a:lnTo>
                    <a:pt x="3138" y="543"/>
                  </a:lnTo>
                  <a:lnTo>
                    <a:pt x="3139" y="542"/>
                  </a:lnTo>
                  <a:lnTo>
                    <a:pt x="3140" y="541"/>
                  </a:lnTo>
                  <a:lnTo>
                    <a:pt x="3141" y="540"/>
                  </a:lnTo>
                  <a:lnTo>
                    <a:pt x="3142" y="539"/>
                  </a:lnTo>
                  <a:lnTo>
                    <a:pt x="3143" y="538"/>
                  </a:lnTo>
                  <a:lnTo>
                    <a:pt x="3143" y="537"/>
                  </a:lnTo>
                  <a:lnTo>
                    <a:pt x="3144" y="537"/>
                  </a:lnTo>
                  <a:lnTo>
                    <a:pt x="3145" y="536"/>
                  </a:lnTo>
                  <a:lnTo>
                    <a:pt x="3146" y="536"/>
                  </a:lnTo>
                  <a:lnTo>
                    <a:pt x="3146" y="535"/>
                  </a:lnTo>
                  <a:lnTo>
                    <a:pt x="3147" y="535"/>
                  </a:lnTo>
                  <a:lnTo>
                    <a:pt x="3148" y="534"/>
                  </a:lnTo>
                  <a:lnTo>
                    <a:pt x="3149" y="534"/>
                  </a:lnTo>
                  <a:lnTo>
                    <a:pt x="3149" y="533"/>
                  </a:lnTo>
                  <a:lnTo>
                    <a:pt x="3150" y="533"/>
                  </a:lnTo>
                  <a:lnTo>
                    <a:pt x="3151" y="533"/>
                  </a:lnTo>
                  <a:lnTo>
                    <a:pt x="3152" y="532"/>
                  </a:lnTo>
                  <a:lnTo>
                    <a:pt x="3153" y="532"/>
                  </a:lnTo>
                  <a:lnTo>
                    <a:pt x="3154" y="531"/>
                  </a:lnTo>
                  <a:lnTo>
                    <a:pt x="3155" y="531"/>
                  </a:lnTo>
                  <a:lnTo>
                    <a:pt x="3156" y="531"/>
                  </a:lnTo>
                  <a:lnTo>
                    <a:pt x="3157" y="530"/>
                  </a:lnTo>
                  <a:lnTo>
                    <a:pt x="3158" y="530"/>
                  </a:lnTo>
                  <a:lnTo>
                    <a:pt x="3159" y="530"/>
                  </a:lnTo>
                  <a:lnTo>
                    <a:pt x="3160" y="530"/>
                  </a:lnTo>
                  <a:lnTo>
                    <a:pt x="3160" y="529"/>
                  </a:lnTo>
                  <a:lnTo>
                    <a:pt x="3161" y="529"/>
                  </a:lnTo>
                  <a:lnTo>
                    <a:pt x="3162" y="529"/>
                  </a:lnTo>
                  <a:lnTo>
                    <a:pt x="3162" y="528"/>
                  </a:lnTo>
                  <a:lnTo>
                    <a:pt x="3163" y="528"/>
                  </a:lnTo>
                  <a:lnTo>
                    <a:pt x="3164" y="528"/>
                  </a:lnTo>
                  <a:lnTo>
                    <a:pt x="3164" y="527"/>
                  </a:lnTo>
                  <a:lnTo>
                    <a:pt x="3165" y="527"/>
                  </a:lnTo>
                  <a:lnTo>
                    <a:pt x="3166" y="527"/>
                  </a:lnTo>
                  <a:lnTo>
                    <a:pt x="3166" y="526"/>
                  </a:lnTo>
                  <a:lnTo>
                    <a:pt x="3167" y="526"/>
                  </a:lnTo>
                  <a:lnTo>
                    <a:pt x="3168" y="525"/>
                  </a:lnTo>
                  <a:lnTo>
                    <a:pt x="3169" y="525"/>
                  </a:lnTo>
                  <a:lnTo>
                    <a:pt x="3169" y="524"/>
                  </a:lnTo>
                  <a:lnTo>
                    <a:pt x="3170" y="524"/>
                  </a:lnTo>
                  <a:lnTo>
                    <a:pt x="3170" y="523"/>
                  </a:lnTo>
                  <a:lnTo>
                    <a:pt x="3171" y="523"/>
                  </a:lnTo>
                  <a:lnTo>
                    <a:pt x="3171" y="522"/>
                  </a:lnTo>
                  <a:lnTo>
                    <a:pt x="3172" y="522"/>
                  </a:lnTo>
                  <a:lnTo>
                    <a:pt x="3173" y="521"/>
                  </a:lnTo>
                  <a:lnTo>
                    <a:pt x="3174" y="520"/>
                  </a:lnTo>
                  <a:lnTo>
                    <a:pt x="3175" y="520"/>
                  </a:lnTo>
                  <a:lnTo>
                    <a:pt x="3175" y="519"/>
                  </a:lnTo>
                  <a:lnTo>
                    <a:pt x="3176" y="519"/>
                  </a:lnTo>
                  <a:lnTo>
                    <a:pt x="3177" y="518"/>
                  </a:lnTo>
                  <a:lnTo>
                    <a:pt x="3178" y="517"/>
                  </a:lnTo>
                  <a:lnTo>
                    <a:pt x="3179" y="517"/>
                  </a:lnTo>
                  <a:lnTo>
                    <a:pt x="3179" y="516"/>
                  </a:lnTo>
                  <a:lnTo>
                    <a:pt x="3180" y="516"/>
                  </a:lnTo>
                  <a:lnTo>
                    <a:pt x="3181" y="516"/>
                  </a:lnTo>
                  <a:lnTo>
                    <a:pt x="3182" y="515"/>
                  </a:lnTo>
                  <a:lnTo>
                    <a:pt x="3183" y="515"/>
                  </a:lnTo>
                  <a:lnTo>
                    <a:pt x="3184" y="515"/>
                  </a:lnTo>
                  <a:lnTo>
                    <a:pt x="3184" y="514"/>
                  </a:lnTo>
                  <a:lnTo>
                    <a:pt x="3185" y="514"/>
                  </a:lnTo>
                  <a:lnTo>
                    <a:pt x="3186" y="514"/>
                  </a:lnTo>
                  <a:lnTo>
                    <a:pt x="3187" y="514"/>
                  </a:lnTo>
                  <a:lnTo>
                    <a:pt x="3188" y="514"/>
                  </a:lnTo>
                  <a:lnTo>
                    <a:pt x="3188" y="513"/>
                  </a:lnTo>
                  <a:lnTo>
                    <a:pt x="3189" y="513"/>
                  </a:lnTo>
                  <a:lnTo>
                    <a:pt x="3190" y="513"/>
                  </a:lnTo>
                  <a:lnTo>
                    <a:pt x="3191" y="513"/>
                  </a:lnTo>
                  <a:lnTo>
                    <a:pt x="3192" y="513"/>
                  </a:lnTo>
                  <a:lnTo>
                    <a:pt x="3193" y="513"/>
                  </a:lnTo>
                  <a:lnTo>
                    <a:pt x="3194" y="513"/>
                  </a:lnTo>
                  <a:lnTo>
                    <a:pt x="3195" y="513"/>
                  </a:lnTo>
                  <a:lnTo>
                    <a:pt x="3196" y="513"/>
                  </a:lnTo>
                  <a:lnTo>
                    <a:pt x="3197" y="513"/>
                  </a:lnTo>
                  <a:lnTo>
                    <a:pt x="3198" y="513"/>
                  </a:lnTo>
                  <a:lnTo>
                    <a:pt x="3199" y="512"/>
                  </a:lnTo>
                  <a:lnTo>
                    <a:pt x="3200" y="512"/>
                  </a:lnTo>
                  <a:lnTo>
                    <a:pt x="3201" y="512"/>
                  </a:lnTo>
                  <a:lnTo>
                    <a:pt x="3202" y="511"/>
                  </a:lnTo>
                  <a:lnTo>
                    <a:pt x="3203" y="511"/>
                  </a:lnTo>
                  <a:lnTo>
                    <a:pt x="3203" y="510"/>
                  </a:lnTo>
                  <a:lnTo>
                    <a:pt x="3204" y="510"/>
                  </a:lnTo>
                  <a:lnTo>
                    <a:pt x="3205" y="509"/>
                  </a:lnTo>
                  <a:lnTo>
                    <a:pt x="3206" y="509"/>
                  </a:lnTo>
                  <a:lnTo>
                    <a:pt x="3207" y="508"/>
                  </a:lnTo>
                  <a:lnTo>
                    <a:pt x="3208" y="508"/>
                  </a:lnTo>
                  <a:lnTo>
                    <a:pt x="3209" y="508"/>
                  </a:lnTo>
                  <a:lnTo>
                    <a:pt x="3209" y="507"/>
                  </a:lnTo>
                  <a:lnTo>
                    <a:pt x="3210" y="507"/>
                  </a:lnTo>
                  <a:lnTo>
                    <a:pt x="3211" y="507"/>
                  </a:lnTo>
                  <a:lnTo>
                    <a:pt x="3212" y="507"/>
                  </a:lnTo>
                  <a:lnTo>
                    <a:pt x="3213" y="507"/>
                  </a:lnTo>
                  <a:lnTo>
                    <a:pt x="3213" y="508"/>
                  </a:lnTo>
                  <a:lnTo>
                    <a:pt x="3214" y="508"/>
                  </a:lnTo>
                  <a:lnTo>
                    <a:pt x="3215" y="509"/>
                  </a:lnTo>
                  <a:lnTo>
                    <a:pt x="3216" y="509"/>
                  </a:lnTo>
                  <a:lnTo>
                    <a:pt x="3216" y="510"/>
                  </a:lnTo>
                  <a:lnTo>
                    <a:pt x="3217" y="510"/>
                  </a:lnTo>
                  <a:lnTo>
                    <a:pt x="3217" y="511"/>
                  </a:lnTo>
                  <a:lnTo>
                    <a:pt x="3218" y="511"/>
                  </a:lnTo>
                  <a:lnTo>
                    <a:pt x="3219" y="512"/>
                  </a:lnTo>
                  <a:lnTo>
                    <a:pt x="3220" y="513"/>
                  </a:lnTo>
                  <a:lnTo>
                    <a:pt x="3220" y="514"/>
                  </a:lnTo>
                  <a:lnTo>
                    <a:pt x="3221" y="514"/>
                  </a:lnTo>
                  <a:lnTo>
                    <a:pt x="3222" y="515"/>
                  </a:lnTo>
                  <a:lnTo>
                    <a:pt x="3223" y="516"/>
                  </a:lnTo>
                  <a:lnTo>
                    <a:pt x="3224" y="516"/>
                  </a:lnTo>
                  <a:lnTo>
                    <a:pt x="3225" y="516"/>
                  </a:lnTo>
                  <a:lnTo>
                    <a:pt x="3225" y="517"/>
                  </a:lnTo>
                  <a:lnTo>
                    <a:pt x="3226" y="517"/>
                  </a:lnTo>
                  <a:lnTo>
                    <a:pt x="3227" y="517"/>
                  </a:lnTo>
                  <a:lnTo>
                    <a:pt x="3228" y="516"/>
                  </a:lnTo>
                  <a:lnTo>
                    <a:pt x="3229" y="516"/>
                  </a:lnTo>
                  <a:lnTo>
                    <a:pt x="3230" y="515"/>
                  </a:lnTo>
                  <a:lnTo>
                    <a:pt x="3231" y="515"/>
                  </a:lnTo>
                  <a:lnTo>
                    <a:pt x="3232" y="514"/>
                  </a:lnTo>
                  <a:lnTo>
                    <a:pt x="3233" y="514"/>
                  </a:lnTo>
                  <a:lnTo>
                    <a:pt x="3233" y="513"/>
                  </a:lnTo>
                  <a:lnTo>
                    <a:pt x="3234" y="513"/>
                  </a:lnTo>
                  <a:lnTo>
                    <a:pt x="3234" y="512"/>
                  </a:lnTo>
                  <a:lnTo>
                    <a:pt x="3235" y="512"/>
                  </a:lnTo>
                  <a:lnTo>
                    <a:pt x="3235" y="511"/>
                  </a:lnTo>
                  <a:lnTo>
                    <a:pt x="3236" y="511"/>
                  </a:lnTo>
                  <a:lnTo>
                    <a:pt x="3236" y="510"/>
                  </a:lnTo>
                  <a:lnTo>
                    <a:pt x="3237" y="510"/>
                  </a:lnTo>
                  <a:lnTo>
                    <a:pt x="3237" y="509"/>
                  </a:lnTo>
                  <a:lnTo>
                    <a:pt x="3238" y="508"/>
                  </a:lnTo>
                  <a:lnTo>
                    <a:pt x="3239" y="507"/>
                  </a:lnTo>
                  <a:lnTo>
                    <a:pt x="3240" y="506"/>
                  </a:lnTo>
                  <a:lnTo>
                    <a:pt x="3241" y="505"/>
                  </a:lnTo>
                  <a:lnTo>
                    <a:pt x="3242" y="504"/>
                  </a:lnTo>
                  <a:lnTo>
                    <a:pt x="3242" y="503"/>
                  </a:lnTo>
                  <a:lnTo>
                    <a:pt x="3243" y="503"/>
                  </a:lnTo>
                  <a:lnTo>
                    <a:pt x="3243" y="502"/>
                  </a:lnTo>
                  <a:lnTo>
                    <a:pt x="3244" y="502"/>
                  </a:lnTo>
                  <a:lnTo>
                    <a:pt x="3244" y="501"/>
                  </a:lnTo>
                  <a:lnTo>
                    <a:pt x="3245" y="501"/>
                  </a:lnTo>
                  <a:lnTo>
                    <a:pt x="3245" y="500"/>
                  </a:lnTo>
                  <a:lnTo>
                    <a:pt x="3246" y="499"/>
                  </a:lnTo>
                  <a:lnTo>
                    <a:pt x="3246" y="498"/>
                  </a:lnTo>
                  <a:lnTo>
                    <a:pt x="3247" y="498"/>
                  </a:lnTo>
                  <a:lnTo>
                    <a:pt x="3247" y="497"/>
                  </a:lnTo>
                  <a:lnTo>
                    <a:pt x="3248" y="497"/>
                  </a:lnTo>
                  <a:lnTo>
                    <a:pt x="3248" y="496"/>
                  </a:lnTo>
                  <a:lnTo>
                    <a:pt x="3249" y="496"/>
                  </a:lnTo>
                  <a:lnTo>
                    <a:pt x="3249" y="495"/>
                  </a:lnTo>
                  <a:lnTo>
                    <a:pt x="3250" y="495"/>
                  </a:lnTo>
                  <a:lnTo>
                    <a:pt x="3250" y="494"/>
                  </a:lnTo>
                  <a:lnTo>
                    <a:pt x="3251" y="493"/>
                  </a:lnTo>
                  <a:lnTo>
                    <a:pt x="3252" y="493"/>
                  </a:lnTo>
                  <a:lnTo>
                    <a:pt x="3252" y="492"/>
                  </a:lnTo>
                  <a:lnTo>
                    <a:pt x="3253" y="492"/>
                  </a:lnTo>
                  <a:lnTo>
                    <a:pt x="3253" y="491"/>
                  </a:lnTo>
                  <a:lnTo>
                    <a:pt x="3254" y="491"/>
                  </a:lnTo>
                  <a:lnTo>
                    <a:pt x="3254" y="490"/>
                  </a:lnTo>
                  <a:lnTo>
                    <a:pt x="3255" y="490"/>
                  </a:lnTo>
                  <a:lnTo>
                    <a:pt x="3255" y="489"/>
                  </a:lnTo>
                  <a:lnTo>
                    <a:pt x="3256" y="489"/>
                  </a:lnTo>
                  <a:lnTo>
                    <a:pt x="3257" y="489"/>
                  </a:lnTo>
                  <a:lnTo>
                    <a:pt x="3257" y="488"/>
                  </a:lnTo>
                  <a:lnTo>
                    <a:pt x="3258" y="488"/>
                  </a:lnTo>
                  <a:lnTo>
                    <a:pt x="3259" y="488"/>
                  </a:lnTo>
                  <a:lnTo>
                    <a:pt x="3260" y="488"/>
                  </a:lnTo>
                  <a:lnTo>
                    <a:pt x="3261" y="488"/>
                  </a:lnTo>
                  <a:lnTo>
                    <a:pt x="3262" y="488"/>
                  </a:lnTo>
                  <a:lnTo>
                    <a:pt x="3263" y="488"/>
                  </a:lnTo>
                  <a:lnTo>
                    <a:pt x="3264" y="489"/>
                  </a:lnTo>
                  <a:lnTo>
                    <a:pt x="3265" y="489"/>
                  </a:lnTo>
                  <a:lnTo>
                    <a:pt x="3266" y="489"/>
                  </a:lnTo>
                  <a:lnTo>
                    <a:pt x="3266" y="490"/>
                  </a:lnTo>
                  <a:lnTo>
                    <a:pt x="3267" y="490"/>
                  </a:lnTo>
                  <a:lnTo>
                    <a:pt x="3268" y="490"/>
                  </a:lnTo>
                  <a:lnTo>
                    <a:pt x="3268" y="491"/>
                  </a:lnTo>
                  <a:lnTo>
                    <a:pt x="3269" y="491"/>
                  </a:lnTo>
                  <a:lnTo>
                    <a:pt x="3270" y="491"/>
                  </a:lnTo>
                  <a:lnTo>
                    <a:pt x="3270" y="492"/>
                  </a:lnTo>
                  <a:lnTo>
                    <a:pt x="3271" y="492"/>
                  </a:lnTo>
                  <a:lnTo>
                    <a:pt x="3272" y="492"/>
                  </a:lnTo>
                  <a:lnTo>
                    <a:pt x="3273" y="492"/>
                  </a:lnTo>
                  <a:lnTo>
                    <a:pt x="3274" y="493"/>
                  </a:lnTo>
                  <a:lnTo>
                    <a:pt x="3275" y="493"/>
                  </a:lnTo>
                  <a:lnTo>
                    <a:pt x="3276" y="493"/>
                  </a:lnTo>
                  <a:lnTo>
                    <a:pt x="3277" y="493"/>
                  </a:lnTo>
                  <a:lnTo>
                    <a:pt x="3278" y="493"/>
                  </a:lnTo>
                  <a:lnTo>
                    <a:pt x="3279" y="492"/>
                  </a:lnTo>
                  <a:lnTo>
                    <a:pt x="3280" y="492"/>
                  </a:lnTo>
                  <a:lnTo>
                    <a:pt x="3281" y="492"/>
                  </a:lnTo>
                  <a:lnTo>
                    <a:pt x="3282" y="492"/>
                  </a:lnTo>
                  <a:lnTo>
                    <a:pt x="3283" y="492"/>
                  </a:lnTo>
                  <a:lnTo>
                    <a:pt x="3284" y="492"/>
                  </a:lnTo>
                  <a:lnTo>
                    <a:pt x="3285" y="492"/>
                  </a:lnTo>
                  <a:lnTo>
                    <a:pt x="3286" y="492"/>
                  </a:lnTo>
                  <a:lnTo>
                    <a:pt x="3287" y="493"/>
                  </a:lnTo>
                  <a:lnTo>
                    <a:pt x="3288" y="493"/>
                  </a:lnTo>
                  <a:lnTo>
                    <a:pt x="3289" y="493"/>
                  </a:lnTo>
                  <a:lnTo>
                    <a:pt x="3290" y="493"/>
                  </a:lnTo>
                  <a:lnTo>
                    <a:pt x="3291" y="493"/>
                  </a:lnTo>
                  <a:lnTo>
                    <a:pt x="3292" y="493"/>
                  </a:lnTo>
                  <a:lnTo>
                    <a:pt x="3293" y="493"/>
                  </a:lnTo>
                  <a:lnTo>
                    <a:pt x="3294" y="493"/>
                  </a:lnTo>
                  <a:lnTo>
                    <a:pt x="3294" y="492"/>
                  </a:lnTo>
                  <a:lnTo>
                    <a:pt x="3295" y="492"/>
                  </a:lnTo>
                  <a:lnTo>
                    <a:pt x="3296" y="492"/>
                  </a:lnTo>
                  <a:lnTo>
                    <a:pt x="3297" y="491"/>
                  </a:lnTo>
                  <a:lnTo>
                    <a:pt x="3298" y="490"/>
                  </a:lnTo>
                  <a:lnTo>
                    <a:pt x="3299" y="489"/>
                  </a:lnTo>
                  <a:lnTo>
                    <a:pt x="3300" y="489"/>
                  </a:lnTo>
                  <a:lnTo>
                    <a:pt x="3300" y="488"/>
                  </a:lnTo>
                  <a:lnTo>
                    <a:pt x="3301" y="488"/>
                  </a:lnTo>
                  <a:lnTo>
                    <a:pt x="3301" y="487"/>
                  </a:lnTo>
                  <a:lnTo>
                    <a:pt x="3302" y="487"/>
                  </a:lnTo>
                  <a:lnTo>
                    <a:pt x="3303" y="486"/>
                  </a:lnTo>
                  <a:lnTo>
                    <a:pt x="3304" y="485"/>
                  </a:lnTo>
                  <a:lnTo>
                    <a:pt x="3305" y="485"/>
                  </a:lnTo>
                  <a:lnTo>
                    <a:pt x="3305" y="484"/>
                  </a:lnTo>
                  <a:lnTo>
                    <a:pt x="3306" y="484"/>
                  </a:lnTo>
                  <a:lnTo>
                    <a:pt x="3306" y="483"/>
                  </a:lnTo>
                  <a:lnTo>
                    <a:pt x="3307" y="483"/>
                  </a:lnTo>
                  <a:lnTo>
                    <a:pt x="3308" y="483"/>
                  </a:lnTo>
                  <a:lnTo>
                    <a:pt x="3309" y="482"/>
                  </a:lnTo>
                  <a:lnTo>
                    <a:pt x="3310" y="482"/>
                  </a:lnTo>
                  <a:lnTo>
                    <a:pt x="3311" y="482"/>
                  </a:lnTo>
                  <a:lnTo>
                    <a:pt x="3312" y="482"/>
                  </a:lnTo>
                  <a:lnTo>
                    <a:pt x="3313" y="482"/>
                  </a:lnTo>
                  <a:lnTo>
                    <a:pt x="3314" y="482"/>
                  </a:lnTo>
                  <a:lnTo>
                    <a:pt x="3315" y="482"/>
                  </a:lnTo>
                  <a:lnTo>
                    <a:pt x="3316" y="483"/>
                  </a:lnTo>
                  <a:lnTo>
                    <a:pt x="3317" y="483"/>
                  </a:lnTo>
                  <a:lnTo>
                    <a:pt x="3318" y="483"/>
                  </a:lnTo>
                  <a:lnTo>
                    <a:pt x="3319" y="483"/>
                  </a:lnTo>
                  <a:lnTo>
                    <a:pt x="3320" y="483"/>
                  </a:lnTo>
                  <a:lnTo>
                    <a:pt x="3321" y="483"/>
                  </a:lnTo>
                  <a:lnTo>
                    <a:pt x="3322" y="483"/>
                  </a:lnTo>
                  <a:lnTo>
                    <a:pt x="3323" y="483"/>
                  </a:lnTo>
                  <a:lnTo>
                    <a:pt x="3324" y="483"/>
                  </a:lnTo>
                  <a:lnTo>
                    <a:pt x="3325" y="483"/>
                  </a:lnTo>
                  <a:lnTo>
                    <a:pt x="3326" y="483"/>
                  </a:lnTo>
                  <a:lnTo>
                    <a:pt x="3327" y="483"/>
                  </a:lnTo>
                  <a:lnTo>
                    <a:pt x="3328" y="483"/>
                  </a:lnTo>
                  <a:lnTo>
                    <a:pt x="3329" y="483"/>
                  </a:lnTo>
                  <a:lnTo>
                    <a:pt x="3330" y="483"/>
                  </a:lnTo>
                  <a:lnTo>
                    <a:pt x="3331" y="483"/>
                  </a:lnTo>
                  <a:lnTo>
                    <a:pt x="3332" y="483"/>
                  </a:lnTo>
                  <a:lnTo>
                    <a:pt x="3333" y="483"/>
                  </a:lnTo>
                  <a:lnTo>
                    <a:pt x="3334" y="483"/>
                  </a:lnTo>
                  <a:lnTo>
                    <a:pt x="3335" y="482"/>
                  </a:lnTo>
                  <a:lnTo>
                    <a:pt x="3336" y="482"/>
                  </a:lnTo>
                  <a:lnTo>
                    <a:pt x="3337" y="482"/>
                  </a:lnTo>
                  <a:lnTo>
                    <a:pt x="3338" y="482"/>
                  </a:lnTo>
                  <a:lnTo>
                    <a:pt x="3339" y="482"/>
                  </a:lnTo>
                  <a:lnTo>
                    <a:pt x="3340" y="482"/>
                  </a:lnTo>
                  <a:lnTo>
                    <a:pt x="3341" y="482"/>
                  </a:lnTo>
                  <a:lnTo>
                    <a:pt x="3342" y="482"/>
                  </a:lnTo>
                  <a:lnTo>
                    <a:pt x="3343" y="482"/>
                  </a:lnTo>
                  <a:lnTo>
                    <a:pt x="3344" y="482"/>
                  </a:lnTo>
                  <a:lnTo>
                    <a:pt x="3345" y="482"/>
                  </a:lnTo>
                  <a:lnTo>
                    <a:pt x="3346" y="482"/>
                  </a:lnTo>
                  <a:lnTo>
                    <a:pt x="3347" y="481"/>
                  </a:lnTo>
                  <a:lnTo>
                    <a:pt x="3348" y="481"/>
                  </a:lnTo>
                  <a:lnTo>
                    <a:pt x="3349" y="481"/>
                  </a:lnTo>
                  <a:lnTo>
                    <a:pt x="3350" y="481"/>
                  </a:lnTo>
                  <a:lnTo>
                    <a:pt x="3351" y="481"/>
                  </a:lnTo>
                  <a:lnTo>
                    <a:pt x="3351" y="480"/>
                  </a:lnTo>
                  <a:lnTo>
                    <a:pt x="3352" y="480"/>
                  </a:lnTo>
                  <a:lnTo>
                    <a:pt x="3353" y="480"/>
                  </a:lnTo>
                  <a:lnTo>
                    <a:pt x="3353" y="479"/>
                  </a:lnTo>
                  <a:lnTo>
                    <a:pt x="3354" y="479"/>
                  </a:lnTo>
                  <a:lnTo>
                    <a:pt x="3354" y="478"/>
                  </a:lnTo>
                  <a:lnTo>
                    <a:pt x="3355" y="478"/>
                  </a:lnTo>
                  <a:lnTo>
                    <a:pt x="3356" y="477"/>
                  </a:lnTo>
                  <a:lnTo>
                    <a:pt x="3356" y="476"/>
                  </a:lnTo>
                  <a:lnTo>
                    <a:pt x="3357" y="476"/>
                  </a:lnTo>
                  <a:lnTo>
                    <a:pt x="3357" y="475"/>
                  </a:lnTo>
                  <a:lnTo>
                    <a:pt x="3358" y="474"/>
                  </a:lnTo>
                  <a:lnTo>
                    <a:pt x="3358" y="473"/>
                  </a:lnTo>
                  <a:lnTo>
                    <a:pt x="3359" y="473"/>
                  </a:lnTo>
                  <a:lnTo>
                    <a:pt x="3359" y="472"/>
                  </a:lnTo>
                  <a:lnTo>
                    <a:pt x="3360" y="471"/>
                  </a:lnTo>
                  <a:lnTo>
                    <a:pt x="3361" y="470"/>
                  </a:lnTo>
                  <a:lnTo>
                    <a:pt x="3361" y="469"/>
                  </a:lnTo>
                  <a:lnTo>
                    <a:pt x="3362" y="469"/>
                  </a:lnTo>
                  <a:lnTo>
                    <a:pt x="3362" y="468"/>
                  </a:lnTo>
                  <a:lnTo>
                    <a:pt x="3363" y="467"/>
                  </a:lnTo>
                  <a:lnTo>
                    <a:pt x="3364" y="466"/>
                  </a:lnTo>
                  <a:lnTo>
                    <a:pt x="3364" y="465"/>
                  </a:lnTo>
                  <a:lnTo>
                    <a:pt x="3365" y="465"/>
                  </a:lnTo>
                  <a:lnTo>
                    <a:pt x="3365" y="464"/>
                  </a:lnTo>
                  <a:lnTo>
                    <a:pt x="3366" y="463"/>
                  </a:lnTo>
                  <a:lnTo>
                    <a:pt x="3367" y="463"/>
                  </a:lnTo>
                  <a:lnTo>
                    <a:pt x="3367" y="462"/>
                  </a:lnTo>
                  <a:lnTo>
                    <a:pt x="3368" y="462"/>
                  </a:lnTo>
                  <a:lnTo>
                    <a:pt x="3369" y="461"/>
                  </a:lnTo>
                  <a:lnTo>
                    <a:pt x="3370" y="461"/>
                  </a:lnTo>
                  <a:lnTo>
                    <a:pt x="3371" y="461"/>
                  </a:lnTo>
                  <a:lnTo>
                    <a:pt x="3372" y="461"/>
                  </a:lnTo>
                  <a:lnTo>
                    <a:pt x="3373" y="461"/>
                  </a:lnTo>
                  <a:lnTo>
                    <a:pt x="3374" y="461"/>
                  </a:lnTo>
                  <a:lnTo>
                    <a:pt x="3375" y="462"/>
                  </a:lnTo>
                  <a:lnTo>
                    <a:pt x="3376" y="462"/>
                  </a:lnTo>
                  <a:lnTo>
                    <a:pt x="3377" y="463"/>
                  </a:lnTo>
                  <a:lnTo>
                    <a:pt x="3378" y="463"/>
                  </a:lnTo>
                  <a:lnTo>
                    <a:pt x="3378" y="464"/>
                  </a:lnTo>
                  <a:lnTo>
                    <a:pt x="3379" y="464"/>
                  </a:lnTo>
                  <a:lnTo>
                    <a:pt x="3379" y="465"/>
                  </a:lnTo>
                  <a:lnTo>
                    <a:pt x="3380" y="465"/>
                  </a:lnTo>
                  <a:lnTo>
                    <a:pt x="3380" y="466"/>
                  </a:lnTo>
                  <a:lnTo>
                    <a:pt x="3381" y="466"/>
                  </a:lnTo>
                  <a:lnTo>
                    <a:pt x="3381" y="467"/>
                  </a:lnTo>
                  <a:lnTo>
                    <a:pt x="3382" y="467"/>
                  </a:lnTo>
                  <a:lnTo>
                    <a:pt x="3382" y="468"/>
                  </a:lnTo>
                  <a:lnTo>
                    <a:pt x="3383" y="468"/>
                  </a:lnTo>
                  <a:lnTo>
                    <a:pt x="3383" y="469"/>
                  </a:lnTo>
                  <a:lnTo>
                    <a:pt x="3384" y="470"/>
                  </a:lnTo>
                  <a:lnTo>
                    <a:pt x="3385" y="471"/>
                  </a:lnTo>
                  <a:lnTo>
                    <a:pt x="3386" y="471"/>
                  </a:lnTo>
                  <a:lnTo>
                    <a:pt x="3386" y="472"/>
                  </a:lnTo>
                  <a:lnTo>
                    <a:pt x="3387" y="472"/>
                  </a:lnTo>
                  <a:lnTo>
                    <a:pt x="3387" y="473"/>
                  </a:lnTo>
                  <a:lnTo>
                    <a:pt x="3388" y="473"/>
                  </a:lnTo>
                  <a:lnTo>
                    <a:pt x="3389" y="474"/>
                  </a:lnTo>
                  <a:lnTo>
                    <a:pt x="3390" y="474"/>
                  </a:lnTo>
                  <a:lnTo>
                    <a:pt x="3391" y="474"/>
                  </a:lnTo>
                  <a:lnTo>
                    <a:pt x="3392" y="474"/>
                  </a:lnTo>
                  <a:lnTo>
                    <a:pt x="3393" y="474"/>
                  </a:lnTo>
                  <a:lnTo>
                    <a:pt x="3394" y="474"/>
                  </a:lnTo>
                  <a:lnTo>
                    <a:pt x="3395" y="473"/>
                  </a:lnTo>
                  <a:lnTo>
                    <a:pt x="3396" y="473"/>
                  </a:lnTo>
                  <a:lnTo>
                    <a:pt x="3397" y="472"/>
                  </a:lnTo>
                  <a:lnTo>
                    <a:pt x="3398" y="472"/>
                  </a:lnTo>
                  <a:lnTo>
                    <a:pt x="3398" y="471"/>
                  </a:lnTo>
                  <a:lnTo>
                    <a:pt x="3399" y="471"/>
                  </a:lnTo>
                  <a:lnTo>
                    <a:pt x="3399" y="470"/>
                  </a:lnTo>
                  <a:lnTo>
                    <a:pt x="3400" y="470"/>
                  </a:lnTo>
                  <a:lnTo>
                    <a:pt x="3400" y="469"/>
                  </a:lnTo>
                  <a:lnTo>
                    <a:pt x="3401" y="468"/>
                  </a:lnTo>
                  <a:lnTo>
                    <a:pt x="3402" y="467"/>
                  </a:lnTo>
                  <a:lnTo>
                    <a:pt x="3403" y="466"/>
                  </a:lnTo>
                  <a:lnTo>
                    <a:pt x="3404" y="465"/>
                  </a:lnTo>
                  <a:lnTo>
                    <a:pt x="3405" y="464"/>
                  </a:lnTo>
                  <a:lnTo>
                    <a:pt x="3406" y="463"/>
                  </a:lnTo>
                  <a:lnTo>
                    <a:pt x="3407" y="462"/>
                  </a:lnTo>
                  <a:lnTo>
                    <a:pt x="3408" y="461"/>
                  </a:lnTo>
                  <a:lnTo>
                    <a:pt x="3408" y="460"/>
                  </a:lnTo>
                  <a:lnTo>
                    <a:pt x="3409" y="459"/>
                  </a:lnTo>
                  <a:lnTo>
                    <a:pt x="3410" y="459"/>
                  </a:lnTo>
                  <a:lnTo>
                    <a:pt x="3410" y="458"/>
                  </a:lnTo>
                  <a:lnTo>
                    <a:pt x="3411" y="458"/>
                  </a:lnTo>
                  <a:lnTo>
                    <a:pt x="3411" y="457"/>
                  </a:lnTo>
                  <a:lnTo>
                    <a:pt x="3412" y="457"/>
                  </a:lnTo>
                  <a:lnTo>
                    <a:pt x="3412" y="456"/>
                  </a:lnTo>
                  <a:lnTo>
                    <a:pt x="3413" y="456"/>
                  </a:lnTo>
                  <a:lnTo>
                    <a:pt x="3414" y="455"/>
                  </a:lnTo>
                  <a:lnTo>
                    <a:pt x="3415" y="455"/>
                  </a:lnTo>
                  <a:lnTo>
                    <a:pt x="3416" y="454"/>
                  </a:lnTo>
                  <a:lnTo>
                    <a:pt x="3417" y="454"/>
                  </a:lnTo>
                  <a:lnTo>
                    <a:pt x="3418" y="454"/>
                  </a:lnTo>
                  <a:lnTo>
                    <a:pt x="3419" y="454"/>
                  </a:lnTo>
                  <a:lnTo>
                    <a:pt x="3420" y="454"/>
                  </a:lnTo>
                  <a:lnTo>
                    <a:pt x="3421" y="454"/>
                  </a:lnTo>
                  <a:lnTo>
                    <a:pt x="3422" y="454"/>
                  </a:lnTo>
                  <a:lnTo>
                    <a:pt x="3423" y="454"/>
                  </a:lnTo>
                  <a:lnTo>
                    <a:pt x="3423" y="455"/>
                  </a:lnTo>
                  <a:lnTo>
                    <a:pt x="3424" y="455"/>
                  </a:lnTo>
                  <a:lnTo>
                    <a:pt x="3425" y="455"/>
                  </a:lnTo>
                  <a:lnTo>
                    <a:pt x="3425" y="456"/>
                  </a:lnTo>
                  <a:lnTo>
                    <a:pt x="3426" y="457"/>
                  </a:lnTo>
                  <a:lnTo>
                    <a:pt x="3427" y="457"/>
                  </a:lnTo>
                  <a:lnTo>
                    <a:pt x="3427" y="458"/>
                  </a:lnTo>
                  <a:lnTo>
                    <a:pt x="3428" y="458"/>
                  </a:lnTo>
                  <a:lnTo>
                    <a:pt x="3428" y="459"/>
                  </a:lnTo>
                  <a:lnTo>
                    <a:pt x="3429" y="459"/>
                  </a:lnTo>
                  <a:lnTo>
                    <a:pt x="3429" y="460"/>
                  </a:lnTo>
                  <a:lnTo>
                    <a:pt x="3430" y="460"/>
                  </a:lnTo>
                  <a:lnTo>
                    <a:pt x="3430" y="461"/>
                  </a:lnTo>
                  <a:lnTo>
                    <a:pt x="3431" y="461"/>
                  </a:lnTo>
                  <a:lnTo>
                    <a:pt x="3431" y="462"/>
                  </a:lnTo>
                  <a:lnTo>
                    <a:pt x="3432" y="462"/>
                  </a:lnTo>
                  <a:lnTo>
                    <a:pt x="3433" y="463"/>
                  </a:lnTo>
                  <a:lnTo>
                    <a:pt x="3434" y="464"/>
                  </a:lnTo>
                  <a:lnTo>
                    <a:pt x="3435" y="464"/>
                  </a:lnTo>
                  <a:lnTo>
                    <a:pt x="3435" y="465"/>
                  </a:lnTo>
                  <a:lnTo>
                    <a:pt x="3436" y="465"/>
                  </a:lnTo>
                  <a:lnTo>
                    <a:pt x="3437" y="465"/>
                  </a:lnTo>
                  <a:lnTo>
                    <a:pt x="3438" y="465"/>
                  </a:lnTo>
                  <a:lnTo>
                    <a:pt x="3439" y="464"/>
                  </a:lnTo>
                  <a:lnTo>
                    <a:pt x="3440" y="464"/>
                  </a:lnTo>
                  <a:lnTo>
                    <a:pt x="3441" y="463"/>
                  </a:lnTo>
                  <a:lnTo>
                    <a:pt x="3442" y="463"/>
                  </a:lnTo>
                  <a:lnTo>
                    <a:pt x="3442" y="462"/>
                  </a:lnTo>
                  <a:lnTo>
                    <a:pt x="3443" y="461"/>
                  </a:lnTo>
                  <a:lnTo>
                    <a:pt x="3444" y="460"/>
                  </a:lnTo>
                  <a:lnTo>
                    <a:pt x="3445" y="459"/>
                  </a:lnTo>
                  <a:lnTo>
                    <a:pt x="3446" y="458"/>
                  </a:lnTo>
                  <a:lnTo>
                    <a:pt x="3447" y="457"/>
                  </a:lnTo>
                  <a:lnTo>
                    <a:pt x="3448" y="457"/>
                  </a:lnTo>
                  <a:lnTo>
                    <a:pt x="3448" y="456"/>
                  </a:lnTo>
                  <a:lnTo>
                    <a:pt x="3449" y="456"/>
                  </a:lnTo>
                  <a:lnTo>
                    <a:pt x="3449" y="455"/>
                  </a:lnTo>
                  <a:lnTo>
                    <a:pt x="3450" y="455"/>
                  </a:lnTo>
                  <a:lnTo>
                    <a:pt x="3451" y="455"/>
                  </a:lnTo>
                  <a:lnTo>
                    <a:pt x="3451" y="454"/>
                  </a:lnTo>
                  <a:lnTo>
                    <a:pt x="3452" y="454"/>
                  </a:lnTo>
                  <a:lnTo>
                    <a:pt x="3453" y="454"/>
                  </a:lnTo>
                  <a:lnTo>
                    <a:pt x="3453" y="453"/>
                  </a:lnTo>
                  <a:lnTo>
                    <a:pt x="3454" y="453"/>
                  </a:lnTo>
                  <a:lnTo>
                    <a:pt x="3455" y="453"/>
                  </a:lnTo>
                  <a:lnTo>
                    <a:pt x="3456" y="453"/>
                  </a:lnTo>
                  <a:lnTo>
                    <a:pt x="3457" y="452"/>
                  </a:lnTo>
                  <a:lnTo>
                    <a:pt x="3458" y="452"/>
                  </a:lnTo>
                  <a:lnTo>
                    <a:pt x="3459" y="452"/>
                  </a:lnTo>
                  <a:lnTo>
                    <a:pt x="3460" y="452"/>
                  </a:lnTo>
                  <a:lnTo>
                    <a:pt x="3460" y="451"/>
                  </a:lnTo>
                  <a:lnTo>
                    <a:pt x="3461" y="451"/>
                  </a:lnTo>
                  <a:lnTo>
                    <a:pt x="3462" y="450"/>
                  </a:lnTo>
                  <a:lnTo>
                    <a:pt x="3463" y="450"/>
                  </a:lnTo>
                  <a:lnTo>
                    <a:pt x="3464" y="449"/>
                  </a:lnTo>
                  <a:lnTo>
                    <a:pt x="3465" y="449"/>
                  </a:lnTo>
                  <a:lnTo>
                    <a:pt x="3465" y="448"/>
                  </a:lnTo>
                  <a:lnTo>
                    <a:pt x="3466" y="448"/>
                  </a:lnTo>
                  <a:lnTo>
                    <a:pt x="3467" y="448"/>
                  </a:lnTo>
                  <a:lnTo>
                    <a:pt x="3467" y="447"/>
                  </a:lnTo>
                  <a:lnTo>
                    <a:pt x="3468" y="447"/>
                  </a:lnTo>
                  <a:lnTo>
                    <a:pt x="3469" y="446"/>
                  </a:lnTo>
                  <a:lnTo>
                    <a:pt x="3470" y="446"/>
                  </a:lnTo>
                  <a:lnTo>
                    <a:pt x="3471" y="446"/>
                  </a:lnTo>
                  <a:lnTo>
                    <a:pt x="3471" y="445"/>
                  </a:lnTo>
                  <a:lnTo>
                    <a:pt x="3472" y="445"/>
                  </a:lnTo>
                  <a:lnTo>
                    <a:pt x="3473" y="445"/>
                  </a:lnTo>
                  <a:lnTo>
                    <a:pt x="3474" y="445"/>
                  </a:lnTo>
                  <a:lnTo>
                    <a:pt x="3475" y="445"/>
                  </a:lnTo>
                  <a:lnTo>
                    <a:pt x="3476" y="446"/>
                  </a:lnTo>
                  <a:lnTo>
                    <a:pt x="3477" y="446"/>
                  </a:lnTo>
                  <a:lnTo>
                    <a:pt x="3478" y="446"/>
                  </a:lnTo>
                  <a:lnTo>
                    <a:pt x="3479" y="446"/>
                  </a:lnTo>
                  <a:lnTo>
                    <a:pt x="3480" y="447"/>
                  </a:lnTo>
                  <a:lnTo>
                    <a:pt x="3481" y="447"/>
                  </a:lnTo>
                  <a:lnTo>
                    <a:pt x="3482" y="447"/>
                  </a:lnTo>
                  <a:lnTo>
                    <a:pt x="3483" y="447"/>
                  </a:lnTo>
                  <a:lnTo>
                    <a:pt x="3484" y="447"/>
                  </a:lnTo>
                  <a:lnTo>
                    <a:pt x="3485" y="447"/>
                  </a:lnTo>
                  <a:lnTo>
                    <a:pt x="3485" y="446"/>
                  </a:lnTo>
                  <a:lnTo>
                    <a:pt x="3486" y="446"/>
                  </a:lnTo>
                  <a:lnTo>
                    <a:pt x="3487" y="445"/>
                  </a:lnTo>
                  <a:lnTo>
                    <a:pt x="3488" y="445"/>
                  </a:lnTo>
                  <a:lnTo>
                    <a:pt x="3488" y="444"/>
                  </a:lnTo>
                  <a:lnTo>
                    <a:pt x="3489" y="444"/>
                  </a:lnTo>
                  <a:lnTo>
                    <a:pt x="3490" y="443"/>
                  </a:lnTo>
                  <a:lnTo>
                    <a:pt x="3491" y="443"/>
                  </a:lnTo>
                  <a:lnTo>
                    <a:pt x="3491" y="442"/>
                  </a:lnTo>
                  <a:lnTo>
                    <a:pt x="3492" y="442"/>
                  </a:lnTo>
                  <a:lnTo>
                    <a:pt x="3492" y="441"/>
                  </a:lnTo>
                  <a:lnTo>
                    <a:pt x="3493" y="441"/>
                  </a:lnTo>
                  <a:lnTo>
                    <a:pt x="3494" y="440"/>
                  </a:lnTo>
                  <a:lnTo>
                    <a:pt x="3495" y="440"/>
                  </a:lnTo>
                  <a:lnTo>
                    <a:pt x="3495" y="439"/>
                  </a:lnTo>
                  <a:lnTo>
                    <a:pt x="3496" y="439"/>
                  </a:lnTo>
                  <a:lnTo>
                    <a:pt x="3497" y="439"/>
                  </a:lnTo>
                  <a:lnTo>
                    <a:pt x="3498" y="439"/>
                  </a:lnTo>
                  <a:lnTo>
                    <a:pt x="3499" y="439"/>
                  </a:lnTo>
                  <a:lnTo>
                    <a:pt x="3500" y="439"/>
                  </a:lnTo>
                  <a:lnTo>
                    <a:pt x="3501" y="439"/>
                  </a:lnTo>
                  <a:lnTo>
                    <a:pt x="3502" y="439"/>
                  </a:lnTo>
                  <a:lnTo>
                    <a:pt x="3503" y="439"/>
                  </a:lnTo>
                  <a:lnTo>
                    <a:pt x="3504" y="439"/>
                  </a:lnTo>
                  <a:lnTo>
                    <a:pt x="3505" y="439"/>
                  </a:lnTo>
                  <a:lnTo>
                    <a:pt x="3506" y="439"/>
                  </a:lnTo>
                  <a:lnTo>
                    <a:pt x="3507" y="439"/>
                  </a:lnTo>
                  <a:lnTo>
                    <a:pt x="3508" y="439"/>
                  </a:lnTo>
                  <a:lnTo>
                    <a:pt x="3509" y="439"/>
                  </a:lnTo>
                  <a:lnTo>
                    <a:pt x="3510" y="438"/>
                  </a:lnTo>
                  <a:lnTo>
                    <a:pt x="3511" y="438"/>
                  </a:lnTo>
                  <a:lnTo>
                    <a:pt x="3512" y="437"/>
                  </a:lnTo>
                  <a:lnTo>
                    <a:pt x="3513" y="437"/>
                  </a:lnTo>
                  <a:lnTo>
                    <a:pt x="3513" y="436"/>
                  </a:lnTo>
                  <a:lnTo>
                    <a:pt x="3514" y="436"/>
                  </a:lnTo>
                  <a:lnTo>
                    <a:pt x="3515" y="436"/>
                  </a:lnTo>
                  <a:lnTo>
                    <a:pt x="3515" y="435"/>
                  </a:lnTo>
                  <a:lnTo>
                    <a:pt x="3516" y="435"/>
                  </a:lnTo>
                  <a:lnTo>
                    <a:pt x="3517" y="434"/>
                  </a:lnTo>
                  <a:lnTo>
                    <a:pt x="3518" y="434"/>
                  </a:lnTo>
                  <a:lnTo>
                    <a:pt x="3519" y="433"/>
                  </a:lnTo>
                  <a:lnTo>
                    <a:pt x="3520" y="433"/>
                  </a:lnTo>
                </a:path>
              </a:pathLst>
            </a:custGeom>
            <a:noFill/>
            <a:ln w="255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Freeform 117"/>
            <p:cNvSpPr/>
            <p:nvPr/>
          </p:nvSpPr>
          <p:spPr>
            <a:xfrm flipV="1">
              <a:off x="2065320" y="2823840"/>
              <a:ext cx="3218040" cy="1141200"/>
            </a:xfrm>
            <a:custGeom>
              <a:avLst/>
              <a:gdLst>
                <a:gd name="textAreaLeft" fmla="*/ 0 w 3218040"/>
                <a:gd name="textAreaRight" fmla="*/ 3218400 w 3218040"/>
                <a:gd name="textAreaTop" fmla="*/ 360 h 1141200"/>
                <a:gd name="textAreaBottom" fmla="*/ 1141920 h 1141200"/>
              </a:gdLst>
              <a:ahLst/>
              <a:rect l="textAreaLeft" t="textAreaTop" r="textAreaRight" b="textAreaBottom"/>
              <a:pathLst>
                <a:path w="3520" h="1282">
                  <a:moveTo>
                    <a:pt x="0" y="12"/>
                  </a:moveTo>
                  <a:lnTo>
                    <a:pt x="1" y="12"/>
                  </a:lnTo>
                  <a:lnTo>
                    <a:pt x="2" y="13"/>
                  </a:lnTo>
                  <a:lnTo>
                    <a:pt x="3" y="13"/>
                  </a:lnTo>
                  <a:lnTo>
                    <a:pt x="4" y="13"/>
                  </a:lnTo>
                  <a:lnTo>
                    <a:pt x="5" y="13"/>
                  </a:lnTo>
                  <a:lnTo>
                    <a:pt x="5" y="14"/>
                  </a:lnTo>
                  <a:lnTo>
                    <a:pt x="6" y="14"/>
                  </a:lnTo>
                  <a:lnTo>
                    <a:pt x="7" y="14"/>
                  </a:lnTo>
                  <a:lnTo>
                    <a:pt x="8" y="14"/>
                  </a:lnTo>
                  <a:lnTo>
                    <a:pt x="9" y="14"/>
                  </a:lnTo>
                  <a:lnTo>
                    <a:pt x="9" y="13"/>
                  </a:lnTo>
                  <a:lnTo>
                    <a:pt x="10" y="13"/>
                  </a:lnTo>
                  <a:lnTo>
                    <a:pt x="11" y="13"/>
                  </a:lnTo>
                  <a:lnTo>
                    <a:pt x="11" y="12"/>
                  </a:lnTo>
                  <a:lnTo>
                    <a:pt x="12" y="12"/>
                  </a:lnTo>
                  <a:lnTo>
                    <a:pt x="13" y="11"/>
                  </a:lnTo>
                  <a:lnTo>
                    <a:pt x="14" y="10"/>
                  </a:lnTo>
                  <a:lnTo>
                    <a:pt x="15" y="9"/>
                  </a:lnTo>
                  <a:lnTo>
                    <a:pt x="16" y="8"/>
                  </a:lnTo>
                  <a:lnTo>
                    <a:pt x="17" y="7"/>
                  </a:lnTo>
                  <a:lnTo>
                    <a:pt x="17" y="6"/>
                  </a:lnTo>
                  <a:lnTo>
                    <a:pt x="18" y="6"/>
                  </a:lnTo>
                  <a:lnTo>
                    <a:pt x="18" y="5"/>
                  </a:lnTo>
                  <a:lnTo>
                    <a:pt x="19" y="5"/>
                  </a:lnTo>
                  <a:lnTo>
                    <a:pt x="19" y="4"/>
                  </a:lnTo>
                  <a:lnTo>
                    <a:pt x="20" y="3"/>
                  </a:lnTo>
                  <a:lnTo>
                    <a:pt x="21" y="2"/>
                  </a:lnTo>
                  <a:lnTo>
                    <a:pt x="22" y="1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7" y="0"/>
                  </a:lnTo>
                  <a:lnTo>
                    <a:pt x="28" y="0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30" y="2"/>
                  </a:lnTo>
                  <a:lnTo>
                    <a:pt x="31" y="3"/>
                  </a:lnTo>
                  <a:lnTo>
                    <a:pt x="32" y="4"/>
                  </a:lnTo>
                  <a:lnTo>
                    <a:pt x="33" y="5"/>
                  </a:lnTo>
                  <a:lnTo>
                    <a:pt x="34" y="6"/>
                  </a:lnTo>
                  <a:lnTo>
                    <a:pt x="34" y="7"/>
                  </a:lnTo>
                  <a:lnTo>
                    <a:pt x="35" y="7"/>
                  </a:lnTo>
                  <a:lnTo>
                    <a:pt x="35" y="8"/>
                  </a:lnTo>
                  <a:lnTo>
                    <a:pt x="36" y="9"/>
                  </a:lnTo>
                  <a:lnTo>
                    <a:pt x="36" y="10"/>
                  </a:lnTo>
                  <a:lnTo>
                    <a:pt x="36" y="11"/>
                  </a:lnTo>
                  <a:lnTo>
                    <a:pt x="37" y="11"/>
                  </a:lnTo>
                  <a:lnTo>
                    <a:pt x="37" y="12"/>
                  </a:lnTo>
                  <a:lnTo>
                    <a:pt x="38" y="13"/>
                  </a:lnTo>
                  <a:lnTo>
                    <a:pt x="38" y="14"/>
                  </a:lnTo>
                  <a:lnTo>
                    <a:pt x="39" y="15"/>
                  </a:lnTo>
                  <a:lnTo>
                    <a:pt x="39" y="16"/>
                  </a:lnTo>
                  <a:lnTo>
                    <a:pt x="40" y="17"/>
                  </a:lnTo>
                  <a:lnTo>
                    <a:pt x="40" y="18"/>
                  </a:lnTo>
                  <a:lnTo>
                    <a:pt x="41" y="19"/>
                  </a:lnTo>
                  <a:lnTo>
                    <a:pt x="41" y="20"/>
                  </a:lnTo>
                  <a:lnTo>
                    <a:pt x="42" y="21"/>
                  </a:lnTo>
                  <a:lnTo>
                    <a:pt x="42" y="22"/>
                  </a:lnTo>
                  <a:lnTo>
                    <a:pt x="43" y="22"/>
                  </a:lnTo>
                  <a:lnTo>
                    <a:pt x="43" y="23"/>
                  </a:lnTo>
                  <a:lnTo>
                    <a:pt x="44" y="24"/>
                  </a:lnTo>
                  <a:lnTo>
                    <a:pt x="44" y="25"/>
                  </a:lnTo>
                  <a:lnTo>
                    <a:pt x="45" y="26"/>
                  </a:lnTo>
                  <a:lnTo>
                    <a:pt x="45" y="27"/>
                  </a:lnTo>
                  <a:lnTo>
                    <a:pt x="45" y="28"/>
                  </a:lnTo>
                  <a:lnTo>
                    <a:pt x="46" y="29"/>
                  </a:lnTo>
                  <a:lnTo>
                    <a:pt x="46" y="30"/>
                  </a:lnTo>
                  <a:lnTo>
                    <a:pt x="47" y="31"/>
                  </a:lnTo>
                  <a:lnTo>
                    <a:pt x="47" y="32"/>
                  </a:lnTo>
                  <a:lnTo>
                    <a:pt x="48" y="33"/>
                  </a:lnTo>
                  <a:lnTo>
                    <a:pt x="48" y="34"/>
                  </a:lnTo>
                  <a:lnTo>
                    <a:pt x="49" y="34"/>
                  </a:lnTo>
                  <a:lnTo>
                    <a:pt x="49" y="35"/>
                  </a:lnTo>
                  <a:lnTo>
                    <a:pt x="50" y="36"/>
                  </a:lnTo>
                  <a:lnTo>
                    <a:pt x="50" y="37"/>
                  </a:lnTo>
                  <a:lnTo>
                    <a:pt x="51" y="38"/>
                  </a:lnTo>
                  <a:lnTo>
                    <a:pt x="51" y="39"/>
                  </a:lnTo>
                  <a:lnTo>
                    <a:pt x="52" y="39"/>
                  </a:lnTo>
                  <a:lnTo>
                    <a:pt x="52" y="40"/>
                  </a:lnTo>
                  <a:lnTo>
                    <a:pt x="53" y="41"/>
                  </a:lnTo>
                  <a:lnTo>
                    <a:pt x="54" y="42"/>
                  </a:lnTo>
                  <a:lnTo>
                    <a:pt x="54" y="43"/>
                  </a:lnTo>
                  <a:lnTo>
                    <a:pt x="55" y="44"/>
                  </a:lnTo>
                  <a:lnTo>
                    <a:pt x="56" y="45"/>
                  </a:lnTo>
                  <a:lnTo>
                    <a:pt x="57" y="45"/>
                  </a:lnTo>
                  <a:lnTo>
                    <a:pt x="57" y="46"/>
                  </a:lnTo>
                  <a:lnTo>
                    <a:pt x="58" y="46"/>
                  </a:lnTo>
                  <a:lnTo>
                    <a:pt x="59" y="47"/>
                  </a:lnTo>
                  <a:lnTo>
                    <a:pt x="60" y="47"/>
                  </a:lnTo>
                  <a:lnTo>
                    <a:pt x="61" y="47"/>
                  </a:lnTo>
                  <a:lnTo>
                    <a:pt x="62" y="47"/>
                  </a:lnTo>
                  <a:lnTo>
                    <a:pt x="63" y="47"/>
                  </a:lnTo>
                  <a:lnTo>
                    <a:pt x="64" y="47"/>
                  </a:lnTo>
                  <a:lnTo>
                    <a:pt x="65" y="47"/>
                  </a:lnTo>
                  <a:lnTo>
                    <a:pt x="66" y="47"/>
                  </a:lnTo>
                  <a:lnTo>
                    <a:pt x="67" y="47"/>
                  </a:lnTo>
                  <a:lnTo>
                    <a:pt x="68" y="47"/>
                  </a:lnTo>
                  <a:lnTo>
                    <a:pt x="69" y="47"/>
                  </a:lnTo>
                  <a:lnTo>
                    <a:pt x="70" y="47"/>
                  </a:lnTo>
                  <a:lnTo>
                    <a:pt x="70" y="48"/>
                  </a:lnTo>
                  <a:lnTo>
                    <a:pt x="71" y="48"/>
                  </a:lnTo>
                  <a:lnTo>
                    <a:pt x="71" y="49"/>
                  </a:lnTo>
                  <a:lnTo>
                    <a:pt x="72" y="49"/>
                  </a:lnTo>
                  <a:lnTo>
                    <a:pt x="72" y="50"/>
                  </a:lnTo>
                  <a:lnTo>
                    <a:pt x="73" y="51"/>
                  </a:lnTo>
                  <a:lnTo>
                    <a:pt x="74" y="52"/>
                  </a:lnTo>
                  <a:lnTo>
                    <a:pt x="74" y="53"/>
                  </a:lnTo>
                  <a:lnTo>
                    <a:pt x="75" y="54"/>
                  </a:lnTo>
                  <a:lnTo>
                    <a:pt x="75" y="55"/>
                  </a:lnTo>
                  <a:lnTo>
                    <a:pt x="76" y="56"/>
                  </a:lnTo>
                  <a:lnTo>
                    <a:pt x="76" y="57"/>
                  </a:lnTo>
                  <a:lnTo>
                    <a:pt x="77" y="58"/>
                  </a:lnTo>
                  <a:lnTo>
                    <a:pt x="77" y="59"/>
                  </a:lnTo>
                  <a:lnTo>
                    <a:pt x="78" y="60"/>
                  </a:lnTo>
                  <a:lnTo>
                    <a:pt x="78" y="61"/>
                  </a:lnTo>
                  <a:lnTo>
                    <a:pt x="79" y="63"/>
                  </a:lnTo>
                  <a:lnTo>
                    <a:pt x="79" y="64"/>
                  </a:lnTo>
                  <a:lnTo>
                    <a:pt x="79" y="65"/>
                  </a:lnTo>
                  <a:lnTo>
                    <a:pt x="80" y="66"/>
                  </a:lnTo>
                  <a:lnTo>
                    <a:pt x="80" y="68"/>
                  </a:lnTo>
                  <a:lnTo>
                    <a:pt x="81" y="69"/>
                  </a:lnTo>
                  <a:lnTo>
                    <a:pt x="81" y="70"/>
                  </a:lnTo>
                  <a:lnTo>
                    <a:pt x="82" y="71"/>
                  </a:lnTo>
                  <a:lnTo>
                    <a:pt x="82" y="73"/>
                  </a:lnTo>
                  <a:lnTo>
                    <a:pt x="83" y="74"/>
                  </a:lnTo>
                  <a:lnTo>
                    <a:pt x="83" y="75"/>
                  </a:lnTo>
                  <a:lnTo>
                    <a:pt x="84" y="77"/>
                  </a:lnTo>
                  <a:lnTo>
                    <a:pt x="84" y="78"/>
                  </a:lnTo>
                  <a:lnTo>
                    <a:pt x="85" y="79"/>
                  </a:lnTo>
                  <a:lnTo>
                    <a:pt x="85" y="80"/>
                  </a:lnTo>
                  <a:lnTo>
                    <a:pt x="86" y="82"/>
                  </a:lnTo>
                  <a:lnTo>
                    <a:pt x="86" y="83"/>
                  </a:lnTo>
                  <a:lnTo>
                    <a:pt x="87" y="84"/>
                  </a:lnTo>
                  <a:lnTo>
                    <a:pt x="87" y="85"/>
                  </a:lnTo>
                  <a:lnTo>
                    <a:pt x="88" y="86"/>
                  </a:lnTo>
                  <a:lnTo>
                    <a:pt x="88" y="87"/>
                  </a:lnTo>
                  <a:lnTo>
                    <a:pt x="88" y="89"/>
                  </a:lnTo>
                  <a:lnTo>
                    <a:pt x="89" y="90"/>
                  </a:lnTo>
                  <a:lnTo>
                    <a:pt x="89" y="91"/>
                  </a:lnTo>
                  <a:lnTo>
                    <a:pt x="90" y="92"/>
                  </a:lnTo>
                  <a:lnTo>
                    <a:pt x="90" y="93"/>
                  </a:lnTo>
                  <a:lnTo>
                    <a:pt x="91" y="94"/>
                  </a:lnTo>
                  <a:lnTo>
                    <a:pt x="91" y="95"/>
                  </a:lnTo>
                  <a:lnTo>
                    <a:pt x="92" y="96"/>
                  </a:lnTo>
                  <a:lnTo>
                    <a:pt x="92" y="97"/>
                  </a:lnTo>
                  <a:lnTo>
                    <a:pt x="93" y="98"/>
                  </a:lnTo>
                  <a:lnTo>
                    <a:pt x="93" y="99"/>
                  </a:lnTo>
                  <a:lnTo>
                    <a:pt x="94" y="100"/>
                  </a:lnTo>
                  <a:lnTo>
                    <a:pt x="94" y="101"/>
                  </a:lnTo>
                  <a:lnTo>
                    <a:pt x="95" y="101"/>
                  </a:lnTo>
                  <a:lnTo>
                    <a:pt x="95" y="102"/>
                  </a:lnTo>
                  <a:lnTo>
                    <a:pt x="96" y="103"/>
                  </a:lnTo>
                  <a:lnTo>
                    <a:pt x="96" y="104"/>
                  </a:lnTo>
                  <a:lnTo>
                    <a:pt x="97" y="105"/>
                  </a:lnTo>
                  <a:lnTo>
                    <a:pt x="98" y="106"/>
                  </a:lnTo>
                  <a:lnTo>
                    <a:pt x="99" y="106"/>
                  </a:lnTo>
                  <a:lnTo>
                    <a:pt x="99" y="107"/>
                  </a:lnTo>
                  <a:lnTo>
                    <a:pt x="100" y="107"/>
                  </a:lnTo>
                  <a:lnTo>
                    <a:pt x="101" y="108"/>
                  </a:lnTo>
                  <a:lnTo>
                    <a:pt x="102" y="108"/>
                  </a:lnTo>
                  <a:lnTo>
                    <a:pt x="103" y="108"/>
                  </a:lnTo>
                  <a:lnTo>
                    <a:pt x="104" y="108"/>
                  </a:lnTo>
                  <a:lnTo>
                    <a:pt x="105" y="108"/>
                  </a:lnTo>
                  <a:lnTo>
                    <a:pt x="106" y="108"/>
                  </a:lnTo>
                  <a:lnTo>
                    <a:pt x="106" y="107"/>
                  </a:lnTo>
                  <a:lnTo>
                    <a:pt x="107" y="107"/>
                  </a:lnTo>
                  <a:lnTo>
                    <a:pt x="108" y="106"/>
                  </a:lnTo>
                  <a:lnTo>
                    <a:pt x="109" y="105"/>
                  </a:lnTo>
                  <a:lnTo>
                    <a:pt x="109" y="104"/>
                  </a:lnTo>
                  <a:lnTo>
                    <a:pt x="110" y="104"/>
                  </a:lnTo>
                  <a:lnTo>
                    <a:pt x="110" y="103"/>
                  </a:lnTo>
                  <a:lnTo>
                    <a:pt x="111" y="103"/>
                  </a:lnTo>
                  <a:lnTo>
                    <a:pt x="111" y="102"/>
                  </a:lnTo>
                  <a:lnTo>
                    <a:pt x="112" y="101"/>
                  </a:lnTo>
                  <a:lnTo>
                    <a:pt x="113" y="100"/>
                  </a:lnTo>
                  <a:lnTo>
                    <a:pt x="113" y="99"/>
                  </a:lnTo>
                  <a:lnTo>
                    <a:pt x="114" y="98"/>
                  </a:lnTo>
                  <a:lnTo>
                    <a:pt x="115" y="97"/>
                  </a:lnTo>
                  <a:lnTo>
                    <a:pt x="116" y="96"/>
                  </a:lnTo>
                  <a:lnTo>
                    <a:pt x="116" y="95"/>
                  </a:lnTo>
                  <a:lnTo>
                    <a:pt x="117" y="95"/>
                  </a:lnTo>
                  <a:lnTo>
                    <a:pt x="118" y="94"/>
                  </a:lnTo>
                  <a:lnTo>
                    <a:pt x="119" y="94"/>
                  </a:lnTo>
                  <a:lnTo>
                    <a:pt x="119" y="93"/>
                  </a:lnTo>
                  <a:lnTo>
                    <a:pt x="120" y="93"/>
                  </a:lnTo>
                  <a:lnTo>
                    <a:pt x="121" y="93"/>
                  </a:lnTo>
                  <a:lnTo>
                    <a:pt x="122" y="93"/>
                  </a:lnTo>
                  <a:lnTo>
                    <a:pt x="123" y="93"/>
                  </a:lnTo>
                  <a:lnTo>
                    <a:pt x="124" y="93"/>
                  </a:lnTo>
                  <a:lnTo>
                    <a:pt x="125" y="93"/>
                  </a:lnTo>
                  <a:lnTo>
                    <a:pt x="126" y="93"/>
                  </a:lnTo>
                  <a:lnTo>
                    <a:pt x="127" y="93"/>
                  </a:lnTo>
                  <a:lnTo>
                    <a:pt x="128" y="93"/>
                  </a:lnTo>
                  <a:lnTo>
                    <a:pt x="129" y="93"/>
                  </a:lnTo>
                  <a:lnTo>
                    <a:pt x="130" y="92"/>
                  </a:lnTo>
                  <a:lnTo>
                    <a:pt x="131" y="92"/>
                  </a:lnTo>
                  <a:lnTo>
                    <a:pt x="131" y="91"/>
                  </a:lnTo>
                  <a:lnTo>
                    <a:pt x="132" y="90"/>
                  </a:lnTo>
                  <a:lnTo>
                    <a:pt x="133" y="89"/>
                  </a:lnTo>
                  <a:lnTo>
                    <a:pt x="134" y="88"/>
                  </a:lnTo>
                  <a:lnTo>
                    <a:pt x="134" y="87"/>
                  </a:lnTo>
                  <a:lnTo>
                    <a:pt x="135" y="87"/>
                  </a:lnTo>
                  <a:lnTo>
                    <a:pt x="135" y="86"/>
                  </a:lnTo>
                  <a:lnTo>
                    <a:pt x="136" y="86"/>
                  </a:lnTo>
                  <a:lnTo>
                    <a:pt x="136" y="85"/>
                  </a:lnTo>
                  <a:lnTo>
                    <a:pt x="137" y="85"/>
                  </a:lnTo>
                  <a:lnTo>
                    <a:pt x="137" y="84"/>
                  </a:lnTo>
                  <a:lnTo>
                    <a:pt x="138" y="84"/>
                  </a:lnTo>
                  <a:lnTo>
                    <a:pt x="139" y="83"/>
                  </a:lnTo>
                  <a:lnTo>
                    <a:pt x="140" y="83"/>
                  </a:lnTo>
                  <a:lnTo>
                    <a:pt x="141" y="83"/>
                  </a:lnTo>
                  <a:lnTo>
                    <a:pt x="142" y="83"/>
                  </a:lnTo>
                  <a:lnTo>
                    <a:pt x="142" y="84"/>
                  </a:lnTo>
                  <a:lnTo>
                    <a:pt x="143" y="85"/>
                  </a:lnTo>
                  <a:lnTo>
                    <a:pt x="144" y="86"/>
                  </a:lnTo>
                  <a:lnTo>
                    <a:pt x="144" y="87"/>
                  </a:lnTo>
                  <a:lnTo>
                    <a:pt x="145" y="88"/>
                  </a:lnTo>
                  <a:lnTo>
                    <a:pt x="145" y="89"/>
                  </a:lnTo>
                  <a:lnTo>
                    <a:pt x="146" y="90"/>
                  </a:lnTo>
                  <a:lnTo>
                    <a:pt x="146" y="91"/>
                  </a:lnTo>
                  <a:lnTo>
                    <a:pt x="147" y="92"/>
                  </a:lnTo>
                  <a:lnTo>
                    <a:pt x="147" y="94"/>
                  </a:lnTo>
                  <a:lnTo>
                    <a:pt x="148" y="95"/>
                  </a:lnTo>
                  <a:lnTo>
                    <a:pt x="148" y="96"/>
                  </a:lnTo>
                  <a:lnTo>
                    <a:pt x="148" y="97"/>
                  </a:lnTo>
                  <a:lnTo>
                    <a:pt x="149" y="98"/>
                  </a:lnTo>
                  <a:lnTo>
                    <a:pt x="149" y="99"/>
                  </a:lnTo>
                  <a:lnTo>
                    <a:pt x="150" y="100"/>
                  </a:lnTo>
                  <a:lnTo>
                    <a:pt x="150" y="101"/>
                  </a:lnTo>
                  <a:lnTo>
                    <a:pt x="151" y="102"/>
                  </a:lnTo>
                  <a:lnTo>
                    <a:pt x="151" y="103"/>
                  </a:lnTo>
                  <a:lnTo>
                    <a:pt x="152" y="104"/>
                  </a:lnTo>
                  <a:lnTo>
                    <a:pt x="153" y="105"/>
                  </a:lnTo>
                  <a:lnTo>
                    <a:pt x="153" y="106"/>
                  </a:lnTo>
                  <a:lnTo>
                    <a:pt x="154" y="106"/>
                  </a:lnTo>
                  <a:lnTo>
                    <a:pt x="155" y="106"/>
                  </a:lnTo>
                  <a:lnTo>
                    <a:pt x="156" y="105"/>
                  </a:lnTo>
                  <a:lnTo>
                    <a:pt x="156" y="104"/>
                  </a:lnTo>
                  <a:lnTo>
                    <a:pt x="157" y="104"/>
                  </a:lnTo>
                  <a:lnTo>
                    <a:pt x="157" y="103"/>
                  </a:lnTo>
                  <a:lnTo>
                    <a:pt x="158" y="103"/>
                  </a:lnTo>
                  <a:lnTo>
                    <a:pt x="158" y="102"/>
                  </a:lnTo>
                  <a:lnTo>
                    <a:pt x="159" y="101"/>
                  </a:lnTo>
                  <a:lnTo>
                    <a:pt x="160" y="100"/>
                  </a:lnTo>
                  <a:lnTo>
                    <a:pt x="160" y="99"/>
                  </a:lnTo>
                  <a:lnTo>
                    <a:pt x="161" y="99"/>
                  </a:lnTo>
                  <a:lnTo>
                    <a:pt x="161" y="98"/>
                  </a:lnTo>
                  <a:lnTo>
                    <a:pt x="162" y="97"/>
                  </a:lnTo>
                  <a:lnTo>
                    <a:pt x="163" y="96"/>
                  </a:lnTo>
                  <a:lnTo>
                    <a:pt x="163" y="95"/>
                  </a:lnTo>
                  <a:lnTo>
                    <a:pt x="164" y="95"/>
                  </a:lnTo>
                  <a:lnTo>
                    <a:pt x="164" y="94"/>
                  </a:lnTo>
                  <a:lnTo>
                    <a:pt x="165" y="94"/>
                  </a:lnTo>
                  <a:lnTo>
                    <a:pt x="166" y="94"/>
                  </a:lnTo>
                  <a:lnTo>
                    <a:pt x="167" y="95"/>
                  </a:lnTo>
                  <a:lnTo>
                    <a:pt x="168" y="96"/>
                  </a:lnTo>
                  <a:lnTo>
                    <a:pt x="168" y="97"/>
                  </a:lnTo>
                  <a:lnTo>
                    <a:pt x="169" y="97"/>
                  </a:lnTo>
                  <a:lnTo>
                    <a:pt x="169" y="98"/>
                  </a:lnTo>
                  <a:lnTo>
                    <a:pt x="170" y="99"/>
                  </a:lnTo>
                  <a:lnTo>
                    <a:pt x="170" y="100"/>
                  </a:lnTo>
                  <a:lnTo>
                    <a:pt x="171" y="101"/>
                  </a:lnTo>
                  <a:lnTo>
                    <a:pt x="171" y="102"/>
                  </a:lnTo>
                  <a:lnTo>
                    <a:pt x="172" y="103"/>
                  </a:lnTo>
                  <a:lnTo>
                    <a:pt x="172" y="104"/>
                  </a:lnTo>
                  <a:lnTo>
                    <a:pt x="173" y="105"/>
                  </a:lnTo>
                  <a:lnTo>
                    <a:pt x="173" y="106"/>
                  </a:lnTo>
                  <a:lnTo>
                    <a:pt x="173" y="107"/>
                  </a:lnTo>
                  <a:lnTo>
                    <a:pt x="174" y="108"/>
                  </a:lnTo>
                  <a:lnTo>
                    <a:pt x="174" y="109"/>
                  </a:lnTo>
                  <a:lnTo>
                    <a:pt x="175" y="110"/>
                  </a:lnTo>
                  <a:lnTo>
                    <a:pt x="175" y="111"/>
                  </a:lnTo>
                  <a:lnTo>
                    <a:pt x="176" y="111"/>
                  </a:lnTo>
                  <a:lnTo>
                    <a:pt x="176" y="112"/>
                  </a:lnTo>
                  <a:lnTo>
                    <a:pt x="177" y="113"/>
                  </a:lnTo>
                  <a:lnTo>
                    <a:pt x="178" y="114"/>
                  </a:lnTo>
                  <a:lnTo>
                    <a:pt x="179" y="114"/>
                  </a:lnTo>
                  <a:lnTo>
                    <a:pt x="180" y="114"/>
                  </a:lnTo>
                  <a:lnTo>
                    <a:pt x="181" y="114"/>
                  </a:lnTo>
                  <a:lnTo>
                    <a:pt x="182" y="114"/>
                  </a:lnTo>
                  <a:lnTo>
                    <a:pt x="182" y="113"/>
                  </a:lnTo>
                  <a:lnTo>
                    <a:pt x="183" y="113"/>
                  </a:lnTo>
                  <a:lnTo>
                    <a:pt x="184" y="113"/>
                  </a:lnTo>
                  <a:lnTo>
                    <a:pt x="185" y="113"/>
                  </a:lnTo>
                  <a:lnTo>
                    <a:pt x="185" y="112"/>
                  </a:lnTo>
                  <a:lnTo>
                    <a:pt x="186" y="112"/>
                  </a:lnTo>
                  <a:lnTo>
                    <a:pt x="187" y="112"/>
                  </a:lnTo>
                  <a:lnTo>
                    <a:pt x="188" y="113"/>
                  </a:lnTo>
                  <a:lnTo>
                    <a:pt x="189" y="113"/>
                  </a:lnTo>
                  <a:lnTo>
                    <a:pt x="190" y="114"/>
                  </a:lnTo>
                  <a:lnTo>
                    <a:pt x="190" y="115"/>
                  </a:lnTo>
                  <a:lnTo>
                    <a:pt x="190" y="116"/>
                  </a:lnTo>
                  <a:lnTo>
                    <a:pt x="191" y="117"/>
                  </a:lnTo>
                  <a:lnTo>
                    <a:pt x="191" y="118"/>
                  </a:lnTo>
                  <a:lnTo>
                    <a:pt x="192" y="119"/>
                  </a:lnTo>
                  <a:lnTo>
                    <a:pt x="192" y="120"/>
                  </a:lnTo>
                  <a:lnTo>
                    <a:pt x="193" y="121"/>
                  </a:lnTo>
                  <a:lnTo>
                    <a:pt x="193" y="122"/>
                  </a:lnTo>
                  <a:lnTo>
                    <a:pt x="194" y="123"/>
                  </a:lnTo>
                  <a:lnTo>
                    <a:pt x="194" y="124"/>
                  </a:lnTo>
                  <a:lnTo>
                    <a:pt x="195" y="125"/>
                  </a:lnTo>
                  <a:lnTo>
                    <a:pt x="195" y="126"/>
                  </a:lnTo>
                  <a:lnTo>
                    <a:pt x="196" y="128"/>
                  </a:lnTo>
                  <a:lnTo>
                    <a:pt x="196" y="129"/>
                  </a:lnTo>
                  <a:lnTo>
                    <a:pt x="197" y="129"/>
                  </a:lnTo>
                  <a:lnTo>
                    <a:pt x="197" y="130"/>
                  </a:lnTo>
                  <a:lnTo>
                    <a:pt x="198" y="131"/>
                  </a:lnTo>
                  <a:lnTo>
                    <a:pt x="198" y="132"/>
                  </a:lnTo>
                  <a:lnTo>
                    <a:pt x="199" y="133"/>
                  </a:lnTo>
                  <a:lnTo>
                    <a:pt x="199" y="134"/>
                  </a:lnTo>
                  <a:lnTo>
                    <a:pt x="200" y="134"/>
                  </a:lnTo>
                  <a:lnTo>
                    <a:pt x="200" y="135"/>
                  </a:lnTo>
                  <a:lnTo>
                    <a:pt x="201" y="135"/>
                  </a:lnTo>
                  <a:lnTo>
                    <a:pt x="201" y="134"/>
                  </a:lnTo>
                  <a:lnTo>
                    <a:pt x="202" y="134"/>
                  </a:lnTo>
                  <a:lnTo>
                    <a:pt x="203" y="133"/>
                  </a:lnTo>
                  <a:lnTo>
                    <a:pt x="203" y="132"/>
                  </a:lnTo>
                  <a:lnTo>
                    <a:pt x="204" y="131"/>
                  </a:lnTo>
                  <a:lnTo>
                    <a:pt x="204" y="130"/>
                  </a:lnTo>
                  <a:lnTo>
                    <a:pt x="205" y="130"/>
                  </a:lnTo>
                  <a:lnTo>
                    <a:pt x="205" y="128"/>
                  </a:lnTo>
                  <a:lnTo>
                    <a:pt x="206" y="127"/>
                  </a:lnTo>
                  <a:lnTo>
                    <a:pt x="206" y="126"/>
                  </a:lnTo>
                  <a:lnTo>
                    <a:pt x="207" y="125"/>
                  </a:lnTo>
                  <a:lnTo>
                    <a:pt x="207" y="124"/>
                  </a:lnTo>
                  <a:lnTo>
                    <a:pt x="208" y="123"/>
                  </a:lnTo>
                  <a:lnTo>
                    <a:pt x="208" y="121"/>
                  </a:lnTo>
                  <a:lnTo>
                    <a:pt x="208" y="120"/>
                  </a:lnTo>
                  <a:lnTo>
                    <a:pt x="209" y="119"/>
                  </a:lnTo>
                  <a:lnTo>
                    <a:pt x="209" y="118"/>
                  </a:lnTo>
                  <a:lnTo>
                    <a:pt x="210" y="117"/>
                  </a:lnTo>
                  <a:lnTo>
                    <a:pt x="210" y="115"/>
                  </a:lnTo>
                  <a:lnTo>
                    <a:pt x="211" y="114"/>
                  </a:lnTo>
                  <a:lnTo>
                    <a:pt x="211" y="113"/>
                  </a:lnTo>
                  <a:lnTo>
                    <a:pt x="212" y="112"/>
                  </a:lnTo>
                  <a:lnTo>
                    <a:pt x="212" y="111"/>
                  </a:lnTo>
                  <a:lnTo>
                    <a:pt x="213" y="110"/>
                  </a:lnTo>
                  <a:lnTo>
                    <a:pt x="214" y="109"/>
                  </a:lnTo>
                  <a:lnTo>
                    <a:pt x="215" y="108"/>
                  </a:lnTo>
                  <a:lnTo>
                    <a:pt x="216" y="108"/>
                  </a:lnTo>
                  <a:lnTo>
                    <a:pt x="216" y="107"/>
                  </a:lnTo>
                  <a:lnTo>
                    <a:pt x="217" y="107"/>
                  </a:lnTo>
                  <a:lnTo>
                    <a:pt x="218" y="107"/>
                  </a:lnTo>
                  <a:lnTo>
                    <a:pt x="218" y="108"/>
                  </a:lnTo>
                  <a:lnTo>
                    <a:pt x="219" y="108"/>
                  </a:lnTo>
                  <a:lnTo>
                    <a:pt x="220" y="108"/>
                  </a:lnTo>
                  <a:lnTo>
                    <a:pt x="221" y="109"/>
                  </a:lnTo>
                  <a:lnTo>
                    <a:pt x="222" y="109"/>
                  </a:lnTo>
                  <a:lnTo>
                    <a:pt x="222" y="110"/>
                  </a:lnTo>
                  <a:lnTo>
                    <a:pt x="223" y="110"/>
                  </a:lnTo>
                  <a:lnTo>
                    <a:pt x="223" y="111"/>
                  </a:lnTo>
                  <a:lnTo>
                    <a:pt x="224" y="111"/>
                  </a:lnTo>
                  <a:lnTo>
                    <a:pt x="225" y="112"/>
                  </a:lnTo>
                  <a:lnTo>
                    <a:pt x="225" y="113"/>
                  </a:lnTo>
                  <a:lnTo>
                    <a:pt x="226" y="113"/>
                  </a:lnTo>
                  <a:lnTo>
                    <a:pt x="226" y="114"/>
                  </a:lnTo>
                  <a:lnTo>
                    <a:pt x="227" y="114"/>
                  </a:lnTo>
                  <a:lnTo>
                    <a:pt x="228" y="115"/>
                  </a:lnTo>
                  <a:lnTo>
                    <a:pt x="229" y="115"/>
                  </a:lnTo>
                  <a:lnTo>
                    <a:pt x="229" y="116"/>
                  </a:lnTo>
                  <a:lnTo>
                    <a:pt x="230" y="116"/>
                  </a:lnTo>
                  <a:lnTo>
                    <a:pt x="231" y="116"/>
                  </a:lnTo>
                  <a:lnTo>
                    <a:pt x="232" y="117"/>
                  </a:lnTo>
                  <a:lnTo>
                    <a:pt x="233" y="117"/>
                  </a:lnTo>
                  <a:lnTo>
                    <a:pt x="234" y="116"/>
                  </a:lnTo>
                  <a:lnTo>
                    <a:pt x="235" y="116"/>
                  </a:lnTo>
                  <a:lnTo>
                    <a:pt x="236" y="115"/>
                  </a:lnTo>
                  <a:lnTo>
                    <a:pt x="237" y="114"/>
                  </a:lnTo>
                  <a:lnTo>
                    <a:pt x="238" y="113"/>
                  </a:lnTo>
                  <a:lnTo>
                    <a:pt x="239" y="112"/>
                  </a:lnTo>
                  <a:lnTo>
                    <a:pt x="239" y="111"/>
                  </a:lnTo>
                  <a:lnTo>
                    <a:pt x="240" y="110"/>
                  </a:lnTo>
                  <a:lnTo>
                    <a:pt x="240" y="109"/>
                  </a:lnTo>
                  <a:lnTo>
                    <a:pt x="241" y="108"/>
                  </a:lnTo>
                  <a:lnTo>
                    <a:pt x="241" y="107"/>
                  </a:lnTo>
                  <a:lnTo>
                    <a:pt x="242" y="106"/>
                  </a:lnTo>
                  <a:lnTo>
                    <a:pt x="242" y="105"/>
                  </a:lnTo>
                  <a:lnTo>
                    <a:pt x="242" y="104"/>
                  </a:lnTo>
                  <a:lnTo>
                    <a:pt x="243" y="103"/>
                  </a:lnTo>
                  <a:lnTo>
                    <a:pt x="243" y="102"/>
                  </a:lnTo>
                  <a:lnTo>
                    <a:pt x="244" y="101"/>
                  </a:lnTo>
                  <a:lnTo>
                    <a:pt x="244" y="100"/>
                  </a:lnTo>
                  <a:lnTo>
                    <a:pt x="245" y="99"/>
                  </a:lnTo>
                  <a:lnTo>
                    <a:pt x="245" y="98"/>
                  </a:lnTo>
                  <a:lnTo>
                    <a:pt x="246" y="97"/>
                  </a:lnTo>
                  <a:lnTo>
                    <a:pt x="246" y="96"/>
                  </a:lnTo>
                  <a:lnTo>
                    <a:pt x="247" y="95"/>
                  </a:lnTo>
                  <a:lnTo>
                    <a:pt x="247" y="94"/>
                  </a:lnTo>
                  <a:lnTo>
                    <a:pt x="248" y="93"/>
                  </a:lnTo>
                  <a:lnTo>
                    <a:pt x="248" y="92"/>
                  </a:lnTo>
                  <a:lnTo>
                    <a:pt x="249" y="92"/>
                  </a:lnTo>
                  <a:lnTo>
                    <a:pt x="249" y="91"/>
                  </a:lnTo>
                  <a:lnTo>
                    <a:pt x="250" y="90"/>
                  </a:lnTo>
                  <a:lnTo>
                    <a:pt x="250" y="89"/>
                  </a:lnTo>
                  <a:lnTo>
                    <a:pt x="251" y="88"/>
                  </a:lnTo>
                  <a:lnTo>
                    <a:pt x="252" y="87"/>
                  </a:lnTo>
                  <a:lnTo>
                    <a:pt x="253" y="87"/>
                  </a:lnTo>
                  <a:lnTo>
                    <a:pt x="253" y="86"/>
                  </a:lnTo>
                  <a:lnTo>
                    <a:pt x="254" y="86"/>
                  </a:lnTo>
                  <a:lnTo>
                    <a:pt x="255" y="86"/>
                  </a:lnTo>
                  <a:lnTo>
                    <a:pt x="255" y="85"/>
                  </a:lnTo>
                  <a:lnTo>
                    <a:pt x="256" y="85"/>
                  </a:lnTo>
                  <a:lnTo>
                    <a:pt x="257" y="85"/>
                  </a:lnTo>
                  <a:lnTo>
                    <a:pt x="258" y="85"/>
                  </a:lnTo>
                  <a:lnTo>
                    <a:pt x="259" y="85"/>
                  </a:lnTo>
                  <a:lnTo>
                    <a:pt x="259" y="86"/>
                  </a:lnTo>
                  <a:lnTo>
                    <a:pt x="260" y="86"/>
                  </a:lnTo>
                  <a:lnTo>
                    <a:pt x="260" y="87"/>
                  </a:lnTo>
                  <a:lnTo>
                    <a:pt x="261" y="87"/>
                  </a:lnTo>
                  <a:lnTo>
                    <a:pt x="262" y="88"/>
                  </a:lnTo>
                  <a:lnTo>
                    <a:pt x="263" y="89"/>
                  </a:lnTo>
                  <a:lnTo>
                    <a:pt x="264" y="90"/>
                  </a:lnTo>
                  <a:lnTo>
                    <a:pt x="264" y="91"/>
                  </a:lnTo>
                  <a:lnTo>
                    <a:pt x="265" y="92"/>
                  </a:lnTo>
                  <a:lnTo>
                    <a:pt x="266" y="93"/>
                  </a:lnTo>
                  <a:lnTo>
                    <a:pt x="266" y="94"/>
                  </a:lnTo>
                  <a:lnTo>
                    <a:pt x="267" y="95"/>
                  </a:lnTo>
                  <a:lnTo>
                    <a:pt x="267" y="96"/>
                  </a:lnTo>
                  <a:lnTo>
                    <a:pt x="267" y="97"/>
                  </a:lnTo>
                  <a:lnTo>
                    <a:pt x="268" y="97"/>
                  </a:lnTo>
                  <a:lnTo>
                    <a:pt x="268" y="98"/>
                  </a:lnTo>
                  <a:lnTo>
                    <a:pt x="269" y="99"/>
                  </a:lnTo>
                  <a:lnTo>
                    <a:pt x="269" y="100"/>
                  </a:lnTo>
                  <a:lnTo>
                    <a:pt x="270" y="101"/>
                  </a:lnTo>
                  <a:lnTo>
                    <a:pt x="270" y="103"/>
                  </a:lnTo>
                  <a:lnTo>
                    <a:pt x="271" y="104"/>
                  </a:lnTo>
                  <a:lnTo>
                    <a:pt x="271" y="105"/>
                  </a:lnTo>
                  <a:lnTo>
                    <a:pt x="272" y="106"/>
                  </a:lnTo>
                  <a:lnTo>
                    <a:pt x="272" y="107"/>
                  </a:lnTo>
                  <a:lnTo>
                    <a:pt x="273" y="108"/>
                  </a:lnTo>
                  <a:lnTo>
                    <a:pt x="273" y="109"/>
                  </a:lnTo>
                  <a:lnTo>
                    <a:pt x="274" y="110"/>
                  </a:lnTo>
                  <a:lnTo>
                    <a:pt x="274" y="112"/>
                  </a:lnTo>
                  <a:lnTo>
                    <a:pt x="275" y="113"/>
                  </a:lnTo>
                  <a:lnTo>
                    <a:pt x="275" y="114"/>
                  </a:lnTo>
                  <a:lnTo>
                    <a:pt x="276" y="115"/>
                  </a:lnTo>
                  <a:lnTo>
                    <a:pt x="276" y="116"/>
                  </a:lnTo>
                  <a:lnTo>
                    <a:pt x="276" y="118"/>
                  </a:lnTo>
                  <a:lnTo>
                    <a:pt x="277" y="119"/>
                  </a:lnTo>
                  <a:lnTo>
                    <a:pt x="277" y="120"/>
                  </a:lnTo>
                  <a:lnTo>
                    <a:pt x="278" y="121"/>
                  </a:lnTo>
                  <a:lnTo>
                    <a:pt x="278" y="122"/>
                  </a:lnTo>
                  <a:lnTo>
                    <a:pt x="279" y="123"/>
                  </a:lnTo>
                  <a:lnTo>
                    <a:pt x="279" y="124"/>
                  </a:lnTo>
                  <a:lnTo>
                    <a:pt x="280" y="125"/>
                  </a:lnTo>
                  <a:lnTo>
                    <a:pt x="280" y="127"/>
                  </a:lnTo>
                  <a:lnTo>
                    <a:pt x="281" y="128"/>
                  </a:lnTo>
                  <a:lnTo>
                    <a:pt x="281" y="129"/>
                  </a:lnTo>
                  <a:lnTo>
                    <a:pt x="282" y="130"/>
                  </a:lnTo>
                  <a:lnTo>
                    <a:pt x="282" y="131"/>
                  </a:lnTo>
                  <a:lnTo>
                    <a:pt x="283" y="131"/>
                  </a:lnTo>
                  <a:lnTo>
                    <a:pt x="283" y="132"/>
                  </a:lnTo>
                  <a:lnTo>
                    <a:pt x="284" y="133"/>
                  </a:lnTo>
                  <a:lnTo>
                    <a:pt x="284" y="134"/>
                  </a:lnTo>
                  <a:lnTo>
                    <a:pt x="285" y="135"/>
                  </a:lnTo>
                  <a:lnTo>
                    <a:pt x="285" y="136"/>
                  </a:lnTo>
                  <a:lnTo>
                    <a:pt x="286" y="137"/>
                  </a:lnTo>
                  <a:lnTo>
                    <a:pt x="286" y="138"/>
                  </a:lnTo>
                  <a:lnTo>
                    <a:pt x="287" y="138"/>
                  </a:lnTo>
                  <a:lnTo>
                    <a:pt x="287" y="139"/>
                  </a:lnTo>
                  <a:lnTo>
                    <a:pt x="288" y="139"/>
                  </a:lnTo>
                  <a:lnTo>
                    <a:pt x="289" y="140"/>
                  </a:lnTo>
                  <a:lnTo>
                    <a:pt x="290" y="140"/>
                  </a:lnTo>
                  <a:lnTo>
                    <a:pt x="291" y="140"/>
                  </a:lnTo>
                  <a:lnTo>
                    <a:pt x="292" y="139"/>
                  </a:lnTo>
                  <a:lnTo>
                    <a:pt x="293" y="138"/>
                  </a:lnTo>
                  <a:lnTo>
                    <a:pt x="293" y="137"/>
                  </a:lnTo>
                  <a:lnTo>
                    <a:pt x="294" y="136"/>
                  </a:lnTo>
                  <a:lnTo>
                    <a:pt x="294" y="135"/>
                  </a:lnTo>
                  <a:lnTo>
                    <a:pt x="295" y="134"/>
                  </a:lnTo>
                  <a:lnTo>
                    <a:pt x="295" y="133"/>
                  </a:lnTo>
                  <a:lnTo>
                    <a:pt x="296" y="132"/>
                  </a:lnTo>
                  <a:lnTo>
                    <a:pt x="296" y="130"/>
                  </a:lnTo>
                  <a:lnTo>
                    <a:pt x="297" y="128"/>
                  </a:lnTo>
                  <a:lnTo>
                    <a:pt x="297" y="127"/>
                  </a:lnTo>
                  <a:lnTo>
                    <a:pt x="298" y="125"/>
                  </a:lnTo>
                  <a:lnTo>
                    <a:pt x="298" y="123"/>
                  </a:lnTo>
                  <a:lnTo>
                    <a:pt x="299" y="121"/>
                  </a:lnTo>
                  <a:lnTo>
                    <a:pt x="299" y="119"/>
                  </a:lnTo>
                  <a:lnTo>
                    <a:pt x="300" y="117"/>
                  </a:lnTo>
                  <a:lnTo>
                    <a:pt x="300" y="114"/>
                  </a:lnTo>
                  <a:lnTo>
                    <a:pt x="301" y="112"/>
                  </a:lnTo>
                  <a:lnTo>
                    <a:pt x="301" y="110"/>
                  </a:lnTo>
                  <a:lnTo>
                    <a:pt x="302" y="108"/>
                  </a:lnTo>
                  <a:lnTo>
                    <a:pt x="302" y="106"/>
                  </a:lnTo>
                  <a:lnTo>
                    <a:pt x="302" y="104"/>
                  </a:lnTo>
                  <a:lnTo>
                    <a:pt x="303" y="102"/>
                  </a:lnTo>
                  <a:lnTo>
                    <a:pt x="303" y="100"/>
                  </a:lnTo>
                  <a:lnTo>
                    <a:pt x="304" y="98"/>
                  </a:lnTo>
                  <a:lnTo>
                    <a:pt x="304" y="96"/>
                  </a:lnTo>
                  <a:lnTo>
                    <a:pt x="305" y="95"/>
                  </a:lnTo>
                  <a:lnTo>
                    <a:pt x="305" y="93"/>
                  </a:lnTo>
                  <a:lnTo>
                    <a:pt x="306" y="91"/>
                  </a:lnTo>
                  <a:lnTo>
                    <a:pt x="306" y="90"/>
                  </a:lnTo>
                  <a:lnTo>
                    <a:pt x="307" y="89"/>
                  </a:lnTo>
                  <a:lnTo>
                    <a:pt x="307" y="88"/>
                  </a:lnTo>
                  <a:lnTo>
                    <a:pt x="308" y="87"/>
                  </a:lnTo>
                  <a:lnTo>
                    <a:pt x="308" y="86"/>
                  </a:lnTo>
                  <a:lnTo>
                    <a:pt x="309" y="86"/>
                  </a:lnTo>
                  <a:lnTo>
                    <a:pt x="309" y="85"/>
                  </a:lnTo>
                  <a:lnTo>
                    <a:pt x="310" y="85"/>
                  </a:lnTo>
                  <a:lnTo>
                    <a:pt x="311" y="85"/>
                  </a:lnTo>
                  <a:lnTo>
                    <a:pt x="312" y="86"/>
                  </a:lnTo>
                  <a:lnTo>
                    <a:pt x="313" y="87"/>
                  </a:lnTo>
                  <a:lnTo>
                    <a:pt x="314" y="88"/>
                  </a:lnTo>
                  <a:lnTo>
                    <a:pt x="314" y="89"/>
                  </a:lnTo>
                  <a:lnTo>
                    <a:pt x="315" y="89"/>
                  </a:lnTo>
                  <a:lnTo>
                    <a:pt x="315" y="90"/>
                  </a:lnTo>
                  <a:lnTo>
                    <a:pt x="316" y="91"/>
                  </a:lnTo>
                  <a:lnTo>
                    <a:pt x="316" y="92"/>
                  </a:lnTo>
                  <a:lnTo>
                    <a:pt x="317" y="93"/>
                  </a:lnTo>
                  <a:lnTo>
                    <a:pt x="317" y="94"/>
                  </a:lnTo>
                  <a:lnTo>
                    <a:pt x="318" y="95"/>
                  </a:lnTo>
                  <a:lnTo>
                    <a:pt x="318" y="96"/>
                  </a:lnTo>
                  <a:lnTo>
                    <a:pt x="319" y="97"/>
                  </a:lnTo>
                  <a:lnTo>
                    <a:pt x="319" y="98"/>
                  </a:lnTo>
                  <a:lnTo>
                    <a:pt x="319" y="99"/>
                  </a:lnTo>
                  <a:lnTo>
                    <a:pt x="320" y="100"/>
                  </a:lnTo>
                  <a:lnTo>
                    <a:pt x="320" y="101"/>
                  </a:lnTo>
                  <a:lnTo>
                    <a:pt x="321" y="102"/>
                  </a:lnTo>
                  <a:lnTo>
                    <a:pt x="321" y="103"/>
                  </a:lnTo>
                  <a:lnTo>
                    <a:pt x="322" y="104"/>
                  </a:lnTo>
                  <a:lnTo>
                    <a:pt x="322" y="105"/>
                  </a:lnTo>
                  <a:lnTo>
                    <a:pt x="323" y="106"/>
                  </a:lnTo>
                  <a:lnTo>
                    <a:pt x="323" y="107"/>
                  </a:lnTo>
                  <a:lnTo>
                    <a:pt x="324" y="108"/>
                  </a:lnTo>
                  <a:lnTo>
                    <a:pt x="324" y="109"/>
                  </a:lnTo>
                  <a:lnTo>
                    <a:pt x="325" y="110"/>
                  </a:lnTo>
                  <a:lnTo>
                    <a:pt x="326" y="111"/>
                  </a:lnTo>
                  <a:lnTo>
                    <a:pt x="327" y="112"/>
                  </a:lnTo>
                  <a:lnTo>
                    <a:pt x="327" y="113"/>
                  </a:lnTo>
                  <a:lnTo>
                    <a:pt x="328" y="113"/>
                  </a:lnTo>
                  <a:lnTo>
                    <a:pt x="329" y="114"/>
                  </a:lnTo>
                  <a:lnTo>
                    <a:pt x="330" y="114"/>
                  </a:lnTo>
                  <a:lnTo>
                    <a:pt x="331" y="113"/>
                  </a:lnTo>
                  <a:lnTo>
                    <a:pt x="332" y="113"/>
                  </a:lnTo>
                  <a:lnTo>
                    <a:pt x="332" y="112"/>
                  </a:lnTo>
                  <a:lnTo>
                    <a:pt x="333" y="111"/>
                  </a:lnTo>
                  <a:lnTo>
                    <a:pt x="334" y="110"/>
                  </a:lnTo>
                  <a:lnTo>
                    <a:pt x="334" y="109"/>
                  </a:lnTo>
                  <a:lnTo>
                    <a:pt x="335" y="108"/>
                  </a:lnTo>
                  <a:lnTo>
                    <a:pt x="335" y="107"/>
                  </a:lnTo>
                  <a:lnTo>
                    <a:pt x="336" y="107"/>
                  </a:lnTo>
                  <a:lnTo>
                    <a:pt x="336" y="106"/>
                  </a:lnTo>
                  <a:lnTo>
                    <a:pt x="336" y="105"/>
                  </a:lnTo>
                  <a:lnTo>
                    <a:pt x="337" y="104"/>
                  </a:lnTo>
                  <a:lnTo>
                    <a:pt x="337" y="103"/>
                  </a:lnTo>
                  <a:lnTo>
                    <a:pt x="338" y="102"/>
                  </a:lnTo>
                  <a:lnTo>
                    <a:pt x="338" y="101"/>
                  </a:lnTo>
                  <a:lnTo>
                    <a:pt x="339" y="100"/>
                  </a:lnTo>
                  <a:lnTo>
                    <a:pt x="339" y="99"/>
                  </a:lnTo>
                  <a:lnTo>
                    <a:pt x="340" y="99"/>
                  </a:lnTo>
                  <a:lnTo>
                    <a:pt x="340" y="98"/>
                  </a:lnTo>
                  <a:lnTo>
                    <a:pt x="341" y="97"/>
                  </a:lnTo>
                  <a:lnTo>
                    <a:pt x="342" y="96"/>
                  </a:lnTo>
                  <a:lnTo>
                    <a:pt x="343" y="95"/>
                  </a:lnTo>
                  <a:lnTo>
                    <a:pt x="344" y="95"/>
                  </a:lnTo>
                  <a:lnTo>
                    <a:pt x="344" y="96"/>
                  </a:lnTo>
                  <a:lnTo>
                    <a:pt x="345" y="96"/>
                  </a:lnTo>
                  <a:lnTo>
                    <a:pt x="345" y="97"/>
                  </a:lnTo>
                  <a:lnTo>
                    <a:pt x="346" y="97"/>
                  </a:lnTo>
                  <a:lnTo>
                    <a:pt x="346" y="98"/>
                  </a:lnTo>
                  <a:lnTo>
                    <a:pt x="347" y="98"/>
                  </a:lnTo>
                  <a:lnTo>
                    <a:pt x="347" y="99"/>
                  </a:lnTo>
                  <a:lnTo>
                    <a:pt x="348" y="99"/>
                  </a:lnTo>
                  <a:lnTo>
                    <a:pt x="348" y="100"/>
                  </a:lnTo>
                  <a:lnTo>
                    <a:pt x="349" y="101"/>
                  </a:lnTo>
                  <a:lnTo>
                    <a:pt x="350" y="102"/>
                  </a:lnTo>
                  <a:lnTo>
                    <a:pt x="351" y="103"/>
                  </a:lnTo>
                  <a:lnTo>
                    <a:pt x="352" y="104"/>
                  </a:lnTo>
                  <a:lnTo>
                    <a:pt x="353" y="104"/>
                  </a:lnTo>
                  <a:lnTo>
                    <a:pt x="354" y="104"/>
                  </a:lnTo>
                  <a:lnTo>
                    <a:pt x="355" y="104"/>
                  </a:lnTo>
                  <a:lnTo>
                    <a:pt x="355" y="103"/>
                  </a:lnTo>
                  <a:lnTo>
                    <a:pt x="356" y="103"/>
                  </a:lnTo>
                  <a:lnTo>
                    <a:pt x="356" y="102"/>
                  </a:lnTo>
                  <a:lnTo>
                    <a:pt x="357" y="101"/>
                  </a:lnTo>
                  <a:lnTo>
                    <a:pt x="357" y="100"/>
                  </a:lnTo>
                  <a:lnTo>
                    <a:pt x="358" y="99"/>
                  </a:lnTo>
                  <a:lnTo>
                    <a:pt x="358" y="98"/>
                  </a:lnTo>
                  <a:lnTo>
                    <a:pt x="359" y="97"/>
                  </a:lnTo>
                  <a:lnTo>
                    <a:pt x="359" y="96"/>
                  </a:lnTo>
                  <a:lnTo>
                    <a:pt x="360" y="95"/>
                  </a:lnTo>
                  <a:lnTo>
                    <a:pt x="360" y="94"/>
                  </a:lnTo>
                  <a:lnTo>
                    <a:pt x="361" y="92"/>
                  </a:lnTo>
                  <a:lnTo>
                    <a:pt x="361" y="91"/>
                  </a:lnTo>
                  <a:lnTo>
                    <a:pt x="362" y="90"/>
                  </a:lnTo>
                  <a:lnTo>
                    <a:pt x="362" y="89"/>
                  </a:lnTo>
                  <a:lnTo>
                    <a:pt x="362" y="88"/>
                  </a:lnTo>
                  <a:lnTo>
                    <a:pt x="363" y="87"/>
                  </a:lnTo>
                  <a:lnTo>
                    <a:pt x="364" y="86"/>
                  </a:lnTo>
                  <a:lnTo>
                    <a:pt x="364" y="85"/>
                  </a:lnTo>
                  <a:lnTo>
                    <a:pt x="365" y="84"/>
                  </a:lnTo>
                  <a:lnTo>
                    <a:pt x="366" y="83"/>
                  </a:lnTo>
                  <a:lnTo>
                    <a:pt x="367" y="83"/>
                  </a:lnTo>
                  <a:lnTo>
                    <a:pt x="367" y="84"/>
                  </a:lnTo>
                  <a:lnTo>
                    <a:pt x="368" y="84"/>
                  </a:lnTo>
                  <a:lnTo>
                    <a:pt x="368" y="85"/>
                  </a:lnTo>
                  <a:lnTo>
                    <a:pt x="369" y="85"/>
                  </a:lnTo>
                  <a:lnTo>
                    <a:pt x="369" y="86"/>
                  </a:lnTo>
                  <a:lnTo>
                    <a:pt x="370" y="87"/>
                  </a:lnTo>
                  <a:lnTo>
                    <a:pt x="370" y="88"/>
                  </a:lnTo>
                  <a:lnTo>
                    <a:pt x="371" y="89"/>
                  </a:lnTo>
                  <a:lnTo>
                    <a:pt x="371" y="90"/>
                  </a:lnTo>
                  <a:lnTo>
                    <a:pt x="372" y="91"/>
                  </a:lnTo>
                  <a:lnTo>
                    <a:pt x="372" y="92"/>
                  </a:lnTo>
                  <a:lnTo>
                    <a:pt x="373" y="93"/>
                  </a:lnTo>
                  <a:lnTo>
                    <a:pt x="373" y="94"/>
                  </a:lnTo>
                  <a:lnTo>
                    <a:pt x="374" y="95"/>
                  </a:lnTo>
                  <a:lnTo>
                    <a:pt x="374" y="96"/>
                  </a:lnTo>
                  <a:lnTo>
                    <a:pt x="375" y="97"/>
                  </a:lnTo>
                  <a:lnTo>
                    <a:pt x="375" y="98"/>
                  </a:lnTo>
                  <a:lnTo>
                    <a:pt x="376" y="99"/>
                  </a:lnTo>
                  <a:lnTo>
                    <a:pt x="376" y="100"/>
                  </a:lnTo>
                  <a:lnTo>
                    <a:pt x="377" y="101"/>
                  </a:lnTo>
                  <a:lnTo>
                    <a:pt x="377" y="102"/>
                  </a:lnTo>
                  <a:lnTo>
                    <a:pt x="378" y="102"/>
                  </a:lnTo>
                  <a:lnTo>
                    <a:pt x="378" y="103"/>
                  </a:lnTo>
                  <a:lnTo>
                    <a:pt x="379" y="103"/>
                  </a:lnTo>
                  <a:lnTo>
                    <a:pt x="380" y="103"/>
                  </a:lnTo>
                  <a:lnTo>
                    <a:pt x="381" y="103"/>
                  </a:lnTo>
                  <a:lnTo>
                    <a:pt x="382" y="102"/>
                  </a:lnTo>
                  <a:lnTo>
                    <a:pt x="383" y="102"/>
                  </a:lnTo>
                  <a:lnTo>
                    <a:pt x="383" y="101"/>
                  </a:lnTo>
                  <a:lnTo>
                    <a:pt x="384" y="101"/>
                  </a:lnTo>
                  <a:lnTo>
                    <a:pt x="384" y="100"/>
                  </a:lnTo>
                  <a:lnTo>
                    <a:pt x="385" y="100"/>
                  </a:lnTo>
                  <a:lnTo>
                    <a:pt x="385" y="99"/>
                  </a:lnTo>
                  <a:lnTo>
                    <a:pt x="386" y="99"/>
                  </a:lnTo>
                  <a:lnTo>
                    <a:pt x="386" y="98"/>
                  </a:lnTo>
                  <a:lnTo>
                    <a:pt x="387" y="98"/>
                  </a:lnTo>
                  <a:lnTo>
                    <a:pt x="387" y="97"/>
                  </a:lnTo>
                  <a:lnTo>
                    <a:pt x="388" y="97"/>
                  </a:lnTo>
                  <a:lnTo>
                    <a:pt x="388" y="96"/>
                  </a:lnTo>
                  <a:lnTo>
                    <a:pt x="389" y="96"/>
                  </a:lnTo>
                  <a:lnTo>
                    <a:pt x="390" y="95"/>
                  </a:lnTo>
                  <a:lnTo>
                    <a:pt x="391" y="96"/>
                  </a:lnTo>
                  <a:lnTo>
                    <a:pt x="392" y="96"/>
                  </a:lnTo>
                  <a:lnTo>
                    <a:pt x="393" y="96"/>
                  </a:lnTo>
                  <a:lnTo>
                    <a:pt x="393" y="97"/>
                  </a:lnTo>
                  <a:lnTo>
                    <a:pt x="394" y="97"/>
                  </a:lnTo>
                  <a:lnTo>
                    <a:pt x="394" y="98"/>
                  </a:lnTo>
                  <a:lnTo>
                    <a:pt x="395" y="98"/>
                  </a:lnTo>
                  <a:lnTo>
                    <a:pt x="396" y="99"/>
                  </a:lnTo>
                  <a:lnTo>
                    <a:pt x="396" y="100"/>
                  </a:lnTo>
                  <a:lnTo>
                    <a:pt x="397" y="100"/>
                  </a:lnTo>
                  <a:lnTo>
                    <a:pt x="397" y="101"/>
                  </a:lnTo>
                  <a:lnTo>
                    <a:pt x="398" y="101"/>
                  </a:lnTo>
                  <a:lnTo>
                    <a:pt x="399" y="102"/>
                  </a:lnTo>
                  <a:lnTo>
                    <a:pt x="400" y="102"/>
                  </a:lnTo>
                  <a:lnTo>
                    <a:pt x="401" y="103"/>
                  </a:lnTo>
                  <a:lnTo>
                    <a:pt x="402" y="103"/>
                  </a:lnTo>
                  <a:lnTo>
                    <a:pt x="403" y="102"/>
                  </a:lnTo>
                  <a:lnTo>
                    <a:pt x="404" y="102"/>
                  </a:lnTo>
                  <a:lnTo>
                    <a:pt x="404" y="101"/>
                  </a:lnTo>
                  <a:lnTo>
                    <a:pt x="405" y="101"/>
                  </a:lnTo>
                  <a:lnTo>
                    <a:pt x="405" y="100"/>
                  </a:lnTo>
                  <a:lnTo>
                    <a:pt x="406" y="100"/>
                  </a:lnTo>
                  <a:lnTo>
                    <a:pt x="407" y="99"/>
                  </a:lnTo>
                  <a:lnTo>
                    <a:pt x="408" y="99"/>
                  </a:lnTo>
                  <a:lnTo>
                    <a:pt x="408" y="98"/>
                  </a:lnTo>
                  <a:lnTo>
                    <a:pt x="409" y="98"/>
                  </a:lnTo>
                  <a:lnTo>
                    <a:pt x="410" y="97"/>
                  </a:lnTo>
                  <a:lnTo>
                    <a:pt x="411" y="97"/>
                  </a:lnTo>
                  <a:lnTo>
                    <a:pt x="412" y="97"/>
                  </a:lnTo>
                  <a:lnTo>
                    <a:pt x="413" y="98"/>
                  </a:lnTo>
                  <a:lnTo>
                    <a:pt x="414" y="99"/>
                  </a:lnTo>
                  <a:lnTo>
                    <a:pt x="414" y="100"/>
                  </a:lnTo>
                  <a:lnTo>
                    <a:pt x="415" y="101"/>
                  </a:lnTo>
                  <a:lnTo>
                    <a:pt x="415" y="102"/>
                  </a:lnTo>
                  <a:lnTo>
                    <a:pt x="416" y="103"/>
                  </a:lnTo>
                  <a:lnTo>
                    <a:pt x="416" y="104"/>
                  </a:lnTo>
                  <a:lnTo>
                    <a:pt x="417" y="105"/>
                  </a:lnTo>
                  <a:lnTo>
                    <a:pt x="417" y="106"/>
                  </a:lnTo>
                  <a:lnTo>
                    <a:pt x="418" y="108"/>
                  </a:lnTo>
                  <a:lnTo>
                    <a:pt x="418" y="109"/>
                  </a:lnTo>
                  <a:lnTo>
                    <a:pt x="419" y="111"/>
                  </a:lnTo>
                  <a:lnTo>
                    <a:pt x="419" y="112"/>
                  </a:lnTo>
                  <a:lnTo>
                    <a:pt x="420" y="113"/>
                  </a:lnTo>
                  <a:lnTo>
                    <a:pt x="420" y="115"/>
                  </a:lnTo>
                  <a:lnTo>
                    <a:pt x="421" y="116"/>
                  </a:lnTo>
                  <a:lnTo>
                    <a:pt x="421" y="118"/>
                  </a:lnTo>
                  <a:lnTo>
                    <a:pt x="422" y="119"/>
                  </a:lnTo>
                  <a:lnTo>
                    <a:pt x="422" y="120"/>
                  </a:lnTo>
                  <a:lnTo>
                    <a:pt x="422" y="122"/>
                  </a:lnTo>
                  <a:lnTo>
                    <a:pt x="423" y="123"/>
                  </a:lnTo>
                  <a:lnTo>
                    <a:pt x="423" y="124"/>
                  </a:lnTo>
                  <a:lnTo>
                    <a:pt x="424" y="125"/>
                  </a:lnTo>
                  <a:lnTo>
                    <a:pt x="424" y="127"/>
                  </a:lnTo>
                  <a:lnTo>
                    <a:pt x="425" y="128"/>
                  </a:lnTo>
                  <a:lnTo>
                    <a:pt x="425" y="129"/>
                  </a:lnTo>
                  <a:lnTo>
                    <a:pt x="426" y="129"/>
                  </a:lnTo>
                  <a:lnTo>
                    <a:pt x="426" y="130"/>
                  </a:lnTo>
                  <a:lnTo>
                    <a:pt x="427" y="131"/>
                  </a:lnTo>
                  <a:lnTo>
                    <a:pt x="428" y="132"/>
                  </a:lnTo>
                  <a:lnTo>
                    <a:pt x="429" y="132"/>
                  </a:lnTo>
                  <a:lnTo>
                    <a:pt x="429" y="133"/>
                  </a:lnTo>
                  <a:lnTo>
                    <a:pt x="430" y="133"/>
                  </a:lnTo>
                  <a:lnTo>
                    <a:pt x="431" y="133"/>
                  </a:lnTo>
                  <a:lnTo>
                    <a:pt x="432" y="133"/>
                  </a:lnTo>
                  <a:lnTo>
                    <a:pt x="433" y="133"/>
                  </a:lnTo>
                  <a:lnTo>
                    <a:pt x="434" y="133"/>
                  </a:lnTo>
                  <a:lnTo>
                    <a:pt x="435" y="133"/>
                  </a:lnTo>
                  <a:lnTo>
                    <a:pt x="436" y="133"/>
                  </a:lnTo>
                  <a:lnTo>
                    <a:pt x="437" y="133"/>
                  </a:lnTo>
                  <a:lnTo>
                    <a:pt x="438" y="133"/>
                  </a:lnTo>
                  <a:lnTo>
                    <a:pt x="439" y="134"/>
                  </a:lnTo>
                  <a:lnTo>
                    <a:pt x="440" y="134"/>
                  </a:lnTo>
                  <a:lnTo>
                    <a:pt x="440" y="135"/>
                  </a:lnTo>
                  <a:lnTo>
                    <a:pt x="441" y="135"/>
                  </a:lnTo>
                  <a:lnTo>
                    <a:pt x="442" y="135"/>
                  </a:lnTo>
                  <a:lnTo>
                    <a:pt x="442" y="136"/>
                  </a:lnTo>
                  <a:lnTo>
                    <a:pt x="443" y="136"/>
                  </a:lnTo>
                  <a:lnTo>
                    <a:pt x="444" y="137"/>
                  </a:lnTo>
                  <a:lnTo>
                    <a:pt x="445" y="137"/>
                  </a:lnTo>
                  <a:lnTo>
                    <a:pt x="445" y="138"/>
                  </a:lnTo>
                  <a:lnTo>
                    <a:pt x="446" y="138"/>
                  </a:lnTo>
                  <a:lnTo>
                    <a:pt x="446" y="139"/>
                  </a:lnTo>
                  <a:lnTo>
                    <a:pt x="447" y="139"/>
                  </a:lnTo>
                  <a:lnTo>
                    <a:pt x="447" y="140"/>
                  </a:lnTo>
                  <a:lnTo>
                    <a:pt x="448" y="140"/>
                  </a:lnTo>
                  <a:lnTo>
                    <a:pt x="449" y="141"/>
                  </a:lnTo>
                  <a:lnTo>
                    <a:pt x="450" y="141"/>
                  </a:lnTo>
                  <a:lnTo>
                    <a:pt x="450" y="142"/>
                  </a:lnTo>
                  <a:lnTo>
                    <a:pt x="451" y="142"/>
                  </a:lnTo>
                  <a:lnTo>
                    <a:pt x="452" y="143"/>
                  </a:lnTo>
                  <a:lnTo>
                    <a:pt x="453" y="143"/>
                  </a:lnTo>
                  <a:lnTo>
                    <a:pt x="454" y="144"/>
                  </a:lnTo>
                  <a:lnTo>
                    <a:pt x="455" y="144"/>
                  </a:lnTo>
                  <a:lnTo>
                    <a:pt x="456" y="144"/>
                  </a:lnTo>
                  <a:lnTo>
                    <a:pt x="456" y="145"/>
                  </a:lnTo>
                  <a:lnTo>
                    <a:pt x="457" y="145"/>
                  </a:lnTo>
                  <a:lnTo>
                    <a:pt x="458" y="145"/>
                  </a:lnTo>
                  <a:lnTo>
                    <a:pt x="459" y="144"/>
                  </a:lnTo>
                  <a:lnTo>
                    <a:pt x="460" y="144"/>
                  </a:lnTo>
                  <a:lnTo>
                    <a:pt x="461" y="144"/>
                  </a:lnTo>
                  <a:lnTo>
                    <a:pt x="461" y="143"/>
                  </a:lnTo>
                  <a:lnTo>
                    <a:pt x="462" y="143"/>
                  </a:lnTo>
                  <a:lnTo>
                    <a:pt x="462" y="142"/>
                  </a:lnTo>
                  <a:lnTo>
                    <a:pt x="463" y="142"/>
                  </a:lnTo>
                  <a:lnTo>
                    <a:pt x="463" y="141"/>
                  </a:lnTo>
                  <a:lnTo>
                    <a:pt x="464" y="141"/>
                  </a:lnTo>
                  <a:lnTo>
                    <a:pt x="464" y="140"/>
                  </a:lnTo>
                  <a:lnTo>
                    <a:pt x="465" y="139"/>
                  </a:lnTo>
                  <a:lnTo>
                    <a:pt x="466" y="138"/>
                  </a:lnTo>
                  <a:lnTo>
                    <a:pt x="467" y="137"/>
                  </a:lnTo>
                  <a:lnTo>
                    <a:pt x="468" y="136"/>
                  </a:lnTo>
                  <a:lnTo>
                    <a:pt x="469" y="136"/>
                  </a:lnTo>
                  <a:lnTo>
                    <a:pt x="470" y="135"/>
                  </a:lnTo>
                  <a:lnTo>
                    <a:pt x="471" y="135"/>
                  </a:lnTo>
                  <a:lnTo>
                    <a:pt x="472" y="136"/>
                  </a:lnTo>
                  <a:lnTo>
                    <a:pt x="473" y="136"/>
                  </a:lnTo>
                  <a:lnTo>
                    <a:pt x="473" y="137"/>
                  </a:lnTo>
                  <a:lnTo>
                    <a:pt x="473" y="138"/>
                  </a:lnTo>
                  <a:lnTo>
                    <a:pt x="474" y="139"/>
                  </a:lnTo>
                  <a:lnTo>
                    <a:pt x="475" y="141"/>
                  </a:lnTo>
                  <a:lnTo>
                    <a:pt x="475" y="142"/>
                  </a:lnTo>
                  <a:lnTo>
                    <a:pt x="476" y="143"/>
                  </a:lnTo>
                  <a:lnTo>
                    <a:pt x="476" y="144"/>
                  </a:lnTo>
                  <a:lnTo>
                    <a:pt x="477" y="145"/>
                  </a:lnTo>
                  <a:lnTo>
                    <a:pt x="477" y="146"/>
                  </a:lnTo>
                  <a:lnTo>
                    <a:pt x="478" y="148"/>
                  </a:lnTo>
                  <a:lnTo>
                    <a:pt x="478" y="149"/>
                  </a:lnTo>
                  <a:lnTo>
                    <a:pt x="479" y="150"/>
                  </a:lnTo>
                  <a:lnTo>
                    <a:pt x="479" y="151"/>
                  </a:lnTo>
                  <a:lnTo>
                    <a:pt x="480" y="152"/>
                  </a:lnTo>
                  <a:lnTo>
                    <a:pt x="480" y="153"/>
                  </a:lnTo>
                  <a:lnTo>
                    <a:pt x="481" y="155"/>
                  </a:lnTo>
                  <a:lnTo>
                    <a:pt x="481" y="156"/>
                  </a:lnTo>
                  <a:lnTo>
                    <a:pt x="481" y="157"/>
                  </a:lnTo>
                  <a:lnTo>
                    <a:pt x="482" y="157"/>
                  </a:lnTo>
                  <a:lnTo>
                    <a:pt x="482" y="158"/>
                  </a:lnTo>
                  <a:lnTo>
                    <a:pt x="483" y="159"/>
                  </a:lnTo>
                  <a:lnTo>
                    <a:pt x="483" y="160"/>
                  </a:lnTo>
                  <a:lnTo>
                    <a:pt x="484" y="160"/>
                  </a:lnTo>
                  <a:lnTo>
                    <a:pt x="485" y="160"/>
                  </a:lnTo>
                  <a:lnTo>
                    <a:pt x="486" y="160"/>
                  </a:lnTo>
                  <a:lnTo>
                    <a:pt x="487" y="159"/>
                  </a:lnTo>
                  <a:lnTo>
                    <a:pt x="488" y="158"/>
                  </a:lnTo>
                  <a:lnTo>
                    <a:pt x="489" y="157"/>
                  </a:lnTo>
                  <a:lnTo>
                    <a:pt x="489" y="156"/>
                  </a:lnTo>
                  <a:lnTo>
                    <a:pt x="490" y="155"/>
                  </a:lnTo>
                  <a:lnTo>
                    <a:pt x="490" y="154"/>
                  </a:lnTo>
                  <a:lnTo>
                    <a:pt x="491" y="153"/>
                  </a:lnTo>
                  <a:lnTo>
                    <a:pt x="491" y="152"/>
                  </a:lnTo>
                  <a:lnTo>
                    <a:pt x="492" y="151"/>
                  </a:lnTo>
                  <a:lnTo>
                    <a:pt x="492" y="150"/>
                  </a:lnTo>
                  <a:lnTo>
                    <a:pt x="493" y="149"/>
                  </a:lnTo>
                  <a:lnTo>
                    <a:pt x="494" y="148"/>
                  </a:lnTo>
                  <a:lnTo>
                    <a:pt x="494" y="147"/>
                  </a:lnTo>
                  <a:lnTo>
                    <a:pt x="495" y="147"/>
                  </a:lnTo>
                  <a:lnTo>
                    <a:pt x="495" y="146"/>
                  </a:lnTo>
                  <a:lnTo>
                    <a:pt x="496" y="146"/>
                  </a:lnTo>
                  <a:lnTo>
                    <a:pt x="496" y="145"/>
                  </a:lnTo>
                  <a:lnTo>
                    <a:pt x="497" y="145"/>
                  </a:lnTo>
                  <a:lnTo>
                    <a:pt x="498" y="145"/>
                  </a:lnTo>
                  <a:lnTo>
                    <a:pt x="499" y="146"/>
                  </a:lnTo>
                  <a:lnTo>
                    <a:pt x="500" y="147"/>
                  </a:lnTo>
                  <a:lnTo>
                    <a:pt x="501" y="148"/>
                  </a:lnTo>
                  <a:lnTo>
                    <a:pt x="501" y="149"/>
                  </a:lnTo>
                  <a:lnTo>
                    <a:pt x="502" y="149"/>
                  </a:lnTo>
                  <a:lnTo>
                    <a:pt x="502" y="150"/>
                  </a:lnTo>
                  <a:lnTo>
                    <a:pt x="503" y="151"/>
                  </a:lnTo>
                  <a:lnTo>
                    <a:pt x="503" y="152"/>
                  </a:lnTo>
                  <a:lnTo>
                    <a:pt x="504" y="153"/>
                  </a:lnTo>
                  <a:lnTo>
                    <a:pt x="504" y="154"/>
                  </a:lnTo>
                  <a:lnTo>
                    <a:pt x="505" y="155"/>
                  </a:lnTo>
                  <a:lnTo>
                    <a:pt x="505" y="156"/>
                  </a:lnTo>
                  <a:lnTo>
                    <a:pt x="506" y="157"/>
                  </a:lnTo>
                  <a:lnTo>
                    <a:pt x="506" y="158"/>
                  </a:lnTo>
                  <a:lnTo>
                    <a:pt x="507" y="160"/>
                  </a:lnTo>
                  <a:lnTo>
                    <a:pt x="507" y="161"/>
                  </a:lnTo>
                  <a:lnTo>
                    <a:pt x="507" y="162"/>
                  </a:lnTo>
                  <a:lnTo>
                    <a:pt x="508" y="163"/>
                  </a:lnTo>
                  <a:lnTo>
                    <a:pt x="508" y="165"/>
                  </a:lnTo>
                  <a:lnTo>
                    <a:pt x="509" y="166"/>
                  </a:lnTo>
                  <a:lnTo>
                    <a:pt x="509" y="167"/>
                  </a:lnTo>
                  <a:lnTo>
                    <a:pt x="510" y="168"/>
                  </a:lnTo>
                  <a:lnTo>
                    <a:pt x="510" y="170"/>
                  </a:lnTo>
                  <a:lnTo>
                    <a:pt x="511" y="171"/>
                  </a:lnTo>
                  <a:lnTo>
                    <a:pt x="511" y="172"/>
                  </a:lnTo>
                  <a:lnTo>
                    <a:pt x="512" y="173"/>
                  </a:lnTo>
                  <a:lnTo>
                    <a:pt x="512" y="175"/>
                  </a:lnTo>
                  <a:lnTo>
                    <a:pt x="513" y="176"/>
                  </a:lnTo>
                  <a:lnTo>
                    <a:pt x="513" y="177"/>
                  </a:lnTo>
                  <a:lnTo>
                    <a:pt x="514" y="178"/>
                  </a:lnTo>
                  <a:lnTo>
                    <a:pt x="514" y="179"/>
                  </a:lnTo>
                  <a:lnTo>
                    <a:pt x="515" y="180"/>
                  </a:lnTo>
                  <a:lnTo>
                    <a:pt x="515" y="181"/>
                  </a:lnTo>
                  <a:lnTo>
                    <a:pt x="516" y="182"/>
                  </a:lnTo>
                  <a:lnTo>
                    <a:pt x="516" y="183"/>
                  </a:lnTo>
                  <a:lnTo>
                    <a:pt x="517" y="183"/>
                  </a:lnTo>
                  <a:lnTo>
                    <a:pt x="517" y="184"/>
                  </a:lnTo>
                  <a:lnTo>
                    <a:pt x="518" y="184"/>
                  </a:lnTo>
                  <a:lnTo>
                    <a:pt x="518" y="185"/>
                  </a:lnTo>
                  <a:lnTo>
                    <a:pt x="519" y="185"/>
                  </a:lnTo>
                  <a:lnTo>
                    <a:pt x="520" y="185"/>
                  </a:lnTo>
                  <a:lnTo>
                    <a:pt x="520" y="184"/>
                  </a:lnTo>
                  <a:lnTo>
                    <a:pt x="521" y="184"/>
                  </a:lnTo>
                  <a:lnTo>
                    <a:pt x="521" y="183"/>
                  </a:lnTo>
                  <a:lnTo>
                    <a:pt x="522" y="182"/>
                  </a:lnTo>
                  <a:lnTo>
                    <a:pt x="522" y="181"/>
                  </a:lnTo>
                  <a:lnTo>
                    <a:pt x="523" y="180"/>
                  </a:lnTo>
                  <a:lnTo>
                    <a:pt x="523" y="179"/>
                  </a:lnTo>
                  <a:lnTo>
                    <a:pt x="524" y="178"/>
                  </a:lnTo>
                  <a:lnTo>
                    <a:pt x="524" y="177"/>
                  </a:lnTo>
                  <a:lnTo>
                    <a:pt x="524" y="176"/>
                  </a:lnTo>
                  <a:lnTo>
                    <a:pt x="525" y="175"/>
                  </a:lnTo>
                  <a:lnTo>
                    <a:pt x="525" y="173"/>
                  </a:lnTo>
                  <a:lnTo>
                    <a:pt x="526" y="172"/>
                  </a:lnTo>
                  <a:lnTo>
                    <a:pt x="526" y="171"/>
                  </a:lnTo>
                  <a:lnTo>
                    <a:pt x="527" y="169"/>
                  </a:lnTo>
                  <a:lnTo>
                    <a:pt x="527" y="168"/>
                  </a:lnTo>
                  <a:lnTo>
                    <a:pt x="528" y="167"/>
                  </a:lnTo>
                  <a:lnTo>
                    <a:pt x="528" y="165"/>
                  </a:lnTo>
                  <a:lnTo>
                    <a:pt x="529" y="164"/>
                  </a:lnTo>
                  <a:lnTo>
                    <a:pt x="529" y="163"/>
                  </a:lnTo>
                  <a:lnTo>
                    <a:pt x="530" y="162"/>
                  </a:lnTo>
                  <a:lnTo>
                    <a:pt x="530" y="160"/>
                  </a:lnTo>
                  <a:lnTo>
                    <a:pt x="531" y="159"/>
                  </a:lnTo>
                  <a:lnTo>
                    <a:pt x="531" y="158"/>
                  </a:lnTo>
                  <a:lnTo>
                    <a:pt x="532" y="157"/>
                  </a:lnTo>
                  <a:lnTo>
                    <a:pt x="533" y="156"/>
                  </a:lnTo>
                  <a:lnTo>
                    <a:pt x="534" y="156"/>
                  </a:lnTo>
                  <a:lnTo>
                    <a:pt x="534" y="155"/>
                  </a:lnTo>
                  <a:lnTo>
                    <a:pt x="535" y="155"/>
                  </a:lnTo>
                  <a:lnTo>
                    <a:pt x="536" y="155"/>
                  </a:lnTo>
                  <a:lnTo>
                    <a:pt x="537" y="155"/>
                  </a:lnTo>
                  <a:lnTo>
                    <a:pt x="537" y="154"/>
                  </a:lnTo>
                  <a:lnTo>
                    <a:pt x="538" y="154"/>
                  </a:lnTo>
                  <a:lnTo>
                    <a:pt x="539" y="154"/>
                  </a:lnTo>
                  <a:lnTo>
                    <a:pt x="539" y="153"/>
                  </a:lnTo>
                  <a:lnTo>
                    <a:pt x="540" y="153"/>
                  </a:lnTo>
                  <a:lnTo>
                    <a:pt x="541" y="152"/>
                  </a:lnTo>
                  <a:lnTo>
                    <a:pt x="541" y="151"/>
                  </a:lnTo>
                  <a:lnTo>
                    <a:pt x="542" y="150"/>
                  </a:lnTo>
                  <a:lnTo>
                    <a:pt x="542" y="149"/>
                  </a:lnTo>
                  <a:lnTo>
                    <a:pt x="543" y="148"/>
                  </a:lnTo>
                  <a:lnTo>
                    <a:pt x="543" y="147"/>
                  </a:lnTo>
                  <a:lnTo>
                    <a:pt x="544" y="145"/>
                  </a:lnTo>
                  <a:lnTo>
                    <a:pt x="544" y="143"/>
                  </a:lnTo>
                  <a:lnTo>
                    <a:pt x="545" y="141"/>
                  </a:lnTo>
                  <a:lnTo>
                    <a:pt x="545" y="139"/>
                  </a:lnTo>
                  <a:lnTo>
                    <a:pt x="546" y="137"/>
                  </a:lnTo>
                  <a:lnTo>
                    <a:pt x="546" y="135"/>
                  </a:lnTo>
                  <a:lnTo>
                    <a:pt x="547" y="132"/>
                  </a:lnTo>
                  <a:lnTo>
                    <a:pt x="547" y="130"/>
                  </a:lnTo>
                  <a:lnTo>
                    <a:pt x="548" y="128"/>
                  </a:lnTo>
                  <a:lnTo>
                    <a:pt x="548" y="126"/>
                  </a:lnTo>
                  <a:lnTo>
                    <a:pt x="549" y="123"/>
                  </a:lnTo>
                  <a:lnTo>
                    <a:pt x="549" y="121"/>
                  </a:lnTo>
                  <a:lnTo>
                    <a:pt x="550" y="119"/>
                  </a:lnTo>
                  <a:lnTo>
                    <a:pt x="550" y="117"/>
                  </a:lnTo>
                  <a:lnTo>
                    <a:pt x="550" y="115"/>
                  </a:lnTo>
                  <a:lnTo>
                    <a:pt x="551" y="114"/>
                  </a:lnTo>
                  <a:lnTo>
                    <a:pt x="551" y="112"/>
                  </a:lnTo>
                  <a:lnTo>
                    <a:pt x="552" y="111"/>
                  </a:lnTo>
                  <a:lnTo>
                    <a:pt x="552" y="110"/>
                  </a:lnTo>
                  <a:lnTo>
                    <a:pt x="553" y="109"/>
                  </a:lnTo>
                  <a:lnTo>
                    <a:pt x="553" y="108"/>
                  </a:lnTo>
                  <a:lnTo>
                    <a:pt x="554" y="107"/>
                  </a:lnTo>
                  <a:lnTo>
                    <a:pt x="555" y="107"/>
                  </a:lnTo>
                  <a:lnTo>
                    <a:pt x="556" y="109"/>
                  </a:lnTo>
                  <a:lnTo>
                    <a:pt x="556" y="110"/>
                  </a:lnTo>
                  <a:lnTo>
                    <a:pt x="557" y="112"/>
                  </a:lnTo>
                  <a:lnTo>
                    <a:pt x="557" y="114"/>
                  </a:lnTo>
                  <a:lnTo>
                    <a:pt x="558" y="117"/>
                  </a:lnTo>
                  <a:lnTo>
                    <a:pt x="558" y="119"/>
                  </a:lnTo>
                  <a:lnTo>
                    <a:pt x="558" y="122"/>
                  </a:lnTo>
                  <a:lnTo>
                    <a:pt x="559" y="125"/>
                  </a:lnTo>
                  <a:lnTo>
                    <a:pt x="559" y="128"/>
                  </a:lnTo>
                  <a:lnTo>
                    <a:pt x="560" y="131"/>
                  </a:lnTo>
                  <a:lnTo>
                    <a:pt x="560" y="134"/>
                  </a:lnTo>
                  <a:lnTo>
                    <a:pt x="561" y="138"/>
                  </a:lnTo>
                  <a:lnTo>
                    <a:pt x="561" y="141"/>
                  </a:lnTo>
                  <a:lnTo>
                    <a:pt x="562" y="144"/>
                  </a:lnTo>
                  <a:lnTo>
                    <a:pt x="562" y="148"/>
                  </a:lnTo>
                  <a:lnTo>
                    <a:pt x="563" y="151"/>
                  </a:lnTo>
                  <a:lnTo>
                    <a:pt x="563" y="155"/>
                  </a:lnTo>
                  <a:lnTo>
                    <a:pt x="564" y="158"/>
                  </a:lnTo>
                  <a:lnTo>
                    <a:pt x="564" y="161"/>
                  </a:lnTo>
                  <a:lnTo>
                    <a:pt x="565" y="164"/>
                  </a:lnTo>
                  <a:lnTo>
                    <a:pt x="565" y="167"/>
                  </a:lnTo>
                  <a:lnTo>
                    <a:pt x="566" y="170"/>
                  </a:lnTo>
                  <a:lnTo>
                    <a:pt x="566" y="172"/>
                  </a:lnTo>
                  <a:lnTo>
                    <a:pt x="567" y="175"/>
                  </a:lnTo>
                  <a:lnTo>
                    <a:pt x="567" y="177"/>
                  </a:lnTo>
                  <a:lnTo>
                    <a:pt x="567" y="178"/>
                  </a:lnTo>
                  <a:lnTo>
                    <a:pt x="568" y="179"/>
                  </a:lnTo>
                  <a:lnTo>
                    <a:pt x="568" y="180"/>
                  </a:lnTo>
                  <a:lnTo>
                    <a:pt x="569" y="180"/>
                  </a:lnTo>
                  <a:lnTo>
                    <a:pt x="569" y="181"/>
                  </a:lnTo>
                  <a:lnTo>
                    <a:pt x="570" y="181"/>
                  </a:lnTo>
                  <a:lnTo>
                    <a:pt x="571" y="181"/>
                  </a:lnTo>
                  <a:lnTo>
                    <a:pt x="572" y="181"/>
                  </a:lnTo>
                  <a:lnTo>
                    <a:pt x="572" y="180"/>
                  </a:lnTo>
                  <a:lnTo>
                    <a:pt x="573" y="180"/>
                  </a:lnTo>
                  <a:lnTo>
                    <a:pt x="574" y="179"/>
                  </a:lnTo>
                  <a:lnTo>
                    <a:pt x="575" y="179"/>
                  </a:lnTo>
                  <a:lnTo>
                    <a:pt x="575" y="178"/>
                  </a:lnTo>
                  <a:lnTo>
                    <a:pt x="576" y="178"/>
                  </a:lnTo>
                  <a:lnTo>
                    <a:pt x="577" y="178"/>
                  </a:lnTo>
                  <a:lnTo>
                    <a:pt x="578" y="179"/>
                  </a:lnTo>
                  <a:lnTo>
                    <a:pt x="579" y="180"/>
                  </a:lnTo>
                  <a:lnTo>
                    <a:pt x="579" y="182"/>
                  </a:lnTo>
                  <a:lnTo>
                    <a:pt x="580" y="184"/>
                  </a:lnTo>
                  <a:lnTo>
                    <a:pt x="580" y="186"/>
                  </a:lnTo>
                  <a:lnTo>
                    <a:pt x="581" y="188"/>
                  </a:lnTo>
                  <a:lnTo>
                    <a:pt x="581" y="191"/>
                  </a:lnTo>
                  <a:lnTo>
                    <a:pt x="582" y="193"/>
                  </a:lnTo>
                  <a:lnTo>
                    <a:pt x="582" y="196"/>
                  </a:lnTo>
                  <a:lnTo>
                    <a:pt x="583" y="199"/>
                  </a:lnTo>
                  <a:lnTo>
                    <a:pt x="583" y="201"/>
                  </a:lnTo>
                  <a:lnTo>
                    <a:pt x="584" y="204"/>
                  </a:lnTo>
                  <a:lnTo>
                    <a:pt x="584" y="206"/>
                  </a:lnTo>
                  <a:lnTo>
                    <a:pt x="584" y="208"/>
                  </a:lnTo>
                  <a:lnTo>
                    <a:pt x="585" y="211"/>
                  </a:lnTo>
                  <a:lnTo>
                    <a:pt x="585" y="213"/>
                  </a:lnTo>
                  <a:lnTo>
                    <a:pt x="586" y="215"/>
                  </a:lnTo>
                  <a:lnTo>
                    <a:pt x="586" y="216"/>
                  </a:lnTo>
                  <a:lnTo>
                    <a:pt x="587" y="218"/>
                  </a:lnTo>
                  <a:lnTo>
                    <a:pt x="587" y="219"/>
                  </a:lnTo>
                  <a:lnTo>
                    <a:pt x="588" y="220"/>
                  </a:lnTo>
                  <a:lnTo>
                    <a:pt x="588" y="221"/>
                  </a:lnTo>
                  <a:lnTo>
                    <a:pt x="589" y="221"/>
                  </a:lnTo>
                  <a:lnTo>
                    <a:pt x="590" y="220"/>
                  </a:lnTo>
                  <a:lnTo>
                    <a:pt x="590" y="219"/>
                  </a:lnTo>
                  <a:lnTo>
                    <a:pt x="591" y="218"/>
                  </a:lnTo>
                  <a:lnTo>
                    <a:pt x="591" y="215"/>
                  </a:lnTo>
                  <a:lnTo>
                    <a:pt x="592" y="212"/>
                  </a:lnTo>
                  <a:lnTo>
                    <a:pt x="592" y="208"/>
                  </a:lnTo>
                  <a:lnTo>
                    <a:pt x="593" y="204"/>
                  </a:lnTo>
                  <a:lnTo>
                    <a:pt x="593" y="199"/>
                  </a:lnTo>
                  <a:lnTo>
                    <a:pt x="593" y="194"/>
                  </a:lnTo>
                  <a:lnTo>
                    <a:pt x="594" y="189"/>
                  </a:lnTo>
                  <a:lnTo>
                    <a:pt x="594" y="184"/>
                  </a:lnTo>
                  <a:lnTo>
                    <a:pt x="595" y="179"/>
                  </a:lnTo>
                  <a:lnTo>
                    <a:pt x="595" y="173"/>
                  </a:lnTo>
                  <a:lnTo>
                    <a:pt x="596" y="167"/>
                  </a:lnTo>
                  <a:lnTo>
                    <a:pt x="596" y="162"/>
                  </a:lnTo>
                  <a:lnTo>
                    <a:pt x="597" y="156"/>
                  </a:lnTo>
                  <a:lnTo>
                    <a:pt x="597" y="150"/>
                  </a:lnTo>
                  <a:lnTo>
                    <a:pt x="598" y="145"/>
                  </a:lnTo>
                  <a:lnTo>
                    <a:pt x="598" y="140"/>
                  </a:lnTo>
                  <a:lnTo>
                    <a:pt x="599" y="134"/>
                  </a:lnTo>
                  <a:lnTo>
                    <a:pt x="599" y="129"/>
                  </a:lnTo>
                  <a:lnTo>
                    <a:pt x="600" y="124"/>
                  </a:lnTo>
                  <a:lnTo>
                    <a:pt x="600" y="120"/>
                  </a:lnTo>
                  <a:lnTo>
                    <a:pt x="601" y="116"/>
                  </a:lnTo>
                  <a:lnTo>
                    <a:pt x="601" y="112"/>
                  </a:lnTo>
                  <a:lnTo>
                    <a:pt x="601" y="108"/>
                  </a:lnTo>
                  <a:lnTo>
                    <a:pt x="602" y="105"/>
                  </a:lnTo>
                  <a:lnTo>
                    <a:pt x="602" y="103"/>
                  </a:lnTo>
                  <a:lnTo>
                    <a:pt x="603" y="102"/>
                  </a:lnTo>
                  <a:lnTo>
                    <a:pt x="603" y="101"/>
                  </a:lnTo>
                  <a:lnTo>
                    <a:pt x="604" y="101"/>
                  </a:lnTo>
                  <a:lnTo>
                    <a:pt x="604" y="102"/>
                  </a:lnTo>
                  <a:lnTo>
                    <a:pt x="605" y="102"/>
                  </a:lnTo>
                  <a:lnTo>
                    <a:pt x="605" y="104"/>
                  </a:lnTo>
                  <a:lnTo>
                    <a:pt x="606" y="105"/>
                  </a:lnTo>
                  <a:lnTo>
                    <a:pt x="606" y="107"/>
                  </a:lnTo>
                  <a:lnTo>
                    <a:pt x="607" y="109"/>
                  </a:lnTo>
                  <a:lnTo>
                    <a:pt x="607" y="111"/>
                  </a:lnTo>
                  <a:lnTo>
                    <a:pt x="608" y="113"/>
                  </a:lnTo>
                  <a:lnTo>
                    <a:pt x="608" y="116"/>
                  </a:lnTo>
                  <a:lnTo>
                    <a:pt x="609" y="119"/>
                  </a:lnTo>
                  <a:lnTo>
                    <a:pt x="609" y="122"/>
                  </a:lnTo>
                  <a:lnTo>
                    <a:pt x="610" y="124"/>
                  </a:lnTo>
                  <a:lnTo>
                    <a:pt x="610" y="127"/>
                  </a:lnTo>
                  <a:lnTo>
                    <a:pt x="610" y="130"/>
                  </a:lnTo>
                  <a:lnTo>
                    <a:pt x="611" y="133"/>
                  </a:lnTo>
                  <a:lnTo>
                    <a:pt x="611" y="136"/>
                  </a:lnTo>
                  <a:lnTo>
                    <a:pt x="612" y="139"/>
                  </a:lnTo>
                  <a:lnTo>
                    <a:pt x="612" y="141"/>
                  </a:lnTo>
                  <a:lnTo>
                    <a:pt x="613" y="144"/>
                  </a:lnTo>
                  <a:lnTo>
                    <a:pt x="613" y="146"/>
                  </a:lnTo>
                  <a:lnTo>
                    <a:pt x="614" y="148"/>
                  </a:lnTo>
                  <a:lnTo>
                    <a:pt x="614" y="150"/>
                  </a:lnTo>
                  <a:lnTo>
                    <a:pt x="615" y="150"/>
                  </a:lnTo>
                  <a:lnTo>
                    <a:pt x="615" y="151"/>
                  </a:lnTo>
                  <a:lnTo>
                    <a:pt x="616" y="151"/>
                  </a:lnTo>
                  <a:lnTo>
                    <a:pt x="617" y="151"/>
                  </a:lnTo>
                  <a:lnTo>
                    <a:pt x="617" y="150"/>
                  </a:lnTo>
                  <a:lnTo>
                    <a:pt x="618" y="149"/>
                  </a:lnTo>
                  <a:lnTo>
                    <a:pt x="618" y="147"/>
                  </a:lnTo>
                  <a:lnTo>
                    <a:pt x="619" y="146"/>
                  </a:lnTo>
                  <a:lnTo>
                    <a:pt x="619" y="145"/>
                  </a:lnTo>
                  <a:lnTo>
                    <a:pt x="620" y="144"/>
                  </a:lnTo>
                  <a:lnTo>
                    <a:pt x="620" y="142"/>
                  </a:lnTo>
                  <a:lnTo>
                    <a:pt x="621" y="141"/>
                  </a:lnTo>
                  <a:lnTo>
                    <a:pt x="621" y="139"/>
                  </a:lnTo>
                  <a:lnTo>
                    <a:pt x="622" y="138"/>
                  </a:lnTo>
                  <a:lnTo>
                    <a:pt x="622" y="136"/>
                  </a:lnTo>
                  <a:lnTo>
                    <a:pt x="623" y="135"/>
                  </a:lnTo>
                  <a:lnTo>
                    <a:pt x="623" y="133"/>
                  </a:lnTo>
                  <a:lnTo>
                    <a:pt x="624" y="132"/>
                  </a:lnTo>
                  <a:lnTo>
                    <a:pt x="624" y="130"/>
                  </a:lnTo>
                  <a:lnTo>
                    <a:pt x="625" y="129"/>
                  </a:lnTo>
                  <a:lnTo>
                    <a:pt x="625" y="128"/>
                  </a:lnTo>
                  <a:lnTo>
                    <a:pt x="626" y="127"/>
                  </a:lnTo>
                  <a:lnTo>
                    <a:pt x="626" y="126"/>
                  </a:lnTo>
                  <a:lnTo>
                    <a:pt x="627" y="125"/>
                  </a:lnTo>
                  <a:lnTo>
                    <a:pt x="627" y="126"/>
                  </a:lnTo>
                  <a:lnTo>
                    <a:pt x="628" y="126"/>
                  </a:lnTo>
                  <a:lnTo>
                    <a:pt x="629" y="127"/>
                  </a:lnTo>
                  <a:lnTo>
                    <a:pt x="630" y="128"/>
                  </a:lnTo>
                  <a:lnTo>
                    <a:pt x="630" y="129"/>
                  </a:lnTo>
                  <a:lnTo>
                    <a:pt x="631" y="129"/>
                  </a:lnTo>
                  <a:lnTo>
                    <a:pt x="631" y="130"/>
                  </a:lnTo>
                  <a:lnTo>
                    <a:pt x="632" y="131"/>
                  </a:lnTo>
                  <a:lnTo>
                    <a:pt x="632" y="132"/>
                  </a:lnTo>
                  <a:lnTo>
                    <a:pt x="633" y="133"/>
                  </a:lnTo>
                  <a:lnTo>
                    <a:pt x="633" y="134"/>
                  </a:lnTo>
                  <a:lnTo>
                    <a:pt x="634" y="135"/>
                  </a:lnTo>
                  <a:lnTo>
                    <a:pt x="634" y="136"/>
                  </a:lnTo>
                  <a:lnTo>
                    <a:pt x="635" y="137"/>
                  </a:lnTo>
                  <a:lnTo>
                    <a:pt x="635" y="138"/>
                  </a:lnTo>
                  <a:lnTo>
                    <a:pt x="635" y="139"/>
                  </a:lnTo>
                  <a:lnTo>
                    <a:pt x="636" y="140"/>
                  </a:lnTo>
                  <a:lnTo>
                    <a:pt x="636" y="141"/>
                  </a:lnTo>
                  <a:lnTo>
                    <a:pt x="637" y="142"/>
                  </a:lnTo>
                  <a:lnTo>
                    <a:pt x="637" y="143"/>
                  </a:lnTo>
                  <a:lnTo>
                    <a:pt x="638" y="144"/>
                  </a:lnTo>
                  <a:lnTo>
                    <a:pt x="639" y="144"/>
                  </a:lnTo>
                  <a:lnTo>
                    <a:pt x="639" y="145"/>
                  </a:lnTo>
                  <a:lnTo>
                    <a:pt x="640" y="145"/>
                  </a:lnTo>
                  <a:lnTo>
                    <a:pt x="641" y="145"/>
                  </a:lnTo>
                  <a:lnTo>
                    <a:pt x="642" y="145"/>
                  </a:lnTo>
                  <a:lnTo>
                    <a:pt x="643" y="145"/>
                  </a:lnTo>
                  <a:lnTo>
                    <a:pt x="643" y="144"/>
                  </a:lnTo>
                  <a:lnTo>
                    <a:pt x="644" y="144"/>
                  </a:lnTo>
                  <a:lnTo>
                    <a:pt x="644" y="143"/>
                  </a:lnTo>
                  <a:lnTo>
                    <a:pt x="645" y="143"/>
                  </a:lnTo>
                  <a:lnTo>
                    <a:pt x="646" y="142"/>
                  </a:lnTo>
                  <a:lnTo>
                    <a:pt x="647" y="142"/>
                  </a:lnTo>
                  <a:lnTo>
                    <a:pt x="647" y="141"/>
                  </a:lnTo>
                  <a:lnTo>
                    <a:pt x="648" y="141"/>
                  </a:lnTo>
                  <a:lnTo>
                    <a:pt x="648" y="140"/>
                  </a:lnTo>
                  <a:lnTo>
                    <a:pt x="649" y="140"/>
                  </a:lnTo>
                  <a:lnTo>
                    <a:pt x="650" y="139"/>
                  </a:lnTo>
                  <a:lnTo>
                    <a:pt x="651" y="139"/>
                  </a:lnTo>
                  <a:lnTo>
                    <a:pt x="652" y="139"/>
                  </a:lnTo>
                  <a:lnTo>
                    <a:pt x="653" y="140"/>
                  </a:lnTo>
                  <a:lnTo>
                    <a:pt x="654" y="140"/>
                  </a:lnTo>
                  <a:lnTo>
                    <a:pt x="655" y="140"/>
                  </a:lnTo>
                  <a:lnTo>
                    <a:pt x="656" y="140"/>
                  </a:lnTo>
                  <a:lnTo>
                    <a:pt x="656" y="141"/>
                  </a:lnTo>
                  <a:lnTo>
                    <a:pt x="657" y="141"/>
                  </a:lnTo>
                  <a:lnTo>
                    <a:pt x="658" y="141"/>
                  </a:lnTo>
                  <a:lnTo>
                    <a:pt x="659" y="141"/>
                  </a:lnTo>
                  <a:lnTo>
                    <a:pt x="659" y="142"/>
                  </a:lnTo>
                  <a:lnTo>
                    <a:pt x="660" y="142"/>
                  </a:lnTo>
                  <a:lnTo>
                    <a:pt x="661" y="142"/>
                  </a:lnTo>
                  <a:lnTo>
                    <a:pt x="662" y="142"/>
                  </a:lnTo>
                  <a:lnTo>
                    <a:pt x="663" y="142"/>
                  </a:lnTo>
                  <a:lnTo>
                    <a:pt x="664" y="141"/>
                  </a:lnTo>
                  <a:lnTo>
                    <a:pt x="665" y="141"/>
                  </a:lnTo>
                  <a:lnTo>
                    <a:pt x="666" y="141"/>
                  </a:lnTo>
                  <a:lnTo>
                    <a:pt x="666" y="142"/>
                  </a:lnTo>
                  <a:lnTo>
                    <a:pt x="667" y="142"/>
                  </a:lnTo>
                  <a:lnTo>
                    <a:pt x="668" y="143"/>
                  </a:lnTo>
                  <a:lnTo>
                    <a:pt x="669" y="144"/>
                  </a:lnTo>
                  <a:lnTo>
                    <a:pt x="669" y="145"/>
                  </a:lnTo>
                  <a:lnTo>
                    <a:pt x="670" y="146"/>
                  </a:lnTo>
                  <a:lnTo>
                    <a:pt x="670" y="147"/>
                  </a:lnTo>
                  <a:lnTo>
                    <a:pt x="670" y="149"/>
                  </a:lnTo>
                  <a:lnTo>
                    <a:pt x="671" y="150"/>
                  </a:lnTo>
                  <a:lnTo>
                    <a:pt x="671" y="152"/>
                  </a:lnTo>
                  <a:lnTo>
                    <a:pt x="672" y="154"/>
                  </a:lnTo>
                  <a:lnTo>
                    <a:pt x="672" y="157"/>
                  </a:lnTo>
                  <a:lnTo>
                    <a:pt x="673" y="159"/>
                  </a:lnTo>
                  <a:lnTo>
                    <a:pt x="673" y="162"/>
                  </a:lnTo>
                  <a:lnTo>
                    <a:pt x="674" y="165"/>
                  </a:lnTo>
                  <a:lnTo>
                    <a:pt x="674" y="169"/>
                  </a:lnTo>
                  <a:lnTo>
                    <a:pt x="675" y="173"/>
                  </a:lnTo>
                  <a:lnTo>
                    <a:pt x="675" y="177"/>
                  </a:lnTo>
                  <a:lnTo>
                    <a:pt x="676" y="181"/>
                  </a:lnTo>
                  <a:lnTo>
                    <a:pt x="676" y="185"/>
                  </a:lnTo>
                  <a:lnTo>
                    <a:pt x="677" y="190"/>
                  </a:lnTo>
                  <a:lnTo>
                    <a:pt x="677" y="194"/>
                  </a:lnTo>
                  <a:lnTo>
                    <a:pt x="678" y="199"/>
                  </a:lnTo>
                  <a:lnTo>
                    <a:pt x="678" y="204"/>
                  </a:lnTo>
                  <a:lnTo>
                    <a:pt x="678" y="208"/>
                  </a:lnTo>
                  <a:lnTo>
                    <a:pt x="679" y="213"/>
                  </a:lnTo>
                  <a:lnTo>
                    <a:pt x="679" y="218"/>
                  </a:lnTo>
                  <a:lnTo>
                    <a:pt x="680" y="222"/>
                  </a:lnTo>
                  <a:lnTo>
                    <a:pt x="680" y="227"/>
                  </a:lnTo>
                  <a:lnTo>
                    <a:pt x="681" y="231"/>
                  </a:lnTo>
                  <a:lnTo>
                    <a:pt x="681" y="235"/>
                  </a:lnTo>
                  <a:lnTo>
                    <a:pt x="682" y="240"/>
                  </a:lnTo>
                  <a:lnTo>
                    <a:pt x="682" y="243"/>
                  </a:lnTo>
                  <a:lnTo>
                    <a:pt x="683" y="247"/>
                  </a:lnTo>
                  <a:lnTo>
                    <a:pt x="683" y="251"/>
                  </a:lnTo>
                  <a:lnTo>
                    <a:pt x="684" y="254"/>
                  </a:lnTo>
                  <a:lnTo>
                    <a:pt x="684" y="257"/>
                  </a:lnTo>
                  <a:lnTo>
                    <a:pt x="685" y="260"/>
                  </a:lnTo>
                  <a:lnTo>
                    <a:pt x="685" y="262"/>
                  </a:lnTo>
                  <a:lnTo>
                    <a:pt x="686" y="264"/>
                  </a:lnTo>
                  <a:lnTo>
                    <a:pt x="686" y="265"/>
                  </a:lnTo>
                  <a:lnTo>
                    <a:pt x="687" y="266"/>
                  </a:lnTo>
                  <a:lnTo>
                    <a:pt x="687" y="267"/>
                  </a:lnTo>
                  <a:lnTo>
                    <a:pt x="687" y="268"/>
                  </a:lnTo>
                  <a:lnTo>
                    <a:pt x="688" y="268"/>
                  </a:lnTo>
                  <a:lnTo>
                    <a:pt x="689" y="267"/>
                  </a:lnTo>
                  <a:lnTo>
                    <a:pt x="690" y="266"/>
                  </a:lnTo>
                  <a:lnTo>
                    <a:pt x="690" y="265"/>
                  </a:lnTo>
                  <a:lnTo>
                    <a:pt x="691" y="264"/>
                  </a:lnTo>
                  <a:lnTo>
                    <a:pt x="691" y="262"/>
                  </a:lnTo>
                  <a:lnTo>
                    <a:pt x="692" y="261"/>
                  </a:lnTo>
                  <a:lnTo>
                    <a:pt x="692" y="259"/>
                  </a:lnTo>
                  <a:lnTo>
                    <a:pt x="693" y="257"/>
                  </a:lnTo>
                  <a:lnTo>
                    <a:pt x="693" y="255"/>
                  </a:lnTo>
                  <a:lnTo>
                    <a:pt x="694" y="253"/>
                  </a:lnTo>
                  <a:lnTo>
                    <a:pt x="694" y="250"/>
                  </a:lnTo>
                  <a:lnTo>
                    <a:pt x="695" y="248"/>
                  </a:lnTo>
                  <a:lnTo>
                    <a:pt x="695" y="245"/>
                  </a:lnTo>
                  <a:lnTo>
                    <a:pt x="695" y="243"/>
                  </a:lnTo>
                  <a:lnTo>
                    <a:pt x="696" y="240"/>
                  </a:lnTo>
                  <a:lnTo>
                    <a:pt x="696" y="237"/>
                  </a:lnTo>
                  <a:lnTo>
                    <a:pt x="697" y="235"/>
                  </a:lnTo>
                  <a:lnTo>
                    <a:pt x="697" y="232"/>
                  </a:lnTo>
                  <a:lnTo>
                    <a:pt x="698" y="229"/>
                  </a:lnTo>
                  <a:lnTo>
                    <a:pt x="698" y="226"/>
                  </a:lnTo>
                  <a:lnTo>
                    <a:pt x="699" y="223"/>
                  </a:lnTo>
                  <a:lnTo>
                    <a:pt x="699" y="221"/>
                  </a:lnTo>
                  <a:lnTo>
                    <a:pt x="700" y="218"/>
                  </a:lnTo>
                  <a:lnTo>
                    <a:pt x="700" y="215"/>
                  </a:lnTo>
                  <a:lnTo>
                    <a:pt x="701" y="213"/>
                  </a:lnTo>
                  <a:lnTo>
                    <a:pt x="701" y="210"/>
                  </a:lnTo>
                  <a:lnTo>
                    <a:pt x="702" y="208"/>
                  </a:lnTo>
                  <a:lnTo>
                    <a:pt x="702" y="206"/>
                  </a:lnTo>
                  <a:lnTo>
                    <a:pt x="703" y="204"/>
                  </a:lnTo>
                  <a:lnTo>
                    <a:pt x="703" y="202"/>
                  </a:lnTo>
                  <a:lnTo>
                    <a:pt x="704" y="200"/>
                  </a:lnTo>
                  <a:lnTo>
                    <a:pt x="704" y="199"/>
                  </a:lnTo>
                  <a:lnTo>
                    <a:pt x="704" y="198"/>
                  </a:lnTo>
                  <a:lnTo>
                    <a:pt x="705" y="197"/>
                  </a:lnTo>
                  <a:lnTo>
                    <a:pt x="705" y="196"/>
                  </a:lnTo>
                  <a:lnTo>
                    <a:pt x="706" y="196"/>
                  </a:lnTo>
                  <a:lnTo>
                    <a:pt x="707" y="196"/>
                  </a:lnTo>
                  <a:lnTo>
                    <a:pt x="708" y="197"/>
                  </a:lnTo>
                  <a:lnTo>
                    <a:pt x="708" y="198"/>
                  </a:lnTo>
                  <a:lnTo>
                    <a:pt x="709" y="200"/>
                  </a:lnTo>
                  <a:lnTo>
                    <a:pt x="709" y="202"/>
                  </a:lnTo>
                  <a:lnTo>
                    <a:pt x="710" y="205"/>
                  </a:lnTo>
                  <a:lnTo>
                    <a:pt x="710" y="208"/>
                  </a:lnTo>
                  <a:lnTo>
                    <a:pt x="711" y="211"/>
                  </a:lnTo>
                  <a:lnTo>
                    <a:pt x="711" y="215"/>
                  </a:lnTo>
                  <a:lnTo>
                    <a:pt x="712" y="219"/>
                  </a:lnTo>
                  <a:lnTo>
                    <a:pt x="712" y="223"/>
                  </a:lnTo>
                  <a:lnTo>
                    <a:pt x="712" y="227"/>
                  </a:lnTo>
                  <a:lnTo>
                    <a:pt x="713" y="232"/>
                  </a:lnTo>
                  <a:lnTo>
                    <a:pt x="713" y="237"/>
                  </a:lnTo>
                  <a:lnTo>
                    <a:pt x="714" y="242"/>
                  </a:lnTo>
                  <a:lnTo>
                    <a:pt x="714" y="247"/>
                  </a:lnTo>
                  <a:lnTo>
                    <a:pt x="715" y="252"/>
                  </a:lnTo>
                  <a:lnTo>
                    <a:pt x="715" y="257"/>
                  </a:lnTo>
                  <a:lnTo>
                    <a:pt x="716" y="263"/>
                  </a:lnTo>
                  <a:lnTo>
                    <a:pt x="716" y="268"/>
                  </a:lnTo>
                  <a:lnTo>
                    <a:pt x="717" y="274"/>
                  </a:lnTo>
                  <a:lnTo>
                    <a:pt x="717" y="279"/>
                  </a:lnTo>
                  <a:lnTo>
                    <a:pt x="718" y="285"/>
                  </a:lnTo>
                  <a:lnTo>
                    <a:pt x="718" y="290"/>
                  </a:lnTo>
                  <a:lnTo>
                    <a:pt x="719" y="296"/>
                  </a:lnTo>
                  <a:lnTo>
                    <a:pt x="719" y="301"/>
                  </a:lnTo>
                  <a:lnTo>
                    <a:pt x="720" y="306"/>
                  </a:lnTo>
                  <a:lnTo>
                    <a:pt x="720" y="311"/>
                  </a:lnTo>
                  <a:lnTo>
                    <a:pt x="721" y="316"/>
                  </a:lnTo>
                  <a:lnTo>
                    <a:pt x="721" y="321"/>
                  </a:lnTo>
                  <a:lnTo>
                    <a:pt x="721" y="326"/>
                  </a:lnTo>
                  <a:lnTo>
                    <a:pt x="722" y="330"/>
                  </a:lnTo>
                  <a:lnTo>
                    <a:pt x="722" y="334"/>
                  </a:lnTo>
                  <a:lnTo>
                    <a:pt x="723" y="338"/>
                  </a:lnTo>
                  <a:lnTo>
                    <a:pt x="723" y="342"/>
                  </a:lnTo>
                  <a:lnTo>
                    <a:pt x="724" y="346"/>
                  </a:lnTo>
                  <a:lnTo>
                    <a:pt x="724" y="350"/>
                  </a:lnTo>
                  <a:lnTo>
                    <a:pt x="725" y="353"/>
                  </a:lnTo>
                  <a:lnTo>
                    <a:pt x="725" y="356"/>
                  </a:lnTo>
                  <a:lnTo>
                    <a:pt x="726" y="359"/>
                  </a:lnTo>
                  <a:lnTo>
                    <a:pt x="726" y="362"/>
                  </a:lnTo>
                  <a:lnTo>
                    <a:pt x="727" y="365"/>
                  </a:lnTo>
                  <a:lnTo>
                    <a:pt x="727" y="368"/>
                  </a:lnTo>
                  <a:lnTo>
                    <a:pt x="728" y="370"/>
                  </a:lnTo>
                  <a:lnTo>
                    <a:pt x="728" y="373"/>
                  </a:lnTo>
                  <a:lnTo>
                    <a:pt x="729" y="375"/>
                  </a:lnTo>
                  <a:lnTo>
                    <a:pt x="729" y="377"/>
                  </a:lnTo>
                  <a:lnTo>
                    <a:pt x="730" y="379"/>
                  </a:lnTo>
                  <a:lnTo>
                    <a:pt x="730" y="381"/>
                  </a:lnTo>
                  <a:lnTo>
                    <a:pt x="730" y="382"/>
                  </a:lnTo>
                  <a:lnTo>
                    <a:pt x="731" y="384"/>
                  </a:lnTo>
                  <a:lnTo>
                    <a:pt x="731" y="385"/>
                  </a:lnTo>
                  <a:lnTo>
                    <a:pt x="732" y="386"/>
                  </a:lnTo>
                  <a:lnTo>
                    <a:pt x="732" y="388"/>
                  </a:lnTo>
                  <a:lnTo>
                    <a:pt x="733" y="389"/>
                  </a:lnTo>
                  <a:lnTo>
                    <a:pt x="733" y="390"/>
                  </a:lnTo>
                  <a:lnTo>
                    <a:pt x="734" y="391"/>
                  </a:lnTo>
                  <a:lnTo>
                    <a:pt x="734" y="392"/>
                  </a:lnTo>
                  <a:lnTo>
                    <a:pt x="735" y="393"/>
                  </a:lnTo>
                  <a:lnTo>
                    <a:pt x="735" y="394"/>
                  </a:lnTo>
                  <a:lnTo>
                    <a:pt x="736" y="394"/>
                  </a:lnTo>
                  <a:lnTo>
                    <a:pt x="736" y="395"/>
                  </a:lnTo>
                  <a:lnTo>
                    <a:pt x="737" y="396"/>
                  </a:lnTo>
                  <a:lnTo>
                    <a:pt x="738" y="397"/>
                  </a:lnTo>
                  <a:lnTo>
                    <a:pt x="738" y="398"/>
                  </a:lnTo>
                  <a:lnTo>
                    <a:pt x="739" y="399"/>
                  </a:lnTo>
                  <a:lnTo>
                    <a:pt x="739" y="400"/>
                  </a:lnTo>
                  <a:lnTo>
                    <a:pt x="740" y="400"/>
                  </a:lnTo>
                  <a:lnTo>
                    <a:pt x="740" y="401"/>
                  </a:lnTo>
                  <a:lnTo>
                    <a:pt x="741" y="402"/>
                  </a:lnTo>
                  <a:lnTo>
                    <a:pt x="741" y="403"/>
                  </a:lnTo>
                  <a:lnTo>
                    <a:pt x="742" y="404"/>
                  </a:lnTo>
                  <a:lnTo>
                    <a:pt x="742" y="406"/>
                  </a:lnTo>
                  <a:lnTo>
                    <a:pt x="743" y="407"/>
                  </a:lnTo>
                  <a:lnTo>
                    <a:pt x="743" y="408"/>
                  </a:lnTo>
                  <a:lnTo>
                    <a:pt x="744" y="410"/>
                  </a:lnTo>
                  <a:lnTo>
                    <a:pt x="744" y="412"/>
                  </a:lnTo>
                  <a:lnTo>
                    <a:pt x="745" y="414"/>
                  </a:lnTo>
                  <a:lnTo>
                    <a:pt x="745" y="416"/>
                  </a:lnTo>
                  <a:lnTo>
                    <a:pt x="746" y="419"/>
                  </a:lnTo>
                  <a:lnTo>
                    <a:pt x="746" y="421"/>
                  </a:lnTo>
                  <a:lnTo>
                    <a:pt x="747" y="424"/>
                  </a:lnTo>
                  <a:lnTo>
                    <a:pt x="747" y="427"/>
                  </a:lnTo>
                  <a:lnTo>
                    <a:pt x="747" y="430"/>
                  </a:lnTo>
                  <a:lnTo>
                    <a:pt x="748" y="434"/>
                  </a:lnTo>
                  <a:lnTo>
                    <a:pt x="748" y="437"/>
                  </a:lnTo>
                  <a:lnTo>
                    <a:pt x="749" y="441"/>
                  </a:lnTo>
                  <a:lnTo>
                    <a:pt x="749" y="445"/>
                  </a:lnTo>
                  <a:lnTo>
                    <a:pt x="750" y="449"/>
                  </a:lnTo>
                  <a:lnTo>
                    <a:pt x="750" y="453"/>
                  </a:lnTo>
                  <a:lnTo>
                    <a:pt x="751" y="457"/>
                  </a:lnTo>
                  <a:lnTo>
                    <a:pt x="751" y="461"/>
                  </a:lnTo>
                  <a:lnTo>
                    <a:pt x="752" y="466"/>
                  </a:lnTo>
                  <a:lnTo>
                    <a:pt x="752" y="471"/>
                  </a:lnTo>
                  <a:lnTo>
                    <a:pt x="753" y="475"/>
                  </a:lnTo>
                  <a:lnTo>
                    <a:pt x="753" y="480"/>
                  </a:lnTo>
                  <a:lnTo>
                    <a:pt x="754" y="486"/>
                  </a:lnTo>
                  <a:lnTo>
                    <a:pt x="754" y="491"/>
                  </a:lnTo>
                  <a:lnTo>
                    <a:pt x="755" y="496"/>
                  </a:lnTo>
                  <a:lnTo>
                    <a:pt x="755" y="502"/>
                  </a:lnTo>
                  <a:lnTo>
                    <a:pt x="755" y="507"/>
                  </a:lnTo>
                  <a:lnTo>
                    <a:pt x="756" y="513"/>
                  </a:lnTo>
                  <a:lnTo>
                    <a:pt x="756" y="519"/>
                  </a:lnTo>
                  <a:lnTo>
                    <a:pt x="757" y="525"/>
                  </a:lnTo>
                  <a:lnTo>
                    <a:pt x="757" y="532"/>
                  </a:lnTo>
                  <a:lnTo>
                    <a:pt x="758" y="538"/>
                  </a:lnTo>
                  <a:lnTo>
                    <a:pt x="758" y="545"/>
                  </a:lnTo>
                  <a:lnTo>
                    <a:pt x="759" y="551"/>
                  </a:lnTo>
                  <a:lnTo>
                    <a:pt x="759" y="558"/>
                  </a:lnTo>
                  <a:lnTo>
                    <a:pt x="760" y="564"/>
                  </a:lnTo>
                  <a:lnTo>
                    <a:pt x="760" y="571"/>
                  </a:lnTo>
                  <a:lnTo>
                    <a:pt x="761" y="578"/>
                  </a:lnTo>
                  <a:lnTo>
                    <a:pt x="761" y="585"/>
                  </a:lnTo>
                  <a:lnTo>
                    <a:pt x="762" y="591"/>
                  </a:lnTo>
                  <a:lnTo>
                    <a:pt x="762" y="598"/>
                  </a:lnTo>
                  <a:lnTo>
                    <a:pt x="763" y="605"/>
                  </a:lnTo>
                  <a:lnTo>
                    <a:pt x="763" y="612"/>
                  </a:lnTo>
                  <a:lnTo>
                    <a:pt x="764" y="619"/>
                  </a:lnTo>
                  <a:lnTo>
                    <a:pt x="764" y="625"/>
                  </a:lnTo>
                  <a:lnTo>
                    <a:pt x="764" y="632"/>
                  </a:lnTo>
                  <a:lnTo>
                    <a:pt x="765" y="639"/>
                  </a:lnTo>
                  <a:lnTo>
                    <a:pt x="765" y="645"/>
                  </a:lnTo>
                  <a:lnTo>
                    <a:pt x="766" y="652"/>
                  </a:lnTo>
                  <a:lnTo>
                    <a:pt x="766" y="658"/>
                  </a:lnTo>
                  <a:lnTo>
                    <a:pt x="767" y="664"/>
                  </a:lnTo>
                  <a:lnTo>
                    <a:pt x="767" y="671"/>
                  </a:lnTo>
                  <a:lnTo>
                    <a:pt x="768" y="677"/>
                  </a:lnTo>
                  <a:lnTo>
                    <a:pt x="768" y="683"/>
                  </a:lnTo>
                  <a:lnTo>
                    <a:pt x="769" y="688"/>
                  </a:lnTo>
                  <a:lnTo>
                    <a:pt x="769" y="694"/>
                  </a:lnTo>
                  <a:lnTo>
                    <a:pt x="770" y="699"/>
                  </a:lnTo>
                  <a:lnTo>
                    <a:pt x="770" y="705"/>
                  </a:lnTo>
                  <a:lnTo>
                    <a:pt x="771" y="710"/>
                  </a:lnTo>
                  <a:lnTo>
                    <a:pt x="771" y="715"/>
                  </a:lnTo>
                  <a:lnTo>
                    <a:pt x="772" y="720"/>
                  </a:lnTo>
                  <a:lnTo>
                    <a:pt x="772" y="725"/>
                  </a:lnTo>
                  <a:lnTo>
                    <a:pt x="772" y="730"/>
                  </a:lnTo>
                  <a:lnTo>
                    <a:pt x="773" y="735"/>
                  </a:lnTo>
                  <a:lnTo>
                    <a:pt x="773" y="739"/>
                  </a:lnTo>
                  <a:lnTo>
                    <a:pt x="774" y="744"/>
                  </a:lnTo>
                  <a:lnTo>
                    <a:pt x="774" y="749"/>
                  </a:lnTo>
                  <a:lnTo>
                    <a:pt x="775" y="753"/>
                  </a:lnTo>
                  <a:lnTo>
                    <a:pt x="775" y="757"/>
                  </a:lnTo>
                  <a:lnTo>
                    <a:pt x="776" y="762"/>
                  </a:lnTo>
                  <a:lnTo>
                    <a:pt x="776" y="766"/>
                  </a:lnTo>
                  <a:lnTo>
                    <a:pt x="777" y="770"/>
                  </a:lnTo>
                  <a:lnTo>
                    <a:pt x="777" y="775"/>
                  </a:lnTo>
                  <a:lnTo>
                    <a:pt x="778" y="779"/>
                  </a:lnTo>
                  <a:lnTo>
                    <a:pt x="778" y="783"/>
                  </a:lnTo>
                  <a:lnTo>
                    <a:pt x="779" y="787"/>
                  </a:lnTo>
                  <a:lnTo>
                    <a:pt x="779" y="791"/>
                  </a:lnTo>
                  <a:lnTo>
                    <a:pt x="780" y="795"/>
                  </a:lnTo>
                  <a:lnTo>
                    <a:pt x="780" y="799"/>
                  </a:lnTo>
                  <a:lnTo>
                    <a:pt x="781" y="803"/>
                  </a:lnTo>
                  <a:lnTo>
                    <a:pt x="781" y="807"/>
                  </a:lnTo>
                  <a:lnTo>
                    <a:pt x="781" y="811"/>
                  </a:lnTo>
                  <a:lnTo>
                    <a:pt x="782" y="814"/>
                  </a:lnTo>
                  <a:lnTo>
                    <a:pt x="782" y="818"/>
                  </a:lnTo>
                  <a:lnTo>
                    <a:pt x="783" y="822"/>
                  </a:lnTo>
                  <a:lnTo>
                    <a:pt x="783" y="825"/>
                  </a:lnTo>
                  <a:lnTo>
                    <a:pt x="784" y="829"/>
                  </a:lnTo>
                  <a:lnTo>
                    <a:pt x="784" y="832"/>
                  </a:lnTo>
                  <a:lnTo>
                    <a:pt x="785" y="836"/>
                  </a:lnTo>
                  <a:lnTo>
                    <a:pt x="785" y="839"/>
                  </a:lnTo>
                  <a:lnTo>
                    <a:pt x="786" y="842"/>
                  </a:lnTo>
                  <a:lnTo>
                    <a:pt x="786" y="846"/>
                  </a:lnTo>
                  <a:lnTo>
                    <a:pt x="787" y="849"/>
                  </a:lnTo>
                  <a:lnTo>
                    <a:pt x="787" y="852"/>
                  </a:lnTo>
                  <a:lnTo>
                    <a:pt x="788" y="854"/>
                  </a:lnTo>
                  <a:lnTo>
                    <a:pt x="788" y="857"/>
                  </a:lnTo>
                  <a:lnTo>
                    <a:pt x="789" y="860"/>
                  </a:lnTo>
                  <a:lnTo>
                    <a:pt x="789" y="862"/>
                  </a:lnTo>
                  <a:lnTo>
                    <a:pt x="790" y="864"/>
                  </a:lnTo>
                  <a:lnTo>
                    <a:pt x="790" y="867"/>
                  </a:lnTo>
                  <a:lnTo>
                    <a:pt x="790" y="869"/>
                  </a:lnTo>
                  <a:lnTo>
                    <a:pt x="791" y="870"/>
                  </a:lnTo>
                  <a:lnTo>
                    <a:pt x="791" y="872"/>
                  </a:lnTo>
                  <a:lnTo>
                    <a:pt x="792" y="873"/>
                  </a:lnTo>
                  <a:lnTo>
                    <a:pt x="792" y="874"/>
                  </a:lnTo>
                  <a:lnTo>
                    <a:pt x="793" y="875"/>
                  </a:lnTo>
                  <a:lnTo>
                    <a:pt x="793" y="876"/>
                  </a:lnTo>
                  <a:lnTo>
                    <a:pt x="794" y="876"/>
                  </a:lnTo>
                  <a:lnTo>
                    <a:pt x="794" y="877"/>
                  </a:lnTo>
                  <a:lnTo>
                    <a:pt x="795" y="877"/>
                  </a:lnTo>
                  <a:lnTo>
                    <a:pt x="796" y="877"/>
                  </a:lnTo>
                  <a:lnTo>
                    <a:pt x="797" y="877"/>
                  </a:lnTo>
                  <a:lnTo>
                    <a:pt x="798" y="877"/>
                  </a:lnTo>
                  <a:lnTo>
                    <a:pt x="799" y="877"/>
                  </a:lnTo>
                  <a:lnTo>
                    <a:pt x="799" y="876"/>
                  </a:lnTo>
                  <a:lnTo>
                    <a:pt x="800" y="876"/>
                  </a:lnTo>
                  <a:lnTo>
                    <a:pt x="801" y="876"/>
                  </a:lnTo>
                  <a:lnTo>
                    <a:pt x="802" y="875"/>
                  </a:lnTo>
                  <a:lnTo>
                    <a:pt x="803" y="875"/>
                  </a:lnTo>
                  <a:lnTo>
                    <a:pt x="804" y="875"/>
                  </a:lnTo>
                  <a:lnTo>
                    <a:pt x="805" y="875"/>
                  </a:lnTo>
                  <a:lnTo>
                    <a:pt x="805" y="876"/>
                  </a:lnTo>
                  <a:lnTo>
                    <a:pt x="806" y="876"/>
                  </a:lnTo>
                  <a:lnTo>
                    <a:pt x="807" y="877"/>
                  </a:lnTo>
                  <a:lnTo>
                    <a:pt x="808" y="878"/>
                  </a:lnTo>
                  <a:lnTo>
                    <a:pt x="809" y="879"/>
                  </a:lnTo>
                  <a:lnTo>
                    <a:pt x="809" y="880"/>
                  </a:lnTo>
                  <a:lnTo>
                    <a:pt x="810" y="880"/>
                  </a:lnTo>
                  <a:lnTo>
                    <a:pt x="810" y="881"/>
                  </a:lnTo>
                  <a:lnTo>
                    <a:pt x="811" y="881"/>
                  </a:lnTo>
                  <a:lnTo>
                    <a:pt x="811" y="882"/>
                  </a:lnTo>
                  <a:lnTo>
                    <a:pt x="812" y="883"/>
                  </a:lnTo>
                  <a:lnTo>
                    <a:pt x="813" y="884"/>
                  </a:lnTo>
                  <a:lnTo>
                    <a:pt x="813" y="885"/>
                  </a:lnTo>
                  <a:lnTo>
                    <a:pt x="814" y="885"/>
                  </a:lnTo>
                  <a:lnTo>
                    <a:pt x="814" y="886"/>
                  </a:lnTo>
                  <a:lnTo>
                    <a:pt x="815" y="887"/>
                  </a:lnTo>
                  <a:lnTo>
                    <a:pt x="815" y="888"/>
                  </a:lnTo>
                  <a:lnTo>
                    <a:pt x="816" y="888"/>
                  </a:lnTo>
                  <a:lnTo>
                    <a:pt x="816" y="889"/>
                  </a:lnTo>
                  <a:lnTo>
                    <a:pt x="817" y="889"/>
                  </a:lnTo>
                  <a:lnTo>
                    <a:pt x="818" y="890"/>
                  </a:lnTo>
                  <a:lnTo>
                    <a:pt x="819" y="891"/>
                  </a:lnTo>
                  <a:lnTo>
                    <a:pt x="820" y="891"/>
                  </a:lnTo>
                  <a:lnTo>
                    <a:pt x="821" y="892"/>
                  </a:lnTo>
                  <a:lnTo>
                    <a:pt x="822" y="892"/>
                  </a:lnTo>
                  <a:lnTo>
                    <a:pt x="823" y="893"/>
                  </a:lnTo>
                  <a:lnTo>
                    <a:pt x="824" y="893"/>
                  </a:lnTo>
                  <a:lnTo>
                    <a:pt x="825" y="893"/>
                  </a:lnTo>
                  <a:lnTo>
                    <a:pt x="826" y="893"/>
                  </a:lnTo>
                  <a:lnTo>
                    <a:pt x="827" y="893"/>
                  </a:lnTo>
                  <a:lnTo>
                    <a:pt x="828" y="893"/>
                  </a:lnTo>
                  <a:lnTo>
                    <a:pt x="829" y="893"/>
                  </a:lnTo>
                  <a:lnTo>
                    <a:pt x="830" y="893"/>
                  </a:lnTo>
                  <a:lnTo>
                    <a:pt x="831" y="893"/>
                  </a:lnTo>
                  <a:lnTo>
                    <a:pt x="832" y="893"/>
                  </a:lnTo>
                  <a:lnTo>
                    <a:pt x="833" y="893"/>
                  </a:lnTo>
                  <a:lnTo>
                    <a:pt x="834" y="893"/>
                  </a:lnTo>
                  <a:lnTo>
                    <a:pt x="835" y="893"/>
                  </a:lnTo>
                  <a:lnTo>
                    <a:pt x="835" y="894"/>
                  </a:lnTo>
                  <a:lnTo>
                    <a:pt x="836" y="894"/>
                  </a:lnTo>
                  <a:lnTo>
                    <a:pt x="837" y="894"/>
                  </a:lnTo>
                  <a:lnTo>
                    <a:pt x="837" y="895"/>
                  </a:lnTo>
                  <a:lnTo>
                    <a:pt x="838" y="895"/>
                  </a:lnTo>
                  <a:lnTo>
                    <a:pt x="838" y="896"/>
                  </a:lnTo>
                  <a:lnTo>
                    <a:pt x="839" y="896"/>
                  </a:lnTo>
                  <a:lnTo>
                    <a:pt x="839" y="897"/>
                  </a:lnTo>
                  <a:lnTo>
                    <a:pt x="840" y="898"/>
                  </a:lnTo>
                  <a:lnTo>
                    <a:pt x="840" y="899"/>
                  </a:lnTo>
                  <a:lnTo>
                    <a:pt x="841" y="900"/>
                  </a:lnTo>
                  <a:lnTo>
                    <a:pt x="841" y="901"/>
                  </a:lnTo>
                  <a:lnTo>
                    <a:pt x="841" y="902"/>
                  </a:lnTo>
                  <a:lnTo>
                    <a:pt x="842" y="903"/>
                  </a:lnTo>
                  <a:lnTo>
                    <a:pt x="842" y="904"/>
                  </a:lnTo>
                  <a:lnTo>
                    <a:pt x="843" y="905"/>
                  </a:lnTo>
                  <a:lnTo>
                    <a:pt x="843" y="906"/>
                  </a:lnTo>
                  <a:lnTo>
                    <a:pt x="844" y="907"/>
                  </a:lnTo>
                  <a:lnTo>
                    <a:pt x="844" y="909"/>
                  </a:lnTo>
                  <a:lnTo>
                    <a:pt x="845" y="910"/>
                  </a:lnTo>
                  <a:lnTo>
                    <a:pt x="845" y="911"/>
                  </a:lnTo>
                  <a:lnTo>
                    <a:pt x="846" y="912"/>
                  </a:lnTo>
                  <a:lnTo>
                    <a:pt x="846" y="914"/>
                  </a:lnTo>
                  <a:lnTo>
                    <a:pt x="847" y="915"/>
                  </a:lnTo>
                  <a:lnTo>
                    <a:pt x="847" y="916"/>
                  </a:lnTo>
                  <a:lnTo>
                    <a:pt x="848" y="918"/>
                  </a:lnTo>
                  <a:lnTo>
                    <a:pt x="848" y="919"/>
                  </a:lnTo>
                  <a:lnTo>
                    <a:pt x="849" y="920"/>
                  </a:lnTo>
                  <a:lnTo>
                    <a:pt x="849" y="921"/>
                  </a:lnTo>
                  <a:lnTo>
                    <a:pt x="849" y="923"/>
                  </a:lnTo>
                  <a:lnTo>
                    <a:pt x="850" y="924"/>
                  </a:lnTo>
                  <a:lnTo>
                    <a:pt x="850" y="925"/>
                  </a:lnTo>
                  <a:lnTo>
                    <a:pt x="851" y="926"/>
                  </a:lnTo>
                  <a:lnTo>
                    <a:pt x="851" y="928"/>
                  </a:lnTo>
                  <a:lnTo>
                    <a:pt x="852" y="929"/>
                  </a:lnTo>
                  <a:lnTo>
                    <a:pt x="852" y="930"/>
                  </a:lnTo>
                  <a:lnTo>
                    <a:pt x="853" y="931"/>
                  </a:lnTo>
                  <a:lnTo>
                    <a:pt x="853" y="932"/>
                  </a:lnTo>
                  <a:lnTo>
                    <a:pt x="854" y="933"/>
                  </a:lnTo>
                  <a:lnTo>
                    <a:pt x="854" y="934"/>
                  </a:lnTo>
                  <a:lnTo>
                    <a:pt x="855" y="935"/>
                  </a:lnTo>
                  <a:lnTo>
                    <a:pt x="855" y="936"/>
                  </a:lnTo>
                  <a:lnTo>
                    <a:pt x="856" y="936"/>
                  </a:lnTo>
                  <a:lnTo>
                    <a:pt x="856" y="937"/>
                  </a:lnTo>
                  <a:lnTo>
                    <a:pt x="857" y="938"/>
                  </a:lnTo>
                  <a:lnTo>
                    <a:pt x="857" y="939"/>
                  </a:lnTo>
                  <a:lnTo>
                    <a:pt x="858" y="939"/>
                  </a:lnTo>
                  <a:lnTo>
                    <a:pt x="858" y="940"/>
                  </a:lnTo>
                  <a:lnTo>
                    <a:pt x="858" y="941"/>
                  </a:lnTo>
                  <a:lnTo>
                    <a:pt x="859" y="941"/>
                  </a:lnTo>
                  <a:lnTo>
                    <a:pt x="859" y="942"/>
                  </a:lnTo>
                  <a:lnTo>
                    <a:pt x="860" y="942"/>
                  </a:lnTo>
                  <a:lnTo>
                    <a:pt x="861" y="943"/>
                  </a:lnTo>
                  <a:lnTo>
                    <a:pt x="862" y="943"/>
                  </a:lnTo>
                  <a:lnTo>
                    <a:pt x="863" y="943"/>
                  </a:lnTo>
                  <a:lnTo>
                    <a:pt x="864" y="943"/>
                  </a:lnTo>
                  <a:lnTo>
                    <a:pt x="865" y="943"/>
                  </a:lnTo>
                  <a:lnTo>
                    <a:pt x="866" y="943"/>
                  </a:lnTo>
                  <a:lnTo>
                    <a:pt x="867" y="943"/>
                  </a:lnTo>
                  <a:lnTo>
                    <a:pt x="867" y="942"/>
                  </a:lnTo>
                  <a:lnTo>
                    <a:pt x="868" y="942"/>
                  </a:lnTo>
                  <a:lnTo>
                    <a:pt x="869" y="942"/>
                  </a:lnTo>
                  <a:lnTo>
                    <a:pt x="869" y="941"/>
                  </a:lnTo>
                  <a:lnTo>
                    <a:pt x="870" y="941"/>
                  </a:lnTo>
                  <a:lnTo>
                    <a:pt x="871" y="941"/>
                  </a:lnTo>
                  <a:lnTo>
                    <a:pt x="872" y="941"/>
                  </a:lnTo>
                  <a:lnTo>
                    <a:pt x="873" y="941"/>
                  </a:lnTo>
                  <a:lnTo>
                    <a:pt x="874" y="942"/>
                  </a:lnTo>
                  <a:lnTo>
                    <a:pt x="875" y="942"/>
                  </a:lnTo>
                  <a:lnTo>
                    <a:pt x="875" y="943"/>
                  </a:lnTo>
                  <a:lnTo>
                    <a:pt x="875" y="944"/>
                  </a:lnTo>
                  <a:lnTo>
                    <a:pt x="876" y="944"/>
                  </a:lnTo>
                  <a:lnTo>
                    <a:pt x="876" y="945"/>
                  </a:lnTo>
                  <a:lnTo>
                    <a:pt x="877" y="946"/>
                  </a:lnTo>
                  <a:lnTo>
                    <a:pt x="877" y="947"/>
                  </a:lnTo>
                  <a:lnTo>
                    <a:pt x="878" y="947"/>
                  </a:lnTo>
                  <a:lnTo>
                    <a:pt x="878" y="948"/>
                  </a:lnTo>
                  <a:lnTo>
                    <a:pt x="879" y="949"/>
                  </a:lnTo>
                  <a:lnTo>
                    <a:pt x="879" y="950"/>
                  </a:lnTo>
                  <a:lnTo>
                    <a:pt x="880" y="951"/>
                  </a:lnTo>
                  <a:lnTo>
                    <a:pt x="880" y="953"/>
                  </a:lnTo>
                  <a:lnTo>
                    <a:pt x="881" y="954"/>
                  </a:lnTo>
                  <a:lnTo>
                    <a:pt x="881" y="955"/>
                  </a:lnTo>
                  <a:lnTo>
                    <a:pt x="882" y="956"/>
                  </a:lnTo>
                  <a:lnTo>
                    <a:pt x="882" y="957"/>
                  </a:lnTo>
                  <a:lnTo>
                    <a:pt x="883" y="958"/>
                  </a:lnTo>
                  <a:lnTo>
                    <a:pt x="883" y="959"/>
                  </a:lnTo>
                  <a:lnTo>
                    <a:pt x="884" y="961"/>
                  </a:lnTo>
                  <a:lnTo>
                    <a:pt x="884" y="962"/>
                  </a:lnTo>
                  <a:lnTo>
                    <a:pt x="884" y="963"/>
                  </a:lnTo>
                  <a:lnTo>
                    <a:pt x="885" y="964"/>
                  </a:lnTo>
                  <a:lnTo>
                    <a:pt x="885" y="965"/>
                  </a:lnTo>
                  <a:lnTo>
                    <a:pt x="886" y="966"/>
                  </a:lnTo>
                  <a:lnTo>
                    <a:pt x="886" y="967"/>
                  </a:lnTo>
                  <a:lnTo>
                    <a:pt x="887" y="968"/>
                  </a:lnTo>
                  <a:lnTo>
                    <a:pt x="887" y="969"/>
                  </a:lnTo>
                  <a:lnTo>
                    <a:pt x="888" y="970"/>
                  </a:lnTo>
                  <a:lnTo>
                    <a:pt x="889" y="971"/>
                  </a:lnTo>
                  <a:lnTo>
                    <a:pt x="889" y="972"/>
                  </a:lnTo>
                  <a:lnTo>
                    <a:pt x="890" y="973"/>
                  </a:lnTo>
                  <a:lnTo>
                    <a:pt x="890" y="974"/>
                  </a:lnTo>
                  <a:lnTo>
                    <a:pt x="891" y="974"/>
                  </a:lnTo>
                  <a:lnTo>
                    <a:pt x="891" y="975"/>
                  </a:lnTo>
                  <a:lnTo>
                    <a:pt x="892" y="976"/>
                  </a:lnTo>
                  <a:lnTo>
                    <a:pt x="892" y="977"/>
                  </a:lnTo>
                  <a:lnTo>
                    <a:pt x="893" y="978"/>
                  </a:lnTo>
                  <a:lnTo>
                    <a:pt x="894" y="979"/>
                  </a:lnTo>
                  <a:lnTo>
                    <a:pt x="894" y="980"/>
                  </a:lnTo>
                  <a:lnTo>
                    <a:pt x="895" y="980"/>
                  </a:lnTo>
                  <a:lnTo>
                    <a:pt x="895" y="981"/>
                  </a:lnTo>
                  <a:lnTo>
                    <a:pt x="896" y="982"/>
                  </a:lnTo>
                  <a:lnTo>
                    <a:pt x="897" y="983"/>
                  </a:lnTo>
                  <a:lnTo>
                    <a:pt x="897" y="984"/>
                  </a:lnTo>
                  <a:lnTo>
                    <a:pt x="898" y="984"/>
                  </a:lnTo>
                  <a:lnTo>
                    <a:pt x="898" y="985"/>
                  </a:lnTo>
                  <a:lnTo>
                    <a:pt x="899" y="986"/>
                  </a:lnTo>
                  <a:lnTo>
                    <a:pt x="900" y="987"/>
                  </a:lnTo>
                  <a:lnTo>
                    <a:pt x="900" y="988"/>
                  </a:lnTo>
                  <a:lnTo>
                    <a:pt x="901" y="989"/>
                  </a:lnTo>
                  <a:lnTo>
                    <a:pt x="901" y="990"/>
                  </a:lnTo>
                  <a:lnTo>
                    <a:pt x="902" y="991"/>
                  </a:lnTo>
                  <a:lnTo>
                    <a:pt x="902" y="992"/>
                  </a:lnTo>
                  <a:lnTo>
                    <a:pt x="903" y="992"/>
                  </a:lnTo>
                  <a:lnTo>
                    <a:pt x="903" y="993"/>
                  </a:lnTo>
                  <a:lnTo>
                    <a:pt x="904" y="993"/>
                  </a:lnTo>
                  <a:lnTo>
                    <a:pt x="904" y="994"/>
                  </a:lnTo>
                  <a:lnTo>
                    <a:pt x="905" y="995"/>
                  </a:lnTo>
                  <a:lnTo>
                    <a:pt x="906" y="996"/>
                  </a:lnTo>
                  <a:lnTo>
                    <a:pt x="907" y="996"/>
                  </a:lnTo>
                  <a:lnTo>
                    <a:pt x="907" y="997"/>
                  </a:lnTo>
                  <a:lnTo>
                    <a:pt x="908" y="997"/>
                  </a:lnTo>
                  <a:lnTo>
                    <a:pt x="909" y="998"/>
                  </a:lnTo>
                  <a:lnTo>
                    <a:pt x="910" y="998"/>
                  </a:lnTo>
                  <a:lnTo>
                    <a:pt x="911" y="997"/>
                  </a:lnTo>
                  <a:lnTo>
                    <a:pt x="912" y="997"/>
                  </a:lnTo>
                  <a:lnTo>
                    <a:pt x="912" y="996"/>
                  </a:lnTo>
                  <a:lnTo>
                    <a:pt x="913" y="996"/>
                  </a:lnTo>
                  <a:lnTo>
                    <a:pt x="914" y="995"/>
                  </a:lnTo>
                  <a:lnTo>
                    <a:pt x="915" y="994"/>
                  </a:lnTo>
                  <a:lnTo>
                    <a:pt x="916" y="993"/>
                  </a:lnTo>
                  <a:lnTo>
                    <a:pt x="917" y="993"/>
                  </a:lnTo>
                  <a:lnTo>
                    <a:pt x="917" y="992"/>
                  </a:lnTo>
                  <a:lnTo>
                    <a:pt x="918" y="992"/>
                  </a:lnTo>
                  <a:lnTo>
                    <a:pt x="918" y="991"/>
                  </a:lnTo>
                  <a:lnTo>
                    <a:pt x="919" y="991"/>
                  </a:lnTo>
                  <a:lnTo>
                    <a:pt x="920" y="991"/>
                  </a:lnTo>
                  <a:lnTo>
                    <a:pt x="920" y="990"/>
                  </a:lnTo>
                  <a:lnTo>
                    <a:pt x="921" y="990"/>
                  </a:lnTo>
                  <a:lnTo>
                    <a:pt x="922" y="990"/>
                  </a:lnTo>
                  <a:lnTo>
                    <a:pt x="922" y="991"/>
                  </a:lnTo>
                  <a:lnTo>
                    <a:pt x="923" y="991"/>
                  </a:lnTo>
                  <a:lnTo>
                    <a:pt x="924" y="992"/>
                  </a:lnTo>
                  <a:lnTo>
                    <a:pt x="925" y="992"/>
                  </a:lnTo>
                  <a:lnTo>
                    <a:pt x="925" y="993"/>
                  </a:lnTo>
                  <a:lnTo>
                    <a:pt x="926" y="993"/>
                  </a:lnTo>
                  <a:lnTo>
                    <a:pt x="926" y="994"/>
                  </a:lnTo>
                  <a:lnTo>
                    <a:pt x="927" y="995"/>
                  </a:lnTo>
                  <a:lnTo>
                    <a:pt x="928" y="996"/>
                  </a:lnTo>
                  <a:lnTo>
                    <a:pt x="929" y="997"/>
                  </a:lnTo>
                  <a:lnTo>
                    <a:pt x="930" y="998"/>
                  </a:lnTo>
                  <a:lnTo>
                    <a:pt x="931" y="999"/>
                  </a:lnTo>
                  <a:lnTo>
                    <a:pt x="932" y="999"/>
                  </a:lnTo>
                  <a:lnTo>
                    <a:pt x="933" y="999"/>
                  </a:lnTo>
                  <a:lnTo>
                    <a:pt x="934" y="999"/>
                  </a:lnTo>
                  <a:lnTo>
                    <a:pt x="935" y="998"/>
                  </a:lnTo>
                  <a:lnTo>
                    <a:pt x="935" y="997"/>
                  </a:lnTo>
                  <a:lnTo>
                    <a:pt x="936" y="997"/>
                  </a:lnTo>
                  <a:lnTo>
                    <a:pt x="936" y="996"/>
                  </a:lnTo>
                  <a:lnTo>
                    <a:pt x="937" y="996"/>
                  </a:lnTo>
                  <a:lnTo>
                    <a:pt x="937" y="995"/>
                  </a:lnTo>
                  <a:lnTo>
                    <a:pt x="938" y="994"/>
                  </a:lnTo>
                  <a:lnTo>
                    <a:pt x="938" y="993"/>
                  </a:lnTo>
                  <a:lnTo>
                    <a:pt x="939" y="993"/>
                  </a:lnTo>
                  <a:lnTo>
                    <a:pt x="939" y="992"/>
                  </a:lnTo>
                  <a:lnTo>
                    <a:pt x="940" y="991"/>
                  </a:lnTo>
                  <a:lnTo>
                    <a:pt x="940" y="990"/>
                  </a:lnTo>
                  <a:lnTo>
                    <a:pt x="941" y="989"/>
                  </a:lnTo>
                  <a:lnTo>
                    <a:pt x="941" y="988"/>
                  </a:lnTo>
                  <a:lnTo>
                    <a:pt x="942" y="987"/>
                  </a:lnTo>
                  <a:lnTo>
                    <a:pt x="942" y="986"/>
                  </a:lnTo>
                  <a:lnTo>
                    <a:pt x="943" y="986"/>
                  </a:lnTo>
                  <a:lnTo>
                    <a:pt x="943" y="985"/>
                  </a:lnTo>
                  <a:lnTo>
                    <a:pt x="944" y="984"/>
                  </a:lnTo>
                  <a:lnTo>
                    <a:pt x="944" y="983"/>
                  </a:lnTo>
                  <a:lnTo>
                    <a:pt x="944" y="982"/>
                  </a:lnTo>
                  <a:lnTo>
                    <a:pt x="945" y="981"/>
                  </a:lnTo>
                  <a:lnTo>
                    <a:pt x="945" y="980"/>
                  </a:lnTo>
                  <a:lnTo>
                    <a:pt x="946" y="980"/>
                  </a:lnTo>
                  <a:lnTo>
                    <a:pt x="946" y="979"/>
                  </a:lnTo>
                  <a:lnTo>
                    <a:pt x="947" y="978"/>
                  </a:lnTo>
                  <a:lnTo>
                    <a:pt x="948" y="977"/>
                  </a:lnTo>
                  <a:lnTo>
                    <a:pt x="948" y="976"/>
                  </a:lnTo>
                  <a:lnTo>
                    <a:pt x="949" y="976"/>
                  </a:lnTo>
                  <a:lnTo>
                    <a:pt x="949" y="975"/>
                  </a:lnTo>
                  <a:lnTo>
                    <a:pt x="950" y="975"/>
                  </a:lnTo>
                  <a:lnTo>
                    <a:pt x="950" y="974"/>
                  </a:lnTo>
                  <a:lnTo>
                    <a:pt x="951" y="974"/>
                  </a:lnTo>
                  <a:lnTo>
                    <a:pt x="951" y="973"/>
                  </a:lnTo>
                  <a:lnTo>
                    <a:pt x="952" y="972"/>
                  </a:lnTo>
                  <a:lnTo>
                    <a:pt x="952" y="971"/>
                  </a:lnTo>
                  <a:lnTo>
                    <a:pt x="953" y="971"/>
                  </a:lnTo>
                  <a:lnTo>
                    <a:pt x="953" y="970"/>
                  </a:lnTo>
                  <a:lnTo>
                    <a:pt x="954" y="970"/>
                  </a:lnTo>
                  <a:lnTo>
                    <a:pt x="954" y="969"/>
                  </a:lnTo>
                  <a:lnTo>
                    <a:pt x="955" y="969"/>
                  </a:lnTo>
                  <a:lnTo>
                    <a:pt x="955" y="968"/>
                  </a:lnTo>
                  <a:lnTo>
                    <a:pt x="956" y="967"/>
                  </a:lnTo>
                  <a:lnTo>
                    <a:pt x="957" y="966"/>
                  </a:lnTo>
                  <a:lnTo>
                    <a:pt x="958" y="965"/>
                  </a:lnTo>
                  <a:lnTo>
                    <a:pt x="958" y="964"/>
                  </a:lnTo>
                  <a:lnTo>
                    <a:pt x="959" y="964"/>
                  </a:lnTo>
                  <a:lnTo>
                    <a:pt x="959" y="963"/>
                  </a:lnTo>
                  <a:lnTo>
                    <a:pt x="960" y="962"/>
                  </a:lnTo>
                  <a:lnTo>
                    <a:pt x="961" y="961"/>
                  </a:lnTo>
                  <a:lnTo>
                    <a:pt x="961" y="960"/>
                  </a:lnTo>
                  <a:lnTo>
                    <a:pt x="961" y="959"/>
                  </a:lnTo>
                  <a:lnTo>
                    <a:pt x="962" y="959"/>
                  </a:lnTo>
                  <a:lnTo>
                    <a:pt x="962" y="958"/>
                  </a:lnTo>
                  <a:lnTo>
                    <a:pt x="963" y="957"/>
                  </a:lnTo>
                  <a:lnTo>
                    <a:pt x="963" y="956"/>
                  </a:lnTo>
                  <a:lnTo>
                    <a:pt x="964" y="955"/>
                  </a:lnTo>
                  <a:lnTo>
                    <a:pt x="964" y="953"/>
                  </a:lnTo>
                  <a:lnTo>
                    <a:pt x="965" y="952"/>
                  </a:lnTo>
                  <a:lnTo>
                    <a:pt x="965" y="951"/>
                  </a:lnTo>
                  <a:lnTo>
                    <a:pt x="966" y="950"/>
                  </a:lnTo>
                  <a:lnTo>
                    <a:pt x="966" y="948"/>
                  </a:lnTo>
                  <a:lnTo>
                    <a:pt x="967" y="947"/>
                  </a:lnTo>
                  <a:lnTo>
                    <a:pt x="967" y="945"/>
                  </a:lnTo>
                  <a:lnTo>
                    <a:pt x="968" y="944"/>
                  </a:lnTo>
                  <a:lnTo>
                    <a:pt x="968" y="942"/>
                  </a:lnTo>
                  <a:lnTo>
                    <a:pt x="969" y="940"/>
                  </a:lnTo>
                  <a:lnTo>
                    <a:pt x="969" y="938"/>
                  </a:lnTo>
                  <a:lnTo>
                    <a:pt x="969" y="936"/>
                  </a:lnTo>
                  <a:lnTo>
                    <a:pt x="970" y="934"/>
                  </a:lnTo>
                  <a:lnTo>
                    <a:pt x="970" y="932"/>
                  </a:lnTo>
                  <a:lnTo>
                    <a:pt x="971" y="930"/>
                  </a:lnTo>
                  <a:lnTo>
                    <a:pt x="971" y="928"/>
                  </a:lnTo>
                  <a:lnTo>
                    <a:pt x="972" y="925"/>
                  </a:lnTo>
                  <a:lnTo>
                    <a:pt x="972" y="923"/>
                  </a:lnTo>
                  <a:lnTo>
                    <a:pt x="973" y="921"/>
                  </a:lnTo>
                  <a:lnTo>
                    <a:pt x="973" y="919"/>
                  </a:lnTo>
                  <a:lnTo>
                    <a:pt x="974" y="917"/>
                  </a:lnTo>
                  <a:lnTo>
                    <a:pt x="974" y="915"/>
                  </a:lnTo>
                  <a:lnTo>
                    <a:pt x="975" y="913"/>
                  </a:lnTo>
                  <a:lnTo>
                    <a:pt x="975" y="911"/>
                  </a:lnTo>
                  <a:lnTo>
                    <a:pt x="976" y="910"/>
                  </a:lnTo>
                  <a:lnTo>
                    <a:pt x="976" y="908"/>
                  </a:lnTo>
                  <a:lnTo>
                    <a:pt x="977" y="906"/>
                  </a:lnTo>
                  <a:lnTo>
                    <a:pt x="977" y="905"/>
                  </a:lnTo>
                  <a:lnTo>
                    <a:pt x="978" y="904"/>
                  </a:lnTo>
                  <a:lnTo>
                    <a:pt x="978" y="903"/>
                  </a:lnTo>
                  <a:lnTo>
                    <a:pt x="978" y="902"/>
                  </a:lnTo>
                  <a:lnTo>
                    <a:pt x="979" y="902"/>
                  </a:lnTo>
                  <a:lnTo>
                    <a:pt x="979" y="901"/>
                  </a:lnTo>
                  <a:lnTo>
                    <a:pt x="980" y="901"/>
                  </a:lnTo>
                  <a:lnTo>
                    <a:pt x="981" y="902"/>
                  </a:lnTo>
                  <a:lnTo>
                    <a:pt x="981" y="903"/>
                  </a:lnTo>
                  <a:lnTo>
                    <a:pt x="982" y="904"/>
                  </a:lnTo>
                  <a:lnTo>
                    <a:pt x="982" y="905"/>
                  </a:lnTo>
                  <a:lnTo>
                    <a:pt x="983" y="907"/>
                  </a:lnTo>
                  <a:lnTo>
                    <a:pt x="983" y="908"/>
                  </a:lnTo>
                  <a:lnTo>
                    <a:pt x="984" y="910"/>
                  </a:lnTo>
                  <a:lnTo>
                    <a:pt x="984" y="912"/>
                  </a:lnTo>
                  <a:lnTo>
                    <a:pt x="985" y="914"/>
                  </a:lnTo>
                  <a:lnTo>
                    <a:pt x="985" y="917"/>
                  </a:lnTo>
                  <a:lnTo>
                    <a:pt x="986" y="919"/>
                  </a:lnTo>
                  <a:lnTo>
                    <a:pt x="986" y="922"/>
                  </a:lnTo>
                  <a:lnTo>
                    <a:pt x="986" y="924"/>
                  </a:lnTo>
                  <a:lnTo>
                    <a:pt x="987" y="926"/>
                  </a:lnTo>
                  <a:lnTo>
                    <a:pt x="987" y="929"/>
                  </a:lnTo>
                  <a:lnTo>
                    <a:pt x="988" y="932"/>
                  </a:lnTo>
                  <a:lnTo>
                    <a:pt x="988" y="934"/>
                  </a:lnTo>
                  <a:lnTo>
                    <a:pt x="989" y="937"/>
                  </a:lnTo>
                  <a:lnTo>
                    <a:pt x="989" y="939"/>
                  </a:lnTo>
                  <a:lnTo>
                    <a:pt x="990" y="942"/>
                  </a:lnTo>
                  <a:lnTo>
                    <a:pt x="990" y="944"/>
                  </a:lnTo>
                  <a:lnTo>
                    <a:pt x="991" y="946"/>
                  </a:lnTo>
                  <a:lnTo>
                    <a:pt x="991" y="948"/>
                  </a:lnTo>
                  <a:lnTo>
                    <a:pt x="992" y="951"/>
                  </a:lnTo>
                  <a:lnTo>
                    <a:pt x="992" y="952"/>
                  </a:lnTo>
                  <a:lnTo>
                    <a:pt x="993" y="954"/>
                  </a:lnTo>
                  <a:lnTo>
                    <a:pt x="993" y="955"/>
                  </a:lnTo>
                  <a:lnTo>
                    <a:pt x="994" y="957"/>
                  </a:lnTo>
                  <a:lnTo>
                    <a:pt x="994" y="958"/>
                  </a:lnTo>
                  <a:lnTo>
                    <a:pt x="995" y="959"/>
                  </a:lnTo>
                  <a:lnTo>
                    <a:pt x="995" y="960"/>
                  </a:lnTo>
                  <a:lnTo>
                    <a:pt x="996" y="961"/>
                  </a:lnTo>
                  <a:lnTo>
                    <a:pt x="996" y="962"/>
                  </a:lnTo>
                  <a:lnTo>
                    <a:pt x="997" y="962"/>
                  </a:lnTo>
                  <a:lnTo>
                    <a:pt x="997" y="963"/>
                  </a:lnTo>
                  <a:lnTo>
                    <a:pt x="998" y="963"/>
                  </a:lnTo>
                  <a:lnTo>
                    <a:pt x="999" y="963"/>
                  </a:lnTo>
                  <a:lnTo>
                    <a:pt x="1000" y="964"/>
                  </a:lnTo>
                  <a:lnTo>
                    <a:pt x="1001" y="964"/>
                  </a:lnTo>
                  <a:lnTo>
                    <a:pt x="1002" y="964"/>
                  </a:lnTo>
                  <a:lnTo>
                    <a:pt x="1002" y="963"/>
                  </a:lnTo>
                  <a:lnTo>
                    <a:pt x="1003" y="963"/>
                  </a:lnTo>
                  <a:lnTo>
                    <a:pt x="1004" y="963"/>
                  </a:lnTo>
                  <a:lnTo>
                    <a:pt x="1005" y="963"/>
                  </a:lnTo>
                  <a:lnTo>
                    <a:pt x="1006" y="964"/>
                  </a:lnTo>
                  <a:lnTo>
                    <a:pt x="1007" y="964"/>
                  </a:lnTo>
                  <a:lnTo>
                    <a:pt x="1008" y="964"/>
                  </a:lnTo>
                  <a:lnTo>
                    <a:pt x="1009" y="965"/>
                  </a:lnTo>
                  <a:lnTo>
                    <a:pt x="1010" y="965"/>
                  </a:lnTo>
                  <a:lnTo>
                    <a:pt x="1011" y="965"/>
                  </a:lnTo>
                  <a:lnTo>
                    <a:pt x="1011" y="966"/>
                  </a:lnTo>
                  <a:lnTo>
                    <a:pt x="1012" y="966"/>
                  </a:lnTo>
                  <a:lnTo>
                    <a:pt x="1013" y="966"/>
                  </a:lnTo>
                  <a:lnTo>
                    <a:pt x="1013" y="967"/>
                  </a:lnTo>
                  <a:lnTo>
                    <a:pt x="1014" y="967"/>
                  </a:lnTo>
                  <a:lnTo>
                    <a:pt x="1015" y="967"/>
                  </a:lnTo>
                  <a:lnTo>
                    <a:pt x="1016" y="968"/>
                  </a:lnTo>
                  <a:lnTo>
                    <a:pt x="1017" y="968"/>
                  </a:lnTo>
                  <a:lnTo>
                    <a:pt x="1018" y="968"/>
                  </a:lnTo>
                  <a:lnTo>
                    <a:pt x="1019" y="968"/>
                  </a:lnTo>
                  <a:lnTo>
                    <a:pt x="1020" y="968"/>
                  </a:lnTo>
                  <a:lnTo>
                    <a:pt x="1021" y="968"/>
                  </a:lnTo>
                  <a:lnTo>
                    <a:pt x="1022" y="968"/>
                  </a:lnTo>
                  <a:lnTo>
                    <a:pt x="1023" y="968"/>
                  </a:lnTo>
                  <a:lnTo>
                    <a:pt x="1024" y="968"/>
                  </a:lnTo>
                  <a:lnTo>
                    <a:pt x="1025" y="968"/>
                  </a:lnTo>
                  <a:lnTo>
                    <a:pt x="1026" y="967"/>
                  </a:lnTo>
                  <a:lnTo>
                    <a:pt x="1027" y="967"/>
                  </a:lnTo>
                  <a:lnTo>
                    <a:pt x="1027" y="966"/>
                  </a:lnTo>
                  <a:lnTo>
                    <a:pt x="1028" y="966"/>
                  </a:lnTo>
                  <a:lnTo>
                    <a:pt x="1029" y="965"/>
                  </a:lnTo>
                  <a:lnTo>
                    <a:pt x="1029" y="964"/>
                  </a:lnTo>
                  <a:lnTo>
                    <a:pt x="1030" y="963"/>
                  </a:lnTo>
                  <a:lnTo>
                    <a:pt x="1031" y="962"/>
                  </a:lnTo>
                  <a:lnTo>
                    <a:pt x="1032" y="961"/>
                  </a:lnTo>
                  <a:lnTo>
                    <a:pt x="1033" y="960"/>
                  </a:lnTo>
                  <a:lnTo>
                    <a:pt x="1034" y="959"/>
                  </a:lnTo>
                  <a:lnTo>
                    <a:pt x="1035" y="958"/>
                  </a:lnTo>
                  <a:lnTo>
                    <a:pt x="1036" y="958"/>
                  </a:lnTo>
                  <a:lnTo>
                    <a:pt x="1036" y="957"/>
                  </a:lnTo>
                  <a:lnTo>
                    <a:pt x="1037" y="957"/>
                  </a:lnTo>
                  <a:lnTo>
                    <a:pt x="1038" y="957"/>
                  </a:lnTo>
                  <a:lnTo>
                    <a:pt x="1039" y="957"/>
                  </a:lnTo>
                  <a:lnTo>
                    <a:pt x="1040" y="957"/>
                  </a:lnTo>
                  <a:lnTo>
                    <a:pt x="1040" y="958"/>
                  </a:lnTo>
                  <a:lnTo>
                    <a:pt x="1041" y="959"/>
                  </a:lnTo>
                  <a:lnTo>
                    <a:pt x="1042" y="960"/>
                  </a:lnTo>
                  <a:lnTo>
                    <a:pt x="1042" y="961"/>
                  </a:lnTo>
                  <a:lnTo>
                    <a:pt x="1043" y="962"/>
                  </a:lnTo>
                  <a:lnTo>
                    <a:pt x="1043" y="963"/>
                  </a:lnTo>
                  <a:lnTo>
                    <a:pt x="1044" y="964"/>
                  </a:lnTo>
                  <a:lnTo>
                    <a:pt x="1044" y="965"/>
                  </a:lnTo>
                  <a:lnTo>
                    <a:pt x="1045" y="966"/>
                  </a:lnTo>
                  <a:lnTo>
                    <a:pt x="1045" y="967"/>
                  </a:lnTo>
                  <a:lnTo>
                    <a:pt x="1046" y="968"/>
                  </a:lnTo>
                  <a:lnTo>
                    <a:pt x="1046" y="969"/>
                  </a:lnTo>
                  <a:lnTo>
                    <a:pt x="1046" y="970"/>
                  </a:lnTo>
                  <a:lnTo>
                    <a:pt x="1047" y="971"/>
                  </a:lnTo>
                  <a:lnTo>
                    <a:pt x="1047" y="972"/>
                  </a:lnTo>
                  <a:lnTo>
                    <a:pt x="1048" y="973"/>
                  </a:lnTo>
                  <a:lnTo>
                    <a:pt x="1048" y="974"/>
                  </a:lnTo>
                  <a:lnTo>
                    <a:pt x="1049" y="975"/>
                  </a:lnTo>
                  <a:lnTo>
                    <a:pt x="1049" y="976"/>
                  </a:lnTo>
                  <a:lnTo>
                    <a:pt x="1050" y="977"/>
                  </a:lnTo>
                  <a:lnTo>
                    <a:pt x="1050" y="978"/>
                  </a:lnTo>
                  <a:lnTo>
                    <a:pt x="1051" y="979"/>
                  </a:lnTo>
                  <a:lnTo>
                    <a:pt x="1051" y="980"/>
                  </a:lnTo>
                  <a:lnTo>
                    <a:pt x="1052" y="980"/>
                  </a:lnTo>
                  <a:lnTo>
                    <a:pt x="1052" y="981"/>
                  </a:lnTo>
                  <a:lnTo>
                    <a:pt x="1053" y="981"/>
                  </a:lnTo>
                  <a:lnTo>
                    <a:pt x="1053" y="982"/>
                  </a:lnTo>
                  <a:lnTo>
                    <a:pt x="1054" y="982"/>
                  </a:lnTo>
                  <a:lnTo>
                    <a:pt x="1055" y="983"/>
                  </a:lnTo>
                  <a:lnTo>
                    <a:pt x="1056" y="984"/>
                  </a:lnTo>
                  <a:lnTo>
                    <a:pt x="1057" y="984"/>
                  </a:lnTo>
                  <a:lnTo>
                    <a:pt x="1058" y="984"/>
                  </a:lnTo>
                  <a:lnTo>
                    <a:pt x="1058" y="985"/>
                  </a:lnTo>
                  <a:lnTo>
                    <a:pt x="1059" y="985"/>
                  </a:lnTo>
                  <a:lnTo>
                    <a:pt x="1060" y="986"/>
                  </a:lnTo>
                  <a:lnTo>
                    <a:pt x="1061" y="986"/>
                  </a:lnTo>
                  <a:lnTo>
                    <a:pt x="1061" y="987"/>
                  </a:lnTo>
                  <a:lnTo>
                    <a:pt x="1062" y="987"/>
                  </a:lnTo>
                  <a:lnTo>
                    <a:pt x="1062" y="988"/>
                  </a:lnTo>
                  <a:lnTo>
                    <a:pt x="1063" y="988"/>
                  </a:lnTo>
                  <a:lnTo>
                    <a:pt x="1063" y="989"/>
                  </a:lnTo>
                  <a:lnTo>
                    <a:pt x="1063" y="990"/>
                  </a:lnTo>
                  <a:lnTo>
                    <a:pt x="1064" y="991"/>
                  </a:lnTo>
                  <a:lnTo>
                    <a:pt x="1064" y="992"/>
                  </a:lnTo>
                  <a:lnTo>
                    <a:pt x="1065" y="993"/>
                  </a:lnTo>
                  <a:lnTo>
                    <a:pt x="1065" y="994"/>
                  </a:lnTo>
                  <a:lnTo>
                    <a:pt x="1066" y="995"/>
                  </a:lnTo>
                  <a:lnTo>
                    <a:pt x="1066" y="996"/>
                  </a:lnTo>
                  <a:lnTo>
                    <a:pt x="1067" y="997"/>
                  </a:lnTo>
                  <a:lnTo>
                    <a:pt x="1067" y="998"/>
                  </a:lnTo>
                  <a:lnTo>
                    <a:pt x="1068" y="999"/>
                  </a:lnTo>
                  <a:lnTo>
                    <a:pt x="1068" y="1001"/>
                  </a:lnTo>
                  <a:lnTo>
                    <a:pt x="1069" y="1002"/>
                  </a:lnTo>
                  <a:lnTo>
                    <a:pt x="1069" y="1003"/>
                  </a:lnTo>
                  <a:lnTo>
                    <a:pt x="1070" y="1004"/>
                  </a:lnTo>
                  <a:lnTo>
                    <a:pt x="1070" y="1006"/>
                  </a:lnTo>
                  <a:lnTo>
                    <a:pt x="1071" y="1007"/>
                  </a:lnTo>
                  <a:lnTo>
                    <a:pt x="1071" y="1008"/>
                  </a:lnTo>
                  <a:lnTo>
                    <a:pt x="1072" y="1009"/>
                  </a:lnTo>
                  <a:lnTo>
                    <a:pt x="1072" y="1010"/>
                  </a:lnTo>
                  <a:lnTo>
                    <a:pt x="1072" y="1011"/>
                  </a:lnTo>
                  <a:lnTo>
                    <a:pt x="1073" y="1012"/>
                  </a:lnTo>
                  <a:lnTo>
                    <a:pt x="1073" y="1013"/>
                  </a:lnTo>
                  <a:lnTo>
                    <a:pt x="1074" y="1014"/>
                  </a:lnTo>
                  <a:lnTo>
                    <a:pt x="1074" y="1015"/>
                  </a:lnTo>
                  <a:lnTo>
                    <a:pt x="1075" y="1016"/>
                  </a:lnTo>
                  <a:lnTo>
                    <a:pt x="1075" y="1017"/>
                  </a:lnTo>
                  <a:lnTo>
                    <a:pt x="1076" y="1017"/>
                  </a:lnTo>
                  <a:lnTo>
                    <a:pt x="1076" y="1018"/>
                  </a:lnTo>
                  <a:lnTo>
                    <a:pt x="1077" y="1018"/>
                  </a:lnTo>
                  <a:lnTo>
                    <a:pt x="1077" y="1019"/>
                  </a:lnTo>
                  <a:lnTo>
                    <a:pt x="1078" y="1019"/>
                  </a:lnTo>
                  <a:lnTo>
                    <a:pt x="1079" y="1019"/>
                  </a:lnTo>
                  <a:lnTo>
                    <a:pt x="1080" y="1020"/>
                  </a:lnTo>
                  <a:lnTo>
                    <a:pt x="1081" y="1020"/>
                  </a:lnTo>
                  <a:lnTo>
                    <a:pt x="1082" y="1020"/>
                  </a:lnTo>
                  <a:lnTo>
                    <a:pt x="1082" y="1019"/>
                  </a:lnTo>
                  <a:lnTo>
                    <a:pt x="1083" y="1019"/>
                  </a:lnTo>
                  <a:lnTo>
                    <a:pt x="1084" y="1019"/>
                  </a:lnTo>
                  <a:lnTo>
                    <a:pt x="1085" y="1019"/>
                  </a:lnTo>
                  <a:lnTo>
                    <a:pt x="1085" y="1018"/>
                  </a:lnTo>
                  <a:lnTo>
                    <a:pt x="1086" y="1018"/>
                  </a:lnTo>
                  <a:lnTo>
                    <a:pt x="1087" y="1018"/>
                  </a:lnTo>
                  <a:lnTo>
                    <a:pt x="1087" y="1017"/>
                  </a:lnTo>
                  <a:lnTo>
                    <a:pt x="1088" y="1017"/>
                  </a:lnTo>
                  <a:lnTo>
                    <a:pt x="1089" y="1017"/>
                  </a:lnTo>
                  <a:lnTo>
                    <a:pt x="1089" y="1016"/>
                  </a:lnTo>
                  <a:lnTo>
                    <a:pt x="1090" y="1016"/>
                  </a:lnTo>
                  <a:lnTo>
                    <a:pt x="1091" y="1016"/>
                  </a:lnTo>
                  <a:lnTo>
                    <a:pt x="1092" y="1015"/>
                  </a:lnTo>
                  <a:lnTo>
                    <a:pt x="1093" y="1015"/>
                  </a:lnTo>
                  <a:lnTo>
                    <a:pt x="1094" y="1015"/>
                  </a:lnTo>
                  <a:lnTo>
                    <a:pt x="1095" y="1014"/>
                  </a:lnTo>
                  <a:lnTo>
                    <a:pt x="1096" y="1014"/>
                  </a:lnTo>
                  <a:lnTo>
                    <a:pt x="1097" y="1014"/>
                  </a:lnTo>
                  <a:lnTo>
                    <a:pt x="1097" y="1013"/>
                  </a:lnTo>
                  <a:lnTo>
                    <a:pt x="1098" y="1013"/>
                  </a:lnTo>
                  <a:lnTo>
                    <a:pt x="1099" y="1013"/>
                  </a:lnTo>
                  <a:lnTo>
                    <a:pt x="1100" y="1012"/>
                  </a:lnTo>
                  <a:lnTo>
                    <a:pt x="1101" y="1012"/>
                  </a:lnTo>
                  <a:lnTo>
                    <a:pt x="1102" y="1012"/>
                  </a:lnTo>
                  <a:lnTo>
                    <a:pt x="1103" y="1012"/>
                  </a:lnTo>
                  <a:lnTo>
                    <a:pt x="1104" y="1012"/>
                  </a:lnTo>
                  <a:lnTo>
                    <a:pt x="1105" y="1012"/>
                  </a:lnTo>
                  <a:lnTo>
                    <a:pt x="1106" y="1012"/>
                  </a:lnTo>
                  <a:lnTo>
                    <a:pt x="1107" y="1013"/>
                  </a:lnTo>
                  <a:lnTo>
                    <a:pt x="1108" y="1013"/>
                  </a:lnTo>
                  <a:lnTo>
                    <a:pt x="1108" y="1014"/>
                  </a:lnTo>
                  <a:lnTo>
                    <a:pt x="1109" y="1014"/>
                  </a:lnTo>
                  <a:lnTo>
                    <a:pt x="1109" y="1015"/>
                  </a:lnTo>
                  <a:lnTo>
                    <a:pt x="1110" y="1015"/>
                  </a:lnTo>
                  <a:lnTo>
                    <a:pt x="1110" y="1016"/>
                  </a:lnTo>
                  <a:lnTo>
                    <a:pt x="1111" y="1017"/>
                  </a:lnTo>
                  <a:lnTo>
                    <a:pt x="1111" y="1018"/>
                  </a:lnTo>
                  <a:lnTo>
                    <a:pt x="1112" y="1019"/>
                  </a:lnTo>
                  <a:lnTo>
                    <a:pt x="1112" y="1020"/>
                  </a:lnTo>
                  <a:lnTo>
                    <a:pt x="1113" y="1021"/>
                  </a:lnTo>
                  <a:lnTo>
                    <a:pt x="1113" y="1022"/>
                  </a:lnTo>
                  <a:lnTo>
                    <a:pt x="1114" y="1023"/>
                  </a:lnTo>
                  <a:lnTo>
                    <a:pt x="1114" y="1024"/>
                  </a:lnTo>
                  <a:lnTo>
                    <a:pt x="1115" y="1025"/>
                  </a:lnTo>
                  <a:lnTo>
                    <a:pt x="1115" y="1026"/>
                  </a:lnTo>
                  <a:lnTo>
                    <a:pt x="1115" y="1028"/>
                  </a:lnTo>
                  <a:lnTo>
                    <a:pt x="1116" y="1029"/>
                  </a:lnTo>
                  <a:lnTo>
                    <a:pt x="1116" y="1030"/>
                  </a:lnTo>
                  <a:lnTo>
                    <a:pt x="1117" y="1031"/>
                  </a:lnTo>
                  <a:lnTo>
                    <a:pt x="1117" y="1032"/>
                  </a:lnTo>
                  <a:lnTo>
                    <a:pt x="1118" y="1034"/>
                  </a:lnTo>
                  <a:lnTo>
                    <a:pt x="1118" y="1035"/>
                  </a:lnTo>
                  <a:lnTo>
                    <a:pt x="1119" y="1036"/>
                  </a:lnTo>
                  <a:lnTo>
                    <a:pt x="1119" y="1037"/>
                  </a:lnTo>
                  <a:lnTo>
                    <a:pt x="1120" y="1038"/>
                  </a:lnTo>
                  <a:lnTo>
                    <a:pt x="1120" y="1039"/>
                  </a:lnTo>
                  <a:lnTo>
                    <a:pt x="1121" y="1040"/>
                  </a:lnTo>
                  <a:lnTo>
                    <a:pt x="1121" y="1041"/>
                  </a:lnTo>
                  <a:lnTo>
                    <a:pt x="1122" y="1042"/>
                  </a:lnTo>
                  <a:lnTo>
                    <a:pt x="1122" y="1043"/>
                  </a:lnTo>
                  <a:lnTo>
                    <a:pt x="1123" y="1044"/>
                  </a:lnTo>
                  <a:lnTo>
                    <a:pt x="1123" y="1045"/>
                  </a:lnTo>
                  <a:lnTo>
                    <a:pt x="1124" y="1045"/>
                  </a:lnTo>
                  <a:lnTo>
                    <a:pt x="1124" y="1046"/>
                  </a:lnTo>
                  <a:lnTo>
                    <a:pt x="1125" y="1046"/>
                  </a:lnTo>
                  <a:lnTo>
                    <a:pt x="1126" y="1046"/>
                  </a:lnTo>
                  <a:lnTo>
                    <a:pt x="1126" y="1047"/>
                  </a:lnTo>
                  <a:lnTo>
                    <a:pt x="1127" y="1047"/>
                  </a:lnTo>
                  <a:lnTo>
                    <a:pt x="1128" y="1047"/>
                  </a:lnTo>
                  <a:lnTo>
                    <a:pt x="1129" y="1048"/>
                  </a:lnTo>
                  <a:lnTo>
                    <a:pt x="1130" y="1048"/>
                  </a:lnTo>
                  <a:lnTo>
                    <a:pt x="1131" y="1048"/>
                  </a:lnTo>
                  <a:lnTo>
                    <a:pt x="1132" y="1048"/>
                  </a:lnTo>
                  <a:lnTo>
                    <a:pt x="1132" y="1049"/>
                  </a:lnTo>
                  <a:lnTo>
                    <a:pt x="1133" y="1049"/>
                  </a:lnTo>
                  <a:lnTo>
                    <a:pt x="1134" y="1049"/>
                  </a:lnTo>
                  <a:lnTo>
                    <a:pt x="1134" y="1050"/>
                  </a:lnTo>
                  <a:lnTo>
                    <a:pt x="1135" y="1050"/>
                  </a:lnTo>
                  <a:lnTo>
                    <a:pt x="1135" y="1051"/>
                  </a:lnTo>
                  <a:lnTo>
                    <a:pt x="1136" y="1051"/>
                  </a:lnTo>
                  <a:lnTo>
                    <a:pt x="1136" y="1052"/>
                  </a:lnTo>
                  <a:lnTo>
                    <a:pt x="1137" y="1052"/>
                  </a:lnTo>
                  <a:lnTo>
                    <a:pt x="1137" y="1053"/>
                  </a:lnTo>
                  <a:lnTo>
                    <a:pt x="1138" y="1053"/>
                  </a:lnTo>
                  <a:lnTo>
                    <a:pt x="1138" y="1054"/>
                  </a:lnTo>
                  <a:lnTo>
                    <a:pt x="1139" y="1054"/>
                  </a:lnTo>
                  <a:lnTo>
                    <a:pt x="1140" y="1054"/>
                  </a:lnTo>
                  <a:lnTo>
                    <a:pt x="1141" y="1054"/>
                  </a:lnTo>
                  <a:lnTo>
                    <a:pt x="1142" y="1053"/>
                  </a:lnTo>
                  <a:lnTo>
                    <a:pt x="1143" y="1052"/>
                  </a:lnTo>
                  <a:lnTo>
                    <a:pt x="1143" y="1051"/>
                  </a:lnTo>
                  <a:lnTo>
                    <a:pt x="1144" y="1050"/>
                  </a:lnTo>
                  <a:lnTo>
                    <a:pt x="1144" y="1049"/>
                  </a:lnTo>
                  <a:lnTo>
                    <a:pt x="1145" y="1047"/>
                  </a:lnTo>
                  <a:lnTo>
                    <a:pt x="1145" y="1045"/>
                  </a:lnTo>
                  <a:lnTo>
                    <a:pt x="1146" y="1043"/>
                  </a:lnTo>
                  <a:lnTo>
                    <a:pt x="1146" y="1041"/>
                  </a:lnTo>
                  <a:lnTo>
                    <a:pt x="1147" y="1038"/>
                  </a:lnTo>
                  <a:lnTo>
                    <a:pt x="1147" y="1035"/>
                  </a:lnTo>
                  <a:lnTo>
                    <a:pt x="1148" y="1032"/>
                  </a:lnTo>
                  <a:lnTo>
                    <a:pt x="1148" y="1029"/>
                  </a:lnTo>
                  <a:lnTo>
                    <a:pt x="1149" y="1025"/>
                  </a:lnTo>
                  <a:lnTo>
                    <a:pt x="1149" y="1022"/>
                  </a:lnTo>
                  <a:lnTo>
                    <a:pt x="1149" y="1018"/>
                  </a:lnTo>
                  <a:lnTo>
                    <a:pt x="1150" y="1014"/>
                  </a:lnTo>
                  <a:lnTo>
                    <a:pt x="1150" y="1010"/>
                  </a:lnTo>
                  <a:lnTo>
                    <a:pt x="1151" y="1007"/>
                  </a:lnTo>
                  <a:lnTo>
                    <a:pt x="1151" y="1003"/>
                  </a:lnTo>
                  <a:lnTo>
                    <a:pt x="1152" y="999"/>
                  </a:lnTo>
                  <a:lnTo>
                    <a:pt x="1152" y="994"/>
                  </a:lnTo>
                  <a:lnTo>
                    <a:pt x="1153" y="990"/>
                  </a:lnTo>
                  <a:lnTo>
                    <a:pt x="1153" y="986"/>
                  </a:lnTo>
                  <a:lnTo>
                    <a:pt x="1154" y="982"/>
                  </a:lnTo>
                  <a:lnTo>
                    <a:pt x="1154" y="979"/>
                  </a:lnTo>
                  <a:lnTo>
                    <a:pt x="1155" y="975"/>
                  </a:lnTo>
                  <a:lnTo>
                    <a:pt x="1155" y="971"/>
                  </a:lnTo>
                  <a:lnTo>
                    <a:pt x="1156" y="967"/>
                  </a:lnTo>
                  <a:lnTo>
                    <a:pt x="1156" y="964"/>
                  </a:lnTo>
                  <a:lnTo>
                    <a:pt x="1157" y="960"/>
                  </a:lnTo>
                  <a:lnTo>
                    <a:pt x="1157" y="957"/>
                  </a:lnTo>
                  <a:lnTo>
                    <a:pt x="1158" y="954"/>
                  </a:lnTo>
                  <a:lnTo>
                    <a:pt x="1158" y="951"/>
                  </a:lnTo>
                  <a:lnTo>
                    <a:pt x="1158" y="949"/>
                  </a:lnTo>
                  <a:lnTo>
                    <a:pt x="1159" y="947"/>
                  </a:lnTo>
                  <a:lnTo>
                    <a:pt x="1159" y="945"/>
                  </a:lnTo>
                  <a:lnTo>
                    <a:pt x="1160" y="943"/>
                  </a:lnTo>
                  <a:lnTo>
                    <a:pt x="1160" y="942"/>
                  </a:lnTo>
                  <a:lnTo>
                    <a:pt x="1161" y="940"/>
                  </a:lnTo>
                  <a:lnTo>
                    <a:pt x="1161" y="939"/>
                  </a:lnTo>
                  <a:lnTo>
                    <a:pt x="1162" y="938"/>
                  </a:lnTo>
                  <a:lnTo>
                    <a:pt x="1162" y="937"/>
                  </a:lnTo>
                  <a:lnTo>
                    <a:pt x="1163" y="936"/>
                  </a:lnTo>
                  <a:lnTo>
                    <a:pt x="1163" y="935"/>
                  </a:lnTo>
                  <a:lnTo>
                    <a:pt x="1164" y="934"/>
                  </a:lnTo>
                  <a:lnTo>
                    <a:pt x="1165" y="934"/>
                  </a:lnTo>
                  <a:lnTo>
                    <a:pt x="1166" y="934"/>
                  </a:lnTo>
                  <a:lnTo>
                    <a:pt x="1167" y="934"/>
                  </a:lnTo>
                  <a:lnTo>
                    <a:pt x="1167" y="935"/>
                  </a:lnTo>
                  <a:lnTo>
                    <a:pt x="1168" y="935"/>
                  </a:lnTo>
                  <a:lnTo>
                    <a:pt x="1168" y="936"/>
                  </a:lnTo>
                  <a:lnTo>
                    <a:pt x="1169" y="936"/>
                  </a:lnTo>
                  <a:lnTo>
                    <a:pt x="1169" y="937"/>
                  </a:lnTo>
                  <a:lnTo>
                    <a:pt x="1170" y="938"/>
                  </a:lnTo>
                  <a:lnTo>
                    <a:pt x="1170" y="939"/>
                  </a:lnTo>
                  <a:lnTo>
                    <a:pt x="1171" y="940"/>
                  </a:lnTo>
                  <a:lnTo>
                    <a:pt x="1171" y="942"/>
                  </a:lnTo>
                  <a:lnTo>
                    <a:pt x="1172" y="943"/>
                  </a:lnTo>
                  <a:lnTo>
                    <a:pt x="1172" y="944"/>
                  </a:lnTo>
                  <a:lnTo>
                    <a:pt x="1173" y="946"/>
                  </a:lnTo>
                  <a:lnTo>
                    <a:pt x="1173" y="947"/>
                  </a:lnTo>
                  <a:lnTo>
                    <a:pt x="1174" y="949"/>
                  </a:lnTo>
                  <a:lnTo>
                    <a:pt x="1174" y="950"/>
                  </a:lnTo>
                  <a:lnTo>
                    <a:pt x="1175" y="952"/>
                  </a:lnTo>
                  <a:lnTo>
                    <a:pt x="1175" y="954"/>
                  </a:lnTo>
                  <a:lnTo>
                    <a:pt x="1175" y="956"/>
                  </a:lnTo>
                  <a:lnTo>
                    <a:pt x="1176" y="957"/>
                  </a:lnTo>
                  <a:lnTo>
                    <a:pt x="1176" y="959"/>
                  </a:lnTo>
                  <a:lnTo>
                    <a:pt x="1177" y="961"/>
                  </a:lnTo>
                  <a:lnTo>
                    <a:pt x="1177" y="963"/>
                  </a:lnTo>
                  <a:lnTo>
                    <a:pt x="1178" y="965"/>
                  </a:lnTo>
                  <a:lnTo>
                    <a:pt x="1178" y="968"/>
                  </a:lnTo>
                  <a:lnTo>
                    <a:pt x="1179" y="970"/>
                  </a:lnTo>
                  <a:lnTo>
                    <a:pt x="1179" y="972"/>
                  </a:lnTo>
                  <a:lnTo>
                    <a:pt x="1180" y="974"/>
                  </a:lnTo>
                  <a:lnTo>
                    <a:pt x="1180" y="977"/>
                  </a:lnTo>
                  <a:lnTo>
                    <a:pt x="1181" y="979"/>
                  </a:lnTo>
                  <a:lnTo>
                    <a:pt x="1181" y="981"/>
                  </a:lnTo>
                  <a:lnTo>
                    <a:pt x="1182" y="984"/>
                  </a:lnTo>
                  <a:lnTo>
                    <a:pt x="1182" y="986"/>
                  </a:lnTo>
                  <a:lnTo>
                    <a:pt x="1183" y="989"/>
                  </a:lnTo>
                  <a:lnTo>
                    <a:pt x="1183" y="992"/>
                  </a:lnTo>
                  <a:lnTo>
                    <a:pt x="1183" y="994"/>
                  </a:lnTo>
                  <a:lnTo>
                    <a:pt x="1184" y="997"/>
                  </a:lnTo>
                  <a:lnTo>
                    <a:pt x="1184" y="1000"/>
                  </a:lnTo>
                  <a:lnTo>
                    <a:pt x="1185" y="1003"/>
                  </a:lnTo>
                  <a:lnTo>
                    <a:pt x="1185" y="1005"/>
                  </a:lnTo>
                  <a:lnTo>
                    <a:pt x="1186" y="1008"/>
                  </a:lnTo>
                  <a:lnTo>
                    <a:pt x="1186" y="1010"/>
                  </a:lnTo>
                  <a:lnTo>
                    <a:pt x="1187" y="1013"/>
                  </a:lnTo>
                  <a:lnTo>
                    <a:pt x="1187" y="1016"/>
                  </a:lnTo>
                  <a:lnTo>
                    <a:pt x="1188" y="1018"/>
                  </a:lnTo>
                  <a:lnTo>
                    <a:pt x="1188" y="1021"/>
                  </a:lnTo>
                  <a:lnTo>
                    <a:pt x="1189" y="1023"/>
                  </a:lnTo>
                  <a:lnTo>
                    <a:pt x="1189" y="1025"/>
                  </a:lnTo>
                  <a:lnTo>
                    <a:pt x="1190" y="1028"/>
                  </a:lnTo>
                  <a:lnTo>
                    <a:pt x="1190" y="1030"/>
                  </a:lnTo>
                  <a:lnTo>
                    <a:pt x="1191" y="1032"/>
                  </a:lnTo>
                  <a:lnTo>
                    <a:pt x="1191" y="1034"/>
                  </a:lnTo>
                  <a:lnTo>
                    <a:pt x="1192" y="1036"/>
                  </a:lnTo>
                  <a:lnTo>
                    <a:pt x="1192" y="1038"/>
                  </a:lnTo>
                  <a:lnTo>
                    <a:pt x="1192" y="1040"/>
                  </a:lnTo>
                  <a:lnTo>
                    <a:pt x="1193" y="1042"/>
                  </a:lnTo>
                  <a:lnTo>
                    <a:pt x="1193" y="1043"/>
                  </a:lnTo>
                  <a:lnTo>
                    <a:pt x="1194" y="1045"/>
                  </a:lnTo>
                  <a:lnTo>
                    <a:pt x="1194" y="1046"/>
                  </a:lnTo>
                  <a:lnTo>
                    <a:pt x="1195" y="1048"/>
                  </a:lnTo>
                  <a:lnTo>
                    <a:pt x="1195" y="1049"/>
                  </a:lnTo>
                  <a:lnTo>
                    <a:pt x="1196" y="1050"/>
                  </a:lnTo>
                  <a:lnTo>
                    <a:pt x="1196" y="1051"/>
                  </a:lnTo>
                  <a:lnTo>
                    <a:pt x="1197" y="1052"/>
                  </a:lnTo>
                  <a:lnTo>
                    <a:pt x="1197" y="1053"/>
                  </a:lnTo>
                  <a:lnTo>
                    <a:pt x="1198" y="1054"/>
                  </a:lnTo>
                  <a:lnTo>
                    <a:pt x="1198" y="1055"/>
                  </a:lnTo>
                  <a:lnTo>
                    <a:pt x="1199" y="1055"/>
                  </a:lnTo>
                  <a:lnTo>
                    <a:pt x="1199" y="1056"/>
                  </a:lnTo>
                  <a:lnTo>
                    <a:pt x="1200" y="1057"/>
                  </a:lnTo>
                  <a:lnTo>
                    <a:pt x="1200" y="1058"/>
                  </a:lnTo>
                  <a:lnTo>
                    <a:pt x="1201" y="1059"/>
                  </a:lnTo>
                  <a:lnTo>
                    <a:pt x="1202" y="1060"/>
                  </a:lnTo>
                  <a:lnTo>
                    <a:pt x="1203" y="1061"/>
                  </a:lnTo>
                  <a:lnTo>
                    <a:pt x="1204" y="1062"/>
                  </a:lnTo>
                  <a:lnTo>
                    <a:pt x="1205" y="1063"/>
                  </a:lnTo>
                  <a:lnTo>
                    <a:pt x="1205" y="1064"/>
                  </a:lnTo>
                  <a:lnTo>
                    <a:pt x="1206" y="1064"/>
                  </a:lnTo>
                  <a:lnTo>
                    <a:pt x="1206" y="1065"/>
                  </a:lnTo>
                  <a:lnTo>
                    <a:pt x="1207" y="1065"/>
                  </a:lnTo>
                  <a:lnTo>
                    <a:pt x="1207" y="1066"/>
                  </a:lnTo>
                  <a:lnTo>
                    <a:pt x="1208" y="1067"/>
                  </a:lnTo>
                  <a:lnTo>
                    <a:pt x="1209" y="1068"/>
                  </a:lnTo>
                  <a:lnTo>
                    <a:pt x="1209" y="1069"/>
                  </a:lnTo>
                  <a:lnTo>
                    <a:pt x="1210" y="1069"/>
                  </a:lnTo>
                  <a:lnTo>
                    <a:pt x="1210" y="1070"/>
                  </a:lnTo>
                  <a:lnTo>
                    <a:pt x="1211" y="1070"/>
                  </a:lnTo>
                  <a:lnTo>
                    <a:pt x="1211" y="1071"/>
                  </a:lnTo>
                  <a:lnTo>
                    <a:pt x="1212" y="1071"/>
                  </a:lnTo>
                  <a:lnTo>
                    <a:pt x="1212" y="1072"/>
                  </a:lnTo>
                  <a:lnTo>
                    <a:pt x="1213" y="1072"/>
                  </a:lnTo>
                  <a:lnTo>
                    <a:pt x="1214" y="1073"/>
                  </a:lnTo>
                  <a:lnTo>
                    <a:pt x="1215" y="1073"/>
                  </a:lnTo>
                  <a:lnTo>
                    <a:pt x="1216" y="1074"/>
                  </a:lnTo>
                  <a:lnTo>
                    <a:pt x="1217" y="1074"/>
                  </a:lnTo>
                  <a:lnTo>
                    <a:pt x="1217" y="1073"/>
                  </a:lnTo>
                  <a:lnTo>
                    <a:pt x="1218" y="1073"/>
                  </a:lnTo>
                  <a:lnTo>
                    <a:pt x="1218" y="1072"/>
                  </a:lnTo>
                  <a:lnTo>
                    <a:pt x="1219" y="1072"/>
                  </a:lnTo>
                  <a:lnTo>
                    <a:pt x="1219" y="1071"/>
                  </a:lnTo>
                  <a:lnTo>
                    <a:pt x="1220" y="1071"/>
                  </a:lnTo>
                  <a:lnTo>
                    <a:pt x="1220" y="1070"/>
                  </a:lnTo>
                  <a:lnTo>
                    <a:pt x="1221" y="1070"/>
                  </a:lnTo>
                  <a:lnTo>
                    <a:pt x="1221" y="1069"/>
                  </a:lnTo>
                  <a:lnTo>
                    <a:pt x="1222" y="1069"/>
                  </a:lnTo>
                  <a:lnTo>
                    <a:pt x="1222" y="1068"/>
                  </a:lnTo>
                  <a:lnTo>
                    <a:pt x="1223" y="1067"/>
                  </a:lnTo>
                  <a:lnTo>
                    <a:pt x="1224" y="1066"/>
                  </a:lnTo>
                  <a:lnTo>
                    <a:pt x="1224" y="1065"/>
                  </a:lnTo>
                  <a:lnTo>
                    <a:pt x="1225" y="1065"/>
                  </a:lnTo>
                  <a:lnTo>
                    <a:pt x="1225" y="1064"/>
                  </a:lnTo>
                  <a:lnTo>
                    <a:pt x="1226" y="1063"/>
                  </a:lnTo>
                  <a:lnTo>
                    <a:pt x="1226" y="1062"/>
                  </a:lnTo>
                  <a:lnTo>
                    <a:pt x="1227" y="1062"/>
                  </a:lnTo>
                  <a:lnTo>
                    <a:pt x="1227" y="1061"/>
                  </a:lnTo>
                  <a:lnTo>
                    <a:pt x="1228" y="1060"/>
                  </a:lnTo>
                  <a:lnTo>
                    <a:pt x="1229" y="1059"/>
                  </a:lnTo>
                  <a:lnTo>
                    <a:pt x="1230" y="1058"/>
                  </a:lnTo>
                  <a:lnTo>
                    <a:pt x="1231" y="1057"/>
                  </a:lnTo>
                  <a:lnTo>
                    <a:pt x="1232" y="1057"/>
                  </a:lnTo>
                  <a:lnTo>
                    <a:pt x="1233" y="1056"/>
                  </a:lnTo>
                  <a:lnTo>
                    <a:pt x="1234" y="1056"/>
                  </a:lnTo>
                  <a:lnTo>
                    <a:pt x="1235" y="1056"/>
                  </a:lnTo>
                  <a:lnTo>
                    <a:pt x="1236" y="1056"/>
                  </a:lnTo>
                  <a:lnTo>
                    <a:pt x="1237" y="1057"/>
                  </a:lnTo>
                  <a:lnTo>
                    <a:pt x="1238" y="1057"/>
                  </a:lnTo>
                  <a:lnTo>
                    <a:pt x="1238" y="1058"/>
                  </a:lnTo>
                  <a:lnTo>
                    <a:pt x="1239" y="1058"/>
                  </a:lnTo>
                  <a:lnTo>
                    <a:pt x="1239" y="1059"/>
                  </a:lnTo>
                  <a:lnTo>
                    <a:pt x="1240" y="1059"/>
                  </a:lnTo>
                  <a:lnTo>
                    <a:pt x="1240" y="1060"/>
                  </a:lnTo>
                  <a:lnTo>
                    <a:pt x="1241" y="1061"/>
                  </a:lnTo>
                  <a:lnTo>
                    <a:pt x="1241" y="1062"/>
                  </a:lnTo>
                  <a:lnTo>
                    <a:pt x="1242" y="1063"/>
                  </a:lnTo>
                  <a:lnTo>
                    <a:pt x="1242" y="1064"/>
                  </a:lnTo>
                  <a:lnTo>
                    <a:pt x="1243" y="1065"/>
                  </a:lnTo>
                  <a:lnTo>
                    <a:pt x="1243" y="1066"/>
                  </a:lnTo>
                  <a:lnTo>
                    <a:pt x="1243" y="1067"/>
                  </a:lnTo>
                  <a:lnTo>
                    <a:pt x="1244" y="1068"/>
                  </a:lnTo>
                  <a:lnTo>
                    <a:pt x="1244" y="1069"/>
                  </a:lnTo>
                  <a:lnTo>
                    <a:pt x="1245" y="1070"/>
                  </a:lnTo>
                  <a:lnTo>
                    <a:pt x="1245" y="1071"/>
                  </a:lnTo>
                  <a:lnTo>
                    <a:pt x="1246" y="1072"/>
                  </a:lnTo>
                  <a:lnTo>
                    <a:pt x="1246" y="1073"/>
                  </a:lnTo>
                  <a:lnTo>
                    <a:pt x="1247" y="1073"/>
                  </a:lnTo>
                  <a:lnTo>
                    <a:pt x="1247" y="1074"/>
                  </a:lnTo>
                  <a:lnTo>
                    <a:pt x="1248" y="1075"/>
                  </a:lnTo>
                  <a:lnTo>
                    <a:pt x="1249" y="1076"/>
                  </a:lnTo>
                  <a:lnTo>
                    <a:pt x="1250" y="1076"/>
                  </a:lnTo>
                  <a:lnTo>
                    <a:pt x="1251" y="1076"/>
                  </a:lnTo>
                  <a:lnTo>
                    <a:pt x="1252" y="1076"/>
                  </a:lnTo>
                  <a:lnTo>
                    <a:pt x="1252" y="1075"/>
                  </a:lnTo>
                  <a:lnTo>
                    <a:pt x="1252" y="1074"/>
                  </a:lnTo>
                  <a:lnTo>
                    <a:pt x="1253" y="1073"/>
                  </a:lnTo>
                  <a:lnTo>
                    <a:pt x="1253" y="1072"/>
                  </a:lnTo>
                  <a:lnTo>
                    <a:pt x="1254" y="1070"/>
                  </a:lnTo>
                  <a:lnTo>
                    <a:pt x="1254" y="1069"/>
                  </a:lnTo>
                  <a:lnTo>
                    <a:pt x="1255" y="1067"/>
                  </a:lnTo>
                  <a:lnTo>
                    <a:pt x="1255" y="1065"/>
                  </a:lnTo>
                  <a:lnTo>
                    <a:pt x="1256" y="1064"/>
                  </a:lnTo>
                  <a:lnTo>
                    <a:pt x="1256" y="1062"/>
                  </a:lnTo>
                  <a:lnTo>
                    <a:pt x="1257" y="1059"/>
                  </a:lnTo>
                  <a:lnTo>
                    <a:pt x="1257" y="1057"/>
                  </a:lnTo>
                  <a:lnTo>
                    <a:pt x="1258" y="1055"/>
                  </a:lnTo>
                  <a:lnTo>
                    <a:pt x="1258" y="1053"/>
                  </a:lnTo>
                  <a:lnTo>
                    <a:pt x="1259" y="1050"/>
                  </a:lnTo>
                  <a:lnTo>
                    <a:pt x="1259" y="1048"/>
                  </a:lnTo>
                  <a:lnTo>
                    <a:pt x="1260" y="1046"/>
                  </a:lnTo>
                  <a:lnTo>
                    <a:pt x="1260" y="1043"/>
                  </a:lnTo>
                  <a:lnTo>
                    <a:pt x="1260" y="1041"/>
                  </a:lnTo>
                  <a:lnTo>
                    <a:pt x="1261" y="1039"/>
                  </a:lnTo>
                  <a:lnTo>
                    <a:pt x="1261" y="1036"/>
                  </a:lnTo>
                  <a:lnTo>
                    <a:pt x="1262" y="1034"/>
                  </a:lnTo>
                  <a:lnTo>
                    <a:pt x="1262" y="1032"/>
                  </a:lnTo>
                  <a:lnTo>
                    <a:pt x="1263" y="1029"/>
                  </a:lnTo>
                  <a:lnTo>
                    <a:pt x="1263" y="1027"/>
                  </a:lnTo>
                  <a:lnTo>
                    <a:pt x="1264" y="1025"/>
                  </a:lnTo>
                  <a:lnTo>
                    <a:pt x="1264" y="1023"/>
                  </a:lnTo>
                  <a:lnTo>
                    <a:pt x="1265" y="1022"/>
                  </a:lnTo>
                  <a:lnTo>
                    <a:pt x="1265" y="1020"/>
                  </a:lnTo>
                  <a:lnTo>
                    <a:pt x="1266" y="1018"/>
                  </a:lnTo>
                  <a:lnTo>
                    <a:pt x="1266" y="1017"/>
                  </a:lnTo>
                  <a:lnTo>
                    <a:pt x="1267" y="1015"/>
                  </a:lnTo>
                  <a:lnTo>
                    <a:pt x="1267" y="1014"/>
                  </a:lnTo>
                  <a:lnTo>
                    <a:pt x="1268" y="1013"/>
                  </a:lnTo>
                  <a:lnTo>
                    <a:pt x="1268" y="1012"/>
                  </a:lnTo>
                  <a:lnTo>
                    <a:pt x="1269" y="1011"/>
                  </a:lnTo>
                  <a:lnTo>
                    <a:pt x="1269" y="1010"/>
                  </a:lnTo>
                  <a:lnTo>
                    <a:pt x="1269" y="1009"/>
                  </a:lnTo>
                  <a:lnTo>
                    <a:pt x="1270" y="1008"/>
                  </a:lnTo>
                  <a:lnTo>
                    <a:pt x="1271" y="1007"/>
                  </a:lnTo>
                  <a:lnTo>
                    <a:pt x="1272" y="1007"/>
                  </a:lnTo>
                  <a:lnTo>
                    <a:pt x="1272" y="1006"/>
                  </a:lnTo>
                  <a:lnTo>
                    <a:pt x="1273" y="1006"/>
                  </a:lnTo>
                  <a:lnTo>
                    <a:pt x="1274" y="1007"/>
                  </a:lnTo>
                  <a:lnTo>
                    <a:pt x="1275" y="1007"/>
                  </a:lnTo>
                  <a:lnTo>
                    <a:pt x="1275" y="1008"/>
                  </a:lnTo>
                  <a:lnTo>
                    <a:pt x="1276" y="1008"/>
                  </a:lnTo>
                  <a:lnTo>
                    <a:pt x="1276" y="1009"/>
                  </a:lnTo>
                  <a:lnTo>
                    <a:pt x="1277" y="1011"/>
                  </a:lnTo>
                  <a:lnTo>
                    <a:pt x="1277" y="1012"/>
                  </a:lnTo>
                  <a:lnTo>
                    <a:pt x="1277" y="1013"/>
                  </a:lnTo>
                  <a:lnTo>
                    <a:pt x="1278" y="1014"/>
                  </a:lnTo>
                  <a:lnTo>
                    <a:pt x="1278" y="1016"/>
                  </a:lnTo>
                  <a:lnTo>
                    <a:pt x="1279" y="1017"/>
                  </a:lnTo>
                  <a:lnTo>
                    <a:pt x="1279" y="1019"/>
                  </a:lnTo>
                  <a:lnTo>
                    <a:pt x="1280" y="1020"/>
                  </a:lnTo>
                  <a:lnTo>
                    <a:pt x="1280" y="1022"/>
                  </a:lnTo>
                  <a:lnTo>
                    <a:pt x="1281" y="1024"/>
                  </a:lnTo>
                  <a:lnTo>
                    <a:pt x="1281" y="1025"/>
                  </a:lnTo>
                  <a:lnTo>
                    <a:pt x="1282" y="1027"/>
                  </a:lnTo>
                  <a:lnTo>
                    <a:pt x="1282" y="1029"/>
                  </a:lnTo>
                  <a:lnTo>
                    <a:pt x="1283" y="1030"/>
                  </a:lnTo>
                  <a:lnTo>
                    <a:pt x="1283" y="1032"/>
                  </a:lnTo>
                  <a:lnTo>
                    <a:pt x="1284" y="1033"/>
                  </a:lnTo>
                  <a:lnTo>
                    <a:pt x="1284" y="1035"/>
                  </a:lnTo>
                  <a:lnTo>
                    <a:pt x="1285" y="1036"/>
                  </a:lnTo>
                  <a:lnTo>
                    <a:pt x="1285" y="1038"/>
                  </a:lnTo>
                  <a:lnTo>
                    <a:pt x="1286" y="1039"/>
                  </a:lnTo>
                  <a:lnTo>
                    <a:pt x="1286" y="1040"/>
                  </a:lnTo>
                  <a:lnTo>
                    <a:pt x="1286" y="1041"/>
                  </a:lnTo>
                  <a:lnTo>
                    <a:pt x="1287" y="1042"/>
                  </a:lnTo>
                  <a:lnTo>
                    <a:pt x="1287" y="1043"/>
                  </a:lnTo>
                  <a:lnTo>
                    <a:pt x="1288" y="1044"/>
                  </a:lnTo>
                  <a:lnTo>
                    <a:pt x="1289" y="1045"/>
                  </a:lnTo>
                  <a:lnTo>
                    <a:pt x="1290" y="1045"/>
                  </a:lnTo>
                  <a:lnTo>
                    <a:pt x="1290" y="1046"/>
                  </a:lnTo>
                  <a:lnTo>
                    <a:pt x="1291" y="1046"/>
                  </a:lnTo>
                  <a:lnTo>
                    <a:pt x="1292" y="1046"/>
                  </a:lnTo>
                  <a:lnTo>
                    <a:pt x="1293" y="1045"/>
                  </a:lnTo>
                  <a:lnTo>
                    <a:pt x="1294" y="1045"/>
                  </a:lnTo>
                  <a:lnTo>
                    <a:pt x="1295" y="1045"/>
                  </a:lnTo>
                  <a:lnTo>
                    <a:pt x="1296" y="1045"/>
                  </a:lnTo>
                  <a:lnTo>
                    <a:pt x="1297" y="1046"/>
                  </a:lnTo>
                  <a:lnTo>
                    <a:pt x="1298" y="1046"/>
                  </a:lnTo>
                  <a:lnTo>
                    <a:pt x="1298" y="1047"/>
                  </a:lnTo>
                  <a:lnTo>
                    <a:pt x="1299" y="1047"/>
                  </a:lnTo>
                  <a:lnTo>
                    <a:pt x="1299" y="1048"/>
                  </a:lnTo>
                  <a:lnTo>
                    <a:pt x="1300" y="1049"/>
                  </a:lnTo>
                  <a:lnTo>
                    <a:pt x="1300" y="1050"/>
                  </a:lnTo>
                  <a:lnTo>
                    <a:pt x="1301" y="1052"/>
                  </a:lnTo>
                  <a:lnTo>
                    <a:pt x="1301" y="1053"/>
                  </a:lnTo>
                  <a:lnTo>
                    <a:pt x="1302" y="1055"/>
                  </a:lnTo>
                  <a:lnTo>
                    <a:pt x="1302" y="1057"/>
                  </a:lnTo>
                  <a:lnTo>
                    <a:pt x="1303" y="1058"/>
                  </a:lnTo>
                  <a:lnTo>
                    <a:pt x="1303" y="1060"/>
                  </a:lnTo>
                  <a:lnTo>
                    <a:pt x="1303" y="1062"/>
                  </a:lnTo>
                  <a:lnTo>
                    <a:pt x="1304" y="1064"/>
                  </a:lnTo>
                  <a:lnTo>
                    <a:pt x="1304" y="1066"/>
                  </a:lnTo>
                  <a:lnTo>
                    <a:pt x="1305" y="1068"/>
                  </a:lnTo>
                  <a:lnTo>
                    <a:pt x="1305" y="1070"/>
                  </a:lnTo>
                  <a:lnTo>
                    <a:pt x="1306" y="1072"/>
                  </a:lnTo>
                  <a:lnTo>
                    <a:pt x="1306" y="1074"/>
                  </a:lnTo>
                  <a:lnTo>
                    <a:pt x="1307" y="1076"/>
                  </a:lnTo>
                  <a:lnTo>
                    <a:pt x="1307" y="1078"/>
                  </a:lnTo>
                  <a:lnTo>
                    <a:pt x="1308" y="1079"/>
                  </a:lnTo>
                  <a:lnTo>
                    <a:pt x="1308" y="1081"/>
                  </a:lnTo>
                  <a:lnTo>
                    <a:pt x="1309" y="1083"/>
                  </a:lnTo>
                  <a:lnTo>
                    <a:pt x="1309" y="1085"/>
                  </a:lnTo>
                  <a:lnTo>
                    <a:pt x="1310" y="1086"/>
                  </a:lnTo>
                  <a:lnTo>
                    <a:pt x="1310" y="1088"/>
                  </a:lnTo>
                  <a:lnTo>
                    <a:pt x="1311" y="1089"/>
                  </a:lnTo>
                  <a:lnTo>
                    <a:pt x="1311" y="1090"/>
                  </a:lnTo>
                  <a:lnTo>
                    <a:pt x="1312" y="1091"/>
                  </a:lnTo>
                  <a:lnTo>
                    <a:pt x="1312" y="1092"/>
                  </a:lnTo>
                  <a:lnTo>
                    <a:pt x="1313" y="1092"/>
                  </a:lnTo>
                  <a:lnTo>
                    <a:pt x="1314" y="1093"/>
                  </a:lnTo>
                  <a:lnTo>
                    <a:pt x="1315" y="1093"/>
                  </a:lnTo>
                  <a:lnTo>
                    <a:pt x="1316" y="1093"/>
                  </a:lnTo>
                  <a:lnTo>
                    <a:pt x="1317" y="1092"/>
                  </a:lnTo>
                  <a:lnTo>
                    <a:pt x="1318" y="1092"/>
                  </a:lnTo>
                  <a:lnTo>
                    <a:pt x="1319" y="1092"/>
                  </a:lnTo>
                  <a:lnTo>
                    <a:pt x="1320" y="1092"/>
                  </a:lnTo>
                  <a:lnTo>
                    <a:pt x="1321" y="1092"/>
                  </a:lnTo>
                  <a:lnTo>
                    <a:pt x="1322" y="1092"/>
                  </a:lnTo>
                  <a:lnTo>
                    <a:pt x="1322" y="1093"/>
                  </a:lnTo>
                  <a:lnTo>
                    <a:pt x="1323" y="1093"/>
                  </a:lnTo>
                  <a:lnTo>
                    <a:pt x="1323" y="1094"/>
                  </a:lnTo>
                  <a:lnTo>
                    <a:pt x="1324" y="1095"/>
                  </a:lnTo>
                  <a:lnTo>
                    <a:pt x="1324" y="1097"/>
                  </a:lnTo>
                  <a:lnTo>
                    <a:pt x="1325" y="1098"/>
                  </a:lnTo>
                  <a:lnTo>
                    <a:pt x="1325" y="1099"/>
                  </a:lnTo>
                  <a:lnTo>
                    <a:pt x="1326" y="1100"/>
                  </a:lnTo>
                  <a:lnTo>
                    <a:pt x="1326" y="1102"/>
                  </a:lnTo>
                  <a:lnTo>
                    <a:pt x="1327" y="1103"/>
                  </a:lnTo>
                  <a:lnTo>
                    <a:pt x="1327" y="1105"/>
                  </a:lnTo>
                  <a:lnTo>
                    <a:pt x="1328" y="1106"/>
                  </a:lnTo>
                  <a:lnTo>
                    <a:pt x="1328" y="1107"/>
                  </a:lnTo>
                  <a:lnTo>
                    <a:pt x="1329" y="1109"/>
                  </a:lnTo>
                  <a:lnTo>
                    <a:pt x="1329" y="1110"/>
                  </a:lnTo>
                  <a:lnTo>
                    <a:pt x="1329" y="1111"/>
                  </a:lnTo>
                  <a:lnTo>
                    <a:pt x="1330" y="1112"/>
                  </a:lnTo>
                  <a:lnTo>
                    <a:pt x="1330" y="1113"/>
                  </a:lnTo>
                  <a:lnTo>
                    <a:pt x="1331" y="1114"/>
                  </a:lnTo>
                  <a:lnTo>
                    <a:pt x="1331" y="1115"/>
                  </a:lnTo>
                  <a:lnTo>
                    <a:pt x="1332" y="1116"/>
                  </a:lnTo>
                  <a:lnTo>
                    <a:pt x="1333" y="1117"/>
                  </a:lnTo>
                  <a:lnTo>
                    <a:pt x="1334" y="1117"/>
                  </a:lnTo>
                  <a:lnTo>
                    <a:pt x="1334" y="1116"/>
                  </a:lnTo>
                  <a:lnTo>
                    <a:pt x="1335" y="1116"/>
                  </a:lnTo>
                  <a:lnTo>
                    <a:pt x="1335" y="1115"/>
                  </a:lnTo>
                  <a:lnTo>
                    <a:pt x="1336" y="1113"/>
                  </a:lnTo>
                  <a:lnTo>
                    <a:pt x="1336" y="1112"/>
                  </a:lnTo>
                  <a:lnTo>
                    <a:pt x="1337" y="1110"/>
                  </a:lnTo>
                  <a:lnTo>
                    <a:pt x="1337" y="1108"/>
                  </a:lnTo>
                  <a:lnTo>
                    <a:pt x="1337" y="1105"/>
                  </a:lnTo>
                  <a:lnTo>
                    <a:pt x="1338" y="1103"/>
                  </a:lnTo>
                  <a:lnTo>
                    <a:pt x="1338" y="1101"/>
                  </a:lnTo>
                  <a:lnTo>
                    <a:pt x="1339" y="1098"/>
                  </a:lnTo>
                  <a:lnTo>
                    <a:pt x="1339" y="1096"/>
                  </a:lnTo>
                  <a:lnTo>
                    <a:pt x="1340" y="1093"/>
                  </a:lnTo>
                  <a:lnTo>
                    <a:pt x="1340" y="1091"/>
                  </a:lnTo>
                  <a:lnTo>
                    <a:pt x="1341" y="1088"/>
                  </a:lnTo>
                  <a:lnTo>
                    <a:pt x="1341" y="1086"/>
                  </a:lnTo>
                  <a:lnTo>
                    <a:pt x="1342" y="1083"/>
                  </a:lnTo>
                  <a:lnTo>
                    <a:pt x="1342" y="1081"/>
                  </a:lnTo>
                  <a:lnTo>
                    <a:pt x="1343" y="1079"/>
                  </a:lnTo>
                  <a:lnTo>
                    <a:pt x="1343" y="1077"/>
                  </a:lnTo>
                  <a:lnTo>
                    <a:pt x="1344" y="1074"/>
                  </a:lnTo>
                  <a:lnTo>
                    <a:pt x="1344" y="1073"/>
                  </a:lnTo>
                  <a:lnTo>
                    <a:pt x="1345" y="1071"/>
                  </a:lnTo>
                  <a:lnTo>
                    <a:pt x="1345" y="1069"/>
                  </a:lnTo>
                  <a:lnTo>
                    <a:pt x="1346" y="1068"/>
                  </a:lnTo>
                  <a:lnTo>
                    <a:pt x="1346" y="1067"/>
                  </a:lnTo>
                  <a:lnTo>
                    <a:pt x="1346" y="1066"/>
                  </a:lnTo>
                  <a:lnTo>
                    <a:pt x="1347" y="1066"/>
                  </a:lnTo>
                  <a:lnTo>
                    <a:pt x="1348" y="1067"/>
                  </a:lnTo>
                  <a:lnTo>
                    <a:pt x="1349" y="1068"/>
                  </a:lnTo>
                  <a:lnTo>
                    <a:pt x="1349" y="1069"/>
                  </a:lnTo>
                  <a:lnTo>
                    <a:pt x="1350" y="1071"/>
                  </a:lnTo>
                  <a:lnTo>
                    <a:pt x="1350" y="1072"/>
                  </a:lnTo>
                  <a:lnTo>
                    <a:pt x="1351" y="1073"/>
                  </a:lnTo>
                  <a:lnTo>
                    <a:pt x="1351" y="1075"/>
                  </a:lnTo>
                  <a:lnTo>
                    <a:pt x="1352" y="1077"/>
                  </a:lnTo>
                  <a:lnTo>
                    <a:pt x="1352" y="1078"/>
                  </a:lnTo>
                  <a:lnTo>
                    <a:pt x="1353" y="1080"/>
                  </a:lnTo>
                  <a:lnTo>
                    <a:pt x="1353" y="1082"/>
                  </a:lnTo>
                  <a:lnTo>
                    <a:pt x="1354" y="1083"/>
                  </a:lnTo>
                  <a:lnTo>
                    <a:pt x="1354" y="1085"/>
                  </a:lnTo>
                  <a:lnTo>
                    <a:pt x="1354" y="1087"/>
                  </a:lnTo>
                  <a:lnTo>
                    <a:pt x="1355" y="1088"/>
                  </a:lnTo>
                  <a:lnTo>
                    <a:pt x="1355" y="1090"/>
                  </a:lnTo>
                  <a:lnTo>
                    <a:pt x="1356" y="1091"/>
                  </a:lnTo>
                  <a:lnTo>
                    <a:pt x="1356" y="1093"/>
                  </a:lnTo>
                  <a:lnTo>
                    <a:pt x="1357" y="1094"/>
                  </a:lnTo>
                  <a:lnTo>
                    <a:pt x="1357" y="1095"/>
                  </a:lnTo>
                  <a:lnTo>
                    <a:pt x="1358" y="1096"/>
                  </a:lnTo>
                  <a:lnTo>
                    <a:pt x="1359" y="1096"/>
                  </a:lnTo>
                  <a:lnTo>
                    <a:pt x="1360" y="1096"/>
                  </a:lnTo>
                  <a:lnTo>
                    <a:pt x="1360" y="1095"/>
                  </a:lnTo>
                  <a:lnTo>
                    <a:pt x="1361" y="1094"/>
                  </a:lnTo>
                  <a:lnTo>
                    <a:pt x="1361" y="1093"/>
                  </a:lnTo>
                  <a:lnTo>
                    <a:pt x="1362" y="1092"/>
                  </a:lnTo>
                  <a:lnTo>
                    <a:pt x="1362" y="1091"/>
                  </a:lnTo>
                  <a:lnTo>
                    <a:pt x="1363" y="1090"/>
                  </a:lnTo>
                  <a:lnTo>
                    <a:pt x="1363" y="1089"/>
                  </a:lnTo>
                  <a:lnTo>
                    <a:pt x="1363" y="1087"/>
                  </a:lnTo>
                  <a:lnTo>
                    <a:pt x="1364" y="1086"/>
                  </a:lnTo>
                  <a:lnTo>
                    <a:pt x="1364" y="1084"/>
                  </a:lnTo>
                  <a:lnTo>
                    <a:pt x="1365" y="1083"/>
                  </a:lnTo>
                  <a:lnTo>
                    <a:pt x="1365" y="1081"/>
                  </a:lnTo>
                  <a:lnTo>
                    <a:pt x="1366" y="1080"/>
                  </a:lnTo>
                  <a:lnTo>
                    <a:pt x="1366" y="1078"/>
                  </a:lnTo>
                  <a:lnTo>
                    <a:pt x="1367" y="1076"/>
                  </a:lnTo>
                  <a:lnTo>
                    <a:pt x="1367" y="1075"/>
                  </a:lnTo>
                  <a:lnTo>
                    <a:pt x="1368" y="1074"/>
                  </a:lnTo>
                  <a:lnTo>
                    <a:pt x="1368" y="1072"/>
                  </a:lnTo>
                  <a:lnTo>
                    <a:pt x="1369" y="1071"/>
                  </a:lnTo>
                  <a:lnTo>
                    <a:pt x="1369" y="1070"/>
                  </a:lnTo>
                  <a:lnTo>
                    <a:pt x="1370" y="1069"/>
                  </a:lnTo>
                  <a:lnTo>
                    <a:pt x="1370" y="1068"/>
                  </a:lnTo>
                  <a:lnTo>
                    <a:pt x="1371" y="1067"/>
                  </a:lnTo>
                  <a:lnTo>
                    <a:pt x="1372" y="1067"/>
                  </a:lnTo>
                  <a:lnTo>
                    <a:pt x="1373" y="1067"/>
                  </a:lnTo>
                  <a:lnTo>
                    <a:pt x="1374" y="1068"/>
                  </a:lnTo>
                  <a:lnTo>
                    <a:pt x="1375" y="1069"/>
                  </a:lnTo>
                  <a:lnTo>
                    <a:pt x="1376" y="1070"/>
                  </a:lnTo>
                  <a:lnTo>
                    <a:pt x="1376" y="1071"/>
                  </a:lnTo>
                  <a:lnTo>
                    <a:pt x="1377" y="1072"/>
                  </a:lnTo>
                  <a:lnTo>
                    <a:pt x="1377" y="1073"/>
                  </a:lnTo>
                  <a:lnTo>
                    <a:pt x="1378" y="1074"/>
                  </a:lnTo>
                  <a:lnTo>
                    <a:pt x="1378" y="1075"/>
                  </a:lnTo>
                  <a:lnTo>
                    <a:pt x="1379" y="1076"/>
                  </a:lnTo>
                  <a:lnTo>
                    <a:pt x="1379" y="1078"/>
                  </a:lnTo>
                  <a:lnTo>
                    <a:pt x="1380" y="1079"/>
                  </a:lnTo>
                  <a:lnTo>
                    <a:pt x="1380" y="1080"/>
                  </a:lnTo>
                  <a:lnTo>
                    <a:pt x="1380" y="1082"/>
                  </a:lnTo>
                  <a:lnTo>
                    <a:pt x="1381" y="1083"/>
                  </a:lnTo>
                  <a:lnTo>
                    <a:pt x="1381" y="1084"/>
                  </a:lnTo>
                  <a:lnTo>
                    <a:pt x="1382" y="1086"/>
                  </a:lnTo>
                  <a:lnTo>
                    <a:pt x="1382" y="1087"/>
                  </a:lnTo>
                  <a:lnTo>
                    <a:pt x="1383" y="1088"/>
                  </a:lnTo>
                  <a:lnTo>
                    <a:pt x="1383" y="1090"/>
                  </a:lnTo>
                  <a:lnTo>
                    <a:pt x="1384" y="1091"/>
                  </a:lnTo>
                  <a:lnTo>
                    <a:pt x="1384" y="1092"/>
                  </a:lnTo>
                  <a:lnTo>
                    <a:pt x="1385" y="1094"/>
                  </a:lnTo>
                  <a:lnTo>
                    <a:pt x="1385" y="1095"/>
                  </a:lnTo>
                  <a:lnTo>
                    <a:pt x="1386" y="1097"/>
                  </a:lnTo>
                  <a:lnTo>
                    <a:pt x="1386" y="1098"/>
                  </a:lnTo>
                  <a:lnTo>
                    <a:pt x="1387" y="1099"/>
                  </a:lnTo>
                  <a:lnTo>
                    <a:pt x="1387" y="1101"/>
                  </a:lnTo>
                  <a:lnTo>
                    <a:pt x="1388" y="1102"/>
                  </a:lnTo>
                  <a:lnTo>
                    <a:pt x="1388" y="1104"/>
                  </a:lnTo>
                  <a:lnTo>
                    <a:pt x="1389" y="1105"/>
                  </a:lnTo>
                  <a:lnTo>
                    <a:pt x="1389" y="1107"/>
                  </a:lnTo>
                  <a:lnTo>
                    <a:pt x="1389" y="1108"/>
                  </a:lnTo>
                  <a:lnTo>
                    <a:pt x="1390" y="1109"/>
                  </a:lnTo>
                  <a:lnTo>
                    <a:pt x="1390" y="1111"/>
                  </a:lnTo>
                  <a:lnTo>
                    <a:pt x="1391" y="1112"/>
                  </a:lnTo>
                  <a:lnTo>
                    <a:pt x="1391" y="1114"/>
                  </a:lnTo>
                  <a:lnTo>
                    <a:pt x="1392" y="1115"/>
                  </a:lnTo>
                  <a:lnTo>
                    <a:pt x="1392" y="1116"/>
                  </a:lnTo>
                  <a:lnTo>
                    <a:pt x="1393" y="1118"/>
                  </a:lnTo>
                  <a:lnTo>
                    <a:pt x="1393" y="1119"/>
                  </a:lnTo>
                  <a:lnTo>
                    <a:pt x="1394" y="1121"/>
                  </a:lnTo>
                  <a:lnTo>
                    <a:pt x="1394" y="1122"/>
                  </a:lnTo>
                  <a:lnTo>
                    <a:pt x="1395" y="1123"/>
                  </a:lnTo>
                  <a:lnTo>
                    <a:pt x="1395" y="1125"/>
                  </a:lnTo>
                  <a:lnTo>
                    <a:pt x="1396" y="1126"/>
                  </a:lnTo>
                  <a:lnTo>
                    <a:pt x="1396" y="1127"/>
                  </a:lnTo>
                  <a:lnTo>
                    <a:pt x="1397" y="1129"/>
                  </a:lnTo>
                  <a:lnTo>
                    <a:pt x="1397" y="1130"/>
                  </a:lnTo>
                  <a:lnTo>
                    <a:pt x="1397" y="1131"/>
                  </a:lnTo>
                  <a:lnTo>
                    <a:pt x="1398" y="1132"/>
                  </a:lnTo>
                  <a:lnTo>
                    <a:pt x="1398" y="1133"/>
                  </a:lnTo>
                  <a:lnTo>
                    <a:pt x="1399" y="1135"/>
                  </a:lnTo>
                  <a:lnTo>
                    <a:pt x="1399" y="1136"/>
                  </a:lnTo>
                  <a:lnTo>
                    <a:pt x="1400" y="1137"/>
                  </a:lnTo>
                  <a:lnTo>
                    <a:pt x="1400" y="1138"/>
                  </a:lnTo>
                  <a:lnTo>
                    <a:pt x="1401" y="1139"/>
                  </a:lnTo>
                  <a:lnTo>
                    <a:pt x="1401" y="1140"/>
                  </a:lnTo>
                  <a:lnTo>
                    <a:pt x="1402" y="1141"/>
                  </a:lnTo>
                  <a:lnTo>
                    <a:pt x="1402" y="1142"/>
                  </a:lnTo>
                  <a:lnTo>
                    <a:pt x="1403" y="1143"/>
                  </a:lnTo>
                  <a:lnTo>
                    <a:pt x="1403" y="1144"/>
                  </a:lnTo>
                  <a:lnTo>
                    <a:pt x="1404" y="1145"/>
                  </a:lnTo>
                  <a:lnTo>
                    <a:pt x="1404" y="1146"/>
                  </a:lnTo>
                  <a:lnTo>
                    <a:pt x="1405" y="1146"/>
                  </a:lnTo>
                  <a:lnTo>
                    <a:pt x="1405" y="1147"/>
                  </a:lnTo>
                  <a:lnTo>
                    <a:pt x="1406" y="1148"/>
                  </a:lnTo>
                  <a:lnTo>
                    <a:pt x="1406" y="1149"/>
                  </a:lnTo>
                  <a:lnTo>
                    <a:pt x="1407" y="1149"/>
                  </a:lnTo>
                  <a:lnTo>
                    <a:pt x="1407" y="1150"/>
                  </a:lnTo>
                  <a:lnTo>
                    <a:pt x="1408" y="1150"/>
                  </a:lnTo>
                  <a:lnTo>
                    <a:pt x="1408" y="1151"/>
                  </a:lnTo>
                  <a:lnTo>
                    <a:pt x="1409" y="1151"/>
                  </a:lnTo>
                  <a:lnTo>
                    <a:pt x="1410" y="1151"/>
                  </a:lnTo>
                  <a:lnTo>
                    <a:pt x="1410" y="1152"/>
                  </a:lnTo>
                  <a:lnTo>
                    <a:pt x="1411" y="1152"/>
                  </a:lnTo>
                  <a:lnTo>
                    <a:pt x="1412" y="1152"/>
                  </a:lnTo>
                  <a:lnTo>
                    <a:pt x="1413" y="1152"/>
                  </a:lnTo>
                  <a:lnTo>
                    <a:pt x="1414" y="1152"/>
                  </a:lnTo>
                  <a:lnTo>
                    <a:pt x="1415" y="1152"/>
                  </a:lnTo>
                  <a:lnTo>
                    <a:pt x="1416" y="1152"/>
                  </a:lnTo>
                  <a:lnTo>
                    <a:pt x="1416" y="1151"/>
                  </a:lnTo>
                  <a:lnTo>
                    <a:pt x="1417" y="1151"/>
                  </a:lnTo>
                  <a:lnTo>
                    <a:pt x="1418" y="1150"/>
                  </a:lnTo>
                  <a:lnTo>
                    <a:pt x="1419" y="1150"/>
                  </a:lnTo>
                  <a:lnTo>
                    <a:pt x="1419" y="1149"/>
                  </a:lnTo>
                  <a:lnTo>
                    <a:pt x="1420" y="1149"/>
                  </a:lnTo>
                  <a:lnTo>
                    <a:pt x="1420" y="1148"/>
                  </a:lnTo>
                  <a:lnTo>
                    <a:pt x="1421" y="1148"/>
                  </a:lnTo>
                  <a:lnTo>
                    <a:pt x="1421" y="1147"/>
                  </a:lnTo>
                  <a:lnTo>
                    <a:pt x="1422" y="1146"/>
                  </a:lnTo>
                  <a:lnTo>
                    <a:pt x="1423" y="1145"/>
                  </a:lnTo>
                  <a:lnTo>
                    <a:pt x="1423" y="1144"/>
                  </a:lnTo>
                  <a:lnTo>
                    <a:pt x="1424" y="1143"/>
                  </a:lnTo>
                  <a:lnTo>
                    <a:pt x="1424" y="1142"/>
                  </a:lnTo>
                  <a:lnTo>
                    <a:pt x="1425" y="1141"/>
                  </a:lnTo>
                  <a:lnTo>
                    <a:pt x="1426" y="1140"/>
                  </a:lnTo>
                  <a:lnTo>
                    <a:pt x="1426" y="1139"/>
                  </a:lnTo>
                  <a:lnTo>
                    <a:pt x="1427" y="1138"/>
                  </a:lnTo>
                  <a:lnTo>
                    <a:pt x="1427" y="1137"/>
                  </a:lnTo>
                  <a:lnTo>
                    <a:pt x="1428" y="1136"/>
                  </a:lnTo>
                  <a:lnTo>
                    <a:pt x="1428" y="1135"/>
                  </a:lnTo>
                  <a:lnTo>
                    <a:pt x="1429" y="1134"/>
                  </a:lnTo>
                  <a:lnTo>
                    <a:pt x="1429" y="1133"/>
                  </a:lnTo>
                  <a:lnTo>
                    <a:pt x="1430" y="1131"/>
                  </a:lnTo>
                  <a:lnTo>
                    <a:pt x="1430" y="1130"/>
                  </a:lnTo>
                  <a:lnTo>
                    <a:pt x="1431" y="1129"/>
                  </a:lnTo>
                  <a:lnTo>
                    <a:pt x="1431" y="1127"/>
                  </a:lnTo>
                  <a:lnTo>
                    <a:pt x="1431" y="1126"/>
                  </a:lnTo>
                  <a:lnTo>
                    <a:pt x="1432" y="1125"/>
                  </a:lnTo>
                  <a:lnTo>
                    <a:pt x="1432" y="1123"/>
                  </a:lnTo>
                  <a:lnTo>
                    <a:pt x="1433" y="1122"/>
                  </a:lnTo>
                  <a:lnTo>
                    <a:pt x="1433" y="1120"/>
                  </a:lnTo>
                  <a:lnTo>
                    <a:pt x="1434" y="1119"/>
                  </a:lnTo>
                  <a:lnTo>
                    <a:pt x="1434" y="1117"/>
                  </a:lnTo>
                  <a:lnTo>
                    <a:pt x="1435" y="1116"/>
                  </a:lnTo>
                  <a:lnTo>
                    <a:pt x="1435" y="1114"/>
                  </a:lnTo>
                  <a:lnTo>
                    <a:pt x="1436" y="1113"/>
                  </a:lnTo>
                  <a:lnTo>
                    <a:pt x="1436" y="1111"/>
                  </a:lnTo>
                  <a:lnTo>
                    <a:pt x="1437" y="1110"/>
                  </a:lnTo>
                  <a:lnTo>
                    <a:pt x="1437" y="1109"/>
                  </a:lnTo>
                  <a:lnTo>
                    <a:pt x="1438" y="1107"/>
                  </a:lnTo>
                  <a:lnTo>
                    <a:pt x="1438" y="1106"/>
                  </a:lnTo>
                  <a:lnTo>
                    <a:pt x="1439" y="1104"/>
                  </a:lnTo>
                  <a:lnTo>
                    <a:pt x="1439" y="1103"/>
                  </a:lnTo>
                  <a:lnTo>
                    <a:pt x="1440" y="1102"/>
                  </a:lnTo>
                  <a:lnTo>
                    <a:pt x="1440" y="1100"/>
                  </a:lnTo>
                  <a:lnTo>
                    <a:pt x="1440" y="1099"/>
                  </a:lnTo>
                  <a:lnTo>
                    <a:pt x="1441" y="1098"/>
                  </a:lnTo>
                  <a:lnTo>
                    <a:pt x="1441" y="1097"/>
                  </a:lnTo>
                  <a:lnTo>
                    <a:pt x="1442" y="1096"/>
                  </a:lnTo>
                  <a:lnTo>
                    <a:pt x="1442" y="1095"/>
                  </a:lnTo>
                  <a:lnTo>
                    <a:pt x="1443" y="1094"/>
                  </a:lnTo>
                  <a:lnTo>
                    <a:pt x="1443" y="1093"/>
                  </a:lnTo>
                  <a:lnTo>
                    <a:pt x="1444" y="1092"/>
                  </a:lnTo>
                  <a:lnTo>
                    <a:pt x="1445" y="1091"/>
                  </a:lnTo>
                  <a:lnTo>
                    <a:pt x="1445" y="1090"/>
                  </a:lnTo>
                  <a:lnTo>
                    <a:pt x="1446" y="1089"/>
                  </a:lnTo>
                  <a:lnTo>
                    <a:pt x="1446" y="1088"/>
                  </a:lnTo>
                  <a:lnTo>
                    <a:pt x="1447" y="1087"/>
                  </a:lnTo>
                  <a:lnTo>
                    <a:pt x="1448" y="1086"/>
                  </a:lnTo>
                  <a:lnTo>
                    <a:pt x="1448" y="1085"/>
                  </a:lnTo>
                  <a:lnTo>
                    <a:pt x="1448" y="1084"/>
                  </a:lnTo>
                  <a:lnTo>
                    <a:pt x="1449" y="1083"/>
                  </a:lnTo>
                  <a:lnTo>
                    <a:pt x="1449" y="1082"/>
                  </a:lnTo>
                  <a:lnTo>
                    <a:pt x="1450" y="1081"/>
                  </a:lnTo>
                  <a:lnTo>
                    <a:pt x="1450" y="1080"/>
                  </a:lnTo>
                  <a:lnTo>
                    <a:pt x="1451" y="1079"/>
                  </a:lnTo>
                  <a:lnTo>
                    <a:pt x="1451" y="1078"/>
                  </a:lnTo>
                  <a:lnTo>
                    <a:pt x="1452" y="1076"/>
                  </a:lnTo>
                  <a:lnTo>
                    <a:pt x="1452" y="1075"/>
                  </a:lnTo>
                  <a:lnTo>
                    <a:pt x="1453" y="1074"/>
                  </a:lnTo>
                  <a:lnTo>
                    <a:pt x="1453" y="1072"/>
                  </a:lnTo>
                  <a:lnTo>
                    <a:pt x="1454" y="1070"/>
                  </a:lnTo>
                  <a:lnTo>
                    <a:pt x="1454" y="1068"/>
                  </a:lnTo>
                  <a:lnTo>
                    <a:pt x="1455" y="1067"/>
                  </a:lnTo>
                  <a:lnTo>
                    <a:pt x="1455" y="1065"/>
                  </a:lnTo>
                  <a:lnTo>
                    <a:pt x="1456" y="1063"/>
                  </a:lnTo>
                  <a:lnTo>
                    <a:pt x="1456" y="1061"/>
                  </a:lnTo>
                  <a:lnTo>
                    <a:pt x="1457" y="1059"/>
                  </a:lnTo>
                  <a:lnTo>
                    <a:pt x="1457" y="1058"/>
                  </a:lnTo>
                  <a:lnTo>
                    <a:pt x="1457" y="1056"/>
                  </a:lnTo>
                  <a:lnTo>
                    <a:pt x="1458" y="1054"/>
                  </a:lnTo>
                  <a:lnTo>
                    <a:pt x="1458" y="1053"/>
                  </a:lnTo>
                  <a:lnTo>
                    <a:pt x="1459" y="1051"/>
                  </a:lnTo>
                  <a:lnTo>
                    <a:pt x="1459" y="1050"/>
                  </a:lnTo>
                  <a:lnTo>
                    <a:pt x="1460" y="1048"/>
                  </a:lnTo>
                  <a:lnTo>
                    <a:pt x="1460" y="1047"/>
                  </a:lnTo>
                  <a:lnTo>
                    <a:pt x="1461" y="1046"/>
                  </a:lnTo>
                  <a:lnTo>
                    <a:pt x="1461" y="1045"/>
                  </a:lnTo>
                  <a:lnTo>
                    <a:pt x="1462" y="1044"/>
                  </a:lnTo>
                  <a:lnTo>
                    <a:pt x="1463" y="1043"/>
                  </a:lnTo>
                  <a:lnTo>
                    <a:pt x="1464" y="1043"/>
                  </a:lnTo>
                  <a:lnTo>
                    <a:pt x="1465" y="1043"/>
                  </a:lnTo>
                  <a:lnTo>
                    <a:pt x="1465" y="1044"/>
                  </a:lnTo>
                  <a:lnTo>
                    <a:pt x="1466" y="1046"/>
                  </a:lnTo>
                  <a:lnTo>
                    <a:pt x="1466" y="1047"/>
                  </a:lnTo>
                  <a:lnTo>
                    <a:pt x="1466" y="1049"/>
                  </a:lnTo>
                  <a:lnTo>
                    <a:pt x="1467" y="1051"/>
                  </a:lnTo>
                  <a:lnTo>
                    <a:pt x="1467" y="1053"/>
                  </a:lnTo>
                  <a:lnTo>
                    <a:pt x="1468" y="1055"/>
                  </a:lnTo>
                  <a:lnTo>
                    <a:pt x="1468" y="1057"/>
                  </a:lnTo>
                  <a:lnTo>
                    <a:pt x="1469" y="1059"/>
                  </a:lnTo>
                  <a:lnTo>
                    <a:pt x="1469" y="1062"/>
                  </a:lnTo>
                  <a:lnTo>
                    <a:pt x="1470" y="1064"/>
                  </a:lnTo>
                  <a:lnTo>
                    <a:pt x="1470" y="1067"/>
                  </a:lnTo>
                  <a:lnTo>
                    <a:pt x="1471" y="1069"/>
                  </a:lnTo>
                  <a:lnTo>
                    <a:pt x="1471" y="1072"/>
                  </a:lnTo>
                  <a:lnTo>
                    <a:pt x="1472" y="1074"/>
                  </a:lnTo>
                  <a:lnTo>
                    <a:pt x="1472" y="1077"/>
                  </a:lnTo>
                  <a:lnTo>
                    <a:pt x="1473" y="1079"/>
                  </a:lnTo>
                  <a:lnTo>
                    <a:pt x="1473" y="1082"/>
                  </a:lnTo>
                  <a:lnTo>
                    <a:pt x="1474" y="1084"/>
                  </a:lnTo>
                  <a:lnTo>
                    <a:pt x="1474" y="1087"/>
                  </a:lnTo>
                  <a:lnTo>
                    <a:pt x="1474" y="1089"/>
                  </a:lnTo>
                  <a:lnTo>
                    <a:pt x="1475" y="1091"/>
                  </a:lnTo>
                  <a:lnTo>
                    <a:pt x="1475" y="1093"/>
                  </a:lnTo>
                  <a:lnTo>
                    <a:pt x="1476" y="1095"/>
                  </a:lnTo>
                  <a:lnTo>
                    <a:pt x="1476" y="1096"/>
                  </a:lnTo>
                  <a:lnTo>
                    <a:pt x="1477" y="1098"/>
                  </a:lnTo>
                  <a:lnTo>
                    <a:pt x="1477" y="1099"/>
                  </a:lnTo>
                  <a:lnTo>
                    <a:pt x="1478" y="1099"/>
                  </a:lnTo>
                  <a:lnTo>
                    <a:pt x="1478" y="1100"/>
                  </a:lnTo>
                  <a:lnTo>
                    <a:pt x="1479" y="1101"/>
                  </a:lnTo>
                  <a:lnTo>
                    <a:pt x="1480" y="1101"/>
                  </a:lnTo>
                  <a:lnTo>
                    <a:pt x="1481" y="1101"/>
                  </a:lnTo>
                  <a:lnTo>
                    <a:pt x="1482" y="1101"/>
                  </a:lnTo>
                  <a:lnTo>
                    <a:pt x="1482" y="1100"/>
                  </a:lnTo>
                  <a:lnTo>
                    <a:pt x="1483" y="1100"/>
                  </a:lnTo>
                  <a:lnTo>
                    <a:pt x="1483" y="1099"/>
                  </a:lnTo>
                  <a:lnTo>
                    <a:pt x="1484" y="1098"/>
                  </a:lnTo>
                  <a:lnTo>
                    <a:pt x="1484" y="1097"/>
                  </a:lnTo>
                  <a:lnTo>
                    <a:pt x="1485" y="1097"/>
                  </a:lnTo>
                  <a:lnTo>
                    <a:pt x="1485" y="1096"/>
                  </a:lnTo>
                  <a:lnTo>
                    <a:pt x="1486" y="1095"/>
                  </a:lnTo>
                  <a:lnTo>
                    <a:pt x="1486" y="1094"/>
                  </a:lnTo>
                  <a:lnTo>
                    <a:pt x="1487" y="1093"/>
                  </a:lnTo>
                  <a:lnTo>
                    <a:pt x="1487" y="1092"/>
                  </a:lnTo>
                  <a:lnTo>
                    <a:pt x="1488" y="1091"/>
                  </a:lnTo>
                  <a:lnTo>
                    <a:pt x="1488" y="1090"/>
                  </a:lnTo>
                  <a:lnTo>
                    <a:pt x="1489" y="1090"/>
                  </a:lnTo>
                  <a:lnTo>
                    <a:pt x="1489" y="1089"/>
                  </a:lnTo>
                  <a:lnTo>
                    <a:pt x="1490" y="1088"/>
                  </a:lnTo>
                  <a:lnTo>
                    <a:pt x="1490" y="1087"/>
                  </a:lnTo>
                  <a:lnTo>
                    <a:pt x="1491" y="1087"/>
                  </a:lnTo>
                  <a:lnTo>
                    <a:pt x="1491" y="1086"/>
                  </a:lnTo>
                  <a:lnTo>
                    <a:pt x="1492" y="1085"/>
                  </a:lnTo>
                  <a:lnTo>
                    <a:pt x="1493" y="1084"/>
                  </a:lnTo>
                  <a:lnTo>
                    <a:pt x="1494" y="1083"/>
                  </a:lnTo>
                  <a:lnTo>
                    <a:pt x="1495" y="1083"/>
                  </a:lnTo>
                  <a:lnTo>
                    <a:pt x="1495" y="1082"/>
                  </a:lnTo>
                  <a:lnTo>
                    <a:pt x="1496" y="1082"/>
                  </a:lnTo>
                  <a:lnTo>
                    <a:pt x="1497" y="1082"/>
                  </a:lnTo>
                  <a:lnTo>
                    <a:pt x="1498" y="1082"/>
                  </a:lnTo>
                  <a:lnTo>
                    <a:pt x="1499" y="1082"/>
                  </a:lnTo>
                  <a:lnTo>
                    <a:pt x="1500" y="1082"/>
                  </a:lnTo>
                  <a:lnTo>
                    <a:pt x="1500" y="1083"/>
                  </a:lnTo>
                  <a:lnTo>
                    <a:pt x="1501" y="1084"/>
                  </a:lnTo>
                  <a:lnTo>
                    <a:pt x="1502" y="1085"/>
                  </a:lnTo>
                  <a:lnTo>
                    <a:pt x="1502" y="1086"/>
                  </a:lnTo>
                  <a:lnTo>
                    <a:pt x="1503" y="1086"/>
                  </a:lnTo>
                  <a:lnTo>
                    <a:pt x="1503" y="1087"/>
                  </a:lnTo>
                  <a:lnTo>
                    <a:pt x="1504" y="1088"/>
                  </a:lnTo>
                  <a:lnTo>
                    <a:pt x="1504" y="1089"/>
                  </a:lnTo>
                  <a:lnTo>
                    <a:pt x="1505" y="1090"/>
                  </a:lnTo>
                  <a:lnTo>
                    <a:pt x="1505" y="1091"/>
                  </a:lnTo>
                  <a:lnTo>
                    <a:pt x="1506" y="1091"/>
                  </a:lnTo>
                  <a:lnTo>
                    <a:pt x="1506" y="1092"/>
                  </a:lnTo>
                  <a:lnTo>
                    <a:pt x="1507" y="1093"/>
                  </a:lnTo>
                  <a:lnTo>
                    <a:pt x="1507" y="1094"/>
                  </a:lnTo>
                  <a:lnTo>
                    <a:pt x="1508" y="1095"/>
                  </a:lnTo>
                  <a:lnTo>
                    <a:pt x="1508" y="1096"/>
                  </a:lnTo>
                  <a:lnTo>
                    <a:pt x="1508" y="1097"/>
                  </a:lnTo>
                  <a:lnTo>
                    <a:pt x="1509" y="1098"/>
                  </a:lnTo>
                  <a:lnTo>
                    <a:pt x="1509" y="1099"/>
                  </a:lnTo>
                  <a:lnTo>
                    <a:pt x="1510" y="1100"/>
                  </a:lnTo>
                  <a:lnTo>
                    <a:pt x="1510" y="1101"/>
                  </a:lnTo>
                  <a:lnTo>
                    <a:pt x="1511" y="1102"/>
                  </a:lnTo>
                  <a:lnTo>
                    <a:pt x="1511" y="1103"/>
                  </a:lnTo>
                  <a:lnTo>
                    <a:pt x="1512" y="1104"/>
                  </a:lnTo>
                  <a:lnTo>
                    <a:pt x="1512" y="1105"/>
                  </a:lnTo>
                  <a:lnTo>
                    <a:pt x="1513" y="1105"/>
                  </a:lnTo>
                  <a:lnTo>
                    <a:pt x="1513" y="1106"/>
                  </a:lnTo>
                  <a:lnTo>
                    <a:pt x="1514" y="1107"/>
                  </a:lnTo>
                  <a:lnTo>
                    <a:pt x="1514" y="1108"/>
                  </a:lnTo>
                  <a:lnTo>
                    <a:pt x="1515" y="1108"/>
                  </a:lnTo>
                  <a:lnTo>
                    <a:pt x="1515" y="1109"/>
                  </a:lnTo>
                  <a:lnTo>
                    <a:pt x="1516" y="1109"/>
                  </a:lnTo>
                  <a:lnTo>
                    <a:pt x="1516" y="1110"/>
                  </a:lnTo>
                  <a:lnTo>
                    <a:pt x="1517" y="1111"/>
                  </a:lnTo>
                  <a:lnTo>
                    <a:pt x="1517" y="1112"/>
                  </a:lnTo>
                  <a:lnTo>
                    <a:pt x="1518" y="1112"/>
                  </a:lnTo>
                  <a:lnTo>
                    <a:pt x="1518" y="1113"/>
                  </a:lnTo>
                  <a:lnTo>
                    <a:pt x="1519" y="1113"/>
                  </a:lnTo>
                  <a:lnTo>
                    <a:pt x="1519" y="1114"/>
                  </a:lnTo>
                  <a:lnTo>
                    <a:pt x="1520" y="1114"/>
                  </a:lnTo>
                  <a:lnTo>
                    <a:pt x="1520" y="1115"/>
                  </a:lnTo>
                  <a:lnTo>
                    <a:pt x="1521" y="1115"/>
                  </a:lnTo>
                  <a:lnTo>
                    <a:pt x="1521" y="1116"/>
                  </a:lnTo>
                  <a:lnTo>
                    <a:pt x="1522" y="1117"/>
                  </a:lnTo>
                  <a:lnTo>
                    <a:pt x="1523" y="1118"/>
                  </a:lnTo>
                  <a:lnTo>
                    <a:pt x="1524" y="1119"/>
                  </a:lnTo>
                  <a:lnTo>
                    <a:pt x="1524" y="1120"/>
                  </a:lnTo>
                  <a:lnTo>
                    <a:pt x="1525" y="1121"/>
                  </a:lnTo>
                  <a:lnTo>
                    <a:pt x="1525" y="1122"/>
                  </a:lnTo>
                  <a:lnTo>
                    <a:pt x="1525" y="1123"/>
                  </a:lnTo>
                  <a:lnTo>
                    <a:pt x="1526" y="1123"/>
                  </a:lnTo>
                  <a:lnTo>
                    <a:pt x="1526" y="1124"/>
                  </a:lnTo>
                  <a:lnTo>
                    <a:pt x="1527" y="1125"/>
                  </a:lnTo>
                  <a:lnTo>
                    <a:pt x="1527" y="1126"/>
                  </a:lnTo>
                  <a:lnTo>
                    <a:pt x="1528" y="1127"/>
                  </a:lnTo>
                  <a:lnTo>
                    <a:pt x="1528" y="1128"/>
                  </a:lnTo>
                  <a:lnTo>
                    <a:pt x="1529" y="1130"/>
                  </a:lnTo>
                  <a:lnTo>
                    <a:pt x="1529" y="1131"/>
                  </a:lnTo>
                  <a:lnTo>
                    <a:pt x="1530" y="1132"/>
                  </a:lnTo>
                  <a:lnTo>
                    <a:pt x="1530" y="1133"/>
                  </a:lnTo>
                  <a:lnTo>
                    <a:pt x="1531" y="1134"/>
                  </a:lnTo>
                  <a:lnTo>
                    <a:pt x="1531" y="1135"/>
                  </a:lnTo>
                  <a:lnTo>
                    <a:pt x="1532" y="1136"/>
                  </a:lnTo>
                  <a:lnTo>
                    <a:pt x="1532" y="1138"/>
                  </a:lnTo>
                  <a:lnTo>
                    <a:pt x="1533" y="1139"/>
                  </a:lnTo>
                  <a:lnTo>
                    <a:pt x="1533" y="1140"/>
                  </a:lnTo>
                  <a:lnTo>
                    <a:pt x="1534" y="1141"/>
                  </a:lnTo>
                  <a:lnTo>
                    <a:pt x="1534" y="1143"/>
                  </a:lnTo>
                  <a:lnTo>
                    <a:pt x="1534" y="1144"/>
                  </a:lnTo>
                  <a:lnTo>
                    <a:pt x="1535" y="1145"/>
                  </a:lnTo>
                  <a:lnTo>
                    <a:pt x="1535" y="1146"/>
                  </a:lnTo>
                  <a:lnTo>
                    <a:pt x="1536" y="1147"/>
                  </a:lnTo>
                  <a:lnTo>
                    <a:pt x="1536" y="1149"/>
                  </a:lnTo>
                  <a:lnTo>
                    <a:pt x="1537" y="1150"/>
                  </a:lnTo>
                  <a:lnTo>
                    <a:pt x="1537" y="1151"/>
                  </a:lnTo>
                  <a:lnTo>
                    <a:pt x="1538" y="1152"/>
                  </a:lnTo>
                  <a:lnTo>
                    <a:pt x="1538" y="1153"/>
                  </a:lnTo>
                  <a:lnTo>
                    <a:pt x="1539" y="1155"/>
                  </a:lnTo>
                  <a:lnTo>
                    <a:pt x="1539" y="1156"/>
                  </a:lnTo>
                  <a:lnTo>
                    <a:pt x="1540" y="1157"/>
                  </a:lnTo>
                  <a:lnTo>
                    <a:pt x="1540" y="1158"/>
                  </a:lnTo>
                  <a:lnTo>
                    <a:pt x="1541" y="1160"/>
                  </a:lnTo>
                  <a:lnTo>
                    <a:pt x="1541" y="1161"/>
                  </a:lnTo>
                  <a:lnTo>
                    <a:pt x="1542" y="1162"/>
                  </a:lnTo>
                  <a:lnTo>
                    <a:pt x="1542" y="1164"/>
                  </a:lnTo>
                  <a:lnTo>
                    <a:pt x="1543" y="1165"/>
                  </a:lnTo>
                  <a:lnTo>
                    <a:pt x="1543" y="1166"/>
                  </a:lnTo>
                  <a:lnTo>
                    <a:pt x="1543" y="1168"/>
                  </a:lnTo>
                  <a:lnTo>
                    <a:pt x="1544" y="1169"/>
                  </a:lnTo>
                  <a:lnTo>
                    <a:pt x="1544" y="1170"/>
                  </a:lnTo>
                  <a:lnTo>
                    <a:pt x="1545" y="1172"/>
                  </a:lnTo>
                  <a:lnTo>
                    <a:pt x="1545" y="1173"/>
                  </a:lnTo>
                  <a:lnTo>
                    <a:pt x="1546" y="1175"/>
                  </a:lnTo>
                  <a:lnTo>
                    <a:pt x="1546" y="1176"/>
                  </a:lnTo>
                  <a:lnTo>
                    <a:pt x="1547" y="1178"/>
                  </a:lnTo>
                  <a:lnTo>
                    <a:pt x="1547" y="1180"/>
                  </a:lnTo>
                  <a:lnTo>
                    <a:pt x="1548" y="1182"/>
                  </a:lnTo>
                  <a:lnTo>
                    <a:pt x="1548" y="1183"/>
                  </a:lnTo>
                  <a:lnTo>
                    <a:pt x="1549" y="1185"/>
                  </a:lnTo>
                  <a:lnTo>
                    <a:pt x="1549" y="1187"/>
                  </a:lnTo>
                  <a:lnTo>
                    <a:pt x="1550" y="1189"/>
                  </a:lnTo>
                  <a:lnTo>
                    <a:pt x="1550" y="1191"/>
                  </a:lnTo>
                  <a:lnTo>
                    <a:pt x="1551" y="1193"/>
                  </a:lnTo>
                  <a:lnTo>
                    <a:pt x="1551" y="1195"/>
                  </a:lnTo>
                  <a:lnTo>
                    <a:pt x="1551" y="1197"/>
                  </a:lnTo>
                  <a:lnTo>
                    <a:pt x="1552" y="1198"/>
                  </a:lnTo>
                  <a:lnTo>
                    <a:pt x="1552" y="1200"/>
                  </a:lnTo>
                  <a:lnTo>
                    <a:pt x="1553" y="1202"/>
                  </a:lnTo>
                  <a:lnTo>
                    <a:pt x="1553" y="1203"/>
                  </a:lnTo>
                  <a:lnTo>
                    <a:pt x="1554" y="1205"/>
                  </a:lnTo>
                  <a:lnTo>
                    <a:pt x="1554" y="1206"/>
                  </a:lnTo>
                  <a:lnTo>
                    <a:pt x="1555" y="1207"/>
                  </a:lnTo>
                  <a:lnTo>
                    <a:pt x="1555" y="1208"/>
                  </a:lnTo>
                  <a:lnTo>
                    <a:pt x="1556" y="1209"/>
                  </a:lnTo>
                  <a:lnTo>
                    <a:pt x="1556" y="1210"/>
                  </a:lnTo>
                  <a:lnTo>
                    <a:pt x="1557" y="1211"/>
                  </a:lnTo>
                  <a:lnTo>
                    <a:pt x="1558" y="1211"/>
                  </a:lnTo>
                  <a:lnTo>
                    <a:pt x="1558" y="1212"/>
                  </a:lnTo>
                  <a:lnTo>
                    <a:pt x="1559" y="1212"/>
                  </a:lnTo>
                  <a:lnTo>
                    <a:pt x="1559" y="1211"/>
                  </a:lnTo>
                  <a:lnTo>
                    <a:pt x="1560" y="1211"/>
                  </a:lnTo>
                  <a:lnTo>
                    <a:pt x="1560" y="1210"/>
                  </a:lnTo>
                  <a:lnTo>
                    <a:pt x="1560" y="1208"/>
                  </a:lnTo>
                  <a:lnTo>
                    <a:pt x="1561" y="1207"/>
                  </a:lnTo>
                  <a:lnTo>
                    <a:pt x="1561" y="1206"/>
                  </a:lnTo>
                  <a:lnTo>
                    <a:pt x="1562" y="1204"/>
                  </a:lnTo>
                  <a:lnTo>
                    <a:pt x="1562" y="1202"/>
                  </a:lnTo>
                  <a:lnTo>
                    <a:pt x="1563" y="1201"/>
                  </a:lnTo>
                  <a:lnTo>
                    <a:pt x="1563" y="1199"/>
                  </a:lnTo>
                  <a:lnTo>
                    <a:pt x="1564" y="1197"/>
                  </a:lnTo>
                  <a:lnTo>
                    <a:pt x="1564" y="1196"/>
                  </a:lnTo>
                  <a:lnTo>
                    <a:pt x="1565" y="1194"/>
                  </a:lnTo>
                  <a:lnTo>
                    <a:pt x="1565" y="1192"/>
                  </a:lnTo>
                  <a:lnTo>
                    <a:pt x="1566" y="1191"/>
                  </a:lnTo>
                  <a:lnTo>
                    <a:pt x="1566" y="1189"/>
                  </a:lnTo>
                  <a:lnTo>
                    <a:pt x="1567" y="1188"/>
                  </a:lnTo>
                  <a:lnTo>
                    <a:pt x="1567" y="1187"/>
                  </a:lnTo>
                  <a:lnTo>
                    <a:pt x="1568" y="1186"/>
                  </a:lnTo>
                  <a:lnTo>
                    <a:pt x="1568" y="1185"/>
                  </a:lnTo>
                  <a:lnTo>
                    <a:pt x="1568" y="1184"/>
                  </a:lnTo>
                  <a:lnTo>
                    <a:pt x="1569" y="1184"/>
                  </a:lnTo>
                  <a:lnTo>
                    <a:pt x="1569" y="1183"/>
                  </a:lnTo>
                  <a:lnTo>
                    <a:pt x="1570" y="1183"/>
                  </a:lnTo>
                  <a:lnTo>
                    <a:pt x="1570" y="1184"/>
                  </a:lnTo>
                  <a:lnTo>
                    <a:pt x="1571" y="1184"/>
                  </a:lnTo>
                  <a:lnTo>
                    <a:pt x="1571" y="1185"/>
                  </a:lnTo>
                  <a:lnTo>
                    <a:pt x="1572" y="1187"/>
                  </a:lnTo>
                  <a:lnTo>
                    <a:pt x="1572" y="1189"/>
                  </a:lnTo>
                  <a:lnTo>
                    <a:pt x="1573" y="1191"/>
                  </a:lnTo>
                  <a:lnTo>
                    <a:pt x="1573" y="1193"/>
                  </a:lnTo>
                  <a:lnTo>
                    <a:pt x="1574" y="1196"/>
                  </a:lnTo>
                  <a:lnTo>
                    <a:pt x="1574" y="1199"/>
                  </a:lnTo>
                  <a:lnTo>
                    <a:pt x="1575" y="1202"/>
                  </a:lnTo>
                  <a:lnTo>
                    <a:pt x="1575" y="1205"/>
                  </a:lnTo>
                  <a:lnTo>
                    <a:pt x="1576" y="1208"/>
                  </a:lnTo>
                  <a:lnTo>
                    <a:pt x="1576" y="1212"/>
                  </a:lnTo>
                  <a:lnTo>
                    <a:pt x="1577" y="1215"/>
                  </a:lnTo>
                  <a:lnTo>
                    <a:pt x="1577" y="1219"/>
                  </a:lnTo>
                  <a:lnTo>
                    <a:pt x="1577" y="1223"/>
                  </a:lnTo>
                  <a:lnTo>
                    <a:pt x="1578" y="1226"/>
                  </a:lnTo>
                  <a:lnTo>
                    <a:pt x="1578" y="1230"/>
                  </a:lnTo>
                  <a:lnTo>
                    <a:pt x="1579" y="1234"/>
                  </a:lnTo>
                  <a:lnTo>
                    <a:pt x="1579" y="1237"/>
                  </a:lnTo>
                  <a:lnTo>
                    <a:pt x="1580" y="1241"/>
                  </a:lnTo>
                  <a:lnTo>
                    <a:pt x="1580" y="1245"/>
                  </a:lnTo>
                  <a:lnTo>
                    <a:pt x="1581" y="1248"/>
                  </a:lnTo>
                  <a:lnTo>
                    <a:pt x="1581" y="1252"/>
                  </a:lnTo>
                  <a:lnTo>
                    <a:pt x="1582" y="1255"/>
                  </a:lnTo>
                  <a:lnTo>
                    <a:pt x="1582" y="1258"/>
                  </a:lnTo>
                  <a:lnTo>
                    <a:pt x="1583" y="1261"/>
                  </a:lnTo>
                  <a:lnTo>
                    <a:pt x="1583" y="1264"/>
                  </a:lnTo>
                  <a:lnTo>
                    <a:pt x="1584" y="1266"/>
                  </a:lnTo>
                  <a:lnTo>
                    <a:pt x="1584" y="1268"/>
                  </a:lnTo>
                  <a:lnTo>
                    <a:pt x="1585" y="1270"/>
                  </a:lnTo>
                  <a:lnTo>
                    <a:pt x="1585" y="1272"/>
                  </a:lnTo>
                  <a:lnTo>
                    <a:pt x="1585" y="1274"/>
                  </a:lnTo>
                  <a:lnTo>
                    <a:pt x="1586" y="1275"/>
                  </a:lnTo>
                  <a:lnTo>
                    <a:pt x="1586" y="1277"/>
                  </a:lnTo>
                  <a:lnTo>
                    <a:pt x="1587" y="1278"/>
                  </a:lnTo>
                  <a:lnTo>
                    <a:pt x="1587" y="1279"/>
                  </a:lnTo>
                  <a:lnTo>
                    <a:pt x="1588" y="1280"/>
                  </a:lnTo>
                  <a:lnTo>
                    <a:pt x="1588" y="1281"/>
                  </a:lnTo>
                  <a:lnTo>
                    <a:pt x="1589" y="1281"/>
                  </a:lnTo>
                  <a:lnTo>
                    <a:pt x="1589" y="1282"/>
                  </a:lnTo>
                  <a:lnTo>
                    <a:pt x="1590" y="1282"/>
                  </a:lnTo>
                  <a:lnTo>
                    <a:pt x="1591" y="1282"/>
                  </a:lnTo>
                  <a:lnTo>
                    <a:pt x="1592" y="1282"/>
                  </a:lnTo>
                  <a:lnTo>
                    <a:pt x="1593" y="1281"/>
                  </a:lnTo>
                  <a:lnTo>
                    <a:pt x="1593" y="1280"/>
                  </a:lnTo>
                  <a:lnTo>
                    <a:pt x="1594" y="1280"/>
                  </a:lnTo>
                  <a:lnTo>
                    <a:pt x="1594" y="1279"/>
                  </a:lnTo>
                  <a:lnTo>
                    <a:pt x="1594" y="1278"/>
                  </a:lnTo>
                  <a:lnTo>
                    <a:pt x="1595" y="1277"/>
                  </a:lnTo>
                  <a:lnTo>
                    <a:pt x="1595" y="1275"/>
                  </a:lnTo>
                  <a:lnTo>
                    <a:pt x="1596" y="1274"/>
                  </a:lnTo>
                  <a:lnTo>
                    <a:pt x="1596" y="1272"/>
                  </a:lnTo>
                  <a:lnTo>
                    <a:pt x="1597" y="1271"/>
                  </a:lnTo>
                  <a:lnTo>
                    <a:pt x="1597" y="1269"/>
                  </a:lnTo>
                  <a:lnTo>
                    <a:pt x="1598" y="1268"/>
                  </a:lnTo>
                  <a:lnTo>
                    <a:pt x="1598" y="1266"/>
                  </a:lnTo>
                  <a:lnTo>
                    <a:pt x="1599" y="1264"/>
                  </a:lnTo>
                  <a:lnTo>
                    <a:pt x="1599" y="1262"/>
                  </a:lnTo>
                  <a:lnTo>
                    <a:pt x="1600" y="1261"/>
                  </a:lnTo>
                  <a:lnTo>
                    <a:pt x="1600" y="1259"/>
                  </a:lnTo>
                  <a:lnTo>
                    <a:pt x="1601" y="1257"/>
                  </a:lnTo>
                  <a:lnTo>
                    <a:pt x="1601" y="1255"/>
                  </a:lnTo>
                  <a:lnTo>
                    <a:pt x="1602" y="1254"/>
                  </a:lnTo>
                  <a:lnTo>
                    <a:pt x="1602" y="1252"/>
                  </a:lnTo>
                  <a:lnTo>
                    <a:pt x="1603" y="1251"/>
                  </a:lnTo>
                  <a:lnTo>
                    <a:pt x="1603" y="1249"/>
                  </a:lnTo>
                  <a:lnTo>
                    <a:pt x="1603" y="1248"/>
                  </a:lnTo>
                  <a:lnTo>
                    <a:pt x="1604" y="1246"/>
                  </a:lnTo>
                  <a:lnTo>
                    <a:pt x="1604" y="1245"/>
                  </a:lnTo>
                  <a:lnTo>
                    <a:pt x="1605" y="1244"/>
                  </a:lnTo>
                  <a:lnTo>
                    <a:pt x="1605" y="1243"/>
                  </a:lnTo>
                  <a:lnTo>
                    <a:pt x="1606" y="1242"/>
                  </a:lnTo>
                  <a:lnTo>
                    <a:pt x="1607" y="1241"/>
                  </a:lnTo>
                  <a:lnTo>
                    <a:pt x="1608" y="1241"/>
                  </a:lnTo>
                  <a:lnTo>
                    <a:pt x="1609" y="1242"/>
                  </a:lnTo>
                  <a:lnTo>
                    <a:pt x="1610" y="1242"/>
                  </a:lnTo>
                  <a:lnTo>
                    <a:pt x="1610" y="1243"/>
                  </a:lnTo>
                  <a:lnTo>
                    <a:pt x="1611" y="1243"/>
                  </a:lnTo>
                  <a:lnTo>
                    <a:pt x="1611" y="1244"/>
                  </a:lnTo>
                  <a:lnTo>
                    <a:pt x="1612" y="1244"/>
                  </a:lnTo>
                  <a:lnTo>
                    <a:pt x="1613" y="1244"/>
                  </a:lnTo>
                  <a:lnTo>
                    <a:pt x="1614" y="1244"/>
                  </a:lnTo>
                  <a:lnTo>
                    <a:pt x="1615" y="1244"/>
                  </a:lnTo>
                  <a:lnTo>
                    <a:pt x="1615" y="1243"/>
                  </a:lnTo>
                  <a:lnTo>
                    <a:pt x="1616" y="1243"/>
                  </a:lnTo>
                  <a:lnTo>
                    <a:pt x="1616" y="1242"/>
                  </a:lnTo>
                  <a:lnTo>
                    <a:pt x="1617" y="1241"/>
                  </a:lnTo>
                  <a:lnTo>
                    <a:pt x="1617" y="1239"/>
                  </a:lnTo>
                  <a:lnTo>
                    <a:pt x="1618" y="1238"/>
                  </a:lnTo>
                  <a:lnTo>
                    <a:pt x="1618" y="1236"/>
                  </a:lnTo>
                  <a:lnTo>
                    <a:pt x="1619" y="1233"/>
                  </a:lnTo>
                  <a:lnTo>
                    <a:pt x="1619" y="1230"/>
                  </a:lnTo>
                  <a:lnTo>
                    <a:pt x="1620" y="1226"/>
                  </a:lnTo>
                  <a:lnTo>
                    <a:pt x="1620" y="1223"/>
                  </a:lnTo>
                  <a:lnTo>
                    <a:pt x="1620" y="1219"/>
                  </a:lnTo>
                  <a:lnTo>
                    <a:pt x="1621" y="1215"/>
                  </a:lnTo>
                  <a:lnTo>
                    <a:pt x="1621" y="1211"/>
                  </a:lnTo>
                  <a:lnTo>
                    <a:pt x="1622" y="1207"/>
                  </a:lnTo>
                  <a:lnTo>
                    <a:pt x="1622" y="1202"/>
                  </a:lnTo>
                  <a:lnTo>
                    <a:pt x="1623" y="1198"/>
                  </a:lnTo>
                  <a:lnTo>
                    <a:pt x="1623" y="1193"/>
                  </a:lnTo>
                  <a:lnTo>
                    <a:pt x="1624" y="1189"/>
                  </a:lnTo>
                  <a:lnTo>
                    <a:pt x="1624" y="1184"/>
                  </a:lnTo>
                  <a:lnTo>
                    <a:pt x="1625" y="1180"/>
                  </a:lnTo>
                  <a:lnTo>
                    <a:pt x="1625" y="1175"/>
                  </a:lnTo>
                  <a:lnTo>
                    <a:pt x="1626" y="1171"/>
                  </a:lnTo>
                  <a:lnTo>
                    <a:pt x="1626" y="1167"/>
                  </a:lnTo>
                  <a:lnTo>
                    <a:pt x="1627" y="1162"/>
                  </a:lnTo>
                  <a:lnTo>
                    <a:pt x="1627" y="1158"/>
                  </a:lnTo>
                  <a:lnTo>
                    <a:pt x="1628" y="1155"/>
                  </a:lnTo>
                  <a:lnTo>
                    <a:pt x="1628" y="1151"/>
                  </a:lnTo>
                  <a:lnTo>
                    <a:pt x="1628" y="1148"/>
                  </a:lnTo>
                  <a:lnTo>
                    <a:pt x="1629" y="1144"/>
                  </a:lnTo>
                  <a:lnTo>
                    <a:pt x="1629" y="1141"/>
                  </a:lnTo>
                  <a:lnTo>
                    <a:pt x="1630" y="1139"/>
                  </a:lnTo>
                  <a:lnTo>
                    <a:pt x="1630" y="1137"/>
                  </a:lnTo>
                  <a:lnTo>
                    <a:pt x="1631" y="1135"/>
                  </a:lnTo>
                  <a:lnTo>
                    <a:pt x="1631" y="1134"/>
                  </a:lnTo>
                  <a:lnTo>
                    <a:pt x="1632" y="1133"/>
                  </a:lnTo>
                  <a:lnTo>
                    <a:pt x="1633" y="1132"/>
                  </a:lnTo>
                  <a:lnTo>
                    <a:pt x="1634" y="1132"/>
                  </a:lnTo>
                  <a:lnTo>
                    <a:pt x="1635" y="1132"/>
                  </a:lnTo>
                  <a:lnTo>
                    <a:pt x="1635" y="1133"/>
                  </a:lnTo>
                  <a:lnTo>
                    <a:pt x="1636" y="1133"/>
                  </a:lnTo>
                  <a:lnTo>
                    <a:pt x="1636" y="1134"/>
                  </a:lnTo>
                  <a:lnTo>
                    <a:pt x="1637" y="1134"/>
                  </a:lnTo>
                  <a:lnTo>
                    <a:pt x="1637" y="1135"/>
                  </a:lnTo>
                  <a:lnTo>
                    <a:pt x="1637" y="1136"/>
                  </a:lnTo>
                  <a:lnTo>
                    <a:pt x="1638" y="1137"/>
                  </a:lnTo>
                  <a:lnTo>
                    <a:pt x="1639" y="1138"/>
                  </a:lnTo>
                  <a:lnTo>
                    <a:pt x="1639" y="1139"/>
                  </a:lnTo>
                  <a:lnTo>
                    <a:pt x="1640" y="1140"/>
                  </a:lnTo>
                  <a:lnTo>
                    <a:pt x="1641" y="1141"/>
                  </a:lnTo>
                  <a:lnTo>
                    <a:pt x="1642" y="1142"/>
                  </a:lnTo>
                  <a:lnTo>
                    <a:pt x="1643" y="1141"/>
                  </a:lnTo>
                  <a:lnTo>
                    <a:pt x="1644" y="1140"/>
                  </a:lnTo>
                  <a:lnTo>
                    <a:pt x="1645" y="1139"/>
                  </a:lnTo>
                  <a:lnTo>
                    <a:pt x="1645" y="1138"/>
                  </a:lnTo>
                  <a:lnTo>
                    <a:pt x="1645" y="1137"/>
                  </a:lnTo>
                  <a:lnTo>
                    <a:pt x="1646" y="1136"/>
                  </a:lnTo>
                  <a:lnTo>
                    <a:pt x="1646" y="1135"/>
                  </a:lnTo>
                  <a:lnTo>
                    <a:pt x="1647" y="1134"/>
                  </a:lnTo>
                  <a:lnTo>
                    <a:pt x="1647" y="1133"/>
                  </a:lnTo>
                  <a:lnTo>
                    <a:pt x="1648" y="1131"/>
                  </a:lnTo>
                  <a:lnTo>
                    <a:pt x="1648" y="1130"/>
                  </a:lnTo>
                  <a:lnTo>
                    <a:pt x="1649" y="1128"/>
                  </a:lnTo>
                  <a:lnTo>
                    <a:pt x="1649" y="1127"/>
                  </a:lnTo>
                  <a:lnTo>
                    <a:pt x="1650" y="1125"/>
                  </a:lnTo>
                  <a:lnTo>
                    <a:pt x="1650" y="1123"/>
                  </a:lnTo>
                  <a:lnTo>
                    <a:pt x="1651" y="1122"/>
                  </a:lnTo>
                  <a:lnTo>
                    <a:pt x="1651" y="1120"/>
                  </a:lnTo>
                  <a:lnTo>
                    <a:pt x="1652" y="1118"/>
                  </a:lnTo>
                  <a:lnTo>
                    <a:pt x="1652" y="1117"/>
                  </a:lnTo>
                  <a:lnTo>
                    <a:pt x="1653" y="1115"/>
                  </a:lnTo>
                  <a:lnTo>
                    <a:pt x="1653" y="1113"/>
                  </a:lnTo>
                  <a:lnTo>
                    <a:pt x="1654" y="1111"/>
                  </a:lnTo>
                  <a:lnTo>
                    <a:pt x="1654" y="1110"/>
                  </a:lnTo>
                  <a:lnTo>
                    <a:pt x="1654" y="1109"/>
                  </a:lnTo>
                  <a:lnTo>
                    <a:pt x="1655" y="1107"/>
                  </a:lnTo>
                  <a:lnTo>
                    <a:pt x="1655" y="1106"/>
                  </a:lnTo>
                  <a:lnTo>
                    <a:pt x="1656" y="1104"/>
                  </a:lnTo>
                  <a:lnTo>
                    <a:pt x="1656" y="1103"/>
                  </a:lnTo>
                  <a:lnTo>
                    <a:pt x="1657" y="1101"/>
                  </a:lnTo>
                  <a:lnTo>
                    <a:pt x="1657" y="1100"/>
                  </a:lnTo>
                  <a:lnTo>
                    <a:pt x="1658" y="1099"/>
                  </a:lnTo>
                  <a:lnTo>
                    <a:pt x="1658" y="1097"/>
                  </a:lnTo>
                  <a:lnTo>
                    <a:pt x="1659" y="1096"/>
                  </a:lnTo>
                  <a:lnTo>
                    <a:pt x="1659" y="1095"/>
                  </a:lnTo>
                  <a:lnTo>
                    <a:pt x="1660" y="1093"/>
                  </a:lnTo>
                  <a:lnTo>
                    <a:pt x="1660" y="1092"/>
                  </a:lnTo>
                  <a:lnTo>
                    <a:pt x="1661" y="1091"/>
                  </a:lnTo>
                  <a:lnTo>
                    <a:pt x="1661" y="1090"/>
                  </a:lnTo>
                  <a:lnTo>
                    <a:pt x="1662" y="1088"/>
                  </a:lnTo>
                  <a:lnTo>
                    <a:pt x="1662" y="1087"/>
                  </a:lnTo>
                  <a:lnTo>
                    <a:pt x="1662" y="1086"/>
                  </a:lnTo>
                  <a:lnTo>
                    <a:pt x="1663" y="1085"/>
                  </a:lnTo>
                  <a:lnTo>
                    <a:pt x="1663" y="1084"/>
                  </a:lnTo>
                  <a:lnTo>
                    <a:pt x="1664" y="1083"/>
                  </a:lnTo>
                  <a:lnTo>
                    <a:pt x="1664" y="1082"/>
                  </a:lnTo>
                  <a:lnTo>
                    <a:pt x="1665" y="1081"/>
                  </a:lnTo>
                  <a:lnTo>
                    <a:pt x="1665" y="1080"/>
                  </a:lnTo>
                  <a:lnTo>
                    <a:pt x="1666" y="1079"/>
                  </a:lnTo>
                  <a:lnTo>
                    <a:pt x="1666" y="1078"/>
                  </a:lnTo>
                  <a:lnTo>
                    <a:pt x="1667" y="1077"/>
                  </a:lnTo>
                  <a:lnTo>
                    <a:pt x="1667" y="1076"/>
                  </a:lnTo>
                  <a:lnTo>
                    <a:pt x="1668" y="1075"/>
                  </a:lnTo>
                  <a:lnTo>
                    <a:pt x="1669" y="1074"/>
                  </a:lnTo>
                  <a:lnTo>
                    <a:pt x="1669" y="1073"/>
                  </a:lnTo>
                  <a:lnTo>
                    <a:pt x="1670" y="1073"/>
                  </a:lnTo>
                  <a:lnTo>
                    <a:pt x="1670" y="1072"/>
                  </a:lnTo>
                  <a:lnTo>
                    <a:pt x="1671" y="1071"/>
                  </a:lnTo>
                  <a:lnTo>
                    <a:pt x="1671" y="1070"/>
                  </a:lnTo>
                  <a:lnTo>
                    <a:pt x="1672" y="1070"/>
                  </a:lnTo>
                  <a:lnTo>
                    <a:pt x="1672" y="1069"/>
                  </a:lnTo>
                  <a:lnTo>
                    <a:pt x="1673" y="1069"/>
                  </a:lnTo>
                  <a:lnTo>
                    <a:pt x="1673" y="1068"/>
                  </a:lnTo>
                  <a:lnTo>
                    <a:pt x="1674" y="1068"/>
                  </a:lnTo>
                  <a:lnTo>
                    <a:pt x="1675" y="1067"/>
                  </a:lnTo>
                  <a:lnTo>
                    <a:pt x="1676" y="1067"/>
                  </a:lnTo>
                  <a:lnTo>
                    <a:pt x="1676" y="1066"/>
                  </a:lnTo>
                  <a:lnTo>
                    <a:pt x="1677" y="1066"/>
                  </a:lnTo>
                  <a:lnTo>
                    <a:pt x="1678" y="1066"/>
                  </a:lnTo>
                  <a:lnTo>
                    <a:pt x="1679" y="1066"/>
                  </a:lnTo>
                  <a:lnTo>
                    <a:pt x="1680" y="1066"/>
                  </a:lnTo>
                  <a:lnTo>
                    <a:pt x="1681" y="1066"/>
                  </a:lnTo>
                  <a:lnTo>
                    <a:pt x="1682" y="1066"/>
                  </a:lnTo>
                  <a:lnTo>
                    <a:pt x="1683" y="1066"/>
                  </a:lnTo>
                  <a:lnTo>
                    <a:pt x="1684" y="1066"/>
                  </a:lnTo>
                  <a:lnTo>
                    <a:pt x="1685" y="1066"/>
                  </a:lnTo>
                  <a:lnTo>
                    <a:pt x="1686" y="1066"/>
                  </a:lnTo>
                  <a:lnTo>
                    <a:pt x="1687" y="1066"/>
                  </a:lnTo>
                  <a:lnTo>
                    <a:pt x="1688" y="1066"/>
                  </a:lnTo>
                  <a:lnTo>
                    <a:pt x="1689" y="1066"/>
                  </a:lnTo>
                  <a:lnTo>
                    <a:pt x="1690" y="1066"/>
                  </a:lnTo>
                  <a:lnTo>
                    <a:pt x="1691" y="1065"/>
                  </a:lnTo>
                  <a:lnTo>
                    <a:pt x="1692" y="1065"/>
                  </a:lnTo>
                  <a:lnTo>
                    <a:pt x="1693" y="1065"/>
                  </a:lnTo>
                  <a:lnTo>
                    <a:pt x="1693" y="1064"/>
                  </a:lnTo>
                  <a:lnTo>
                    <a:pt x="1694" y="1064"/>
                  </a:lnTo>
                  <a:lnTo>
                    <a:pt x="1695" y="1063"/>
                  </a:lnTo>
                  <a:lnTo>
                    <a:pt x="1696" y="1063"/>
                  </a:lnTo>
                  <a:lnTo>
                    <a:pt x="1697" y="1062"/>
                  </a:lnTo>
                  <a:lnTo>
                    <a:pt x="1698" y="1061"/>
                  </a:lnTo>
                  <a:lnTo>
                    <a:pt x="1699" y="1061"/>
                  </a:lnTo>
                  <a:lnTo>
                    <a:pt x="1700" y="1060"/>
                  </a:lnTo>
                  <a:lnTo>
                    <a:pt x="1701" y="1060"/>
                  </a:lnTo>
                  <a:lnTo>
                    <a:pt x="1702" y="1060"/>
                  </a:lnTo>
                  <a:lnTo>
                    <a:pt x="1703" y="1060"/>
                  </a:lnTo>
                  <a:lnTo>
                    <a:pt x="1704" y="1060"/>
                  </a:lnTo>
                  <a:lnTo>
                    <a:pt x="1705" y="1060"/>
                  </a:lnTo>
                  <a:lnTo>
                    <a:pt x="1705" y="1061"/>
                  </a:lnTo>
                  <a:lnTo>
                    <a:pt x="1706" y="1061"/>
                  </a:lnTo>
                  <a:lnTo>
                    <a:pt x="1707" y="1061"/>
                  </a:lnTo>
                  <a:lnTo>
                    <a:pt x="1708" y="1061"/>
                  </a:lnTo>
                  <a:lnTo>
                    <a:pt x="1709" y="1061"/>
                  </a:lnTo>
                  <a:lnTo>
                    <a:pt x="1710" y="1061"/>
                  </a:lnTo>
                  <a:lnTo>
                    <a:pt x="1710" y="1062"/>
                  </a:lnTo>
                  <a:lnTo>
                    <a:pt x="1711" y="1062"/>
                  </a:lnTo>
                  <a:lnTo>
                    <a:pt x="1712" y="1062"/>
                  </a:lnTo>
                  <a:lnTo>
                    <a:pt x="1713" y="1061"/>
                  </a:lnTo>
                  <a:lnTo>
                    <a:pt x="1714" y="1061"/>
                  </a:lnTo>
                  <a:lnTo>
                    <a:pt x="1715" y="1060"/>
                  </a:lnTo>
                  <a:lnTo>
                    <a:pt x="1716" y="1060"/>
                  </a:lnTo>
                  <a:lnTo>
                    <a:pt x="1717" y="1060"/>
                  </a:lnTo>
                  <a:lnTo>
                    <a:pt x="1717" y="1059"/>
                  </a:lnTo>
                  <a:lnTo>
                    <a:pt x="1718" y="1059"/>
                  </a:lnTo>
                  <a:lnTo>
                    <a:pt x="1719" y="1059"/>
                  </a:lnTo>
                  <a:lnTo>
                    <a:pt x="1720" y="1060"/>
                  </a:lnTo>
                  <a:lnTo>
                    <a:pt x="1721" y="1060"/>
                  </a:lnTo>
                  <a:lnTo>
                    <a:pt x="1722" y="1061"/>
                  </a:lnTo>
                  <a:lnTo>
                    <a:pt x="1722" y="1062"/>
                  </a:lnTo>
                  <a:lnTo>
                    <a:pt x="1723" y="1063"/>
                  </a:lnTo>
                  <a:lnTo>
                    <a:pt x="1723" y="1064"/>
                  </a:lnTo>
                  <a:lnTo>
                    <a:pt x="1724" y="1065"/>
                  </a:lnTo>
                  <a:lnTo>
                    <a:pt x="1724" y="1066"/>
                  </a:lnTo>
                  <a:lnTo>
                    <a:pt x="1725" y="1068"/>
                  </a:lnTo>
                  <a:lnTo>
                    <a:pt x="1725" y="1069"/>
                  </a:lnTo>
                  <a:lnTo>
                    <a:pt x="1726" y="1071"/>
                  </a:lnTo>
                  <a:lnTo>
                    <a:pt x="1726" y="1073"/>
                  </a:lnTo>
                  <a:lnTo>
                    <a:pt x="1727" y="1075"/>
                  </a:lnTo>
                  <a:lnTo>
                    <a:pt x="1727" y="1077"/>
                  </a:lnTo>
                  <a:lnTo>
                    <a:pt x="1728" y="1079"/>
                  </a:lnTo>
                  <a:lnTo>
                    <a:pt x="1728" y="1082"/>
                  </a:lnTo>
                  <a:lnTo>
                    <a:pt x="1729" y="1084"/>
                  </a:lnTo>
                  <a:lnTo>
                    <a:pt x="1729" y="1086"/>
                  </a:lnTo>
                  <a:lnTo>
                    <a:pt x="1730" y="1088"/>
                  </a:lnTo>
                  <a:lnTo>
                    <a:pt x="1730" y="1091"/>
                  </a:lnTo>
                  <a:lnTo>
                    <a:pt x="1731" y="1093"/>
                  </a:lnTo>
                  <a:lnTo>
                    <a:pt x="1731" y="1095"/>
                  </a:lnTo>
                  <a:lnTo>
                    <a:pt x="1731" y="1097"/>
                  </a:lnTo>
                  <a:lnTo>
                    <a:pt x="1732" y="1100"/>
                  </a:lnTo>
                  <a:lnTo>
                    <a:pt x="1732" y="1102"/>
                  </a:lnTo>
                  <a:lnTo>
                    <a:pt x="1733" y="1104"/>
                  </a:lnTo>
                  <a:lnTo>
                    <a:pt x="1733" y="1106"/>
                  </a:lnTo>
                  <a:lnTo>
                    <a:pt x="1734" y="1107"/>
                  </a:lnTo>
                  <a:lnTo>
                    <a:pt x="1734" y="1109"/>
                  </a:lnTo>
                  <a:lnTo>
                    <a:pt x="1735" y="1111"/>
                  </a:lnTo>
                  <a:lnTo>
                    <a:pt x="1735" y="1112"/>
                  </a:lnTo>
                  <a:lnTo>
                    <a:pt x="1736" y="1113"/>
                  </a:lnTo>
                  <a:lnTo>
                    <a:pt x="1736" y="1114"/>
                  </a:lnTo>
                  <a:lnTo>
                    <a:pt x="1737" y="1115"/>
                  </a:lnTo>
                  <a:lnTo>
                    <a:pt x="1737" y="1116"/>
                  </a:lnTo>
                  <a:lnTo>
                    <a:pt x="1738" y="1116"/>
                  </a:lnTo>
                  <a:lnTo>
                    <a:pt x="1738" y="1117"/>
                  </a:lnTo>
                  <a:lnTo>
                    <a:pt x="1739" y="1117"/>
                  </a:lnTo>
                  <a:lnTo>
                    <a:pt x="1740" y="1117"/>
                  </a:lnTo>
                  <a:lnTo>
                    <a:pt x="1740" y="1116"/>
                  </a:lnTo>
                  <a:lnTo>
                    <a:pt x="1741" y="1116"/>
                  </a:lnTo>
                  <a:lnTo>
                    <a:pt x="1741" y="1115"/>
                  </a:lnTo>
                  <a:lnTo>
                    <a:pt x="1742" y="1115"/>
                  </a:lnTo>
                  <a:lnTo>
                    <a:pt x="1742" y="1114"/>
                  </a:lnTo>
                  <a:lnTo>
                    <a:pt x="1743" y="1114"/>
                  </a:lnTo>
                  <a:lnTo>
                    <a:pt x="1743" y="1113"/>
                  </a:lnTo>
                  <a:lnTo>
                    <a:pt x="1744" y="1112"/>
                  </a:lnTo>
                  <a:lnTo>
                    <a:pt x="1744" y="1111"/>
                  </a:lnTo>
                  <a:lnTo>
                    <a:pt x="1745" y="1111"/>
                  </a:lnTo>
                  <a:lnTo>
                    <a:pt x="1745" y="1110"/>
                  </a:lnTo>
                  <a:lnTo>
                    <a:pt x="1746" y="1109"/>
                  </a:lnTo>
                  <a:lnTo>
                    <a:pt x="1746" y="1108"/>
                  </a:lnTo>
                  <a:lnTo>
                    <a:pt x="1747" y="1107"/>
                  </a:lnTo>
                  <a:lnTo>
                    <a:pt x="1748" y="1106"/>
                  </a:lnTo>
                  <a:lnTo>
                    <a:pt x="1748" y="1105"/>
                  </a:lnTo>
                  <a:lnTo>
                    <a:pt x="1749" y="1105"/>
                  </a:lnTo>
                  <a:lnTo>
                    <a:pt x="1749" y="1104"/>
                  </a:lnTo>
                  <a:lnTo>
                    <a:pt x="1750" y="1104"/>
                  </a:lnTo>
                  <a:lnTo>
                    <a:pt x="1751" y="1104"/>
                  </a:lnTo>
                  <a:lnTo>
                    <a:pt x="1752" y="1104"/>
                  </a:lnTo>
                  <a:lnTo>
                    <a:pt x="1753" y="1104"/>
                  </a:lnTo>
                  <a:lnTo>
                    <a:pt x="1754" y="1105"/>
                  </a:lnTo>
                  <a:lnTo>
                    <a:pt x="1755" y="1106"/>
                  </a:lnTo>
                  <a:lnTo>
                    <a:pt x="1755" y="1107"/>
                  </a:lnTo>
                  <a:lnTo>
                    <a:pt x="1756" y="1107"/>
                  </a:lnTo>
                  <a:lnTo>
                    <a:pt x="1756" y="1108"/>
                  </a:lnTo>
                  <a:lnTo>
                    <a:pt x="1757" y="1109"/>
                  </a:lnTo>
                  <a:lnTo>
                    <a:pt x="1757" y="1110"/>
                  </a:lnTo>
                  <a:lnTo>
                    <a:pt x="1757" y="1111"/>
                  </a:lnTo>
                  <a:lnTo>
                    <a:pt x="1758" y="1113"/>
                  </a:lnTo>
                  <a:lnTo>
                    <a:pt x="1758" y="1114"/>
                  </a:lnTo>
                  <a:lnTo>
                    <a:pt x="1759" y="1116"/>
                  </a:lnTo>
                  <a:lnTo>
                    <a:pt x="1759" y="1117"/>
                  </a:lnTo>
                  <a:lnTo>
                    <a:pt x="1760" y="1119"/>
                  </a:lnTo>
                  <a:lnTo>
                    <a:pt x="1760" y="1121"/>
                  </a:lnTo>
                  <a:lnTo>
                    <a:pt x="1761" y="1123"/>
                  </a:lnTo>
                  <a:lnTo>
                    <a:pt x="1761" y="1125"/>
                  </a:lnTo>
                  <a:lnTo>
                    <a:pt x="1762" y="1128"/>
                  </a:lnTo>
                  <a:lnTo>
                    <a:pt x="1762" y="1130"/>
                  </a:lnTo>
                  <a:lnTo>
                    <a:pt x="1763" y="1132"/>
                  </a:lnTo>
                  <a:lnTo>
                    <a:pt x="1763" y="1135"/>
                  </a:lnTo>
                  <a:lnTo>
                    <a:pt x="1764" y="1137"/>
                  </a:lnTo>
                  <a:lnTo>
                    <a:pt x="1764" y="1140"/>
                  </a:lnTo>
                  <a:lnTo>
                    <a:pt x="1765" y="1143"/>
                  </a:lnTo>
                  <a:lnTo>
                    <a:pt x="1765" y="1145"/>
                  </a:lnTo>
                  <a:lnTo>
                    <a:pt x="1765" y="1148"/>
                  </a:lnTo>
                  <a:lnTo>
                    <a:pt x="1766" y="1151"/>
                  </a:lnTo>
                  <a:lnTo>
                    <a:pt x="1766" y="1154"/>
                  </a:lnTo>
                  <a:lnTo>
                    <a:pt x="1767" y="1156"/>
                  </a:lnTo>
                  <a:lnTo>
                    <a:pt x="1767" y="1159"/>
                  </a:lnTo>
                  <a:lnTo>
                    <a:pt x="1768" y="1162"/>
                  </a:lnTo>
                  <a:lnTo>
                    <a:pt x="1768" y="1164"/>
                  </a:lnTo>
                  <a:lnTo>
                    <a:pt x="1769" y="1167"/>
                  </a:lnTo>
                  <a:lnTo>
                    <a:pt x="1769" y="1170"/>
                  </a:lnTo>
                  <a:lnTo>
                    <a:pt x="1770" y="1172"/>
                  </a:lnTo>
                  <a:lnTo>
                    <a:pt x="1770" y="1174"/>
                  </a:lnTo>
                  <a:lnTo>
                    <a:pt x="1771" y="1177"/>
                  </a:lnTo>
                  <a:lnTo>
                    <a:pt x="1771" y="1179"/>
                  </a:lnTo>
                  <a:lnTo>
                    <a:pt x="1772" y="1181"/>
                  </a:lnTo>
                  <a:lnTo>
                    <a:pt x="1772" y="1183"/>
                  </a:lnTo>
                  <a:lnTo>
                    <a:pt x="1773" y="1185"/>
                  </a:lnTo>
                  <a:lnTo>
                    <a:pt x="1773" y="1186"/>
                  </a:lnTo>
                  <a:lnTo>
                    <a:pt x="1774" y="1188"/>
                  </a:lnTo>
                  <a:lnTo>
                    <a:pt x="1774" y="1189"/>
                  </a:lnTo>
                  <a:lnTo>
                    <a:pt x="1774" y="1191"/>
                  </a:lnTo>
                  <a:lnTo>
                    <a:pt x="1775" y="1192"/>
                  </a:lnTo>
                  <a:lnTo>
                    <a:pt x="1775" y="1193"/>
                  </a:lnTo>
                  <a:lnTo>
                    <a:pt x="1776" y="1194"/>
                  </a:lnTo>
                  <a:lnTo>
                    <a:pt x="1776" y="1196"/>
                  </a:lnTo>
                  <a:lnTo>
                    <a:pt x="1777" y="1197"/>
                  </a:lnTo>
                  <a:lnTo>
                    <a:pt x="1777" y="1198"/>
                  </a:lnTo>
                  <a:lnTo>
                    <a:pt x="1778" y="1198"/>
                  </a:lnTo>
                  <a:lnTo>
                    <a:pt x="1778" y="1199"/>
                  </a:lnTo>
                  <a:lnTo>
                    <a:pt x="1779" y="1200"/>
                  </a:lnTo>
                  <a:lnTo>
                    <a:pt x="1779" y="1201"/>
                  </a:lnTo>
                  <a:lnTo>
                    <a:pt x="1780" y="1202"/>
                  </a:lnTo>
                  <a:lnTo>
                    <a:pt x="1781" y="1203"/>
                  </a:lnTo>
                  <a:lnTo>
                    <a:pt x="1781" y="1204"/>
                  </a:lnTo>
                  <a:lnTo>
                    <a:pt x="1782" y="1204"/>
                  </a:lnTo>
                  <a:lnTo>
                    <a:pt x="1782" y="1205"/>
                  </a:lnTo>
                  <a:lnTo>
                    <a:pt x="1782" y="1206"/>
                  </a:lnTo>
                  <a:lnTo>
                    <a:pt x="1783" y="1206"/>
                  </a:lnTo>
                  <a:lnTo>
                    <a:pt x="1783" y="1207"/>
                  </a:lnTo>
                  <a:lnTo>
                    <a:pt x="1784" y="1208"/>
                  </a:lnTo>
                  <a:lnTo>
                    <a:pt x="1785" y="1209"/>
                  </a:lnTo>
                  <a:lnTo>
                    <a:pt x="1785" y="1210"/>
                  </a:lnTo>
                  <a:lnTo>
                    <a:pt x="1786" y="1211"/>
                  </a:lnTo>
                  <a:lnTo>
                    <a:pt x="1787" y="1212"/>
                  </a:lnTo>
                  <a:lnTo>
                    <a:pt x="1787" y="1213"/>
                  </a:lnTo>
                  <a:lnTo>
                    <a:pt x="1788" y="1214"/>
                  </a:lnTo>
                  <a:lnTo>
                    <a:pt x="1789" y="1215"/>
                  </a:lnTo>
                  <a:lnTo>
                    <a:pt x="1789" y="1216"/>
                  </a:lnTo>
                  <a:lnTo>
                    <a:pt x="1790" y="1216"/>
                  </a:lnTo>
                  <a:lnTo>
                    <a:pt x="1790" y="1217"/>
                  </a:lnTo>
                  <a:lnTo>
                    <a:pt x="1791" y="1218"/>
                  </a:lnTo>
                  <a:lnTo>
                    <a:pt x="1791" y="1219"/>
                  </a:lnTo>
                  <a:lnTo>
                    <a:pt x="1792" y="1219"/>
                  </a:lnTo>
                  <a:lnTo>
                    <a:pt x="1792" y="1220"/>
                  </a:lnTo>
                  <a:lnTo>
                    <a:pt x="1793" y="1220"/>
                  </a:lnTo>
                  <a:lnTo>
                    <a:pt x="1793" y="1221"/>
                  </a:lnTo>
                  <a:lnTo>
                    <a:pt x="1794" y="1221"/>
                  </a:lnTo>
                  <a:lnTo>
                    <a:pt x="1795" y="1222"/>
                  </a:lnTo>
                  <a:lnTo>
                    <a:pt x="1796" y="1222"/>
                  </a:lnTo>
                  <a:lnTo>
                    <a:pt x="1797" y="1222"/>
                  </a:lnTo>
                  <a:lnTo>
                    <a:pt x="1798" y="1221"/>
                  </a:lnTo>
                  <a:lnTo>
                    <a:pt x="1799" y="1221"/>
                  </a:lnTo>
                  <a:lnTo>
                    <a:pt x="1800" y="1220"/>
                  </a:lnTo>
                  <a:lnTo>
                    <a:pt x="1801" y="1220"/>
                  </a:lnTo>
                  <a:lnTo>
                    <a:pt x="1801" y="1219"/>
                  </a:lnTo>
                  <a:lnTo>
                    <a:pt x="1802" y="1219"/>
                  </a:lnTo>
                  <a:lnTo>
                    <a:pt x="1803" y="1219"/>
                  </a:lnTo>
                  <a:lnTo>
                    <a:pt x="1803" y="1218"/>
                  </a:lnTo>
                  <a:lnTo>
                    <a:pt x="1804" y="1218"/>
                  </a:lnTo>
                  <a:lnTo>
                    <a:pt x="1805" y="1218"/>
                  </a:lnTo>
                  <a:lnTo>
                    <a:pt x="1806" y="1218"/>
                  </a:lnTo>
                  <a:lnTo>
                    <a:pt x="1806" y="1217"/>
                  </a:lnTo>
                  <a:lnTo>
                    <a:pt x="1807" y="1217"/>
                  </a:lnTo>
                  <a:lnTo>
                    <a:pt x="1808" y="1217"/>
                  </a:lnTo>
                  <a:lnTo>
                    <a:pt x="1808" y="1218"/>
                  </a:lnTo>
                  <a:lnTo>
                    <a:pt x="1809" y="1218"/>
                  </a:lnTo>
                  <a:lnTo>
                    <a:pt x="1810" y="1218"/>
                  </a:lnTo>
                  <a:lnTo>
                    <a:pt x="1811" y="1219"/>
                  </a:lnTo>
                  <a:lnTo>
                    <a:pt x="1812" y="1219"/>
                  </a:lnTo>
                  <a:lnTo>
                    <a:pt x="1812" y="1220"/>
                  </a:lnTo>
                  <a:lnTo>
                    <a:pt x="1813" y="1220"/>
                  </a:lnTo>
                  <a:lnTo>
                    <a:pt x="1813" y="1221"/>
                  </a:lnTo>
                  <a:lnTo>
                    <a:pt x="1814" y="1221"/>
                  </a:lnTo>
                  <a:lnTo>
                    <a:pt x="1815" y="1222"/>
                  </a:lnTo>
                  <a:lnTo>
                    <a:pt x="1816" y="1223"/>
                  </a:lnTo>
                  <a:lnTo>
                    <a:pt x="1817" y="1224"/>
                  </a:lnTo>
                  <a:lnTo>
                    <a:pt x="1818" y="1224"/>
                  </a:lnTo>
                  <a:lnTo>
                    <a:pt x="1818" y="1225"/>
                  </a:lnTo>
                  <a:lnTo>
                    <a:pt x="1819" y="1225"/>
                  </a:lnTo>
                  <a:lnTo>
                    <a:pt x="1820" y="1226"/>
                  </a:lnTo>
                  <a:lnTo>
                    <a:pt x="1821" y="1226"/>
                  </a:lnTo>
                  <a:lnTo>
                    <a:pt x="1822" y="1226"/>
                  </a:lnTo>
                  <a:lnTo>
                    <a:pt x="1823" y="1226"/>
                  </a:lnTo>
                  <a:lnTo>
                    <a:pt x="1824" y="1226"/>
                  </a:lnTo>
                  <a:lnTo>
                    <a:pt x="1825" y="1225"/>
                  </a:lnTo>
                  <a:lnTo>
                    <a:pt x="1826" y="1224"/>
                  </a:lnTo>
                  <a:lnTo>
                    <a:pt x="1826" y="1223"/>
                  </a:lnTo>
                  <a:lnTo>
                    <a:pt x="1827" y="1222"/>
                  </a:lnTo>
                  <a:lnTo>
                    <a:pt x="1828" y="1220"/>
                  </a:lnTo>
                  <a:lnTo>
                    <a:pt x="1828" y="1219"/>
                  </a:lnTo>
                  <a:lnTo>
                    <a:pt x="1829" y="1218"/>
                  </a:lnTo>
                  <a:lnTo>
                    <a:pt x="1829" y="1217"/>
                  </a:lnTo>
                  <a:lnTo>
                    <a:pt x="1830" y="1215"/>
                  </a:lnTo>
                  <a:lnTo>
                    <a:pt x="1830" y="1213"/>
                  </a:lnTo>
                  <a:lnTo>
                    <a:pt x="1831" y="1211"/>
                  </a:lnTo>
                  <a:lnTo>
                    <a:pt x="1831" y="1209"/>
                  </a:lnTo>
                  <a:lnTo>
                    <a:pt x="1832" y="1206"/>
                  </a:lnTo>
                  <a:lnTo>
                    <a:pt x="1832" y="1203"/>
                  </a:lnTo>
                  <a:lnTo>
                    <a:pt x="1833" y="1201"/>
                  </a:lnTo>
                  <a:lnTo>
                    <a:pt x="1833" y="1198"/>
                  </a:lnTo>
                  <a:lnTo>
                    <a:pt x="1834" y="1195"/>
                  </a:lnTo>
                  <a:lnTo>
                    <a:pt x="1834" y="1192"/>
                  </a:lnTo>
                  <a:lnTo>
                    <a:pt x="1834" y="1188"/>
                  </a:lnTo>
                  <a:lnTo>
                    <a:pt x="1835" y="1185"/>
                  </a:lnTo>
                  <a:lnTo>
                    <a:pt x="1835" y="1182"/>
                  </a:lnTo>
                  <a:lnTo>
                    <a:pt x="1836" y="1179"/>
                  </a:lnTo>
                  <a:lnTo>
                    <a:pt x="1836" y="1176"/>
                  </a:lnTo>
                  <a:lnTo>
                    <a:pt x="1837" y="1173"/>
                  </a:lnTo>
                  <a:lnTo>
                    <a:pt x="1837" y="1170"/>
                  </a:lnTo>
                  <a:lnTo>
                    <a:pt x="1838" y="1168"/>
                  </a:lnTo>
                  <a:lnTo>
                    <a:pt x="1838" y="1165"/>
                  </a:lnTo>
                  <a:lnTo>
                    <a:pt x="1839" y="1162"/>
                  </a:lnTo>
                  <a:lnTo>
                    <a:pt x="1839" y="1160"/>
                  </a:lnTo>
                  <a:lnTo>
                    <a:pt x="1840" y="1158"/>
                  </a:lnTo>
                  <a:lnTo>
                    <a:pt x="1840" y="1156"/>
                  </a:lnTo>
                  <a:lnTo>
                    <a:pt x="1841" y="1154"/>
                  </a:lnTo>
                  <a:lnTo>
                    <a:pt x="1841" y="1153"/>
                  </a:lnTo>
                  <a:lnTo>
                    <a:pt x="1842" y="1151"/>
                  </a:lnTo>
                  <a:lnTo>
                    <a:pt x="1842" y="1150"/>
                  </a:lnTo>
                  <a:lnTo>
                    <a:pt x="1842" y="1149"/>
                  </a:lnTo>
                  <a:lnTo>
                    <a:pt x="1843" y="1149"/>
                  </a:lnTo>
                  <a:lnTo>
                    <a:pt x="1843" y="1150"/>
                  </a:lnTo>
                  <a:lnTo>
                    <a:pt x="1844" y="1150"/>
                  </a:lnTo>
                  <a:lnTo>
                    <a:pt x="1844" y="1151"/>
                  </a:lnTo>
                  <a:lnTo>
                    <a:pt x="1845" y="1152"/>
                  </a:lnTo>
                  <a:lnTo>
                    <a:pt x="1845" y="1153"/>
                  </a:lnTo>
                  <a:lnTo>
                    <a:pt x="1846" y="1154"/>
                  </a:lnTo>
                  <a:lnTo>
                    <a:pt x="1846" y="1155"/>
                  </a:lnTo>
                  <a:lnTo>
                    <a:pt x="1847" y="1157"/>
                  </a:lnTo>
                  <a:lnTo>
                    <a:pt x="1847" y="1158"/>
                  </a:lnTo>
                  <a:lnTo>
                    <a:pt x="1848" y="1160"/>
                  </a:lnTo>
                  <a:lnTo>
                    <a:pt x="1848" y="1161"/>
                  </a:lnTo>
                  <a:lnTo>
                    <a:pt x="1849" y="1163"/>
                  </a:lnTo>
                  <a:lnTo>
                    <a:pt x="1849" y="1164"/>
                  </a:lnTo>
                  <a:lnTo>
                    <a:pt x="1850" y="1165"/>
                  </a:lnTo>
                  <a:lnTo>
                    <a:pt x="1850" y="1167"/>
                  </a:lnTo>
                  <a:lnTo>
                    <a:pt x="1851" y="1168"/>
                  </a:lnTo>
                  <a:lnTo>
                    <a:pt x="1851" y="1169"/>
                  </a:lnTo>
                  <a:lnTo>
                    <a:pt x="1852" y="1170"/>
                  </a:lnTo>
                  <a:lnTo>
                    <a:pt x="1853" y="1170"/>
                  </a:lnTo>
                  <a:lnTo>
                    <a:pt x="1853" y="1169"/>
                  </a:lnTo>
                  <a:lnTo>
                    <a:pt x="1854" y="1169"/>
                  </a:lnTo>
                  <a:lnTo>
                    <a:pt x="1854" y="1168"/>
                  </a:lnTo>
                  <a:lnTo>
                    <a:pt x="1855" y="1166"/>
                  </a:lnTo>
                  <a:lnTo>
                    <a:pt x="1855" y="1164"/>
                  </a:lnTo>
                  <a:lnTo>
                    <a:pt x="1856" y="1161"/>
                  </a:lnTo>
                  <a:lnTo>
                    <a:pt x="1856" y="1158"/>
                  </a:lnTo>
                  <a:lnTo>
                    <a:pt x="1857" y="1155"/>
                  </a:lnTo>
                  <a:lnTo>
                    <a:pt x="1857" y="1152"/>
                  </a:lnTo>
                  <a:lnTo>
                    <a:pt x="1858" y="1148"/>
                  </a:lnTo>
                  <a:lnTo>
                    <a:pt x="1858" y="1144"/>
                  </a:lnTo>
                  <a:lnTo>
                    <a:pt x="1859" y="1140"/>
                  </a:lnTo>
                  <a:lnTo>
                    <a:pt x="1859" y="1136"/>
                  </a:lnTo>
                  <a:lnTo>
                    <a:pt x="1859" y="1131"/>
                  </a:lnTo>
                  <a:lnTo>
                    <a:pt x="1860" y="1127"/>
                  </a:lnTo>
                  <a:lnTo>
                    <a:pt x="1860" y="1122"/>
                  </a:lnTo>
                  <a:lnTo>
                    <a:pt x="1861" y="1117"/>
                  </a:lnTo>
                  <a:lnTo>
                    <a:pt x="1861" y="1112"/>
                  </a:lnTo>
                  <a:lnTo>
                    <a:pt x="1862" y="1107"/>
                  </a:lnTo>
                  <a:lnTo>
                    <a:pt x="1862" y="1102"/>
                  </a:lnTo>
                  <a:lnTo>
                    <a:pt x="1863" y="1096"/>
                  </a:lnTo>
                  <a:lnTo>
                    <a:pt x="1863" y="1091"/>
                  </a:lnTo>
                  <a:lnTo>
                    <a:pt x="1864" y="1086"/>
                  </a:lnTo>
                  <a:lnTo>
                    <a:pt x="1864" y="1080"/>
                  </a:lnTo>
                  <a:lnTo>
                    <a:pt x="1865" y="1075"/>
                  </a:lnTo>
                  <a:lnTo>
                    <a:pt x="1865" y="1070"/>
                  </a:lnTo>
                  <a:lnTo>
                    <a:pt x="1866" y="1065"/>
                  </a:lnTo>
                  <a:lnTo>
                    <a:pt x="1866" y="1060"/>
                  </a:lnTo>
                  <a:lnTo>
                    <a:pt x="1867" y="1055"/>
                  </a:lnTo>
                  <a:lnTo>
                    <a:pt x="1867" y="1051"/>
                  </a:lnTo>
                  <a:lnTo>
                    <a:pt x="1868" y="1046"/>
                  </a:lnTo>
                  <a:lnTo>
                    <a:pt x="1868" y="1042"/>
                  </a:lnTo>
                  <a:lnTo>
                    <a:pt x="1868" y="1038"/>
                  </a:lnTo>
                  <a:lnTo>
                    <a:pt x="1869" y="1034"/>
                  </a:lnTo>
                  <a:lnTo>
                    <a:pt x="1869" y="1030"/>
                  </a:lnTo>
                  <a:lnTo>
                    <a:pt x="1870" y="1027"/>
                  </a:lnTo>
                  <a:lnTo>
                    <a:pt x="1870" y="1024"/>
                  </a:lnTo>
                  <a:lnTo>
                    <a:pt x="1871" y="1021"/>
                  </a:lnTo>
                  <a:lnTo>
                    <a:pt x="1871" y="1018"/>
                  </a:lnTo>
                  <a:lnTo>
                    <a:pt x="1872" y="1016"/>
                  </a:lnTo>
                  <a:lnTo>
                    <a:pt x="1872" y="1014"/>
                  </a:lnTo>
                  <a:lnTo>
                    <a:pt x="1873" y="1012"/>
                  </a:lnTo>
                  <a:lnTo>
                    <a:pt x="1873" y="1010"/>
                  </a:lnTo>
                  <a:lnTo>
                    <a:pt x="1874" y="1009"/>
                  </a:lnTo>
                  <a:lnTo>
                    <a:pt x="1874" y="1008"/>
                  </a:lnTo>
                  <a:lnTo>
                    <a:pt x="1875" y="1008"/>
                  </a:lnTo>
                  <a:lnTo>
                    <a:pt x="1876" y="1008"/>
                  </a:lnTo>
                  <a:lnTo>
                    <a:pt x="1876" y="1009"/>
                  </a:lnTo>
                  <a:lnTo>
                    <a:pt x="1876" y="1010"/>
                  </a:lnTo>
                  <a:lnTo>
                    <a:pt x="1877" y="1011"/>
                  </a:lnTo>
                  <a:lnTo>
                    <a:pt x="1877" y="1014"/>
                  </a:lnTo>
                  <a:lnTo>
                    <a:pt x="1878" y="1016"/>
                  </a:lnTo>
                  <a:lnTo>
                    <a:pt x="1878" y="1020"/>
                  </a:lnTo>
                  <a:lnTo>
                    <a:pt x="1879" y="1024"/>
                  </a:lnTo>
                  <a:lnTo>
                    <a:pt x="1879" y="1028"/>
                  </a:lnTo>
                  <a:lnTo>
                    <a:pt x="1880" y="1033"/>
                  </a:lnTo>
                  <a:lnTo>
                    <a:pt x="1880" y="1038"/>
                  </a:lnTo>
                  <a:lnTo>
                    <a:pt x="1881" y="1043"/>
                  </a:lnTo>
                  <a:lnTo>
                    <a:pt x="1881" y="1049"/>
                  </a:lnTo>
                  <a:lnTo>
                    <a:pt x="1882" y="1055"/>
                  </a:lnTo>
                  <a:lnTo>
                    <a:pt x="1882" y="1061"/>
                  </a:lnTo>
                  <a:lnTo>
                    <a:pt x="1883" y="1067"/>
                  </a:lnTo>
                  <a:lnTo>
                    <a:pt x="1883" y="1074"/>
                  </a:lnTo>
                  <a:lnTo>
                    <a:pt x="1884" y="1080"/>
                  </a:lnTo>
                  <a:lnTo>
                    <a:pt x="1884" y="1087"/>
                  </a:lnTo>
                  <a:lnTo>
                    <a:pt x="1885" y="1093"/>
                  </a:lnTo>
                  <a:lnTo>
                    <a:pt x="1885" y="1100"/>
                  </a:lnTo>
                  <a:lnTo>
                    <a:pt x="1885" y="1107"/>
                  </a:lnTo>
                  <a:lnTo>
                    <a:pt x="1886" y="1113"/>
                  </a:lnTo>
                  <a:lnTo>
                    <a:pt x="1886" y="1120"/>
                  </a:lnTo>
                  <a:lnTo>
                    <a:pt x="1887" y="1126"/>
                  </a:lnTo>
                  <a:lnTo>
                    <a:pt x="1887" y="1132"/>
                  </a:lnTo>
                  <a:lnTo>
                    <a:pt x="1888" y="1138"/>
                  </a:lnTo>
                  <a:lnTo>
                    <a:pt x="1888" y="1143"/>
                  </a:lnTo>
                  <a:lnTo>
                    <a:pt x="1889" y="1149"/>
                  </a:lnTo>
                  <a:lnTo>
                    <a:pt x="1889" y="1154"/>
                  </a:lnTo>
                  <a:lnTo>
                    <a:pt x="1890" y="1158"/>
                  </a:lnTo>
                  <a:lnTo>
                    <a:pt x="1890" y="1162"/>
                  </a:lnTo>
                  <a:lnTo>
                    <a:pt x="1891" y="1166"/>
                  </a:lnTo>
                  <a:lnTo>
                    <a:pt x="1891" y="1169"/>
                  </a:lnTo>
                  <a:lnTo>
                    <a:pt x="1892" y="1172"/>
                  </a:lnTo>
                  <a:lnTo>
                    <a:pt x="1892" y="1174"/>
                  </a:lnTo>
                  <a:lnTo>
                    <a:pt x="1893" y="1177"/>
                  </a:lnTo>
                  <a:lnTo>
                    <a:pt x="1893" y="1178"/>
                  </a:lnTo>
                  <a:lnTo>
                    <a:pt x="1893" y="1180"/>
                  </a:lnTo>
                  <a:lnTo>
                    <a:pt x="1894" y="1181"/>
                  </a:lnTo>
                  <a:lnTo>
                    <a:pt x="1894" y="1182"/>
                  </a:lnTo>
                  <a:lnTo>
                    <a:pt x="1895" y="1183"/>
                  </a:lnTo>
                  <a:lnTo>
                    <a:pt x="1895" y="1184"/>
                  </a:lnTo>
                  <a:lnTo>
                    <a:pt x="1896" y="1184"/>
                  </a:lnTo>
                  <a:lnTo>
                    <a:pt x="1897" y="1184"/>
                  </a:lnTo>
                  <a:lnTo>
                    <a:pt x="1898" y="1183"/>
                  </a:lnTo>
                  <a:lnTo>
                    <a:pt x="1899" y="1182"/>
                  </a:lnTo>
                  <a:lnTo>
                    <a:pt x="1899" y="1181"/>
                  </a:lnTo>
                  <a:lnTo>
                    <a:pt x="1900" y="1180"/>
                  </a:lnTo>
                  <a:lnTo>
                    <a:pt x="1900" y="1179"/>
                  </a:lnTo>
                  <a:lnTo>
                    <a:pt x="1901" y="1178"/>
                  </a:lnTo>
                  <a:lnTo>
                    <a:pt x="1901" y="1176"/>
                  </a:lnTo>
                  <a:lnTo>
                    <a:pt x="1902" y="1175"/>
                  </a:lnTo>
                  <a:lnTo>
                    <a:pt x="1902" y="1174"/>
                  </a:lnTo>
                  <a:lnTo>
                    <a:pt x="1902" y="1173"/>
                  </a:lnTo>
                  <a:lnTo>
                    <a:pt x="1903" y="1172"/>
                  </a:lnTo>
                  <a:lnTo>
                    <a:pt x="1903" y="1171"/>
                  </a:lnTo>
                  <a:lnTo>
                    <a:pt x="1904" y="1170"/>
                  </a:lnTo>
                  <a:lnTo>
                    <a:pt x="1904" y="1169"/>
                  </a:lnTo>
                  <a:lnTo>
                    <a:pt x="1905" y="1168"/>
                  </a:lnTo>
                  <a:lnTo>
                    <a:pt x="1905" y="1166"/>
                  </a:lnTo>
                  <a:lnTo>
                    <a:pt x="1906" y="1165"/>
                  </a:lnTo>
                  <a:lnTo>
                    <a:pt x="1906" y="1164"/>
                  </a:lnTo>
                  <a:lnTo>
                    <a:pt x="1907" y="1163"/>
                  </a:lnTo>
                  <a:lnTo>
                    <a:pt x="1907" y="1162"/>
                  </a:lnTo>
                  <a:lnTo>
                    <a:pt x="1908" y="1160"/>
                  </a:lnTo>
                  <a:lnTo>
                    <a:pt x="1908" y="1159"/>
                  </a:lnTo>
                  <a:lnTo>
                    <a:pt x="1909" y="1158"/>
                  </a:lnTo>
                  <a:lnTo>
                    <a:pt x="1909" y="1157"/>
                  </a:lnTo>
                  <a:lnTo>
                    <a:pt x="1910" y="1156"/>
                  </a:lnTo>
                  <a:lnTo>
                    <a:pt x="1910" y="1155"/>
                  </a:lnTo>
                  <a:lnTo>
                    <a:pt x="1911" y="1154"/>
                  </a:lnTo>
                  <a:lnTo>
                    <a:pt x="1911" y="1152"/>
                  </a:lnTo>
                  <a:lnTo>
                    <a:pt x="1911" y="1151"/>
                  </a:lnTo>
                  <a:lnTo>
                    <a:pt x="1912" y="1150"/>
                  </a:lnTo>
                  <a:lnTo>
                    <a:pt x="1913" y="1149"/>
                  </a:lnTo>
                  <a:lnTo>
                    <a:pt x="1913" y="1148"/>
                  </a:lnTo>
                  <a:lnTo>
                    <a:pt x="1914" y="1147"/>
                  </a:lnTo>
                  <a:lnTo>
                    <a:pt x="1914" y="1146"/>
                  </a:lnTo>
                  <a:lnTo>
                    <a:pt x="1915" y="1145"/>
                  </a:lnTo>
                  <a:lnTo>
                    <a:pt x="1915" y="1144"/>
                  </a:lnTo>
                  <a:lnTo>
                    <a:pt x="1916" y="1143"/>
                  </a:lnTo>
                  <a:lnTo>
                    <a:pt x="1916" y="1142"/>
                  </a:lnTo>
                  <a:lnTo>
                    <a:pt x="1917" y="1142"/>
                  </a:lnTo>
                  <a:lnTo>
                    <a:pt x="1917" y="1141"/>
                  </a:lnTo>
                  <a:lnTo>
                    <a:pt x="1918" y="1141"/>
                  </a:lnTo>
                  <a:lnTo>
                    <a:pt x="1919" y="1141"/>
                  </a:lnTo>
                  <a:lnTo>
                    <a:pt x="1920" y="1141"/>
                  </a:lnTo>
                  <a:lnTo>
                    <a:pt x="1921" y="1142"/>
                  </a:lnTo>
                  <a:lnTo>
                    <a:pt x="1922" y="1143"/>
                  </a:lnTo>
                  <a:lnTo>
                    <a:pt x="1922" y="1144"/>
                  </a:lnTo>
                  <a:lnTo>
                    <a:pt x="1923" y="1145"/>
                  </a:lnTo>
                  <a:lnTo>
                    <a:pt x="1923" y="1147"/>
                  </a:lnTo>
                  <a:lnTo>
                    <a:pt x="1924" y="1148"/>
                  </a:lnTo>
                  <a:lnTo>
                    <a:pt x="1924" y="1150"/>
                  </a:lnTo>
                  <a:lnTo>
                    <a:pt x="1925" y="1152"/>
                  </a:lnTo>
                  <a:lnTo>
                    <a:pt x="1925" y="1154"/>
                  </a:lnTo>
                  <a:lnTo>
                    <a:pt x="1926" y="1156"/>
                  </a:lnTo>
                  <a:lnTo>
                    <a:pt x="1926" y="1159"/>
                  </a:lnTo>
                  <a:lnTo>
                    <a:pt x="1927" y="1162"/>
                  </a:lnTo>
                  <a:lnTo>
                    <a:pt x="1927" y="1165"/>
                  </a:lnTo>
                  <a:lnTo>
                    <a:pt x="1928" y="1168"/>
                  </a:lnTo>
                  <a:lnTo>
                    <a:pt x="1928" y="1171"/>
                  </a:lnTo>
                  <a:lnTo>
                    <a:pt x="1928" y="1175"/>
                  </a:lnTo>
                  <a:lnTo>
                    <a:pt x="1929" y="1178"/>
                  </a:lnTo>
                  <a:lnTo>
                    <a:pt x="1929" y="1182"/>
                  </a:lnTo>
                  <a:lnTo>
                    <a:pt x="1930" y="1186"/>
                  </a:lnTo>
                  <a:lnTo>
                    <a:pt x="1930" y="1189"/>
                  </a:lnTo>
                  <a:lnTo>
                    <a:pt x="1931" y="1193"/>
                  </a:lnTo>
                  <a:lnTo>
                    <a:pt x="1931" y="1197"/>
                  </a:lnTo>
                  <a:lnTo>
                    <a:pt x="1932" y="1200"/>
                  </a:lnTo>
                  <a:lnTo>
                    <a:pt x="1932" y="1204"/>
                  </a:lnTo>
                  <a:lnTo>
                    <a:pt x="1933" y="1208"/>
                  </a:lnTo>
                  <a:lnTo>
                    <a:pt x="1933" y="1212"/>
                  </a:lnTo>
                  <a:lnTo>
                    <a:pt x="1934" y="1215"/>
                  </a:lnTo>
                  <a:lnTo>
                    <a:pt x="1934" y="1219"/>
                  </a:lnTo>
                  <a:lnTo>
                    <a:pt x="1935" y="1222"/>
                  </a:lnTo>
                  <a:lnTo>
                    <a:pt x="1935" y="1225"/>
                  </a:lnTo>
                  <a:lnTo>
                    <a:pt x="1936" y="1229"/>
                  </a:lnTo>
                  <a:lnTo>
                    <a:pt x="1936" y="1232"/>
                  </a:lnTo>
                  <a:lnTo>
                    <a:pt x="1936" y="1234"/>
                  </a:lnTo>
                  <a:lnTo>
                    <a:pt x="1937" y="1237"/>
                  </a:lnTo>
                  <a:lnTo>
                    <a:pt x="1937" y="1239"/>
                  </a:lnTo>
                  <a:lnTo>
                    <a:pt x="1938" y="1242"/>
                  </a:lnTo>
                  <a:lnTo>
                    <a:pt x="1938" y="1243"/>
                  </a:lnTo>
                  <a:lnTo>
                    <a:pt x="1939" y="1245"/>
                  </a:lnTo>
                  <a:lnTo>
                    <a:pt x="1939" y="1247"/>
                  </a:lnTo>
                  <a:lnTo>
                    <a:pt x="1940" y="1248"/>
                  </a:lnTo>
                  <a:lnTo>
                    <a:pt x="1940" y="1250"/>
                  </a:lnTo>
                  <a:lnTo>
                    <a:pt x="1941" y="1251"/>
                  </a:lnTo>
                  <a:lnTo>
                    <a:pt x="1941" y="1252"/>
                  </a:lnTo>
                  <a:lnTo>
                    <a:pt x="1942" y="1253"/>
                  </a:lnTo>
                  <a:lnTo>
                    <a:pt x="1942" y="1254"/>
                  </a:lnTo>
                  <a:lnTo>
                    <a:pt x="1943" y="1254"/>
                  </a:lnTo>
                  <a:lnTo>
                    <a:pt x="1943" y="1255"/>
                  </a:lnTo>
                  <a:lnTo>
                    <a:pt x="1944" y="1255"/>
                  </a:lnTo>
                  <a:lnTo>
                    <a:pt x="1944" y="1256"/>
                  </a:lnTo>
                  <a:lnTo>
                    <a:pt x="1945" y="1256"/>
                  </a:lnTo>
                  <a:lnTo>
                    <a:pt x="1945" y="1257"/>
                  </a:lnTo>
                  <a:lnTo>
                    <a:pt x="1946" y="1257"/>
                  </a:lnTo>
                  <a:lnTo>
                    <a:pt x="1947" y="1257"/>
                  </a:lnTo>
                  <a:lnTo>
                    <a:pt x="1948" y="1257"/>
                  </a:lnTo>
                  <a:lnTo>
                    <a:pt x="1949" y="1257"/>
                  </a:lnTo>
                  <a:lnTo>
                    <a:pt x="1950" y="1257"/>
                  </a:lnTo>
                  <a:lnTo>
                    <a:pt x="1951" y="1257"/>
                  </a:lnTo>
                  <a:lnTo>
                    <a:pt x="1952" y="1257"/>
                  </a:lnTo>
                  <a:lnTo>
                    <a:pt x="1953" y="1257"/>
                  </a:lnTo>
                  <a:lnTo>
                    <a:pt x="1954" y="1257"/>
                  </a:lnTo>
                  <a:lnTo>
                    <a:pt x="1955" y="1257"/>
                  </a:lnTo>
                  <a:lnTo>
                    <a:pt x="1956" y="1257"/>
                  </a:lnTo>
                  <a:lnTo>
                    <a:pt x="1957" y="1257"/>
                  </a:lnTo>
                  <a:lnTo>
                    <a:pt x="1958" y="1257"/>
                  </a:lnTo>
                  <a:lnTo>
                    <a:pt x="1959" y="1257"/>
                  </a:lnTo>
                  <a:lnTo>
                    <a:pt x="1960" y="1257"/>
                  </a:lnTo>
                  <a:lnTo>
                    <a:pt x="1961" y="1257"/>
                  </a:lnTo>
                  <a:lnTo>
                    <a:pt x="1962" y="1257"/>
                  </a:lnTo>
                  <a:lnTo>
                    <a:pt x="1963" y="1257"/>
                  </a:lnTo>
                  <a:lnTo>
                    <a:pt x="1964" y="1257"/>
                  </a:lnTo>
                  <a:lnTo>
                    <a:pt x="1965" y="1257"/>
                  </a:lnTo>
                  <a:lnTo>
                    <a:pt x="1966" y="1257"/>
                  </a:lnTo>
                  <a:lnTo>
                    <a:pt x="1967" y="1257"/>
                  </a:lnTo>
                  <a:lnTo>
                    <a:pt x="1968" y="1257"/>
                  </a:lnTo>
                  <a:lnTo>
                    <a:pt x="1969" y="1256"/>
                  </a:lnTo>
                  <a:lnTo>
                    <a:pt x="1970" y="1256"/>
                  </a:lnTo>
                  <a:lnTo>
                    <a:pt x="1971" y="1255"/>
                  </a:lnTo>
                  <a:lnTo>
                    <a:pt x="1972" y="1254"/>
                  </a:lnTo>
                  <a:lnTo>
                    <a:pt x="1973" y="1253"/>
                  </a:lnTo>
                  <a:lnTo>
                    <a:pt x="1973" y="1252"/>
                  </a:lnTo>
                  <a:lnTo>
                    <a:pt x="1974" y="1252"/>
                  </a:lnTo>
                  <a:lnTo>
                    <a:pt x="1974" y="1251"/>
                  </a:lnTo>
                  <a:lnTo>
                    <a:pt x="1975" y="1250"/>
                  </a:lnTo>
                  <a:lnTo>
                    <a:pt x="1975" y="1249"/>
                  </a:lnTo>
                  <a:lnTo>
                    <a:pt x="1976" y="1248"/>
                  </a:lnTo>
                  <a:lnTo>
                    <a:pt x="1976" y="1247"/>
                  </a:lnTo>
                  <a:lnTo>
                    <a:pt x="1977" y="1246"/>
                  </a:lnTo>
                  <a:lnTo>
                    <a:pt x="1977" y="1245"/>
                  </a:lnTo>
                  <a:lnTo>
                    <a:pt x="1978" y="1244"/>
                  </a:lnTo>
                  <a:lnTo>
                    <a:pt x="1978" y="1243"/>
                  </a:lnTo>
                  <a:lnTo>
                    <a:pt x="1979" y="1242"/>
                  </a:lnTo>
                  <a:lnTo>
                    <a:pt x="1979" y="1241"/>
                  </a:lnTo>
                  <a:lnTo>
                    <a:pt x="1980" y="1240"/>
                  </a:lnTo>
                  <a:lnTo>
                    <a:pt x="1980" y="1239"/>
                  </a:lnTo>
                  <a:lnTo>
                    <a:pt x="1981" y="1238"/>
                  </a:lnTo>
                  <a:lnTo>
                    <a:pt x="1981" y="1237"/>
                  </a:lnTo>
                  <a:lnTo>
                    <a:pt x="1982" y="1237"/>
                  </a:lnTo>
                  <a:lnTo>
                    <a:pt x="1982" y="1236"/>
                  </a:lnTo>
                  <a:lnTo>
                    <a:pt x="1983" y="1235"/>
                  </a:lnTo>
                  <a:lnTo>
                    <a:pt x="1984" y="1234"/>
                  </a:lnTo>
                  <a:lnTo>
                    <a:pt x="1985" y="1234"/>
                  </a:lnTo>
                  <a:lnTo>
                    <a:pt x="1986" y="1234"/>
                  </a:lnTo>
                  <a:lnTo>
                    <a:pt x="1987" y="1234"/>
                  </a:lnTo>
                  <a:lnTo>
                    <a:pt x="1987" y="1235"/>
                  </a:lnTo>
                  <a:lnTo>
                    <a:pt x="1988" y="1235"/>
                  </a:lnTo>
                  <a:lnTo>
                    <a:pt x="1988" y="1236"/>
                  </a:lnTo>
                  <a:lnTo>
                    <a:pt x="1989" y="1236"/>
                  </a:lnTo>
                  <a:lnTo>
                    <a:pt x="1990" y="1237"/>
                  </a:lnTo>
                  <a:lnTo>
                    <a:pt x="1991" y="1238"/>
                  </a:lnTo>
                  <a:lnTo>
                    <a:pt x="1992" y="1239"/>
                  </a:lnTo>
                  <a:lnTo>
                    <a:pt x="1993" y="1240"/>
                  </a:lnTo>
                  <a:lnTo>
                    <a:pt x="1994" y="1240"/>
                  </a:lnTo>
                  <a:lnTo>
                    <a:pt x="1994" y="1241"/>
                  </a:lnTo>
                  <a:lnTo>
                    <a:pt x="1995" y="1241"/>
                  </a:lnTo>
                  <a:lnTo>
                    <a:pt x="1996" y="1242"/>
                  </a:lnTo>
                  <a:lnTo>
                    <a:pt x="1997" y="1242"/>
                  </a:lnTo>
                  <a:lnTo>
                    <a:pt x="1997" y="1241"/>
                  </a:lnTo>
                  <a:lnTo>
                    <a:pt x="1998" y="1241"/>
                  </a:lnTo>
                  <a:lnTo>
                    <a:pt x="1999" y="1241"/>
                  </a:lnTo>
                  <a:lnTo>
                    <a:pt x="1999" y="1240"/>
                  </a:lnTo>
                  <a:lnTo>
                    <a:pt x="2000" y="1240"/>
                  </a:lnTo>
                  <a:lnTo>
                    <a:pt x="2001" y="1239"/>
                  </a:lnTo>
                  <a:lnTo>
                    <a:pt x="2002" y="1239"/>
                  </a:lnTo>
                  <a:lnTo>
                    <a:pt x="2002" y="1238"/>
                  </a:lnTo>
                  <a:lnTo>
                    <a:pt x="2003" y="1238"/>
                  </a:lnTo>
                  <a:lnTo>
                    <a:pt x="2004" y="1237"/>
                  </a:lnTo>
                  <a:lnTo>
                    <a:pt x="2005" y="1237"/>
                  </a:lnTo>
                  <a:lnTo>
                    <a:pt x="2005" y="1236"/>
                  </a:lnTo>
                  <a:lnTo>
                    <a:pt x="2006" y="1236"/>
                  </a:lnTo>
                  <a:lnTo>
                    <a:pt x="2007" y="1236"/>
                  </a:lnTo>
                  <a:lnTo>
                    <a:pt x="2008" y="1236"/>
                  </a:lnTo>
                  <a:lnTo>
                    <a:pt x="2009" y="1236"/>
                  </a:lnTo>
                  <a:lnTo>
                    <a:pt x="2009" y="1237"/>
                  </a:lnTo>
                  <a:lnTo>
                    <a:pt x="2010" y="1237"/>
                  </a:lnTo>
                  <a:lnTo>
                    <a:pt x="2010" y="1238"/>
                  </a:lnTo>
                  <a:lnTo>
                    <a:pt x="2011" y="1238"/>
                  </a:lnTo>
                  <a:lnTo>
                    <a:pt x="2011" y="1239"/>
                  </a:lnTo>
                  <a:lnTo>
                    <a:pt x="2012" y="1239"/>
                  </a:lnTo>
                  <a:lnTo>
                    <a:pt x="2012" y="1240"/>
                  </a:lnTo>
                  <a:lnTo>
                    <a:pt x="2013" y="1241"/>
                  </a:lnTo>
                  <a:lnTo>
                    <a:pt x="2013" y="1242"/>
                  </a:lnTo>
                  <a:lnTo>
                    <a:pt x="2014" y="1243"/>
                  </a:lnTo>
                  <a:lnTo>
                    <a:pt x="2015" y="1244"/>
                  </a:lnTo>
                  <a:lnTo>
                    <a:pt x="2015" y="1245"/>
                  </a:lnTo>
                  <a:lnTo>
                    <a:pt x="2016" y="1245"/>
                  </a:lnTo>
                  <a:lnTo>
                    <a:pt x="2016" y="1246"/>
                  </a:lnTo>
                  <a:lnTo>
                    <a:pt x="2017" y="1246"/>
                  </a:lnTo>
                  <a:lnTo>
                    <a:pt x="2017" y="1247"/>
                  </a:lnTo>
                  <a:lnTo>
                    <a:pt x="2018" y="1248"/>
                  </a:lnTo>
                  <a:lnTo>
                    <a:pt x="2019" y="1249"/>
                  </a:lnTo>
                  <a:lnTo>
                    <a:pt x="2020" y="1249"/>
                  </a:lnTo>
                  <a:lnTo>
                    <a:pt x="2021" y="1250"/>
                  </a:lnTo>
                  <a:lnTo>
                    <a:pt x="2022" y="1250"/>
                  </a:lnTo>
                  <a:lnTo>
                    <a:pt x="2023" y="1249"/>
                  </a:lnTo>
                  <a:lnTo>
                    <a:pt x="2024" y="1249"/>
                  </a:lnTo>
                  <a:lnTo>
                    <a:pt x="2025" y="1249"/>
                  </a:lnTo>
                  <a:lnTo>
                    <a:pt x="2026" y="1248"/>
                  </a:lnTo>
                  <a:lnTo>
                    <a:pt x="2027" y="1248"/>
                  </a:lnTo>
                  <a:lnTo>
                    <a:pt x="2028" y="1247"/>
                  </a:lnTo>
                  <a:lnTo>
                    <a:pt x="2029" y="1247"/>
                  </a:lnTo>
                  <a:lnTo>
                    <a:pt x="2030" y="1247"/>
                  </a:lnTo>
                  <a:lnTo>
                    <a:pt x="2030" y="1246"/>
                  </a:lnTo>
                  <a:lnTo>
                    <a:pt x="2031" y="1246"/>
                  </a:lnTo>
                  <a:lnTo>
                    <a:pt x="2032" y="1246"/>
                  </a:lnTo>
                  <a:lnTo>
                    <a:pt x="2033" y="1246"/>
                  </a:lnTo>
                  <a:lnTo>
                    <a:pt x="2034" y="1247"/>
                  </a:lnTo>
                  <a:lnTo>
                    <a:pt x="2035" y="1247"/>
                  </a:lnTo>
                  <a:lnTo>
                    <a:pt x="2036" y="1248"/>
                  </a:lnTo>
                  <a:lnTo>
                    <a:pt x="2037" y="1248"/>
                  </a:lnTo>
                  <a:lnTo>
                    <a:pt x="2037" y="1249"/>
                  </a:lnTo>
                  <a:lnTo>
                    <a:pt x="2038" y="1249"/>
                  </a:lnTo>
                  <a:lnTo>
                    <a:pt x="2038" y="1250"/>
                  </a:lnTo>
                  <a:lnTo>
                    <a:pt x="2039" y="1250"/>
                  </a:lnTo>
                  <a:lnTo>
                    <a:pt x="2039" y="1251"/>
                  </a:lnTo>
                  <a:lnTo>
                    <a:pt x="2040" y="1252"/>
                  </a:lnTo>
                  <a:lnTo>
                    <a:pt x="2041" y="1253"/>
                  </a:lnTo>
                  <a:lnTo>
                    <a:pt x="2041" y="1254"/>
                  </a:lnTo>
                  <a:lnTo>
                    <a:pt x="2042" y="1255"/>
                  </a:lnTo>
                  <a:lnTo>
                    <a:pt x="2043" y="1256"/>
                  </a:lnTo>
                  <a:lnTo>
                    <a:pt x="2043" y="1257"/>
                  </a:lnTo>
                  <a:lnTo>
                    <a:pt x="2044" y="1258"/>
                  </a:lnTo>
                  <a:lnTo>
                    <a:pt x="2045" y="1259"/>
                  </a:lnTo>
                  <a:lnTo>
                    <a:pt x="2045" y="1260"/>
                  </a:lnTo>
                  <a:lnTo>
                    <a:pt x="2046" y="1261"/>
                  </a:lnTo>
                  <a:lnTo>
                    <a:pt x="2046" y="1262"/>
                  </a:lnTo>
                  <a:lnTo>
                    <a:pt x="2047" y="1263"/>
                  </a:lnTo>
                  <a:lnTo>
                    <a:pt x="2048" y="1264"/>
                  </a:lnTo>
                  <a:lnTo>
                    <a:pt x="2048" y="1265"/>
                  </a:lnTo>
                  <a:lnTo>
                    <a:pt x="2048" y="1266"/>
                  </a:lnTo>
                  <a:lnTo>
                    <a:pt x="2049" y="1266"/>
                  </a:lnTo>
                  <a:lnTo>
                    <a:pt x="2049" y="1267"/>
                  </a:lnTo>
                  <a:lnTo>
                    <a:pt x="2050" y="1267"/>
                  </a:lnTo>
                  <a:lnTo>
                    <a:pt x="2050" y="1268"/>
                  </a:lnTo>
                  <a:lnTo>
                    <a:pt x="2051" y="1268"/>
                  </a:lnTo>
                  <a:lnTo>
                    <a:pt x="2052" y="1269"/>
                  </a:lnTo>
                  <a:lnTo>
                    <a:pt x="2053" y="1269"/>
                  </a:lnTo>
                  <a:lnTo>
                    <a:pt x="2054" y="1269"/>
                  </a:lnTo>
                  <a:lnTo>
                    <a:pt x="2054" y="1268"/>
                  </a:lnTo>
                  <a:lnTo>
                    <a:pt x="2055" y="1268"/>
                  </a:lnTo>
                  <a:lnTo>
                    <a:pt x="2055" y="1267"/>
                  </a:lnTo>
                  <a:lnTo>
                    <a:pt x="2056" y="1267"/>
                  </a:lnTo>
                  <a:lnTo>
                    <a:pt x="2056" y="1266"/>
                  </a:lnTo>
                  <a:lnTo>
                    <a:pt x="2056" y="1264"/>
                  </a:lnTo>
                  <a:lnTo>
                    <a:pt x="2057" y="1263"/>
                  </a:lnTo>
                  <a:lnTo>
                    <a:pt x="2057" y="1262"/>
                  </a:lnTo>
                  <a:lnTo>
                    <a:pt x="2058" y="1260"/>
                  </a:lnTo>
                  <a:lnTo>
                    <a:pt x="2058" y="1259"/>
                  </a:lnTo>
                  <a:lnTo>
                    <a:pt x="2059" y="1257"/>
                  </a:lnTo>
                  <a:lnTo>
                    <a:pt x="2059" y="1255"/>
                  </a:lnTo>
                  <a:lnTo>
                    <a:pt x="2060" y="1254"/>
                  </a:lnTo>
                  <a:lnTo>
                    <a:pt x="2060" y="1252"/>
                  </a:lnTo>
                  <a:lnTo>
                    <a:pt x="2061" y="1250"/>
                  </a:lnTo>
                  <a:lnTo>
                    <a:pt x="2061" y="1248"/>
                  </a:lnTo>
                  <a:lnTo>
                    <a:pt x="2062" y="1246"/>
                  </a:lnTo>
                  <a:lnTo>
                    <a:pt x="2062" y="1244"/>
                  </a:lnTo>
                  <a:lnTo>
                    <a:pt x="2063" y="1242"/>
                  </a:lnTo>
                  <a:lnTo>
                    <a:pt x="2063" y="1240"/>
                  </a:lnTo>
                  <a:lnTo>
                    <a:pt x="2064" y="1238"/>
                  </a:lnTo>
                  <a:lnTo>
                    <a:pt x="2064" y="1236"/>
                  </a:lnTo>
                  <a:lnTo>
                    <a:pt x="2065" y="1234"/>
                  </a:lnTo>
                  <a:lnTo>
                    <a:pt x="2065" y="1232"/>
                  </a:lnTo>
                  <a:lnTo>
                    <a:pt x="2065" y="1230"/>
                  </a:lnTo>
                  <a:lnTo>
                    <a:pt x="2066" y="1227"/>
                  </a:lnTo>
                  <a:lnTo>
                    <a:pt x="2066" y="1225"/>
                  </a:lnTo>
                  <a:lnTo>
                    <a:pt x="2067" y="1224"/>
                  </a:lnTo>
                  <a:lnTo>
                    <a:pt x="2067" y="1222"/>
                  </a:lnTo>
                  <a:lnTo>
                    <a:pt x="2068" y="1220"/>
                  </a:lnTo>
                  <a:lnTo>
                    <a:pt x="2068" y="1218"/>
                  </a:lnTo>
                  <a:lnTo>
                    <a:pt x="2069" y="1217"/>
                  </a:lnTo>
                  <a:lnTo>
                    <a:pt x="2069" y="1215"/>
                  </a:lnTo>
                  <a:lnTo>
                    <a:pt x="2070" y="1214"/>
                  </a:lnTo>
                  <a:lnTo>
                    <a:pt x="2070" y="1212"/>
                  </a:lnTo>
                  <a:lnTo>
                    <a:pt x="2071" y="1210"/>
                  </a:lnTo>
                  <a:lnTo>
                    <a:pt x="2071" y="1209"/>
                  </a:lnTo>
                  <a:lnTo>
                    <a:pt x="2072" y="1207"/>
                  </a:lnTo>
                  <a:lnTo>
                    <a:pt x="2072" y="1206"/>
                  </a:lnTo>
                  <a:lnTo>
                    <a:pt x="2073" y="1205"/>
                  </a:lnTo>
                  <a:lnTo>
                    <a:pt x="2073" y="1203"/>
                  </a:lnTo>
                  <a:lnTo>
                    <a:pt x="2073" y="1202"/>
                  </a:lnTo>
                  <a:lnTo>
                    <a:pt x="2074" y="1200"/>
                  </a:lnTo>
                  <a:lnTo>
                    <a:pt x="2074" y="1199"/>
                  </a:lnTo>
                  <a:lnTo>
                    <a:pt x="2075" y="1197"/>
                  </a:lnTo>
                  <a:lnTo>
                    <a:pt x="2075" y="1196"/>
                  </a:lnTo>
                  <a:lnTo>
                    <a:pt x="2076" y="1195"/>
                  </a:lnTo>
                  <a:lnTo>
                    <a:pt x="2076" y="1193"/>
                  </a:lnTo>
                  <a:lnTo>
                    <a:pt x="2077" y="1192"/>
                  </a:lnTo>
                  <a:lnTo>
                    <a:pt x="2077" y="1190"/>
                  </a:lnTo>
                  <a:lnTo>
                    <a:pt x="2078" y="1189"/>
                  </a:lnTo>
                  <a:lnTo>
                    <a:pt x="2078" y="1187"/>
                  </a:lnTo>
                  <a:lnTo>
                    <a:pt x="2079" y="1186"/>
                  </a:lnTo>
                  <a:lnTo>
                    <a:pt x="2079" y="1184"/>
                  </a:lnTo>
                  <a:lnTo>
                    <a:pt x="2080" y="1182"/>
                  </a:lnTo>
                  <a:lnTo>
                    <a:pt x="2080" y="1181"/>
                  </a:lnTo>
                  <a:lnTo>
                    <a:pt x="2081" y="1179"/>
                  </a:lnTo>
                  <a:lnTo>
                    <a:pt x="2081" y="1177"/>
                  </a:lnTo>
                  <a:lnTo>
                    <a:pt x="2082" y="1176"/>
                  </a:lnTo>
                  <a:lnTo>
                    <a:pt x="2082" y="1174"/>
                  </a:lnTo>
                  <a:lnTo>
                    <a:pt x="2082" y="1172"/>
                  </a:lnTo>
                  <a:lnTo>
                    <a:pt x="2083" y="1171"/>
                  </a:lnTo>
                  <a:lnTo>
                    <a:pt x="2083" y="1169"/>
                  </a:lnTo>
                  <a:lnTo>
                    <a:pt x="2084" y="1167"/>
                  </a:lnTo>
                  <a:lnTo>
                    <a:pt x="2084" y="1166"/>
                  </a:lnTo>
                  <a:lnTo>
                    <a:pt x="2085" y="1164"/>
                  </a:lnTo>
                  <a:lnTo>
                    <a:pt x="2085" y="1163"/>
                  </a:lnTo>
                  <a:lnTo>
                    <a:pt x="2086" y="1161"/>
                  </a:lnTo>
                  <a:lnTo>
                    <a:pt x="2086" y="1160"/>
                  </a:lnTo>
                  <a:lnTo>
                    <a:pt x="2087" y="1158"/>
                  </a:lnTo>
                  <a:lnTo>
                    <a:pt x="2087" y="1157"/>
                  </a:lnTo>
                  <a:lnTo>
                    <a:pt x="2088" y="1156"/>
                  </a:lnTo>
                  <a:lnTo>
                    <a:pt x="2088" y="1154"/>
                  </a:lnTo>
                  <a:lnTo>
                    <a:pt x="2089" y="1153"/>
                  </a:lnTo>
                  <a:lnTo>
                    <a:pt x="2089" y="1152"/>
                  </a:lnTo>
                  <a:lnTo>
                    <a:pt x="2090" y="1151"/>
                  </a:lnTo>
                  <a:lnTo>
                    <a:pt x="2090" y="1150"/>
                  </a:lnTo>
                  <a:lnTo>
                    <a:pt x="2090" y="1149"/>
                  </a:lnTo>
                  <a:lnTo>
                    <a:pt x="2091" y="1149"/>
                  </a:lnTo>
                  <a:lnTo>
                    <a:pt x="2091" y="1148"/>
                  </a:lnTo>
                  <a:lnTo>
                    <a:pt x="2092" y="1148"/>
                  </a:lnTo>
                  <a:lnTo>
                    <a:pt x="2092" y="1147"/>
                  </a:lnTo>
                  <a:lnTo>
                    <a:pt x="2093" y="1147"/>
                  </a:lnTo>
                  <a:lnTo>
                    <a:pt x="2094" y="1146"/>
                  </a:lnTo>
                  <a:lnTo>
                    <a:pt x="2095" y="1146"/>
                  </a:lnTo>
                  <a:lnTo>
                    <a:pt x="2096" y="1147"/>
                  </a:lnTo>
                  <a:lnTo>
                    <a:pt x="2097" y="1147"/>
                  </a:lnTo>
                  <a:lnTo>
                    <a:pt x="2097" y="1148"/>
                  </a:lnTo>
                  <a:lnTo>
                    <a:pt x="2098" y="1148"/>
                  </a:lnTo>
                  <a:lnTo>
                    <a:pt x="2098" y="1149"/>
                  </a:lnTo>
                  <a:lnTo>
                    <a:pt x="2099" y="1149"/>
                  </a:lnTo>
                  <a:lnTo>
                    <a:pt x="2099" y="1150"/>
                  </a:lnTo>
                  <a:lnTo>
                    <a:pt x="2099" y="1151"/>
                  </a:lnTo>
                  <a:lnTo>
                    <a:pt x="2100" y="1152"/>
                  </a:lnTo>
                  <a:lnTo>
                    <a:pt x="2100" y="1153"/>
                  </a:lnTo>
                  <a:lnTo>
                    <a:pt x="2101" y="1154"/>
                  </a:lnTo>
                  <a:lnTo>
                    <a:pt x="2101" y="1155"/>
                  </a:lnTo>
                  <a:lnTo>
                    <a:pt x="2102" y="1156"/>
                  </a:lnTo>
                  <a:lnTo>
                    <a:pt x="2102" y="1157"/>
                  </a:lnTo>
                  <a:lnTo>
                    <a:pt x="2103" y="1158"/>
                  </a:lnTo>
                  <a:lnTo>
                    <a:pt x="2103" y="1160"/>
                  </a:lnTo>
                  <a:lnTo>
                    <a:pt x="2104" y="1161"/>
                  </a:lnTo>
                  <a:lnTo>
                    <a:pt x="2104" y="1163"/>
                  </a:lnTo>
                  <a:lnTo>
                    <a:pt x="2105" y="1165"/>
                  </a:lnTo>
                  <a:lnTo>
                    <a:pt x="2105" y="1166"/>
                  </a:lnTo>
                  <a:lnTo>
                    <a:pt x="2106" y="1168"/>
                  </a:lnTo>
                  <a:lnTo>
                    <a:pt x="2106" y="1169"/>
                  </a:lnTo>
                  <a:lnTo>
                    <a:pt x="2107" y="1171"/>
                  </a:lnTo>
                  <a:lnTo>
                    <a:pt x="2107" y="1173"/>
                  </a:lnTo>
                  <a:lnTo>
                    <a:pt x="2107" y="1174"/>
                  </a:lnTo>
                  <a:lnTo>
                    <a:pt x="2108" y="1176"/>
                  </a:lnTo>
                  <a:lnTo>
                    <a:pt x="2108" y="1177"/>
                  </a:lnTo>
                  <a:lnTo>
                    <a:pt x="2109" y="1179"/>
                  </a:lnTo>
                  <a:lnTo>
                    <a:pt x="2109" y="1180"/>
                  </a:lnTo>
                  <a:lnTo>
                    <a:pt x="2110" y="1181"/>
                  </a:lnTo>
                  <a:lnTo>
                    <a:pt x="2110" y="1182"/>
                  </a:lnTo>
                  <a:lnTo>
                    <a:pt x="2111" y="1183"/>
                  </a:lnTo>
                  <a:lnTo>
                    <a:pt x="2111" y="1184"/>
                  </a:lnTo>
                  <a:lnTo>
                    <a:pt x="2112" y="1185"/>
                  </a:lnTo>
                  <a:lnTo>
                    <a:pt x="2112" y="1186"/>
                  </a:lnTo>
                  <a:lnTo>
                    <a:pt x="2113" y="1186"/>
                  </a:lnTo>
                  <a:lnTo>
                    <a:pt x="2113" y="1187"/>
                  </a:lnTo>
                  <a:lnTo>
                    <a:pt x="2114" y="1187"/>
                  </a:lnTo>
                  <a:lnTo>
                    <a:pt x="2115" y="1187"/>
                  </a:lnTo>
                  <a:lnTo>
                    <a:pt x="2116" y="1186"/>
                  </a:lnTo>
                  <a:lnTo>
                    <a:pt x="2116" y="1185"/>
                  </a:lnTo>
                  <a:lnTo>
                    <a:pt x="2116" y="1184"/>
                  </a:lnTo>
                  <a:lnTo>
                    <a:pt x="2117" y="1183"/>
                  </a:lnTo>
                  <a:lnTo>
                    <a:pt x="2117" y="1182"/>
                  </a:lnTo>
                  <a:lnTo>
                    <a:pt x="2118" y="1181"/>
                  </a:lnTo>
                  <a:lnTo>
                    <a:pt x="2118" y="1180"/>
                  </a:lnTo>
                  <a:lnTo>
                    <a:pt x="2119" y="1178"/>
                  </a:lnTo>
                  <a:lnTo>
                    <a:pt x="2119" y="1177"/>
                  </a:lnTo>
                  <a:lnTo>
                    <a:pt x="2120" y="1175"/>
                  </a:lnTo>
                  <a:lnTo>
                    <a:pt x="2120" y="1174"/>
                  </a:lnTo>
                  <a:lnTo>
                    <a:pt x="2121" y="1172"/>
                  </a:lnTo>
                  <a:lnTo>
                    <a:pt x="2121" y="1171"/>
                  </a:lnTo>
                  <a:lnTo>
                    <a:pt x="2122" y="1169"/>
                  </a:lnTo>
                  <a:lnTo>
                    <a:pt x="2122" y="1167"/>
                  </a:lnTo>
                  <a:lnTo>
                    <a:pt x="2123" y="1166"/>
                  </a:lnTo>
                  <a:lnTo>
                    <a:pt x="2123" y="1164"/>
                  </a:lnTo>
                  <a:lnTo>
                    <a:pt x="2124" y="1163"/>
                  </a:lnTo>
                  <a:lnTo>
                    <a:pt x="2124" y="1161"/>
                  </a:lnTo>
                  <a:lnTo>
                    <a:pt x="2125" y="1160"/>
                  </a:lnTo>
                  <a:lnTo>
                    <a:pt x="2125" y="1158"/>
                  </a:lnTo>
                  <a:lnTo>
                    <a:pt x="2125" y="1157"/>
                  </a:lnTo>
                  <a:lnTo>
                    <a:pt x="2126" y="1155"/>
                  </a:lnTo>
                  <a:lnTo>
                    <a:pt x="2126" y="1154"/>
                  </a:lnTo>
                  <a:lnTo>
                    <a:pt x="2127" y="1153"/>
                  </a:lnTo>
                  <a:lnTo>
                    <a:pt x="2127" y="1152"/>
                  </a:lnTo>
                  <a:lnTo>
                    <a:pt x="2128" y="1152"/>
                  </a:lnTo>
                  <a:lnTo>
                    <a:pt x="2128" y="1151"/>
                  </a:lnTo>
                  <a:lnTo>
                    <a:pt x="2129" y="1150"/>
                  </a:lnTo>
                  <a:lnTo>
                    <a:pt x="2130" y="1149"/>
                  </a:lnTo>
                  <a:lnTo>
                    <a:pt x="2131" y="1148"/>
                  </a:lnTo>
                  <a:lnTo>
                    <a:pt x="2132" y="1147"/>
                  </a:lnTo>
                  <a:lnTo>
                    <a:pt x="2133" y="1147"/>
                  </a:lnTo>
                  <a:lnTo>
                    <a:pt x="2134" y="1146"/>
                  </a:lnTo>
                  <a:lnTo>
                    <a:pt x="2135" y="1146"/>
                  </a:lnTo>
                  <a:lnTo>
                    <a:pt x="2136" y="1146"/>
                  </a:lnTo>
                  <a:lnTo>
                    <a:pt x="2137" y="1146"/>
                  </a:lnTo>
                  <a:lnTo>
                    <a:pt x="2138" y="1146"/>
                  </a:lnTo>
                  <a:lnTo>
                    <a:pt x="2139" y="1146"/>
                  </a:lnTo>
                  <a:lnTo>
                    <a:pt x="2140" y="1146"/>
                  </a:lnTo>
                  <a:lnTo>
                    <a:pt x="2141" y="1146"/>
                  </a:lnTo>
                  <a:lnTo>
                    <a:pt x="2141" y="1145"/>
                  </a:lnTo>
                  <a:lnTo>
                    <a:pt x="2142" y="1145"/>
                  </a:lnTo>
                  <a:lnTo>
                    <a:pt x="2143" y="1145"/>
                  </a:lnTo>
                  <a:lnTo>
                    <a:pt x="2144" y="1145"/>
                  </a:lnTo>
                  <a:lnTo>
                    <a:pt x="2144" y="1144"/>
                  </a:lnTo>
                  <a:lnTo>
                    <a:pt x="2145" y="1144"/>
                  </a:lnTo>
                  <a:lnTo>
                    <a:pt x="2146" y="1144"/>
                  </a:lnTo>
                  <a:lnTo>
                    <a:pt x="2147" y="1143"/>
                  </a:lnTo>
                  <a:lnTo>
                    <a:pt x="2148" y="1143"/>
                  </a:lnTo>
                  <a:lnTo>
                    <a:pt x="2149" y="1142"/>
                  </a:lnTo>
                  <a:lnTo>
                    <a:pt x="2150" y="1142"/>
                  </a:lnTo>
                  <a:lnTo>
                    <a:pt x="2150" y="1141"/>
                  </a:lnTo>
                  <a:lnTo>
                    <a:pt x="2151" y="1141"/>
                  </a:lnTo>
                  <a:lnTo>
                    <a:pt x="2152" y="1141"/>
                  </a:lnTo>
                  <a:lnTo>
                    <a:pt x="2152" y="1140"/>
                  </a:lnTo>
                  <a:lnTo>
                    <a:pt x="2153" y="1140"/>
                  </a:lnTo>
                  <a:lnTo>
                    <a:pt x="2154" y="1139"/>
                  </a:lnTo>
                  <a:lnTo>
                    <a:pt x="2155" y="1138"/>
                  </a:lnTo>
                  <a:lnTo>
                    <a:pt x="2156" y="1137"/>
                  </a:lnTo>
                  <a:lnTo>
                    <a:pt x="2157" y="1136"/>
                  </a:lnTo>
                  <a:lnTo>
                    <a:pt x="2157" y="1135"/>
                  </a:lnTo>
                  <a:lnTo>
                    <a:pt x="2158" y="1135"/>
                  </a:lnTo>
                  <a:lnTo>
                    <a:pt x="2158" y="1134"/>
                  </a:lnTo>
                  <a:lnTo>
                    <a:pt x="2159" y="1133"/>
                  </a:lnTo>
                  <a:lnTo>
                    <a:pt x="2159" y="1132"/>
                  </a:lnTo>
                  <a:lnTo>
                    <a:pt x="2160" y="1131"/>
                  </a:lnTo>
                  <a:lnTo>
                    <a:pt x="2160" y="1130"/>
                  </a:lnTo>
                  <a:lnTo>
                    <a:pt x="2161" y="1129"/>
                  </a:lnTo>
                  <a:lnTo>
                    <a:pt x="2161" y="1128"/>
                  </a:lnTo>
                  <a:lnTo>
                    <a:pt x="2162" y="1127"/>
                  </a:lnTo>
                  <a:lnTo>
                    <a:pt x="2162" y="1126"/>
                  </a:lnTo>
                  <a:lnTo>
                    <a:pt x="2163" y="1125"/>
                  </a:lnTo>
                  <a:lnTo>
                    <a:pt x="2163" y="1123"/>
                  </a:lnTo>
                  <a:lnTo>
                    <a:pt x="2164" y="1122"/>
                  </a:lnTo>
                  <a:lnTo>
                    <a:pt x="2164" y="1121"/>
                  </a:lnTo>
                  <a:lnTo>
                    <a:pt x="2165" y="1120"/>
                  </a:lnTo>
                  <a:lnTo>
                    <a:pt x="2165" y="1118"/>
                  </a:lnTo>
                  <a:lnTo>
                    <a:pt x="2166" y="1117"/>
                  </a:lnTo>
                  <a:lnTo>
                    <a:pt x="2166" y="1116"/>
                  </a:lnTo>
                  <a:lnTo>
                    <a:pt x="2167" y="1115"/>
                  </a:lnTo>
                  <a:lnTo>
                    <a:pt x="2167" y="1113"/>
                  </a:lnTo>
                  <a:lnTo>
                    <a:pt x="2167" y="1112"/>
                  </a:lnTo>
                  <a:lnTo>
                    <a:pt x="2168" y="1111"/>
                  </a:lnTo>
                  <a:lnTo>
                    <a:pt x="2168" y="1110"/>
                  </a:lnTo>
                  <a:lnTo>
                    <a:pt x="2169" y="1109"/>
                  </a:lnTo>
                  <a:lnTo>
                    <a:pt x="2169" y="1108"/>
                  </a:lnTo>
                  <a:lnTo>
                    <a:pt x="2170" y="1107"/>
                  </a:lnTo>
                  <a:lnTo>
                    <a:pt x="2170" y="1106"/>
                  </a:lnTo>
                  <a:lnTo>
                    <a:pt x="2171" y="1106"/>
                  </a:lnTo>
                  <a:lnTo>
                    <a:pt x="2171" y="1105"/>
                  </a:lnTo>
                  <a:lnTo>
                    <a:pt x="2172" y="1105"/>
                  </a:lnTo>
                  <a:lnTo>
                    <a:pt x="2172" y="1104"/>
                  </a:lnTo>
                  <a:lnTo>
                    <a:pt x="2173" y="1104"/>
                  </a:lnTo>
                  <a:lnTo>
                    <a:pt x="2174" y="1104"/>
                  </a:lnTo>
                  <a:lnTo>
                    <a:pt x="2175" y="1105"/>
                  </a:lnTo>
                  <a:lnTo>
                    <a:pt x="2176" y="1106"/>
                  </a:lnTo>
                  <a:lnTo>
                    <a:pt x="2176" y="1107"/>
                  </a:lnTo>
                  <a:lnTo>
                    <a:pt x="2176" y="1108"/>
                  </a:lnTo>
                  <a:lnTo>
                    <a:pt x="2177" y="1108"/>
                  </a:lnTo>
                  <a:lnTo>
                    <a:pt x="2177" y="1109"/>
                  </a:lnTo>
                  <a:lnTo>
                    <a:pt x="2178" y="1110"/>
                  </a:lnTo>
                  <a:lnTo>
                    <a:pt x="2178" y="1111"/>
                  </a:lnTo>
                  <a:lnTo>
                    <a:pt x="2179" y="1112"/>
                  </a:lnTo>
                  <a:lnTo>
                    <a:pt x="2179" y="1113"/>
                  </a:lnTo>
                  <a:lnTo>
                    <a:pt x="2180" y="1115"/>
                  </a:lnTo>
                  <a:lnTo>
                    <a:pt x="2180" y="1116"/>
                  </a:lnTo>
                  <a:lnTo>
                    <a:pt x="2181" y="1117"/>
                  </a:lnTo>
                  <a:lnTo>
                    <a:pt x="2181" y="1118"/>
                  </a:lnTo>
                  <a:lnTo>
                    <a:pt x="2182" y="1119"/>
                  </a:lnTo>
                  <a:lnTo>
                    <a:pt x="2182" y="1120"/>
                  </a:lnTo>
                  <a:lnTo>
                    <a:pt x="2183" y="1121"/>
                  </a:lnTo>
                  <a:lnTo>
                    <a:pt x="2183" y="1122"/>
                  </a:lnTo>
                  <a:lnTo>
                    <a:pt x="2184" y="1123"/>
                  </a:lnTo>
                  <a:lnTo>
                    <a:pt x="2184" y="1124"/>
                  </a:lnTo>
                  <a:lnTo>
                    <a:pt x="2185" y="1125"/>
                  </a:lnTo>
                  <a:lnTo>
                    <a:pt x="2185" y="1126"/>
                  </a:lnTo>
                  <a:lnTo>
                    <a:pt x="2186" y="1126"/>
                  </a:lnTo>
                  <a:lnTo>
                    <a:pt x="2187" y="1126"/>
                  </a:lnTo>
                  <a:lnTo>
                    <a:pt x="2187" y="1127"/>
                  </a:lnTo>
                  <a:lnTo>
                    <a:pt x="2188" y="1127"/>
                  </a:lnTo>
                  <a:lnTo>
                    <a:pt x="2189" y="1127"/>
                  </a:lnTo>
                  <a:lnTo>
                    <a:pt x="2190" y="1127"/>
                  </a:lnTo>
                  <a:lnTo>
                    <a:pt x="2190" y="1126"/>
                  </a:lnTo>
                  <a:lnTo>
                    <a:pt x="2191" y="1126"/>
                  </a:lnTo>
                  <a:lnTo>
                    <a:pt x="2192" y="1126"/>
                  </a:lnTo>
                  <a:lnTo>
                    <a:pt x="2192" y="1125"/>
                  </a:lnTo>
                  <a:lnTo>
                    <a:pt x="2193" y="1125"/>
                  </a:lnTo>
                  <a:lnTo>
                    <a:pt x="2193" y="1124"/>
                  </a:lnTo>
                  <a:lnTo>
                    <a:pt x="2194" y="1124"/>
                  </a:lnTo>
                  <a:lnTo>
                    <a:pt x="2195" y="1123"/>
                  </a:lnTo>
                  <a:lnTo>
                    <a:pt x="2196" y="1123"/>
                  </a:lnTo>
                  <a:lnTo>
                    <a:pt x="2196" y="1122"/>
                  </a:lnTo>
                  <a:lnTo>
                    <a:pt x="2197" y="1122"/>
                  </a:lnTo>
                  <a:lnTo>
                    <a:pt x="2198" y="1122"/>
                  </a:lnTo>
                  <a:lnTo>
                    <a:pt x="2199" y="1122"/>
                  </a:lnTo>
                  <a:lnTo>
                    <a:pt x="2200" y="1122"/>
                  </a:lnTo>
                  <a:lnTo>
                    <a:pt x="2201" y="1122"/>
                  </a:lnTo>
                  <a:lnTo>
                    <a:pt x="2202" y="1122"/>
                  </a:lnTo>
                  <a:lnTo>
                    <a:pt x="2203" y="1122"/>
                  </a:lnTo>
                  <a:lnTo>
                    <a:pt x="2204" y="1123"/>
                  </a:lnTo>
                  <a:lnTo>
                    <a:pt x="2205" y="1123"/>
                  </a:lnTo>
                  <a:lnTo>
                    <a:pt x="2206" y="1123"/>
                  </a:lnTo>
                  <a:lnTo>
                    <a:pt x="2206" y="1124"/>
                  </a:lnTo>
                  <a:lnTo>
                    <a:pt x="2207" y="1124"/>
                  </a:lnTo>
                  <a:lnTo>
                    <a:pt x="2208" y="1124"/>
                  </a:lnTo>
                  <a:lnTo>
                    <a:pt x="2208" y="1125"/>
                  </a:lnTo>
                  <a:lnTo>
                    <a:pt x="2209" y="1125"/>
                  </a:lnTo>
                  <a:lnTo>
                    <a:pt x="2210" y="1125"/>
                  </a:lnTo>
                  <a:lnTo>
                    <a:pt x="2210" y="1126"/>
                  </a:lnTo>
                  <a:lnTo>
                    <a:pt x="2211" y="1126"/>
                  </a:lnTo>
                  <a:lnTo>
                    <a:pt x="2212" y="1127"/>
                  </a:lnTo>
                  <a:lnTo>
                    <a:pt x="2213" y="1127"/>
                  </a:lnTo>
                  <a:lnTo>
                    <a:pt x="2214" y="1128"/>
                  </a:lnTo>
                  <a:lnTo>
                    <a:pt x="2215" y="1128"/>
                  </a:lnTo>
                  <a:lnTo>
                    <a:pt x="2215" y="1129"/>
                  </a:lnTo>
                  <a:lnTo>
                    <a:pt x="2216" y="1129"/>
                  </a:lnTo>
                  <a:lnTo>
                    <a:pt x="2217" y="1130"/>
                  </a:lnTo>
                  <a:lnTo>
                    <a:pt x="2218" y="1130"/>
                  </a:lnTo>
                  <a:lnTo>
                    <a:pt x="2218" y="1131"/>
                  </a:lnTo>
                  <a:lnTo>
                    <a:pt x="2219" y="1131"/>
                  </a:lnTo>
                  <a:lnTo>
                    <a:pt x="2219" y="1132"/>
                  </a:lnTo>
                  <a:lnTo>
                    <a:pt x="2220" y="1132"/>
                  </a:lnTo>
                  <a:lnTo>
                    <a:pt x="2220" y="1133"/>
                  </a:lnTo>
                  <a:lnTo>
                    <a:pt x="2221" y="1133"/>
                  </a:lnTo>
                  <a:lnTo>
                    <a:pt x="2222" y="1134"/>
                  </a:lnTo>
                  <a:lnTo>
                    <a:pt x="2223" y="1135"/>
                  </a:lnTo>
                  <a:lnTo>
                    <a:pt x="2224" y="1135"/>
                  </a:lnTo>
                  <a:lnTo>
                    <a:pt x="2224" y="1136"/>
                  </a:lnTo>
                  <a:lnTo>
                    <a:pt x="2225" y="1136"/>
                  </a:lnTo>
                  <a:lnTo>
                    <a:pt x="2226" y="1136"/>
                  </a:lnTo>
                  <a:lnTo>
                    <a:pt x="2226" y="1137"/>
                  </a:lnTo>
                  <a:lnTo>
                    <a:pt x="2227" y="1137"/>
                  </a:lnTo>
                  <a:lnTo>
                    <a:pt x="2228" y="1137"/>
                  </a:lnTo>
                  <a:lnTo>
                    <a:pt x="2229" y="1137"/>
                  </a:lnTo>
                  <a:lnTo>
                    <a:pt x="2230" y="1136"/>
                  </a:lnTo>
                  <a:lnTo>
                    <a:pt x="2231" y="1136"/>
                  </a:lnTo>
                  <a:lnTo>
                    <a:pt x="2231" y="1135"/>
                  </a:lnTo>
                  <a:lnTo>
                    <a:pt x="2232" y="1135"/>
                  </a:lnTo>
                  <a:lnTo>
                    <a:pt x="2232" y="1134"/>
                  </a:lnTo>
                  <a:lnTo>
                    <a:pt x="2233" y="1133"/>
                  </a:lnTo>
                  <a:lnTo>
                    <a:pt x="2233" y="1132"/>
                  </a:lnTo>
                  <a:lnTo>
                    <a:pt x="2234" y="1131"/>
                  </a:lnTo>
                  <a:lnTo>
                    <a:pt x="2234" y="1130"/>
                  </a:lnTo>
                  <a:lnTo>
                    <a:pt x="2235" y="1129"/>
                  </a:lnTo>
                  <a:lnTo>
                    <a:pt x="2235" y="1127"/>
                  </a:lnTo>
                  <a:lnTo>
                    <a:pt x="2236" y="1126"/>
                  </a:lnTo>
                  <a:lnTo>
                    <a:pt x="2236" y="1124"/>
                  </a:lnTo>
                  <a:lnTo>
                    <a:pt x="2236" y="1123"/>
                  </a:lnTo>
                  <a:lnTo>
                    <a:pt x="2237" y="1121"/>
                  </a:lnTo>
                  <a:lnTo>
                    <a:pt x="2237" y="1120"/>
                  </a:lnTo>
                  <a:lnTo>
                    <a:pt x="2238" y="1118"/>
                  </a:lnTo>
                  <a:lnTo>
                    <a:pt x="2238" y="1117"/>
                  </a:lnTo>
                  <a:lnTo>
                    <a:pt x="2239" y="1115"/>
                  </a:lnTo>
                  <a:lnTo>
                    <a:pt x="2239" y="1113"/>
                  </a:lnTo>
                  <a:lnTo>
                    <a:pt x="2240" y="1112"/>
                  </a:lnTo>
                  <a:lnTo>
                    <a:pt x="2240" y="1110"/>
                  </a:lnTo>
                  <a:lnTo>
                    <a:pt x="2241" y="1108"/>
                  </a:lnTo>
                  <a:lnTo>
                    <a:pt x="2241" y="1106"/>
                  </a:lnTo>
                  <a:lnTo>
                    <a:pt x="2242" y="1105"/>
                  </a:lnTo>
                  <a:lnTo>
                    <a:pt x="2242" y="1103"/>
                  </a:lnTo>
                  <a:lnTo>
                    <a:pt x="2243" y="1101"/>
                  </a:lnTo>
                  <a:lnTo>
                    <a:pt x="2243" y="1100"/>
                  </a:lnTo>
                  <a:lnTo>
                    <a:pt x="2244" y="1098"/>
                  </a:lnTo>
                  <a:lnTo>
                    <a:pt x="2244" y="1096"/>
                  </a:lnTo>
                  <a:lnTo>
                    <a:pt x="2244" y="1095"/>
                  </a:lnTo>
                  <a:lnTo>
                    <a:pt x="2245" y="1093"/>
                  </a:lnTo>
                  <a:lnTo>
                    <a:pt x="2245" y="1092"/>
                  </a:lnTo>
                  <a:lnTo>
                    <a:pt x="2246" y="1090"/>
                  </a:lnTo>
                  <a:lnTo>
                    <a:pt x="2246" y="1089"/>
                  </a:lnTo>
                  <a:lnTo>
                    <a:pt x="2247" y="1087"/>
                  </a:lnTo>
                  <a:lnTo>
                    <a:pt x="2247" y="1086"/>
                  </a:lnTo>
                  <a:lnTo>
                    <a:pt x="2248" y="1084"/>
                  </a:lnTo>
                  <a:lnTo>
                    <a:pt x="2248" y="1083"/>
                  </a:lnTo>
                  <a:lnTo>
                    <a:pt x="2249" y="1081"/>
                  </a:lnTo>
                  <a:lnTo>
                    <a:pt x="2249" y="1080"/>
                  </a:lnTo>
                  <a:lnTo>
                    <a:pt x="2250" y="1078"/>
                  </a:lnTo>
                  <a:lnTo>
                    <a:pt x="2250" y="1077"/>
                  </a:lnTo>
                  <a:lnTo>
                    <a:pt x="2251" y="1075"/>
                  </a:lnTo>
                  <a:lnTo>
                    <a:pt x="2251" y="1074"/>
                  </a:lnTo>
                  <a:lnTo>
                    <a:pt x="2252" y="1073"/>
                  </a:lnTo>
                  <a:lnTo>
                    <a:pt x="2252" y="1071"/>
                  </a:lnTo>
                  <a:lnTo>
                    <a:pt x="2253" y="1070"/>
                  </a:lnTo>
                  <a:lnTo>
                    <a:pt x="2253" y="1068"/>
                  </a:lnTo>
                  <a:lnTo>
                    <a:pt x="2253" y="1067"/>
                  </a:lnTo>
                  <a:lnTo>
                    <a:pt x="2254" y="1065"/>
                  </a:lnTo>
                  <a:lnTo>
                    <a:pt x="2254" y="1063"/>
                  </a:lnTo>
                  <a:lnTo>
                    <a:pt x="2255" y="1062"/>
                  </a:lnTo>
                  <a:lnTo>
                    <a:pt x="2255" y="1060"/>
                  </a:lnTo>
                  <a:lnTo>
                    <a:pt x="2256" y="1058"/>
                  </a:lnTo>
                  <a:lnTo>
                    <a:pt x="2256" y="1057"/>
                  </a:lnTo>
                  <a:lnTo>
                    <a:pt x="2257" y="1055"/>
                  </a:lnTo>
                  <a:lnTo>
                    <a:pt x="2257" y="1053"/>
                  </a:lnTo>
                  <a:lnTo>
                    <a:pt x="2258" y="1051"/>
                  </a:lnTo>
                  <a:lnTo>
                    <a:pt x="2258" y="1049"/>
                  </a:lnTo>
                  <a:lnTo>
                    <a:pt x="2259" y="1047"/>
                  </a:lnTo>
                  <a:lnTo>
                    <a:pt x="2259" y="1045"/>
                  </a:lnTo>
                  <a:lnTo>
                    <a:pt x="2260" y="1043"/>
                  </a:lnTo>
                  <a:lnTo>
                    <a:pt x="2260" y="1041"/>
                  </a:lnTo>
                  <a:lnTo>
                    <a:pt x="2261" y="1039"/>
                  </a:lnTo>
                  <a:lnTo>
                    <a:pt x="2261" y="1037"/>
                  </a:lnTo>
                  <a:lnTo>
                    <a:pt x="2261" y="1035"/>
                  </a:lnTo>
                  <a:lnTo>
                    <a:pt x="2262" y="1032"/>
                  </a:lnTo>
                  <a:lnTo>
                    <a:pt x="2262" y="1030"/>
                  </a:lnTo>
                  <a:lnTo>
                    <a:pt x="2263" y="1028"/>
                  </a:lnTo>
                  <a:lnTo>
                    <a:pt x="2263" y="1025"/>
                  </a:lnTo>
                  <a:lnTo>
                    <a:pt x="2264" y="1023"/>
                  </a:lnTo>
                  <a:lnTo>
                    <a:pt x="2264" y="1021"/>
                  </a:lnTo>
                  <a:lnTo>
                    <a:pt x="2265" y="1018"/>
                  </a:lnTo>
                  <a:lnTo>
                    <a:pt x="2265" y="1016"/>
                  </a:lnTo>
                  <a:lnTo>
                    <a:pt x="2266" y="1013"/>
                  </a:lnTo>
                  <a:lnTo>
                    <a:pt x="2266" y="1010"/>
                  </a:lnTo>
                  <a:lnTo>
                    <a:pt x="2267" y="1008"/>
                  </a:lnTo>
                  <a:lnTo>
                    <a:pt x="2267" y="1005"/>
                  </a:lnTo>
                  <a:lnTo>
                    <a:pt x="2268" y="1002"/>
                  </a:lnTo>
                  <a:lnTo>
                    <a:pt x="2268" y="1000"/>
                  </a:lnTo>
                  <a:lnTo>
                    <a:pt x="2269" y="997"/>
                  </a:lnTo>
                  <a:lnTo>
                    <a:pt x="2269" y="994"/>
                  </a:lnTo>
                  <a:lnTo>
                    <a:pt x="2270" y="991"/>
                  </a:lnTo>
                  <a:lnTo>
                    <a:pt x="2270" y="988"/>
                  </a:lnTo>
                  <a:lnTo>
                    <a:pt x="2270" y="985"/>
                  </a:lnTo>
                  <a:lnTo>
                    <a:pt x="2271" y="983"/>
                  </a:lnTo>
                  <a:lnTo>
                    <a:pt x="2271" y="980"/>
                  </a:lnTo>
                  <a:lnTo>
                    <a:pt x="2272" y="977"/>
                  </a:lnTo>
                  <a:lnTo>
                    <a:pt x="2272" y="974"/>
                  </a:lnTo>
                  <a:lnTo>
                    <a:pt x="2273" y="971"/>
                  </a:lnTo>
                  <a:lnTo>
                    <a:pt x="2273" y="969"/>
                  </a:lnTo>
                  <a:lnTo>
                    <a:pt x="2274" y="966"/>
                  </a:lnTo>
                  <a:lnTo>
                    <a:pt x="2274" y="963"/>
                  </a:lnTo>
                  <a:lnTo>
                    <a:pt x="2275" y="961"/>
                  </a:lnTo>
                  <a:lnTo>
                    <a:pt x="2275" y="958"/>
                  </a:lnTo>
                  <a:lnTo>
                    <a:pt x="2276" y="956"/>
                  </a:lnTo>
                  <a:lnTo>
                    <a:pt x="2276" y="954"/>
                  </a:lnTo>
                  <a:lnTo>
                    <a:pt x="2277" y="951"/>
                  </a:lnTo>
                  <a:lnTo>
                    <a:pt x="2277" y="949"/>
                  </a:lnTo>
                  <a:lnTo>
                    <a:pt x="2278" y="947"/>
                  </a:lnTo>
                  <a:lnTo>
                    <a:pt x="2278" y="945"/>
                  </a:lnTo>
                  <a:lnTo>
                    <a:pt x="2279" y="944"/>
                  </a:lnTo>
                  <a:lnTo>
                    <a:pt x="2279" y="942"/>
                  </a:lnTo>
                  <a:lnTo>
                    <a:pt x="2279" y="940"/>
                  </a:lnTo>
                  <a:lnTo>
                    <a:pt x="2280" y="939"/>
                  </a:lnTo>
                  <a:lnTo>
                    <a:pt x="2280" y="938"/>
                  </a:lnTo>
                  <a:lnTo>
                    <a:pt x="2281" y="937"/>
                  </a:lnTo>
                  <a:lnTo>
                    <a:pt x="2281" y="936"/>
                  </a:lnTo>
                  <a:lnTo>
                    <a:pt x="2282" y="936"/>
                  </a:lnTo>
                  <a:lnTo>
                    <a:pt x="2282" y="935"/>
                  </a:lnTo>
                  <a:lnTo>
                    <a:pt x="2283" y="934"/>
                  </a:lnTo>
                  <a:lnTo>
                    <a:pt x="2284" y="934"/>
                  </a:lnTo>
                  <a:lnTo>
                    <a:pt x="2284" y="933"/>
                  </a:lnTo>
                  <a:lnTo>
                    <a:pt x="2285" y="933"/>
                  </a:lnTo>
                  <a:lnTo>
                    <a:pt x="2286" y="933"/>
                  </a:lnTo>
                  <a:lnTo>
                    <a:pt x="2287" y="933"/>
                  </a:lnTo>
                  <a:lnTo>
                    <a:pt x="2288" y="933"/>
                  </a:lnTo>
                  <a:lnTo>
                    <a:pt x="2288" y="934"/>
                  </a:lnTo>
                  <a:lnTo>
                    <a:pt x="2289" y="934"/>
                  </a:lnTo>
                  <a:lnTo>
                    <a:pt x="2290" y="934"/>
                  </a:lnTo>
                  <a:lnTo>
                    <a:pt x="2291" y="934"/>
                  </a:lnTo>
                  <a:lnTo>
                    <a:pt x="2292" y="934"/>
                  </a:lnTo>
                  <a:lnTo>
                    <a:pt x="2293" y="934"/>
                  </a:lnTo>
                  <a:lnTo>
                    <a:pt x="2294" y="934"/>
                  </a:lnTo>
                  <a:lnTo>
                    <a:pt x="2295" y="934"/>
                  </a:lnTo>
                  <a:lnTo>
                    <a:pt x="2296" y="933"/>
                  </a:lnTo>
                  <a:lnTo>
                    <a:pt x="2297" y="933"/>
                  </a:lnTo>
                  <a:lnTo>
                    <a:pt x="2297" y="932"/>
                  </a:lnTo>
                  <a:lnTo>
                    <a:pt x="2298" y="932"/>
                  </a:lnTo>
                  <a:lnTo>
                    <a:pt x="2298" y="931"/>
                  </a:lnTo>
                  <a:lnTo>
                    <a:pt x="2299" y="931"/>
                  </a:lnTo>
                  <a:lnTo>
                    <a:pt x="2299" y="930"/>
                  </a:lnTo>
                  <a:lnTo>
                    <a:pt x="2300" y="930"/>
                  </a:lnTo>
                  <a:lnTo>
                    <a:pt x="2300" y="929"/>
                  </a:lnTo>
                  <a:lnTo>
                    <a:pt x="2301" y="929"/>
                  </a:lnTo>
                  <a:lnTo>
                    <a:pt x="2301" y="928"/>
                  </a:lnTo>
                  <a:lnTo>
                    <a:pt x="2302" y="927"/>
                  </a:lnTo>
                  <a:lnTo>
                    <a:pt x="2303" y="926"/>
                  </a:lnTo>
                  <a:lnTo>
                    <a:pt x="2303" y="925"/>
                  </a:lnTo>
                  <a:lnTo>
                    <a:pt x="2304" y="925"/>
                  </a:lnTo>
                  <a:lnTo>
                    <a:pt x="2304" y="924"/>
                  </a:lnTo>
                  <a:lnTo>
                    <a:pt x="2304" y="923"/>
                  </a:lnTo>
                  <a:lnTo>
                    <a:pt x="2305" y="922"/>
                  </a:lnTo>
                  <a:lnTo>
                    <a:pt x="2306" y="921"/>
                  </a:lnTo>
                  <a:lnTo>
                    <a:pt x="2306" y="920"/>
                  </a:lnTo>
                  <a:lnTo>
                    <a:pt x="2307" y="919"/>
                  </a:lnTo>
                  <a:lnTo>
                    <a:pt x="2307" y="918"/>
                  </a:lnTo>
                  <a:lnTo>
                    <a:pt x="2308" y="917"/>
                  </a:lnTo>
                  <a:lnTo>
                    <a:pt x="2308" y="916"/>
                  </a:lnTo>
                  <a:lnTo>
                    <a:pt x="2309" y="915"/>
                  </a:lnTo>
                  <a:lnTo>
                    <a:pt x="2309" y="914"/>
                  </a:lnTo>
                  <a:lnTo>
                    <a:pt x="2310" y="913"/>
                  </a:lnTo>
                  <a:lnTo>
                    <a:pt x="2310" y="912"/>
                  </a:lnTo>
                  <a:lnTo>
                    <a:pt x="2311" y="911"/>
                  </a:lnTo>
                  <a:lnTo>
                    <a:pt x="2311" y="910"/>
                  </a:lnTo>
                  <a:lnTo>
                    <a:pt x="2312" y="909"/>
                  </a:lnTo>
                  <a:lnTo>
                    <a:pt x="2312" y="908"/>
                  </a:lnTo>
                  <a:lnTo>
                    <a:pt x="2313" y="907"/>
                  </a:lnTo>
                  <a:lnTo>
                    <a:pt x="2313" y="906"/>
                  </a:lnTo>
                  <a:lnTo>
                    <a:pt x="2313" y="904"/>
                  </a:lnTo>
                  <a:lnTo>
                    <a:pt x="2314" y="903"/>
                  </a:lnTo>
                  <a:lnTo>
                    <a:pt x="2314" y="902"/>
                  </a:lnTo>
                  <a:lnTo>
                    <a:pt x="2315" y="901"/>
                  </a:lnTo>
                  <a:lnTo>
                    <a:pt x="2315" y="900"/>
                  </a:lnTo>
                  <a:lnTo>
                    <a:pt x="2316" y="899"/>
                  </a:lnTo>
                  <a:lnTo>
                    <a:pt x="2316" y="897"/>
                  </a:lnTo>
                  <a:lnTo>
                    <a:pt x="2317" y="896"/>
                  </a:lnTo>
                  <a:lnTo>
                    <a:pt x="2317" y="895"/>
                  </a:lnTo>
                  <a:lnTo>
                    <a:pt x="2318" y="894"/>
                  </a:lnTo>
                  <a:lnTo>
                    <a:pt x="2318" y="893"/>
                  </a:lnTo>
                  <a:lnTo>
                    <a:pt x="2319" y="892"/>
                  </a:lnTo>
                  <a:lnTo>
                    <a:pt x="2319" y="891"/>
                  </a:lnTo>
                  <a:lnTo>
                    <a:pt x="2320" y="889"/>
                  </a:lnTo>
                  <a:lnTo>
                    <a:pt x="2320" y="888"/>
                  </a:lnTo>
                  <a:lnTo>
                    <a:pt x="2321" y="888"/>
                  </a:lnTo>
                  <a:lnTo>
                    <a:pt x="2321" y="887"/>
                  </a:lnTo>
                  <a:lnTo>
                    <a:pt x="2321" y="886"/>
                  </a:lnTo>
                  <a:lnTo>
                    <a:pt x="2322" y="885"/>
                  </a:lnTo>
                  <a:lnTo>
                    <a:pt x="2322" y="884"/>
                  </a:lnTo>
                  <a:lnTo>
                    <a:pt x="2323" y="884"/>
                  </a:lnTo>
                  <a:lnTo>
                    <a:pt x="2323" y="883"/>
                  </a:lnTo>
                  <a:lnTo>
                    <a:pt x="2324" y="883"/>
                  </a:lnTo>
                  <a:lnTo>
                    <a:pt x="2324" y="882"/>
                  </a:lnTo>
                  <a:lnTo>
                    <a:pt x="2325" y="882"/>
                  </a:lnTo>
                  <a:lnTo>
                    <a:pt x="2325" y="881"/>
                  </a:lnTo>
                  <a:lnTo>
                    <a:pt x="2326" y="881"/>
                  </a:lnTo>
                  <a:lnTo>
                    <a:pt x="2327" y="881"/>
                  </a:lnTo>
                  <a:lnTo>
                    <a:pt x="2327" y="882"/>
                  </a:lnTo>
                  <a:lnTo>
                    <a:pt x="2328" y="882"/>
                  </a:lnTo>
                  <a:lnTo>
                    <a:pt x="2329" y="883"/>
                  </a:lnTo>
                  <a:lnTo>
                    <a:pt x="2329" y="884"/>
                  </a:lnTo>
                  <a:lnTo>
                    <a:pt x="2330" y="884"/>
                  </a:lnTo>
                  <a:lnTo>
                    <a:pt x="2330" y="885"/>
                  </a:lnTo>
                  <a:lnTo>
                    <a:pt x="2330" y="886"/>
                  </a:lnTo>
                  <a:lnTo>
                    <a:pt x="2331" y="887"/>
                  </a:lnTo>
                  <a:lnTo>
                    <a:pt x="2331" y="888"/>
                  </a:lnTo>
                  <a:lnTo>
                    <a:pt x="2332" y="889"/>
                  </a:lnTo>
                  <a:lnTo>
                    <a:pt x="2332" y="890"/>
                  </a:lnTo>
                  <a:lnTo>
                    <a:pt x="2333" y="891"/>
                  </a:lnTo>
                  <a:lnTo>
                    <a:pt x="2333" y="892"/>
                  </a:lnTo>
                  <a:lnTo>
                    <a:pt x="2334" y="893"/>
                  </a:lnTo>
                  <a:lnTo>
                    <a:pt x="2334" y="894"/>
                  </a:lnTo>
                  <a:lnTo>
                    <a:pt x="2335" y="895"/>
                  </a:lnTo>
                  <a:lnTo>
                    <a:pt x="2335" y="896"/>
                  </a:lnTo>
                  <a:lnTo>
                    <a:pt x="2336" y="897"/>
                  </a:lnTo>
                  <a:lnTo>
                    <a:pt x="2336" y="898"/>
                  </a:lnTo>
                  <a:lnTo>
                    <a:pt x="2337" y="898"/>
                  </a:lnTo>
                  <a:lnTo>
                    <a:pt x="2337" y="899"/>
                  </a:lnTo>
                  <a:lnTo>
                    <a:pt x="2338" y="900"/>
                  </a:lnTo>
                  <a:lnTo>
                    <a:pt x="2339" y="901"/>
                  </a:lnTo>
                  <a:lnTo>
                    <a:pt x="2340" y="902"/>
                  </a:lnTo>
                  <a:lnTo>
                    <a:pt x="2341" y="902"/>
                  </a:lnTo>
                  <a:lnTo>
                    <a:pt x="2342" y="902"/>
                  </a:lnTo>
                  <a:lnTo>
                    <a:pt x="2342" y="901"/>
                  </a:lnTo>
                  <a:lnTo>
                    <a:pt x="2343" y="901"/>
                  </a:lnTo>
                  <a:lnTo>
                    <a:pt x="2344" y="901"/>
                  </a:lnTo>
                  <a:lnTo>
                    <a:pt x="2344" y="900"/>
                  </a:lnTo>
                  <a:lnTo>
                    <a:pt x="2345" y="900"/>
                  </a:lnTo>
                  <a:lnTo>
                    <a:pt x="2345" y="899"/>
                  </a:lnTo>
                  <a:lnTo>
                    <a:pt x="2346" y="899"/>
                  </a:lnTo>
                  <a:lnTo>
                    <a:pt x="2347" y="898"/>
                  </a:lnTo>
                  <a:lnTo>
                    <a:pt x="2347" y="897"/>
                  </a:lnTo>
                  <a:lnTo>
                    <a:pt x="2348" y="897"/>
                  </a:lnTo>
                  <a:lnTo>
                    <a:pt x="2348" y="896"/>
                  </a:lnTo>
                  <a:lnTo>
                    <a:pt x="2349" y="896"/>
                  </a:lnTo>
                  <a:lnTo>
                    <a:pt x="2350" y="895"/>
                  </a:lnTo>
                  <a:lnTo>
                    <a:pt x="2351" y="895"/>
                  </a:lnTo>
                  <a:lnTo>
                    <a:pt x="2352" y="895"/>
                  </a:lnTo>
                  <a:lnTo>
                    <a:pt x="2353" y="894"/>
                  </a:lnTo>
                  <a:lnTo>
                    <a:pt x="2354" y="894"/>
                  </a:lnTo>
                  <a:lnTo>
                    <a:pt x="2355" y="894"/>
                  </a:lnTo>
                  <a:lnTo>
                    <a:pt x="2356" y="894"/>
                  </a:lnTo>
                  <a:lnTo>
                    <a:pt x="2357" y="894"/>
                  </a:lnTo>
                  <a:lnTo>
                    <a:pt x="2358" y="894"/>
                  </a:lnTo>
                  <a:lnTo>
                    <a:pt x="2359" y="894"/>
                  </a:lnTo>
                  <a:lnTo>
                    <a:pt x="2360" y="894"/>
                  </a:lnTo>
                  <a:lnTo>
                    <a:pt x="2360" y="893"/>
                  </a:lnTo>
                  <a:lnTo>
                    <a:pt x="2361" y="893"/>
                  </a:lnTo>
                  <a:lnTo>
                    <a:pt x="2362" y="892"/>
                  </a:lnTo>
                  <a:lnTo>
                    <a:pt x="2363" y="891"/>
                  </a:lnTo>
                  <a:lnTo>
                    <a:pt x="2364" y="890"/>
                  </a:lnTo>
                  <a:lnTo>
                    <a:pt x="2364" y="889"/>
                  </a:lnTo>
                  <a:lnTo>
                    <a:pt x="2364" y="888"/>
                  </a:lnTo>
                  <a:lnTo>
                    <a:pt x="2365" y="887"/>
                  </a:lnTo>
                  <a:lnTo>
                    <a:pt x="2366" y="886"/>
                  </a:lnTo>
                  <a:lnTo>
                    <a:pt x="2366" y="885"/>
                  </a:lnTo>
                  <a:lnTo>
                    <a:pt x="2367" y="884"/>
                  </a:lnTo>
                  <a:lnTo>
                    <a:pt x="2367" y="883"/>
                  </a:lnTo>
                  <a:lnTo>
                    <a:pt x="2368" y="882"/>
                  </a:lnTo>
                  <a:lnTo>
                    <a:pt x="2368" y="881"/>
                  </a:lnTo>
                  <a:lnTo>
                    <a:pt x="2369" y="880"/>
                  </a:lnTo>
                  <a:lnTo>
                    <a:pt x="2369" y="879"/>
                  </a:lnTo>
                  <a:lnTo>
                    <a:pt x="2370" y="878"/>
                  </a:lnTo>
                  <a:lnTo>
                    <a:pt x="2370" y="877"/>
                  </a:lnTo>
                  <a:lnTo>
                    <a:pt x="2371" y="876"/>
                  </a:lnTo>
                  <a:lnTo>
                    <a:pt x="2371" y="875"/>
                  </a:lnTo>
                  <a:lnTo>
                    <a:pt x="2372" y="874"/>
                  </a:lnTo>
                  <a:lnTo>
                    <a:pt x="2373" y="873"/>
                  </a:lnTo>
                  <a:lnTo>
                    <a:pt x="2373" y="872"/>
                  </a:lnTo>
                  <a:lnTo>
                    <a:pt x="2373" y="871"/>
                  </a:lnTo>
                  <a:lnTo>
                    <a:pt x="2374" y="871"/>
                  </a:lnTo>
                  <a:lnTo>
                    <a:pt x="2374" y="870"/>
                  </a:lnTo>
                  <a:lnTo>
                    <a:pt x="2375" y="870"/>
                  </a:lnTo>
                  <a:lnTo>
                    <a:pt x="2376" y="870"/>
                  </a:lnTo>
                  <a:lnTo>
                    <a:pt x="2377" y="869"/>
                  </a:lnTo>
                  <a:lnTo>
                    <a:pt x="2378" y="869"/>
                  </a:lnTo>
                  <a:lnTo>
                    <a:pt x="2379" y="869"/>
                  </a:lnTo>
                  <a:lnTo>
                    <a:pt x="2379" y="870"/>
                  </a:lnTo>
                  <a:lnTo>
                    <a:pt x="2380" y="870"/>
                  </a:lnTo>
                  <a:lnTo>
                    <a:pt x="2381" y="870"/>
                  </a:lnTo>
                  <a:lnTo>
                    <a:pt x="2381" y="871"/>
                  </a:lnTo>
                  <a:lnTo>
                    <a:pt x="2382" y="871"/>
                  </a:lnTo>
                  <a:lnTo>
                    <a:pt x="2383" y="871"/>
                  </a:lnTo>
                  <a:lnTo>
                    <a:pt x="2383" y="872"/>
                  </a:lnTo>
                  <a:lnTo>
                    <a:pt x="2384" y="872"/>
                  </a:lnTo>
                  <a:lnTo>
                    <a:pt x="2384" y="873"/>
                  </a:lnTo>
                  <a:lnTo>
                    <a:pt x="2385" y="873"/>
                  </a:lnTo>
                  <a:lnTo>
                    <a:pt x="2386" y="874"/>
                  </a:lnTo>
                  <a:lnTo>
                    <a:pt x="2387" y="874"/>
                  </a:lnTo>
                  <a:lnTo>
                    <a:pt x="2387" y="875"/>
                  </a:lnTo>
                  <a:lnTo>
                    <a:pt x="2388" y="875"/>
                  </a:lnTo>
                  <a:lnTo>
                    <a:pt x="2389" y="876"/>
                  </a:lnTo>
                  <a:lnTo>
                    <a:pt x="2390" y="877"/>
                  </a:lnTo>
                  <a:lnTo>
                    <a:pt x="2390" y="878"/>
                  </a:lnTo>
                  <a:lnTo>
                    <a:pt x="2391" y="879"/>
                  </a:lnTo>
                  <a:lnTo>
                    <a:pt x="2392" y="880"/>
                  </a:lnTo>
                  <a:lnTo>
                    <a:pt x="2392" y="881"/>
                  </a:lnTo>
                  <a:lnTo>
                    <a:pt x="2393" y="882"/>
                  </a:lnTo>
                  <a:lnTo>
                    <a:pt x="2393" y="883"/>
                  </a:lnTo>
                  <a:lnTo>
                    <a:pt x="2394" y="885"/>
                  </a:lnTo>
                  <a:lnTo>
                    <a:pt x="2394" y="886"/>
                  </a:lnTo>
                  <a:lnTo>
                    <a:pt x="2395" y="887"/>
                  </a:lnTo>
                  <a:lnTo>
                    <a:pt x="2395" y="889"/>
                  </a:lnTo>
                  <a:lnTo>
                    <a:pt x="2396" y="891"/>
                  </a:lnTo>
                  <a:lnTo>
                    <a:pt x="2396" y="893"/>
                  </a:lnTo>
                  <a:lnTo>
                    <a:pt x="2397" y="895"/>
                  </a:lnTo>
                  <a:lnTo>
                    <a:pt x="2397" y="897"/>
                  </a:lnTo>
                  <a:lnTo>
                    <a:pt x="2398" y="899"/>
                  </a:lnTo>
                  <a:lnTo>
                    <a:pt x="2398" y="902"/>
                  </a:lnTo>
                  <a:lnTo>
                    <a:pt x="2398" y="905"/>
                  </a:lnTo>
                  <a:lnTo>
                    <a:pt x="2399" y="908"/>
                  </a:lnTo>
                  <a:lnTo>
                    <a:pt x="2399" y="911"/>
                  </a:lnTo>
                  <a:lnTo>
                    <a:pt x="2400" y="914"/>
                  </a:lnTo>
                  <a:lnTo>
                    <a:pt x="2400" y="918"/>
                  </a:lnTo>
                  <a:lnTo>
                    <a:pt x="2401" y="921"/>
                  </a:lnTo>
                  <a:lnTo>
                    <a:pt x="2401" y="925"/>
                  </a:lnTo>
                  <a:lnTo>
                    <a:pt x="2402" y="928"/>
                  </a:lnTo>
                  <a:lnTo>
                    <a:pt x="2402" y="932"/>
                  </a:lnTo>
                  <a:lnTo>
                    <a:pt x="2403" y="936"/>
                  </a:lnTo>
                  <a:lnTo>
                    <a:pt x="2403" y="939"/>
                  </a:lnTo>
                  <a:lnTo>
                    <a:pt x="2404" y="943"/>
                  </a:lnTo>
                  <a:lnTo>
                    <a:pt x="2404" y="947"/>
                  </a:lnTo>
                  <a:lnTo>
                    <a:pt x="2405" y="950"/>
                  </a:lnTo>
                  <a:lnTo>
                    <a:pt x="2405" y="954"/>
                  </a:lnTo>
                  <a:lnTo>
                    <a:pt x="2406" y="958"/>
                  </a:lnTo>
                  <a:lnTo>
                    <a:pt x="2406" y="961"/>
                  </a:lnTo>
                  <a:lnTo>
                    <a:pt x="2407" y="964"/>
                  </a:lnTo>
                  <a:lnTo>
                    <a:pt x="2407" y="968"/>
                  </a:lnTo>
                  <a:lnTo>
                    <a:pt x="2407" y="971"/>
                  </a:lnTo>
                  <a:lnTo>
                    <a:pt x="2408" y="974"/>
                  </a:lnTo>
                  <a:lnTo>
                    <a:pt x="2408" y="977"/>
                  </a:lnTo>
                  <a:lnTo>
                    <a:pt x="2409" y="980"/>
                  </a:lnTo>
                  <a:lnTo>
                    <a:pt x="2409" y="983"/>
                  </a:lnTo>
                  <a:lnTo>
                    <a:pt x="2410" y="985"/>
                  </a:lnTo>
                  <a:lnTo>
                    <a:pt x="2410" y="987"/>
                  </a:lnTo>
                  <a:lnTo>
                    <a:pt x="2411" y="989"/>
                  </a:lnTo>
                  <a:lnTo>
                    <a:pt x="2411" y="991"/>
                  </a:lnTo>
                  <a:lnTo>
                    <a:pt x="2412" y="993"/>
                  </a:lnTo>
                  <a:lnTo>
                    <a:pt x="2412" y="994"/>
                  </a:lnTo>
                  <a:lnTo>
                    <a:pt x="2413" y="995"/>
                  </a:lnTo>
                  <a:lnTo>
                    <a:pt x="2413" y="997"/>
                  </a:lnTo>
                  <a:lnTo>
                    <a:pt x="2414" y="998"/>
                  </a:lnTo>
                  <a:lnTo>
                    <a:pt x="2415" y="999"/>
                  </a:lnTo>
                  <a:lnTo>
                    <a:pt x="2415" y="1000"/>
                  </a:lnTo>
                  <a:lnTo>
                    <a:pt x="2416" y="1000"/>
                  </a:lnTo>
                  <a:lnTo>
                    <a:pt x="2417" y="1000"/>
                  </a:lnTo>
                  <a:lnTo>
                    <a:pt x="2418" y="999"/>
                  </a:lnTo>
                  <a:lnTo>
                    <a:pt x="2419" y="998"/>
                  </a:lnTo>
                  <a:lnTo>
                    <a:pt x="2419" y="997"/>
                  </a:lnTo>
                  <a:lnTo>
                    <a:pt x="2420" y="996"/>
                  </a:lnTo>
                  <a:lnTo>
                    <a:pt x="2420" y="995"/>
                  </a:lnTo>
                  <a:lnTo>
                    <a:pt x="2421" y="993"/>
                  </a:lnTo>
                  <a:lnTo>
                    <a:pt x="2421" y="992"/>
                  </a:lnTo>
                  <a:lnTo>
                    <a:pt x="2422" y="990"/>
                  </a:lnTo>
                  <a:lnTo>
                    <a:pt x="2422" y="988"/>
                  </a:lnTo>
                  <a:lnTo>
                    <a:pt x="2423" y="986"/>
                  </a:lnTo>
                  <a:lnTo>
                    <a:pt x="2423" y="984"/>
                  </a:lnTo>
                  <a:lnTo>
                    <a:pt x="2424" y="981"/>
                  </a:lnTo>
                  <a:lnTo>
                    <a:pt x="2424" y="979"/>
                  </a:lnTo>
                  <a:lnTo>
                    <a:pt x="2424" y="976"/>
                  </a:lnTo>
                  <a:lnTo>
                    <a:pt x="2425" y="974"/>
                  </a:lnTo>
                  <a:lnTo>
                    <a:pt x="2425" y="971"/>
                  </a:lnTo>
                  <a:lnTo>
                    <a:pt x="2426" y="968"/>
                  </a:lnTo>
                  <a:lnTo>
                    <a:pt x="2426" y="966"/>
                  </a:lnTo>
                  <a:lnTo>
                    <a:pt x="2427" y="963"/>
                  </a:lnTo>
                  <a:lnTo>
                    <a:pt x="2427" y="960"/>
                  </a:lnTo>
                  <a:lnTo>
                    <a:pt x="2428" y="958"/>
                  </a:lnTo>
                  <a:lnTo>
                    <a:pt x="2428" y="955"/>
                  </a:lnTo>
                  <a:lnTo>
                    <a:pt x="2429" y="952"/>
                  </a:lnTo>
                  <a:lnTo>
                    <a:pt x="2429" y="950"/>
                  </a:lnTo>
                  <a:lnTo>
                    <a:pt x="2430" y="947"/>
                  </a:lnTo>
                  <a:lnTo>
                    <a:pt x="2430" y="944"/>
                  </a:lnTo>
                  <a:lnTo>
                    <a:pt x="2431" y="942"/>
                  </a:lnTo>
                  <a:lnTo>
                    <a:pt x="2431" y="940"/>
                  </a:lnTo>
                  <a:lnTo>
                    <a:pt x="2432" y="937"/>
                  </a:lnTo>
                  <a:lnTo>
                    <a:pt x="2432" y="935"/>
                  </a:lnTo>
                  <a:lnTo>
                    <a:pt x="2433" y="933"/>
                  </a:lnTo>
                  <a:lnTo>
                    <a:pt x="2433" y="931"/>
                  </a:lnTo>
                  <a:lnTo>
                    <a:pt x="2433" y="930"/>
                  </a:lnTo>
                  <a:lnTo>
                    <a:pt x="2434" y="928"/>
                  </a:lnTo>
                  <a:lnTo>
                    <a:pt x="2434" y="927"/>
                  </a:lnTo>
                  <a:lnTo>
                    <a:pt x="2435" y="925"/>
                  </a:lnTo>
                  <a:lnTo>
                    <a:pt x="2435" y="924"/>
                  </a:lnTo>
                  <a:lnTo>
                    <a:pt x="2436" y="923"/>
                  </a:lnTo>
                  <a:lnTo>
                    <a:pt x="2436" y="922"/>
                  </a:lnTo>
                  <a:lnTo>
                    <a:pt x="2437" y="921"/>
                  </a:lnTo>
                  <a:lnTo>
                    <a:pt x="2437" y="920"/>
                  </a:lnTo>
                  <a:lnTo>
                    <a:pt x="2438" y="920"/>
                  </a:lnTo>
                  <a:lnTo>
                    <a:pt x="2438" y="919"/>
                  </a:lnTo>
                  <a:lnTo>
                    <a:pt x="2439" y="919"/>
                  </a:lnTo>
                  <a:lnTo>
                    <a:pt x="2439" y="918"/>
                  </a:lnTo>
                  <a:lnTo>
                    <a:pt x="2440" y="918"/>
                  </a:lnTo>
                  <a:lnTo>
                    <a:pt x="2441" y="917"/>
                  </a:lnTo>
                  <a:lnTo>
                    <a:pt x="2442" y="917"/>
                  </a:lnTo>
                  <a:lnTo>
                    <a:pt x="2443" y="916"/>
                  </a:lnTo>
                  <a:lnTo>
                    <a:pt x="2444" y="916"/>
                  </a:lnTo>
                  <a:lnTo>
                    <a:pt x="2445" y="916"/>
                  </a:lnTo>
                  <a:lnTo>
                    <a:pt x="2446" y="916"/>
                  </a:lnTo>
                  <a:lnTo>
                    <a:pt x="2446" y="915"/>
                  </a:lnTo>
                  <a:lnTo>
                    <a:pt x="2447" y="915"/>
                  </a:lnTo>
                  <a:lnTo>
                    <a:pt x="2448" y="914"/>
                  </a:lnTo>
                  <a:lnTo>
                    <a:pt x="2449" y="913"/>
                  </a:lnTo>
                  <a:lnTo>
                    <a:pt x="2450" y="913"/>
                  </a:lnTo>
                  <a:lnTo>
                    <a:pt x="2450" y="912"/>
                  </a:lnTo>
                  <a:lnTo>
                    <a:pt x="2451" y="912"/>
                  </a:lnTo>
                  <a:lnTo>
                    <a:pt x="2451" y="911"/>
                  </a:lnTo>
                  <a:lnTo>
                    <a:pt x="2452" y="911"/>
                  </a:lnTo>
                  <a:lnTo>
                    <a:pt x="2452" y="910"/>
                  </a:lnTo>
                  <a:lnTo>
                    <a:pt x="2453" y="910"/>
                  </a:lnTo>
                  <a:lnTo>
                    <a:pt x="2454" y="909"/>
                  </a:lnTo>
                  <a:lnTo>
                    <a:pt x="2455" y="908"/>
                  </a:lnTo>
                  <a:lnTo>
                    <a:pt x="2456" y="908"/>
                  </a:lnTo>
                  <a:lnTo>
                    <a:pt x="2456" y="907"/>
                  </a:lnTo>
                  <a:lnTo>
                    <a:pt x="2457" y="907"/>
                  </a:lnTo>
                  <a:lnTo>
                    <a:pt x="2458" y="907"/>
                  </a:lnTo>
                  <a:lnTo>
                    <a:pt x="2459" y="906"/>
                  </a:lnTo>
                  <a:lnTo>
                    <a:pt x="2460" y="906"/>
                  </a:lnTo>
                  <a:lnTo>
                    <a:pt x="2461" y="906"/>
                  </a:lnTo>
                  <a:lnTo>
                    <a:pt x="2462" y="906"/>
                  </a:lnTo>
                  <a:lnTo>
                    <a:pt x="2462" y="905"/>
                  </a:lnTo>
                  <a:lnTo>
                    <a:pt x="2463" y="905"/>
                  </a:lnTo>
                  <a:lnTo>
                    <a:pt x="2464" y="904"/>
                  </a:lnTo>
                  <a:lnTo>
                    <a:pt x="2465" y="903"/>
                  </a:lnTo>
                  <a:lnTo>
                    <a:pt x="2466" y="902"/>
                  </a:lnTo>
                  <a:lnTo>
                    <a:pt x="2467" y="901"/>
                  </a:lnTo>
                  <a:lnTo>
                    <a:pt x="2467" y="900"/>
                  </a:lnTo>
                  <a:lnTo>
                    <a:pt x="2468" y="899"/>
                  </a:lnTo>
                  <a:lnTo>
                    <a:pt x="2468" y="898"/>
                  </a:lnTo>
                  <a:lnTo>
                    <a:pt x="2469" y="897"/>
                  </a:lnTo>
                  <a:lnTo>
                    <a:pt x="2469" y="895"/>
                  </a:lnTo>
                  <a:lnTo>
                    <a:pt x="2470" y="894"/>
                  </a:lnTo>
                  <a:lnTo>
                    <a:pt x="2470" y="893"/>
                  </a:lnTo>
                  <a:lnTo>
                    <a:pt x="2471" y="891"/>
                  </a:lnTo>
                  <a:lnTo>
                    <a:pt x="2471" y="890"/>
                  </a:lnTo>
                  <a:lnTo>
                    <a:pt x="2472" y="888"/>
                  </a:lnTo>
                  <a:lnTo>
                    <a:pt x="2472" y="887"/>
                  </a:lnTo>
                  <a:lnTo>
                    <a:pt x="2473" y="886"/>
                  </a:lnTo>
                  <a:lnTo>
                    <a:pt x="2473" y="884"/>
                  </a:lnTo>
                  <a:lnTo>
                    <a:pt x="2474" y="883"/>
                  </a:lnTo>
                  <a:lnTo>
                    <a:pt x="2474" y="881"/>
                  </a:lnTo>
                  <a:lnTo>
                    <a:pt x="2475" y="880"/>
                  </a:lnTo>
                  <a:lnTo>
                    <a:pt x="2475" y="879"/>
                  </a:lnTo>
                  <a:lnTo>
                    <a:pt x="2475" y="877"/>
                  </a:lnTo>
                  <a:lnTo>
                    <a:pt x="2476" y="876"/>
                  </a:lnTo>
                  <a:lnTo>
                    <a:pt x="2476" y="875"/>
                  </a:lnTo>
                  <a:lnTo>
                    <a:pt x="2477" y="874"/>
                  </a:lnTo>
                  <a:lnTo>
                    <a:pt x="2477" y="873"/>
                  </a:lnTo>
                  <a:lnTo>
                    <a:pt x="2478" y="873"/>
                  </a:lnTo>
                  <a:lnTo>
                    <a:pt x="2478" y="872"/>
                  </a:lnTo>
                  <a:lnTo>
                    <a:pt x="2479" y="871"/>
                  </a:lnTo>
                  <a:lnTo>
                    <a:pt x="2480" y="871"/>
                  </a:lnTo>
                  <a:lnTo>
                    <a:pt x="2481" y="871"/>
                  </a:lnTo>
                  <a:lnTo>
                    <a:pt x="2481" y="872"/>
                  </a:lnTo>
                  <a:lnTo>
                    <a:pt x="2482" y="872"/>
                  </a:lnTo>
                  <a:lnTo>
                    <a:pt x="2482" y="873"/>
                  </a:lnTo>
                  <a:lnTo>
                    <a:pt x="2483" y="874"/>
                  </a:lnTo>
                  <a:lnTo>
                    <a:pt x="2483" y="875"/>
                  </a:lnTo>
                  <a:lnTo>
                    <a:pt x="2484" y="876"/>
                  </a:lnTo>
                  <a:lnTo>
                    <a:pt x="2484" y="878"/>
                  </a:lnTo>
                  <a:lnTo>
                    <a:pt x="2484" y="879"/>
                  </a:lnTo>
                  <a:lnTo>
                    <a:pt x="2485" y="880"/>
                  </a:lnTo>
                  <a:lnTo>
                    <a:pt x="2485" y="882"/>
                  </a:lnTo>
                  <a:lnTo>
                    <a:pt x="2486" y="883"/>
                  </a:lnTo>
                  <a:lnTo>
                    <a:pt x="2486" y="884"/>
                  </a:lnTo>
                  <a:lnTo>
                    <a:pt x="2487" y="886"/>
                  </a:lnTo>
                  <a:lnTo>
                    <a:pt x="2487" y="887"/>
                  </a:lnTo>
                  <a:lnTo>
                    <a:pt x="2488" y="888"/>
                  </a:lnTo>
                  <a:lnTo>
                    <a:pt x="2488" y="890"/>
                  </a:lnTo>
                  <a:lnTo>
                    <a:pt x="2489" y="891"/>
                  </a:lnTo>
                  <a:lnTo>
                    <a:pt x="2489" y="892"/>
                  </a:lnTo>
                  <a:lnTo>
                    <a:pt x="2490" y="893"/>
                  </a:lnTo>
                  <a:lnTo>
                    <a:pt x="2490" y="894"/>
                  </a:lnTo>
                  <a:lnTo>
                    <a:pt x="2491" y="895"/>
                  </a:lnTo>
                  <a:lnTo>
                    <a:pt x="2492" y="896"/>
                  </a:lnTo>
                  <a:lnTo>
                    <a:pt x="2493" y="896"/>
                  </a:lnTo>
                  <a:lnTo>
                    <a:pt x="2494" y="895"/>
                  </a:lnTo>
                  <a:lnTo>
                    <a:pt x="2494" y="894"/>
                  </a:lnTo>
                  <a:lnTo>
                    <a:pt x="2495" y="893"/>
                  </a:lnTo>
                  <a:lnTo>
                    <a:pt x="2495" y="892"/>
                  </a:lnTo>
                  <a:lnTo>
                    <a:pt x="2496" y="891"/>
                  </a:lnTo>
                  <a:lnTo>
                    <a:pt x="2496" y="890"/>
                  </a:lnTo>
                  <a:lnTo>
                    <a:pt x="2497" y="889"/>
                  </a:lnTo>
                  <a:lnTo>
                    <a:pt x="2497" y="888"/>
                  </a:lnTo>
                  <a:lnTo>
                    <a:pt x="2498" y="886"/>
                  </a:lnTo>
                  <a:lnTo>
                    <a:pt x="2498" y="885"/>
                  </a:lnTo>
                  <a:lnTo>
                    <a:pt x="2499" y="883"/>
                  </a:lnTo>
                  <a:lnTo>
                    <a:pt x="2499" y="882"/>
                  </a:lnTo>
                  <a:lnTo>
                    <a:pt x="2500" y="880"/>
                  </a:lnTo>
                  <a:lnTo>
                    <a:pt x="2500" y="879"/>
                  </a:lnTo>
                  <a:lnTo>
                    <a:pt x="2501" y="877"/>
                  </a:lnTo>
                  <a:lnTo>
                    <a:pt x="2501" y="876"/>
                  </a:lnTo>
                  <a:lnTo>
                    <a:pt x="2501" y="874"/>
                  </a:lnTo>
                  <a:lnTo>
                    <a:pt x="2502" y="873"/>
                  </a:lnTo>
                  <a:lnTo>
                    <a:pt x="2502" y="872"/>
                  </a:lnTo>
                  <a:lnTo>
                    <a:pt x="2503" y="870"/>
                  </a:lnTo>
                  <a:lnTo>
                    <a:pt x="2503" y="869"/>
                  </a:lnTo>
                  <a:lnTo>
                    <a:pt x="2504" y="868"/>
                  </a:lnTo>
                  <a:lnTo>
                    <a:pt x="2504" y="867"/>
                  </a:lnTo>
                  <a:lnTo>
                    <a:pt x="2505" y="866"/>
                  </a:lnTo>
                  <a:lnTo>
                    <a:pt x="2505" y="865"/>
                  </a:lnTo>
                  <a:lnTo>
                    <a:pt x="2506" y="864"/>
                  </a:lnTo>
                  <a:lnTo>
                    <a:pt x="2507" y="863"/>
                  </a:lnTo>
                  <a:lnTo>
                    <a:pt x="2507" y="862"/>
                  </a:lnTo>
                  <a:lnTo>
                    <a:pt x="2508" y="862"/>
                  </a:lnTo>
                  <a:lnTo>
                    <a:pt x="2508" y="861"/>
                  </a:lnTo>
                  <a:lnTo>
                    <a:pt x="2509" y="861"/>
                  </a:lnTo>
                  <a:lnTo>
                    <a:pt x="2510" y="860"/>
                  </a:lnTo>
                  <a:lnTo>
                    <a:pt x="2510" y="859"/>
                  </a:lnTo>
                  <a:lnTo>
                    <a:pt x="2511" y="859"/>
                  </a:lnTo>
                  <a:lnTo>
                    <a:pt x="2512" y="858"/>
                  </a:lnTo>
                  <a:lnTo>
                    <a:pt x="2513" y="857"/>
                  </a:lnTo>
                  <a:lnTo>
                    <a:pt x="2514" y="856"/>
                  </a:lnTo>
                  <a:lnTo>
                    <a:pt x="2515" y="855"/>
                  </a:lnTo>
                  <a:lnTo>
                    <a:pt x="2516" y="854"/>
                  </a:lnTo>
                  <a:lnTo>
                    <a:pt x="2516" y="853"/>
                  </a:lnTo>
                  <a:lnTo>
                    <a:pt x="2517" y="852"/>
                  </a:lnTo>
                  <a:lnTo>
                    <a:pt x="2517" y="851"/>
                  </a:lnTo>
                  <a:lnTo>
                    <a:pt x="2518" y="850"/>
                  </a:lnTo>
                  <a:lnTo>
                    <a:pt x="2518" y="849"/>
                  </a:lnTo>
                  <a:lnTo>
                    <a:pt x="2518" y="848"/>
                  </a:lnTo>
                  <a:lnTo>
                    <a:pt x="2519" y="847"/>
                  </a:lnTo>
                  <a:lnTo>
                    <a:pt x="2519" y="845"/>
                  </a:lnTo>
                  <a:lnTo>
                    <a:pt x="2520" y="844"/>
                  </a:lnTo>
                  <a:lnTo>
                    <a:pt x="2520" y="843"/>
                  </a:lnTo>
                  <a:lnTo>
                    <a:pt x="2521" y="842"/>
                  </a:lnTo>
                  <a:lnTo>
                    <a:pt x="2521" y="840"/>
                  </a:lnTo>
                  <a:lnTo>
                    <a:pt x="2522" y="839"/>
                  </a:lnTo>
                  <a:lnTo>
                    <a:pt x="2522" y="837"/>
                  </a:lnTo>
                  <a:lnTo>
                    <a:pt x="2523" y="836"/>
                  </a:lnTo>
                  <a:lnTo>
                    <a:pt x="2523" y="835"/>
                  </a:lnTo>
                  <a:lnTo>
                    <a:pt x="2524" y="833"/>
                  </a:lnTo>
                  <a:lnTo>
                    <a:pt x="2524" y="832"/>
                  </a:lnTo>
                  <a:lnTo>
                    <a:pt x="2525" y="830"/>
                  </a:lnTo>
                  <a:lnTo>
                    <a:pt x="2525" y="829"/>
                  </a:lnTo>
                  <a:lnTo>
                    <a:pt x="2526" y="828"/>
                  </a:lnTo>
                  <a:lnTo>
                    <a:pt x="2526" y="826"/>
                  </a:lnTo>
                  <a:lnTo>
                    <a:pt x="2527" y="825"/>
                  </a:lnTo>
                  <a:lnTo>
                    <a:pt x="2527" y="824"/>
                  </a:lnTo>
                  <a:lnTo>
                    <a:pt x="2527" y="822"/>
                  </a:lnTo>
                  <a:lnTo>
                    <a:pt x="2528" y="821"/>
                  </a:lnTo>
                  <a:lnTo>
                    <a:pt x="2528" y="820"/>
                  </a:lnTo>
                  <a:lnTo>
                    <a:pt x="2529" y="819"/>
                  </a:lnTo>
                  <a:lnTo>
                    <a:pt x="2529" y="817"/>
                  </a:lnTo>
                  <a:lnTo>
                    <a:pt x="2530" y="816"/>
                  </a:lnTo>
                  <a:lnTo>
                    <a:pt x="2530" y="815"/>
                  </a:lnTo>
                  <a:lnTo>
                    <a:pt x="2531" y="814"/>
                  </a:lnTo>
                  <a:lnTo>
                    <a:pt x="2531" y="813"/>
                  </a:lnTo>
                  <a:lnTo>
                    <a:pt x="2532" y="812"/>
                  </a:lnTo>
                  <a:lnTo>
                    <a:pt x="2532" y="811"/>
                  </a:lnTo>
                  <a:lnTo>
                    <a:pt x="2533" y="810"/>
                  </a:lnTo>
                  <a:lnTo>
                    <a:pt x="2533" y="809"/>
                  </a:lnTo>
                  <a:lnTo>
                    <a:pt x="2534" y="808"/>
                  </a:lnTo>
                  <a:lnTo>
                    <a:pt x="2534" y="807"/>
                  </a:lnTo>
                  <a:lnTo>
                    <a:pt x="2535" y="806"/>
                  </a:lnTo>
                  <a:lnTo>
                    <a:pt x="2535" y="805"/>
                  </a:lnTo>
                  <a:lnTo>
                    <a:pt x="2535" y="804"/>
                  </a:lnTo>
                  <a:lnTo>
                    <a:pt x="2536" y="803"/>
                  </a:lnTo>
                  <a:lnTo>
                    <a:pt x="2537" y="802"/>
                  </a:lnTo>
                  <a:lnTo>
                    <a:pt x="2537" y="801"/>
                  </a:lnTo>
                  <a:lnTo>
                    <a:pt x="2538" y="800"/>
                  </a:lnTo>
                  <a:lnTo>
                    <a:pt x="2538" y="799"/>
                  </a:lnTo>
                  <a:lnTo>
                    <a:pt x="2539" y="799"/>
                  </a:lnTo>
                  <a:lnTo>
                    <a:pt x="2539" y="798"/>
                  </a:lnTo>
                  <a:lnTo>
                    <a:pt x="2540" y="797"/>
                  </a:lnTo>
                  <a:lnTo>
                    <a:pt x="2541" y="796"/>
                  </a:lnTo>
                  <a:lnTo>
                    <a:pt x="2541" y="795"/>
                  </a:lnTo>
                  <a:lnTo>
                    <a:pt x="2542" y="795"/>
                  </a:lnTo>
                  <a:lnTo>
                    <a:pt x="2542" y="794"/>
                  </a:lnTo>
                  <a:lnTo>
                    <a:pt x="2543" y="793"/>
                  </a:lnTo>
                  <a:lnTo>
                    <a:pt x="2544" y="792"/>
                  </a:lnTo>
                  <a:lnTo>
                    <a:pt x="2544" y="791"/>
                  </a:lnTo>
                  <a:lnTo>
                    <a:pt x="2545" y="791"/>
                  </a:lnTo>
                  <a:lnTo>
                    <a:pt x="2545" y="790"/>
                  </a:lnTo>
                  <a:lnTo>
                    <a:pt x="2546" y="790"/>
                  </a:lnTo>
                  <a:lnTo>
                    <a:pt x="2547" y="789"/>
                  </a:lnTo>
                  <a:lnTo>
                    <a:pt x="2548" y="789"/>
                  </a:lnTo>
                  <a:lnTo>
                    <a:pt x="2548" y="788"/>
                  </a:lnTo>
                  <a:lnTo>
                    <a:pt x="2549" y="788"/>
                  </a:lnTo>
                  <a:lnTo>
                    <a:pt x="2550" y="788"/>
                  </a:lnTo>
                  <a:lnTo>
                    <a:pt x="2551" y="787"/>
                  </a:lnTo>
                  <a:lnTo>
                    <a:pt x="2552" y="787"/>
                  </a:lnTo>
                  <a:lnTo>
                    <a:pt x="2552" y="788"/>
                  </a:lnTo>
                  <a:lnTo>
                    <a:pt x="2553" y="788"/>
                  </a:lnTo>
                  <a:lnTo>
                    <a:pt x="2554" y="788"/>
                  </a:lnTo>
                  <a:lnTo>
                    <a:pt x="2555" y="789"/>
                  </a:lnTo>
                  <a:lnTo>
                    <a:pt x="2556" y="789"/>
                  </a:lnTo>
                  <a:lnTo>
                    <a:pt x="2557" y="789"/>
                  </a:lnTo>
                  <a:lnTo>
                    <a:pt x="2558" y="790"/>
                  </a:lnTo>
                  <a:lnTo>
                    <a:pt x="2559" y="790"/>
                  </a:lnTo>
                  <a:lnTo>
                    <a:pt x="2560" y="790"/>
                  </a:lnTo>
                  <a:lnTo>
                    <a:pt x="2561" y="790"/>
                  </a:lnTo>
                  <a:lnTo>
                    <a:pt x="2562" y="789"/>
                  </a:lnTo>
                  <a:lnTo>
                    <a:pt x="2563" y="789"/>
                  </a:lnTo>
                  <a:lnTo>
                    <a:pt x="2564" y="788"/>
                  </a:lnTo>
                  <a:lnTo>
                    <a:pt x="2565" y="787"/>
                  </a:lnTo>
                  <a:lnTo>
                    <a:pt x="2566" y="786"/>
                  </a:lnTo>
                  <a:lnTo>
                    <a:pt x="2566" y="785"/>
                  </a:lnTo>
                  <a:lnTo>
                    <a:pt x="2567" y="785"/>
                  </a:lnTo>
                  <a:lnTo>
                    <a:pt x="2567" y="784"/>
                  </a:lnTo>
                  <a:lnTo>
                    <a:pt x="2568" y="783"/>
                  </a:lnTo>
                  <a:lnTo>
                    <a:pt x="2568" y="782"/>
                  </a:lnTo>
                  <a:lnTo>
                    <a:pt x="2569" y="782"/>
                  </a:lnTo>
                  <a:lnTo>
                    <a:pt x="2569" y="781"/>
                  </a:lnTo>
                  <a:lnTo>
                    <a:pt x="2570" y="780"/>
                  </a:lnTo>
                  <a:lnTo>
                    <a:pt x="2570" y="779"/>
                  </a:lnTo>
                  <a:lnTo>
                    <a:pt x="2570" y="778"/>
                  </a:lnTo>
                  <a:lnTo>
                    <a:pt x="2571" y="777"/>
                  </a:lnTo>
                  <a:lnTo>
                    <a:pt x="2571" y="776"/>
                  </a:lnTo>
                  <a:lnTo>
                    <a:pt x="2572" y="775"/>
                  </a:lnTo>
                  <a:lnTo>
                    <a:pt x="2572" y="774"/>
                  </a:lnTo>
                  <a:lnTo>
                    <a:pt x="2573" y="773"/>
                  </a:lnTo>
                  <a:lnTo>
                    <a:pt x="2573" y="772"/>
                  </a:lnTo>
                  <a:lnTo>
                    <a:pt x="2574" y="771"/>
                  </a:lnTo>
                  <a:lnTo>
                    <a:pt x="2574" y="770"/>
                  </a:lnTo>
                  <a:lnTo>
                    <a:pt x="2575" y="769"/>
                  </a:lnTo>
                  <a:lnTo>
                    <a:pt x="2575" y="768"/>
                  </a:lnTo>
                  <a:lnTo>
                    <a:pt x="2576" y="767"/>
                  </a:lnTo>
                  <a:lnTo>
                    <a:pt x="2577" y="766"/>
                  </a:lnTo>
                  <a:lnTo>
                    <a:pt x="2577" y="765"/>
                  </a:lnTo>
                  <a:lnTo>
                    <a:pt x="2578" y="764"/>
                  </a:lnTo>
                  <a:lnTo>
                    <a:pt x="2578" y="763"/>
                  </a:lnTo>
                  <a:lnTo>
                    <a:pt x="2579" y="762"/>
                  </a:lnTo>
                  <a:lnTo>
                    <a:pt x="2580" y="761"/>
                  </a:lnTo>
                  <a:lnTo>
                    <a:pt x="2581" y="760"/>
                  </a:lnTo>
                  <a:lnTo>
                    <a:pt x="2582" y="759"/>
                  </a:lnTo>
                  <a:lnTo>
                    <a:pt x="2583" y="759"/>
                  </a:lnTo>
                  <a:lnTo>
                    <a:pt x="2584" y="759"/>
                  </a:lnTo>
                  <a:lnTo>
                    <a:pt x="2585" y="760"/>
                  </a:lnTo>
                  <a:lnTo>
                    <a:pt x="2586" y="760"/>
                  </a:lnTo>
                  <a:lnTo>
                    <a:pt x="2586" y="761"/>
                  </a:lnTo>
                  <a:lnTo>
                    <a:pt x="2587" y="762"/>
                  </a:lnTo>
                  <a:lnTo>
                    <a:pt x="2587" y="763"/>
                  </a:lnTo>
                  <a:lnTo>
                    <a:pt x="2588" y="765"/>
                  </a:lnTo>
                  <a:lnTo>
                    <a:pt x="2588" y="766"/>
                  </a:lnTo>
                  <a:lnTo>
                    <a:pt x="2589" y="767"/>
                  </a:lnTo>
                  <a:lnTo>
                    <a:pt x="2589" y="768"/>
                  </a:lnTo>
                  <a:lnTo>
                    <a:pt x="2590" y="770"/>
                  </a:lnTo>
                  <a:lnTo>
                    <a:pt x="2590" y="771"/>
                  </a:lnTo>
                  <a:lnTo>
                    <a:pt x="2591" y="773"/>
                  </a:lnTo>
                  <a:lnTo>
                    <a:pt x="2591" y="775"/>
                  </a:lnTo>
                  <a:lnTo>
                    <a:pt x="2592" y="776"/>
                  </a:lnTo>
                  <a:lnTo>
                    <a:pt x="2592" y="778"/>
                  </a:lnTo>
                  <a:lnTo>
                    <a:pt x="2593" y="780"/>
                  </a:lnTo>
                  <a:lnTo>
                    <a:pt x="2593" y="782"/>
                  </a:lnTo>
                  <a:lnTo>
                    <a:pt x="2594" y="783"/>
                  </a:lnTo>
                  <a:lnTo>
                    <a:pt x="2594" y="785"/>
                  </a:lnTo>
                  <a:lnTo>
                    <a:pt x="2595" y="787"/>
                  </a:lnTo>
                  <a:lnTo>
                    <a:pt x="2595" y="789"/>
                  </a:lnTo>
                  <a:lnTo>
                    <a:pt x="2595" y="791"/>
                  </a:lnTo>
                  <a:lnTo>
                    <a:pt x="2596" y="793"/>
                  </a:lnTo>
                  <a:lnTo>
                    <a:pt x="2596" y="795"/>
                  </a:lnTo>
                  <a:lnTo>
                    <a:pt x="2597" y="797"/>
                  </a:lnTo>
                  <a:lnTo>
                    <a:pt x="2597" y="799"/>
                  </a:lnTo>
                  <a:lnTo>
                    <a:pt x="2598" y="801"/>
                  </a:lnTo>
                  <a:lnTo>
                    <a:pt x="2598" y="803"/>
                  </a:lnTo>
                  <a:lnTo>
                    <a:pt x="2599" y="804"/>
                  </a:lnTo>
                  <a:lnTo>
                    <a:pt x="2599" y="806"/>
                  </a:lnTo>
                  <a:lnTo>
                    <a:pt x="2600" y="808"/>
                  </a:lnTo>
                  <a:lnTo>
                    <a:pt x="2600" y="809"/>
                  </a:lnTo>
                  <a:lnTo>
                    <a:pt x="2601" y="811"/>
                  </a:lnTo>
                  <a:lnTo>
                    <a:pt x="2601" y="813"/>
                  </a:lnTo>
                  <a:lnTo>
                    <a:pt x="2602" y="814"/>
                  </a:lnTo>
                  <a:lnTo>
                    <a:pt x="2602" y="816"/>
                  </a:lnTo>
                  <a:lnTo>
                    <a:pt x="2603" y="817"/>
                  </a:lnTo>
                  <a:lnTo>
                    <a:pt x="2603" y="818"/>
                  </a:lnTo>
                  <a:lnTo>
                    <a:pt x="2604" y="820"/>
                  </a:lnTo>
                  <a:lnTo>
                    <a:pt x="2604" y="821"/>
                  </a:lnTo>
                  <a:lnTo>
                    <a:pt x="2604" y="822"/>
                  </a:lnTo>
                  <a:lnTo>
                    <a:pt x="2605" y="823"/>
                  </a:lnTo>
                  <a:lnTo>
                    <a:pt x="2605" y="824"/>
                  </a:lnTo>
                  <a:lnTo>
                    <a:pt x="2606" y="825"/>
                  </a:lnTo>
                  <a:lnTo>
                    <a:pt x="2606" y="826"/>
                  </a:lnTo>
                  <a:lnTo>
                    <a:pt x="2607" y="826"/>
                  </a:lnTo>
                  <a:lnTo>
                    <a:pt x="2607" y="827"/>
                  </a:lnTo>
                  <a:lnTo>
                    <a:pt x="2608" y="827"/>
                  </a:lnTo>
                  <a:lnTo>
                    <a:pt x="2608" y="828"/>
                  </a:lnTo>
                  <a:lnTo>
                    <a:pt x="2609" y="828"/>
                  </a:lnTo>
                  <a:lnTo>
                    <a:pt x="2610" y="828"/>
                  </a:lnTo>
                  <a:lnTo>
                    <a:pt x="2611" y="828"/>
                  </a:lnTo>
                  <a:lnTo>
                    <a:pt x="2612" y="827"/>
                  </a:lnTo>
                  <a:lnTo>
                    <a:pt x="2612" y="826"/>
                  </a:lnTo>
                  <a:lnTo>
                    <a:pt x="2613" y="825"/>
                  </a:lnTo>
                  <a:lnTo>
                    <a:pt x="2613" y="824"/>
                  </a:lnTo>
                  <a:lnTo>
                    <a:pt x="2614" y="823"/>
                  </a:lnTo>
                  <a:lnTo>
                    <a:pt x="2614" y="822"/>
                  </a:lnTo>
                  <a:lnTo>
                    <a:pt x="2615" y="821"/>
                  </a:lnTo>
                  <a:lnTo>
                    <a:pt x="2615" y="820"/>
                  </a:lnTo>
                  <a:lnTo>
                    <a:pt x="2616" y="819"/>
                  </a:lnTo>
                  <a:lnTo>
                    <a:pt x="2616" y="818"/>
                  </a:lnTo>
                  <a:lnTo>
                    <a:pt x="2617" y="817"/>
                  </a:lnTo>
                  <a:lnTo>
                    <a:pt x="2617" y="816"/>
                  </a:lnTo>
                  <a:lnTo>
                    <a:pt x="2618" y="814"/>
                  </a:lnTo>
                  <a:lnTo>
                    <a:pt x="2618" y="813"/>
                  </a:lnTo>
                  <a:lnTo>
                    <a:pt x="2619" y="812"/>
                  </a:lnTo>
                  <a:lnTo>
                    <a:pt x="2619" y="811"/>
                  </a:lnTo>
                  <a:lnTo>
                    <a:pt x="2620" y="809"/>
                  </a:lnTo>
                  <a:lnTo>
                    <a:pt x="2620" y="808"/>
                  </a:lnTo>
                  <a:lnTo>
                    <a:pt x="2621" y="807"/>
                  </a:lnTo>
                  <a:lnTo>
                    <a:pt x="2621" y="806"/>
                  </a:lnTo>
                  <a:lnTo>
                    <a:pt x="2621" y="805"/>
                  </a:lnTo>
                  <a:lnTo>
                    <a:pt x="2622" y="804"/>
                  </a:lnTo>
                  <a:lnTo>
                    <a:pt x="2622" y="803"/>
                  </a:lnTo>
                  <a:lnTo>
                    <a:pt x="2623" y="802"/>
                  </a:lnTo>
                  <a:lnTo>
                    <a:pt x="2623" y="801"/>
                  </a:lnTo>
                  <a:lnTo>
                    <a:pt x="2624" y="801"/>
                  </a:lnTo>
                  <a:lnTo>
                    <a:pt x="2624" y="800"/>
                  </a:lnTo>
                  <a:lnTo>
                    <a:pt x="2625" y="799"/>
                  </a:lnTo>
                  <a:lnTo>
                    <a:pt x="2626" y="798"/>
                  </a:lnTo>
                  <a:lnTo>
                    <a:pt x="2627" y="797"/>
                  </a:lnTo>
                  <a:lnTo>
                    <a:pt x="2628" y="796"/>
                  </a:lnTo>
                  <a:lnTo>
                    <a:pt x="2629" y="795"/>
                  </a:lnTo>
                  <a:lnTo>
                    <a:pt x="2630" y="794"/>
                  </a:lnTo>
                  <a:lnTo>
                    <a:pt x="2631" y="794"/>
                  </a:lnTo>
                  <a:lnTo>
                    <a:pt x="2631" y="793"/>
                  </a:lnTo>
                  <a:lnTo>
                    <a:pt x="2632" y="793"/>
                  </a:lnTo>
                  <a:lnTo>
                    <a:pt x="2633" y="792"/>
                  </a:lnTo>
                  <a:lnTo>
                    <a:pt x="2634" y="792"/>
                  </a:lnTo>
                  <a:lnTo>
                    <a:pt x="2635" y="791"/>
                  </a:lnTo>
                  <a:lnTo>
                    <a:pt x="2636" y="791"/>
                  </a:lnTo>
                  <a:lnTo>
                    <a:pt x="2637" y="790"/>
                  </a:lnTo>
                  <a:lnTo>
                    <a:pt x="2638" y="790"/>
                  </a:lnTo>
                  <a:lnTo>
                    <a:pt x="2638" y="789"/>
                  </a:lnTo>
                  <a:lnTo>
                    <a:pt x="2639" y="789"/>
                  </a:lnTo>
                  <a:lnTo>
                    <a:pt x="2639" y="788"/>
                  </a:lnTo>
                  <a:lnTo>
                    <a:pt x="2640" y="788"/>
                  </a:lnTo>
                  <a:lnTo>
                    <a:pt x="2640" y="787"/>
                  </a:lnTo>
                  <a:lnTo>
                    <a:pt x="2641" y="787"/>
                  </a:lnTo>
                  <a:lnTo>
                    <a:pt x="2641" y="786"/>
                  </a:lnTo>
                  <a:lnTo>
                    <a:pt x="2642" y="786"/>
                  </a:lnTo>
                  <a:lnTo>
                    <a:pt x="2642" y="785"/>
                  </a:lnTo>
                  <a:lnTo>
                    <a:pt x="2643" y="784"/>
                  </a:lnTo>
                  <a:lnTo>
                    <a:pt x="2644" y="783"/>
                  </a:lnTo>
                  <a:lnTo>
                    <a:pt x="2644" y="782"/>
                  </a:lnTo>
                  <a:lnTo>
                    <a:pt x="2645" y="782"/>
                  </a:lnTo>
                  <a:lnTo>
                    <a:pt x="2645" y="781"/>
                  </a:lnTo>
                  <a:lnTo>
                    <a:pt x="2646" y="780"/>
                  </a:lnTo>
                  <a:lnTo>
                    <a:pt x="2646" y="779"/>
                  </a:lnTo>
                  <a:lnTo>
                    <a:pt x="2647" y="778"/>
                  </a:lnTo>
                  <a:lnTo>
                    <a:pt x="2647" y="776"/>
                  </a:lnTo>
                  <a:lnTo>
                    <a:pt x="2647" y="775"/>
                  </a:lnTo>
                  <a:lnTo>
                    <a:pt x="2648" y="774"/>
                  </a:lnTo>
                  <a:lnTo>
                    <a:pt x="2648" y="773"/>
                  </a:lnTo>
                  <a:lnTo>
                    <a:pt x="2649" y="772"/>
                  </a:lnTo>
                  <a:lnTo>
                    <a:pt x="2649" y="771"/>
                  </a:lnTo>
                  <a:lnTo>
                    <a:pt x="2650" y="770"/>
                  </a:lnTo>
                  <a:lnTo>
                    <a:pt x="2650" y="768"/>
                  </a:lnTo>
                  <a:lnTo>
                    <a:pt x="2651" y="767"/>
                  </a:lnTo>
                  <a:lnTo>
                    <a:pt x="2651" y="766"/>
                  </a:lnTo>
                  <a:lnTo>
                    <a:pt x="2652" y="765"/>
                  </a:lnTo>
                  <a:lnTo>
                    <a:pt x="2653" y="764"/>
                  </a:lnTo>
                  <a:lnTo>
                    <a:pt x="2653" y="763"/>
                  </a:lnTo>
                  <a:lnTo>
                    <a:pt x="2654" y="763"/>
                  </a:lnTo>
                  <a:lnTo>
                    <a:pt x="2654" y="762"/>
                  </a:lnTo>
                  <a:lnTo>
                    <a:pt x="2655" y="762"/>
                  </a:lnTo>
                  <a:lnTo>
                    <a:pt x="2656" y="762"/>
                  </a:lnTo>
                  <a:lnTo>
                    <a:pt x="2657" y="763"/>
                  </a:lnTo>
                  <a:lnTo>
                    <a:pt x="2658" y="764"/>
                  </a:lnTo>
                  <a:lnTo>
                    <a:pt x="2658" y="766"/>
                  </a:lnTo>
                  <a:lnTo>
                    <a:pt x="2659" y="767"/>
                  </a:lnTo>
                  <a:lnTo>
                    <a:pt x="2659" y="769"/>
                  </a:lnTo>
                  <a:lnTo>
                    <a:pt x="2660" y="771"/>
                  </a:lnTo>
                  <a:lnTo>
                    <a:pt x="2660" y="773"/>
                  </a:lnTo>
                  <a:lnTo>
                    <a:pt x="2661" y="775"/>
                  </a:lnTo>
                  <a:lnTo>
                    <a:pt x="2661" y="777"/>
                  </a:lnTo>
                  <a:lnTo>
                    <a:pt x="2662" y="779"/>
                  </a:lnTo>
                  <a:lnTo>
                    <a:pt x="2662" y="781"/>
                  </a:lnTo>
                  <a:lnTo>
                    <a:pt x="2663" y="783"/>
                  </a:lnTo>
                  <a:lnTo>
                    <a:pt x="2663" y="786"/>
                  </a:lnTo>
                  <a:lnTo>
                    <a:pt x="2664" y="788"/>
                  </a:lnTo>
                  <a:lnTo>
                    <a:pt x="2664" y="790"/>
                  </a:lnTo>
                  <a:lnTo>
                    <a:pt x="2664" y="792"/>
                  </a:lnTo>
                  <a:lnTo>
                    <a:pt x="2665" y="794"/>
                  </a:lnTo>
                  <a:lnTo>
                    <a:pt x="2665" y="797"/>
                  </a:lnTo>
                  <a:lnTo>
                    <a:pt x="2666" y="799"/>
                  </a:lnTo>
                  <a:lnTo>
                    <a:pt x="2666" y="800"/>
                  </a:lnTo>
                  <a:lnTo>
                    <a:pt x="2667" y="802"/>
                  </a:lnTo>
                  <a:lnTo>
                    <a:pt x="2667" y="804"/>
                  </a:lnTo>
                  <a:lnTo>
                    <a:pt x="2668" y="805"/>
                  </a:lnTo>
                  <a:lnTo>
                    <a:pt x="2668" y="807"/>
                  </a:lnTo>
                  <a:lnTo>
                    <a:pt x="2669" y="808"/>
                  </a:lnTo>
                  <a:lnTo>
                    <a:pt x="2669" y="809"/>
                  </a:lnTo>
                  <a:lnTo>
                    <a:pt x="2670" y="809"/>
                  </a:lnTo>
                  <a:lnTo>
                    <a:pt x="2671" y="809"/>
                  </a:lnTo>
                  <a:lnTo>
                    <a:pt x="2672" y="808"/>
                  </a:lnTo>
                  <a:lnTo>
                    <a:pt x="2672" y="807"/>
                  </a:lnTo>
                  <a:lnTo>
                    <a:pt x="2673" y="806"/>
                  </a:lnTo>
                  <a:lnTo>
                    <a:pt x="2673" y="805"/>
                  </a:lnTo>
                  <a:lnTo>
                    <a:pt x="2674" y="804"/>
                  </a:lnTo>
                  <a:lnTo>
                    <a:pt x="2674" y="803"/>
                  </a:lnTo>
                  <a:lnTo>
                    <a:pt x="2675" y="802"/>
                  </a:lnTo>
                  <a:lnTo>
                    <a:pt x="2675" y="801"/>
                  </a:lnTo>
                  <a:lnTo>
                    <a:pt x="2676" y="800"/>
                  </a:lnTo>
                  <a:lnTo>
                    <a:pt x="2676" y="799"/>
                  </a:lnTo>
                  <a:lnTo>
                    <a:pt x="2677" y="798"/>
                  </a:lnTo>
                  <a:lnTo>
                    <a:pt x="2677" y="797"/>
                  </a:lnTo>
                  <a:lnTo>
                    <a:pt x="2678" y="796"/>
                  </a:lnTo>
                  <a:lnTo>
                    <a:pt x="2678" y="795"/>
                  </a:lnTo>
                  <a:lnTo>
                    <a:pt x="2679" y="794"/>
                  </a:lnTo>
                  <a:lnTo>
                    <a:pt x="2679" y="793"/>
                  </a:lnTo>
                  <a:lnTo>
                    <a:pt x="2680" y="792"/>
                  </a:lnTo>
                  <a:lnTo>
                    <a:pt x="2680" y="791"/>
                  </a:lnTo>
                  <a:lnTo>
                    <a:pt x="2681" y="791"/>
                  </a:lnTo>
                  <a:lnTo>
                    <a:pt x="2681" y="790"/>
                  </a:lnTo>
                  <a:lnTo>
                    <a:pt x="2682" y="791"/>
                  </a:lnTo>
                  <a:lnTo>
                    <a:pt x="2683" y="792"/>
                  </a:lnTo>
                  <a:lnTo>
                    <a:pt x="2684" y="793"/>
                  </a:lnTo>
                  <a:lnTo>
                    <a:pt x="2684" y="794"/>
                  </a:lnTo>
                  <a:lnTo>
                    <a:pt x="2685" y="795"/>
                  </a:lnTo>
                  <a:lnTo>
                    <a:pt x="2685" y="796"/>
                  </a:lnTo>
                  <a:lnTo>
                    <a:pt x="2686" y="797"/>
                  </a:lnTo>
                  <a:lnTo>
                    <a:pt x="2686" y="798"/>
                  </a:lnTo>
                  <a:lnTo>
                    <a:pt x="2687" y="799"/>
                  </a:lnTo>
                  <a:lnTo>
                    <a:pt x="2687" y="800"/>
                  </a:lnTo>
                  <a:lnTo>
                    <a:pt x="2688" y="801"/>
                  </a:lnTo>
                  <a:lnTo>
                    <a:pt x="2688" y="802"/>
                  </a:lnTo>
                  <a:lnTo>
                    <a:pt x="2689" y="804"/>
                  </a:lnTo>
                  <a:lnTo>
                    <a:pt x="2689" y="805"/>
                  </a:lnTo>
                  <a:lnTo>
                    <a:pt x="2689" y="806"/>
                  </a:lnTo>
                  <a:lnTo>
                    <a:pt x="2690" y="807"/>
                  </a:lnTo>
                  <a:lnTo>
                    <a:pt x="2690" y="808"/>
                  </a:lnTo>
                  <a:lnTo>
                    <a:pt x="2691" y="809"/>
                  </a:lnTo>
                  <a:lnTo>
                    <a:pt x="2691" y="810"/>
                  </a:lnTo>
                  <a:lnTo>
                    <a:pt x="2692" y="811"/>
                  </a:lnTo>
                  <a:lnTo>
                    <a:pt x="2692" y="812"/>
                  </a:lnTo>
                  <a:lnTo>
                    <a:pt x="2693" y="813"/>
                  </a:lnTo>
                  <a:lnTo>
                    <a:pt x="2694" y="814"/>
                  </a:lnTo>
                  <a:lnTo>
                    <a:pt x="2695" y="814"/>
                  </a:lnTo>
                  <a:lnTo>
                    <a:pt x="2696" y="814"/>
                  </a:lnTo>
                  <a:lnTo>
                    <a:pt x="2697" y="813"/>
                  </a:lnTo>
                  <a:lnTo>
                    <a:pt x="2698" y="813"/>
                  </a:lnTo>
                  <a:lnTo>
                    <a:pt x="2698" y="812"/>
                  </a:lnTo>
                  <a:lnTo>
                    <a:pt x="2699" y="811"/>
                  </a:lnTo>
                  <a:lnTo>
                    <a:pt x="2699" y="810"/>
                  </a:lnTo>
                  <a:lnTo>
                    <a:pt x="2700" y="810"/>
                  </a:lnTo>
                  <a:lnTo>
                    <a:pt x="2700" y="809"/>
                  </a:lnTo>
                  <a:lnTo>
                    <a:pt x="2701" y="808"/>
                  </a:lnTo>
                  <a:lnTo>
                    <a:pt x="2701" y="807"/>
                  </a:lnTo>
                  <a:lnTo>
                    <a:pt x="2702" y="807"/>
                  </a:lnTo>
                  <a:lnTo>
                    <a:pt x="2702" y="806"/>
                  </a:lnTo>
                  <a:lnTo>
                    <a:pt x="2703" y="805"/>
                  </a:lnTo>
                  <a:lnTo>
                    <a:pt x="2703" y="804"/>
                  </a:lnTo>
                  <a:lnTo>
                    <a:pt x="2704" y="803"/>
                  </a:lnTo>
                  <a:lnTo>
                    <a:pt x="2704" y="802"/>
                  </a:lnTo>
                  <a:lnTo>
                    <a:pt x="2705" y="801"/>
                  </a:lnTo>
                  <a:lnTo>
                    <a:pt x="2705" y="800"/>
                  </a:lnTo>
                  <a:lnTo>
                    <a:pt x="2706" y="799"/>
                  </a:lnTo>
                  <a:lnTo>
                    <a:pt x="2706" y="798"/>
                  </a:lnTo>
                  <a:lnTo>
                    <a:pt x="2706" y="797"/>
                  </a:lnTo>
                  <a:lnTo>
                    <a:pt x="2707" y="796"/>
                  </a:lnTo>
                  <a:lnTo>
                    <a:pt x="2707" y="795"/>
                  </a:lnTo>
                  <a:lnTo>
                    <a:pt x="2708" y="794"/>
                  </a:lnTo>
                  <a:lnTo>
                    <a:pt x="2708" y="793"/>
                  </a:lnTo>
                  <a:lnTo>
                    <a:pt x="2709" y="792"/>
                  </a:lnTo>
                  <a:lnTo>
                    <a:pt x="2709" y="791"/>
                  </a:lnTo>
                  <a:lnTo>
                    <a:pt x="2710" y="790"/>
                  </a:lnTo>
                  <a:lnTo>
                    <a:pt x="2710" y="789"/>
                  </a:lnTo>
                  <a:lnTo>
                    <a:pt x="2711" y="788"/>
                  </a:lnTo>
                  <a:lnTo>
                    <a:pt x="2711" y="787"/>
                  </a:lnTo>
                  <a:lnTo>
                    <a:pt x="2712" y="786"/>
                  </a:lnTo>
                  <a:lnTo>
                    <a:pt x="2712" y="784"/>
                  </a:lnTo>
                  <a:lnTo>
                    <a:pt x="2713" y="783"/>
                  </a:lnTo>
                  <a:lnTo>
                    <a:pt x="2713" y="782"/>
                  </a:lnTo>
                  <a:lnTo>
                    <a:pt x="2714" y="781"/>
                  </a:lnTo>
                  <a:lnTo>
                    <a:pt x="2714" y="779"/>
                  </a:lnTo>
                  <a:lnTo>
                    <a:pt x="2715" y="778"/>
                  </a:lnTo>
                  <a:lnTo>
                    <a:pt x="2715" y="777"/>
                  </a:lnTo>
                  <a:lnTo>
                    <a:pt x="2715" y="775"/>
                  </a:lnTo>
                  <a:lnTo>
                    <a:pt x="2716" y="774"/>
                  </a:lnTo>
                  <a:lnTo>
                    <a:pt x="2716" y="772"/>
                  </a:lnTo>
                  <a:lnTo>
                    <a:pt x="2717" y="771"/>
                  </a:lnTo>
                  <a:lnTo>
                    <a:pt x="2717" y="769"/>
                  </a:lnTo>
                  <a:lnTo>
                    <a:pt x="2718" y="767"/>
                  </a:lnTo>
                  <a:lnTo>
                    <a:pt x="2718" y="766"/>
                  </a:lnTo>
                  <a:lnTo>
                    <a:pt x="2719" y="764"/>
                  </a:lnTo>
                  <a:lnTo>
                    <a:pt x="2719" y="762"/>
                  </a:lnTo>
                  <a:lnTo>
                    <a:pt x="2720" y="760"/>
                  </a:lnTo>
                  <a:lnTo>
                    <a:pt x="2720" y="758"/>
                  </a:lnTo>
                  <a:lnTo>
                    <a:pt x="2721" y="757"/>
                  </a:lnTo>
                  <a:lnTo>
                    <a:pt x="2721" y="755"/>
                  </a:lnTo>
                  <a:lnTo>
                    <a:pt x="2722" y="753"/>
                  </a:lnTo>
                  <a:lnTo>
                    <a:pt x="2722" y="751"/>
                  </a:lnTo>
                  <a:lnTo>
                    <a:pt x="2723" y="750"/>
                  </a:lnTo>
                  <a:lnTo>
                    <a:pt x="2723" y="748"/>
                  </a:lnTo>
                  <a:lnTo>
                    <a:pt x="2724" y="746"/>
                  </a:lnTo>
                  <a:lnTo>
                    <a:pt x="2724" y="744"/>
                  </a:lnTo>
                  <a:lnTo>
                    <a:pt x="2724" y="742"/>
                  </a:lnTo>
                  <a:lnTo>
                    <a:pt x="2725" y="741"/>
                  </a:lnTo>
                  <a:lnTo>
                    <a:pt x="2725" y="739"/>
                  </a:lnTo>
                  <a:lnTo>
                    <a:pt x="2726" y="737"/>
                  </a:lnTo>
                  <a:lnTo>
                    <a:pt x="2726" y="736"/>
                  </a:lnTo>
                  <a:lnTo>
                    <a:pt x="2727" y="734"/>
                  </a:lnTo>
                  <a:lnTo>
                    <a:pt x="2727" y="733"/>
                  </a:lnTo>
                  <a:lnTo>
                    <a:pt x="2728" y="731"/>
                  </a:lnTo>
                  <a:lnTo>
                    <a:pt x="2728" y="730"/>
                  </a:lnTo>
                  <a:lnTo>
                    <a:pt x="2729" y="729"/>
                  </a:lnTo>
                  <a:lnTo>
                    <a:pt x="2729" y="727"/>
                  </a:lnTo>
                  <a:lnTo>
                    <a:pt x="2730" y="726"/>
                  </a:lnTo>
                  <a:lnTo>
                    <a:pt x="2730" y="725"/>
                  </a:lnTo>
                  <a:lnTo>
                    <a:pt x="2731" y="724"/>
                  </a:lnTo>
                  <a:lnTo>
                    <a:pt x="2731" y="723"/>
                  </a:lnTo>
                  <a:lnTo>
                    <a:pt x="2732" y="722"/>
                  </a:lnTo>
                  <a:lnTo>
                    <a:pt x="2732" y="721"/>
                  </a:lnTo>
                  <a:lnTo>
                    <a:pt x="2732" y="720"/>
                  </a:lnTo>
                  <a:lnTo>
                    <a:pt x="2733" y="719"/>
                  </a:lnTo>
                  <a:lnTo>
                    <a:pt x="2733" y="718"/>
                  </a:lnTo>
                  <a:lnTo>
                    <a:pt x="2734" y="717"/>
                  </a:lnTo>
                  <a:lnTo>
                    <a:pt x="2735" y="716"/>
                  </a:lnTo>
                  <a:lnTo>
                    <a:pt x="2735" y="715"/>
                  </a:lnTo>
                  <a:lnTo>
                    <a:pt x="2736" y="715"/>
                  </a:lnTo>
                  <a:lnTo>
                    <a:pt x="2736" y="714"/>
                  </a:lnTo>
                  <a:lnTo>
                    <a:pt x="2737" y="713"/>
                  </a:lnTo>
                  <a:lnTo>
                    <a:pt x="2738" y="712"/>
                  </a:lnTo>
                  <a:lnTo>
                    <a:pt x="2739" y="711"/>
                  </a:lnTo>
                  <a:lnTo>
                    <a:pt x="2740" y="711"/>
                  </a:lnTo>
                  <a:lnTo>
                    <a:pt x="2740" y="710"/>
                  </a:lnTo>
                  <a:lnTo>
                    <a:pt x="2741" y="710"/>
                  </a:lnTo>
                  <a:lnTo>
                    <a:pt x="2741" y="709"/>
                  </a:lnTo>
                  <a:lnTo>
                    <a:pt x="2742" y="709"/>
                  </a:lnTo>
                  <a:lnTo>
                    <a:pt x="2743" y="709"/>
                  </a:lnTo>
                  <a:lnTo>
                    <a:pt x="2744" y="708"/>
                  </a:lnTo>
                  <a:lnTo>
                    <a:pt x="2745" y="708"/>
                  </a:lnTo>
                  <a:lnTo>
                    <a:pt x="2746" y="708"/>
                  </a:lnTo>
                  <a:lnTo>
                    <a:pt x="2747" y="708"/>
                  </a:lnTo>
                  <a:lnTo>
                    <a:pt x="2748" y="708"/>
                  </a:lnTo>
                  <a:lnTo>
                    <a:pt x="2749" y="708"/>
                  </a:lnTo>
                  <a:lnTo>
                    <a:pt x="2749" y="707"/>
                  </a:lnTo>
                  <a:lnTo>
                    <a:pt x="2750" y="707"/>
                  </a:lnTo>
                  <a:lnTo>
                    <a:pt x="2751" y="707"/>
                  </a:lnTo>
                  <a:lnTo>
                    <a:pt x="2752" y="707"/>
                  </a:lnTo>
                  <a:lnTo>
                    <a:pt x="2753" y="707"/>
                  </a:lnTo>
                  <a:lnTo>
                    <a:pt x="2754" y="707"/>
                  </a:lnTo>
                  <a:lnTo>
                    <a:pt x="2755" y="707"/>
                  </a:lnTo>
                  <a:lnTo>
                    <a:pt x="2756" y="707"/>
                  </a:lnTo>
                  <a:lnTo>
                    <a:pt x="2757" y="707"/>
                  </a:lnTo>
                  <a:lnTo>
                    <a:pt x="2758" y="707"/>
                  </a:lnTo>
                  <a:lnTo>
                    <a:pt x="2758" y="706"/>
                  </a:lnTo>
                  <a:lnTo>
                    <a:pt x="2759" y="706"/>
                  </a:lnTo>
                  <a:lnTo>
                    <a:pt x="2760" y="706"/>
                  </a:lnTo>
                  <a:lnTo>
                    <a:pt x="2760" y="707"/>
                  </a:lnTo>
                  <a:lnTo>
                    <a:pt x="2761" y="707"/>
                  </a:lnTo>
                  <a:lnTo>
                    <a:pt x="2762" y="707"/>
                  </a:lnTo>
                  <a:lnTo>
                    <a:pt x="2763" y="707"/>
                  </a:lnTo>
                  <a:lnTo>
                    <a:pt x="2764" y="707"/>
                  </a:lnTo>
                  <a:lnTo>
                    <a:pt x="2765" y="708"/>
                  </a:lnTo>
                  <a:lnTo>
                    <a:pt x="2766" y="708"/>
                  </a:lnTo>
                  <a:lnTo>
                    <a:pt x="2766" y="709"/>
                  </a:lnTo>
                  <a:lnTo>
                    <a:pt x="2767" y="709"/>
                  </a:lnTo>
                  <a:lnTo>
                    <a:pt x="2767" y="710"/>
                  </a:lnTo>
                  <a:lnTo>
                    <a:pt x="2768" y="710"/>
                  </a:lnTo>
                  <a:lnTo>
                    <a:pt x="2769" y="711"/>
                  </a:lnTo>
                  <a:lnTo>
                    <a:pt x="2770" y="711"/>
                  </a:lnTo>
                  <a:lnTo>
                    <a:pt x="2771" y="712"/>
                  </a:lnTo>
                  <a:lnTo>
                    <a:pt x="2772" y="712"/>
                  </a:lnTo>
                  <a:lnTo>
                    <a:pt x="2772" y="713"/>
                  </a:lnTo>
                  <a:lnTo>
                    <a:pt x="2773" y="713"/>
                  </a:lnTo>
                  <a:lnTo>
                    <a:pt x="2774" y="713"/>
                  </a:lnTo>
                  <a:lnTo>
                    <a:pt x="2775" y="713"/>
                  </a:lnTo>
                  <a:lnTo>
                    <a:pt x="2776" y="713"/>
                  </a:lnTo>
                  <a:lnTo>
                    <a:pt x="2777" y="713"/>
                  </a:lnTo>
                  <a:lnTo>
                    <a:pt x="2777" y="712"/>
                  </a:lnTo>
                  <a:lnTo>
                    <a:pt x="2778" y="712"/>
                  </a:lnTo>
                  <a:lnTo>
                    <a:pt x="2779" y="712"/>
                  </a:lnTo>
                  <a:lnTo>
                    <a:pt x="2779" y="711"/>
                  </a:lnTo>
                  <a:lnTo>
                    <a:pt x="2780" y="711"/>
                  </a:lnTo>
                  <a:lnTo>
                    <a:pt x="2780" y="710"/>
                  </a:lnTo>
                  <a:lnTo>
                    <a:pt x="2781" y="710"/>
                  </a:lnTo>
                  <a:lnTo>
                    <a:pt x="2782" y="709"/>
                  </a:lnTo>
                  <a:lnTo>
                    <a:pt x="2783" y="708"/>
                  </a:lnTo>
                  <a:lnTo>
                    <a:pt x="2784" y="707"/>
                  </a:lnTo>
                  <a:lnTo>
                    <a:pt x="2784" y="706"/>
                  </a:lnTo>
                  <a:lnTo>
                    <a:pt x="2785" y="706"/>
                  </a:lnTo>
                  <a:lnTo>
                    <a:pt x="2786" y="705"/>
                  </a:lnTo>
                  <a:lnTo>
                    <a:pt x="2787" y="704"/>
                  </a:lnTo>
                  <a:lnTo>
                    <a:pt x="2788" y="704"/>
                  </a:lnTo>
                  <a:lnTo>
                    <a:pt x="2789" y="703"/>
                  </a:lnTo>
                  <a:lnTo>
                    <a:pt x="2790" y="703"/>
                  </a:lnTo>
                  <a:lnTo>
                    <a:pt x="2791" y="703"/>
                  </a:lnTo>
                  <a:lnTo>
                    <a:pt x="2792" y="703"/>
                  </a:lnTo>
                  <a:lnTo>
                    <a:pt x="2793" y="702"/>
                  </a:lnTo>
                  <a:lnTo>
                    <a:pt x="2794" y="702"/>
                  </a:lnTo>
                  <a:lnTo>
                    <a:pt x="2795" y="702"/>
                  </a:lnTo>
                  <a:lnTo>
                    <a:pt x="2796" y="702"/>
                  </a:lnTo>
                  <a:lnTo>
                    <a:pt x="2797" y="702"/>
                  </a:lnTo>
                  <a:lnTo>
                    <a:pt x="2798" y="703"/>
                  </a:lnTo>
                  <a:lnTo>
                    <a:pt x="2799" y="703"/>
                  </a:lnTo>
                  <a:lnTo>
                    <a:pt x="2800" y="702"/>
                  </a:lnTo>
                  <a:lnTo>
                    <a:pt x="2801" y="702"/>
                  </a:lnTo>
                  <a:lnTo>
                    <a:pt x="2802" y="702"/>
                  </a:lnTo>
                  <a:lnTo>
                    <a:pt x="2803" y="701"/>
                  </a:lnTo>
                  <a:lnTo>
                    <a:pt x="2804" y="701"/>
                  </a:lnTo>
                  <a:lnTo>
                    <a:pt x="2805" y="701"/>
                  </a:lnTo>
                  <a:lnTo>
                    <a:pt x="2806" y="701"/>
                  </a:lnTo>
                  <a:lnTo>
                    <a:pt x="2807" y="701"/>
                  </a:lnTo>
                  <a:lnTo>
                    <a:pt x="2808" y="701"/>
                  </a:lnTo>
                  <a:lnTo>
                    <a:pt x="2809" y="701"/>
                  </a:lnTo>
                  <a:lnTo>
                    <a:pt x="2810" y="701"/>
                  </a:lnTo>
                  <a:lnTo>
                    <a:pt x="2811" y="701"/>
                  </a:lnTo>
                  <a:lnTo>
                    <a:pt x="2812" y="702"/>
                  </a:lnTo>
                  <a:lnTo>
                    <a:pt x="2813" y="702"/>
                  </a:lnTo>
                  <a:lnTo>
                    <a:pt x="2813" y="703"/>
                  </a:lnTo>
                  <a:lnTo>
                    <a:pt x="2814" y="703"/>
                  </a:lnTo>
                  <a:lnTo>
                    <a:pt x="2815" y="704"/>
                  </a:lnTo>
                  <a:lnTo>
                    <a:pt x="2816" y="704"/>
                  </a:lnTo>
                  <a:lnTo>
                    <a:pt x="2817" y="705"/>
                  </a:lnTo>
                  <a:lnTo>
                    <a:pt x="2818" y="705"/>
                  </a:lnTo>
                  <a:lnTo>
                    <a:pt x="2819" y="704"/>
                  </a:lnTo>
                  <a:lnTo>
                    <a:pt x="2820" y="704"/>
                  </a:lnTo>
                  <a:lnTo>
                    <a:pt x="2820" y="703"/>
                  </a:lnTo>
                  <a:lnTo>
                    <a:pt x="2821" y="703"/>
                  </a:lnTo>
                  <a:lnTo>
                    <a:pt x="2821" y="702"/>
                  </a:lnTo>
                  <a:lnTo>
                    <a:pt x="2822" y="701"/>
                  </a:lnTo>
                  <a:lnTo>
                    <a:pt x="2823" y="700"/>
                  </a:lnTo>
                  <a:lnTo>
                    <a:pt x="2823" y="698"/>
                  </a:lnTo>
                  <a:lnTo>
                    <a:pt x="2824" y="697"/>
                  </a:lnTo>
                  <a:lnTo>
                    <a:pt x="2824" y="695"/>
                  </a:lnTo>
                  <a:lnTo>
                    <a:pt x="2825" y="693"/>
                  </a:lnTo>
                  <a:lnTo>
                    <a:pt x="2825" y="692"/>
                  </a:lnTo>
                  <a:lnTo>
                    <a:pt x="2826" y="690"/>
                  </a:lnTo>
                  <a:lnTo>
                    <a:pt x="2826" y="688"/>
                  </a:lnTo>
                  <a:lnTo>
                    <a:pt x="2826" y="686"/>
                  </a:lnTo>
                  <a:lnTo>
                    <a:pt x="2827" y="683"/>
                  </a:lnTo>
                  <a:lnTo>
                    <a:pt x="2827" y="681"/>
                  </a:lnTo>
                  <a:lnTo>
                    <a:pt x="2828" y="679"/>
                  </a:lnTo>
                  <a:lnTo>
                    <a:pt x="2828" y="677"/>
                  </a:lnTo>
                  <a:lnTo>
                    <a:pt x="2829" y="674"/>
                  </a:lnTo>
                  <a:lnTo>
                    <a:pt x="2829" y="672"/>
                  </a:lnTo>
                  <a:lnTo>
                    <a:pt x="2830" y="670"/>
                  </a:lnTo>
                  <a:lnTo>
                    <a:pt x="2830" y="667"/>
                  </a:lnTo>
                  <a:lnTo>
                    <a:pt x="2831" y="665"/>
                  </a:lnTo>
                  <a:lnTo>
                    <a:pt x="2831" y="663"/>
                  </a:lnTo>
                  <a:lnTo>
                    <a:pt x="2832" y="661"/>
                  </a:lnTo>
                  <a:lnTo>
                    <a:pt x="2832" y="658"/>
                  </a:lnTo>
                  <a:lnTo>
                    <a:pt x="2833" y="656"/>
                  </a:lnTo>
                  <a:lnTo>
                    <a:pt x="2833" y="654"/>
                  </a:lnTo>
                  <a:lnTo>
                    <a:pt x="2834" y="652"/>
                  </a:lnTo>
                  <a:lnTo>
                    <a:pt x="2834" y="650"/>
                  </a:lnTo>
                  <a:lnTo>
                    <a:pt x="2835" y="648"/>
                  </a:lnTo>
                  <a:lnTo>
                    <a:pt x="2835" y="646"/>
                  </a:lnTo>
                  <a:lnTo>
                    <a:pt x="2835" y="645"/>
                  </a:lnTo>
                  <a:lnTo>
                    <a:pt x="2836" y="643"/>
                  </a:lnTo>
                  <a:lnTo>
                    <a:pt x="2836" y="642"/>
                  </a:lnTo>
                  <a:lnTo>
                    <a:pt x="2837" y="641"/>
                  </a:lnTo>
                  <a:lnTo>
                    <a:pt x="2837" y="640"/>
                  </a:lnTo>
                  <a:lnTo>
                    <a:pt x="2838" y="639"/>
                  </a:lnTo>
                  <a:lnTo>
                    <a:pt x="2838" y="638"/>
                  </a:lnTo>
                  <a:lnTo>
                    <a:pt x="2839" y="637"/>
                  </a:lnTo>
                  <a:lnTo>
                    <a:pt x="2839" y="636"/>
                  </a:lnTo>
                  <a:lnTo>
                    <a:pt x="2840" y="635"/>
                  </a:lnTo>
                  <a:lnTo>
                    <a:pt x="2840" y="634"/>
                  </a:lnTo>
                  <a:lnTo>
                    <a:pt x="2841" y="633"/>
                  </a:lnTo>
                  <a:lnTo>
                    <a:pt x="2842" y="632"/>
                  </a:lnTo>
                  <a:lnTo>
                    <a:pt x="2843" y="631"/>
                  </a:lnTo>
                  <a:lnTo>
                    <a:pt x="2844" y="631"/>
                  </a:lnTo>
                  <a:lnTo>
                    <a:pt x="2844" y="630"/>
                  </a:lnTo>
                  <a:lnTo>
                    <a:pt x="2845" y="630"/>
                  </a:lnTo>
                  <a:lnTo>
                    <a:pt x="2846" y="630"/>
                  </a:lnTo>
                  <a:lnTo>
                    <a:pt x="2847" y="630"/>
                  </a:lnTo>
                  <a:lnTo>
                    <a:pt x="2848" y="630"/>
                  </a:lnTo>
                  <a:lnTo>
                    <a:pt x="2849" y="630"/>
                  </a:lnTo>
                  <a:lnTo>
                    <a:pt x="2850" y="630"/>
                  </a:lnTo>
                  <a:lnTo>
                    <a:pt x="2851" y="631"/>
                  </a:lnTo>
                  <a:lnTo>
                    <a:pt x="2852" y="631"/>
                  </a:lnTo>
                  <a:lnTo>
                    <a:pt x="2852" y="632"/>
                  </a:lnTo>
                  <a:lnTo>
                    <a:pt x="2853" y="632"/>
                  </a:lnTo>
                  <a:lnTo>
                    <a:pt x="2853" y="633"/>
                  </a:lnTo>
                  <a:lnTo>
                    <a:pt x="2854" y="633"/>
                  </a:lnTo>
                  <a:lnTo>
                    <a:pt x="2854" y="634"/>
                  </a:lnTo>
                  <a:lnTo>
                    <a:pt x="2855" y="634"/>
                  </a:lnTo>
                  <a:lnTo>
                    <a:pt x="2855" y="635"/>
                  </a:lnTo>
                  <a:lnTo>
                    <a:pt x="2856" y="635"/>
                  </a:lnTo>
                  <a:lnTo>
                    <a:pt x="2856" y="636"/>
                  </a:lnTo>
                  <a:lnTo>
                    <a:pt x="2857" y="637"/>
                  </a:lnTo>
                  <a:lnTo>
                    <a:pt x="2858" y="638"/>
                  </a:lnTo>
                  <a:lnTo>
                    <a:pt x="2858" y="639"/>
                  </a:lnTo>
                  <a:lnTo>
                    <a:pt x="2859" y="640"/>
                  </a:lnTo>
                  <a:lnTo>
                    <a:pt x="2859" y="641"/>
                  </a:lnTo>
                  <a:lnTo>
                    <a:pt x="2860" y="642"/>
                  </a:lnTo>
                  <a:lnTo>
                    <a:pt x="2860" y="643"/>
                  </a:lnTo>
                  <a:lnTo>
                    <a:pt x="2861" y="644"/>
                  </a:lnTo>
                  <a:lnTo>
                    <a:pt x="2861" y="645"/>
                  </a:lnTo>
                  <a:lnTo>
                    <a:pt x="2861" y="646"/>
                  </a:lnTo>
                  <a:lnTo>
                    <a:pt x="2862" y="647"/>
                  </a:lnTo>
                  <a:lnTo>
                    <a:pt x="2862" y="648"/>
                  </a:lnTo>
                  <a:lnTo>
                    <a:pt x="2863" y="649"/>
                  </a:lnTo>
                  <a:lnTo>
                    <a:pt x="2863" y="650"/>
                  </a:lnTo>
                  <a:lnTo>
                    <a:pt x="2864" y="651"/>
                  </a:lnTo>
                  <a:lnTo>
                    <a:pt x="2864" y="652"/>
                  </a:lnTo>
                  <a:lnTo>
                    <a:pt x="2865" y="653"/>
                  </a:lnTo>
                  <a:lnTo>
                    <a:pt x="2865" y="654"/>
                  </a:lnTo>
                  <a:lnTo>
                    <a:pt x="2866" y="655"/>
                  </a:lnTo>
                  <a:lnTo>
                    <a:pt x="2866" y="656"/>
                  </a:lnTo>
                  <a:lnTo>
                    <a:pt x="2867" y="657"/>
                  </a:lnTo>
                  <a:lnTo>
                    <a:pt x="2868" y="658"/>
                  </a:lnTo>
                  <a:lnTo>
                    <a:pt x="2868" y="659"/>
                  </a:lnTo>
                  <a:lnTo>
                    <a:pt x="2869" y="659"/>
                  </a:lnTo>
                  <a:lnTo>
                    <a:pt x="2869" y="660"/>
                  </a:lnTo>
                  <a:lnTo>
                    <a:pt x="2870" y="660"/>
                  </a:lnTo>
                  <a:lnTo>
                    <a:pt x="2871" y="660"/>
                  </a:lnTo>
                  <a:lnTo>
                    <a:pt x="2872" y="660"/>
                  </a:lnTo>
                  <a:lnTo>
                    <a:pt x="2873" y="659"/>
                  </a:lnTo>
                  <a:lnTo>
                    <a:pt x="2874" y="658"/>
                  </a:lnTo>
                  <a:lnTo>
                    <a:pt x="2875" y="657"/>
                  </a:lnTo>
                  <a:lnTo>
                    <a:pt x="2876" y="656"/>
                  </a:lnTo>
                  <a:lnTo>
                    <a:pt x="2877" y="655"/>
                  </a:lnTo>
                  <a:lnTo>
                    <a:pt x="2877" y="654"/>
                  </a:lnTo>
                  <a:lnTo>
                    <a:pt x="2878" y="654"/>
                  </a:lnTo>
                  <a:lnTo>
                    <a:pt x="2878" y="653"/>
                  </a:lnTo>
                  <a:lnTo>
                    <a:pt x="2878" y="652"/>
                  </a:lnTo>
                  <a:lnTo>
                    <a:pt x="2879" y="652"/>
                  </a:lnTo>
                  <a:lnTo>
                    <a:pt x="2879" y="651"/>
                  </a:lnTo>
                  <a:lnTo>
                    <a:pt x="2880" y="650"/>
                  </a:lnTo>
                  <a:lnTo>
                    <a:pt x="2881" y="649"/>
                  </a:lnTo>
                  <a:lnTo>
                    <a:pt x="2882" y="648"/>
                  </a:lnTo>
                  <a:lnTo>
                    <a:pt x="2883" y="647"/>
                  </a:lnTo>
                  <a:lnTo>
                    <a:pt x="2884" y="646"/>
                  </a:lnTo>
                  <a:lnTo>
                    <a:pt x="2885" y="646"/>
                  </a:lnTo>
                  <a:lnTo>
                    <a:pt x="2886" y="646"/>
                  </a:lnTo>
                  <a:lnTo>
                    <a:pt x="2886" y="645"/>
                  </a:lnTo>
                  <a:lnTo>
                    <a:pt x="2887" y="645"/>
                  </a:lnTo>
                  <a:lnTo>
                    <a:pt x="2888" y="645"/>
                  </a:lnTo>
                  <a:lnTo>
                    <a:pt x="2889" y="645"/>
                  </a:lnTo>
                  <a:lnTo>
                    <a:pt x="2889" y="646"/>
                  </a:lnTo>
                  <a:lnTo>
                    <a:pt x="2890" y="646"/>
                  </a:lnTo>
                  <a:lnTo>
                    <a:pt x="2891" y="646"/>
                  </a:lnTo>
                  <a:lnTo>
                    <a:pt x="2892" y="647"/>
                  </a:lnTo>
                  <a:lnTo>
                    <a:pt x="2893" y="647"/>
                  </a:lnTo>
                  <a:lnTo>
                    <a:pt x="2893" y="648"/>
                  </a:lnTo>
                  <a:lnTo>
                    <a:pt x="2894" y="648"/>
                  </a:lnTo>
                  <a:lnTo>
                    <a:pt x="2895" y="649"/>
                  </a:lnTo>
                  <a:lnTo>
                    <a:pt x="2895" y="650"/>
                  </a:lnTo>
                  <a:lnTo>
                    <a:pt x="2896" y="650"/>
                  </a:lnTo>
                  <a:lnTo>
                    <a:pt x="2896" y="651"/>
                  </a:lnTo>
                  <a:lnTo>
                    <a:pt x="2897" y="651"/>
                  </a:lnTo>
                  <a:lnTo>
                    <a:pt x="2898" y="652"/>
                  </a:lnTo>
                  <a:lnTo>
                    <a:pt x="2899" y="653"/>
                  </a:lnTo>
                  <a:lnTo>
                    <a:pt x="2900" y="653"/>
                  </a:lnTo>
                  <a:lnTo>
                    <a:pt x="2901" y="653"/>
                  </a:lnTo>
                  <a:lnTo>
                    <a:pt x="2901" y="654"/>
                  </a:lnTo>
                  <a:lnTo>
                    <a:pt x="2902" y="654"/>
                  </a:lnTo>
                  <a:lnTo>
                    <a:pt x="2903" y="654"/>
                  </a:lnTo>
                  <a:lnTo>
                    <a:pt x="2903" y="653"/>
                  </a:lnTo>
                  <a:lnTo>
                    <a:pt x="2904" y="653"/>
                  </a:lnTo>
                  <a:lnTo>
                    <a:pt x="2904" y="652"/>
                  </a:lnTo>
                  <a:lnTo>
                    <a:pt x="2905" y="652"/>
                  </a:lnTo>
                  <a:lnTo>
                    <a:pt x="2905" y="651"/>
                  </a:lnTo>
                  <a:lnTo>
                    <a:pt x="2906" y="650"/>
                  </a:lnTo>
                  <a:lnTo>
                    <a:pt x="2906" y="649"/>
                  </a:lnTo>
                  <a:lnTo>
                    <a:pt x="2907" y="648"/>
                  </a:lnTo>
                  <a:lnTo>
                    <a:pt x="2907" y="647"/>
                  </a:lnTo>
                  <a:lnTo>
                    <a:pt x="2908" y="646"/>
                  </a:lnTo>
                  <a:lnTo>
                    <a:pt x="2908" y="644"/>
                  </a:lnTo>
                  <a:lnTo>
                    <a:pt x="2909" y="643"/>
                  </a:lnTo>
                  <a:lnTo>
                    <a:pt x="2909" y="641"/>
                  </a:lnTo>
                  <a:lnTo>
                    <a:pt x="2910" y="640"/>
                  </a:lnTo>
                  <a:lnTo>
                    <a:pt x="2910" y="638"/>
                  </a:lnTo>
                  <a:lnTo>
                    <a:pt x="2911" y="636"/>
                  </a:lnTo>
                  <a:lnTo>
                    <a:pt x="2911" y="635"/>
                  </a:lnTo>
                  <a:lnTo>
                    <a:pt x="2912" y="633"/>
                  </a:lnTo>
                  <a:lnTo>
                    <a:pt x="2912" y="631"/>
                  </a:lnTo>
                  <a:lnTo>
                    <a:pt x="2912" y="630"/>
                  </a:lnTo>
                  <a:lnTo>
                    <a:pt x="2913" y="628"/>
                  </a:lnTo>
                  <a:lnTo>
                    <a:pt x="2913" y="626"/>
                  </a:lnTo>
                  <a:lnTo>
                    <a:pt x="2914" y="624"/>
                  </a:lnTo>
                  <a:lnTo>
                    <a:pt x="2914" y="623"/>
                  </a:lnTo>
                  <a:lnTo>
                    <a:pt x="2915" y="621"/>
                  </a:lnTo>
                  <a:lnTo>
                    <a:pt x="2915" y="619"/>
                  </a:lnTo>
                  <a:lnTo>
                    <a:pt x="2916" y="618"/>
                  </a:lnTo>
                  <a:lnTo>
                    <a:pt x="2916" y="616"/>
                  </a:lnTo>
                  <a:lnTo>
                    <a:pt x="2917" y="615"/>
                  </a:lnTo>
                  <a:lnTo>
                    <a:pt x="2917" y="613"/>
                  </a:lnTo>
                  <a:lnTo>
                    <a:pt x="2918" y="612"/>
                  </a:lnTo>
                  <a:lnTo>
                    <a:pt x="2918" y="611"/>
                  </a:lnTo>
                  <a:lnTo>
                    <a:pt x="2919" y="610"/>
                  </a:lnTo>
                  <a:lnTo>
                    <a:pt x="2919" y="609"/>
                  </a:lnTo>
                  <a:lnTo>
                    <a:pt x="2920" y="608"/>
                  </a:lnTo>
                  <a:lnTo>
                    <a:pt x="2920" y="607"/>
                  </a:lnTo>
                  <a:lnTo>
                    <a:pt x="2920" y="606"/>
                  </a:lnTo>
                  <a:lnTo>
                    <a:pt x="2921" y="605"/>
                  </a:lnTo>
                  <a:lnTo>
                    <a:pt x="2921" y="604"/>
                  </a:lnTo>
                  <a:lnTo>
                    <a:pt x="2922" y="603"/>
                  </a:lnTo>
                  <a:lnTo>
                    <a:pt x="2923" y="602"/>
                  </a:lnTo>
                  <a:lnTo>
                    <a:pt x="2923" y="601"/>
                  </a:lnTo>
                  <a:lnTo>
                    <a:pt x="2924" y="601"/>
                  </a:lnTo>
                  <a:lnTo>
                    <a:pt x="2924" y="600"/>
                  </a:lnTo>
                  <a:lnTo>
                    <a:pt x="2925" y="599"/>
                  </a:lnTo>
                  <a:lnTo>
                    <a:pt x="2926" y="598"/>
                  </a:lnTo>
                  <a:lnTo>
                    <a:pt x="2927" y="597"/>
                  </a:lnTo>
                  <a:lnTo>
                    <a:pt x="2928" y="596"/>
                  </a:lnTo>
                  <a:lnTo>
                    <a:pt x="2929" y="595"/>
                  </a:lnTo>
                  <a:lnTo>
                    <a:pt x="2930" y="594"/>
                  </a:lnTo>
                  <a:lnTo>
                    <a:pt x="2931" y="593"/>
                  </a:lnTo>
                  <a:lnTo>
                    <a:pt x="2932" y="592"/>
                  </a:lnTo>
                  <a:lnTo>
                    <a:pt x="2933" y="591"/>
                  </a:lnTo>
                  <a:lnTo>
                    <a:pt x="2934" y="590"/>
                  </a:lnTo>
                  <a:lnTo>
                    <a:pt x="2935" y="590"/>
                  </a:lnTo>
                  <a:lnTo>
                    <a:pt x="2935" y="589"/>
                  </a:lnTo>
                  <a:lnTo>
                    <a:pt x="2936" y="589"/>
                  </a:lnTo>
                  <a:lnTo>
                    <a:pt x="2936" y="588"/>
                  </a:lnTo>
                  <a:lnTo>
                    <a:pt x="2937" y="588"/>
                  </a:lnTo>
                  <a:lnTo>
                    <a:pt x="2938" y="587"/>
                  </a:lnTo>
                  <a:lnTo>
                    <a:pt x="2939" y="587"/>
                  </a:lnTo>
                  <a:lnTo>
                    <a:pt x="2939" y="586"/>
                  </a:lnTo>
                  <a:lnTo>
                    <a:pt x="2940" y="586"/>
                  </a:lnTo>
                  <a:lnTo>
                    <a:pt x="2941" y="586"/>
                  </a:lnTo>
                  <a:lnTo>
                    <a:pt x="2942" y="586"/>
                  </a:lnTo>
                  <a:lnTo>
                    <a:pt x="2943" y="586"/>
                  </a:lnTo>
                  <a:lnTo>
                    <a:pt x="2944" y="586"/>
                  </a:lnTo>
                  <a:lnTo>
                    <a:pt x="2945" y="586"/>
                  </a:lnTo>
                  <a:lnTo>
                    <a:pt x="2946" y="587"/>
                  </a:lnTo>
                  <a:lnTo>
                    <a:pt x="2947" y="587"/>
                  </a:lnTo>
                  <a:lnTo>
                    <a:pt x="2948" y="588"/>
                  </a:lnTo>
                  <a:lnTo>
                    <a:pt x="2949" y="588"/>
                  </a:lnTo>
                  <a:lnTo>
                    <a:pt x="2950" y="589"/>
                  </a:lnTo>
                  <a:lnTo>
                    <a:pt x="2951" y="589"/>
                  </a:lnTo>
                  <a:lnTo>
                    <a:pt x="2951" y="590"/>
                  </a:lnTo>
                  <a:lnTo>
                    <a:pt x="2952" y="590"/>
                  </a:lnTo>
                  <a:lnTo>
                    <a:pt x="2953" y="591"/>
                  </a:lnTo>
                  <a:lnTo>
                    <a:pt x="2954" y="591"/>
                  </a:lnTo>
                  <a:lnTo>
                    <a:pt x="2954" y="592"/>
                  </a:lnTo>
                  <a:lnTo>
                    <a:pt x="2955" y="592"/>
                  </a:lnTo>
                  <a:lnTo>
                    <a:pt x="2955" y="593"/>
                  </a:lnTo>
                  <a:lnTo>
                    <a:pt x="2956" y="593"/>
                  </a:lnTo>
                  <a:lnTo>
                    <a:pt x="2957" y="594"/>
                  </a:lnTo>
                  <a:lnTo>
                    <a:pt x="2958" y="594"/>
                  </a:lnTo>
                  <a:lnTo>
                    <a:pt x="2959" y="594"/>
                  </a:lnTo>
                  <a:lnTo>
                    <a:pt x="2960" y="594"/>
                  </a:lnTo>
                  <a:lnTo>
                    <a:pt x="2961" y="594"/>
                  </a:lnTo>
                  <a:lnTo>
                    <a:pt x="2962" y="594"/>
                  </a:lnTo>
                  <a:lnTo>
                    <a:pt x="2963" y="594"/>
                  </a:lnTo>
                  <a:lnTo>
                    <a:pt x="2963" y="593"/>
                  </a:lnTo>
                  <a:lnTo>
                    <a:pt x="2964" y="593"/>
                  </a:lnTo>
                  <a:lnTo>
                    <a:pt x="2964" y="592"/>
                  </a:lnTo>
                  <a:lnTo>
                    <a:pt x="2965" y="591"/>
                  </a:lnTo>
                  <a:lnTo>
                    <a:pt x="2966" y="590"/>
                  </a:lnTo>
                  <a:lnTo>
                    <a:pt x="2966" y="589"/>
                  </a:lnTo>
                  <a:lnTo>
                    <a:pt x="2967" y="588"/>
                  </a:lnTo>
                  <a:lnTo>
                    <a:pt x="2967" y="587"/>
                  </a:lnTo>
                  <a:lnTo>
                    <a:pt x="2968" y="586"/>
                  </a:lnTo>
                  <a:lnTo>
                    <a:pt x="2968" y="585"/>
                  </a:lnTo>
                  <a:lnTo>
                    <a:pt x="2969" y="584"/>
                  </a:lnTo>
                  <a:lnTo>
                    <a:pt x="2969" y="582"/>
                  </a:lnTo>
                  <a:lnTo>
                    <a:pt x="2970" y="581"/>
                  </a:lnTo>
                  <a:lnTo>
                    <a:pt x="2970" y="580"/>
                  </a:lnTo>
                  <a:lnTo>
                    <a:pt x="2971" y="579"/>
                  </a:lnTo>
                  <a:lnTo>
                    <a:pt x="2971" y="578"/>
                  </a:lnTo>
                  <a:lnTo>
                    <a:pt x="2972" y="576"/>
                  </a:lnTo>
                  <a:lnTo>
                    <a:pt x="2972" y="575"/>
                  </a:lnTo>
                  <a:lnTo>
                    <a:pt x="2972" y="574"/>
                  </a:lnTo>
                  <a:lnTo>
                    <a:pt x="2973" y="573"/>
                  </a:lnTo>
                  <a:lnTo>
                    <a:pt x="2973" y="571"/>
                  </a:lnTo>
                  <a:lnTo>
                    <a:pt x="2974" y="570"/>
                  </a:lnTo>
                  <a:lnTo>
                    <a:pt x="2974" y="569"/>
                  </a:lnTo>
                  <a:lnTo>
                    <a:pt x="2975" y="568"/>
                  </a:lnTo>
                  <a:lnTo>
                    <a:pt x="2975" y="567"/>
                  </a:lnTo>
                  <a:lnTo>
                    <a:pt x="2976" y="566"/>
                  </a:lnTo>
                  <a:lnTo>
                    <a:pt x="2976" y="565"/>
                  </a:lnTo>
                  <a:lnTo>
                    <a:pt x="2977" y="564"/>
                  </a:lnTo>
                  <a:lnTo>
                    <a:pt x="2977" y="563"/>
                  </a:lnTo>
                  <a:lnTo>
                    <a:pt x="2978" y="563"/>
                  </a:lnTo>
                  <a:lnTo>
                    <a:pt x="2978" y="562"/>
                  </a:lnTo>
                  <a:lnTo>
                    <a:pt x="2979" y="561"/>
                  </a:lnTo>
                  <a:lnTo>
                    <a:pt x="2980" y="560"/>
                  </a:lnTo>
                  <a:lnTo>
                    <a:pt x="2981" y="559"/>
                  </a:lnTo>
                  <a:lnTo>
                    <a:pt x="2982" y="559"/>
                  </a:lnTo>
                  <a:lnTo>
                    <a:pt x="2982" y="558"/>
                  </a:lnTo>
                  <a:lnTo>
                    <a:pt x="2983" y="558"/>
                  </a:lnTo>
                  <a:lnTo>
                    <a:pt x="2984" y="558"/>
                  </a:lnTo>
                  <a:lnTo>
                    <a:pt x="2984" y="557"/>
                  </a:lnTo>
                  <a:lnTo>
                    <a:pt x="2985" y="557"/>
                  </a:lnTo>
                  <a:lnTo>
                    <a:pt x="2986" y="557"/>
                  </a:lnTo>
                  <a:lnTo>
                    <a:pt x="2986" y="556"/>
                  </a:lnTo>
                  <a:lnTo>
                    <a:pt x="2987" y="556"/>
                  </a:lnTo>
                  <a:lnTo>
                    <a:pt x="2988" y="556"/>
                  </a:lnTo>
                  <a:lnTo>
                    <a:pt x="2989" y="555"/>
                  </a:lnTo>
                  <a:lnTo>
                    <a:pt x="2989" y="554"/>
                  </a:lnTo>
                  <a:lnTo>
                    <a:pt x="2990" y="554"/>
                  </a:lnTo>
                  <a:lnTo>
                    <a:pt x="2990" y="553"/>
                  </a:lnTo>
                  <a:lnTo>
                    <a:pt x="2991" y="553"/>
                  </a:lnTo>
                  <a:lnTo>
                    <a:pt x="2991" y="552"/>
                  </a:lnTo>
                  <a:lnTo>
                    <a:pt x="2992" y="552"/>
                  </a:lnTo>
                  <a:lnTo>
                    <a:pt x="2992" y="551"/>
                  </a:lnTo>
                  <a:lnTo>
                    <a:pt x="2993" y="551"/>
                  </a:lnTo>
                  <a:lnTo>
                    <a:pt x="2994" y="551"/>
                  </a:lnTo>
                  <a:lnTo>
                    <a:pt x="2995" y="551"/>
                  </a:lnTo>
                  <a:lnTo>
                    <a:pt x="2996" y="551"/>
                  </a:lnTo>
                  <a:lnTo>
                    <a:pt x="2997" y="552"/>
                  </a:lnTo>
                  <a:lnTo>
                    <a:pt x="2997" y="553"/>
                  </a:lnTo>
                  <a:lnTo>
                    <a:pt x="2998" y="554"/>
                  </a:lnTo>
                  <a:lnTo>
                    <a:pt x="2998" y="555"/>
                  </a:lnTo>
                  <a:lnTo>
                    <a:pt x="2999" y="556"/>
                  </a:lnTo>
                  <a:lnTo>
                    <a:pt x="2999" y="557"/>
                  </a:lnTo>
                  <a:lnTo>
                    <a:pt x="3000" y="559"/>
                  </a:lnTo>
                  <a:lnTo>
                    <a:pt x="3000" y="561"/>
                  </a:lnTo>
                  <a:lnTo>
                    <a:pt x="3001" y="563"/>
                  </a:lnTo>
                  <a:lnTo>
                    <a:pt x="3001" y="566"/>
                  </a:lnTo>
                  <a:lnTo>
                    <a:pt x="3002" y="568"/>
                  </a:lnTo>
                  <a:lnTo>
                    <a:pt x="3002" y="571"/>
                  </a:lnTo>
                  <a:lnTo>
                    <a:pt x="3003" y="573"/>
                  </a:lnTo>
                  <a:lnTo>
                    <a:pt x="3003" y="576"/>
                  </a:lnTo>
                  <a:lnTo>
                    <a:pt x="3004" y="579"/>
                  </a:lnTo>
                  <a:lnTo>
                    <a:pt x="3004" y="581"/>
                  </a:lnTo>
                  <a:lnTo>
                    <a:pt x="3005" y="584"/>
                  </a:lnTo>
                  <a:lnTo>
                    <a:pt x="3005" y="587"/>
                  </a:lnTo>
                  <a:lnTo>
                    <a:pt x="3006" y="589"/>
                  </a:lnTo>
                  <a:lnTo>
                    <a:pt x="3006" y="592"/>
                  </a:lnTo>
                  <a:lnTo>
                    <a:pt x="3006" y="594"/>
                  </a:lnTo>
                  <a:lnTo>
                    <a:pt x="3007" y="596"/>
                  </a:lnTo>
                  <a:lnTo>
                    <a:pt x="3007" y="598"/>
                  </a:lnTo>
                  <a:lnTo>
                    <a:pt x="3008" y="600"/>
                  </a:lnTo>
                  <a:lnTo>
                    <a:pt x="3008" y="602"/>
                  </a:lnTo>
                  <a:lnTo>
                    <a:pt x="3009" y="603"/>
                  </a:lnTo>
                  <a:lnTo>
                    <a:pt x="3009" y="604"/>
                  </a:lnTo>
                  <a:lnTo>
                    <a:pt x="3010" y="605"/>
                  </a:lnTo>
                  <a:lnTo>
                    <a:pt x="3010" y="606"/>
                  </a:lnTo>
                  <a:lnTo>
                    <a:pt x="3011" y="606"/>
                  </a:lnTo>
                  <a:lnTo>
                    <a:pt x="3012" y="605"/>
                  </a:lnTo>
                  <a:lnTo>
                    <a:pt x="3012" y="604"/>
                  </a:lnTo>
                  <a:lnTo>
                    <a:pt x="3013" y="602"/>
                  </a:lnTo>
                  <a:lnTo>
                    <a:pt x="3013" y="600"/>
                  </a:lnTo>
                  <a:lnTo>
                    <a:pt x="3014" y="597"/>
                  </a:lnTo>
                  <a:lnTo>
                    <a:pt x="3014" y="594"/>
                  </a:lnTo>
                  <a:lnTo>
                    <a:pt x="3015" y="591"/>
                  </a:lnTo>
                  <a:lnTo>
                    <a:pt x="3015" y="588"/>
                  </a:lnTo>
                  <a:lnTo>
                    <a:pt x="3015" y="584"/>
                  </a:lnTo>
                  <a:lnTo>
                    <a:pt x="3016" y="580"/>
                  </a:lnTo>
                  <a:lnTo>
                    <a:pt x="3016" y="577"/>
                  </a:lnTo>
                  <a:lnTo>
                    <a:pt x="3017" y="573"/>
                  </a:lnTo>
                  <a:lnTo>
                    <a:pt x="3017" y="569"/>
                  </a:lnTo>
                  <a:lnTo>
                    <a:pt x="3018" y="565"/>
                  </a:lnTo>
                  <a:lnTo>
                    <a:pt x="3018" y="560"/>
                  </a:lnTo>
                  <a:lnTo>
                    <a:pt x="3019" y="556"/>
                  </a:lnTo>
                  <a:lnTo>
                    <a:pt x="3019" y="552"/>
                  </a:lnTo>
                  <a:lnTo>
                    <a:pt x="3020" y="548"/>
                  </a:lnTo>
                  <a:lnTo>
                    <a:pt x="3020" y="544"/>
                  </a:lnTo>
                  <a:lnTo>
                    <a:pt x="3021" y="540"/>
                  </a:lnTo>
                  <a:lnTo>
                    <a:pt x="3021" y="536"/>
                  </a:lnTo>
                  <a:lnTo>
                    <a:pt x="3022" y="533"/>
                  </a:lnTo>
                  <a:lnTo>
                    <a:pt x="3022" y="530"/>
                  </a:lnTo>
                  <a:lnTo>
                    <a:pt x="3023" y="526"/>
                  </a:lnTo>
                  <a:lnTo>
                    <a:pt x="3023" y="523"/>
                  </a:lnTo>
                  <a:lnTo>
                    <a:pt x="3023" y="521"/>
                  </a:lnTo>
                  <a:lnTo>
                    <a:pt x="3024" y="519"/>
                  </a:lnTo>
                  <a:lnTo>
                    <a:pt x="3024" y="518"/>
                  </a:lnTo>
                  <a:lnTo>
                    <a:pt x="3025" y="517"/>
                  </a:lnTo>
                  <a:lnTo>
                    <a:pt x="3025" y="516"/>
                  </a:lnTo>
                  <a:lnTo>
                    <a:pt x="3026" y="516"/>
                  </a:lnTo>
                  <a:lnTo>
                    <a:pt x="3026" y="515"/>
                  </a:lnTo>
                  <a:lnTo>
                    <a:pt x="3027" y="515"/>
                  </a:lnTo>
                  <a:lnTo>
                    <a:pt x="3028" y="515"/>
                  </a:lnTo>
                  <a:lnTo>
                    <a:pt x="3028" y="516"/>
                  </a:lnTo>
                  <a:lnTo>
                    <a:pt x="3029" y="516"/>
                  </a:lnTo>
                  <a:lnTo>
                    <a:pt x="3029" y="517"/>
                  </a:lnTo>
                  <a:lnTo>
                    <a:pt x="3030" y="518"/>
                  </a:lnTo>
                  <a:lnTo>
                    <a:pt x="3030" y="519"/>
                  </a:lnTo>
                  <a:lnTo>
                    <a:pt x="3031" y="520"/>
                  </a:lnTo>
                  <a:lnTo>
                    <a:pt x="3031" y="521"/>
                  </a:lnTo>
                  <a:lnTo>
                    <a:pt x="3032" y="522"/>
                  </a:lnTo>
                  <a:lnTo>
                    <a:pt x="3032" y="523"/>
                  </a:lnTo>
                  <a:lnTo>
                    <a:pt x="3032" y="524"/>
                  </a:lnTo>
                  <a:lnTo>
                    <a:pt x="3033" y="525"/>
                  </a:lnTo>
                  <a:lnTo>
                    <a:pt x="3033" y="526"/>
                  </a:lnTo>
                  <a:lnTo>
                    <a:pt x="3034" y="527"/>
                  </a:lnTo>
                  <a:lnTo>
                    <a:pt x="3034" y="528"/>
                  </a:lnTo>
                  <a:lnTo>
                    <a:pt x="3035" y="529"/>
                  </a:lnTo>
                  <a:lnTo>
                    <a:pt x="3035" y="530"/>
                  </a:lnTo>
                  <a:lnTo>
                    <a:pt x="3036" y="530"/>
                  </a:lnTo>
                  <a:lnTo>
                    <a:pt x="3037" y="530"/>
                  </a:lnTo>
                  <a:lnTo>
                    <a:pt x="3038" y="530"/>
                  </a:lnTo>
                  <a:lnTo>
                    <a:pt x="3039" y="530"/>
                  </a:lnTo>
                  <a:lnTo>
                    <a:pt x="3039" y="529"/>
                  </a:lnTo>
                  <a:lnTo>
                    <a:pt x="3040" y="529"/>
                  </a:lnTo>
                  <a:lnTo>
                    <a:pt x="3041" y="529"/>
                  </a:lnTo>
                  <a:lnTo>
                    <a:pt x="3041" y="528"/>
                  </a:lnTo>
                  <a:lnTo>
                    <a:pt x="3042" y="528"/>
                  </a:lnTo>
                  <a:lnTo>
                    <a:pt x="3043" y="528"/>
                  </a:lnTo>
                  <a:lnTo>
                    <a:pt x="3043" y="529"/>
                  </a:lnTo>
                  <a:lnTo>
                    <a:pt x="3044" y="529"/>
                  </a:lnTo>
                  <a:lnTo>
                    <a:pt x="3045" y="530"/>
                  </a:lnTo>
                  <a:lnTo>
                    <a:pt x="3046" y="531"/>
                  </a:lnTo>
                  <a:lnTo>
                    <a:pt x="3046" y="532"/>
                  </a:lnTo>
                  <a:lnTo>
                    <a:pt x="3047" y="533"/>
                  </a:lnTo>
                  <a:lnTo>
                    <a:pt x="3047" y="534"/>
                  </a:lnTo>
                  <a:lnTo>
                    <a:pt x="3048" y="537"/>
                  </a:lnTo>
                  <a:lnTo>
                    <a:pt x="3048" y="539"/>
                  </a:lnTo>
                  <a:lnTo>
                    <a:pt x="3049" y="541"/>
                  </a:lnTo>
                  <a:lnTo>
                    <a:pt x="3049" y="544"/>
                  </a:lnTo>
                  <a:lnTo>
                    <a:pt x="3049" y="546"/>
                  </a:lnTo>
                  <a:lnTo>
                    <a:pt x="3050" y="549"/>
                  </a:lnTo>
                  <a:lnTo>
                    <a:pt x="3050" y="552"/>
                  </a:lnTo>
                  <a:lnTo>
                    <a:pt x="3051" y="555"/>
                  </a:lnTo>
                  <a:lnTo>
                    <a:pt x="3051" y="558"/>
                  </a:lnTo>
                  <a:lnTo>
                    <a:pt x="3052" y="561"/>
                  </a:lnTo>
                  <a:lnTo>
                    <a:pt x="3052" y="564"/>
                  </a:lnTo>
                  <a:lnTo>
                    <a:pt x="3053" y="567"/>
                  </a:lnTo>
                  <a:lnTo>
                    <a:pt x="3053" y="570"/>
                  </a:lnTo>
                  <a:lnTo>
                    <a:pt x="3054" y="574"/>
                  </a:lnTo>
                  <a:lnTo>
                    <a:pt x="3054" y="577"/>
                  </a:lnTo>
                  <a:lnTo>
                    <a:pt x="3055" y="580"/>
                  </a:lnTo>
                  <a:lnTo>
                    <a:pt x="3055" y="583"/>
                  </a:lnTo>
                  <a:lnTo>
                    <a:pt x="3056" y="585"/>
                  </a:lnTo>
                  <a:lnTo>
                    <a:pt x="3056" y="588"/>
                  </a:lnTo>
                  <a:lnTo>
                    <a:pt x="3057" y="591"/>
                  </a:lnTo>
                  <a:lnTo>
                    <a:pt x="3057" y="593"/>
                  </a:lnTo>
                  <a:lnTo>
                    <a:pt x="3057" y="595"/>
                  </a:lnTo>
                  <a:lnTo>
                    <a:pt x="3058" y="597"/>
                  </a:lnTo>
                  <a:lnTo>
                    <a:pt x="3058" y="599"/>
                  </a:lnTo>
                  <a:lnTo>
                    <a:pt x="3059" y="601"/>
                  </a:lnTo>
                  <a:lnTo>
                    <a:pt x="3059" y="602"/>
                  </a:lnTo>
                  <a:lnTo>
                    <a:pt x="3060" y="603"/>
                  </a:lnTo>
                  <a:lnTo>
                    <a:pt x="3060" y="604"/>
                  </a:lnTo>
                  <a:lnTo>
                    <a:pt x="3061" y="604"/>
                  </a:lnTo>
                  <a:lnTo>
                    <a:pt x="3061" y="605"/>
                  </a:lnTo>
                  <a:lnTo>
                    <a:pt x="3062" y="605"/>
                  </a:lnTo>
                  <a:lnTo>
                    <a:pt x="3063" y="605"/>
                  </a:lnTo>
                  <a:lnTo>
                    <a:pt x="3063" y="604"/>
                  </a:lnTo>
                  <a:lnTo>
                    <a:pt x="3064" y="604"/>
                  </a:lnTo>
                  <a:lnTo>
                    <a:pt x="3064" y="603"/>
                  </a:lnTo>
                  <a:lnTo>
                    <a:pt x="3065" y="602"/>
                  </a:lnTo>
                  <a:lnTo>
                    <a:pt x="3066" y="601"/>
                  </a:lnTo>
                  <a:lnTo>
                    <a:pt x="3066" y="600"/>
                  </a:lnTo>
                  <a:lnTo>
                    <a:pt x="3066" y="599"/>
                  </a:lnTo>
                  <a:lnTo>
                    <a:pt x="3067" y="597"/>
                  </a:lnTo>
                  <a:lnTo>
                    <a:pt x="3067" y="596"/>
                  </a:lnTo>
                  <a:lnTo>
                    <a:pt x="3068" y="595"/>
                  </a:lnTo>
                  <a:lnTo>
                    <a:pt x="3068" y="594"/>
                  </a:lnTo>
                  <a:lnTo>
                    <a:pt x="3069" y="593"/>
                  </a:lnTo>
                  <a:lnTo>
                    <a:pt x="3069" y="591"/>
                  </a:lnTo>
                  <a:lnTo>
                    <a:pt x="3070" y="590"/>
                  </a:lnTo>
                  <a:lnTo>
                    <a:pt x="3070" y="589"/>
                  </a:lnTo>
                  <a:lnTo>
                    <a:pt x="3071" y="587"/>
                  </a:lnTo>
                  <a:lnTo>
                    <a:pt x="3071" y="586"/>
                  </a:lnTo>
                  <a:lnTo>
                    <a:pt x="3072" y="585"/>
                  </a:lnTo>
                  <a:lnTo>
                    <a:pt x="3072" y="584"/>
                  </a:lnTo>
                  <a:lnTo>
                    <a:pt x="3073" y="583"/>
                  </a:lnTo>
                  <a:lnTo>
                    <a:pt x="3073" y="582"/>
                  </a:lnTo>
                  <a:lnTo>
                    <a:pt x="3074" y="581"/>
                  </a:lnTo>
                  <a:lnTo>
                    <a:pt x="3074" y="580"/>
                  </a:lnTo>
                  <a:lnTo>
                    <a:pt x="3075" y="579"/>
                  </a:lnTo>
                  <a:lnTo>
                    <a:pt x="3075" y="578"/>
                  </a:lnTo>
                  <a:lnTo>
                    <a:pt x="3076" y="578"/>
                  </a:lnTo>
                  <a:lnTo>
                    <a:pt x="3076" y="577"/>
                  </a:lnTo>
                  <a:lnTo>
                    <a:pt x="3077" y="576"/>
                  </a:lnTo>
                  <a:lnTo>
                    <a:pt x="3078" y="575"/>
                  </a:lnTo>
                  <a:lnTo>
                    <a:pt x="3079" y="574"/>
                  </a:lnTo>
                  <a:lnTo>
                    <a:pt x="3080" y="573"/>
                  </a:lnTo>
                  <a:lnTo>
                    <a:pt x="3081" y="573"/>
                  </a:lnTo>
                  <a:lnTo>
                    <a:pt x="3082" y="572"/>
                  </a:lnTo>
                  <a:lnTo>
                    <a:pt x="3083" y="572"/>
                  </a:lnTo>
                  <a:lnTo>
                    <a:pt x="3084" y="572"/>
                  </a:lnTo>
                  <a:lnTo>
                    <a:pt x="3085" y="572"/>
                  </a:lnTo>
                  <a:lnTo>
                    <a:pt x="3085" y="573"/>
                  </a:lnTo>
                  <a:lnTo>
                    <a:pt x="3086" y="573"/>
                  </a:lnTo>
                  <a:lnTo>
                    <a:pt x="3087" y="573"/>
                  </a:lnTo>
                  <a:lnTo>
                    <a:pt x="3088" y="574"/>
                  </a:lnTo>
                  <a:lnTo>
                    <a:pt x="3089" y="574"/>
                  </a:lnTo>
                  <a:lnTo>
                    <a:pt x="3089" y="575"/>
                  </a:lnTo>
                  <a:lnTo>
                    <a:pt x="3090" y="575"/>
                  </a:lnTo>
                  <a:lnTo>
                    <a:pt x="3091" y="576"/>
                  </a:lnTo>
                  <a:lnTo>
                    <a:pt x="3092" y="577"/>
                  </a:lnTo>
                  <a:lnTo>
                    <a:pt x="3093" y="578"/>
                  </a:lnTo>
                  <a:lnTo>
                    <a:pt x="3094" y="578"/>
                  </a:lnTo>
                  <a:lnTo>
                    <a:pt x="3095" y="579"/>
                  </a:lnTo>
                  <a:lnTo>
                    <a:pt x="3096" y="579"/>
                  </a:lnTo>
                  <a:lnTo>
                    <a:pt x="3097" y="579"/>
                  </a:lnTo>
                  <a:lnTo>
                    <a:pt x="3098" y="579"/>
                  </a:lnTo>
                  <a:lnTo>
                    <a:pt x="3099" y="579"/>
                  </a:lnTo>
                  <a:lnTo>
                    <a:pt x="3100" y="579"/>
                  </a:lnTo>
                  <a:lnTo>
                    <a:pt x="3101" y="579"/>
                  </a:lnTo>
                  <a:lnTo>
                    <a:pt x="3102" y="579"/>
                  </a:lnTo>
                  <a:lnTo>
                    <a:pt x="3103" y="579"/>
                  </a:lnTo>
                  <a:lnTo>
                    <a:pt x="3104" y="579"/>
                  </a:lnTo>
                  <a:lnTo>
                    <a:pt x="3104" y="580"/>
                  </a:lnTo>
                  <a:lnTo>
                    <a:pt x="3105" y="580"/>
                  </a:lnTo>
                  <a:lnTo>
                    <a:pt x="3106" y="580"/>
                  </a:lnTo>
                  <a:lnTo>
                    <a:pt x="3107" y="580"/>
                  </a:lnTo>
                  <a:lnTo>
                    <a:pt x="3108" y="581"/>
                  </a:lnTo>
                  <a:lnTo>
                    <a:pt x="3109" y="581"/>
                  </a:lnTo>
                  <a:lnTo>
                    <a:pt x="3109" y="582"/>
                  </a:lnTo>
                  <a:lnTo>
                    <a:pt x="3110" y="582"/>
                  </a:lnTo>
                  <a:lnTo>
                    <a:pt x="3110" y="583"/>
                  </a:lnTo>
                  <a:lnTo>
                    <a:pt x="3111" y="583"/>
                  </a:lnTo>
                  <a:lnTo>
                    <a:pt x="3112" y="584"/>
                  </a:lnTo>
                  <a:lnTo>
                    <a:pt x="3113" y="584"/>
                  </a:lnTo>
                  <a:lnTo>
                    <a:pt x="3114" y="584"/>
                  </a:lnTo>
                  <a:lnTo>
                    <a:pt x="3114" y="585"/>
                  </a:lnTo>
                  <a:lnTo>
                    <a:pt x="3115" y="585"/>
                  </a:lnTo>
                  <a:lnTo>
                    <a:pt x="3116" y="585"/>
                  </a:lnTo>
                  <a:lnTo>
                    <a:pt x="3117" y="585"/>
                  </a:lnTo>
                  <a:lnTo>
                    <a:pt x="3118" y="584"/>
                  </a:lnTo>
                  <a:lnTo>
                    <a:pt x="3119" y="584"/>
                  </a:lnTo>
                  <a:lnTo>
                    <a:pt x="3119" y="583"/>
                  </a:lnTo>
                  <a:lnTo>
                    <a:pt x="3120" y="583"/>
                  </a:lnTo>
                  <a:lnTo>
                    <a:pt x="3120" y="582"/>
                  </a:lnTo>
                  <a:lnTo>
                    <a:pt x="3121" y="581"/>
                  </a:lnTo>
                  <a:lnTo>
                    <a:pt x="3122" y="580"/>
                  </a:lnTo>
                  <a:lnTo>
                    <a:pt x="3122" y="579"/>
                  </a:lnTo>
                  <a:lnTo>
                    <a:pt x="3123" y="579"/>
                  </a:lnTo>
                  <a:lnTo>
                    <a:pt x="3123" y="578"/>
                  </a:lnTo>
                  <a:lnTo>
                    <a:pt x="3124" y="577"/>
                  </a:lnTo>
                  <a:lnTo>
                    <a:pt x="3125" y="576"/>
                  </a:lnTo>
                  <a:lnTo>
                    <a:pt x="3125" y="575"/>
                  </a:lnTo>
                  <a:lnTo>
                    <a:pt x="3126" y="574"/>
                  </a:lnTo>
                  <a:lnTo>
                    <a:pt x="3126" y="573"/>
                  </a:lnTo>
                  <a:lnTo>
                    <a:pt x="3127" y="572"/>
                  </a:lnTo>
                  <a:lnTo>
                    <a:pt x="3128" y="571"/>
                  </a:lnTo>
                  <a:lnTo>
                    <a:pt x="3129" y="570"/>
                  </a:lnTo>
                  <a:lnTo>
                    <a:pt x="3130" y="569"/>
                  </a:lnTo>
                  <a:lnTo>
                    <a:pt x="3131" y="569"/>
                  </a:lnTo>
                  <a:lnTo>
                    <a:pt x="3132" y="569"/>
                  </a:lnTo>
                  <a:lnTo>
                    <a:pt x="3133" y="568"/>
                  </a:lnTo>
                  <a:lnTo>
                    <a:pt x="3134" y="569"/>
                  </a:lnTo>
                  <a:lnTo>
                    <a:pt x="3135" y="569"/>
                  </a:lnTo>
                  <a:lnTo>
                    <a:pt x="3136" y="569"/>
                  </a:lnTo>
                  <a:lnTo>
                    <a:pt x="3137" y="569"/>
                  </a:lnTo>
                  <a:lnTo>
                    <a:pt x="3137" y="570"/>
                  </a:lnTo>
                  <a:lnTo>
                    <a:pt x="3138" y="570"/>
                  </a:lnTo>
                  <a:lnTo>
                    <a:pt x="3139" y="570"/>
                  </a:lnTo>
                  <a:lnTo>
                    <a:pt x="3140" y="570"/>
                  </a:lnTo>
                  <a:lnTo>
                    <a:pt x="3140" y="571"/>
                  </a:lnTo>
                  <a:lnTo>
                    <a:pt x="3141" y="571"/>
                  </a:lnTo>
                  <a:lnTo>
                    <a:pt x="3142" y="571"/>
                  </a:lnTo>
                  <a:lnTo>
                    <a:pt x="3143" y="571"/>
                  </a:lnTo>
                  <a:lnTo>
                    <a:pt x="3143" y="570"/>
                  </a:lnTo>
                  <a:lnTo>
                    <a:pt x="3144" y="570"/>
                  </a:lnTo>
                  <a:lnTo>
                    <a:pt x="3145" y="570"/>
                  </a:lnTo>
                  <a:lnTo>
                    <a:pt x="3145" y="569"/>
                  </a:lnTo>
                  <a:lnTo>
                    <a:pt x="3146" y="569"/>
                  </a:lnTo>
                  <a:lnTo>
                    <a:pt x="3147" y="568"/>
                  </a:lnTo>
                  <a:lnTo>
                    <a:pt x="3148" y="568"/>
                  </a:lnTo>
                  <a:lnTo>
                    <a:pt x="3148" y="567"/>
                  </a:lnTo>
                  <a:lnTo>
                    <a:pt x="3149" y="567"/>
                  </a:lnTo>
                  <a:lnTo>
                    <a:pt x="3149" y="566"/>
                  </a:lnTo>
                  <a:lnTo>
                    <a:pt x="3150" y="566"/>
                  </a:lnTo>
                  <a:lnTo>
                    <a:pt x="3150" y="565"/>
                  </a:lnTo>
                  <a:lnTo>
                    <a:pt x="3151" y="565"/>
                  </a:lnTo>
                  <a:lnTo>
                    <a:pt x="3151" y="564"/>
                  </a:lnTo>
                  <a:lnTo>
                    <a:pt x="3152" y="564"/>
                  </a:lnTo>
                  <a:lnTo>
                    <a:pt x="3152" y="563"/>
                  </a:lnTo>
                  <a:lnTo>
                    <a:pt x="3153" y="562"/>
                  </a:lnTo>
                  <a:lnTo>
                    <a:pt x="3154" y="561"/>
                  </a:lnTo>
                  <a:lnTo>
                    <a:pt x="3155" y="560"/>
                  </a:lnTo>
                  <a:lnTo>
                    <a:pt x="3155" y="559"/>
                  </a:lnTo>
                  <a:lnTo>
                    <a:pt x="3156" y="559"/>
                  </a:lnTo>
                  <a:lnTo>
                    <a:pt x="3156" y="558"/>
                  </a:lnTo>
                  <a:lnTo>
                    <a:pt x="3157" y="558"/>
                  </a:lnTo>
                  <a:lnTo>
                    <a:pt x="3157" y="557"/>
                  </a:lnTo>
                  <a:lnTo>
                    <a:pt x="3158" y="556"/>
                  </a:lnTo>
                  <a:lnTo>
                    <a:pt x="3159" y="555"/>
                  </a:lnTo>
                  <a:lnTo>
                    <a:pt x="3160" y="554"/>
                  </a:lnTo>
                  <a:lnTo>
                    <a:pt x="3160" y="553"/>
                  </a:lnTo>
                  <a:lnTo>
                    <a:pt x="3161" y="552"/>
                  </a:lnTo>
                  <a:lnTo>
                    <a:pt x="3161" y="551"/>
                  </a:lnTo>
                  <a:lnTo>
                    <a:pt x="3162" y="551"/>
                  </a:lnTo>
                  <a:lnTo>
                    <a:pt x="3162" y="550"/>
                  </a:lnTo>
                  <a:lnTo>
                    <a:pt x="3163" y="550"/>
                  </a:lnTo>
                  <a:lnTo>
                    <a:pt x="3163" y="549"/>
                  </a:lnTo>
                  <a:lnTo>
                    <a:pt x="3164" y="548"/>
                  </a:lnTo>
                  <a:lnTo>
                    <a:pt x="3165" y="547"/>
                  </a:lnTo>
                  <a:lnTo>
                    <a:pt x="3166" y="546"/>
                  </a:lnTo>
                  <a:lnTo>
                    <a:pt x="3166" y="545"/>
                  </a:lnTo>
                  <a:lnTo>
                    <a:pt x="3167" y="545"/>
                  </a:lnTo>
                  <a:lnTo>
                    <a:pt x="3167" y="544"/>
                  </a:lnTo>
                  <a:lnTo>
                    <a:pt x="3168" y="544"/>
                  </a:lnTo>
                  <a:lnTo>
                    <a:pt x="3168" y="543"/>
                  </a:lnTo>
                  <a:lnTo>
                    <a:pt x="3169" y="543"/>
                  </a:lnTo>
                  <a:lnTo>
                    <a:pt x="3169" y="542"/>
                  </a:lnTo>
                  <a:lnTo>
                    <a:pt x="3170" y="541"/>
                  </a:lnTo>
                  <a:lnTo>
                    <a:pt x="3171" y="540"/>
                  </a:lnTo>
                  <a:lnTo>
                    <a:pt x="3172" y="539"/>
                  </a:lnTo>
                  <a:lnTo>
                    <a:pt x="3173" y="538"/>
                  </a:lnTo>
                  <a:lnTo>
                    <a:pt x="3174" y="537"/>
                  </a:lnTo>
                  <a:lnTo>
                    <a:pt x="3175" y="536"/>
                  </a:lnTo>
                  <a:lnTo>
                    <a:pt x="3176" y="536"/>
                  </a:lnTo>
                  <a:lnTo>
                    <a:pt x="3176" y="535"/>
                  </a:lnTo>
                  <a:lnTo>
                    <a:pt x="3177" y="535"/>
                  </a:lnTo>
                  <a:lnTo>
                    <a:pt x="3177" y="534"/>
                  </a:lnTo>
                  <a:lnTo>
                    <a:pt x="3178" y="534"/>
                  </a:lnTo>
                  <a:lnTo>
                    <a:pt x="3178" y="533"/>
                  </a:lnTo>
                  <a:lnTo>
                    <a:pt x="3179" y="533"/>
                  </a:lnTo>
                  <a:lnTo>
                    <a:pt x="3180" y="532"/>
                  </a:lnTo>
                  <a:lnTo>
                    <a:pt x="3181" y="532"/>
                  </a:lnTo>
                  <a:lnTo>
                    <a:pt x="3182" y="531"/>
                  </a:lnTo>
                  <a:lnTo>
                    <a:pt x="3183" y="531"/>
                  </a:lnTo>
                  <a:lnTo>
                    <a:pt x="3184" y="530"/>
                  </a:lnTo>
                  <a:lnTo>
                    <a:pt x="3185" y="530"/>
                  </a:lnTo>
                  <a:lnTo>
                    <a:pt x="3186" y="529"/>
                  </a:lnTo>
                  <a:lnTo>
                    <a:pt x="3187" y="529"/>
                  </a:lnTo>
                  <a:lnTo>
                    <a:pt x="3188" y="529"/>
                  </a:lnTo>
                  <a:lnTo>
                    <a:pt x="3189" y="528"/>
                  </a:lnTo>
                  <a:lnTo>
                    <a:pt x="3190" y="528"/>
                  </a:lnTo>
                  <a:lnTo>
                    <a:pt x="3191" y="528"/>
                  </a:lnTo>
                  <a:lnTo>
                    <a:pt x="3192" y="528"/>
                  </a:lnTo>
                  <a:lnTo>
                    <a:pt x="3193" y="528"/>
                  </a:lnTo>
                  <a:lnTo>
                    <a:pt x="3194" y="528"/>
                  </a:lnTo>
                  <a:lnTo>
                    <a:pt x="3195" y="528"/>
                  </a:lnTo>
                  <a:lnTo>
                    <a:pt x="3196" y="528"/>
                  </a:lnTo>
                  <a:lnTo>
                    <a:pt x="3197" y="528"/>
                  </a:lnTo>
                  <a:lnTo>
                    <a:pt x="3198" y="528"/>
                  </a:lnTo>
                  <a:lnTo>
                    <a:pt x="3199" y="528"/>
                  </a:lnTo>
                  <a:lnTo>
                    <a:pt x="3200" y="528"/>
                  </a:lnTo>
                  <a:lnTo>
                    <a:pt x="3201" y="528"/>
                  </a:lnTo>
                  <a:lnTo>
                    <a:pt x="3201" y="529"/>
                  </a:lnTo>
                  <a:lnTo>
                    <a:pt x="3202" y="529"/>
                  </a:lnTo>
                  <a:lnTo>
                    <a:pt x="3203" y="529"/>
                  </a:lnTo>
                  <a:lnTo>
                    <a:pt x="3203" y="530"/>
                  </a:lnTo>
                  <a:lnTo>
                    <a:pt x="3204" y="530"/>
                  </a:lnTo>
                  <a:lnTo>
                    <a:pt x="3205" y="530"/>
                  </a:lnTo>
                  <a:lnTo>
                    <a:pt x="3206" y="530"/>
                  </a:lnTo>
                  <a:lnTo>
                    <a:pt x="3207" y="530"/>
                  </a:lnTo>
                  <a:lnTo>
                    <a:pt x="3208" y="530"/>
                  </a:lnTo>
                  <a:lnTo>
                    <a:pt x="3209" y="530"/>
                  </a:lnTo>
                  <a:lnTo>
                    <a:pt x="3210" y="530"/>
                  </a:lnTo>
                  <a:lnTo>
                    <a:pt x="3211" y="530"/>
                  </a:lnTo>
                  <a:lnTo>
                    <a:pt x="3211" y="529"/>
                  </a:lnTo>
                  <a:lnTo>
                    <a:pt x="3212" y="529"/>
                  </a:lnTo>
                  <a:lnTo>
                    <a:pt x="3212" y="528"/>
                  </a:lnTo>
                  <a:lnTo>
                    <a:pt x="3213" y="528"/>
                  </a:lnTo>
                  <a:lnTo>
                    <a:pt x="3213" y="527"/>
                  </a:lnTo>
                  <a:lnTo>
                    <a:pt x="3214" y="526"/>
                  </a:lnTo>
                  <a:lnTo>
                    <a:pt x="3214" y="525"/>
                  </a:lnTo>
                  <a:lnTo>
                    <a:pt x="3215" y="524"/>
                  </a:lnTo>
                  <a:lnTo>
                    <a:pt x="3216" y="523"/>
                  </a:lnTo>
                  <a:lnTo>
                    <a:pt x="3216" y="522"/>
                  </a:lnTo>
                  <a:lnTo>
                    <a:pt x="3217" y="521"/>
                  </a:lnTo>
                  <a:lnTo>
                    <a:pt x="3218" y="520"/>
                  </a:lnTo>
                  <a:lnTo>
                    <a:pt x="3219" y="519"/>
                  </a:lnTo>
                  <a:lnTo>
                    <a:pt x="3220" y="518"/>
                  </a:lnTo>
                  <a:lnTo>
                    <a:pt x="3221" y="518"/>
                  </a:lnTo>
                  <a:lnTo>
                    <a:pt x="3221" y="519"/>
                  </a:lnTo>
                  <a:lnTo>
                    <a:pt x="3222" y="519"/>
                  </a:lnTo>
                  <a:lnTo>
                    <a:pt x="3222" y="520"/>
                  </a:lnTo>
                  <a:lnTo>
                    <a:pt x="3223" y="520"/>
                  </a:lnTo>
                  <a:lnTo>
                    <a:pt x="3223" y="521"/>
                  </a:lnTo>
                  <a:lnTo>
                    <a:pt x="3224" y="523"/>
                  </a:lnTo>
                  <a:lnTo>
                    <a:pt x="3224" y="524"/>
                  </a:lnTo>
                  <a:lnTo>
                    <a:pt x="3225" y="526"/>
                  </a:lnTo>
                  <a:lnTo>
                    <a:pt x="3225" y="528"/>
                  </a:lnTo>
                  <a:lnTo>
                    <a:pt x="3226" y="531"/>
                  </a:lnTo>
                  <a:lnTo>
                    <a:pt x="3226" y="533"/>
                  </a:lnTo>
                  <a:lnTo>
                    <a:pt x="3227" y="536"/>
                  </a:lnTo>
                  <a:lnTo>
                    <a:pt x="3227" y="539"/>
                  </a:lnTo>
                  <a:lnTo>
                    <a:pt x="3228" y="542"/>
                  </a:lnTo>
                  <a:lnTo>
                    <a:pt x="3228" y="545"/>
                  </a:lnTo>
                  <a:lnTo>
                    <a:pt x="3229" y="547"/>
                  </a:lnTo>
                  <a:lnTo>
                    <a:pt x="3229" y="550"/>
                  </a:lnTo>
                  <a:lnTo>
                    <a:pt x="3229" y="553"/>
                  </a:lnTo>
                  <a:lnTo>
                    <a:pt x="3230" y="556"/>
                  </a:lnTo>
                  <a:lnTo>
                    <a:pt x="3230" y="559"/>
                  </a:lnTo>
                  <a:lnTo>
                    <a:pt x="3231" y="562"/>
                  </a:lnTo>
                  <a:lnTo>
                    <a:pt x="3231" y="564"/>
                  </a:lnTo>
                  <a:lnTo>
                    <a:pt x="3232" y="567"/>
                  </a:lnTo>
                  <a:lnTo>
                    <a:pt x="3232" y="569"/>
                  </a:lnTo>
                  <a:lnTo>
                    <a:pt x="3233" y="571"/>
                  </a:lnTo>
                  <a:lnTo>
                    <a:pt x="3233" y="573"/>
                  </a:lnTo>
                  <a:lnTo>
                    <a:pt x="3234" y="575"/>
                  </a:lnTo>
                  <a:lnTo>
                    <a:pt x="3234" y="576"/>
                  </a:lnTo>
                  <a:lnTo>
                    <a:pt x="3235" y="577"/>
                  </a:lnTo>
                  <a:lnTo>
                    <a:pt x="3235" y="578"/>
                  </a:lnTo>
                  <a:lnTo>
                    <a:pt x="3236" y="578"/>
                  </a:lnTo>
                  <a:lnTo>
                    <a:pt x="3237" y="577"/>
                  </a:lnTo>
                  <a:lnTo>
                    <a:pt x="3237" y="576"/>
                  </a:lnTo>
                  <a:lnTo>
                    <a:pt x="3237" y="574"/>
                  </a:lnTo>
                  <a:lnTo>
                    <a:pt x="3238" y="572"/>
                  </a:lnTo>
                  <a:lnTo>
                    <a:pt x="3238" y="570"/>
                  </a:lnTo>
                  <a:lnTo>
                    <a:pt x="3239" y="567"/>
                  </a:lnTo>
                  <a:lnTo>
                    <a:pt x="3239" y="565"/>
                  </a:lnTo>
                  <a:lnTo>
                    <a:pt x="3240" y="562"/>
                  </a:lnTo>
                  <a:lnTo>
                    <a:pt x="3240" y="558"/>
                  </a:lnTo>
                  <a:lnTo>
                    <a:pt x="3241" y="555"/>
                  </a:lnTo>
                  <a:lnTo>
                    <a:pt x="3241" y="552"/>
                  </a:lnTo>
                  <a:lnTo>
                    <a:pt x="3242" y="548"/>
                  </a:lnTo>
                  <a:lnTo>
                    <a:pt x="3242" y="544"/>
                  </a:lnTo>
                  <a:lnTo>
                    <a:pt x="3243" y="541"/>
                  </a:lnTo>
                  <a:lnTo>
                    <a:pt x="3243" y="537"/>
                  </a:lnTo>
                  <a:lnTo>
                    <a:pt x="3244" y="533"/>
                  </a:lnTo>
                  <a:lnTo>
                    <a:pt x="3244" y="529"/>
                  </a:lnTo>
                  <a:lnTo>
                    <a:pt x="3245" y="525"/>
                  </a:lnTo>
                  <a:lnTo>
                    <a:pt x="3245" y="522"/>
                  </a:lnTo>
                  <a:lnTo>
                    <a:pt x="3246" y="518"/>
                  </a:lnTo>
                  <a:lnTo>
                    <a:pt x="3246" y="515"/>
                  </a:lnTo>
                  <a:lnTo>
                    <a:pt x="3246" y="511"/>
                  </a:lnTo>
                  <a:lnTo>
                    <a:pt x="3247" y="508"/>
                  </a:lnTo>
                  <a:lnTo>
                    <a:pt x="3247" y="505"/>
                  </a:lnTo>
                  <a:lnTo>
                    <a:pt x="3248" y="503"/>
                  </a:lnTo>
                  <a:lnTo>
                    <a:pt x="3248" y="501"/>
                  </a:lnTo>
                  <a:lnTo>
                    <a:pt x="3249" y="499"/>
                  </a:lnTo>
                  <a:lnTo>
                    <a:pt x="3249" y="497"/>
                  </a:lnTo>
                  <a:lnTo>
                    <a:pt x="3250" y="496"/>
                  </a:lnTo>
                  <a:lnTo>
                    <a:pt x="3250" y="495"/>
                  </a:lnTo>
                  <a:lnTo>
                    <a:pt x="3251" y="494"/>
                  </a:lnTo>
                  <a:lnTo>
                    <a:pt x="3251" y="493"/>
                  </a:lnTo>
                  <a:lnTo>
                    <a:pt x="3252" y="493"/>
                  </a:lnTo>
                  <a:lnTo>
                    <a:pt x="3252" y="492"/>
                  </a:lnTo>
                  <a:lnTo>
                    <a:pt x="3253" y="492"/>
                  </a:lnTo>
                  <a:lnTo>
                    <a:pt x="3254" y="492"/>
                  </a:lnTo>
                  <a:lnTo>
                    <a:pt x="3255" y="493"/>
                  </a:lnTo>
                  <a:lnTo>
                    <a:pt x="3256" y="493"/>
                  </a:lnTo>
                  <a:lnTo>
                    <a:pt x="3256" y="494"/>
                  </a:lnTo>
                  <a:lnTo>
                    <a:pt x="3257" y="494"/>
                  </a:lnTo>
                  <a:lnTo>
                    <a:pt x="3257" y="495"/>
                  </a:lnTo>
                  <a:lnTo>
                    <a:pt x="3258" y="496"/>
                  </a:lnTo>
                  <a:lnTo>
                    <a:pt x="3259" y="497"/>
                  </a:lnTo>
                  <a:lnTo>
                    <a:pt x="3259" y="498"/>
                  </a:lnTo>
                  <a:lnTo>
                    <a:pt x="3260" y="498"/>
                  </a:lnTo>
                  <a:lnTo>
                    <a:pt x="3261" y="499"/>
                  </a:lnTo>
                  <a:lnTo>
                    <a:pt x="3262" y="499"/>
                  </a:lnTo>
                  <a:lnTo>
                    <a:pt x="3263" y="499"/>
                  </a:lnTo>
                  <a:lnTo>
                    <a:pt x="3263" y="500"/>
                  </a:lnTo>
                  <a:lnTo>
                    <a:pt x="3264" y="500"/>
                  </a:lnTo>
                  <a:lnTo>
                    <a:pt x="3265" y="500"/>
                  </a:lnTo>
                  <a:lnTo>
                    <a:pt x="3266" y="500"/>
                  </a:lnTo>
                  <a:lnTo>
                    <a:pt x="3266" y="499"/>
                  </a:lnTo>
                  <a:lnTo>
                    <a:pt x="3267" y="499"/>
                  </a:lnTo>
                  <a:lnTo>
                    <a:pt x="3268" y="499"/>
                  </a:lnTo>
                  <a:lnTo>
                    <a:pt x="3269" y="499"/>
                  </a:lnTo>
                  <a:lnTo>
                    <a:pt x="3269" y="498"/>
                  </a:lnTo>
                  <a:lnTo>
                    <a:pt x="3270" y="498"/>
                  </a:lnTo>
                  <a:lnTo>
                    <a:pt x="3271" y="497"/>
                  </a:lnTo>
                  <a:lnTo>
                    <a:pt x="3272" y="496"/>
                  </a:lnTo>
                  <a:lnTo>
                    <a:pt x="3273" y="496"/>
                  </a:lnTo>
                  <a:lnTo>
                    <a:pt x="3273" y="495"/>
                  </a:lnTo>
                  <a:lnTo>
                    <a:pt x="3274" y="495"/>
                  </a:lnTo>
                  <a:lnTo>
                    <a:pt x="3275" y="494"/>
                  </a:lnTo>
                  <a:lnTo>
                    <a:pt x="3276" y="494"/>
                  </a:lnTo>
                  <a:lnTo>
                    <a:pt x="3276" y="493"/>
                  </a:lnTo>
                  <a:lnTo>
                    <a:pt x="3277" y="493"/>
                  </a:lnTo>
                  <a:lnTo>
                    <a:pt x="3277" y="492"/>
                  </a:lnTo>
                  <a:lnTo>
                    <a:pt x="3278" y="492"/>
                  </a:lnTo>
                  <a:lnTo>
                    <a:pt x="3279" y="491"/>
                  </a:lnTo>
                  <a:lnTo>
                    <a:pt x="3280" y="490"/>
                  </a:lnTo>
                  <a:lnTo>
                    <a:pt x="3281" y="489"/>
                  </a:lnTo>
                  <a:lnTo>
                    <a:pt x="3282" y="488"/>
                  </a:lnTo>
                  <a:lnTo>
                    <a:pt x="3283" y="488"/>
                  </a:lnTo>
                  <a:lnTo>
                    <a:pt x="3284" y="487"/>
                  </a:lnTo>
                  <a:lnTo>
                    <a:pt x="3285" y="487"/>
                  </a:lnTo>
                  <a:lnTo>
                    <a:pt x="3286" y="487"/>
                  </a:lnTo>
                  <a:lnTo>
                    <a:pt x="3287" y="487"/>
                  </a:lnTo>
                  <a:lnTo>
                    <a:pt x="3287" y="486"/>
                  </a:lnTo>
                  <a:lnTo>
                    <a:pt x="3288" y="486"/>
                  </a:lnTo>
                  <a:lnTo>
                    <a:pt x="3289" y="486"/>
                  </a:lnTo>
                  <a:lnTo>
                    <a:pt x="3290" y="486"/>
                  </a:lnTo>
                  <a:lnTo>
                    <a:pt x="3291" y="487"/>
                  </a:lnTo>
                  <a:lnTo>
                    <a:pt x="3292" y="487"/>
                  </a:lnTo>
                  <a:lnTo>
                    <a:pt x="3293" y="487"/>
                  </a:lnTo>
                  <a:lnTo>
                    <a:pt x="3294" y="487"/>
                  </a:lnTo>
                  <a:lnTo>
                    <a:pt x="3295" y="487"/>
                  </a:lnTo>
                  <a:lnTo>
                    <a:pt x="3295" y="488"/>
                  </a:lnTo>
                  <a:lnTo>
                    <a:pt x="3296" y="488"/>
                  </a:lnTo>
                  <a:lnTo>
                    <a:pt x="3297" y="488"/>
                  </a:lnTo>
                  <a:lnTo>
                    <a:pt x="3298" y="488"/>
                  </a:lnTo>
                  <a:lnTo>
                    <a:pt x="3298" y="489"/>
                  </a:lnTo>
                  <a:lnTo>
                    <a:pt x="3299" y="489"/>
                  </a:lnTo>
                  <a:lnTo>
                    <a:pt x="3300" y="489"/>
                  </a:lnTo>
                  <a:lnTo>
                    <a:pt x="3301" y="489"/>
                  </a:lnTo>
                  <a:lnTo>
                    <a:pt x="3301" y="490"/>
                  </a:lnTo>
                  <a:lnTo>
                    <a:pt x="3302" y="490"/>
                  </a:lnTo>
                  <a:lnTo>
                    <a:pt x="3303" y="490"/>
                  </a:lnTo>
                  <a:lnTo>
                    <a:pt x="3304" y="491"/>
                  </a:lnTo>
                  <a:lnTo>
                    <a:pt x="3305" y="491"/>
                  </a:lnTo>
                  <a:lnTo>
                    <a:pt x="3306" y="491"/>
                  </a:lnTo>
                  <a:lnTo>
                    <a:pt x="3306" y="492"/>
                  </a:lnTo>
                  <a:lnTo>
                    <a:pt x="3307" y="492"/>
                  </a:lnTo>
                  <a:lnTo>
                    <a:pt x="3308" y="493"/>
                  </a:lnTo>
                  <a:lnTo>
                    <a:pt x="3309" y="493"/>
                  </a:lnTo>
                  <a:lnTo>
                    <a:pt x="3310" y="493"/>
                  </a:lnTo>
                  <a:lnTo>
                    <a:pt x="3310" y="494"/>
                  </a:lnTo>
                  <a:lnTo>
                    <a:pt x="3311" y="494"/>
                  </a:lnTo>
                  <a:lnTo>
                    <a:pt x="3312" y="494"/>
                  </a:lnTo>
                  <a:lnTo>
                    <a:pt x="3313" y="495"/>
                  </a:lnTo>
                  <a:lnTo>
                    <a:pt x="3314" y="495"/>
                  </a:lnTo>
                  <a:lnTo>
                    <a:pt x="3315" y="496"/>
                  </a:lnTo>
                  <a:lnTo>
                    <a:pt x="3316" y="496"/>
                  </a:lnTo>
                  <a:lnTo>
                    <a:pt x="3317" y="496"/>
                  </a:lnTo>
                  <a:lnTo>
                    <a:pt x="3318" y="496"/>
                  </a:lnTo>
                  <a:lnTo>
                    <a:pt x="3318" y="497"/>
                  </a:lnTo>
                  <a:lnTo>
                    <a:pt x="3319" y="497"/>
                  </a:lnTo>
                  <a:lnTo>
                    <a:pt x="3320" y="497"/>
                  </a:lnTo>
                  <a:lnTo>
                    <a:pt x="3321" y="497"/>
                  </a:lnTo>
                  <a:lnTo>
                    <a:pt x="3322" y="497"/>
                  </a:lnTo>
                  <a:lnTo>
                    <a:pt x="3323" y="497"/>
                  </a:lnTo>
                  <a:lnTo>
                    <a:pt x="3324" y="497"/>
                  </a:lnTo>
                  <a:lnTo>
                    <a:pt x="3325" y="497"/>
                  </a:lnTo>
                  <a:lnTo>
                    <a:pt x="3326" y="496"/>
                  </a:lnTo>
                  <a:lnTo>
                    <a:pt x="3327" y="496"/>
                  </a:lnTo>
                  <a:lnTo>
                    <a:pt x="3328" y="496"/>
                  </a:lnTo>
                  <a:lnTo>
                    <a:pt x="3329" y="496"/>
                  </a:lnTo>
                  <a:lnTo>
                    <a:pt x="3330" y="495"/>
                  </a:lnTo>
                  <a:lnTo>
                    <a:pt x="3331" y="495"/>
                  </a:lnTo>
                  <a:lnTo>
                    <a:pt x="3332" y="494"/>
                  </a:lnTo>
                  <a:lnTo>
                    <a:pt x="3333" y="494"/>
                  </a:lnTo>
                  <a:lnTo>
                    <a:pt x="3334" y="494"/>
                  </a:lnTo>
                  <a:lnTo>
                    <a:pt x="3334" y="493"/>
                  </a:lnTo>
                  <a:lnTo>
                    <a:pt x="3335" y="493"/>
                  </a:lnTo>
                  <a:lnTo>
                    <a:pt x="3336" y="492"/>
                  </a:lnTo>
                  <a:lnTo>
                    <a:pt x="3337" y="492"/>
                  </a:lnTo>
                  <a:lnTo>
                    <a:pt x="3338" y="491"/>
                  </a:lnTo>
                  <a:lnTo>
                    <a:pt x="3339" y="491"/>
                  </a:lnTo>
                  <a:lnTo>
                    <a:pt x="3339" y="490"/>
                  </a:lnTo>
                  <a:lnTo>
                    <a:pt x="3340" y="490"/>
                  </a:lnTo>
                  <a:lnTo>
                    <a:pt x="3340" y="489"/>
                  </a:lnTo>
                  <a:lnTo>
                    <a:pt x="3341" y="489"/>
                  </a:lnTo>
                  <a:lnTo>
                    <a:pt x="3341" y="488"/>
                  </a:lnTo>
                  <a:lnTo>
                    <a:pt x="3342" y="488"/>
                  </a:lnTo>
                  <a:lnTo>
                    <a:pt x="3343" y="487"/>
                  </a:lnTo>
                  <a:lnTo>
                    <a:pt x="3344" y="486"/>
                  </a:lnTo>
                  <a:lnTo>
                    <a:pt x="3345" y="485"/>
                  </a:lnTo>
                  <a:lnTo>
                    <a:pt x="3346" y="484"/>
                  </a:lnTo>
                  <a:lnTo>
                    <a:pt x="3347" y="483"/>
                  </a:lnTo>
                  <a:lnTo>
                    <a:pt x="3348" y="482"/>
                  </a:lnTo>
                  <a:lnTo>
                    <a:pt x="3348" y="481"/>
                  </a:lnTo>
                  <a:lnTo>
                    <a:pt x="3349" y="481"/>
                  </a:lnTo>
                  <a:lnTo>
                    <a:pt x="3350" y="480"/>
                  </a:lnTo>
                  <a:lnTo>
                    <a:pt x="3351" y="480"/>
                  </a:lnTo>
                  <a:lnTo>
                    <a:pt x="3351" y="479"/>
                  </a:lnTo>
                  <a:lnTo>
                    <a:pt x="3352" y="479"/>
                  </a:lnTo>
                  <a:lnTo>
                    <a:pt x="3353" y="479"/>
                  </a:lnTo>
                  <a:lnTo>
                    <a:pt x="3354" y="479"/>
                  </a:lnTo>
                  <a:lnTo>
                    <a:pt x="3354" y="478"/>
                  </a:lnTo>
                  <a:lnTo>
                    <a:pt x="3355" y="478"/>
                  </a:lnTo>
                  <a:lnTo>
                    <a:pt x="3355" y="479"/>
                  </a:lnTo>
                  <a:lnTo>
                    <a:pt x="3356" y="479"/>
                  </a:lnTo>
                  <a:lnTo>
                    <a:pt x="3357" y="479"/>
                  </a:lnTo>
                  <a:lnTo>
                    <a:pt x="3358" y="480"/>
                  </a:lnTo>
                  <a:lnTo>
                    <a:pt x="3359" y="480"/>
                  </a:lnTo>
                  <a:lnTo>
                    <a:pt x="3359" y="481"/>
                  </a:lnTo>
                  <a:lnTo>
                    <a:pt x="3360" y="481"/>
                  </a:lnTo>
                  <a:lnTo>
                    <a:pt x="3361" y="481"/>
                  </a:lnTo>
                  <a:lnTo>
                    <a:pt x="3361" y="482"/>
                  </a:lnTo>
                  <a:lnTo>
                    <a:pt x="3362" y="482"/>
                  </a:lnTo>
                  <a:lnTo>
                    <a:pt x="3363" y="482"/>
                  </a:lnTo>
                  <a:lnTo>
                    <a:pt x="3364" y="483"/>
                  </a:lnTo>
                  <a:lnTo>
                    <a:pt x="3365" y="483"/>
                  </a:lnTo>
                  <a:lnTo>
                    <a:pt x="3366" y="483"/>
                  </a:lnTo>
                  <a:lnTo>
                    <a:pt x="3367" y="483"/>
                  </a:lnTo>
                  <a:lnTo>
                    <a:pt x="3367" y="482"/>
                  </a:lnTo>
                  <a:lnTo>
                    <a:pt x="3368" y="482"/>
                  </a:lnTo>
                  <a:lnTo>
                    <a:pt x="3369" y="481"/>
                  </a:lnTo>
                  <a:lnTo>
                    <a:pt x="3370" y="481"/>
                  </a:lnTo>
                  <a:lnTo>
                    <a:pt x="3370" y="480"/>
                  </a:lnTo>
                  <a:lnTo>
                    <a:pt x="3371" y="480"/>
                  </a:lnTo>
                  <a:lnTo>
                    <a:pt x="3371" y="479"/>
                  </a:lnTo>
                  <a:lnTo>
                    <a:pt x="3372" y="479"/>
                  </a:lnTo>
                  <a:lnTo>
                    <a:pt x="3372" y="478"/>
                  </a:lnTo>
                  <a:lnTo>
                    <a:pt x="3373" y="478"/>
                  </a:lnTo>
                  <a:lnTo>
                    <a:pt x="3374" y="477"/>
                  </a:lnTo>
                  <a:lnTo>
                    <a:pt x="3374" y="476"/>
                  </a:lnTo>
                  <a:lnTo>
                    <a:pt x="3375" y="476"/>
                  </a:lnTo>
                  <a:lnTo>
                    <a:pt x="3375" y="475"/>
                  </a:lnTo>
                  <a:lnTo>
                    <a:pt x="3376" y="475"/>
                  </a:lnTo>
                  <a:lnTo>
                    <a:pt x="3377" y="474"/>
                  </a:lnTo>
                  <a:lnTo>
                    <a:pt x="3378" y="474"/>
                  </a:lnTo>
                  <a:lnTo>
                    <a:pt x="3379" y="474"/>
                  </a:lnTo>
                  <a:lnTo>
                    <a:pt x="3380" y="474"/>
                  </a:lnTo>
                  <a:lnTo>
                    <a:pt x="3381" y="474"/>
                  </a:lnTo>
                  <a:lnTo>
                    <a:pt x="3382" y="474"/>
                  </a:lnTo>
                  <a:lnTo>
                    <a:pt x="3383" y="474"/>
                  </a:lnTo>
                  <a:lnTo>
                    <a:pt x="3384" y="474"/>
                  </a:lnTo>
                  <a:lnTo>
                    <a:pt x="3385" y="474"/>
                  </a:lnTo>
                  <a:lnTo>
                    <a:pt x="3385" y="475"/>
                  </a:lnTo>
                  <a:lnTo>
                    <a:pt x="3386" y="475"/>
                  </a:lnTo>
                  <a:lnTo>
                    <a:pt x="3387" y="475"/>
                  </a:lnTo>
                  <a:lnTo>
                    <a:pt x="3388" y="475"/>
                  </a:lnTo>
                  <a:lnTo>
                    <a:pt x="3389" y="475"/>
                  </a:lnTo>
                  <a:lnTo>
                    <a:pt x="3390" y="475"/>
                  </a:lnTo>
                  <a:lnTo>
                    <a:pt x="3391" y="475"/>
                  </a:lnTo>
                  <a:lnTo>
                    <a:pt x="3392" y="475"/>
                  </a:lnTo>
                  <a:lnTo>
                    <a:pt x="3393" y="475"/>
                  </a:lnTo>
                  <a:lnTo>
                    <a:pt x="3393" y="474"/>
                  </a:lnTo>
                  <a:lnTo>
                    <a:pt x="3394" y="474"/>
                  </a:lnTo>
                  <a:lnTo>
                    <a:pt x="3395" y="474"/>
                  </a:lnTo>
                  <a:lnTo>
                    <a:pt x="3395" y="473"/>
                  </a:lnTo>
                  <a:lnTo>
                    <a:pt x="3396" y="473"/>
                  </a:lnTo>
                  <a:lnTo>
                    <a:pt x="3396" y="472"/>
                  </a:lnTo>
                  <a:lnTo>
                    <a:pt x="3397" y="472"/>
                  </a:lnTo>
                  <a:lnTo>
                    <a:pt x="3398" y="471"/>
                  </a:lnTo>
                  <a:lnTo>
                    <a:pt x="3399" y="470"/>
                  </a:lnTo>
                  <a:lnTo>
                    <a:pt x="3400" y="469"/>
                  </a:lnTo>
                  <a:lnTo>
                    <a:pt x="3400" y="468"/>
                  </a:lnTo>
                  <a:lnTo>
                    <a:pt x="3401" y="467"/>
                  </a:lnTo>
                  <a:lnTo>
                    <a:pt x="3401" y="466"/>
                  </a:lnTo>
                  <a:lnTo>
                    <a:pt x="3402" y="466"/>
                  </a:lnTo>
                  <a:lnTo>
                    <a:pt x="3402" y="465"/>
                  </a:lnTo>
                  <a:lnTo>
                    <a:pt x="3403" y="464"/>
                  </a:lnTo>
                  <a:lnTo>
                    <a:pt x="3403" y="463"/>
                  </a:lnTo>
                  <a:lnTo>
                    <a:pt x="3404" y="462"/>
                  </a:lnTo>
                  <a:lnTo>
                    <a:pt x="3405" y="461"/>
                  </a:lnTo>
                  <a:lnTo>
                    <a:pt x="3405" y="460"/>
                  </a:lnTo>
                  <a:lnTo>
                    <a:pt x="3406" y="459"/>
                  </a:lnTo>
                  <a:lnTo>
                    <a:pt x="3406" y="458"/>
                  </a:lnTo>
                  <a:lnTo>
                    <a:pt x="3407" y="457"/>
                  </a:lnTo>
                  <a:lnTo>
                    <a:pt x="3408" y="456"/>
                  </a:lnTo>
                  <a:lnTo>
                    <a:pt x="3408" y="455"/>
                  </a:lnTo>
                  <a:lnTo>
                    <a:pt x="3408" y="454"/>
                  </a:lnTo>
                  <a:lnTo>
                    <a:pt x="3409" y="454"/>
                  </a:lnTo>
                  <a:lnTo>
                    <a:pt x="3409" y="453"/>
                  </a:lnTo>
                  <a:lnTo>
                    <a:pt x="3410" y="452"/>
                  </a:lnTo>
                  <a:lnTo>
                    <a:pt x="3411" y="451"/>
                  </a:lnTo>
                  <a:lnTo>
                    <a:pt x="3412" y="450"/>
                  </a:lnTo>
                  <a:lnTo>
                    <a:pt x="3413" y="450"/>
                  </a:lnTo>
                  <a:lnTo>
                    <a:pt x="3414" y="450"/>
                  </a:lnTo>
                  <a:lnTo>
                    <a:pt x="3415" y="450"/>
                  </a:lnTo>
                  <a:lnTo>
                    <a:pt x="3416" y="450"/>
                  </a:lnTo>
                  <a:lnTo>
                    <a:pt x="3417" y="451"/>
                  </a:lnTo>
                  <a:lnTo>
                    <a:pt x="3417" y="452"/>
                  </a:lnTo>
                  <a:lnTo>
                    <a:pt x="3418" y="452"/>
                  </a:lnTo>
                  <a:lnTo>
                    <a:pt x="3418" y="453"/>
                  </a:lnTo>
                  <a:lnTo>
                    <a:pt x="3419" y="453"/>
                  </a:lnTo>
                  <a:lnTo>
                    <a:pt x="3419" y="454"/>
                  </a:lnTo>
                  <a:lnTo>
                    <a:pt x="3420" y="454"/>
                  </a:lnTo>
                  <a:lnTo>
                    <a:pt x="3420" y="455"/>
                  </a:lnTo>
                  <a:lnTo>
                    <a:pt x="3421" y="456"/>
                  </a:lnTo>
                  <a:lnTo>
                    <a:pt x="3422" y="457"/>
                  </a:lnTo>
                  <a:lnTo>
                    <a:pt x="3422" y="458"/>
                  </a:lnTo>
                  <a:lnTo>
                    <a:pt x="3423" y="458"/>
                  </a:lnTo>
                  <a:lnTo>
                    <a:pt x="3423" y="459"/>
                  </a:lnTo>
                  <a:lnTo>
                    <a:pt x="3424" y="460"/>
                  </a:lnTo>
                  <a:lnTo>
                    <a:pt x="3425" y="461"/>
                  </a:lnTo>
                  <a:lnTo>
                    <a:pt x="3425" y="462"/>
                  </a:lnTo>
                  <a:lnTo>
                    <a:pt x="3426" y="463"/>
                  </a:lnTo>
                  <a:lnTo>
                    <a:pt x="3426" y="464"/>
                  </a:lnTo>
                  <a:lnTo>
                    <a:pt x="3427" y="464"/>
                  </a:lnTo>
                  <a:lnTo>
                    <a:pt x="3427" y="465"/>
                  </a:lnTo>
                  <a:lnTo>
                    <a:pt x="3428" y="465"/>
                  </a:lnTo>
                  <a:lnTo>
                    <a:pt x="3428" y="466"/>
                  </a:lnTo>
                  <a:lnTo>
                    <a:pt x="3429" y="466"/>
                  </a:lnTo>
                  <a:lnTo>
                    <a:pt x="3430" y="467"/>
                  </a:lnTo>
                  <a:lnTo>
                    <a:pt x="3431" y="468"/>
                  </a:lnTo>
                  <a:lnTo>
                    <a:pt x="3432" y="468"/>
                  </a:lnTo>
                  <a:lnTo>
                    <a:pt x="3433" y="469"/>
                  </a:lnTo>
                  <a:lnTo>
                    <a:pt x="3434" y="469"/>
                  </a:lnTo>
                  <a:lnTo>
                    <a:pt x="3435" y="469"/>
                  </a:lnTo>
                  <a:lnTo>
                    <a:pt x="3436" y="469"/>
                  </a:lnTo>
                  <a:lnTo>
                    <a:pt x="3437" y="469"/>
                  </a:lnTo>
                  <a:lnTo>
                    <a:pt x="3438" y="469"/>
                  </a:lnTo>
                  <a:lnTo>
                    <a:pt x="3439" y="469"/>
                  </a:lnTo>
                  <a:lnTo>
                    <a:pt x="3440" y="468"/>
                  </a:lnTo>
                  <a:lnTo>
                    <a:pt x="3441" y="468"/>
                  </a:lnTo>
                  <a:lnTo>
                    <a:pt x="3441" y="467"/>
                  </a:lnTo>
                  <a:lnTo>
                    <a:pt x="3442" y="467"/>
                  </a:lnTo>
                  <a:lnTo>
                    <a:pt x="3442" y="466"/>
                  </a:lnTo>
                  <a:lnTo>
                    <a:pt x="3443" y="466"/>
                  </a:lnTo>
                  <a:lnTo>
                    <a:pt x="3443" y="465"/>
                  </a:lnTo>
                  <a:lnTo>
                    <a:pt x="3444" y="465"/>
                  </a:lnTo>
                  <a:lnTo>
                    <a:pt x="3444" y="464"/>
                  </a:lnTo>
                  <a:lnTo>
                    <a:pt x="3445" y="464"/>
                  </a:lnTo>
                  <a:lnTo>
                    <a:pt x="3446" y="463"/>
                  </a:lnTo>
                  <a:lnTo>
                    <a:pt x="3447" y="462"/>
                  </a:lnTo>
                  <a:lnTo>
                    <a:pt x="3448" y="461"/>
                  </a:lnTo>
                  <a:lnTo>
                    <a:pt x="3449" y="460"/>
                  </a:lnTo>
                  <a:lnTo>
                    <a:pt x="3450" y="459"/>
                  </a:lnTo>
                  <a:lnTo>
                    <a:pt x="3451" y="459"/>
                  </a:lnTo>
                  <a:lnTo>
                    <a:pt x="3451" y="458"/>
                  </a:lnTo>
                  <a:lnTo>
                    <a:pt x="3452" y="457"/>
                  </a:lnTo>
                  <a:lnTo>
                    <a:pt x="3453" y="457"/>
                  </a:lnTo>
                  <a:lnTo>
                    <a:pt x="3453" y="456"/>
                  </a:lnTo>
                  <a:lnTo>
                    <a:pt x="3454" y="456"/>
                  </a:lnTo>
                  <a:lnTo>
                    <a:pt x="3454" y="455"/>
                  </a:lnTo>
                  <a:lnTo>
                    <a:pt x="3455" y="455"/>
                  </a:lnTo>
                  <a:lnTo>
                    <a:pt x="3455" y="454"/>
                  </a:lnTo>
                  <a:lnTo>
                    <a:pt x="3456" y="454"/>
                  </a:lnTo>
                  <a:lnTo>
                    <a:pt x="3457" y="453"/>
                  </a:lnTo>
                  <a:lnTo>
                    <a:pt x="3458" y="452"/>
                  </a:lnTo>
                  <a:lnTo>
                    <a:pt x="3459" y="452"/>
                  </a:lnTo>
                  <a:lnTo>
                    <a:pt x="3459" y="451"/>
                  </a:lnTo>
                  <a:lnTo>
                    <a:pt x="3460" y="451"/>
                  </a:lnTo>
                  <a:lnTo>
                    <a:pt x="3460" y="450"/>
                  </a:lnTo>
                  <a:lnTo>
                    <a:pt x="3461" y="449"/>
                  </a:lnTo>
                  <a:lnTo>
                    <a:pt x="3462" y="448"/>
                  </a:lnTo>
                  <a:lnTo>
                    <a:pt x="3462" y="447"/>
                  </a:lnTo>
                  <a:lnTo>
                    <a:pt x="3463" y="447"/>
                  </a:lnTo>
                  <a:lnTo>
                    <a:pt x="3463" y="446"/>
                  </a:lnTo>
                  <a:lnTo>
                    <a:pt x="3464" y="446"/>
                  </a:lnTo>
                  <a:lnTo>
                    <a:pt x="3464" y="445"/>
                  </a:lnTo>
                  <a:lnTo>
                    <a:pt x="3465" y="445"/>
                  </a:lnTo>
                  <a:lnTo>
                    <a:pt x="3465" y="444"/>
                  </a:lnTo>
                  <a:lnTo>
                    <a:pt x="3466" y="444"/>
                  </a:lnTo>
                  <a:lnTo>
                    <a:pt x="3466" y="443"/>
                  </a:lnTo>
                  <a:lnTo>
                    <a:pt x="3467" y="443"/>
                  </a:lnTo>
                  <a:lnTo>
                    <a:pt x="3467" y="442"/>
                  </a:lnTo>
                  <a:lnTo>
                    <a:pt x="3468" y="442"/>
                  </a:lnTo>
                  <a:lnTo>
                    <a:pt x="3468" y="441"/>
                  </a:lnTo>
                  <a:lnTo>
                    <a:pt x="3469" y="440"/>
                  </a:lnTo>
                  <a:lnTo>
                    <a:pt x="3470" y="440"/>
                  </a:lnTo>
                  <a:lnTo>
                    <a:pt x="3471" y="439"/>
                  </a:lnTo>
                  <a:lnTo>
                    <a:pt x="3472" y="439"/>
                  </a:lnTo>
                  <a:lnTo>
                    <a:pt x="3473" y="439"/>
                  </a:lnTo>
                  <a:lnTo>
                    <a:pt x="3474" y="439"/>
                  </a:lnTo>
                  <a:lnTo>
                    <a:pt x="3474" y="440"/>
                  </a:lnTo>
                  <a:lnTo>
                    <a:pt x="3475" y="440"/>
                  </a:lnTo>
                  <a:lnTo>
                    <a:pt x="3476" y="440"/>
                  </a:lnTo>
                  <a:lnTo>
                    <a:pt x="3476" y="441"/>
                  </a:lnTo>
                  <a:lnTo>
                    <a:pt x="3477" y="441"/>
                  </a:lnTo>
                  <a:lnTo>
                    <a:pt x="3477" y="442"/>
                  </a:lnTo>
                  <a:lnTo>
                    <a:pt x="3478" y="442"/>
                  </a:lnTo>
                  <a:lnTo>
                    <a:pt x="3478" y="443"/>
                  </a:lnTo>
                  <a:lnTo>
                    <a:pt x="3479" y="443"/>
                  </a:lnTo>
                  <a:lnTo>
                    <a:pt x="3480" y="444"/>
                  </a:lnTo>
                  <a:lnTo>
                    <a:pt x="3481" y="445"/>
                  </a:lnTo>
                  <a:lnTo>
                    <a:pt x="3482" y="445"/>
                  </a:lnTo>
                  <a:lnTo>
                    <a:pt x="3482" y="446"/>
                  </a:lnTo>
                  <a:lnTo>
                    <a:pt x="3483" y="446"/>
                  </a:lnTo>
                  <a:lnTo>
                    <a:pt x="3484" y="446"/>
                  </a:lnTo>
                  <a:lnTo>
                    <a:pt x="3484" y="447"/>
                  </a:lnTo>
                  <a:lnTo>
                    <a:pt x="3485" y="447"/>
                  </a:lnTo>
                  <a:lnTo>
                    <a:pt x="3486" y="447"/>
                  </a:lnTo>
                  <a:lnTo>
                    <a:pt x="3487" y="447"/>
                  </a:lnTo>
                  <a:lnTo>
                    <a:pt x="3488" y="447"/>
                  </a:lnTo>
                  <a:lnTo>
                    <a:pt x="3488" y="446"/>
                  </a:lnTo>
                  <a:lnTo>
                    <a:pt x="3489" y="446"/>
                  </a:lnTo>
                  <a:lnTo>
                    <a:pt x="3490" y="446"/>
                  </a:lnTo>
                  <a:lnTo>
                    <a:pt x="3491" y="446"/>
                  </a:lnTo>
                  <a:lnTo>
                    <a:pt x="3491" y="445"/>
                  </a:lnTo>
                  <a:lnTo>
                    <a:pt x="3492" y="445"/>
                  </a:lnTo>
                  <a:lnTo>
                    <a:pt x="3493" y="445"/>
                  </a:lnTo>
                  <a:lnTo>
                    <a:pt x="3494" y="444"/>
                  </a:lnTo>
                  <a:lnTo>
                    <a:pt x="3495" y="444"/>
                  </a:lnTo>
                  <a:lnTo>
                    <a:pt x="3496" y="444"/>
                  </a:lnTo>
                  <a:lnTo>
                    <a:pt x="3497" y="444"/>
                  </a:lnTo>
                  <a:lnTo>
                    <a:pt x="3498" y="444"/>
                  </a:lnTo>
                  <a:lnTo>
                    <a:pt x="3499" y="444"/>
                  </a:lnTo>
                  <a:lnTo>
                    <a:pt x="3500" y="444"/>
                  </a:lnTo>
                  <a:lnTo>
                    <a:pt x="3501" y="444"/>
                  </a:lnTo>
                  <a:lnTo>
                    <a:pt x="3502" y="444"/>
                  </a:lnTo>
                  <a:lnTo>
                    <a:pt x="3502" y="445"/>
                  </a:lnTo>
                  <a:lnTo>
                    <a:pt x="3503" y="445"/>
                  </a:lnTo>
                  <a:lnTo>
                    <a:pt x="3504" y="445"/>
                  </a:lnTo>
                  <a:lnTo>
                    <a:pt x="3505" y="445"/>
                  </a:lnTo>
                  <a:lnTo>
                    <a:pt x="3506" y="445"/>
                  </a:lnTo>
                  <a:lnTo>
                    <a:pt x="3507" y="445"/>
                  </a:lnTo>
                  <a:lnTo>
                    <a:pt x="3508" y="445"/>
                  </a:lnTo>
                  <a:lnTo>
                    <a:pt x="3509" y="445"/>
                  </a:lnTo>
                  <a:lnTo>
                    <a:pt x="3510" y="444"/>
                  </a:lnTo>
                  <a:lnTo>
                    <a:pt x="3511" y="444"/>
                  </a:lnTo>
                  <a:lnTo>
                    <a:pt x="3512" y="443"/>
                  </a:lnTo>
                  <a:lnTo>
                    <a:pt x="3513" y="443"/>
                  </a:lnTo>
                  <a:lnTo>
                    <a:pt x="3513" y="442"/>
                  </a:lnTo>
                  <a:lnTo>
                    <a:pt x="3514" y="442"/>
                  </a:lnTo>
                  <a:lnTo>
                    <a:pt x="3515" y="442"/>
                  </a:lnTo>
                  <a:lnTo>
                    <a:pt x="3515" y="441"/>
                  </a:lnTo>
                  <a:lnTo>
                    <a:pt x="3516" y="441"/>
                  </a:lnTo>
                  <a:lnTo>
                    <a:pt x="3517" y="440"/>
                  </a:lnTo>
                  <a:lnTo>
                    <a:pt x="3518" y="440"/>
                  </a:lnTo>
                  <a:lnTo>
                    <a:pt x="3519" y="439"/>
                  </a:lnTo>
                  <a:lnTo>
                    <a:pt x="3520" y="439"/>
                  </a:lnTo>
                </a:path>
              </a:pathLst>
            </a:custGeom>
            <a:noFill/>
            <a:ln w="2556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Line 118"/>
            <p:cNvSpPr/>
            <p:nvPr/>
          </p:nvSpPr>
          <p:spPr>
            <a:xfrm>
              <a:off x="2050920" y="4032360"/>
              <a:ext cx="27936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Line 119"/>
            <p:cNvSpPr/>
            <p:nvPr/>
          </p:nvSpPr>
          <p:spPr>
            <a:xfrm>
              <a:off x="2376360" y="4033800"/>
              <a:ext cx="209520" cy="0"/>
            </a:xfrm>
            <a:prstGeom prst="line">
              <a:avLst/>
            </a:prstGeom>
            <a:ln w="2232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120"/>
            <p:cNvSpPr/>
            <p:nvPr/>
          </p:nvSpPr>
          <p:spPr>
            <a:xfrm>
              <a:off x="2624040" y="4033800"/>
              <a:ext cx="158760" cy="0"/>
            </a:xfrm>
            <a:prstGeom prst="line">
              <a:avLst/>
            </a:prstGeom>
            <a:ln w="2232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Line 122"/>
            <p:cNvSpPr/>
            <p:nvPr/>
          </p:nvSpPr>
          <p:spPr>
            <a:xfrm flipV="1">
              <a:off x="3664080" y="447804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Text Box 124"/>
            <p:cNvSpPr/>
            <p:nvPr/>
          </p:nvSpPr>
          <p:spPr>
            <a:xfrm>
              <a:off x="2009880" y="5473800"/>
              <a:ext cx="8773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Formation of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gonadal ridges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~35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Text Box 125"/>
            <p:cNvSpPr/>
            <p:nvPr/>
          </p:nvSpPr>
          <p:spPr>
            <a:xfrm>
              <a:off x="2597760" y="4694400"/>
              <a:ext cx="74160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Rapid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proliferation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of PGCs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fter 60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Text Box 126"/>
            <p:cNvSpPr/>
            <p:nvPr/>
          </p:nvSpPr>
          <p:spPr>
            <a:xfrm>
              <a:off x="2834280" y="5473800"/>
              <a:ext cx="1040400" cy="70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First sex dimorphi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expression of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s-ES_tradnl" sz="800" spc="-1" strike="noStrike">
                  <a:solidFill>
                    <a:srgbClr val="000000"/>
                  </a:solidFill>
                  <a:latin typeface="Arial"/>
                </a:rPr>
                <a:t>cyp19a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(females &gt; males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t 120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Text Box 128"/>
            <p:cNvSpPr/>
            <p:nvPr/>
          </p:nvSpPr>
          <p:spPr>
            <a:xfrm>
              <a:off x="3203280" y="4694400"/>
              <a:ext cx="9151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First histological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signs of sex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differentiation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t 150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Text Box 129"/>
            <p:cNvSpPr/>
            <p:nvPr/>
          </p:nvSpPr>
          <p:spPr>
            <a:xfrm>
              <a:off x="4301640" y="4694400"/>
              <a:ext cx="7995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ll fish sex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differentiated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by 250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Text Box 130"/>
            <p:cNvSpPr/>
            <p:nvPr/>
          </p:nvSpPr>
          <p:spPr>
            <a:xfrm>
              <a:off x="5191200" y="4694400"/>
              <a:ext cx="6350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Sex ratio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nalysi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t 330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Line 131"/>
            <p:cNvSpPr/>
            <p:nvPr/>
          </p:nvSpPr>
          <p:spPr>
            <a:xfrm flipV="1">
              <a:off x="5508720" y="447804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Line 132"/>
            <p:cNvSpPr/>
            <p:nvPr/>
          </p:nvSpPr>
          <p:spPr>
            <a:xfrm flipV="1">
              <a:off x="2968560" y="447804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Line 134"/>
            <p:cNvSpPr/>
            <p:nvPr/>
          </p:nvSpPr>
          <p:spPr>
            <a:xfrm flipV="1">
              <a:off x="2273400" y="447804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Text Box 123"/>
            <p:cNvSpPr/>
            <p:nvPr/>
          </p:nvSpPr>
          <p:spPr>
            <a:xfrm>
              <a:off x="1814040" y="4694400"/>
              <a:ext cx="9169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Appearance o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primordial germ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cells (PGC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~25 dp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Line 140"/>
            <p:cNvSpPr/>
            <p:nvPr/>
          </p:nvSpPr>
          <p:spPr>
            <a:xfrm flipV="1">
              <a:off x="2449440" y="4478040"/>
              <a:ext cx="0" cy="228600"/>
            </a:xfrm>
            <a:prstGeom prst="line">
              <a:avLst/>
            </a:prstGeom>
            <a:ln w="12600">
              <a:solidFill>
                <a:srgbClr val="008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Line 141"/>
            <p:cNvSpPr/>
            <p:nvPr/>
          </p:nvSpPr>
          <p:spPr>
            <a:xfrm>
              <a:off x="2449440" y="5257800"/>
              <a:ext cx="0" cy="190440"/>
            </a:xfrm>
            <a:prstGeom prst="line">
              <a:avLst/>
            </a:prstGeom>
            <a:ln w="1260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Line 142"/>
            <p:cNvSpPr/>
            <p:nvPr/>
          </p:nvSpPr>
          <p:spPr>
            <a:xfrm flipV="1">
              <a:off x="4702320" y="447804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Line 143"/>
            <p:cNvSpPr/>
            <p:nvPr/>
          </p:nvSpPr>
          <p:spPr>
            <a:xfrm flipV="1">
              <a:off x="3354480" y="4478040"/>
              <a:ext cx="0" cy="228600"/>
            </a:xfrm>
            <a:prstGeom prst="line">
              <a:avLst/>
            </a:prstGeom>
            <a:ln w="12600">
              <a:solidFill>
                <a:srgbClr val="008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Line 144"/>
            <p:cNvSpPr/>
            <p:nvPr/>
          </p:nvSpPr>
          <p:spPr>
            <a:xfrm>
              <a:off x="3354480" y="5164200"/>
              <a:ext cx="0" cy="253800"/>
            </a:xfrm>
            <a:prstGeom prst="line">
              <a:avLst/>
            </a:prstGeom>
            <a:ln w="1260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Text Box 146"/>
            <p:cNvSpPr/>
            <p:nvPr/>
          </p:nvSpPr>
          <p:spPr>
            <a:xfrm>
              <a:off x="2252880" y="289080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200" spc="-1" strike="noStrike">
                  <a:solidFill>
                    <a:srgbClr val="000000"/>
                  </a:solidFill>
                  <a:latin typeface="Arial"/>
                </a:rPr>
                <a:t>H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Text Box 147"/>
            <p:cNvSpPr/>
            <p:nvPr/>
          </p:nvSpPr>
          <p:spPr>
            <a:xfrm>
              <a:off x="2261520" y="3533760"/>
              <a:ext cx="36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200" spc="-1" strike="noStrike">
                  <a:solidFill>
                    <a:srgbClr val="000000"/>
                  </a:solidFill>
                  <a:latin typeface="Arial"/>
                </a:rPr>
                <a:t>L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Text Box 150"/>
            <p:cNvSpPr/>
            <p:nvPr/>
          </p:nvSpPr>
          <p:spPr>
            <a:xfrm>
              <a:off x="2241000" y="3863880"/>
              <a:ext cx="38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TSP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Line 151"/>
            <p:cNvSpPr/>
            <p:nvPr/>
          </p:nvSpPr>
          <p:spPr>
            <a:xfrm>
              <a:off x="3678120" y="4027320"/>
              <a:ext cx="103500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  <a:headEnd len="sm" type="arrow" w="sm"/>
              <a:tail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Text Box 152"/>
            <p:cNvSpPr/>
            <p:nvPr/>
          </p:nvSpPr>
          <p:spPr>
            <a:xfrm>
              <a:off x="3659040" y="3821040"/>
              <a:ext cx="108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800" spc="-1" strike="noStrike">
                  <a:solidFill>
                    <a:srgbClr val="000000"/>
                  </a:solidFill>
                  <a:latin typeface="Arial"/>
                </a:rPr>
                <a:t>Sex Differentiation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4T15:31:37Z</dcterms:created>
  <dc:creator>HOME</dc:creator>
  <dc:description/>
  <dc:language>en-US</dc:language>
  <cp:lastModifiedBy>Francesc Piferrer</cp:lastModifiedBy>
  <cp:lastPrinted>2011-08-01T10:23:31Z</cp:lastPrinted>
  <dcterms:modified xsi:type="dcterms:W3CDTF">2011-10-18T15:24:49Z</dcterms:modified>
  <cp:revision>49</cp:revision>
  <dc:subject/>
  <dc:title>PowerPoint Presentation</dc:title>
</cp:coreProperties>
</file>